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923" r:id="rId3"/>
    <p:sldId id="926" r:id="rId4"/>
    <p:sldId id="270" r:id="rId5"/>
    <p:sldId id="264" r:id="rId6"/>
    <p:sldId id="261" r:id="rId7"/>
  </p:sldIdLst>
  <p:sldSz cx="68580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4" autoAdjust="0"/>
    <p:restoredTop sz="94660"/>
  </p:normalViewPr>
  <p:slideViewPr>
    <p:cSldViewPr snapToGrid="0">
      <p:cViewPr>
        <p:scale>
          <a:sx n="100" d="100"/>
          <a:sy n="100" d="100"/>
        </p:scale>
        <p:origin x="167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46133"/>
            <a:ext cx="5829300" cy="350181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82989"/>
            <a:ext cx="5143500" cy="242845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082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330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35517"/>
            <a:ext cx="1478756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35517"/>
            <a:ext cx="4350544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5221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279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507618"/>
            <a:ext cx="5915025" cy="418401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731215"/>
            <a:ext cx="5915025" cy="220027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421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77584"/>
            <a:ext cx="291465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77584"/>
            <a:ext cx="291465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497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5519"/>
            <a:ext cx="591502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65706"/>
            <a:ext cx="2901255" cy="120840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74110"/>
            <a:ext cx="2901255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65706"/>
            <a:ext cx="2915543" cy="120840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74110"/>
            <a:ext cx="2915543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5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351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490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70560"/>
            <a:ext cx="2211884" cy="23469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48226"/>
            <a:ext cx="3471863" cy="714798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17520"/>
            <a:ext cx="2211884" cy="559032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700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70560"/>
            <a:ext cx="2211884" cy="23469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48226"/>
            <a:ext cx="3471863" cy="7147983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017520"/>
            <a:ext cx="2211884" cy="559032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210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35519"/>
            <a:ext cx="591502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77584"/>
            <a:ext cx="591502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322649"/>
            <a:ext cx="154305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AF43C4-D1C4-4A9B-96E0-D106861A348D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322649"/>
            <a:ext cx="231457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322649"/>
            <a:ext cx="154305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8F633-B70F-4BDA-AD6E-C417752B26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453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10.png"/><Relationship Id="rId3" Type="http://schemas.openxmlformats.org/officeDocument/2006/relationships/image" Target="../media/image4.jpeg"/><Relationship Id="rId7" Type="http://schemas.openxmlformats.org/officeDocument/2006/relationships/image" Target="../media/image7.png"/><Relationship Id="rId12" Type="http://schemas.microsoft.com/office/2007/relationships/hdphoto" Target="../media/hdphoto5.wdp"/><Relationship Id="rId2" Type="http://schemas.openxmlformats.org/officeDocument/2006/relationships/image" Target="../media/image3.jpeg"/><Relationship Id="rId16" Type="http://schemas.microsoft.com/office/2007/relationships/hdphoto" Target="../media/hdphoto7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9.png"/><Relationship Id="rId5" Type="http://schemas.openxmlformats.org/officeDocument/2006/relationships/image" Target="../media/image6.png"/><Relationship Id="rId15" Type="http://schemas.openxmlformats.org/officeDocument/2006/relationships/image" Target="../media/image11.png"/><Relationship Id="rId10" Type="http://schemas.microsoft.com/office/2007/relationships/hdphoto" Target="../media/hdphoto4.wdp"/><Relationship Id="rId4" Type="http://schemas.openxmlformats.org/officeDocument/2006/relationships/image" Target="../media/image5.jpeg"/><Relationship Id="rId9" Type="http://schemas.openxmlformats.org/officeDocument/2006/relationships/image" Target="../media/image8.png"/><Relationship Id="rId14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microsoft.com/office/2007/relationships/hdphoto" Target="../media/hdphoto13.wdp"/><Relationship Id="rId18" Type="http://schemas.openxmlformats.org/officeDocument/2006/relationships/image" Target="../media/image20.png"/><Relationship Id="rId3" Type="http://schemas.microsoft.com/office/2007/relationships/hdphoto" Target="../media/hdphoto8.wdp"/><Relationship Id="rId7" Type="http://schemas.microsoft.com/office/2007/relationships/hdphoto" Target="../media/hdphoto10.wdp"/><Relationship Id="rId12" Type="http://schemas.openxmlformats.org/officeDocument/2006/relationships/image" Target="../media/image17.png"/><Relationship Id="rId17" Type="http://schemas.microsoft.com/office/2007/relationships/hdphoto" Target="../media/hdphoto15.wdp"/><Relationship Id="rId2" Type="http://schemas.openxmlformats.org/officeDocument/2006/relationships/image" Target="../media/image12.png"/><Relationship Id="rId16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microsoft.com/office/2007/relationships/hdphoto" Target="../media/hdphoto12.wdp"/><Relationship Id="rId5" Type="http://schemas.microsoft.com/office/2007/relationships/hdphoto" Target="../media/hdphoto9.wdp"/><Relationship Id="rId15" Type="http://schemas.microsoft.com/office/2007/relationships/hdphoto" Target="../media/hdphoto14.wdp"/><Relationship Id="rId10" Type="http://schemas.openxmlformats.org/officeDocument/2006/relationships/image" Target="../media/image16.png"/><Relationship Id="rId19" Type="http://schemas.microsoft.com/office/2007/relationships/hdphoto" Target="../media/hdphoto16.wdp"/><Relationship Id="rId4" Type="http://schemas.openxmlformats.org/officeDocument/2006/relationships/image" Target="../media/image13.png"/><Relationship Id="rId9" Type="http://schemas.microsoft.com/office/2007/relationships/hdphoto" Target="../media/hdphoto11.wdp"/><Relationship Id="rId14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9.wdp"/><Relationship Id="rId13" Type="http://schemas.openxmlformats.org/officeDocument/2006/relationships/image" Target="../media/image27.png"/><Relationship Id="rId18" Type="http://schemas.microsoft.com/office/2007/relationships/hdphoto" Target="../media/hdphoto22.wdp"/><Relationship Id="rId3" Type="http://schemas.openxmlformats.org/officeDocument/2006/relationships/image" Target="../media/image22.png"/><Relationship Id="rId21" Type="http://schemas.openxmlformats.org/officeDocument/2006/relationships/image" Target="../media/image32.emf"/><Relationship Id="rId7" Type="http://schemas.openxmlformats.org/officeDocument/2006/relationships/image" Target="../media/image24.png"/><Relationship Id="rId12" Type="http://schemas.openxmlformats.org/officeDocument/2006/relationships/image" Target="../media/image26.emf"/><Relationship Id="rId17" Type="http://schemas.openxmlformats.org/officeDocument/2006/relationships/image" Target="../media/image29.png"/><Relationship Id="rId2" Type="http://schemas.openxmlformats.org/officeDocument/2006/relationships/slideLayout" Target="../slideLayouts/slideLayout7.xml"/><Relationship Id="rId16" Type="http://schemas.microsoft.com/office/2007/relationships/hdphoto" Target="../media/hdphoto21.wdp"/><Relationship Id="rId20" Type="http://schemas.openxmlformats.org/officeDocument/2006/relationships/image" Target="../media/image31.emf"/><Relationship Id="rId1" Type="http://schemas.openxmlformats.org/officeDocument/2006/relationships/vmlDrawing" Target="../drawings/vmlDrawing1.vml"/><Relationship Id="rId6" Type="http://schemas.microsoft.com/office/2007/relationships/hdphoto" Target="../media/hdphoto18.wdp"/><Relationship Id="rId11" Type="http://schemas.openxmlformats.org/officeDocument/2006/relationships/image" Target="../media/image21.wmf"/><Relationship Id="rId24" Type="http://schemas.openxmlformats.org/officeDocument/2006/relationships/image" Target="../media/image35.png"/><Relationship Id="rId5" Type="http://schemas.openxmlformats.org/officeDocument/2006/relationships/image" Target="../media/image23.png"/><Relationship Id="rId15" Type="http://schemas.openxmlformats.org/officeDocument/2006/relationships/image" Target="../media/image28.png"/><Relationship Id="rId23" Type="http://schemas.openxmlformats.org/officeDocument/2006/relationships/image" Target="../media/image34.png"/><Relationship Id="rId10" Type="http://schemas.openxmlformats.org/officeDocument/2006/relationships/oleObject" Target="../embeddings/oleObject1.bin"/><Relationship Id="rId19" Type="http://schemas.openxmlformats.org/officeDocument/2006/relationships/image" Target="../media/image30.emf"/><Relationship Id="rId4" Type="http://schemas.microsoft.com/office/2007/relationships/hdphoto" Target="../media/hdphoto17.wdp"/><Relationship Id="rId9" Type="http://schemas.openxmlformats.org/officeDocument/2006/relationships/image" Target="../media/image25.emf"/><Relationship Id="rId14" Type="http://schemas.microsoft.com/office/2007/relationships/hdphoto" Target="../media/hdphoto20.wdp"/><Relationship Id="rId22" Type="http://schemas.openxmlformats.org/officeDocument/2006/relationships/image" Target="../media/image3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9B1AAB7-1443-4C1D-83E7-7AD91ED0D2A8}"/>
              </a:ext>
            </a:extLst>
          </p:cNvPr>
          <p:cNvSpPr txBox="1"/>
          <p:nvPr/>
        </p:nvSpPr>
        <p:spPr>
          <a:xfrm>
            <a:off x="179794" y="305327"/>
            <a:ext cx="1526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1</a:t>
            </a:r>
          </a:p>
        </p:txBody>
      </p:sp>
      <p:grpSp>
        <p:nvGrpSpPr>
          <p:cNvPr id="76" name="Group 75">
            <a:extLst>
              <a:ext uri="{FF2B5EF4-FFF2-40B4-BE49-F238E27FC236}">
                <a16:creationId xmlns:a16="http://schemas.microsoft.com/office/drawing/2014/main" id="{D0B881A1-657D-441A-A51C-12D997B95E45}"/>
              </a:ext>
            </a:extLst>
          </p:cNvPr>
          <p:cNvGrpSpPr/>
          <p:nvPr/>
        </p:nvGrpSpPr>
        <p:grpSpPr>
          <a:xfrm>
            <a:off x="377503" y="915170"/>
            <a:ext cx="2206377" cy="1473967"/>
            <a:chOff x="729169" y="3319833"/>
            <a:chExt cx="2274977" cy="1473967"/>
          </a:xfrm>
        </p:grpSpPr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51D9478A-480B-4E7C-8CC9-B4BD120359A3}"/>
                </a:ext>
              </a:extLst>
            </p:cNvPr>
            <p:cNvGrpSpPr/>
            <p:nvPr/>
          </p:nvGrpSpPr>
          <p:grpSpPr>
            <a:xfrm>
              <a:off x="729169" y="3478213"/>
              <a:ext cx="2274977" cy="1315587"/>
              <a:chOff x="729169" y="3478213"/>
              <a:chExt cx="2274977" cy="1315587"/>
            </a:xfrm>
          </p:grpSpPr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35B83FE0-8661-432C-A0AD-1980236A1356}"/>
                  </a:ext>
                </a:extLst>
              </p:cNvPr>
              <p:cNvGrpSpPr/>
              <p:nvPr/>
            </p:nvGrpSpPr>
            <p:grpSpPr>
              <a:xfrm>
                <a:off x="2078883" y="3512908"/>
                <a:ext cx="820124" cy="539718"/>
                <a:chOff x="2003425" y="3522595"/>
                <a:chExt cx="820124" cy="539718"/>
              </a:xfrm>
            </p:grpSpPr>
            <p:sp>
              <p:nvSpPr>
                <p:cNvPr id="60" name="Rectangle 58">
                  <a:extLst>
                    <a:ext uri="{FF2B5EF4-FFF2-40B4-BE49-F238E27FC236}">
                      <a16:creationId xmlns:a16="http://schemas.microsoft.com/office/drawing/2014/main" id="{E1ED6377-F385-4B3D-8D1B-BCE20790BE0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36788" y="3522595"/>
                  <a:ext cx="396683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en-US" sz="1000" dirty="0">
                      <a:solidFill>
                        <a:srgbClr val="000000"/>
                      </a:solidFill>
                    </a:rPr>
                    <a:t>DMSO</a:t>
                  </a:r>
                  <a:endParaRPr lang="en-US" altLang="en-US" sz="1000" dirty="0"/>
                </a:p>
              </p:txBody>
            </p:sp>
            <p:sp>
              <p:nvSpPr>
                <p:cNvPr id="61" name="Line 59">
                  <a:extLst>
                    <a:ext uri="{FF2B5EF4-FFF2-40B4-BE49-F238E27FC236}">
                      <a16:creationId xmlns:a16="http://schemas.microsoft.com/office/drawing/2014/main" id="{71F13C43-3B98-4C80-9026-2A29F6B914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03425" y="3611549"/>
                  <a:ext cx="149225" cy="0"/>
                </a:xfrm>
                <a:prstGeom prst="line">
                  <a:avLst/>
                </a:prstGeom>
                <a:noFill/>
                <a:ln w="14288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/>
                </a:p>
              </p:txBody>
            </p:sp>
            <p:sp>
              <p:nvSpPr>
                <p:cNvPr id="62" name="Rectangle 60">
                  <a:extLst>
                    <a:ext uri="{FF2B5EF4-FFF2-40B4-BE49-F238E27FC236}">
                      <a16:creationId xmlns:a16="http://schemas.microsoft.com/office/drawing/2014/main" id="{EFB00456-8E67-41B2-8C6D-E35F277129C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36788" y="3649622"/>
                  <a:ext cx="586761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en-US" sz="1000" dirty="0">
                      <a:solidFill>
                        <a:srgbClr val="000000"/>
                      </a:solidFill>
                    </a:rPr>
                    <a:t>Nob(1um)</a:t>
                  </a:r>
                  <a:endParaRPr lang="en-US" altLang="en-US" sz="1000" dirty="0"/>
                </a:p>
              </p:txBody>
            </p:sp>
            <p:sp>
              <p:nvSpPr>
                <p:cNvPr id="63" name="Line 61">
                  <a:extLst>
                    <a:ext uri="{FF2B5EF4-FFF2-40B4-BE49-F238E27FC236}">
                      <a16:creationId xmlns:a16="http://schemas.microsoft.com/office/drawing/2014/main" id="{AB2D591E-0D50-47D6-A4E6-D4FC868310F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03425" y="3730625"/>
                  <a:ext cx="149225" cy="0"/>
                </a:xfrm>
                <a:prstGeom prst="line">
                  <a:avLst/>
                </a:prstGeom>
                <a:noFill/>
                <a:ln w="14288">
                  <a:solidFill>
                    <a:srgbClr val="C000C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/>
                </a:p>
              </p:txBody>
            </p:sp>
            <p:sp>
              <p:nvSpPr>
                <p:cNvPr id="64" name="Rectangle 62">
                  <a:extLst>
                    <a:ext uri="{FF2B5EF4-FFF2-40B4-BE49-F238E27FC236}">
                      <a16:creationId xmlns:a16="http://schemas.microsoft.com/office/drawing/2014/main" id="{AA030A21-9D5A-4BA1-9667-12C155FF9B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36788" y="3784600"/>
                  <a:ext cx="586760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en-US" sz="1000" dirty="0">
                      <a:solidFill>
                        <a:srgbClr val="000000"/>
                      </a:solidFill>
                    </a:rPr>
                    <a:t>Nob(2um)</a:t>
                  </a:r>
                  <a:endParaRPr lang="en-US" altLang="en-US" sz="1000" dirty="0"/>
                </a:p>
              </p:txBody>
            </p:sp>
            <p:sp>
              <p:nvSpPr>
                <p:cNvPr id="65" name="Line 63">
                  <a:extLst>
                    <a:ext uri="{FF2B5EF4-FFF2-40B4-BE49-F238E27FC236}">
                      <a16:creationId xmlns:a16="http://schemas.microsoft.com/office/drawing/2014/main" id="{A5EC5D7C-EE04-4289-9148-0E367DEAD9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03425" y="3867191"/>
                  <a:ext cx="149225" cy="0"/>
                </a:xfrm>
                <a:prstGeom prst="line">
                  <a:avLst/>
                </a:prstGeom>
                <a:noFill/>
                <a:ln w="14288">
                  <a:solidFill>
                    <a:srgbClr val="00FF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/>
                </a:p>
              </p:txBody>
            </p:sp>
            <p:sp>
              <p:nvSpPr>
                <p:cNvPr id="66" name="Rectangle 64">
                  <a:extLst>
                    <a:ext uri="{FF2B5EF4-FFF2-40B4-BE49-F238E27FC236}">
                      <a16:creationId xmlns:a16="http://schemas.microsoft.com/office/drawing/2014/main" id="{1755E639-C4DE-4696-82BD-1BB81FD5F5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236788" y="3908425"/>
                  <a:ext cx="586760" cy="1538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en-US" sz="1000" dirty="0">
                      <a:solidFill>
                        <a:srgbClr val="000000"/>
                      </a:solidFill>
                    </a:rPr>
                    <a:t>Nob(5um)</a:t>
                  </a:r>
                  <a:endParaRPr lang="en-US" altLang="en-US" sz="1000" dirty="0"/>
                </a:p>
              </p:txBody>
            </p:sp>
            <p:sp>
              <p:nvSpPr>
                <p:cNvPr id="67" name="Line 65">
                  <a:extLst>
                    <a:ext uri="{FF2B5EF4-FFF2-40B4-BE49-F238E27FC236}">
                      <a16:creationId xmlns:a16="http://schemas.microsoft.com/office/drawing/2014/main" id="{A69B4559-8365-4CD6-B73C-051BCDDBBE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03425" y="3981477"/>
                  <a:ext cx="149225" cy="0"/>
                </a:xfrm>
                <a:prstGeom prst="line">
                  <a:avLst/>
                </a:prstGeom>
                <a:noFill/>
                <a:ln w="14288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1000" dirty="0"/>
                </a:p>
              </p:txBody>
            </p:sp>
          </p:grpSp>
          <p:grpSp>
            <p:nvGrpSpPr>
              <p:cNvPr id="74" name="Group 73">
                <a:extLst>
                  <a:ext uri="{FF2B5EF4-FFF2-40B4-BE49-F238E27FC236}">
                    <a16:creationId xmlns:a16="http://schemas.microsoft.com/office/drawing/2014/main" id="{B969ED93-97EE-4640-A9FB-C856B515E289}"/>
                  </a:ext>
                </a:extLst>
              </p:cNvPr>
              <p:cNvGrpSpPr/>
              <p:nvPr/>
            </p:nvGrpSpPr>
            <p:grpSpPr>
              <a:xfrm>
                <a:off x="729169" y="3478213"/>
                <a:ext cx="2274977" cy="1315587"/>
                <a:chOff x="728132" y="3478213"/>
                <a:chExt cx="2412490" cy="1476163"/>
              </a:xfrm>
            </p:grpSpPr>
            <p:grpSp>
              <p:nvGrpSpPr>
                <p:cNvPr id="73" name="Group 72">
                  <a:extLst>
                    <a:ext uri="{FF2B5EF4-FFF2-40B4-BE49-F238E27FC236}">
                      <a16:creationId xmlns:a16="http://schemas.microsoft.com/office/drawing/2014/main" id="{10074801-F0DB-4F8E-86C8-0C3D0B2CBBDE}"/>
                    </a:ext>
                  </a:extLst>
                </p:cNvPr>
                <p:cNvGrpSpPr/>
                <p:nvPr/>
              </p:nvGrpSpPr>
              <p:grpSpPr>
                <a:xfrm>
                  <a:off x="1095375" y="3478213"/>
                  <a:ext cx="2045247" cy="1476163"/>
                  <a:chOff x="1095375" y="3478213"/>
                  <a:chExt cx="2074582" cy="1476163"/>
                </a:xfrm>
              </p:grpSpPr>
              <p:grpSp>
                <p:nvGrpSpPr>
                  <p:cNvPr id="72" name="Group 71">
                    <a:extLst>
                      <a:ext uri="{FF2B5EF4-FFF2-40B4-BE49-F238E27FC236}">
                        <a16:creationId xmlns:a16="http://schemas.microsoft.com/office/drawing/2014/main" id="{3AEE3E47-4847-421A-B116-AE5D0DC82B28}"/>
                      </a:ext>
                    </a:extLst>
                  </p:cNvPr>
                  <p:cNvGrpSpPr/>
                  <p:nvPr/>
                </p:nvGrpSpPr>
                <p:grpSpPr>
                  <a:xfrm>
                    <a:off x="1095375" y="3478213"/>
                    <a:ext cx="192012" cy="1239863"/>
                    <a:chOff x="1095375" y="3478213"/>
                    <a:chExt cx="192012" cy="1239863"/>
                  </a:xfrm>
                </p:grpSpPr>
                <p:sp>
                  <p:nvSpPr>
                    <p:cNvPr id="20" name="Rectangle 18">
                      <a:extLst>
                        <a:ext uri="{FF2B5EF4-FFF2-40B4-BE49-F238E27FC236}">
                          <a16:creationId xmlns:a16="http://schemas.microsoft.com/office/drawing/2014/main" id="{3B28B955-AFD2-489E-A179-7B47B59044E6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203325" y="4579938"/>
                      <a:ext cx="64004" cy="13813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800" dirty="0">
                          <a:solidFill>
                            <a:srgbClr val="000000"/>
                          </a:solidFill>
                        </a:rPr>
                        <a:t>0</a:t>
                      </a:r>
                      <a:endParaRPr lang="en-US" altLang="en-US" sz="800" dirty="0"/>
                    </a:p>
                  </p:txBody>
                </p:sp>
                <p:sp>
                  <p:nvSpPr>
                    <p:cNvPr id="21" name="Rectangle 19">
                      <a:extLst>
                        <a:ext uri="{FF2B5EF4-FFF2-40B4-BE49-F238E27FC236}">
                          <a16:creationId xmlns:a16="http://schemas.microsoft.com/office/drawing/2014/main" id="{5812066E-A8ED-468C-B619-D937136A9D8B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095375" y="4305300"/>
                      <a:ext cx="192012" cy="13813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800">
                          <a:solidFill>
                            <a:srgbClr val="000000"/>
                          </a:solidFill>
                        </a:rPr>
                        <a:t>200</a:t>
                      </a:r>
                      <a:endParaRPr lang="en-US" altLang="en-US" sz="800"/>
                    </a:p>
                  </p:txBody>
                </p:sp>
                <p:sp>
                  <p:nvSpPr>
                    <p:cNvPr id="22" name="Rectangle 20">
                      <a:extLst>
                        <a:ext uri="{FF2B5EF4-FFF2-40B4-BE49-F238E27FC236}">
                          <a16:creationId xmlns:a16="http://schemas.microsoft.com/office/drawing/2014/main" id="{AE1D1824-2843-4AE2-A904-A1B4E9445C03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095375" y="4029075"/>
                      <a:ext cx="192012" cy="13813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800">
                          <a:solidFill>
                            <a:srgbClr val="000000"/>
                          </a:solidFill>
                        </a:rPr>
                        <a:t>400</a:t>
                      </a:r>
                      <a:endParaRPr lang="en-US" altLang="en-US" sz="800"/>
                    </a:p>
                  </p:txBody>
                </p:sp>
                <p:sp>
                  <p:nvSpPr>
                    <p:cNvPr id="23" name="Rectangle 21">
                      <a:extLst>
                        <a:ext uri="{FF2B5EF4-FFF2-40B4-BE49-F238E27FC236}">
                          <a16:creationId xmlns:a16="http://schemas.microsoft.com/office/drawing/2014/main" id="{8547F7F3-D168-4C54-9E6A-2311A2DE6220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095375" y="3752850"/>
                      <a:ext cx="192012" cy="13813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800">
                          <a:solidFill>
                            <a:srgbClr val="000000"/>
                          </a:solidFill>
                        </a:rPr>
                        <a:t>600</a:t>
                      </a:r>
                      <a:endParaRPr lang="en-US" altLang="en-US" sz="800"/>
                    </a:p>
                  </p:txBody>
                </p:sp>
                <p:sp>
                  <p:nvSpPr>
                    <p:cNvPr id="24" name="Rectangle 22">
                      <a:extLst>
                        <a:ext uri="{FF2B5EF4-FFF2-40B4-BE49-F238E27FC236}">
                          <a16:creationId xmlns:a16="http://schemas.microsoft.com/office/drawing/2014/main" id="{68E97429-2D53-4701-952B-7CF6DFC4FCDC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095375" y="3478213"/>
                      <a:ext cx="192012" cy="13813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800">
                          <a:solidFill>
                            <a:srgbClr val="000000"/>
                          </a:solidFill>
                        </a:rPr>
                        <a:t>800</a:t>
                      </a:r>
                      <a:endParaRPr lang="en-US" altLang="en-US" sz="800"/>
                    </a:p>
                  </p:txBody>
                </p:sp>
              </p:grpSp>
              <p:grpSp>
                <p:nvGrpSpPr>
                  <p:cNvPr id="71" name="Group 70">
                    <a:extLst>
                      <a:ext uri="{FF2B5EF4-FFF2-40B4-BE49-F238E27FC236}">
                        <a16:creationId xmlns:a16="http://schemas.microsoft.com/office/drawing/2014/main" id="{48ABBBB8-7EE4-484F-A69B-BFF90E518F48}"/>
                      </a:ext>
                    </a:extLst>
                  </p:cNvPr>
                  <p:cNvGrpSpPr/>
                  <p:nvPr/>
                </p:nvGrpSpPr>
                <p:grpSpPr>
                  <a:xfrm>
                    <a:off x="1295441" y="3519488"/>
                    <a:ext cx="1874516" cy="1434888"/>
                    <a:chOff x="1271588" y="3519488"/>
                    <a:chExt cx="1874516" cy="1434888"/>
                  </a:xfrm>
                </p:grpSpPr>
                <p:sp>
                  <p:nvSpPr>
                    <p:cNvPr id="7" name="Rectangle 5">
                      <a:extLst>
                        <a:ext uri="{FF2B5EF4-FFF2-40B4-BE49-F238E27FC236}">
                          <a16:creationId xmlns:a16="http://schemas.microsoft.com/office/drawing/2014/main" id="{02328D39-4626-46FB-8604-46D3D4B46AF1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284288" y="4681538"/>
                      <a:ext cx="71116" cy="1554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900">
                          <a:solidFill>
                            <a:srgbClr val="000000"/>
                          </a:solidFill>
                        </a:rPr>
                        <a:t>0</a:t>
                      </a:r>
                      <a:endParaRPr lang="en-US" altLang="en-US" sz="900"/>
                    </a:p>
                  </p:txBody>
                </p:sp>
                <p:sp>
                  <p:nvSpPr>
                    <p:cNvPr id="8" name="Rectangle 6">
                      <a:extLst>
                        <a:ext uri="{FF2B5EF4-FFF2-40B4-BE49-F238E27FC236}">
                          <a16:creationId xmlns:a16="http://schemas.microsoft.com/office/drawing/2014/main" id="{3FABFA26-D524-4975-9902-D8070781F435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643063" y="4681538"/>
                      <a:ext cx="71116" cy="1554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900">
                          <a:solidFill>
                            <a:srgbClr val="000000"/>
                          </a:solidFill>
                        </a:rPr>
                        <a:t>1</a:t>
                      </a:r>
                      <a:endParaRPr lang="en-US" altLang="en-US" sz="900"/>
                    </a:p>
                  </p:txBody>
                </p:sp>
                <p:sp>
                  <p:nvSpPr>
                    <p:cNvPr id="9" name="Rectangle 7">
                      <a:extLst>
                        <a:ext uri="{FF2B5EF4-FFF2-40B4-BE49-F238E27FC236}">
                          <a16:creationId xmlns:a16="http://schemas.microsoft.com/office/drawing/2014/main" id="{E45C156B-4E30-4B8E-8605-CC30EDFF5AF7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000250" y="4681538"/>
                      <a:ext cx="71116" cy="1554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900">
                          <a:solidFill>
                            <a:srgbClr val="000000"/>
                          </a:solidFill>
                        </a:rPr>
                        <a:t>2</a:t>
                      </a:r>
                      <a:endParaRPr lang="en-US" altLang="en-US" sz="900"/>
                    </a:p>
                  </p:txBody>
                </p:sp>
                <p:sp>
                  <p:nvSpPr>
                    <p:cNvPr id="10" name="Rectangle 8">
                      <a:extLst>
                        <a:ext uri="{FF2B5EF4-FFF2-40B4-BE49-F238E27FC236}">
                          <a16:creationId xmlns:a16="http://schemas.microsoft.com/office/drawing/2014/main" id="{D7F8B93C-B7F5-49E9-9AAF-B826CDE09869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359026" y="4681538"/>
                      <a:ext cx="71116" cy="1554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900">
                          <a:solidFill>
                            <a:srgbClr val="000000"/>
                          </a:solidFill>
                        </a:rPr>
                        <a:t>3</a:t>
                      </a:r>
                      <a:endParaRPr lang="en-US" altLang="en-US" sz="900"/>
                    </a:p>
                  </p:txBody>
                </p:sp>
                <p:sp>
                  <p:nvSpPr>
                    <p:cNvPr id="11" name="Rectangle 9">
                      <a:extLst>
                        <a:ext uri="{FF2B5EF4-FFF2-40B4-BE49-F238E27FC236}">
                          <a16:creationId xmlns:a16="http://schemas.microsoft.com/office/drawing/2014/main" id="{3D012AA2-F5F3-4AAB-9065-4C7AC357B20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717800" y="4681538"/>
                      <a:ext cx="71116" cy="1554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900" dirty="0">
                          <a:solidFill>
                            <a:srgbClr val="000000"/>
                          </a:solidFill>
                        </a:rPr>
                        <a:t>4</a:t>
                      </a:r>
                      <a:endParaRPr lang="en-US" altLang="en-US" sz="900" dirty="0"/>
                    </a:p>
                  </p:txBody>
                </p:sp>
                <p:sp>
                  <p:nvSpPr>
                    <p:cNvPr id="12" name="Rectangle 10">
                      <a:extLst>
                        <a:ext uri="{FF2B5EF4-FFF2-40B4-BE49-F238E27FC236}">
                          <a16:creationId xmlns:a16="http://schemas.microsoft.com/office/drawing/2014/main" id="{BF287504-EB0B-4C0C-81CC-F751BEC0B4C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074988" y="4681538"/>
                      <a:ext cx="71116" cy="1554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900" dirty="0">
                          <a:solidFill>
                            <a:srgbClr val="000000"/>
                          </a:solidFill>
                        </a:rPr>
                        <a:t>5</a:t>
                      </a:r>
                      <a:endParaRPr lang="en-US" altLang="en-US" sz="900" dirty="0"/>
                    </a:p>
                  </p:txBody>
                </p:sp>
                <p:sp>
                  <p:nvSpPr>
                    <p:cNvPr id="13" name="Line 11">
                      <a:extLst>
                        <a:ext uri="{FF2B5EF4-FFF2-40B4-BE49-F238E27FC236}">
                          <a16:creationId xmlns:a16="http://schemas.microsoft.com/office/drawing/2014/main" id="{781B9575-3B63-4C19-B65B-326F031A1668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306513" y="4627563"/>
                      <a:ext cx="1804987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4" name="Line 12">
                      <a:extLst>
                        <a:ext uri="{FF2B5EF4-FFF2-40B4-BE49-F238E27FC236}">
                          <a16:creationId xmlns:a16="http://schemas.microsoft.com/office/drawing/2014/main" id="{E10C74DB-A40D-49A6-ADEA-C8865484F17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314450" y="4627563"/>
                      <a:ext cx="0" cy="36513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5" name="Line 13">
                      <a:extLst>
                        <a:ext uri="{FF2B5EF4-FFF2-40B4-BE49-F238E27FC236}">
                          <a16:creationId xmlns:a16="http://schemas.microsoft.com/office/drawing/2014/main" id="{F3649718-6197-4590-81CD-C32585B0520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71638" y="4627563"/>
                      <a:ext cx="0" cy="36513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" name="Line 14">
                      <a:extLst>
                        <a:ext uri="{FF2B5EF4-FFF2-40B4-BE49-F238E27FC236}">
                          <a16:creationId xmlns:a16="http://schemas.microsoft.com/office/drawing/2014/main" id="{30572B0E-0E72-4EC5-A957-DBD678CC9CF6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030413" y="4627563"/>
                      <a:ext cx="0" cy="36513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" name="Line 15">
                      <a:extLst>
                        <a:ext uri="{FF2B5EF4-FFF2-40B4-BE49-F238E27FC236}">
                          <a16:creationId xmlns:a16="http://schemas.microsoft.com/office/drawing/2014/main" id="{C351D061-26CF-402D-AF29-B73D5C451604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387600" y="4627563"/>
                      <a:ext cx="0" cy="36513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" name="Line 16">
                      <a:extLst>
                        <a:ext uri="{FF2B5EF4-FFF2-40B4-BE49-F238E27FC236}">
                          <a16:creationId xmlns:a16="http://schemas.microsoft.com/office/drawing/2014/main" id="{3AE12C22-9AD7-4F89-8BA9-35B4F5B8F75E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746375" y="4627563"/>
                      <a:ext cx="0" cy="36513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" name="Line 17">
                      <a:extLst>
                        <a:ext uri="{FF2B5EF4-FFF2-40B4-BE49-F238E27FC236}">
                          <a16:creationId xmlns:a16="http://schemas.microsoft.com/office/drawing/2014/main" id="{DB67486B-0358-4831-B75B-3D512B9BB8E4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105150" y="4627563"/>
                      <a:ext cx="0" cy="36513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5" name="Line 23">
                      <a:extLst>
                        <a:ext uri="{FF2B5EF4-FFF2-40B4-BE49-F238E27FC236}">
                          <a16:creationId xmlns:a16="http://schemas.microsoft.com/office/drawing/2014/main" id="{E96CDBC7-C277-4592-A10C-7913DA5D09BE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1314450" y="3519488"/>
                      <a:ext cx="0" cy="1112838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6" name="Line 24">
                      <a:extLst>
                        <a:ext uri="{FF2B5EF4-FFF2-40B4-BE49-F238E27FC236}">
                          <a16:creationId xmlns:a16="http://schemas.microsoft.com/office/drawing/2014/main" id="{1F715A82-86DF-47DF-BACA-4DF51E58652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271588" y="4627563"/>
                      <a:ext cx="42862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" name="Line 25">
                      <a:extLst>
                        <a:ext uri="{FF2B5EF4-FFF2-40B4-BE49-F238E27FC236}">
                          <a16:creationId xmlns:a16="http://schemas.microsoft.com/office/drawing/2014/main" id="{87A0EE86-26E2-487E-87EC-BE0AAA3D2034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271588" y="4351338"/>
                      <a:ext cx="42862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" name="Line 26">
                      <a:extLst>
                        <a:ext uri="{FF2B5EF4-FFF2-40B4-BE49-F238E27FC236}">
                          <a16:creationId xmlns:a16="http://schemas.microsoft.com/office/drawing/2014/main" id="{791366E1-225F-4B43-A63D-D748C20A82E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271588" y="4076700"/>
                      <a:ext cx="42862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9" name="Line 27">
                      <a:extLst>
                        <a:ext uri="{FF2B5EF4-FFF2-40B4-BE49-F238E27FC236}">
                          <a16:creationId xmlns:a16="http://schemas.microsoft.com/office/drawing/2014/main" id="{A2059625-D0C7-49DC-9820-B64B9AD84759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271588" y="3800475"/>
                      <a:ext cx="42862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0" name="Line 28">
                      <a:extLst>
                        <a:ext uri="{FF2B5EF4-FFF2-40B4-BE49-F238E27FC236}">
                          <a16:creationId xmlns:a16="http://schemas.microsoft.com/office/drawing/2014/main" id="{4CE95E29-EF17-4F6F-A425-37C8304054C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1271588" y="3525838"/>
                      <a:ext cx="42862" cy="0"/>
                    </a:xfrm>
                    <a:prstGeom prst="line">
                      <a:avLst/>
                    </a:prstGeom>
                    <a:noFill/>
                    <a:ln w="1428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1" name="Freeform 29">
                      <a:extLst>
                        <a:ext uri="{FF2B5EF4-FFF2-40B4-BE49-F238E27FC236}">
                          <a16:creationId xmlns:a16="http://schemas.microsoft.com/office/drawing/2014/main" id="{9BC5E533-C4DA-4E06-99BB-B587AF2936A4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1314450" y="3673475"/>
                      <a:ext cx="1778000" cy="898525"/>
                    </a:xfrm>
                    <a:custGeom>
                      <a:avLst/>
                      <a:gdLst>
                        <a:gd name="T0" fmla="*/ 15 w 2240"/>
                        <a:gd name="T1" fmla="*/ 74 h 1133"/>
                        <a:gd name="T2" fmla="*/ 34 w 2240"/>
                        <a:gd name="T3" fmla="*/ 191 h 1133"/>
                        <a:gd name="T4" fmla="*/ 53 w 2240"/>
                        <a:gd name="T5" fmla="*/ 312 h 1133"/>
                        <a:gd name="T6" fmla="*/ 71 w 2240"/>
                        <a:gd name="T7" fmla="*/ 432 h 1133"/>
                        <a:gd name="T8" fmla="*/ 90 w 2240"/>
                        <a:gd name="T9" fmla="*/ 548 h 1133"/>
                        <a:gd name="T10" fmla="*/ 109 w 2240"/>
                        <a:gd name="T11" fmla="*/ 662 h 1133"/>
                        <a:gd name="T12" fmla="*/ 128 w 2240"/>
                        <a:gd name="T13" fmla="*/ 768 h 1133"/>
                        <a:gd name="T14" fmla="*/ 146 w 2240"/>
                        <a:gd name="T15" fmla="*/ 864 h 1133"/>
                        <a:gd name="T16" fmla="*/ 165 w 2240"/>
                        <a:gd name="T17" fmla="*/ 940 h 1133"/>
                        <a:gd name="T18" fmla="*/ 185 w 2240"/>
                        <a:gd name="T19" fmla="*/ 995 h 1133"/>
                        <a:gd name="T20" fmla="*/ 204 w 2240"/>
                        <a:gd name="T21" fmla="*/ 1031 h 1133"/>
                        <a:gd name="T22" fmla="*/ 241 w 2240"/>
                        <a:gd name="T23" fmla="*/ 1067 h 1133"/>
                        <a:gd name="T24" fmla="*/ 285 w 2240"/>
                        <a:gd name="T25" fmla="*/ 1070 h 1133"/>
                        <a:gd name="T26" fmla="*/ 313 w 2240"/>
                        <a:gd name="T27" fmla="*/ 1052 h 1133"/>
                        <a:gd name="T28" fmla="*/ 341 w 2240"/>
                        <a:gd name="T29" fmla="*/ 1014 h 1133"/>
                        <a:gd name="T30" fmla="*/ 363 w 2240"/>
                        <a:gd name="T31" fmla="*/ 975 h 1133"/>
                        <a:gd name="T32" fmla="*/ 385 w 2240"/>
                        <a:gd name="T33" fmla="*/ 930 h 1133"/>
                        <a:gd name="T34" fmla="*/ 407 w 2240"/>
                        <a:gd name="T35" fmla="*/ 888 h 1133"/>
                        <a:gd name="T36" fmla="*/ 435 w 2240"/>
                        <a:gd name="T37" fmla="*/ 851 h 1133"/>
                        <a:gd name="T38" fmla="*/ 479 w 2240"/>
                        <a:gd name="T39" fmla="*/ 837 h 1133"/>
                        <a:gd name="T40" fmla="*/ 513 w 2240"/>
                        <a:gd name="T41" fmla="*/ 859 h 1133"/>
                        <a:gd name="T42" fmla="*/ 541 w 2240"/>
                        <a:gd name="T43" fmla="*/ 888 h 1133"/>
                        <a:gd name="T44" fmla="*/ 572 w 2240"/>
                        <a:gd name="T45" fmla="*/ 926 h 1133"/>
                        <a:gd name="T46" fmla="*/ 597 w 2240"/>
                        <a:gd name="T47" fmla="*/ 955 h 1133"/>
                        <a:gd name="T48" fmla="*/ 623 w 2240"/>
                        <a:gd name="T49" fmla="*/ 985 h 1133"/>
                        <a:gd name="T50" fmla="*/ 655 w 2240"/>
                        <a:gd name="T51" fmla="*/ 1017 h 1133"/>
                        <a:gd name="T52" fmla="*/ 701 w 2240"/>
                        <a:gd name="T53" fmla="*/ 1052 h 1133"/>
                        <a:gd name="T54" fmla="*/ 755 w 2240"/>
                        <a:gd name="T55" fmla="*/ 1065 h 1133"/>
                        <a:gd name="T56" fmla="*/ 802 w 2240"/>
                        <a:gd name="T57" fmla="*/ 1053 h 1133"/>
                        <a:gd name="T58" fmla="*/ 833 w 2240"/>
                        <a:gd name="T59" fmla="*/ 1035 h 1133"/>
                        <a:gd name="T60" fmla="*/ 867 w 2240"/>
                        <a:gd name="T61" fmla="*/ 1005 h 1133"/>
                        <a:gd name="T62" fmla="*/ 895 w 2240"/>
                        <a:gd name="T63" fmla="*/ 980 h 1133"/>
                        <a:gd name="T64" fmla="*/ 931 w 2240"/>
                        <a:gd name="T65" fmla="*/ 953 h 1133"/>
                        <a:gd name="T66" fmla="*/ 968 w 2240"/>
                        <a:gd name="T67" fmla="*/ 937 h 1133"/>
                        <a:gd name="T68" fmla="*/ 1015 w 2240"/>
                        <a:gd name="T69" fmla="*/ 946 h 1133"/>
                        <a:gd name="T70" fmla="*/ 1046 w 2240"/>
                        <a:gd name="T71" fmla="*/ 963 h 1133"/>
                        <a:gd name="T72" fmla="*/ 1078 w 2240"/>
                        <a:gd name="T73" fmla="*/ 986 h 1133"/>
                        <a:gd name="T74" fmla="*/ 1106 w 2240"/>
                        <a:gd name="T75" fmla="*/ 1008 h 1133"/>
                        <a:gd name="T76" fmla="*/ 1137 w 2240"/>
                        <a:gd name="T77" fmla="*/ 1031 h 1133"/>
                        <a:gd name="T78" fmla="*/ 1168 w 2240"/>
                        <a:gd name="T79" fmla="*/ 1051 h 1133"/>
                        <a:gd name="T80" fmla="*/ 1221 w 2240"/>
                        <a:gd name="T81" fmla="*/ 1069 h 1133"/>
                        <a:gd name="T82" fmla="*/ 1265 w 2240"/>
                        <a:gd name="T83" fmla="*/ 1075 h 1133"/>
                        <a:gd name="T84" fmla="*/ 1319 w 2240"/>
                        <a:gd name="T85" fmla="*/ 1072 h 1133"/>
                        <a:gd name="T86" fmla="*/ 1363 w 2240"/>
                        <a:gd name="T87" fmla="*/ 1061 h 1133"/>
                        <a:gd name="T88" fmla="*/ 1416 w 2240"/>
                        <a:gd name="T89" fmla="*/ 1052 h 1133"/>
                        <a:gd name="T90" fmla="*/ 1469 w 2240"/>
                        <a:gd name="T91" fmla="*/ 1053 h 1133"/>
                        <a:gd name="T92" fmla="*/ 1507 w 2240"/>
                        <a:gd name="T93" fmla="*/ 1062 h 1133"/>
                        <a:gd name="T94" fmla="*/ 1547 w 2240"/>
                        <a:gd name="T95" fmla="*/ 1078 h 1133"/>
                        <a:gd name="T96" fmla="*/ 1588 w 2240"/>
                        <a:gd name="T97" fmla="*/ 1093 h 1133"/>
                        <a:gd name="T98" fmla="*/ 1639 w 2240"/>
                        <a:gd name="T99" fmla="*/ 1107 h 1133"/>
                        <a:gd name="T100" fmla="*/ 1678 w 2240"/>
                        <a:gd name="T101" fmla="*/ 1116 h 1133"/>
                        <a:gd name="T102" fmla="*/ 1726 w 2240"/>
                        <a:gd name="T103" fmla="*/ 1121 h 1133"/>
                        <a:gd name="T104" fmla="*/ 1770 w 2240"/>
                        <a:gd name="T105" fmla="*/ 1125 h 1133"/>
                        <a:gd name="T106" fmla="*/ 1823 w 2240"/>
                        <a:gd name="T107" fmla="*/ 1125 h 1133"/>
                        <a:gd name="T108" fmla="*/ 1876 w 2240"/>
                        <a:gd name="T109" fmla="*/ 1125 h 1133"/>
                        <a:gd name="T110" fmla="*/ 1931 w 2240"/>
                        <a:gd name="T111" fmla="*/ 1124 h 1133"/>
                        <a:gd name="T112" fmla="*/ 1956 w 2240"/>
                        <a:gd name="T113" fmla="*/ 1123 h 1133"/>
                        <a:gd name="T114" fmla="*/ 2001 w 2240"/>
                        <a:gd name="T115" fmla="*/ 1126 h 1133"/>
                        <a:gd name="T116" fmla="*/ 2054 w 2240"/>
                        <a:gd name="T117" fmla="*/ 1128 h 1133"/>
                        <a:gd name="T118" fmla="*/ 2109 w 2240"/>
                        <a:gd name="T119" fmla="*/ 1129 h 1133"/>
                        <a:gd name="T120" fmla="*/ 2156 w 2240"/>
                        <a:gd name="T121" fmla="*/ 1130 h 1133"/>
                        <a:gd name="T122" fmla="*/ 2196 w 2240"/>
                        <a:gd name="T123" fmla="*/ 1132 h 1133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  <a:cxn ang="0">
                          <a:pos x="T12" y="T13"/>
                        </a:cxn>
                        <a:cxn ang="0">
                          <a:pos x="T14" y="T15"/>
                        </a:cxn>
                        <a:cxn ang="0">
                          <a:pos x="T16" y="T17"/>
                        </a:cxn>
                        <a:cxn ang="0">
                          <a:pos x="T18" y="T19"/>
                        </a:cxn>
                        <a:cxn ang="0">
                          <a:pos x="T20" y="T21"/>
                        </a:cxn>
                        <a:cxn ang="0">
                          <a:pos x="T22" y="T23"/>
                        </a:cxn>
                        <a:cxn ang="0">
                          <a:pos x="T24" y="T25"/>
                        </a:cxn>
                        <a:cxn ang="0">
                          <a:pos x="T26" y="T27"/>
                        </a:cxn>
                        <a:cxn ang="0">
                          <a:pos x="T28" y="T29"/>
                        </a:cxn>
                        <a:cxn ang="0">
                          <a:pos x="T30" y="T31"/>
                        </a:cxn>
                        <a:cxn ang="0">
                          <a:pos x="T32" y="T33"/>
                        </a:cxn>
                        <a:cxn ang="0">
                          <a:pos x="T34" y="T35"/>
                        </a:cxn>
                        <a:cxn ang="0">
                          <a:pos x="T36" y="T37"/>
                        </a:cxn>
                        <a:cxn ang="0">
                          <a:pos x="T38" y="T39"/>
                        </a:cxn>
                        <a:cxn ang="0">
                          <a:pos x="T40" y="T41"/>
                        </a:cxn>
                        <a:cxn ang="0">
                          <a:pos x="T42" y="T43"/>
                        </a:cxn>
                        <a:cxn ang="0">
                          <a:pos x="T44" y="T45"/>
                        </a:cxn>
                        <a:cxn ang="0">
                          <a:pos x="T46" y="T47"/>
                        </a:cxn>
                        <a:cxn ang="0">
                          <a:pos x="T48" y="T49"/>
                        </a:cxn>
                        <a:cxn ang="0">
                          <a:pos x="T50" y="T51"/>
                        </a:cxn>
                        <a:cxn ang="0">
                          <a:pos x="T52" y="T53"/>
                        </a:cxn>
                        <a:cxn ang="0">
                          <a:pos x="T54" y="T55"/>
                        </a:cxn>
                        <a:cxn ang="0">
                          <a:pos x="T56" y="T57"/>
                        </a:cxn>
                        <a:cxn ang="0">
                          <a:pos x="T58" y="T59"/>
                        </a:cxn>
                        <a:cxn ang="0">
                          <a:pos x="T60" y="T61"/>
                        </a:cxn>
                        <a:cxn ang="0">
                          <a:pos x="T62" y="T63"/>
                        </a:cxn>
                        <a:cxn ang="0">
                          <a:pos x="T64" y="T65"/>
                        </a:cxn>
                        <a:cxn ang="0">
                          <a:pos x="T66" y="T67"/>
                        </a:cxn>
                        <a:cxn ang="0">
                          <a:pos x="T68" y="T69"/>
                        </a:cxn>
                        <a:cxn ang="0">
                          <a:pos x="T70" y="T71"/>
                        </a:cxn>
                        <a:cxn ang="0">
                          <a:pos x="T72" y="T73"/>
                        </a:cxn>
                        <a:cxn ang="0">
                          <a:pos x="T74" y="T75"/>
                        </a:cxn>
                        <a:cxn ang="0">
                          <a:pos x="T76" y="T77"/>
                        </a:cxn>
                        <a:cxn ang="0">
                          <a:pos x="T78" y="T79"/>
                        </a:cxn>
                        <a:cxn ang="0">
                          <a:pos x="T80" y="T81"/>
                        </a:cxn>
                        <a:cxn ang="0">
                          <a:pos x="T82" y="T83"/>
                        </a:cxn>
                        <a:cxn ang="0">
                          <a:pos x="T84" y="T85"/>
                        </a:cxn>
                        <a:cxn ang="0">
                          <a:pos x="T86" y="T87"/>
                        </a:cxn>
                        <a:cxn ang="0">
                          <a:pos x="T88" y="T89"/>
                        </a:cxn>
                        <a:cxn ang="0">
                          <a:pos x="T90" y="T91"/>
                        </a:cxn>
                        <a:cxn ang="0">
                          <a:pos x="T92" y="T93"/>
                        </a:cxn>
                        <a:cxn ang="0">
                          <a:pos x="T94" y="T95"/>
                        </a:cxn>
                        <a:cxn ang="0">
                          <a:pos x="T96" y="T97"/>
                        </a:cxn>
                        <a:cxn ang="0">
                          <a:pos x="T98" y="T99"/>
                        </a:cxn>
                        <a:cxn ang="0">
                          <a:pos x="T100" y="T101"/>
                        </a:cxn>
                        <a:cxn ang="0">
                          <a:pos x="T102" y="T103"/>
                        </a:cxn>
                        <a:cxn ang="0">
                          <a:pos x="T104" y="T105"/>
                        </a:cxn>
                        <a:cxn ang="0">
                          <a:pos x="T106" y="T107"/>
                        </a:cxn>
                        <a:cxn ang="0">
                          <a:pos x="T108" y="T109"/>
                        </a:cxn>
                        <a:cxn ang="0">
                          <a:pos x="T110" y="T111"/>
                        </a:cxn>
                        <a:cxn ang="0">
                          <a:pos x="T112" y="T113"/>
                        </a:cxn>
                        <a:cxn ang="0">
                          <a:pos x="T114" y="T115"/>
                        </a:cxn>
                        <a:cxn ang="0">
                          <a:pos x="T116" y="T117"/>
                        </a:cxn>
                        <a:cxn ang="0">
                          <a:pos x="T118" y="T119"/>
                        </a:cxn>
                        <a:cxn ang="0">
                          <a:pos x="T120" y="T121"/>
                        </a:cxn>
                        <a:cxn ang="0">
                          <a:pos x="T122" y="T123"/>
                        </a:cxn>
                      </a:cxnLst>
                      <a:rect l="0" t="0" r="r" b="b"/>
                      <a:pathLst>
                        <a:path w="2240" h="1133">
                          <a:moveTo>
                            <a:pt x="0" y="0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  <a:lnTo>
                            <a:pt x="3" y="12"/>
                          </a:lnTo>
                          <a:lnTo>
                            <a:pt x="3" y="12"/>
                          </a:lnTo>
                          <a:lnTo>
                            <a:pt x="6" y="27"/>
                          </a:lnTo>
                          <a:lnTo>
                            <a:pt x="6" y="27"/>
                          </a:lnTo>
                          <a:lnTo>
                            <a:pt x="9" y="41"/>
                          </a:lnTo>
                          <a:lnTo>
                            <a:pt x="9" y="41"/>
                          </a:lnTo>
                          <a:lnTo>
                            <a:pt x="12" y="57"/>
                          </a:lnTo>
                          <a:lnTo>
                            <a:pt x="12" y="57"/>
                          </a:lnTo>
                          <a:lnTo>
                            <a:pt x="15" y="74"/>
                          </a:lnTo>
                          <a:lnTo>
                            <a:pt x="15" y="74"/>
                          </a:lnTo>
                          <a:lnTo>
                            <a:pt x="18" y="91"/>
                          </a:lnTo>
                          <a:lnTo>
                            <a:pt x="18" y="91"/>
                          </a:lnTo>
                          <a:lnTo>
                            <a:pt x="21" y="109"/>
                          </a:lnTo>
                          <a:lnTo>
                            <a:pt x="21" y="109"/>
                          </a:lnTo>
                          <a:lnTo>
                            <a:pt x="24" y="128"/>
                          </a:lnTo>
                          <a:lnTo>
                            <a:pt x="24" y="128"/>
                          </a:lnTo>
                          <a:lnTo>
                            <a:pt x="28" y="149"/>
                          </a:lnTo>
                          <a:lnTo>
                            <a:pt x="28" y="149"/>
                          </a:lnTo>
                          <a:lnTo>
                            <a:pt x="31" y="169"/>
                          </a:lnTo>
                          <a:lnTo>
                            <a:pt x="31" y="169"/>
                          </a:lnTo>
                          <a:lnTo>
                            <a:pt x="34" y="191"/>
                          </a:lnTo>
                          <a:lnTo>
                            <a:pt x="34" y="191"/>
                          </a:lnTo>
                          <a:lnTo>
                            <a:pt x="37" y="212"/>
                          </a:lnTo>
                          <a:lnTo>
                            <a:pt x="37" y="212"/>
                          </a:lnTo>
                          <a:lnTo>
                            <a:pt x="40" y="232"/>
                          </a:lnTo>
                          <a:lnTo>
                            <a:pt x="40" y="232"/>
                          </a:lnTo>
                          <a:lnTo>
                            <a:pt x="43" y="252"/>
                          </a:lnTo>
                          <a:lnTo>
                            <a:pt x="43" y="252"/>
                          </a:lnTo>
                          <a:lnTo>
                            <a:pt x="46" y="272"/>
                          </a:lnTo>
                          <a:lnTo>
                            <a:pt x="46" y="272"/>
                          </a:lnTo>
                          <a:lnTo>
                            <a:pt x="49" y="293"/>
                          </a:lnTo>
                          <a:lnTo>
                            <a:pt x="49" y="293"/>
                          </a:lnTo>
                          <a:lnTo>
                            <a:pt x="53" y="312"/>
                          </a:lnTo>
                          <a:lnTo>
                            <a:pt x="53" y="312"/>
                          </a:lnTo>
                          <a:lnTo>
                            <a:pt x="56" y="334"/>
                          </a:lnTo>
                          <a:lnTo>
                            <a:pt x="56" y="334"/>
                          </a:lnTo>
                          <a:lnTo>
                            <a:pt x="59" y="355"/>
                          </a:lnTo>
                          <a:lnTo>
                            <a:pt x="59" y="355"/>
                          </a:lnTo>
                          <a:lnTo>
                            <a:pt x="62" y="374"/>
                          </a:lnTo>
                          <a:lnTo>
                            <a:pt x="62" y="374"/>
                          </a:lnTo>
                          <a:lnTo>
                            <a:pt x="65" y="393"/>
                          </a:lnTo>
                          <a:lnTo>
                            <a:pt x="65" y="393"/>
                          </a:lnTo>
                          <a:lnTo>
                            <a:pt x="68" y="412"/>
                          </a:lnTo>
                          <a:lnTo>
                            <a:pt x="68" y="412"/>
                          </a:lnTo>
                          <a:lnTo>
                            <a:pt x="71" y="432"/>
                          </a:lnTo>
                          <a:lnTo>
                            <a:pt x="71" y="432"/>
                          </a:lnTo>
                          <a:lnTo>
                            <a:pt x="74" y="451"/>
                          </a:lnTo>
                          <a:lnTo>
                            <a:pt x="74" y="451"/>
                          </a:lnTo>
                          <a:lnTo>
                            <a:pt x="78" y="472"/>
                          </a:lnTo>
                          <a:lnTo>
                            <a:pt x="78" y="472"/>
                          </a:lnTo>
                          <a:lnTo>
                            <a:pt x="81" y="490"/>
                          </a:lnTo>
                          <a:lnTo>
                            <a:pt x="81" y="490"/>
                          </a:lnTo>
                          <a:lnTo>
                            <a:pt x="84" y="509"/>
                          </a:lnTo>
                          <a:lnTo>
                            <a:pt x="84" y="509"/>
                          </a:lnTo>
                          <a:lnTo>
                            <a:pt x="87" y="530"/>
                          </a:lnTo>
                          <a:lnTo>
                            <a:pt x="87" y="530"/>
                          </a:lnTo>
                          <a:lnTo>
                            <a:pt x="90" y="548"/>
                          </a:lnTo>
                          <a:lnTo>
                            <a:pt x="90" y="548"/>
                          </a:lnTo>
                          <a:lnTo>
                            <a:pt x="93" y="567"/>
                          </a:lnTo>
                          <a:lnTo>
                            <a:pt x="93" y="567"/>
                          </a:lnTo>
                          <a:lnTo>
                            <a:pt x="96" y="586"/>
                          </a:lnTo>
                          <a:lnTo>
                            <a:pt x="96" y="586"/>
                          </a:lnTo>
                          <a:lnTo>
                            <a:pt x="99" y="605"/>
                          </a:lnTo>
                          <a:lnTo>
                            <a:pt x="99" y="605"/>
                          </a:lnTo>
                          <a:lnTo>
                            <a:pt x="103" y="625"/>
                          </a:lnTo>
                          <a:lnTo>
                            <a:pt x="103" y="625"/>
                          </a:lnTo>
                          <a:lnTo>
                            <a:pt x="106" y="644"/>
                          </a:lnTo>
                          <a:lnTo>
                            <a:pt x="106" y="644"/>
                          </a:lnTo>
                          <a:lnTo>
                            <a:pt x="109" y="662"/>
                          </a:lnTo>
                          <a:lnTo>
                            <a:pt x="109" y="662"/>
                          </a:lnTo>
                          <a:lnTo>
                            <a:pt x="112" y="681"/>
                          </a:lnTo>
                          <a:lnTo>
                            <a:pt x="112" y="681"/>
                          </a:lnTo>
                          <a:lnTo>
                            <a:pt x="115" y="698"/>
                          </a:lnTo>
                          <a:lnTo>
                            <a:pt x="115" y="698"/>
                          </a:lnTo>
                          <a:lnTo>
                            <a:pt x="118" y="716"/>
                          </a:lnTo>
                          <a:lnTo>
                            <a:pt x="118" y="716"/>
                          </a:lnTo>
                          <a:lnTo>
                            <a:pt x="121" y="734"/>
                          </a:lnTo>
                          <a:lnTo>
                            <a:pt x="121" y="734"/>
                          </a:lnTo>
                          <a:lnTo>
                            <a:pt x="126" y="751"/>
                          </a:lnTo>
                          <a:lnTo>
                            <a:pt x="126" y="751"/>
                          </a:lnTo>
                          <a:lnTo>
                            <a:pt x="128" y="768"/>
                          </a:lnTo>
                          <a:lnTo>
                            <a:pt x="128" y="768"/>
                          </a:lnTo>
                          <a:lnTo>
                            <a:pt x="131" y="786"/>
                          </a:lnTo>
                          <a:lnTo>
                            <a:pt x="131" y="786"/>
                          </a:lnTo>
                          <a:lnTo>
                            <a:pt x="134" y="802"/>
                          </a:lnTo>
                          <a:lnTo>
                            <a:pt x="134" y="802"/>
                          </a:lnTo>
                          <a:lnTo>
                            <a:pt x="137" y="818"/>
                          </a:lnTo>
                          <a:lnTo>
                            <a:pt x="137" y="818"/>
                          </a:lnTo>
                          <a:lnTo>
                            <a:pt x="140" y="833"/>
                          </a:lnTo>
                          <a:lnTo>
                            <a:pt x="140" y="833"/>
                          </a:lnTo>
                          <a:lnTo>
                            <a:pt x="143" y="849"/>
                          </a:lnTo>
                          <a:lnTo>
                            <a:pt x="143" y="849"/>
                          </a:lnTo>
                          <a:lnTo>
                            <a:pt x="146" y="864"/>
                          </a:lnTo>
                          <a:lnTo>
                            <a:pt x="146" y="864"/>
                          </a:lnTo>
                          <a:lnTo>
                            <a:pt x="151" y="878"/>
                          </a:lnTo>
                          <a:lnTo>
                            <a:pt x="151" y="878"/>
                          </a:lnTo>
                          <a:lnTo>
                            <a:pt x="154" y="892"/>
                          </a:lnTo>
                          <a:lnTo>
                            <a:pt x="154" y="892"/>
                          </a:lnTo>
                          <a:lnTo>
                            <a:pt x="157" y="905"/>
                          </a:lnTo>
                          <a:lnTo>
                            <a:pt x="157" y="905"/>
                          </a:lnTo>
                          <a:lnTo>
                            <a:pt x="159" y="917"/>
                          </a:lnTo>
                          <a:lnTo>
                            <a:pt x="159" y="917"/>
                          </a:lnTo>
                          <a:lnTo>
                            <a:pt x="162" y="928"/>
                          </a:lnTo>
                          <a:lnTo>
                            <a:pt x="162" y="928"/>
                          </a:lnTo>
                          <a:lnTo>
                            <a:pt x="165" y="940"/>
                          </a:lnTo>
                          <a:lnTo>
                            <a:pt x="165" y="940"/>
                          </a:lnTo>
                          <a:lnTo>
                            <a:pt x="168" y="950"/>
                          </a:lnTo>
                          <a:lnTo>
                            <a:pt x="168" y="950"/>
                          </a:lnTo>
                          <a:lnTo>
                            <a:pt x="171" y="960"/>
                          </a:lnTo>
                          <a:lnTo>
                            <a:pt x="171" y="960"/>
                          </a:lnTo>
                          <a:lnTo>
                            <a:pt x="176" y="969"/>
                          </a:lnTo>
                          <a:lnTo>
                            <a:pt x="176" y="969"/>
                          </a:lnTo>
                          <a:lnTo>
                            <a:pt x="179" y="978"/>
                          </a:lnTo>
                          <a:lnTo>
                            <a:pt x="179" y="978"/>
                          </a:lnTo>
                          <a:lnTo>
                            <a:pt x="182" y="987"/>
                          </a:lnTo>
                          <a:lnTo>
                            <a:pt x="182" y="987"/>
                          </a:lnTo>
                          <a:lnTo>
                            <a:pt x="185" y="995"/>
                          </a:lnTo>
                          <a:lnTo>
                            <a:pt x="185" y="995"/>
                          </a:lnTo>
                          <a:lnTo>
                            <a:pt x="187" y="1002"/>
                          </a:lnTo>
                          <a:lnTo>
                            <a:pt x="187" y="1002"/>
                          </a:lnTo>
                          <a:lnTo>
                            <a:pt x="190" y="1009"/>
                          </a:lnTo>
                          <a:lnTo>
                            <a:pt x="190" y="1009"/>
                          </a:lnTo>
                          <a:lnTo>
                            <a:pt x="193" y="1016"/>
                          </a:lnTo>
                          <a:lnTo>
                            <a:pt x="193" y="1016"/>
                          </a:lnTo>
                          <a:lnTo>
                            <a:pt x="196" y="1021"/>
                          </a:lnTo>
                          <a:lnTo>
                            <a:pt x="196" y="1021"/>
                          </a:lnTo>
                          <a:lnTo>
                            <a:pt x="201" y="1026"/>
                          </a:lnTo>
                          <a:lnTo>
                            <a:pt x="201" y="1026"/>
                          </a:lnTo>
                          <a:lnTo>
                            <a:pt x="204" y="1031"/>
                          </a:lnTo>
                          <a:lnTo>
                            <a:pt x="207" y="1036"/>
                          </a:lnTo>
                          <a:lnTo>
                            <a:pt x="210" y="1040"/>
                          </a:lnTo>
                          <a:lnTo>
                            <a:pt x="210" y="1040"/>
                          </a:lnTo>
                          <a:lnTo>
                            <a:pt x="213" y="1044"/>
                          </a:lnTo>
                          <a:lnTo>
                            <a:pt x="213" y="1044"/>
                          </a:lnTo>
                          <a:lnTo>
                            <a:pt x="216" y="1048"/>
                          </a:lnTo>
                          <a:lnTo>
                            <a:pt x="218" y="1052"/>
                          </a:lnTo>
                          <a:lnTo>
                            <a:pt x="221" y="1054"/>
                          </a:lnTo>
                          <a:lnTo>
                            <a:pt x="229" y="1060"/>
                          </a:lnTo>
                          <a:lnTo>
                            <a:pt x="232" y="1062"/>
                          </a:lnTo>
                          <a:lnTo>
                            <a:pt x="238" y="1066"/>
                          </a:lnTo>
                          <a:lnTo>
                            <a:pt x="241" y="1067"/>
                          </a:lnTo>
                          <a:lnTo>
                            <a:pt x="241" y="1067"/>
                          </a:lnTo>
                          <a:lnTo>
                            <a:pt x="244" y="1070"/>
                          </a:lnTo>
                          <a:lnTo>
                            <a:pt x="246" y="1071"/>
                          </a:lnTo>
                          <a:lnTo>
                            <a:pt x="249" y="1071"/>
                          </a:lnTo>
                          <a:lnTo>
                            <a:pt x="254" y="1072"/>
                          </a:lnTo>
                          <a:lnTo>
                            <a:pt x="257" y="1072"/>
                          </a:lnTo>
                          <a:lnTo>
                            <a:pt x="263" y="1074"/>
                          </a:lnTo>
                          <a:lnTo>
                            <a:pt x="266" y="1074"/>
                          </a:lnTo>
                          <a:lnTo>
                            <a:pt x="272" y="1074"/>
                          </a:lnTo>
                          <a:lnTo>
                            <a:pt x="274" y="1072"/>
                          </a:lnTo>
                          <a:lnTo>
                            <a:pt x="282" y="1071"/>
                          </a:lnTo>
                          <a:lnTo>
                            <a:pt x="285" y="1070"/>
                          </a:lnTo>
                          <a:lnTo>
                            <a:pt x="285" y="1070"/>
                          </a:lnTo>
                          <a:lnTo>
                            <a:pt x="288" y="1069"/>
                          </a:lnTo>
                          <a:lnTo>
                            <a:pt x="291" y="1067"/>
                          </a:lnTo>
                          <a:lnTo>
                            <a:pt x="294" y="1066"/>
                          </a:lnTo>
                          <a:lnTo>
                            <a:pt x="297" y="1063"/>
                          </a:lnTo>
                          <a:lnTo>
                            <a:pt x="300" y="1061"/>
                          </a:lnTo>
                          <a:lnTo>
                            <a:pt x="300" y="1061"/>
                          </a:lnTo>
                          <a:lnTo>
                            <a:pt x="304" y="1060"/>
                          </a:lnTo>
                          <a:lnTo>
                            <a:pt x="307" y="1057"/>
                          </a:lnTo>
                          <a:lnTo>
                            <a:pt x="310" y="1054"/>
                          </a:lnTo>
                          <a:lnTo>
                            <a:pt x="310" y="1054"/>
                          </a:lnTo>
                          <a:lnTo>
                            <a:pt x="313" y="1052"/>
                          </a:lnTo>
                          <a:lnTo>
                            <a:pt x="316" y="1048"/>
                          </a:lnTo>
                          <a:lnTo>
                            <a:pt x="319" y="1045"/>
                          </a:lnTo>
                          <a:lnTo>
                            <a:pt x="322" y="1042"/>
                          </a:lnTo>
                          <a:lnTo>
                            <a:pt x="325" y="1038"/>
                          </a:lnTo>
                          <a:lnTo>
                            <a:pt x="325" y="1038"/>
                          </a:lnTo>
                          <a:lnTo>
                            <a:pt x="329" y="1034"/>
                          </a:lnTo>
                          <a:lnTo>
                            <a:pt x="329" y="1034"/>
                          </a:lnTo>
                          <a:lnTo>
                            <a:pt x="332" y="1030"/>
                          </a:lnTo>
                          <a:lnTo>
                            <a:pt x="335" y="1025"/>
                          </a:lnTo>
                          <a:lnTo>
                            <a:pt x="338" y="1020"/>
                          </a:lnTo>
                          <a:lnTo>
                            <a:pt x="338" y="1020"/>
                          </a:lnTo>
                          <a:lnTo>
                            <a:pt x="341" y="1014"/>
                          </a:lnTo>
                          <a:lnTo>
                            <a:pt x="344" y="1009"/>
                          </a:lnTo>
                          <a:lnTo>
                            <a:pt x="347" y="1004"/>
                          </a:lnTo>
                          <a:lnTo>
                            <a:pt x="347" y="1004"/>
                          </a:lnTo>
                          <a:lnTo>
                            <a:pt x="351" y="998"/>
                          </a:lnTo>
                          <a:lnTo>
                            <a:pt x="351" y="998"/>
                          </a:lnTo>
                          <a:lnTo>
                            <a:pt x="354" y="993"/>
                          </a:lnTo>
                          <a:lnTo>
                            <a:pt x="354" y="993"/>
                          </a:lnTo>
                          <a:lnTo>
                            <a:pt x="357" y="987"/>
                          </a:lnTo>
                          <a:lnTo>
                            <a:pt x="357" y="987"/>
                          </a:lnTo>
                          <a:lnTo>
                            <a:pt x="360" y="981"/>
                          </a:lnTo>
                          <a:lnTo>
                            <a:pt x="360" y="981"/>
                          </a:lnTo>
                          <a:lnTo>
                            <a:pt x="363" y="975"/>
                          </a:lnTo>
                          <a:lnTo>
                            <a:pt x="363" y="975"/>
                          </a:lnTo>
                          <a:lnTo>
                            <a:pt x="366" y="968"/>
                          </a:lnTo>
                          <a:lnTo>
                            <a:pt x="369" y="962"/>
                          </a:lnTo>
                          <a:lnTo>
                            <a:pt x="372" y="955"/>
                          </a:lnTo>
                          <a:lnTo>
                            <a:pt x="372" y="955"/>
                          </a:lnTo>
                          <a:lnTo>
                            <a:pt x="376" y="949"/>
                          </a:lnTo>
                          <a:lnTo>
                            <a:pt x="376" y="949"/>
                          </a:lnTo>
                          <a:lnTo>
                            <a:pt x="379" y="942"/>
                          </a:lnTo>
                          <a:lnTo>
                            <a:pt x="379" y="942"/>
                          </a:lnTo>
                          <a:lnTo>
                            <a:pt x="382" y="936"/>
                          </a:lnTo>
                          <a:lnTo>
                            <a:pt x="382" y="936"/>
                          </a:lnTo>
                          <a:lnTo>
                            <a:pt x="385" y="930"/>
                          </a:lnTo>
                          <a:lnTo>
                            <a:pt x="388" y="923"/>
                          </a:lnTo>
                          <a:lnTo>
                            <a:pt x="391" y="917"/>
                          </a:lnTo>
                          <a:lnTo>
                            <a:pt x="391" y="917"/>
                          </a:lnTo>
                          <a:lnTo>
                            <a:pt x="394" y="910"/>
                          </a:lnTo>
                          <a:lnTo>
                            <a:pt x="394" y="910"/>
                          </a:lnTo>
                          <a:lnTo>
                            <a:pt x="397" y="905"/>
                          </a:lnTo>
                          <a:lnTo>
                            <a:pt x="397" y="905"/>
                          </a:lnTo>
                          <a:lnTo>
                            <a:pt x="401" y="900"/>
                          </a:lnTo>
                          <a:lnTo>
                            <a:pt x="401" y="900"/>
                          </a:lnTo>
                          <a:lnTo>
                            <a:pt x="404" y="894"/>
                          </a:lnTo>
                          <a:lnTo>
                            <a:pt x="404" y="894"/>
                          </a:lnTo>
                          <a:lnTo>
                            <a:pt x="407" y="888"/>
                          </a:lnTo>
                          <a:lnTo>
                            <a:pt x="407" y="888"/>
                          </a:lnTo>
                          <a:lnTo>
                            <a:pt x="410" y="883"/>
                          </a:lnTo>
                          <a:lnTo>
                            <a:pt x="413" y="878"/>
                          </a:lnTo>
                          <a:lnTo>
                            <a:pt x="416" y="873"/>
                          </a:lnTo>
                          <a:lnTo>
                            <a:pt x="419" y="869"/>
                          </a:lnTo>
                          <a:lnTo>
                            <a:pt x="422" y="865"/>
                          </a:lnTo>
                          <a:lnTo>
                            <a:pt x="422" y="865"/>
                          </a:lnTo>
                          <a:lnTo>
                            <a:pt x="426" y="861"/>
                          </a:lnTo>
                          <a:lnTo>
                            <a:pt x="426" y="861"/>
                          </a:lnTo>
                          <a:lnTo>
                            <a:pt x="429" y="858"/>
                          </a:lnTo>
                          <a:lnTo>
                            <a:pt x="432" y="854"/>
                          </a:lnTo>
                          <a:lnTo>
                            <a:pt x="435" y="851"/>
                          </a:lnTo>
                          <a:lnTo>
                            <a:pt x="441" y="846"/>
                          </a:lnTo>
                          <a:lnTo>
                            <a:pt x="444" y="843"/>
                          </a:lnTo>
                          <a:lnTo>
                            <a:pt x="447" y="842"/>
                          </a:lnTo>
                          <a:lnTo>
                            <a:pt x="451" y="840"/>
                          </a:lnTo>
                          <a:lnTo>
                            <a:pt x="454" y="838"/>
                          </a:lnTo>
                          <a:lnTo>
                            <a:pt x="457" y="837"/>
                          </a:lnTo>
                          <a:lnTo>
                            <a:pt x="457" y="837"/>
                          </a:lnTo>
                          <a:lnTo>
                            <a:pt x="460" y="837"/>
                          </a:lnTo>
                          <a:lnTo>
                            <a:pt x="466" y="836"/>
                          </a:lnTo>
                          <a:lnTo>
                            <a:pt x="469" y="836"/>
                          </a:lnTo>
                          <a:lnTo>
                            <a:pt x="475" y="837"/>
                          </a:lnTo>
                          <a:lnTo>
                            <a:pt x="479" y="837"/>
                          </a:lnTo>
                          <a:lnTo>
                            <a:pt x="482" y="837"/>
                          </a:lnTo>
                          <a:lnTo>
                            <a:pt x="485" y="840"/>
                          </a:lnTo>
                          <a:lnTo>
                            <a:pt x="485" y="840"/>
                          </a:lnTo>
                          <a:lnTo>
                            <a:pt x="488" y="841"/>
                          </a:lnTo>
                          <a:lnTo>
                            <a:pt x="494" y="845"/>
                          </a:lnTo>
                          <a:lnTo>
                            <a:pt x="497" y="846"/>
                          </a:lnTo>
                          <a:lnTo>
                            <a:pt x="500" y="849"/>
                          </a:lnTo>
                          <a:lnTo>
                            <a:pt x="505" y="850"/>
                          </a:lnTo>
                          <a:lnTo>
                            <a:pt x="507" y="852"/>
                          </a:lnTo>
                          <a:lnTo>
                            <a:pt x="510" y="855"/>
                          </a:lnTo>
                          <a:lnTo>
                            <a:pt x="510" y="855"/>
                          </a:lnTo>
                          <a:lnTo>
                            <a:pt x="513" y="859"/>
                          </a:lnTo>
                          <a:lnTo>
                            <a:pt x="513" y="859"/>
                          </a:lnTo>
                          <a:lnTo>
                            <a:pt x="516" y="861"/>
                          </a:lnTo>
                          <a:lnTo>
                            <a:pt x="519" y="864"/>
                          </a:lnTo>
                          <a:lnTo>
                            <a:pt x="522" y="868"/>
                          </a:lnTo>
                          <a:lnTo>
                            <a:pt x="522" y="868"/>
                          </a:lnTo>
                          <a:lnTo>
                            <a:pt x="525" y="870"/>
                          </a:lnTo>
                          <a:lnTo>
                            <a:pt x="530" y="874"/>
                          </a:lnTo>
                          <a:lnTo>
                            <a:pt x="533" y="878"/>
                          </a:lnTo>
                          <a:lnTo>
                            <a:pt x="536" y="882"/>
                          </a:lnTo>
                          <a:lnTo>
                            <a:pt x="538" y="885"/>
                          </a:lnTo>
                          <a:lnTo>
                            <a:pt x="538" y="885"/>
                          </a:lnTo>
                          <a:lnTo>
                            <a:pt x="541" y="888"/>
                          </a:lnTo>
                          <a:lnTo>
                            <a:pt x="541" y="888"/>
                          </a:lnTo>
                          <a:lnTo>
                            <a:pt x="544" y="892"/>
                          </a:lnTo>
                          <a:lnTo>
                            <a:pt x="547" y="896"/>
                          </a:lnTo>
                          <a:lnTo>
                            <a:pt x="550" y="900"/>
                          </a:lnTo>
                          <a:lnTo>
                            <a:pt x="555" y="903"/>
                          </a:lnTo>
                          <a:lnTo>
                            <a:pt x="558" y="906"/>
                          </a:lnTo>
                          <a:lnTo>
                            <a:pt x="558" y="906"/>
                          </a:lnTo>
                          <a:lnTo>
                            <a:pt x="561" y="910"/>
                          </a:lnTo>
                          <a:lnTo>
                            <a:pt x="564" y="914"/>
                          </a:lnTo>
                          <a:lnTo>
                            <a:pt x="566" y="918"/>
                          </a:lnTo>
                          <a:lnTo>
                            <a:pt x="569" y="922"/>
                          </a:lnTo>
                          <a:lnTo>
                            <a:pt x="572" y="926"/>
                          </a:lnTo>
                          <a:lnTo>
                            <a:pt x="572" y="926"/>
                          </a:lnTo>
                          <a:lnTo>
                            <a:pt x="577" y="930"/>
                          </a:lnTo>
                          <a:lnTo>
                            <a:pt x="577" y="930"/>
                          </a:lnTo>
                          <a:lnTo>
                            <a:pt x="580" y="933"/>
                          </a:lnTo>
                          <a:lnTo>
                            <a:pt x="583" y="937"/>
                          </a:lnTo>
                          <a:lnTo>
                            <a:pt x="586" y="941"/>
                          </a:lnTo>
                          <a:lnTo>
                            <a:pt x="589" y="945"/>
                          </a:lnTo>
                          <a:lnTo>
                            <a:pt x="592" y="948"/>
                          </a:lnTo>
                          <a:lnTo>
                            <a:pt x="592" y="948"/>
                          </a:lnTo>
                          <a:lnTo>
                            <a:pt x="595" y="951"/>
                          </a:lnTo>
                          <a:lnTo>
                            <a:pt x="595" y="951"/>
                          </a:lnTo>
                          <a:lnTo>
                            <a:pt x="597" y="955"/>
                          </a:lnTo>
                          <a:lnTo>
                            <a:pt x="597" y="955"/>
                          </a:lnTo>
                          <a:lnTo>
                            <a:pt x="602" y="959"/>
                          </a:lnTo>
                          <a:lnTo>
                            <a:pt x="602" y="959"/>
                          </a:lnTo>
                          <a:lnTo>
                            <a:pt x="605" y="963"/>
                          </a:lnTo>
                          <a:lnTo>
                            <a:pt x="608" y="967"/>
                          </a:lnTo>
                          <a:lnTo>
                            <a:pt x="611" y="971"/>
                          </a:lnTo>
                          <a:lnTo>
                            <a:pt x="614" y="975"/>
                          </a:lnTo>
                          <a:lnTo>
                            <a:pt x="617" y="978"/>
                          </a:lnTo>
                          <a:lnTo>
                            <a:pt x="617" y="978"/>
                          </a:lnTo>
                          <a:lnTo>
                            <a:pt x="620" y="982"/>
                          </a:lnTo>
                          <a:lnTo>
                            <a:pt x="620" y="982"/>
                          </a:lnTo>
                          <a:lnTo>
                            <a:pt x="623" y="985"/>
                          </a:lnTo>
                          <a:lnTo>
                            <a:pt x="627" y="989"/>
                          </a:lnTo>
                          <a:lnTo>
                            <a:pt x="630" y="991"/>
                          </a:lnTo>
                          <a:lnTo>
                            <a:pt x="630" y="991"/>
                          </a:lnTo>
                          <a:lnTo>
                            <a:pt x="633" y="995"/>
                          </a:lnTo>
                          <a:lnTo>
                            <a:pt x="636" y="999"/>
                          </a:lnTo>
                          <a:lnTo>
                            <a:pt x="639" y="1002"/>
                          </a:lnTo>
                          <a:lnTo>
                            <a:pt x="642" y="1005"/>
                          </a:lnTo>
                          <a:lnTo>
                            <a:pt x="645" y="1008"/>
                          </a:lnTo>
                          <a:lnTo>
                            <a:pt x="645" y="1008"/>
                          </a:lnTo>
                          <a:lnTo>
                            <a:pt x="648" y="1011"/>
                          </a:lnTo>
                          <a:lnTo>
                            <a:pt x="652" y="1014"/>
                          </a:lnTo>
                          <a:lnTo>
                            <a:pt x="655" y="1017"/>
                          </a:lnTo>
                          <a:lnTo>
                            <a:pt x="661" y="1022"/>
                          </a:lnTo>
                          <a:lnTo>
                            <a:pt x="664" y="1025"/>
                          </a:lnTo>
                          <a:lnTo>
                            <a:pt x="670" y="1030"/>
                          </a:lnTo>
                          <a:lnTo>
                            <a:pt x="673" y="1033"/>
                          </a:lnTo>
                          <a:lnTo>
                            <a:pt x="680" y="1038"/>
                          </a:lnTo>
                          <a:lnTo>
                            <a:pt x="683" y="1039"/>
                          </a:lnTo>
                          <a:lnTo>
                            <a:pt x="689" y="1044"/>
                          </a:lnTo>
                          <a:lnTo>
                            <a:pt x="692" y="1045"/>
                          </a:lnTo>
                          <a:lnTo>
                            <a:pt x="692" y="1045"/>
                          </a:lnTo>
                          <a:lnTo>
                            <a:pt x="695" y="1048"/>
                          </a:lnTo>
                          <a:lnTo>
                            <a:pt x="698" y="1049"/>
                          </a:lnTo>
                          <a:lnTo>
                            <a:pt x="701" y="1052"/>
                          </a:lnTo>
                          <a:lnTo>
                            <a:pt x="705" y="1053"/>
                          </a:lnTo>
                          <a:lnTo>
                            <a:pt x="708" y="1054"/>
                          </a:lnTo>
                          <a:lnTo>
                            <a:pt x="714" y="1058"/>
                          </a:lnTo>
                          <a:lnTo>
                            <a:pt x="717" y="1058"/>
                          </a:lnTo>
                          <a:lnTo>
                            <a:pt x="723" y="1061"/>
                          </a:lnTo>
                          <a:lnTo>
                            <a:pt x="726" y="1062"/>
                          </a:lnTo>
                          <a:lnTo>
                            <a:pt x="733" y="1063"/>
                          </a:lnTo>
                          <a:lnTo>
                            <a:pt x="736" y="1063"/>
                          </a:lnTo>
                          <a:lnTo>
                            <a:pt x="742" y="1065"/>
                          </a:lnTo>
                          <a:lnTo>
                            <a:pt x="745" y="1065"/>
                          </a:lnTo>
                          <a:lnTo>
                            <a:pt x="751" y="1065"/>
                          </a:lnTo>
                          <a:lnTo>
                            <a:pt x="755" y="1065"/>
                          </a:lnTo>
                          <a:lnTo>
                            <a:pt x="758" y="1065"/>
                          </a:lnTo>
                          <a:lnTo>
                            <a:pt x="761" y="1065"/>
                          </a:lnTo>
                          <a:lnTo>
                            <a:pt x="767" y="1063"/>
                          </a:lnTo>
                          <a:lnTo>
                            <a:pt x="770" y="1063"/>
                          </a:lnTo>
                          <a:lnTo>
                            <a:pt x="776" y="1062"/>
                          </a:lnTo>
                          <a:lnTo>
                            <a:pt x="780" y="1061"/>
                          </a:lnTo>
                          <a:lnTo>
                            <a:pt x="786" y="1060"/>
                          </a:lnTo>
                          <a:lnTo>
                            <a:pt x="789" y="1058"/>
                          </a:lnTo>
                          <a:lnTo>
                            <a:pt x="795" y="1056"/>
                          </a:lnTo>
                          <a:lnTo>
                            <a:pt x="798" y="1054"/>
                          </a:lnTo>
                          <a:lnTo>
                            <a:pt x="798" y="1054"/>
                          </a:lnTo>
                          <a:lnTo>
                            <a:pt x="802" y="1053"/>
                          </a:lnTo>
                          <a:lnTo>
                            <a:pt x="802" y="1053"/>
                          </a:lnTo>
                          <a:lnTo>
                            <a:pt x="805" y="1052"/>
                          </a:lnTo>
                          <a:lnTo>
                            <a:pt x="811" y="1048"/>
                          </a:lnTo>
                          <a:lnTo>
                            <a:pt x="814" y="1047"/>
                          </a:lnTo>
                          <a:lnTo>
                            <a:pt x="814" y="1047"/>
                          </a:lnTo>
                          <a:lnTo>
                            <a:pt x="817" y="1045"/>
                          </a:lnTo>
                          <a:lnTo>
                            <a:pt x="820" y="1043"/>
                          </a:lnTo>
                          <a:lnTo>
                            <a:pt x="823" y="1042"/>
                          </a:lnTo>
                          <a:lnTo>
                            <a:pt x="828" y="1039"/>
                          </a:lnTo>
                          <a:lnTo>
                            <a:pt x="830" y="1036"/>
                          </a:lnTo>
                          <a:lnTo>
                            <a:pt x="830" y="1036"/>
                          </a:lnTo>
                          <a:lnTo>
                            <a:pt x="833" y="1035"/>
                          </a:lnTo>
                          <a:lnTo>
                            <a:pt x="836" y="1033"/>
                          </a:lnTo>
                          <a:lnTo>
                            <a:pt x="839" y="1030"/>
                          </a:lnTo>
                          <a:lnTo>
                            <a:pt x="839" y="1030"/>
                          </a:lnTo>
                          <a:lnTo>
                            <a:pt x="842" y="1026"/>
                          </a:lnTo>
                          <a:lnTo>
                            <a:pt x="845" y="1025"/>
                          </a:lnTo>
                          <a:lnTo>
                            <a:pt x="848" y="1022"/>
                          </a:lnTo>
                          <a:lnTo>
                            <a:pt x="848" y="1022"/>
                          </a:lnTo>
                          <a:lnTo>
                            <a:pt x="853" y="1020"/>
                          </a:lnTo>
                          <a:lnTo>
                            <a:pt x="856" y="1016"/>
                          </a:lnTo>
                          <a:lnTo>
                            <a:pt x="858" y="1013"/>
                          </a:lnTo>
                          <a:lnTo>
                            <a:pt x="864" y="1008"/>
                          </a:lnTo>
                          <a:lnTo>
                            <a:pt x="867" y="1005"/>
                          </a:lnTo>
                          <a:lnTo>
                            <a:pt x="870" y="1003"/>
                          </a:lnTo>
                          <a:lnTo>
                            <a:pt x="873" y="999"/>
                          </a:lnTo>
                          <a:lnTo>
                            <a:pt x="873" y="999"/>
                          </a:lnTo>
                          <a:lnTo>
                            <a:pt x="878" y="996"/>
                          </a:lnTo>
                          <a:lnTo>
                            <a:pt x="881" y="994"/>
                          </a:lnTo>
                          <a:lnTo>
                            <a:pt x="884" y="991"/>
                          </a:lnTo>
                          <a:lnTo>
                            <a:pt x="884" y="991"/>
                          </a:lnTo>
                          <a:lnTo>
                            <a:pt x="886" y="987"/>
                          </a:lnTo>
                          <a:lnTo>
                            <a:pt x="889" y="985"/>
                          </a:lnTo>
                          <a:lnTo>
                            <a:pt x="892" y="982"/>
                          </a:lnTo>
                          <a:lnTo>
                            <a:pt x="892" y="982"/>
                          </a:lnTo>
                          <a:lnTo>
                            <a:pt x="895" y="980"/>
                          </a:lnTo>
                          <a:lnTo>
                            <a:pt x="898" y="977"/>
                          </a:lnTo>
                          <a:lnTo>
                            <a:pt x="903" y="975"/>
                          </a:lnTo>
                          <a:lnTo>
                            <a:pt x="906" y="972"/>
                          </a:lnTo>
                          <a:lnTo>
                            <a:pt x="909" y="968"/>
                          </a:lnTo>
                          <a:lnTo>
                            <a:pt x="909" y="968"/>
                          </a:lnTo>
                          <a:lnTo>
                            <a:pt x="912" y="966"/>
                          </a:lnTo>
                          <a:lnTo>
                            <a:pt x="915" y="963"/>
                          </a:lnTo>
                          <a:lnTo>
                            <a:pt x="917" y="960"/>
                          </a:lnTo>
                          <a:lnTo>
                            <a:pt x="917" y="960"/>
                          </a:lnTo>
                          <a:lnTo>
                            <a:pt x="920" y="959"/>
                          </a:lnTo>
                          <a:lnTo>
                            <a:pt x="926" y="954"/>
                          </a:lnTo>
                          <a:lnTo>
                            <a:pt x="931" y="953"/>
                          </a:lnTo>
                          <a:lnTo>
                            <a:pt x="937" y="949"/>
                          </a:lnTo>
                          <a:lnTo>
                            <a:pt x="940" y="946"/>
                          </a:lnTo>
                          <a:lnTo>
                            <a:pt x="940" y="946"/>
                          </a:lnTo>
                          <a:lnTo>
                            <a:pt x="943" y="945"/>
                          </a:lnTo>
                          <a:lnTo>
                            <a:pt x="945" y="944"/>
                          </a:lnTo>
                          <a:lnTo>
                            <a:pt x="948" y="942"/>
                          </a:lnTo>
                          <a:lnTo>
                            <a:pt x="951" y="941"/>
                          </a:lnTo>
                          <a:lnTo>
                            <a:pt x="956" y="940"/>
                          </a:lnTo>
                          <a:lnTo>
                            <a:pt x="962" y="939"/>
                          </a:lnTo>
                          <a:lnTo>
                            <a:pt x="965" y="939"/>
                          </a:lnTo>
                          <a:lnTo>
                            <a:pt x="965" y="939"/>
                          </a:lnTo>
                          <a:lnTo>
                            <a:pt x="968" y="937"/>
                          </a:lnTo>
                          <a:lnTo>
                            <a:pt x="971" y="937"/>
                          </a:lnTo>
                          <a:lnTo>
                            <a:pt x="974" y="937"/>
                          </a:lnTo>
                          <a:lnTo>
                            <a:pt x="981" y="937"/>
                          </a:lnTo>
                          <a:lnTo>
                            <a:pt x="984" y="939"/>
                          </a:lnTo>
                          <a:lnTo>
                            <a:pt x="990" y="939"/>
                          </a:lnTo>
                          <a:lnTo>
                            <a:pt x="993" y="940"/>
                          </a:lnTo>
                          <a:lnTo>
                            <a:pt x="999" y="941"/>
                          </a:lnTo>
                          <a:lnTo>
                            <a:pt x="1002" y="941"/>
                          </a:lnTo>
                          <a:lnTo>
                            <a:pt x="1006" y="942"/>
                          </a:lnTo>
                          <a:lnTo>
                            <a:pt x="1009" y="944"/>
                          </a:lnTo>
                          <a:lnTo>
                            <a:pt x="1012" y="945"/>
                          </a:lnTo>
                          <a:lnTo>
                            <a:pt x="1015" y="946"/>
                          </a:lnTo>
                          <a:lnTo>
                            <a:pt x="1015" y="946"/>
                          </a:lnTo>
                          <a:lnTo>
                            <a:pt x="1018" y="948"/>
                          </a:lnTo>
                          <a:lnTo>
                            <a:pt x="1024" y="951"/>
                          </a:lnTo>
                          <a:lnTo>
                            <a:pt x="1028" y="953"/>
                          </a:lnTo>
                          <a:lnTo>
                            <a:pt x="1028" y="953"/>
                          </a:lnTo>
                          <a:lnTo>
                            <a:pt x="1031" y="954"/>
                          </a:lnTo>
                          <a:lnTo>
                            <a:pt x="1034" y="957"/>
                          </a:lnTo>
                          <a:lnTo>
                            <a:pt x="1037" y="958"/>
                          </a:lnTo>
                          <a:lnTo>
                            <a:pt x="1040" y="959"/>
                          </a:lnTo>
                          <a:lnTo>
                            <a:pt x="1043" y="962"/>
                          </a:lnTo>
                          <a:lnTo>
                            <a:pt x="1043" y="962"/>
                          </a:lnTo>
                          <a:lnTo>
                            <a:pt x="1046" y="963"/>
                          </a:lnTo>
                          <a:lnTo>
                            <a:pt x="1049" y="966"/>
                          </a:lnTo>
                          <a:lnTo>
                            <a:pt x="1053" y="967"/>
                          </a:lnTo>
                          <a:lnTo>
                            <a:pt x="1053" y="967"/>
                          </a:lnTo>
                          <a:lnTo>
                            <a:pt x="1056" y="969"/>
                          </a:lnTo>
                          <a:lnTo>
                            <a:pt x="1059" y="972"/>
                          </a:lnTo>
                          <a:lnTo>
                            <a:pt x="1062" y="973"/>
                          </a:lnTo>
                          <a:lnTo>
                            <a:pt x="1065" y="976"/>
                          </a:lnTo>
                          <a:lnTo>
                            <a:pt x="1068" y="978"/>
                          </a:lnTo>
                          <a:lnTo>
                            <a:pt x="1068" y="978"/>
                          </a:lnTo>
                          <a:lnTo>
                            <a:pt x="1071" y="981"/>
                          </a:lnTo>
                          <a:lnTo>
                            <a:pt x="1074" y="984"/>
                          </a:lnTo>
                          <a:lnTo>
                            <a:pt x="1078" y="986"/>
                          </a:lnTo>
                          <a:lnTo>
                            <a:pt x="1078" y="986"/>
                          </a:lnTo>
                          <a:lnTo>
                            <a:pt x="1081" y="989"/>
                          </a:lnTo>
                          <a:lnTo>
                            <a:pt x="1084" y="990"/>
                          </a:lnTo>
                          <a:lnTo>
                            <a:pt x="1087" y="993"/>
                          </a:lnTo>
                          <a:lnTo>
                            <a:pt x="1087" y="993"/>
                          </a:lnTo>
                          <a:lnTo>
                            <a:pt x="1090" y="995"/>
                          </a:lnTo>
                          <a:lnTo>
                            <a:pt x="1093" y="998"/>
                          </a:lnTo>
                          <a:lnTo>
                            <a:pt x="1096" y="1000"/>
                          </a:lnTo>
                          <a:lnTo>
                            <a:pt x="1096" y="1000"/>
                          </a:lnTo>
                          <a:lnTo>
                            <a:pt x="1099" y="1003"/>
                          </a:lnTo>
                          <a:lnTo>
                            <a:pt x="1103" y="1005"/>
                          </a:lnTo>
                          <a:lnTo>
                            <a:pt x="1106" y="1008"/>
                          </a:lnTo>
                          <a:lnTo>
                            <a:pt x="1112" y="1013"/>
                          </a:lnTo>
                          <a:lnTo>
                            <a:pt x="1115" y="1014"/>
                          </a:lnTo>
                          <a:lnTo>
                            <a:pt x="1115" y="1014"/>
                          </a:lnTo>
                          <a:lnTo>
                            <a:pt x="1118" y="1017"/>
                          </a:lnTo>
                          <a:lnTo>
                            <a:pt x="1121" y="1020"/>
                          </a:lnTo>
                          <a:lnTo>
                            <a:pt x="1124" y="1022"/>
                          </a:lnTo>
                          <a:lnTo>
                            <a:pt x="1124" y="1022"/>
                          </a:lnTo>
                          <a:lnTo>
                            <a:pt x="1128" y="1025"/>
                          </a:lnTo>
                          <a:lnTo>
                            <a:pt x="1131" y="1026"/>
                          </a:lnTo>
                          <a:lnTo>
                            <a:pt x="1134" y="1029"/>
                          </a:lnTo>
                          <a:lnTo>
                            <a:pt x="1134" y="1029"/>
                          </a:lnTo>
                          <a:lnTo>
                            <a:pt x="1137" y="1031"/>
                          </a:lnTo>
                          <a:lnTo>
                            <a:pt x="1140" y="1033"/>
                          </a:lnTo>
                          <a:lnTo>
                            <a:pt x="1143" y="1035"/>
                          </a:lnTo>
                          <a:lnTo>
                            <a:pt x="1146" y="1038"/>
                          </a:lnTo>
                          <a:lnTo>
                            <a:pt x="1149" y="1039"/>
                          </a:lnTo>
                          <a:lnTo>
                            <a:pt x="1149" y="1039"/>
                          </a:lnTo>
                          <a:lnTo>
                            <a:pt x="1152" y="1042"/>
                          </a:lnTo>
                          <a:lnTo>
                            <a:pt x="1156" y="1043"/>
                          </a:lnTo>
                          <a:lnTo>
                            <a:pt x="1159" y="1045"/>
                          </a:lnTo>
                          <a:lnTo>
                            <a:pt x="1159" y="1045"/>
                          </a:lnTo>
                          <a:lnTo>
                            <a:pt x="1162" y="1047"/>
                          </a:lnTo>
                          <a:lnTo>
                            <a:pt x="1165" y="1049"/>
                          </a:lnTo>
                          <a:lnTo>
                            <a:pt x="1168" y="1051"/>
                          </a:lnTo>
                          <a:lnTo>
                            <a:pt x="1174" y="1053"/>
                          </a:lnTo>
                          <a:lnTo>
                            <a:pt x="1177" y="1054"/>
                          </a:lnTo>
                          <a:lnTo>
                            <a:pt x="1184" y="1057"/>
                          </a:lnTo>
                          <a:lnTo>
                            <a:pt x="1187" y="1058"/>
                          </a:lnTo>
                          <a:lnTo>
                            <a:pt x="1193" y="1061"/>
                          </a:lnTo>
                          <a:lnTo>
                            <a:pt x="1196" y="1062"/>
                          </a:lnTo>
                          <a:lnTo>
                            <a:pt x="1202" y="1063"/>
                          </a:lnTo>
                          <a:lnTo>
                            <a:pt x="1207" y="1065"/>
                          </a:lnTo>
                          <a:lnTo>
                            <a:pt x="1209" y="1065"/>
                          </a:lnTo>
                          <a:lnTo>
                            <a:pt x="1212" y="1066"/>
                          </a:lnTo>
                          <a:lnTo>
                            <a:pt x="1218" y="1067"/>
                          </a:lnTo>
                          <a:lnTo>
                            <a:pt x="1221" y="1069"/>
                          </a:lnTo>
                          <a:lnTo>
                            <a:pt x="1224" y="1069"/>
                          </a:lnTo>
                          <a:lnTo>
                            <a:pt x="1227" y="1070"/>
                          </a:lnTo>
                          <a:lnTo>
                            <a:pt x="1227" y="1070"/>
                          </a:lnTo>
                          <a:lnTo>
                            <a:pt x="1232" y="1070"/>
                          </a:lnTo>
                          <a:lnTo>
                            <a:pt x="1237" y="1071"/>
                          </a:lnTo>
                          <a:lnTo>
                            <a:pt x="1240" y="1072"/>
                          </a:lnTo>
                          <a:lnTo>
                            <a:pt x="1246" y="1074"/>
                          </a:lnTo>
                          <a:lnTo>
                            <a:pt x="1249" y="1074"/>
                          </a:lnTo>
                          <a:lnTo>
                            <a:pt x="1254" y="1074"/>
                          </a:lnTo>
                          <a:lnTo>
                            <a:pt x="1257" y="1075"/>
                          </a:lnTo>
                          <a:lnTo>
                            <a:pt x="1263" y="1075"/>
                          </a:lnTo>
                          <a:lnTo>
                            <a:pt x="1265" y="1075"/>
                          </a:lnTo>
                          <a:lnTo>
                            <a:pt x="1271" y="1076"/>
                          </a:lnTo>
                          <a:lnTo>
                            <a:pt x="1274" y="1076"/>
                          </a:lnTo>
                          <a:lnTo>
                            <a:pt x="1282" y="1076"/>
                          </a:lnTo>
                          <a:lnTo>
                            <a:pt x="1285" y="1076"/>
                          </a:lnTo>
                          <a:lnTo>
                            <a:pt x="1291" y="1076"/>
                          </a:lnTo>
                          <a:lnTo>
                            <a:pt x="1294" y="1076"/>
                          </a:lnTo>
                          <a:lnTo>
                            <a:pt x="1299" y="1075"/>
                          </a:lnTo>
                          <a:lnTo>
                            <a:pt x="1304" y="1075"/>
                          </a:lnTo>
                          <a:lnTo>
                            <a:pt x="1307" y="1075"/>
                          </a:lnTo>
                          <a:lnTo>
                            <a:pt x="1310" y="1074"/>
                          </a:lnTo>
                          <a:lnTo>
                            <a:pt x="1316" y="1074"/>
                          </a:lnTo>
                          <a:lnTo>
                            <a:pt x="1319" y="1072"/>
                          </a:lnTo>
                          <a:lnTo>
                            <a:pt x="1324" y="1071"/>
                          </a:lnTo>
                          <a:lnTo>
                            <a:pt x="1329" y="1070"/>
                          </a:lnTo>
                          <a:lnTo>
                            <a:pt x="1332" y="1070"/>
                          </a:lnTo>
                          <a:lnTo>
                            <a:pt x="1335" y="1069"/>
                          </a:lnTo>
                          <a:lnTo>
                            <a:pt x="1335" y="1069"/>
                          </a:lnTo>
                          <a:lnTo>
                            <a:pt x="1338" y="1067"/>
                          </a:lnTo>
                          <a:lnTo>
                            <a:pt x="1344" y="1066"/>
                          </a:lnTo>
                          <a:lnTo>
                            <a:pt x="1347" y="1065"/>
                          </a:lnTo>
                          <a:lnTo>
                            <a:pt x="1350" y="1065"/>
                          </a:lnTo>
                          <a:lnTo>
                            <a:pt x="1354" y="1063"/>
                          </a:lnTo>
                          <a:lnTo>
                            <a:pt x="1360" y="1062"/>
                          </a:lnTo>
                          <a:lnTo>
                            <a:pt x="1363" y="1061"/>
                          </a:lnTo>
                          <a:lnTo>
                            <a:pt x="1369" y="1060"/>
                          </a:lnTo>
                          <a:lnTo>
                            <a:pt x="1372" y="1058"/>
                          </a:lnTo>
                          <a:lnTo>
                            <a:pt x="1378" y="1057"/>
                          </a:lnTo>
                          <a:lnTo>
                            <a:pt x="1382" y="1057"/>
                          </a:lnTo>
                          <a:lnTo>
                            <a:pt x="1388" y="1056"/>
                          </a:lnTo>
                          <a:lnTo>
                            <a:pt x="1391" y="1056"/>
                          </a:lnTo>
                          <a:lnTo>
                            <a:pt x="1397" y="1054"/>
                          </a:lnTo>
                          <a:lnTo>
                            <a:pt x="1400" y="1053"/>
                          </a:lnTo>
                          <a:lnTo>
                            <a:pt x="1403" y="1053"/>
                          </a:lnTo>
                          <a:lnTo>
                            <a:pt x="1407" y="1053"/>
                          </a:lnTo>
                          <a:lnTo>
                            <a:pt x="1413" y="1052"/>
                          </a:lnTo>
                          <a:lnTo>
                            <a:pt x="1416" y="1052"/>
                          </a:lnTo>
                          <a:lnTo>
                            <a:pt x="1422" y="1052"/>
                          </a:lnTo>
                          <a:lnTo>
                            <a:pt x="1425" y="1051"/>
                          </a:lnTo>
                          <a:lnTo>
                            <a:pt x="1432" y="1051"/>
                          </a:lnTo>
                          <a:lnTo>
                            <a:pt x="1435" y="1051"/>
                          </a:lnTo>
                          <a:lnTo>
                            <a:pt x="1441" y="1051"/>
                          </a:lnTo>
                          <a:lnTo>
                            <a:pt x="1444" y="1051"/>
                          </a:lnTo>
                          <a:lnTo>
                            <a:pt x="1450" y="1052"/>
                          </a:lnTo>
                          <a:lnTo>
                            <a:pt x="1453" y="1052"/>
                          </a:lnTo>
                          <a:lnTo>
                            <a:pt x="1457" y="1052"/>
                          </a:lnTo>
                          <a:lnTo>
                            <a:pt x="1460" y="1052"/>
                          </a:lnTo>
                          <a:lnTo>
                            <a:pt x="1466" y="1053"/>
                          </a:lnTo>
                          <a:lnTo>
                            <a:pt x="1469" y="1053"/>
                          </a:lnTo>
                          <a:lnTo>
                            <a:pt x="1469" y="1053"/>
                          </a:lnTo>
                          <a:lnTo>
                            <a:pt x="1472" y="1054"/>
                          </a:lnTo>
                          <a:lnTo>
                            <a:pt x="1475" y="1054"/>
                          </a:lnTo>
                          <a:lnTo>
                            <a:pt x="1479" y="1056"/>
                          </a:lnTo>
                          <a:lnTo>
                            <a:pt x="1485" y="1056"/>
                          </a:lnTo>
                          <a:lnTo>
                            <a:pt x="1488" y="1057"/>
                          </a:lnTo>
                          <a:lnTo>
                            <a:pt x="1494" y="1058"/>
                          </a:lnTo>
                          <a:lnTo>
                            <a:pt x="1497" y="1060"/>
                          </a:lnTo>
                          <a:lnTo>
                            <a:pt x="1500" y="1061"/>
                          </a:lnTo>
                          <a:lnTo>
                            <a:pt x="1504" y="1061"/>
                          </a:lnTo>
                          <a:lnTo>
                            <a:pt x="1504" y="1061"/>
                          </a:lnTo>
                          <a:lnTo>
                            <a:pt x="1507" y="1062"/>
                          </a:lnTo>
                          <a:lnTo>
                            <a:pt x="1510" y="1063"/>
                          </a:lnTo>
                          <a:lnTo>
                            <a:pt x="1513" y="1065"/>
                          </a:lnTo>
                          <a:lnTo>
                            <a:pt x="1519" y="1066"/>
                          </a:lnTo>
                          <a:lnTo>
                            <a:pt x="1522" y="1067"/>
                          </a:lnTo>
                          <a:lnTo>
                            <a:pt x="1525" y="1069"/>
                          </a:lnTo>
                          <a:lnTo>
                            <a:pt x="1529" y="1070"/>
                          </a:lnTo>
                          <a:lnTo>
                            <a:pt x="1529" y="1070"/>
                          </a:lnTo>
                          <a:lnTo>
                            <a:pt x="1532" y="1071"/>
                          </a:lnTo>
                          <a:lnTo>
                            <a:pt x="1538" y="1074"/>
                          </a:lnTo>
                          <a:lnTo>
                            <a:pt x="1541" y="1075"/>
                          </a:lnTo>
                          <a:lnTo>
                            <a:pt x="1544" y="1076"/>
                          </a:lnTo>
                          <a:lnTo>
                            <a:pt x="1547" y="1078"/>
                          </a:lnTo>
                          <a:lnTo>
                            <a:pt x="1547" y="1078"/>
                          </a:lnTo>
                          <a:lnTo>
                            <a:pt x="1550" y="1079"/>
                          </a:lnTo>
                          <a:lnTo>
                            <a:pt x="1555" y="1080"/>
                          </a:lnTo>
                          <a:lnTo>
                            <a:pt x="1557" y="1081"/>
                          </a:lnTo>
                          <a:lnTo>
                            <a:pt x="1563" y="1084"/>
                          </a:lnTo>
                          <a:lnTo>
                            <a:pt x="1566" y="1085"/>
                          </a:lnTo>
                          <a:lnTo>
                            <a:pt x="1572" y="1088"/>
                          </a:lnTo>
                          <a:lnTo>
                            <a:pt x="1575" y="1089"/>
                          </a:lnTo>
                          <a:lnTo>
                            <a:pt x="1583" y="1090"/>
                          </a:lnTo>
                          <a:lnTo>
                            <a:pt x="1586" y="1092"/>
                          </a:lnTo>
                          <a:lnTo>
                            <a:pt x="1586" y="1092"/>
                          </a:lnTo>
                          <a:lnTo>
                            <a:pt x="1588" y="1093"/>
                          </a:lnTo>
                          <a:lnTo>
                            <a:pt x="1591" y="1094"/>
                          </a:lnTo>
                          <a:lnTo>
                            <a:pt x="1594" y="1096"/>
                          </a:lnTo>
                          <a:lnTo>
                            <a:pt x="1600" y="1098"/>
                          </a:lnTo>
                          <a:lnTo>
                            <a:pt x="1603" y="1098"/>
                          </a:lnTo>
                          <a:lnTo>
                            <a:pt x="1608" y="1099"/>
                          </a:lnTo>
                          <a:lnTo>
                            <a:pt x="1611" y="1101"/>
                          </a:lnTo>
                          <a:lnTo>
                            <a:pt x="1616" y="1102"/>
                          </a:lnTo>
                          <a:lnTo>
                            <a:pt x="1619" y="1103"/>
                          </a:lnTo>
                          <a:lnTo>
                            <a:pt x="1625" y="1105"/>
                          </a:lnTo>
                          <a:lnTo>
                            <a:pt x="1628" y="1106"/>
                          </a:lnTo>
                          <a:lnTo>
                            <a:pt x="1636" y="1107"/>
                          </a:lnTo>
                          <a:lnTo>
                            <a:pt x="1639" y="1107"/>
                          </a:lnTo>
                          <a:lnTo>
                            <a:pt x="1639" y="1107"/>
                          </a:lnTo>
                          <a:lnTo>
                            <a:pt x="1642" y="1108"/>
                          </a:lnTo>
                          <a:lnTo>
                            <a:pt x="1644" y="1108"/>
                          </a:lnTo>
                          <a:lnTo>
                            <a:pt x="1647" y="1110"/>
                          </a:lnTo>
                          <a:lnTo>
                            <a:pt x="1653" y="1111"/>
                          </a:lnTo>
                          <a:lnTo>
                            <a:pt x="1658" y="1112"/>
                          </a:lnTo>
                          <a:lnTo>
                            <a:pt x="1661" y="1112"/>
                          </a:lnTo>
                          <a:lnTo>
                            <a:pt x="1664" y="1112"/>
                          </a:lnTo>
                          <a:lnTo>
                            <a:pt x="1670" y="1114"/>
                          </a:lnTo>
                          <a:lnTo>
                            <a:pt x="1673" y="1115"/>
                          </a:lnTo>
                          <a:lnTo>
                            <a:pt x="1675" y="1115"/>
                          </a:lnTo>
                          <a:lnTo>
                            <a:pt x="1678" y="1116"/>
                          </a:lnTo>
                          <a:lnTo>
                            <a:pt x="1678" y="1116"/>
                          </a:lnTo>
                          <a:lnTo>
                            <a:pt x="1683" y="1116"/>
                          </a:lnTo>
                          <a:lnTo>
                            <a:pt x="1689" y="1117"/>
                          </a:lnTo>
                          <a:lnTo>
                            <a:pt x="1692" y="1117"/>
                          </a:lnTo>
                          <a:lnTo>
                            <a:pt x="1698" y="1117"/>
                          </a:lnTo>
                          <a:lnTo>
                            <a:pt x="1701" y="1119"/>
                          </a:lnTo>
                          <a:lnTo>
                            <a:pt x="1705" y="1119"/>
                          </a:lnTo>
                          <a:lnTo>
                            <a:pt x="1708" y="1119"/>
                          </a:lnTo>
                          <a:lnTo>
                            <a:pt x="1714" y="1120"/>
                          </a:lnTo>
                          <a:lnTo>
                            <a:pt x="1717" y="1120"/>
                          </a:lnTo>
                          <a:lnTo>
                            <a:pt x="1723" y="1120"/>
                          </a:lnTo>
                          <a:lnTo>
                            <a:pt x="1726" y="1121"/>
                          </a:lnTo>
                          <a:lnTo>
                            <a:pt x="1733" y="1121"/>
                          </a:lnTo>
                          <a:lnTo>
                            <a:pt x="1736" y="1123"/>
                          </a:lnTo>
                          <a:lnTo>
                            <a:pt x="1742" y="1123"/>
                          </a:lnTo>
                          <a:lnTo>
                            <a:pt x="1745" y="1123"/>
                          </a:lnTo>
                          <a:lnTo>
                            <a:pt x="1748" y="1123"/>
                          </a:lnTo>
                          <a:lnTo>
                            <a:pt x="1751" y="1124"/>
                          </a:lnTo>
                          <a:lnTo>
                            <a:pt x="1751" y="1124"/>
                          </a:lnTo>
                          <a:lnTo>
                            <a:pt x="1755" y="1124"/>
                          </a:lnTo>
                          <a:lnTo>
                            <a:pt x="1758" y="1124"/>
                          </a:lnTo>
                          <a:lnTo>
                            <a:pt x="1761" y="1124"/>
                          </a:lnTo>
                          <a:lnTo>
                            <a:pt x="1767" y="1125"/>
                          </a:lnTo>
                          <a:lnTo>
                            <a:pt x="1770" y="1125"/>
                          </a:lnTo>
                          <a:lnTo>
                            <a:pt x="1776" y="1125"/>
                          </a:lnTo>
                          <a:lnTo>
                            <a:pt x="1780" y="1125"/>
                          </a:lnTo>
                          <a:lnTo>
                            <a:pt x="1786" y="1125"/>
                          </a:lnTo>
                          <a:lnTo>
                            <a:pt x="1789" y="1125"/>
                          </a:lnTo>
                          <a:lnTo>
                            <a:pt x="1795" y="1125"/>
                          </a:lnTo>
                          <a:lnTo>
                            <a:pt x="1798" y="1125"/>
                          </a:lnTo>
                          <a:lnTo>
                            <a:pt x="1801" y="1125"/>
                          </a:lnTo>
                          <a:lnTo>
                            <a:pt x="1805" y="1126"/>
                          </a:lnTo>
                          <a:lnTo>
                            <a:pt x="1811" y="1126"/>
                          </a:lnTo>
                          <a:lnTo>
                            <a:pt x="1814" y="1125"/>
                          </a:lnTo>
                          <a:lnTo>
                            <a:pt x="1820" y="1125"/>
                          </a:lnTo>
                          <a:lnTo>
                            <a:pt x="1823" y="1125"/>
                          </a:lnTo>
                          <a:lnTo>
                            <a:pt x="1829" y="1125"/>
                          </a:lnTo>
                          <a:lnTo>
                            <a:pt x="1833" y="1126"/>
                          </a:lnTo>
                          <a:lnTo>
                            <a:pt x="1839" y="1125"/>
                          </a:lnTo>
                          <a:lnTo>
                            <a:pt x="1842" y="1125"/>
                          </a:lnTo>
                          <a:lnTo>
                            <a:pt x="1848" y="1125"/>
                          </a:lnTo>
                          <a:lnTo>
                            <a:pt x="1851" y="1125"/>
                          </a:lnTo>
                          <a:lnTo>
                            <a:pt x="1854" y="1126"/>
                          </a:lnTo>
                          <a:lnTo>
                            <a:pt x="1858" y="1125"/>
                          </a:lnTo>
                          <a:lnTo>
                            <a:pt x="1864" y="1126"/>
                          </a:lnTo>
                          <a:lnTo>
                            <a:pt x="1867" y="1125"/>
                          </a:lnTo>
                          <a:lnTo>
                            <a:pt x="1873" y="1125"/>
                          </a:lnTo>
                          <a:lnTo>
                            <a:pt x="1876" y="1125"/>
                          </a:lnTo>
                          <a:lnTo>
                            <a:pt x="1883" y="1125"/>
                          </a:lnTo>
                          <a:lnTo>
                            <a:pt x="1886" y="1125"/>
                          </a:lnTo>
                          <a:lnTo>
                            <a:pt x="1892" y="1125"/>
                          </a:lnTo>
                          <a:lnTo>
                            <a:pt x="1895" y="1125"/>
                          </a:lnTo>
                          <a:lnTo>
                            <a:pt x="1901" y="1125"/>
                          </a:lnTo>
                          <a:lnTo>
                            <a:pt x="1904" y="1125"/>
                          </a:lnTo>
                          <a:lnTo>
                            <a:pt x="1908" y="1124"/>
                          </a:lnTo>
                          <a:lnTo>
                            <a:pt x="1911" y="1124"/>
                          </a:lnTo>
                          <a:lnTo>
                            <a:pt x="1917" y="1124"/>
                          </a:lnTo>
                          <a:lnTo>
                            <a:pt x="1920" y="1124"/>
                          </a:lnTo>
                          <a:lnTo>
                            <a:pt x="1926" y="1124"/>
                          </a:lnTo>
                          <a:lnTo>
                            <a:pt x="1931" y="1124"/>
                          </a:lnTo>
                          <a:lnTo>
                            <a:pt x="1936" y="1124"/>
                          </a:lnTo>
                          <a:lnTo>
                            <a:pt x="1939" y="1124"/>
                          </a:lnTo>
                          <a:lnTo>
                            <a:pt x="1939" y="1124"/>
                          </a:lnTo>
                          <a:lnTo>
                            <a:pt x="1942" y="1123"/>
                          </a:lnTo>
                          <a:lnTo>
                            <a:pt x="1942" y="1123"/>
                          </a:lnTo>
                          <a:lnTo>
                            <a:pt x="1945" y="1124"/>
                          </a:lnTo>
                          <a:lnTo>
                            <a:pt x="1945" y="1124"/>
                          </a:lnTo>
                          <a:lnTo>
                            <a:pt x="1948" y="1124"/>
                          </a:lnTo>
                          <a:lnTo>
                            <a:pt x="1948" y="1124"/>
                          </a:lnTo>
                          <a:lnTo>
                            <a:pt x="1951" y="1123"/>
                          </a:lnTo>
                          <a:lnTo>
                            <a:pt x="1951" y="1123"/>
                          </a:lnTo>
                          <a:lnTo>
                            <a:pt x="1956" y="1123"/>
                          </a:lnTo>
                          <a:lnTo>
                            <a:pt x="1956" y="1123"/>
                          </a:lnTo>
                          <a:lnTo>
                            <a:pt x="1959" y="1124"/>
                          </a:lnTo>
                          <a:lnTo>
                            <a:pt x="1962" y="1124"/>
                          </a:lnTo>
                          <a:lnTo>
                            <a:pt x="1965" y="1124"/>
                          </a:lnTo>
                          <a:lnTo>
                            <a:pt x="1970" y="1124"/>
                          </a:lnTo>
                          <a:lnTo>
                            <a:pt x="1973" y="1125"/>
                          </a:lnTo>
                          <a:lnTo>
                            <a:pt x="1981" y="1125"/>
                          </a:lnTo>
                          <a:lnTo>
                            <a:pt x="1984" y="1125"/>
                          </a:lnTo>
                          <a:lnTo>
                            <a:pt x="1990" y="1125"/>
                          </a:lnTo>
                          <a:lnTo>
                            <a:pt x="1993" y="1126"/>
                          </a:lnTo>
                          <a:lnTo>
                            <a:pt x="1998" y="1126"/>
                          </a:lnTo>
                          <a:lnTo>
                            <a:pt x="2001" y="1126"/>
                          </a:lnTo>
                          <a:lnTo>
                            <a:pt x="2006" y="1126"/>
                          </a:lnTo>
                          <a:lnTo>
                            <a:pt x="2009" y="1126"/>
                          </a:lnTo>
                          <a:lnTo>
                            <a:pt x="2015" y="1128"/>
                          </a:lnTo>
                          <a:lnTo>
                            <a:pt x="2018" y="1128"/>
                          </a:lnTo>
                          <a:lnTo>
                            <a:pt x="2023" y="1128"/>
                          </a:lnTo>
                          <a:lnTo>
                            <a:pt x="2026" y="1128"/>
                          </a:lnTo>
                          <a:lnTo>
                            <a:pt x="2034" y="1128"/>
                          </a:lnTo>
                          <a:lnTo>
                            <a:pt x="2037" y="1128"/>
                          </a:lnTo>
                          <a:lnTo>
                            <a:pt x="2043" y="1128"/>
                          </a:lnTo>
                          <a:lnTo>
                            <a:pt x="2046" y="1128"/>
                          </a:lnTo>
                          <a:lnTo>
                            <a:pt x="2052" y="1128"/>
                          </a:lnTo>
                          <a:lnTo>
                            <a:pt x="2054" y="1128"/>
                          </a:lnTo>
                          <a:lnTo>
                            <a:pt x="2059" y="1128"/>
                          </a:lnTo>
                          <a:lnTo>
                            <a:pt x="2062" y="1128"/>
                          </a:lnTo>
                          <a:lnTo>
                            <a:pt x="2068" y="1128"/>
                          </a:lnTo>
                          <a:lnTo>
                            <a:pt x="2071" y="1128"/>
                          </a:lnTo>
                          <a:lnTo>
                            <a:pt x="2077" y="1128"/>
                          </a:lnTo>
                          <a:lnTo>
                            <a:pt x="2080" y="1128"/>
                          </a:lnTo>
                          <a:lnTo>
                            <a:pt x="2087" y="1128"/>
                          </a:lnTo>
                          <a:lnTo>
                            <a:pt x="2090" y="1128"/>
                          </a:lnTo>
                          <a:lnTo>
                            <a:pt x="2096" y="1129"/>
                          </a:lnTo>
                          <a:lnTo>
                            <a:pt x="2099" y="1129"/>
                          </a:lnTo>
                          <a:lnTo>
                            <a:pt x="2105" y="1129"/>
                          </a:lnTo>
                          <a:lnTo>
                            <a:pt x="2109" y="1129"/>
                          </a:lnTo>
                          <a:lnTo>
                            <a:pt x="2112" y="1129"/>
                          </a:lnTo>
                          <a:lnTo>
                            <a:pt x="2115" y="1129"/>
                          </a:lnTo>
                          <a:lnTo>
                            <a:pt x="2121" y="1129"/>
                          </a:lnTo>
                          <a:lnTo>
                            <a:pt x="2124" y="1130"/>
                          </a:lnTo>
                          <a:lnTo>
                            <a:pt x="2130" y="1130"/>
                          </a:lnTo>
                          <a:lnTo>
                            <a:pt x="2134" y="1130"/>
                          </a:lnTo>
                          <a:lnTo>
                            <a:pt x="2140" y="1130"/>
                          </a:lnTo>
                          <a:lnTo>
                            <a:pt x="2143" y="1130"/>
                          </a:lnTo>
                          <a:lnTo>
                            <a:pt x="2149" y="1130"/>
                          </a:lnTo>
                          <a:lnTo>
                            <a:pt x="2152" y="1132"/>
                          </a:lnTo>
                          <a:lnTo>
                            <a:pt x="2152" y="1132"/>
                          </a:lnTo>
                          <a:lnTo>
                            <a:pt x="2156" y="1130"/>
                          </a:lnTo>
                          <a:lnTo>
                            <a:pt x="2156" y="1130"/>
                          </a:lnTo>
                          <a:lnTo>
                            <a:pt x="2159" y="1130"/>
                          </a:lnTo>
                          <a:lnTo>
                            <a:pt x="2159" y="1130"/>
                          </a:lnTo>
                          <a:lnTo>
                            <a:pt x="2162" y="1132"/>
                          </a:lnTo>
                          <a:lnTo>
                            <a:pt x="2165" y="1132"/>
                          </a:lnTo>
                          <a:lnTo>
                            <a:pt x="2168" y="1132"/>
                          </a:lnTo>
                          <a:lnTo>
                            <a:pt x="2174" y="1132"/>
                          </a:lnTo>
                          <a:lnTo>
                            <a:pt x="2177" y="1132"/>
                          </a:lnTo>
                          <a:lnTo>
                            <a:pt x="2184" y="1132"/>
                          </a:lnTo>
                          <a:lnTo>
                            <a:pt x="2187" y="1132"/>
                          </a:lnTo>
                          <a:lnTo>
                            <a:pt x="2193" y="1132"/>
                          </a:lnTo>
                          <a:lnTo>
                            <a:pt x="2196" y="1132"/>
                          </a:lnTo>
                          <a:lnTo>
                            <a:pt x="2202" y="1132"/>
                          </a:lnTo>
                          <a:lnTo>
                            <a:pt x="2206" y="1132"/>
                          </a:lnTo>
                          <a:lnTo>
                            <a:pt x="2209" y="1132"/>
                          </a:lnTo>
                          <a:lnTo>
                            <a:pt x="2212" y="1132"/>
                          </a:lnTo>
                          <a:lnTo>
                            <a:pt x="2218" y="1132"/>
                          </a:lnTo>
                          <a:lnTo>
                            <a:pt x="2221" y="1132"/>
                          </a:lnTo>
                          <a:lnTo>
                            <a:pt x="2227" y="1132"/>
                          </a:lnTo>
                          <a:lnTo>
                            <a:pt x="2231" y="1132"/>
                          </a:lnTo>
                          <a:lnTo>
                            <a:pt x="2237" y="1133"/>
                          </a:lnTo>
                          <a:lnTo>
                            <a:pt x="2240" y="1133"/>
                          </a:lnTo>
                        </a:path>
                      </a:pathLst>
                    </a:custGeom>
                    <a:noFill/>
                    <a:ln w="14288">
                      <a:solidFill>
                        <a:srgbClr val="FF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2" name="Freeform 30">
                      <a:extLst>
                        <a:ext uri="{FF2B5EF4-FFF2-40B4-BE49-F238E27FC236}">
                          <a16:creationId xmlns:a16="http://schemas.microsoft.com/office/drawing/2014/main" id="{D462FEC5-5293-4014-B6DA-72C38B0A311E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1314450" y="3570288"/>
                      <a:ext cx="1778000" cy="971550"/>
                    </a:xfrm>
                    <a:custGeom>
                      <a:avLst/>
                      <a:gdLst>
                        <a:gd name="T0" fmla="*/ 15 w 2240"/>
                        <a:gd name="T1" fmla="*/ 65 h 1224"/>
                        <a:gd name="T2" fmla="*/ 34 w 2240"/>
                        <a:gd name="T3" fmla="*/ 175 h 1224"/>
                        <a:gd name="T4" fmla="*/ 53 w 2240"/>
                        <a:gd name="T5" fmla="*/ 297 h 1224"/>
                        <a:gd name="T6" fmla="*/ 71 w 2240"/>
                        <a:gd name="T7" fmla="*/ 424 h 1224"/>
                        <a:gd name="T8" fmla="*/ 90 w 2240"/>
                        <a:gd name="T9" fmla="*/ 558 h 1224"/>
                        <a:gd name="T10" fmla="*/ 109 w 2240"/>
                        <a:gd name="T11" fmla="*/ 698 h 1224"/>
                        <a:gd name="T12" fmla="*/ 128 w 2240"/>
                        <a:gd name="T13" fmla="*/ 828 h 1224"/>
                        <a:gd name="T14" fmla="*/ 146 w 2240"/>
                        <a:gd name="T15" fmla="*/ 943 h 1224"/>
                        <a:gd name="T16" fmla="*/ 165 w 2240"/>
                        <a:gd name="T17" fmla="*/ 1031 h 1224"/>
                        <a:gd name="T18" fmla="*/ 185 w 2240"/>
                        <a:gd name="T19" fmla="*/ 1093 h 1224"/>
                        <a:gd name="T20" fmla="*/ 204 w 2240"/>
                        <a:gd name="T21" fmla="*/ 1132 h 1224"/>
                        <a:gd name="T22" fmla="*/ 241 w 2240"/>
                        <a:gd name="T23" fmla="*/ 1166 h 1224"/>
                        <a:gd name="T24" fmla="*/ 285 w 2240"/>
                        <a:gd name="T25" fmla="*/ 1153 h 1224"/>
                        <a:gd name="T26" fmla="*/ 310 w 2240"/>
                        <a:gd name="T27" fmla="*/ 1121 h 1224"/>
                        <a:gd name="T28" fmla="*/ 332 w 2240"/>
                        <a:gd name="T29" fmla="*/ 1076 h 1224"/>
                        <a:gd name="T30" fmla="*/ 351 w 2240"/>
                        <a:gd name="T31" fmla="*/ 1030 h 1224"/>
                        <a:gd name="T32" fmla="*/ 369 w 2240"/>
                        <a:gd name="T33" fmla="*/ 979 h 1224"/>
                        <a:gd name="T34" fmla="*/ 388 w 2240"/>
                        <a:gd name="T35" fmla="*/ 936 h 1224"/>
                        <a:gd name="T36" fmla="*/ 407 w 2240"/>
                        <a:gd name="T37" fmla="*/ 907 h 1224"/>
                        <a:gd name="T38" fmla="*/ 444 w 2240"/>
                        <a:gd name="T39" fmla="*/ 896 h 1224"/>
                        <a:gd name="T40" fmla="*/ 482 w 2240"/>
                        <a:gd name="T41" fmla="*/ 930 h 1224"/>
                        <a:gd name="T42" fmla="*/ 510 w 2240"/>
                        <a:gd name="T43" fmla="*/ 970 h 1224"/>
                        <a:gd name="T44" fmla="*/ 530 w 2240"/>
                        <a:gd name="T45" fmla="*/ 999 h 1224"/>
                        <a:gd name="T46" fmla="*/ 547 w 2240"/>
                        <a:gd name="T47" fmla="*/ 1030 h 1224"/>
                        <a:gd name="T48" fmla="*/ 572 w 2240"/>
                        <a:gd name="T49" fmla="*/ 1070 h 1224"/>
                        <a:gd name="T50" fmla="*/ 592 w 2240"/>
                        <a:gd name="T51" fmla="*/ 1099 h 1224"/>
                        <a:gd name="T52" fmla="*/ 614 w 2240"/>
                        <a:gd name="T53" fmla="*/ 1130 h 1224"/>
                        <a:gd name="T54" fmla="*/ 648 w 2240"/>
                        <a:gd name="T55" fmla="*/ 1166 h 1224"/>
                        <a:gd name="T56" fmla="*/ 683 w 2240"/>
                        <a:gd name="T57" fmla="*/ 1188 h 1224"/>
                        <a:gd name="T58" fmla="*/ 736 w 2240"/>
                        <a:gd name="T59" fmla="*/ 1195 h 1224"/>
                        <a:gd name="T60" fmla="*/ 770 w 2240"/>
                        <a:gd name="T61" fmla="*/ 1182 h 1224"/>
                        <a:gd name="T62" fmla="*/ 805 w 2240"/>
                        <a:gd name="T63" fmla="*/ 1159 h 1224"/>
                        <a:gd name="T64" fmla="*/ 842 w 2240"/>
                        <a:gd name="T65" fmla="*/ 1125 h 1224"/>
                        <a:gd name="T66" fmla="*/ 886 w 2240"/>
                        <a:gd name="T67" fmla="*/ 1092 h 1224"/>
                        <a:gd name="T68" fmla="*/ 920 w 2240"/>
                        <a:gd name="T69" fmla="*/ 1078 h 1224"/>
                        <a:gd name="T70" fmla="*/ 968 w 2240"/>
                        <a:gd name="T71" fmla="*/ 1085 h 1224"/>
                        <a:gd name="T72" fmla="*/ 1009 w 2240"/>
                        <a:gd name="T73" fmla="*/ 1106 h 1224"/>
                        <a:gd name="T74" fmla="*/ 1037 w 2240"/>
                        <a:gd name="T75" fmla="*/ 1128 h 1224"/>
                        <a:gd name="T76" fmla="*/ 1081 w 2240"/>
                        <a:gd name="T77" fmla="*/ 1160 h 1224"/>
                        <a:gd name="T78" fmla="*/ 1115 w 2240"/>
                        <a:gd name="T79" fmla="*/ 1182 h 1224"/>
                        <a:gd name="T80" fmla="*/ 1156 w 2240"/>
                        <a:gd name="T81" fmla="*/ 1200 h 1224"/>
                        <a:gd name="T82" fmla="*/ 1196 w 2240"/>
                        <a:gd name="T83" fmla="*/ 1208 h 1224"/>
                        <a:gd name="T84" fmla="*/ 1240 w 2240"/>
                        <a:gd name="T85" fmla="*/ 1205 h 1224"/>
                        <a:gd name="T86" fmla="*/ 1294 w 2240"/>
                        <a:gd name="T87" fmla="*/ 1195 h 1224"/>
                        <a:gd name="T88" fmla="*/ 1335 w 2240"/>
                        <a:gd name="T89" fmla="*/ 1183 h 1224"/>
                        <a:gd name="T90" fmla="*/ 1372 w 2240"/>
                        <a:gd name="T91" fmla="*/ 1174 h 1224"/>
                        <a:gd name="T92" fmla="*/ 1425 w 2240"/>
                        <a:gd name="T93" fmla="*/ 1170 h 1224"/>
                        <a:gd name="T94" fmla="*/ 1479 w 2240"/>
                        <a:gd name="T95" fmla="*/ 1175 h 1224"/>
                        <a:gd name="T96" fmla="*/ 1522 w 2240"/>
                        <a:gd name="T97" fmla="*/ 1188 h 1224"/>
                        <a:gd name="T98" fmla="*/ 1560 w 2240"/>
                        <a:gd name="T99" fmla="*/ 1200 h 1224"/>
                        <a:gd name="T100" fmla="*/ 1603 w 2240"/>
                        <a:gd name="T101" fmla="*/ 1214 h 1224"/>
                        <a:gd name="T102" fmla="*/ 1658 w 2240"/>
                        <a:gd name="T103" fmla="*/ 1223 h 1224"/>
                        <a:gd name="T104" fmla="*/ 1708 w 2240"/>
                        <a:gd name="T105" fmla="*/ 1224 h 1224"/>
                        <a:gd name="T106" fmla="*/ 1761 w 2240"/>
                        <a:gd name="T107" fmla="*/ 1223 h 1224"/>
                        <a:gd name="T108" fmla="*/ 1814 w 2240"/>
                        <a:gd name="T109" fmla="*/ 1218 h 1224"/>
                        <a:gd name="T110" fmla="*/ 1864 w 2240"/>
                        <a:gd name="T111" fmla="*/ 1214 h 1224"/>
                        <a:gd name="T112" fmla="*/ 1911 w 2240"/>
                        <a:gd name="T113" fmla="*/ 1213 h 1224"/>
                        <a:gd name="T114" fmla="*/ 1965 w 2240"/>
                        <a:gd name="T115" fmla="*/ 1214 h 1224"/>
                        <a:gd name="T116" fmla="*/ 2001 w 2240"/>
                        <a:gd name="T117" fmla="*/ 1217 h 1224"/>
                        <a:gd name="T118" fmla="*/ 2054 w 2240"/>
                        <a:gd name="T119" fmla="*/ 1220 h 1224"/>
                        <a:gd name="T120" fmla="*/ 2109 w 2240"/>
                        <a:gd name="T121" fmla="*/ 1224 h 1224"/>
                        <a:gd name="T122" fmla="*/ 2152 w 2240"/>
                        <a:gd name="T123" fmla="*/ 1222 h 1224"/>
                        <a:gd name="T124" fmla="*/ 2206 w 2240"/>
                        <a:gd name="T125" fmla="*/ 1218 h 1224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  <a:cxn ang="0">
                          <a:pos x="T12" y="T13"/>
                        </a:cxn>
                        <a:cxn ang="0">
                          <a:pos x="T14" y="T15"/>
                        </a:cxn>
                        <a:cxn ang="0">
                          <a:pos x="T16" y="T17"/>
                        </a:cxn>
                        <a:cxn ang="0">
                          <a:pos x="T18" y="T19"/>
                        </a:cxn>
                        <a:cxn ang="0">
                          <a:pos x="T20" y="T21"/>
                        </a:cxn>
                        <a:cxn ang="0">
                          <a:pos x="T22" y="T23"/>
                        </a:cxn>
                        <a:cxn ang="0">
                          <a:pos x="T24" y="T25"/>
                        </a:cxn>
                        <a:cxn ang="0">
                          <a:pos x="T26" y="T27"/>
                        </a:cxn>
                        <a:cxn ang="0">
                          <a:pos x="T28" y="T29"/>
                        </a:cxn>
                        <a:cxn ang="0">
                          <a:pos x="T30" y="T31"/>
                        </a:cxn>
                        <a:cxn ang="0">
                          <a:pos x="T32" y="T33"/>
                        </a:cxn>
                        <a:cxn ang="0">
                          <a:pos x="T34" y="T35"/>
                        </a:cxn>
                        <a:cxn ang="0">
                          <a:pos x="T36" y="T37"/>
                        </a:cxn>
                        <a:cxn ang="0">
                          <a:pos x="T38" y="T39"/>
                        </a:cxn>
                        <a:cxn ang="0">
                          <a:pos x="T40" y="T41"/>
                        </a:cxn>
                        <a:cxn ang="0">
                          <a:pos x="T42" y="T43"/>
                        </a:cxn>
                        <a:cxn ang="0">
                          <a:pos x="T44" y="T45"/>
                        </a:cxn>
                        <a:cxn ang="0">
                          <a:pos x="T46" y="T47"/>
                        </a:cxn>
                        <a:cxn ang="0">
                          <a:pos x="T48" y="T49"/>
                        </a:cxn>
                        <a:cxn ang="0">
                          <a:pos x="T50" y="T51"/>
                        </a:cxn>
                        <a:cxn ang="0">
                          <a:pos x="T52" y="T53"/>
                        </a:cxn>
                        <a:cxn ang="0">
                          <a:pos x="T54" y="T55"/>
                        </a:cxn>
                        <a:cxn ang="0">
                          <a:pos x="T56" y="T57"/>
                        </a:cxn>
                        <a:cxn ang="0">
                          <a:pos x="T58" y="T59"/>
                        </a:cxn>
                        <a:cxn ang="0">
                          <a:pos x="T60" y="T61"/>
                        </a:cxn>
                        <a:cxn ang="0">
                          <a:pos x="T62" y="T63"/>
                        </a:cxn>
                        <a:cxn ang="0">
                          <a:pos x="T64" y="T65"/>
                        </a:cxn>
                        <a:cxn ang="0">
                          <a:pos x="T66" y="T67"/>
                        </a:cxn>
                        <a:cxn ang="0">
                          <a:pos x="T68" y="T69"/>
                        </a:cxn>
                        <a:cxn ang="0">
                          <a:pos x="T70" y="T71"/>
                        </a:cxn>
                        <a:cxn ang="0">
                          <a:pos x="T72" y="T73"/>
                        </a:cxn>
                        <a:cxn ang="0">
                          <a:pos x="T74" y="T75"/>
                        </a:cxn>
                        <a:cxn ang="0">
                          <a:pos x="T76" y="T77"/>
                        </a:cxn>
                        <a:cxn ang="0">
                          <a:pos x="T78" y="T79"/>
                        </a:cxn>
                        <a:cxn ang="0">
                          <a:pos x="T80" y="T81"/>
                        </a:cxn>
                        <a:cxn ang="0">
                          <a:pos x="T82" y="T83"/>
                        </a:cxn>
                        <a:cxn ang="0">
                          <a:pos x="T84" y="T85"/>
                        </a:cxn>
                        <a:cxn ang="0">
                          <a:pos x="T86" y="T87"/>
                        </a:cxn>
                        <a:cxn ang="0">
                          <a:pos x="T88" y="T89"/>
                        </a:cxn>
                        <a:cxn ang="0">
                          <a:pos x="T90" y="T91"/>
                        </a:cxn>
                        <a:cxn ang="0">
                          <a:pos x="T92" y="T93"/>
                        </a:cxn>
                        <a:cxn ang="0">
                          <a:pos x="T94" y="T95"/>
                        </a:cxn>
                        <a:cxn ang="0">
                          <a:pos x="T96" y="T97"/>
                        </a:cxn>
                        <a:cxn ang="0">
                          <a:pos x="T98" y="T99"/>
                        </a:cxn>
                        <a:cxn ang="0">
                          <a:pos x="T100" y="T101"/>
                        </a:cxn>
                        <a:cxn ang="0">
                          <a:pos x="T102" y="T103"/>
                        </a:cxn>
                        <a:cxn ang="0">
                          <a:pos x="T104" y="T105"/>
                        </a:cxn>
                        <a:cxn ang="0">
                          <a:pos x="T106" y="T107"/>
                        </a:cxn>
                        <a:cxn ang="0">
                          <a:pos x="T108" y="T109"/>
                        </a:cxn>
                        <a:cxn ang="0">
                          <a:pos x="T110" y="T111"/>
                        </a:cxn>
                        <a:cxn ang="0">
                          <a:pos x="T112" y="T113"/>
                        </a:cxn>
                        <a:cxn ang="0">
                          <a:pos x="T114" y="T115"/>
                        </a:cxn>
                        <a:cxn ang="0">
                          <a:pos x="T116" y="T117"/>
                        </a:cxn>
                        <a:cxn ang="0">
                          <a:pos x="T118" y="T119"/>
                        </a:cxn>
                        <a:cxn ang="0">
                          <a:pos x="T120" y="T121"/>
                        </a:cxn>
                        <a:cxn ang="0">
                          <a:pos x="T122" y="T123"/>
                        </a:cxn>
                        <a:cxn ang="0">
                          <a:pos x="T124" y="T125"/>
                        </a:cxn>
                      </a:cxnLst>
                      <a:rect l="0" t="0" r="r" b="b"/>
                      <a:pathLst>
                        <a:path w="2240" h="1224">
                          <a:moveTo>
                            <a:pt x="0" y="0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  <a:lnTo>
                            <a:pt x="3" y="11"/>
                          </a:lnTo>
                          <a:lnTo>
                            <a:pt x="3" y="11"/>
                          </a:lnTo>
                          <a:lnTo>
                            <a:pt x="6" y="23"/>
                          </a:lnTo>
                          <a:lnTo>
                            <a:pt x="6" y="23"/>
                          </a:lnTo>
                          <a:lnTo>
                            <a:pt x="9" y="36"/>
                          </a:lnTo>
                          <a:lnTo>
                            <a:pt x="9" y="36"/>
                          </a:lnTo>
                          <a:lnTo>
                            <a:pt x="12" y="50"/>
                          </a:lnTo>
                          <a:lnTo>
                            <a:pt x="12" y="50"/>
                          </a:lnTo>
                          <a:lnTo>
                            <a:pt x="15" y="65"/>
                          </a:lnTo>
                          <a:lnTo>
                            <a:pt x="15" y="65"/>
                          </a:lnTo>
                          <a:lnTo>
                            <a:pt x="18" y="81"/>
                          </a:lnTo>
                          <a:lnTo>
                            <a:pt x="18" y="81"/>
                          </a:lnTo>
                          <a:lnTo>
                            <a:pt x="21" y="97"/>
                          </a:lnTo>
                          <a:lnTo>
                            <a:pt x="21" y="97"/>
                          </a:lnTo>
                          <a:lnTo>
                            <a:pt x="24" y="117"/>
                          </a:lnTo>
                          <a:lnTo>
                            <a:pt x="24" y="117"/>
                          </a:lnTo>
                          <a:lnTo>
                            <a:pt x="28" y="135"/>
                          </a:lnTo>
                          <a:lnTo>
                            <a:pt x="28" y="135"/>
                          </a:lnTo>
                          <a:lnTo>
                            <a:pt x="31" y="154"/>
                          </a:lnTo>
                          <a:lnTo>
                            <a:pt x="31" y="154"/>
                          </a:lnTo>
                          <a:lnTo>
                            <a:pt x="34" y="175"/>
                          </a:lnTo>
                          <a:lnTo>
                            <a:pt x="34" y="175"/>
                          </a:lnTo>
                          <a:lnTo>
                            <a:pt x="37" y="194"/>
                          </a:lnTo>
                          <a:lnTo>
                            <a:pt x="37" y="194"/>
                          </a:lnTo>
                          <a:lnTo>
                            <a:pt x="40" y="213"/>
                          </a:lnTo>
                          <a:lnTo>
                            <a:pt x="40" y="213"/>
                          </a:lnTo>
                          <a:lnTo>
                            <a:pt x="43" y="234"/>
                          </a:lnTo>
                          <a:lnTo>
                            <a:pt x="43" y="234"/>
                          </a:lnTo>
                          <a:lnTo>
                            <a:pt x="46" y="254"/>
                          </a:lnTo>
                          <a:lnTo>
                            <a:pt x="46" y="254"/>
                          </a:lnTo>
                          <a:lnTo>
                            <a:pt x="49" y="275"/>
                          </a:lnTo>
                          <a:lnTo>
                            <a:pt x="49" y="275"/>
                          </a:lnTo>
                          <a:lnTo>
                            <a:pt x="53" y="297"/>
                          </a:lnTo>
                          <a:lnTo>
                            <a:pt x="53" y="297"/>
                          </a:lnTo>
                          <a:lnTo>
                            <a:pt x="56" y="319"/>
                          </a:lnTo>
                          <a:lnTo>
                            <a:pt x="56" y="319"/>
                          </a:lnTo>
                          <a:lnTo>
                            <a:pt x="59" y="339"/>
                          </a:lnTo>
                          <a:lnTo>
                            <a:pt x="59" y="339"/>
                          </a:lnTo>
                          <a:lnTo>
                            <a:pt x="62" y="360"/>
                          </a:lnTo>
                          <a:lnTo>
                            <a:pt x="62" y="360"/>
                          </a:lnTo>
                          <a:lnTo>
                            <a:pt x="65" y="382"/>
                          </a:lnTo>
                          <a:lnTo>
                            <a:pt x="65" y="382"/>
                          </a:lnTo>
                          <a:lnTo>
                            <a:pt x="68" y="402"/>
                          </a:lnTo>
                          <a:lnTo>
                            <a:pt x="68" y="402"/>
                          </a:lnTo>
                          <a:lnTo>
                            <a:pt x="71" y="424"/>
                          </a:lnTo>
                          <a:lnTo>
                            <a:pt x="71" y="424"/>
                          </a:lnTo>
                          <a:lnTo>
                            <a:pt x="74" y="447"/>
                          </a:lnTo>
                          <a:lnTo>
                            <a:pt x="74" y="447"/>
                          </a:lnTo>
                          <a:lnTo>
                            <a:pt x="78" y="470"/>
                          </a:lnTo>
                          <a:lnTo>
                            <a:pt x="78" y="470"/>
                          </a:lnTo>
                          <a:lnTo>
                            <a:pt x="81" y="491"/>
                          </a:lnTo>
                          <a:lnTo>
                            <a:pt x="81" y="491"/>
                          </a:lnTo>
                          <a:lnTo>
                            <a:pt x="84" y="514"/>
                          </a:lnTo>
                          <a:lnTo>
                            <a:pt x="84" y="514"/>
                          </a:lnTo>
                          <a:lnTo>
                            <a:pt x="87" y="536"/>
                          </a:lnTo>
                          <a:lnTo>
                            <a:pt x="87" y="536"/>
                          </a:lnTo>
                          <a:lnTo>
                            <a:pt x="90" y="558"/>
                          </a:lnTo>
                          <a:lnTo>
                            <a:pt x="90" y="558"/>
                          </a:lnTo>
                          <a:lnTo>
                            <a:pt x="93" y="581"/>
                          </a:lnTo>
                          <a:lnTo>
                            <a:pt x="93" y="581"/>
                          </a:lnTo>
                          <a:lnTo>
                            <a:pt x="96" y="604"/>
                          </a:lnTo>
                          <a:lnTo>
                            <a:pt x="96" y="604"/>
                          </a:lnTo>
                          <a:lnTo>
                            <a:pt x="99" y="629"/>
                          </a:lnTo>
                          <a:lnTo>
                            <a:pt x="99" y="629"/>
                          </a:lnTo>
                          <a:lnTo>
                            <a:pt x="103" y="653"/>
                          </a:lnTo>
                          <a:lnTo>
                            <a:pt x="103" y="653"/>
                          </a:lnTo>
                          <a:lnTo>
                            <a:pt x="106" y="676"/>
                          </a:lnTo>
                          <a:lnTo>
                            <a:pt x="106" y="676"/>
                          </a:lnTo>
                          <a:lnTo>
                            <a:pt x="109" y="698"/>
                          </a:lnTo>
                          <a:lnTo>
                            <a:pt x="109" y="698"/>
                          </a:lnTo>
                          <a:lnTo>
                            <a:pt x="112" y="720"/>
                          </a:lnTo>
                          <a:lnTo>
                            <a:pt x="112" y="720"/>
                          </a:lnTo>
                          <a:lnTo>
                            <a:pt x="115" y="742"/>
                          </a:lnTo>
                          <a:lnTo>
                            <a:pt x="115" y="742"/>
                          </a:lnTo>
                          <a:lnTo>
                            <a:pt x="118" y="764"/>
                          </a:lnTo>
                          <a:lnTo>
                            <a:pt x="118" y="764"/>
                          </a:lnTo>
                          <a:lnTo>
                            <a:pt x="121" y="786"/>
                          </a:lnTo>
                          <a:lnTo>
                            <a:pt x="121" y="786"/>
                          </a:lnTo>
                          <a:lnTo>
                            <a:pt x="126" y="807"/>
                          </a:lnTo>
                          <a:lnTo>
                            <a:pt x="126" y="807"/>
                          </a:lnTo>
                          <a:lnTo>
                            <a:pt x="128" y="828"/>
                          </a:lnTo>
                          <a:lnTo>
                            <a:pt x="128" y="828"/>
                          </a:lnTo>
                          <a:lnTo>
                            <a:pt x="131" y="849"/>
                          </a:lnTo>
                          <a:lnTo>
                            <a:pt x="131" y="849"/>
                          </a:lnTo>
                          <a:lnTo>
                            <a:pt x="134" y="869"/>
                          </a:lnTo>
                          <a:lnTo>
                            <a:pt x="134" y="869"/>
                          </a:lnTo>
                          <a:lnTo>
                            <a:pt x="137" y="889"/>
                          </a:lnTo>
                          <a:lnTo>
                            <a:pt x="137" y="889"/>
                          </a:lnTo>
                          <a:lnTo>
                            <a:pt x="140" y="907"/>
                          </a:lnTo>
                          <a:lnTo>
                            <a:pt x="140" y="907"/>
                          </a:lnTo>
                          <a:lnTo>
                            <a:pt x="143" y="925"/>
                          </a:lnTo>
                          <a:lnTo>
                            <a:pt x="143" y="925"/>
                          </a:lnTo>
                          <a:lnTo>
                            <a:pt x="146" y="943"/>
                          </a:lnTo>
                          <a:lnTo>
                            <a:pt x="146" y="943"/>
                          </a:lnTo>
                          <a:lnTo>
                            <a:pt x="151" y="959"/>
                          </a:lnTo>
                          <a:lnTo>
                            <a:pt x="151" y="959"/>
                          </a:lnTo>
                          <a:lnTo>
                            <a:pt x="154" y="976"/>
                          </a:lnTo>
                          <a:lnTo>
                            <a:pt x="154" y="976"/>
                          </a:lnTo>
                          <a:lnTo>
                            <a:pt x="157" y="990"/>
                          </a:lnTo>
                          <a:lnTo>
                            <a:pt x="157" y="990"/>
                          </a:lnTo>
                          <a:lnTo>
                            <a:pt x="159" y="1004"/>
                          </a:lnTo>
                          <a:lnTo>
                            <a:pt x="159" y="1004"/>
                          </a:lnTo>
                          <a:lnTo>
                            <a:pt x="162" y="1017"/>
                          </a:lnTo>
                          <a:lnTo>
                            <a:pt x="162" y="1017"/>
                          </a:lnTo>
                          <a:lnTo>
                            <a:pt x="165" y="1031"/>
                          </a:lnTo>
                          <a:lnTo>
                            <a:pt x="165" y="1031"/>
                          </a:lnTo>
                          <a:lnTo>
                            <a:pt x="168" y="1043"/>
                          </a:lnTo>
                          <a:lnTo>
                            <a:pt x="168" y="1043"/>
                          </a:lnTo>
                          <a:lnTo>
                            <a:pt x="171" y="1054"/>
                          </a:lnTo>
                          <a:lnTo>
                            <a:pt x="171" y="1054"/>
                          </a:lnTo>
                          <a:lnTo>
                            <a:pt x="176" y="1065"/>
                          </a:lnTo>
                          <a:lnTo>
                            <a:pt x="176" y="1065"/>
                          </a:lnTo>
                          <a:lnTo>
                            <a:pt x="179" y="1075"/>
                          </a:lnTo>
                          <a:lnTo>
                            <a:pt x="179" y="1075"/>
                          </a:lnTo>
                          <a:lnTo>
                            <a:pt x="182" y="1084"/>
                          </a:lnTo>
                          <a:lnTo>
                            <a:pt x="182" y="1084"/>
                          </a:lnTo>
                          <a:lnTo>
                            <a:pt x="185" y="1093"/>
                          </a:lnTo>
                          <a:lnTo>
                            <a:pt x="185" y="1093"/>
                          </a:lnTo>
                          <a:lnTo>
                            <a:pt x="187" y="1101"/>
                          </a:lnTo>
                          <a:lnTo>
                            <a:pt x="187" y="1101"/>
                          </a:lnTo>
                          <a:lnTo>
                            <a:pt x="190" y="1107"/>
                          </a:lnTo>
                          <a:lnTo>
                            <a:pt x="190" y="1107"/>
                          </a:lnTo>
                          <a:lnTo>
                            <a:pt x="193" y="1115"/>
                          </a:lnTo>
                          <a:lnTo>
                            <a:pt x="193" y="1115"/>
                          </a:lnTo>
                          <a:lnTo>
                            <a:pt x="196" y="1121"/>
                          </a:lnTo>
                          <a:lnTo>
                            <a:pt x="196" y="1121"/>
                          </a:lnTo>
                          <a:lnTo>
                            <a:pt x="201" y="1126"/>
                          </a:lnTo>
                          <a:lnTo>
                            <a:pt x="201" y="1126"/>
                          </a:lnTo>
                          <a:lnTo>
                            <a:pt x="204" y="1132"/>
                          </a:lnTo>
                          <a:lnTo>
                            <a:pt x="207" y="1137"/>
                          </a:lnTo>
                          <a:lnTo>
                            <a:pt x="210" y="1141"/>
                          </a:lnTo>
                          <a:lnTo>
                            <a:pt x="210" y="1141"/>
                          </a:lnTo>
                          <a:lnTo>
                            <a:pt x="213" y="1144"/>
                          </a:lnTo>
                          <a:lnTo>
                            <a:pt x="213" y="1144"/>
                          </a:lnTo>
                          <a:lnTo>
                            <a:pt x="216" y="1148"/>
                          </a:lnTo>
                          <a:lnTo>
                            <a:pt x="218" y="1152"/>
                          </a:lnTo>
                          <a:lnTo>
                            <a:pt x="221" y="1156"/>
                          </a:lnTo>
                          <a:lnTo>
                            <a:pt x="229" y="1160"/>
                          </a:lnTo>
                          <a:lnTo>
                            <a:pt x="232" y="1163"/>
                          </a:lnTo>
                          <a:lnTo>
                            <a:pt x="238" y="1165"/>
                          </a:lnTo>
                          <a:lnTo>
                            <a:pt x="241" y="1166"/>
                          </a:lnTo>
                          <a:lnTo>
                            <a:pt x="246" y="1168"/>
                          </a:lnTo>
                          <a:lnTo>
                            <a:pt x="249" y="1169"/>
                          </a:lnTo>
                          <a:lnTo>
                            <a:pt x="254" y="1169"/>
                          </a:lnTo>
                          <a:lnTo>
                            <a:pt x="257" y="1168"/>
                          </a:lnTo>
                          <a:lnTo>
                            <a:pt x="263" y="1166"/>
                          </a:lnTo>
                          <a:lnTo>
                            <a:pt x="266" y="1166"/>
                          </a:lnTo>
                          <a:lnTo>
                            <a:pt x="272" y="1163"/>
                          </a:lnTo>
                          <a:lnTo>
                            <a:pt x="274" y="1161"/>
                          </a:lnTo>
                          <a:lnTo>
                            <a:pt x="274" y="1161"/>
                          </a:lnTo>
                          <a:lnTo>
                            <a:pt x="279" y="1159"/>
                          </a:lnTo>
                          <a:lnTo>
                            <a:pt x="282" y="1156"/>
                          </a:lnTo>
                          <a:lnTo>
                            <a:pt x="285" y="1153"/>
                          </a:lnTo>
                          <a:lnTo>
                            <a:pt x="285" y="1153"/>
                          </a:lnTo>
                          <a:lnTo>
                            <a:pt x="288" y="1151"/>
                          </a:lnTo>
                          <a:lnTo>
                            <a:pt x="291" y="1147"/>
                          </a:lnTo>
                          <a:lnTo>
                            <a:pt x="294" y="1144"/>
                          </a:lnTo>
                          <a:lnTo>
                            <a:pt x="297" y="1141"/>
                          </a:lnTo>
                          <a:lnTo>
                            <a:pt x="300" y="1135"/>
                          </a:lnTo>
                          <a:lnTo>
                            <a:pt x="300" y="1135"/>
                          </a:lnTo>
                          <a:lnTo>
                            <a:pt x="304" y="1132"/>
                          </a:lnTo>
                          <a:lnTo>
                            <a:pt x="304" y="1132"/>
                          </a:lnTo>
                          <a:lnTo>
                            <a:pt x="307" y="1126"/>
                          </a:lnTo>
                          <a:lnTo>
                            <a:pt x="307" y="1126"/>
                          </a:lnTo>
                          <a:lnTo>
                            <a:pt x="310" y="1121"/>
                          </a:lnTo>
                          <a:lnTo>
                            <a:pt x="313" y="1115"/>
                          </a:lnTo>
                          <a:lnTo>
                            <a:pt x="316" y="1110"/>
                          </a:lnTo>
                          <a:lnTo>
                            <a:pt x="316" y="1110"/>
                          </a:lnTo>
                          <a:lnTo>
                            <a:pt x="319" y="1103"/>
                          </a:lnTo>
                          <a:lnTo>
                            <a:pt x="319" y="1103"/>
                          </a:lnTo>
                          <a:lnTo>
                            <a:pt x="322" y="1097"/>
                          </a:lnTo>
                          <a:lnTo>
                            <a:pt x="322" y="1097"/>
                          </a:lnTo>
                          <a:lnTo>
                            <a:pt x="325" y="1090"/>
                          </a:lnTo>
                          <a:lnTo>
                            <a:pt x="325" y="1090"/>
                          </a:lnTo>
                          <a:lnTo>
                            <a:pt x="329" y="1084"/>
                          </a:lnTo>
                          <a:lnTo>
                            <a:pt x="329" y="1084"/>
                          </a:lnTo>
                          <a:lnTo>
                            <a:pt x="332" y="1076"/>
                          </a:lnTo>
                          <a:lnTo>
                            <a:pt x="332" y="1076"/>
                          </a:lnTo>
                          <a:lnTo>
                            <a:pt x="335" y="1069"/>
                          </a:lnTo>
                          <a:lnTo>
                            <a:pt x="335" y="1069"/>
                          </a:lnTo>
                          <a:lnTo>
                            <a:pt x="338" y="1061"/>
                          </a:lnTo>
                          <a:lnTo>
                            <a:pt x="338" y="1061"/>
                          </a:lnTo>
                          <a:lnTo>
                            <a:pt x="341" y="1053"/>
                          </a:lnTo>
                          <a:lnTo>
                            <a:pt x="341" y="1053"/>
                          </a:lnTo>
                          <a:lnTo>
                            <a:pt x="344" y="1045"/>
                          </a:lnTo>
                          <a:lnTo>
                            <a:pt x="344" y="1045"/>
                          </a:lnTo>
                          <a:lnTo>
                            <a:pt x="347" y="1038"/>
                          </a:lnTo>
                          <a:lnTo>
                            <a:pt x="347" y="1038"/>
                          </a:lnTo>
                          <a:lnTo>
                            <a:pt x="351" y="1030"/>
                          </a:lnTo>
                          <a:lnTo>
                            <a:pt x="351" y="1030"/>
                          </a:lnTo>
                          <a:lnTo>
                            <a:pt x="354" y="1021"/>
                          </a:lnTo>
                          <a:lnTo>
                            <a:pt x="354" y="1021"/>
                          </a:lnTo>
                          <a:lnTo>
                            <a:pt x="357" y="1013"/>
                          </a:lnTo>
                          <a:lnTo>
                            <a:pt x="357" y="1013"/>
                          </a:lnTo>
                          <a:lnTo>
                            <a:pt x="360" y="1004"/>
                          </a:lnTo>
                          <a:lnTo>
                            <a:pt x="360" y="1004"/>
                          </a:lnTo>
                          <a:lnTo>
                            <a:pt x="363" y="995"/>
                          </a:lnTo>
                          <a:lnTo>
                            <a:pt x="363" y="995"/>
                          </a:lnTo>
                          <a:lnTo>
                            <a:pt x="366" y="988"/>
                          </a:lnTo>
                          <a:lnTo>
                            <a:pt x="366" y="988"/>
                          </a:lnTo>
                          <a:lnTo>
                            <a:pt x="369" y="979"/>
                          </a:lnTo>
                          <a:lnTo>
                            <a:pt x="369" y="979"/>
                          </a:lnTo>
                          <a:lnTo>
                            <a:pt x="372" y="972"/>
                          </a:lnTo>
                          <a:lnTo>
                            <a:pt x="372" y="972"/>
                          </a:lnTo>
                          <a:lnTo>
                            <a:pt x="376" y="964"/>
                          </a:lnTo>
                          <a:lnTo>
                            <a:pt x="376" y="964"/>
                          </a:lnTo>
                          <a:lnTo>
                            <a:pt x="379" y="957"/>
                          </a:lnTo>
                          <a:lnTo>
                            <a:pt x="379" y="957"/>
                          </a:lnTo>
                          <a:lnTo>
                            <a:pt x="382" y="950"/>
                          </a:lnTo>
                          <a:lnTo>
                            <a:pt x="382" y="950"/>
                          </a:lnTo>
                          <a:lnTo>
                            <a:pt x="385" y="943"/>
                          </a:lnTo>
                          <a:lnTo>
                            <a:pt x="385" y="943"/>
                          </a:lnTo>
                          <a:lnTo>
                            <a:pt x="388" y="936"/>
                          </a:lnTo>
                          <a:lnTo>
                            <a:pt x="388" y="936"/>
                          </a:lnTo>
                          <a:lnTo>
                            <a:pt x="391" y="931"/>
                          </a:lnTo>
                          <a:lnTo>
                            <a:pt x="391" y="931"/>
                          </a:lnTo>
                          <a:lnTo>
                            <a:pt x="394" y="925"/>
                          </a:lnTo>
                          <a:lnTo>
                            <a:pt x="394" y="925"/>
                          </a:lnTo>
                          <a:lnTo>
                            <a:pt x="397" y="919"/>
                          </a:lnTo>
                          <a:lnTo>
                            <a:pt x="397" y="919"/>
                          </a:lnTo>
                          <a:lnTo>
                            <a:pt x="401" y="914"/>
                          </a:lnTo>
                          <a:lnTo>
                            <a:pt x="401" y="914"/>
                          </a:lnTo>
                          <a:lnTo>
                            <a:pt x="404" y="910"/>
                          </a:lnTo>
                          <a:lnTo>
                            <a:pt x="404" y="910"/>
                          </a:lnTo>
                          <a:lnTo>
                            <a:pt x="407" y="907"/>
                          </a:lnTo>
                          <a:lnTo>
                            <a:pt x="407" y="907"/>
                          </a:lnTo>
                          <a:lnTo>
                            <a:pt x="410" y="904"/>
                          </a:lnTo>
                          <a:lnTo>
                            <a:pt x="413" y="901"/>
                          </a:lnTo>
                          <a:lnTo>
                            <a:pt x="416" y="899"/>
                          </a:lnTo>
                          <a:lnTo>
                            <a:pt x="416" y="899"/>
                          </a:lnTo>
                          <a:lnTo>
                            <a:pt x="419" y="896"/>
                          </a:lnTo>
                          <a:lnTo>
                            <a:pt x="422" y="895"/>
                          </a:lnTo>
                          <a:lnTo>
                            <a:pt x="426" y="894"/>
                          </a:lnTo>
                          <a:lnTo>
                            <a:pt x="432" y="892"/>
                          </a:lnTo>
                          <a:lnTo>
                            <a:pt x="435" y="892"/>
                          </a:lnTo>
                          <a:lnTo>
                            <a:pt x="441" y="895"/>
                          </a:lnTo>
                          <a:lnTo>
                            <a:pt x="444" y="896"/>
                          </a:lnTo>
                          <a:lnTo>
                            <a:pt x="447" y="898"/>
                          </a:lnTo>
                          <a:lnTo>
                            <a:pt x="451" y="899"/>
                          </a:lnTo>
                          <a:lnTo>
                            <a:pt x="457" y="903"/>
                          </a:lnTo>
                          <a:lnTo>
                            <a:pt x="460" y="907"/>
                          </a:lnTo>
                          <a:lnTo>
                            <a:pt x="466" y="913"/>
                          </a:lnTo>
                          <a:lnTo>
                            <a:pt x="469" y="916"/>
                          </a:lnTo>
                          <a:lnTo>
                            <a:pt x="472" y="919"/>
                          </a:lnTo>
                          <a:lnTo>
                            <a:pt x="475" y="923"/>
                          </a:lnTo>
                          <a:lnTo>
                            <a:pt x="475" y="923"/>
                          </a:lnTo>
                          <a:lnTo>
                            <a:pt x="479" y="926"/>
                          </a:lnTo>
                          <a:lnTo>
                            <a:pt x="479" y="926"/>
                          </a:lnTo>
                          <a:lnTo>
                            <a:pt x="482" y="930"/>
                          </a:lnTo>
                          <a:lnTo>
                            <a:pt x="485" y="935"/>
                          </a:lnTo>
                          <a:lnTo>
                            <a:pt x="488" y="939"/>
                          </a:lnTo>
                          <a:lnTo>
                            <a:pt x="491" y="944"/>
                          </a:lnTo>
                          <a:lnTo>
                            <a:pt x="494" y="948"/>
                          </a:lnTo>
                          <a:lnTo>
                            <a:pt x="494" y="948"/>
                          </a:lnTo>
                          <a:lnTo>
                            <a:pt x="497" y="952"/>
                          </a:lnTo>
                          <a:lnTo>
                            <a:pt x="497" y="952"/>
                          </a:lnTo>
                          <a:lnTo>
                            <a:pt x="500" y="957"/>
                          </a:lnTo>
                          <a:lnTo>
                            <a:pt x="500" y="957"/>
                          </a:lnTo>
                          <a:lnTo>
                            <a:pt x="505" y="961"/>
                          </a:lnTo>
                          <a:lnTo>
                            <a:pt x="507" y="964"/>
                          </a:lnTo>
                          <a:lnTo>
                            <a:pt x="510" y="970"/>
                          </a:lnTo>
                          <a:lnTo>
                            <a:pt x="510" y="970"/>
                          </a:lnTo>
                          <a:lnTo>
                            <a:pt x="513" y="975"/>
                          </a:lnTo>
                          <a:lnTo>
                            <a:pt x="513" y="975"/>
                          </a:lnTo>
                          <a:lnTo>
                            <a:pt x="516" y="980"/>
                          </a:lnTo>
                          <a:lnTo>
                            <a:pt x="516" y="980"/>
                          </a:lnTo>
                          <a:lnTo>
                            <a:pt x="519" y="984"/>
                          </a:lnTo>
                          <a:lnTo>
                            <a:pt x="519" y="984"/>
                          </a:lnTo>
                          <a:lnTo>
                            <a:pt x="522" y="989"/>
                          </a:lnTo>
                          <a:lnTo>
                            <a:pt x="522" y="989"/>
                          </a:lnTo>
                          <a:lnTo>
                            <a:pt x="525" y="994"/>
                          </a:lnTo>
                          <a:lnTo>
                            <a:pt x="525" y="994"/>
                          </a:lnTo>
                          <a:lnTo>
                            <a:pt x="530" y="999"/>
                          </a:lnTo>
                          <a:lnTo>
                            <a:pt x="530" y="999"/>
                          </a:lnTo>
                          <a:lnTo>
                            <a:pt x="533" y="1004"/>
                          </a:lnTo>
                          <a:lnTo>
                            <a:pt x="533" y="1004"/>
                          </a:lnTo>
                          <a:lnTo>
                            <a:pt x="536" y="1008"/>
                          </a:lnTo>
                          <a:lnTo>
                            <a:pt x="536" y="1008"/>
                          </a:lnTo>
                          <a:lnTo>
                            <a:pt x="538" y="1015"/>
                          </a:lnTo>
                          <a:lnTo>
                            <a:pt x="538" y="1015"/>
                          </a:lnTo>
                          <a:lnTo>
                            <a:pt x="541" y="1018"/>
                          </a:lnTo>
                          <a:lnTo>
                            <a:pt x="541" y="1018"/>
                          </a:lnTo>
                          <a:lnTo>
                            <a:pt x="544" y="1024"/>
                          </a:lnTo>
                          <a:lnTo>
                            <a:pt x="544" y="1024"/>
                          </a:lnTo>
                          <a:lnTo>
                            <a:pt x="547" y="1030"/>
                          </a:lnTo>
                          <a:lnTo>
                            <a:pt x="547" y="1030"/>
                          </a:lnTo>
                          <a:lnTo>
                            <a:pt x="550" y="1034"/>
                          </a:lnTo>
                          <a:lnTo>
                            <a:pt x="550" y="1034"/>
                          </a:lnTo>
                          <a:lnTo>
                            <a:pt x="555" y="1040"/>
                          </a:lnTo>
                          <a:lnTo>
                            <a:pt x="555" y="1040"/>
                          </a:lnTo>
                          <a:lnTo>
                            <a:pt x="558" y="1045"/>
                          </a:lnTo>
                          <a:lnTo>
                            <a:pt x="561" y="1051"/>
                          </a:lnTo>
                          <a:lnTo>
                            <a:pt x="564" y="1056"/>
                          </a:lnTo>
                          <a:lnTo>
                            <a:pt x="564" y="1056"/>
                          </a:lnTo>
                          <a:lnTo>
                            <a:pt x="566" y="1061"/>
                          </a:lnTo>
                          <a:lnTo>
                            <a:pt x="569" y="1065"/>
                          </a:lnTo>
                          <a:lnTo>
                            <a:pt x="572" y="1070"/>
                          </a:lnTo>
                          <a:lnTo>
                            <a:pt x="572" y="1070"/>
                          </a:lnTo>
                          <a:lnTo>
                            <a:pt x="577" y="1075"/>
                          </a:lnTo>
                          <a:lnTo>
                            <a:pt x="577" y="1075"/>
                          </a:lnTo>
                          <a:lnTo>
                            <a:pt x="580" y="1080"/>
                          </a:lnTo>
                          <a:lnTo>
                            <a:pt x="580" y="1080"/>
                          </a:lnTo>
                          <a:lnTo>
                            <a:pt x="583" y="1085"/>
                          </a:lnTo>
                          <a:lnTo>
                            <a:pt x="583" y="1085"/>
                          </a:lnTo>
                          <a:lnTo>
                            <a:pt x="586" y="1090"/>
                          </a:lnTo>
                          <a:lnTo>
                            <a:pt x="586" y="1090"/>
                          </a:lnTo>
                          <a:lnTo>
                            <a:pt x="589" y="1096"/>
                          </a:lnTo>
                          <a:lnTo>
                            <a:pt x="589" y="1096"/>
                          </a:lnTo>
                          <a:lnTo>
                            <a:pt x="592" y="1099"/>
                          </a:lnTo>
                          <a:lnTo>
                            <a:pt x="592" y="1099"/>
                          </a:lnTo>
                          <a:lnTo>
                            <a:pt x="595" y="1103"/>
                          </a:lnTo>
                          <a:lnTo>
                            <a:pt x="595" y="1103"/>
                          </a:lnTo>
                          <a:lnTo>
                            <a:pt x="597" y="1108"/>
                          </a:lnTo>
                          <a:lnTo>
                            <a:pt x="597" y="1108"/>
                          </a:lnTo>
                          <a:lnTo>
                            <a:pt x="602" y="1112"/>
                          </a:lnTo>
                          <a:lnTo>
                            <a:pt x="602" y="1112"/>
                          </a:lnTo>
                          <a:lnTo>
                            <a:pt x="605" y="1117"/>
                          </a:lnTo>
                          <a:lnTo>
                            <a:pt x="608" y="1121"/>
                          </a:lnTo>
                          <a:lnTo>
                            <a:pt x="611" y="1125"/>
                          </a:lnTo>
                          <a:lnTo>
                            <a:pt x="611" y="1125"/>
                          </a:lnTo>
                          <a:lnTo>
                            <a:pt x="614" y="1130"/>
                          </a:lnTo>
                          <a:lnTo>
                            <a:pt x="617" y="1134"/>
                          </a:lnTo>
                          <a:lnTo>
                            <a:pt x="620" y="1138"/>
                          </a:lnTo>
                          <a:lnTo>
                            <a:pt x="627" y="1144"/>
                          </a:lnTo>
                          <a:lnTo>
                            <a:pt x="630" y="1148"/>
                          </a:lnTo>
                          <a:lnTo>
                            <a:pt x="633" y="1151"/>
                          </a:lnTo>
                          <a:lnTo>
                            <a:pt x="636" y="1155"/>
                          </a:lnTo>
                          <a:lnTo>
                            <a:pt x="636" y="1155"/>
                          </a:lnTo>
                          <a:lnTo>
                            <a:pt x="639" y="1159"/>
                          </a:lnTo>
                          <a:lnTo>
                            <a:pt x="639" y="1159"/>
                          </a:lnTo>
                          <a:lnTo>
                            <a:pt x="642" y="1161"/>
                          </a:lnTo>
                          <a:lnTo>
                            <a:pt x="645" y="1164"/>
                          </a:lnTo>
                          <a:lnTo>
                            <a:pt x="648" y="1166"/>
                          </a:lnTo>
                          <a:lnTo>
                            <a:pt x="648" y="1166"/>
                          </a:lnTo>
                          <a:lnTo>
                            <a:pt x="652" y="1169"/>
                          </a:lnTo>
                          <a:lnTo>
                            <a:pt x="652" y="1169"/>
                          </a:lnTo>
                          <a:lnTo>
                            <a:pt x="655" y="1172"/>
                          </a:lnTo>
                          <a:lnTo>
                            <a:pt x="661" y="1175"/>
                          </a:lnTo>
                          <a:lnTo>
                            <a:pt x="664" y="1178"/>
                          </a:lnTo>
                          <a:lnTo>
                            <a:pt x="670" y="1182"/>
                          </a:lnTo>
                          <a:lnTo>
                            <a:pt x="673" y="1183"/>
                          </a:lnTo>
                          <a:lnTo>
                            <a:pt x="673" y="1183"/>
                          </a:lnTo>
                          <a:lnTo>
                            <a:pt x="677" y="1184"/>
                          </a:lnTo>
                          <a:lnTo>
                            <a:pt x="680" y="1187"/>
                          </a:lnTo>
                          <a:lnTo>
                            <a:pt x="683" y="1188"/>
                          </a:lnTo>
                          <a:lnTo>
                            <a:pt x="689" y="1191"/>
                          </a:lnTo>
                          <a:lnTo>
                            <a:pt x="692" y="1192"/>
                          </a:lnTo>
                          <a:lnTo>
                            <a:pt x="698" y="1193"/>
                          </a:lnTo>
                          <a:lnTo>
                            <a:pt x="701" y="1195"/>
                          </a:lnTo>
                          <a:lnTo>
                            <a:pt x="705" y="1195"/>
                          </a:lnTo>
                          <a:lnTo>
                            <a:pt x="708" y="1196"/>
                          </a:lnTo>
                          <a:lnTo>
                            <a:pt x="714" y="1196"/>
                          </a:lnTo>
                          <a:lnTo>
                            <a:pt x="717" y="1196"/>
                          </a:lnTo>
                          <a:lnTo>
                            <a:pt x="723" y="1197"/>
                          </a:lnTo>
                          <a:lnTo>
                            <a:pt x="726" y="1196"/>
                          </a:lnTo>
                          <a:lnTo>
                            <a:pt x="733" y="1196"/>
                          </a:lnTo>
                          <a:lnTo>
                            <a:pt x="736" y="1195"/>
                          </a:lnTo>
                          <a:lnTo>
                            <a:pt x="742" y="1193"/>
                          </a:lnTo>
                          <a:lnTo>
                            <a:pt x="745" y="1193"/>
                          </a:lnTo>
                          <a:lnTo>
                            <a:pt x="748" y="1192"/>
                          </a:lnTo>
                          <a:lnTo>
                            <a:pt x="751" y="1191"/>
                          </a:lnTo>
                          <a:lnTo>
                            <a:pt x="751" y="1191"/>
                          </a:lnTo>
                          <a:lnTo>
                            <a:pt x="755" y="1190"/>
                          </a:lnTo>
                          <a:lnTo>
                            <a:pt x="758" y="1188"/>
                          </a:lnTo>
                          <a:lnTo>
                            <a:pt x="761" y="1187"/>
                          </a:lnTo>
                          <a:lnTo>
                            <a:pt x="764" y="1186"/>
                          </a:lnTo>
                          <a:lnTo>
                            <a:pt x="767" y="1183"/>
                          </a:lnTo>
                          <a:lnTo>
                            <a:pt x="767" y="1183"/>
                          </a:lnTo>
                          <a:lnTo>
                            <a:pt x="770" y="1182"/>
                          </a:lnTo>
                          <a:lnTo>
                            <a:pt x="776" y="1179"/>
                          </a:lnTo>
                          <a:lnTo>
                            <a:pt x="780" y="1177"/>
                          </a:lnTo>
                          <a:lnTo>
                            <a:pt x="780" y="1177"/>
                          </a:lnTo>
                          <a:lnTo>
                            <a:pt x="783" y="1175"/>
                          </a:lnTo>
                          <a:lnTo>
                            <a:pt x="786" y="1173"/>
                          </a:lnTo>
                          <a:lnTo>
                            <a:pt x="789" y="1170"/>
                          </a:lnTo>
                          <a:lnTo>
                            <a:pt x="792" y="1169"/>
                          </a:lnTo>
                          <a:lnTo>
                            <a:pt x="795" y="1166"/>
                          </a:lnTo>
                          <a:lnTo>
                            <a:pt x="795" y="1166"/>
                          </a:lnTo>
                          <a:lnTo>
                            <a:pt x="798" y="1164"/>
                          </a:lnTo>
                          <a:lnTo>
                            <a:pt x="802" y="1161"/>
                          </a:lnTo>
                          <a:lnTo>
                            <a:pt x="805" y="1159"/>
                          </a:lnTo>
                          <a:lnTo>
                            <a:pt x="811" y="1153"/>
                          </a:lnTo>
                          <a:lnTo>
                            <a:pt x="814" y="1151"/>
                          </a:lnTo>
                          <a:lnTo>
                            <a:pt x="820" y="1146"/>
                          </a:lnTo>
                          <a:lnTo>
                            <a:pt x="823" y="1143"/>
                          </a:lnTo>
                          <a:lnTo>
                            <a:pt x="828" y="1141"/>
                          </a:lnTo>
                          <a:lnTo>
                            <a:pt x="830" y="1137"/>
                          </a:lnTo>
                          <a:lnTo>
                            <a:pt x="830" y="1137"/>
                          </a:lnTo>
                          <a:lnTo>
                            <a:pt x="833" y="1134"/>
                          </a:lnTo>
                          <a:lnTo>
                            <a:pt x="836" y="1132"/>
                          </a:lnTo>
                          <a:lnTo>
                            <a:pt x="839" y="1128"/>
                          </a:lnTo>
                          <a:lnTo>
                            <a:pt x="839" y="1128"/>
                          </a:lnTo>
                          <a:lnTo>
                            <a:pt x="842" y="1125"/>
                          </a:lnTo>
                          <a:lnTo>
                            <a:pt x="845" y="1123"/>
                          </a:lnTo>
                          <a:lnTo>
                            <a:pt x="848" y="1120"/>
                          </a:lnTo>
                          <a:lnTo>
                            <a:pt x="848" y="1120"/>
                          </a:lnTo>
                          <a:lnTo>
                            <a:pt x="853" y="1117"/>
                          </a:lnTo>
                          <a:lnTo>
                            <a:pt x="856" y="1115"/>
                          </a:lnTo>
                          <a:lnTo>
                            <a:pt x="858" y="1112"/>
                          </a:lnTo>
                          <a:lnTo>
                            <a:pt x="864" y="1107"/>
                          </a:lnTo>
                          <a:lnTo>
                            <a:pt x="867" y="1105"/>
                          </a:lnTo>
                          <a:lnTo>
                            <a:pt x="873" y="1099"/>
                          </a:lnTo>
                          <a:lnTo>
                            <a:pt x="878" y="1098"/>
                          </a:lnTo>
                          <a:lnTo>
                            <a:pt x="884" y="1093"/>
                          </a:lnTo>
                          <a:lnTo>
                            <a:pt x="886" y="1092"/>
                          </a:lnTo>
                          <a:lnTo>
                            <a:pt x="886" y="1092"/>
                          </a:lnTo>
                          <a:lnTo>
                            <a:pt x="889" y="1089"/>
                          </a:lnTo>
                          <a:lnTo>
                            <a:pt x="892" y="1088"/>
                          </a:lnTo>
                          <a:lnTo>
                            <a:pt x="895" y="1087"/>
                          </a:lnTo>
                          <a:lnTo>
                            <a:pt x="898" y="1085"/>
                          </a:lnTo>
                          <a:lnTo>
                            <a:pt x="903" y="1084"/>
                          </a:lnTo>
                          <a:lnTo>
                            <a:pt x="903" y="1084"/>
                          </a:lnTo>
                          <a:lnTo>
                            <a:pt x="906" y="1083"/>
                          </a:lnTo>
                          <a:lnTo>
                            <a:pt x="909" y="1081"/>
                          </a:lnTo>
                          <a:lnTo>
                            <a:pt x="912" y="1080"/>
                          </a:lnTo>
                          <a:lnTo>
                            <a:pt x="917" y="1079"/>
                          </a:lnTo>
                          <a:lnTo>
                            <a:pt x="920" y="1078"/>
                          </a:lnTo>
                          <a:lnTo>
                            <a:pt x="926" y="1078"/>
                          </a:lnTo>
                          <a:lnTo>
                            <a:pt x="931" y="1078"/>
                          </a:lnTo>
                          <a:lnTo>
                            <a:pt x="937" y="1078"/>
                          </a:lnTo>
                          <a:lnTo>
                            <a:pt x="940" y="1078"/>
                          </a:lnTo>
                          <a:lnTo>
                            <a:pt x="945" y="1079"/>
                          </a:lnTo>
                          <a:lnTo>
                            <a:pt x="948" y="1079"/>
                          </a:lnTo>
                          <a:lnTo>
                            <a:pt x="951" y="1080"/>
                          </a:lnTo>
                          <a:lnTo>
                            <a:pt x="956" y="1080"/>
                          </a:lnTo>
                          <a:lnTo>
                            <a:pt x="962" y="1083"/>
                          </a:lnTo>
                          <a:lnTo>
                            <a:pt x="965" y="1083"/>
                          </a:lnTo>
                          <a:lnTo>
                            <a:pt x="965" y="1083"/>
                          </a:lnTo>
                          <a:lnTo>
                            <a:pt x="968" y="1085"/>
                          </a:lnTo>
                          <a:lnTo>
                            <a:pt x="971" y="1087"/>
                          </a:lnTo>
                          <a:lnTo>
                            <a:pt x="974" y="1088"/>
                          </a:lnTo>
                          <a:lnTo>
                            <a:pt x="981" y="1090"/>
                          </a:lnTo>
                          <a:lnTo>
                            <a:pt x="984" y="1092"/>
                          </a:lnTo>
                          <a:lnTo>
                            <a:pt x="990" y="1096"/>
                          </a:lnTo>
                          <a:lnTo>
                            <a:pt x="993" y="1097"/>
                          </a:lnTo>
                          <a:lnTo>
                            <a:pt x="993" y="1097"/>
                          </a:lnTo>
                          <a:lnTo>
                            <a:pt x="996" y="1099"/>
                          </a:lnTo>
                          <a:lnTo>
                            <a:pt x="999" y="1101"/>
                          </a:lnTo>
                          <a:lnTo>
                            <a:pt x="1002" y="1103"/>
                          </a:lnTo>
                          <a:lnTo>
                            <a:pt x="1006" y="1105"/>
                          </a:lnTo>
                          <a:lnTo>
                            <a:pt x="1009" y="1106"/>
                          </a:lnTo>
                          <a:lnTo>
                            <a:pt x="1009" y="1106"/>
                          </a:lnTo>
                          <a:lnTo>
                            <a:pt x="1012" y="1108"/>
                          </a:lnTo>
                          <a:lnTo>
                            <a:pt x="1015" y="1111"/>
                          </a:lnTo>
                          <a:lnTo>
                            <a:pt x="1018" y="1114"/>
                          </a:lnTo>
                          <a:lnTo>
                            <a:pt x="1018" y="1114"/>
                          </a:lnTo>
                          <a:lnTo>
                            <a:pt x="1021" y="1115"/>
                          </a:lnTo>
                          <a:lnTo>
                            <a:pt x="1024" y="1117"/>
                          </a:lnTo>
                          <a:lnTo>
                            <a:pt x="1028" y="1120"/>
                          </a:lnTo>
                          <a:lnTo>
                            <a:pt x="1028" y="1120"/>
                          </a:lnTo>
                          <a:lnTo>
                            <a:pt x="1031" y="1123"/>
                          </a:lnTo>
                          <a:lnTo>
                            <a:pt x="1034" y="1125"/>
                          </a:lnTo>
                          <a:lnTo>
                            <a:pt x="1037" y="1128"/>
                          </a:lnTo>
                          <a:lnTo>
                            <a:pt x="1040" y="1129"/>
                          </a:lnTo>
                          <a:lnTo>
                            <a:pt x="1043" y="1132"/>
                          </a:lnTo>
                          <a:lnTo>
                            <a:pt x="1043" y="1132"/>
                          </a:lnTo>
                          <a:lnTo>
                            <a:pt x="1046" y="1134"/>
                          </a:lnTo>
                          <a:lnTo>
                            <a:pt x="1049" y="1137"/>
                          </a:lnTo>
                          <a:lnTo>
                            <a:pt x="1053" y="1139"/>
                          </a:lnTo>
                          <a:lnTo>
                            <a:pt x="1059" y="1143"/>
                          </a:lnTo>
                          <a:lnTo>
                            <a:pt x="1062" y="1146"/>
                          </a:lnTo>
                          <a:lnTo>
                            <a:pt x="1068" y="1151"/>
                          </a:lnTo>
                          <a:lnTo>
                            <a:pt x="1071" y="1153"/>
                          </a:lnTo>
                          <a:lnTo>
                            <a:pt x="1078" y="1159"/>
                          </a:lnTo>
                          <a:lnTo>
                            <a:pt x="1081" y="1160"/>
                          </a:lnTo>
                          <a:lnTo>
                            <a:pt x="1081" y="1160"/>
                          </a:lnTo>
                          <a:lnTo>
                            <a:pt x="1084" y="1163"/>
                          </a:lnTo>
                          <a:lnTo>
                            <a:pt x="1087" y="1165"/>
                          </a:lnTo>
                          <a:lnTo>
                            <a:pt x="1090" y="1166"/>
                          </a:lnTo>
                          <a:lnTo>
                            <a:pt x="1090" y="1166"/>
                          </a:lnTo>
                          <a:lnTo>
                            <a:pt x="1093" y="1169"/>
                          </a:lnTo>
                          <a:lnTo>
                            <a:pt x="1096" y="1170"/>
                          </a:lnTo>
                          <a:lnTo>
                            <a:pt x="1099" y="1173"/>
                          </a:lnTo>
                          <a:lnTo>
                            <a:pt x="1103" y="1175"/>
                          </a:lnTo>
                          <a:lnTo>
                            <a:pt x="1106" y="1177"/>
                          </a:lnTo>
                          <a:lnTo>
                            <a:pt x="1112" y="1181"/>
                          </a:lnTo>
                          <a:lnTo>
                            <a:pt x="1115" y="1182"/>
                          </a:lnTo>
                          <a:lnTo>
                            <a:pt x="1115" y="1182"/>
                          </a:lnTo>
                          <a:lnTo>
                            <a:pt x="1118" y="1184"/>
                          </a:lnTo>
                          <a:lnTo>
                            <a:pt x="1121" y="1186"/>
                          </a:lnTo>
                          <a:lnTo>
                            <a:pt x="1124" y="1187"/>
                          </a:lnTo>
                          <a:lnTo>
                            <a:pt x="1131" y="1191"/>
                          </a:lnTo>
                          <a:lnTo>
                            <a:pt x="1134" y="1192"/>
                          </a:lnTo>
                          <a:lnTo>
                            <a:pt x="1140" y="1195"/>
                          </a:lnTo>
                          <a:lnTo>
                            <a:pt x="1143" y="1196"/>
                          </a:lnTo>
                          <a:lnTo>
                            <a:pt x="1149" y="1197"/>
                          </a:lnTo>
                          <a:lnTo>
                            <a:pt x="1152" y="1199"/>
                          </a:lnTo>
                          <a:lnTo>
                            <a:pt x="1152" y="1199"/>
                          </a:lnTo>
                          <a:lnTo>
                            <a:pt x="1156" y="1200"/>
                          </a:lnTo>
                          <a:lnTo>
                            <a:pt x="1156" y="1200"/>
                          </a:lnTo>
                          <a:lnTo>
                            <a:pt x="1159" y="1201"/>
                          </a:lnTo>
                          <a:lnTo>
                            <a:pt x="1165" y="1202"/>
                          </a:lnTo>
                          <a:lnTo>
                            <a:pt x="1168" y="1204"/>
                          </a:lnTo>
                          <a:lnTo>
                            <a:pt x="1174" y="1204"/>
                          </a:lnTo>
                          <a:lnTo>
                            <a:pt x="1177" y="1205"/>
                          </a:lnTo>
                          <a:lnTo>
                            <a:pt x="1184" y="1206"/>
                          </a:lnTo>
                          <a:lnTo>
                            <a:pt x="1187" y="1206"/>
                          </a:lnTo>
                          <a:lnTo>
                            <a:pt x="1190" y="1206"/>
                          </a:lnTo>
                          <a:lnTo>
                            <a:pt x="1193" y="1208"/>
                          </a:lnTo>
                          <a:lnTo>
                            <a:pt x="1193" y="1208"/>
                          </a:lnTo>
                          <a:lnTo>
                            <a:pt x="1196" y="1208"/>
                          </a:lnTo>
                          <a:lnTo>
                            <a:pt x="1202" y="1208"/>
                          </a:lnTo>
                          <a:lnTo>
                            <a:pt x="1207" y="1208"/>
                          </a:lnTo>
                          <a:lnTo>
                            <a:pt x="1209" y="1208"/>
                          </a:lnTo>
                          <a:lnTo>
                            <a:pt x="1212" y="1208"/>
                          </a:lnTo>
                          <a:lnTo>
                            <a:pt x="1218" y="1208"/>
                          </a:lnTo>
                          <a:lnTo>
                            <a:pt x="1221" y="1208"/>
                          </a:lnTo>
                          <a:lnTo>
                            <a:pt x="1224" y="1208"/>
                          </a:lnTo>
                          <a:lnTo>
                            <a:pt x="1227" y="1206"/>
                          </a:lnTo>
                          <a:lnTo>
                            <a:pt x="1227" y="1206"/>
                          </a:lnTo>
                          <a:lnTo>
                            <a:pt x="1232" y="1206"/>
                          </a:lnTo>
                          <a:lnTo>
                            <a:pt x="1237" y="1206"/>
                          </a:lnTo>
                          <a:lnTo>
                            <a:pt x="1240" y="1205"/>
                          </a:lnTo>
                          <a:lnTo>
                            <a:pt x="1246" y="1204"/>
                          </a:lnTo>
                          <a:lnTo>
                            <a:pt x="1249" y="1204"/>
                          </a:lnTo>
                          <a:lnTo>
                            <a:pt x="1254" y="1204"/>
                          </a:lnTo>
                          <a:lnTo>
                            <a:pt x="1257" y="1202"/>
                          </a:lnTo>
                          <a:lnTo>
                            <a:pt x="1263" y="1201"/>
                          </a:lnTo>
                          <a:lnTo>
                            <a:pt x="1265" y="1201"/>
                          </a:lnTo>
                          <a:lnTo>
                            <a:pt x="1271" y="1200"/>
                          </a:lnTo>
                          <a:lnTo>
                            <a:pt x="1274" y="1199"/>
                          </a:lnTo>
                          <a:lnTo>
                            <a:pt x="1282" y="1199"/>
                          </a:lnTo>
                          <a:lnTo>
                            <a:pt x="1285" y="1197"/>
                          </a:lnTo>
                          <a:lnTo>
                            <a:pt x="1291" y="1196"/>
                          </a:lnTo>
                          <a:lnTo>
                            <a:pt x="1294" y="1195"/>
                          </a:lnTo>
                          <a:lnTo>
                            <a:pt x="1299" y="1193"/>
                          </a:lnTo>
                          <a:lnTo>
                            <a:pt x="1304" y="1192"/>
                          </a:lnTo>
                          <a:lnTo>
                            <a:pt x="1304" y="1192"/>
                          </a:lnTo>
                          <a:lnTo>
                            <a:pt x="1307" y="1191"/>
                          </a:lnTo>
                          <a:lnTo>
                            <a:pt x="1307" y="1191"/>
                          </a:lnTo>
                          <a:lnTo>
                            <a:pt x="1310" y="1191"/>
                          </a:lnTo>
                          <a:lnTo>
                            <a:pt x="1316" y="1188"/>
                          </a:lnTo>
                          <a:lnTo>
                            <a:pt x="1319" y="1188"/>
                          </a:lnTo>
                          <a:lnTo>
                            <a:pt x="1324" y="1186"/>
                          </a:lnTo>
                          <a:lnTo>
                            <a:pt x="1329" y="1184"/>
                          </a:lnTo>
                          <a:lnTo>
                            <a:pt x="1332" y="1184"/>
                          </a:lnTo>
                          <a:lnTo>
                            <a:pt x="1335" y="1183"/>
                          </a:lnTo>
                          <a:lnTo>
                            <a:pt x="1335" y="1183"/>
                          </a:lnTo>
                          <a:lnTo>
                            <a:pt x="1338" y="1182"/>
                          </a:lnTo>
                          <a:lnTo>
                            <a:pt x="1344" y="1181"/>
                          </a:lnTo>
                          <a:lnTo>
                            <a:pt x="1347" y="1179"/>
                          </a:lnTo>
                          <a:lnTo>
                            <a:pt x="1350" y="1179"/>
                          </a:lnTo>
                          <a:lnTo>
                            <a:pt x="1354" y="1178"/>
                          </a:lnTo>
                          <a:lnTo>
                            <a:pt x="1360" y="1177"/>
                          </a:lnTo>
                          <a:lnTo>
                            <a:pt x="1363" y="1177"/>
                          </a:lnTo>
                          <a:lnTo>
                            <a:pt x="1363" y="1177"/>
                          </a:lnTo>
                          <a:lnTo>
                            <a:pt x="1366" y="1175"/>
                          </a:lnTo>
                          <a:lnTo>
                            <a:pt x="1369" y="1175"/>
                          </a:lnTo>
                          <a:lnTo>
                            <a:pt x="1372" y="1174"/>
                          </a:lnTo>
                          <a:lnTo>
                            <a:pt x="1378" y="1173"/>
                          </a:lnTo>
                          <a:lnTo>
                            <a:pt x="1382" y="1173"/>
                          </a:lnTo>
                          <a:lnTo>
                            <a:pt x="1388" y="1172"/>
                          </a:lnTo>
                          <a:lnTo>
                            <a:pt x="1391" y="1172"/>
                          </a:lnTo>
                          <a:lnTo>
                            <a:pt x="1397" y="1172"/>
                          </a:lnTo>
                          <a:lnTo>
                            <a:pt x="1400" y="1172"/>
                          </a:lnTo>
                          <a:lnTo>
                            <a:pt x="1403" y="1170"/>
                          </a:lnTo>
                          <a:lnTo>
                            <a:pt x="1407" y="1170"/>
                          </a:lnTo>
                          <a:lnTo>
                            <a:pt x="1413" y="1170"/>
                          </a:lnTo>
                          <a:lnTo>
                            <a:pt x="1416" y="1170"/>
                          </a:lnTo>
                          <a:lnTo>
                            <a:pt x="1422" y="1170"/>
                          </a:lnTo>
                          <a:lnTo>
                            <a:pt x="1425" y="1170"/>
                          </a:lnTo>
                          <a:lnTo>
                            <a:pt x="1432" y="1170"/>
                          </a:lnTo>
                          <a:lnTo>
                            <a:pt x="1435" y="1170"/>
                          </a:lnTo>
                          <a:lnTo>
                            <a:pt x="1441" y="1170"/>
                          </a:lnTo>
                          <a:lnTo>
                            <a:pt x="1444" y="1172"/>
                          </a:lnTo>
                          <a:lnTo>
                            <a:pt x="1450" y="1172"/>
                          </a:lnTo>
                          <a:lnTo>
                            <a:pt x="1453" y="1172"/>
                          </a:lnTo>
                          <a:lnTo>
                            <a:pt x="1457" y="1172"/>
                          </a:lnTo>
                          <a:lnTo>
                            <a:pt x="1460" y="1173"/>
                          </a:lnTo>
                          <a:lnTo>
                            <a:pt x="1466" y="1174"/>
                          </a:lnTo>
                          <a:lnTo>
                            <a:pt x="1469" y="1174"/>
                          </a:lnTo>
                          <a:lnTo>
                            <a:pt x="1475" y="1175"/>
                          </a:lnTo>
                          <a:lnTo>
                            <a:pt x="1479" y="1175"/>
                          </a:lnTo>
                          <a:lnTo>
                            <a:pt x="1479" y="1175"/>
                          </a:lnTo>
                          <a:lnTo>
                            <a:pt x="1482" y="1177"/>
                          </a:lnTo>
                          <a:lnTo>
                            <a:pt x="1485" y="1177"/>
                          </a:lnTo>
                          <a:lnTo>
                            <a:pt x="1488" y="1178"/>
                          </a:lnTo>
                          <a:lnTo>
                            <a:pt x="1494" y="1179"/>
                          </a:lnTo>
                          <a:lnTo>
                            <a:pt x="1497" y="1181"/>
                          </a:lnTo>
                          <a:lnTo>
                            <a:pt x="1500" y="1182"/>
                          </a:lnTo>
                          <a:lnTo>
                            <a:pt x="1504" y="1182"/>
                          </a:lnTo>
                          <a:lnTo>
                            <a:pt x="1510" y="1183"/>
                          </a:lnTo>
                          <a:lnTo>
                            <a:pt x="1513" y="1184"/>
                          </a:lnTo>
                          <a:lnTo>
                            <a:pt x="1519" y="1187"/>
                          </a:lnTo>
                          <a:lnTo>
                            <a:pt x="1522" y="1188"/>
                          </a:lnTo>
                          <a:lnTo>
                            <a:pt x="1529" y="1190"/>
                          </a:lnTo>
                          <a:lnTo>
                            <a:pt x="1532" y="1191"/>
                          </a:lnTo>
                          <a:lnTo>
                            <a:pt x="1532" y="1191"/>
                          </a:lnTo>
                          <a:lnTo>
                            <a:pt x="1535" y="1192"/>
                          </a:lnTo>
                          <a:lnTo>
                            <a:pt x="1538" y="1192"/>
                          </a:lnTo>
                          <a:lnTo>
                            <a:pt x="1541" y="1193"/>
                          </a:lnTo>
                          <a:lnTo>
                            <a:pt x="1547" y="1196"/>
                          </a:lnTo>
                          <a:lnTo>
                            <a:pt x="1550" y="1197"/>
                          </a:lnTo>
                          <a:lnTo>
                            <a:pt x="1555" y="1199"/>
                          </a:lnTo>
                          <a:lnTo>
                            <a:pt x="1557" y="1199"/>
                          </a:lnTo>
                          <a:lnTo>
                            <a:pt x="1557" y="1199"/>
                          </a:lnTo>
                          <a:lnTo>
                            <a:pt x="1560" y="1200"/>
                          </a:lnTo>
                          <a:lnTo>
                            <a:pt x="1563" y="1201"/>
                          </a:lnTo>
                          <a:lnTo>
                            <a:pt x="1566" y="1202"/>
                          </a:lnTo>
                          <a:lnTo>
                            <a:pt x="1572" y="1205"/>
                          </a:lnTo>
                          <a:lnTo>
                            <a:pt x="1575" y="1206"/>
                          </a:lnTo>
                          <a:lnTo>
                            <a:pt x="1580" y="1206"/>
                          </a:lnTo>
                          <a:lnTo>
                            <a:pt x="1583" y="1208"/>
                          </a:lnTo>
                          <a:lnTo>
                            <a:pt x="1583" y="1208"/>
                          </a:lnTo>
                          <a:lnTo>
                            <a:pt x="1586" y="1209"/>
                          </a:lnTo>
                          <a:lnTo>
                            <a:pt x="1591" y="1210"/>
                          </a:lnTo>
                          <a:lnTo>
                            <a:pt x="1594" y="1211"/>
                          </a:lnTo>
                          <a:lnTo>
                            <a:pt x="1600" y="1213"/>
                          </a:lnTo>
                          <a:lnTo>
                            <a:pt x="1603" y="1214"/>
                          </a:lnTo>
                          <a:lnTo>
                            <a:pt x="1608" y="1214"/>
                          </a:lnTo>
                          <a:lnTo>
                            <a:pt x="1611" y="1215"/>
                          </a:lnTo>
                          <a:lnTo>
                            <a:pt x="1616" y="1217"/>
                          </a:lnTo>
                          <a:lnTo>
                            <a:pt x="1619" y="1217"/>
                          </a:lnTo>
                          <a:lnTo>
                            <a:pt x="1625" y="1218"/>
                          </a:lnTo>
                          <a:lnTo>
                            <a:pt x="1628" y="1219"/>
                          </a:lnTo>
                          <a:lnTo>
                            <a:pt x="1636" y="1220"/>
                          </a:lnTo>
                          <a:lnTo>
                            <a:pt x="1639" y="1220"/>
                          </a:lnTo>
                          <a:lnTo>
                            <a:pt x="1644" y="1220"/>
                          </a:lnTo>
                          <a:lnTo>
                            <a:pt x="1647" y="1222"/>
                          </a:lnTo>
                          <a:lnTo>
                            <a:pt x="1653" y="1222"/>
                          </a:lnTo>
                          <a:lnTo>
                            <a:pt x="1658" y="1223"/>
                          </a:lnTo>
                          <a:lnTo>
                            <a:pt x="1661" y="1223"/>
                          </a:lnTo>
                          <a:lnTo>
                            <a:pt x="1664" y="1223"/>
                          </a:lnTo>
                          <a:lnTo>
                            <a:pt x="1670" y="1224"/>
                          </a:lnTo>
                          <a:lnTo>
                            <a:pt x="1673" y="1224"/>
                          </a:lnTo>
                          <a:lnTo>
                            <a:pt x="1678" y="1224"/>
                          </a:lnTo>
                          <a:lnTo>
                            <a:pt x="1683" y="1224"/>
                          </a:lnTo>
                          <a:lnTo>
                            <a:pt x="1689" y="1224"/>
                          </a:lnTo>
                          <a:lnTo>
                            <a:pt x="1692" y="1224"/>
                          </a:lnTo>
                          <a:lnTo>
                            <a:pt x="1698" y="1224"/>
                          </a:lnTo>
                          <a:lnTo>
                            <a:pt x="1701" y="1224"/>
                          </a:lnTo>
                          <a:lnTo>
                            <a:pt x="1705" y="1224"/>
                          </a:lnTo>
                          <a:lnTo>
                            <a:pt x="1708" y="1224"/>
                          </a:lnTo>
                          <a:lnTo>
                            <a:pt x="1714" y="1224"/>
                          </a:lnTo>
                          <a:lnTo>
                            <a:pt x="1717" y="1224"/>
                          </a:lnTo>
                          <a:lnTo>
                            <a:pt x="1723" y="1224"/>
                          </a:lnTo>
                          <a:lnTo>
                            <a:pt x="1726" y="1224"/>
                          </a:lnTo>
                          <a:lnTo>
                            <a:pt x="1733" y="1224"/>
                          </a:lnTo>
                          <a:lnTo>
                            <a:pt x="1736" y="1224"/>
                          </a:lnTo>
                          <a:lnTo>
                            <a:pt x="1742" y="1223"/>
                          </a:lnTo>
                          <a:lnTo>
                            <a:pt x="1745" y="1223"/>
                          </a:lnTo>
                          <a:lnTo>
                            <a:pt x="1751" y="1223"/>
                          </a:lnTo>
                          <a:lnTo>
                            <a:pt x="1755" y="1223"/>
                          </a:lnTo>
                          <a:lnTo>
                            <a:pt x="1758" y="1223"/>
                          </a:lnTo>
                          <a:lnTo>
                            <a:pt x="1761" y="1223"/>
                          </a:lnTo>
                          <a:lnTo>
                            <a:pt x="1767" y="1223"/>
                          </a:lnTo>
                          <a:lnTo>
                            <a:pt x="1770" y="1222"/>
                          </a:lnTo>
                          <a:lnTo>
                            <a:pt x="1776" y="1222"/>
                          </a:lnTo>
                          <a:lnTo>
                            <a:pt x="1780" y="1222"/>
                          </a:lnTo>
                          <a:lnTo>
                            <a:pt x="1786" y="1220"/>
                          </a:lnTo>
                          <a:lnTo>
                            <a:pt x="1789" y="1220"/>
                          </a:lnTo>
                          <a:lnTo>
                            <a:pt x="1795" y="1220"/>
                          </a:lnTo>
                          <a:lnTo>
                            <a:pt x="1798" y="1219"/>
                          </a:lnTo>
                          <a:lnTo>
                            <a:pt x="1801" y="1219"/>
                          </a:lnTo>
                          <a:lnTo>
                            <a:pt x="1805" y="1219"/>
                          </a:lnTo>
                          <a:lnTo>
                            <a:pt x="1811" y="1218"/>
                          </a:lnTo>
                          <a:lnTo>
                            <a:pt x="1814" y="1218"/>
                          </a:lnTo>
                          <a:lnTo>
                            <a:pt x="1820" y="1217"/>
                          </a:lnTo>
                          <a:lnTo>
                            <a:pt x="1823" y="1217"/>
                          </a:lnTo>
                          <a:lnTo>
                            <a:pt x="1829" y="1217"/>
                          </a:lnTo>
                          <a:lnTo>
                            <a:pt x="1833" y="1217"/>
                          </a:lnTo>
                          <a:lnTo>
                            <a:pt x="1839" y="1215"/>
                          </a:lnTo>
                          <a:lnTo>
                            <a:pt x="1842" y="1215"/>
                          </a:lnTo>
                          <a:lnTo>
                            <a:pt x="1848" y="1215"/>
                          </a:lnTo>
                          <a:lnTo>
                            <a:pt x="1851" y="1215"/>
                          </a:lnTo>
                          <a:lnTo>
                            <a:pt x="1854" y="1215"/>
                          </a:lnTo>
                          <a:lnTo>
                            <a:pt x="1858" y="1215"/>
                          </a:lnTo>
                          <a:lnTo>
                            <a:pt x="1861" y="1215"/>
                          </a:lnTo>
                          <a:lnTo>
                            <a:pt x="1864" y="1214"/>
                          </a:lnTo>
                          <a:lnTo>
                            <a:pt x="1864" y="1214"/>
                          </a:lnTo>
                          <a:lnTo>
                            <a:pt x="1867" y="1214"/>
                          </a:lnTo>
                          <a:lnTo>
                            <a:pt x="1873" y="1214"/>
                          </a:lnTo>
                          <a:lnTo>
                            <a:pt x="1876" y="1214"/>
                          </a:lnTo>
                          <a:lnTo>
                            <a:pt x="1883" y="1214"/>
                          </a:lnTo>
                          <a:lnTo>
                            <a:pt x="1886" y="1214"/>
                          </a:lnTo>
                          <a:lnTo>
                            <a:pt x="1892" y="1213"/>
                          </a:lnTo>
                          <a:lnTo>
                            <a:pt x="1895" y="1213"/>
                          </a:lnTo>
                          <a:lnTo>
                            <a:pt x="1901" y="1213"/>
                          </a:lnTo>
                          <a:lnTo>
                            <a:pt x="1904" y="1213"/>
                          </a:lnTo>
                          <a:lnTo>
                            <a:pt x="1908" y="1213"/>
                          </a:lnTo>
                          <a:lnTo>
                            <a:pt x="1911" y="1213"/>
                          </a:lnTo>
                          <a:lnTo>
                            <a:pt x="1917" y="1213"/>
                          </a:lnTo>
                          <a:lnTo>
                            <a:pt x="1920" y="1213"/>
                          </a:lnTo>
                          <a:lnTo>
                            <a:pt x="1926" y="1213"/>
                          </a:lnTo>
                          <a:lnTo>
                            <a:pt x="1931" y="1213"/>
                          </a:lnTo>
                          <a:lnTo>
                            <a:pt x="1936" y="1213"/>
                          </a:lnTo>
                          <a:lnTo>
                            <a:pt x="1939" y="1213"/>
                          </a:lnTo>
                          <a:lnTo>
                            <a:pt x="1945" y="1213"/>
                          </a:lnTo>
                          <a:lnTo>
                            <a:pt x="1948" y="1213"/>
                          </a:lnTo>
                          <a:lnTo>
                            <a:pt x="1951" y="1213"/>
                          </a:lnTo>
                          <a:lnTo>
                            <a:pt x="1956" y="1213"/>
                          </a:lnTo>
                          <a:lnTo>
                            <a:pt x="1962" y="1214"/>
                          </a:lnTo>
                          <a:lnTo>
                            <a:pt x="1965" y="1214"/>
                          </a:lnTo>
                          <a:lnTo>
                            <a:pt x="1970" y="1214"/>
                          </a:lnTo>
                          <a:lnTo>
                            <a:pt x="1973" y="1215"/>
                          </a:lnTo>
                          <a:lnTo>
                            <a:pt x="1973" y="1215"/>
                          </a:lnTo>
                          <a:lnTo>
                            <a:pt x="1976" y="1214"/>
                          </a:lnTo>
                          <a:lnTo>
                            <a:pt x="1976" y="1214"/>
                          </a:lnTo>
                          <a:lnTo>
                            <a:pt x="1981" y="1215"/>
                          </a:lnTo>
                          <a:lnTo>
                            <a:pt x="1981" y="1215"/>
                          </a:lnTo>
                          <a:lnTo>
                            <a:pt x="1984" y="1215"/>
                          </a:lnTo>
                          <a:lnTo>
                            <a:pt x="1990" y="1215"/>
                          </a:lnTo>
                          <a:lnTo>
                            <a:pt x="1993" y="1215"/>
                          </a:lnTo>
                          <a:lnTo>
                            <a:pt x="1998" y="1215"/>
                          </a:lnTo>
                          <a:lnTo>
                            <a:pt x="2001" y="1217"/>
                          </a:lnTo>
                          <a:lnTo>
                            <a:pt x="2006" y="1217"/>
                          </a:lnTo>
                          <a:lnTo>
                            <a:pt x="2009" y="1217"/>
                          </a:lnTo>
                          <a:lnTo>
                            <a:pt x="2015" y="1217"/>
                          </a:lnTo>
                          <a:lnTo>
                            <a:pt x="2018" y="1217"/>
                          </a:lnTo>
                          <a:lnTo>
                            <a:pt x="2023" y="1218"/>
                          </a:lnTo>
                          <a:lnTo>
                            <a:pt x="2026" y="1218"/>
                          </a:lnTo>
                          <a:lnTo>
                            <a:pt x="2034" y="1218"/>
                          </a:lnTo>
                          <a:lnTo>
                            <a:pt x="2037" y="1219"/>
                          </a:lnTo>
                          <a:lnTo>
                            <a:pt x="2043" y="1219"/>
                          </a:lnTo>
                          <a:lnTo>
                            <a:pt x="2046" y="1220"/>
                          </a:lnTo>
                          <a:lnTo>
                            <a:pt x="2052" y="1220"/>
                          </a:lnTo>
                          <a:lnTo>
                            <a:pt x="2054" y="1220"/>
                          </a:lnTo>
                          <a:lnTo>
                            <a:pt x="2059" y="1222"/>
                          </a:lnTo>
                          <a:lnTo>
                            <a:pt x="2062" y="1222"/>
                          </a:lnTo>
                          <a:lnTo>
                            <a:pt x="2068" y="1222"/>
                          </a:lnTo>
                          <a:lnTo>
                            <a:pt x="2071" y="1223"/>
                          </a:lnTo>
                          <a:lnTo>
                            <a:pt x="2077" y="1223"/>
                          </a:lnTo>
                          <a:lnTo>
                            <a:pt x="2080" y="1223"/>
                          </a:lnTo>
                          <a:lnTo>
                            <a:pt x="2087" y="1223"/>
                          </a:lnTo>
                          <a:lnTo>
                            <a:pt x="2090" y="1223"/>
                          </a:lnTo>
                          <a:lnTo>
                            <a:pt x="2096" y="1224"/>
                          </a:lnTo>
                          <a:lnTo>
                            <a:pt x="2099" y="1224"/>
                          </a:lnTo>
                          <a:lnTo>
                            <a:pt x="2105" y="1224"/>
                          </a:lnTo>
                          <a:lnTo>
                            <a:pt x="2109" y="1224"/>
                          </a:lnTo>
                          <a:lnTo>
                            <a:pt x="2112" y="1224"/>
                          </a:lnTo>
                          <a:lnTo>
                            <a:pt x="2115" y="1223"/>
                          </a:lnTo>
                          <a:lnTo>
                            <a:pt x="2121" y="1223"/>
                          </a:lnTo>
                          <a:lnTo>
                            <a:pt x="2124" y="1223"/>
                          </a:lnTo>
                          <a:lnTo>
                            <a:pt x="2130" y="1223"/>
                          </a:lnTo>
                          <a:lnTo>
                            <a:pt x="2134" y="1223"/>
                          </a:lnTo>
                          <a:lnTo>
                            <a:pt x="2137" y="1223"/>
                          </a:lnTo>
                          <a:lnTo>
                            <a:pt x="2140" y="1222"/>
                          </a:lnTo>
                          <a:lnTo>
                            <a:pt x="2140" y="1222"/>
                          </a:lnTo>
                          <a:lnTo>
                            <a:pt x="2143" y="1222"/>
                          </a:lnTo>
                          <a:lnTo>
                            <a:pt x="2149" y="1222"/>
                          </a:lnTo>
                          <a:lnTo>
                            <a:pt x="2152" y="1222"/>
                          </a:lnTo>
                          <a:lnTo>
                            <a:pt x="2156" y="1220"/>
                          </a:lnTo>
                          <a:lnTo>
                            <a:pt x="2159" y="1220"/>
                          </a:lnTo>
                          <a:lnTo>
                            <a:pt x="2165" y="1220"/>
                          </a:lnTo>
                          <a:lnTo>
                            <a:pt x="2168" y="1220"/>
                          </a:lnTo>
                          <a:lnTo>
                            <a:pt x="2174" y="1219"/>
                          </a:lnTo>
                          <a:lnTo>
                            <a:pt x="2177" y="1219"/>
                          </a:lnTo>
                          <a:lnTo>
                            <a:pt x="2184" y="1219"/>
                          </a:lnTo>
                          <a:lnTo>
                            <a:pt x="2187" y="1219"/>
                          </a:lnTo>
                          <a:lnTo>
                            <a:pt x="2193" y="1219"/>
                          </a:lnTo>
                          <a:lnTo>
                            <a:pt x="2196" y="1218"/>
                          </a:lnTo>
                          <a:lnTo>
                            <a:pt x="2202" y="1218"/>
                          </a:lnTo>
                          <a:lnTo>
                            <a:pt x="2206" y="1218"/>
                          </a:lnTo>
                          <a:lnTo>
                            <a:pt x="2209" y="1218"/>
                          </a:lnTo>
                          <a:lnTo>
                            <a:pt x="2212" y="1218"/>
                          </a:lnTo>
                          <a:lnTo>
                            <a:pt x="2218" y="1217"/>
                          </a:lnTo>
                          <a:lnTo>
                            <a:pt x="2221" y="1217"/>
                          </a:lnTo>
                          <a:lnTo>
                            <a:pt x="2227" y="1215"/>
                          </a:lnTo>
                          <a:lnTo>
                            <a:pt x="2231" y="1215"/>
                          </a:lnTo>
                          <a:lnTo>
                            <a:pt x="2237" y="1215"/>
                          </a:lnTo>
                          <a:lnTo>
                            <a:pt x="2240" y="1214"/>
                          </a:lnTo>
                        </a:path>
                      </a:pathLst>
                    </a:custGeom>
                    <a:noFill/>
                    <a:ln w="14288">
                      <a:solidFill>
                        <a:srgbClr val="00FF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3" name="Freeform 31">
                      <a:extLst>
                        <a:ext uri="{FF2B5EF4-FFF2-40B4-BE49-F238E27FC236}">
                          <a16:creationId xmlns:a16="http://schemas.microsoft.com/office/drawing/2014/main" id="{62CBD582-5DE1-484D-BAD3-473F7C52635D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1314450" y="3752850"/>
                      <a:ext cx="1778000" cy="796925"/>
                    </a:xfrm>
                    <a:custGeom>
                      <a:avLst/>
                      <a:gdLst>
                        <a:gd name="T0" fmla="*/ 15 w 2240"/>
                        <a:gd name="T1" fmla="*/ 56 h 1003"/>
                        <a:gd name="T2" fmla="*/ 37 w 2240"/>
                        <a:gd name="T3" fmla="*/ 161 h 1003"/>
                        <a:gd name="T4" fmla="*/ 56 w 2240"/>
                        <a:gd name="T5" fmla="*/ 262 h 1003"/>
                        <a:gd name="T6" fmla="*/ 78 w 2240"/>
                        <a:gd name="T7" fmla="*/ 388 h 1003"/>
                        <a:gd name="T8" fmla="*/ 96 w 2240"/>
                        <a:gd name="T9" fmla="*/ 508 h 1003"/>
                        <a:gd name="T10" fmla="*/ 118 w 2240"/>
                        <a:gd name="T11" fmla="*/ 643 h 1003"/>
                        <a:gd name="T12" fmla="*/ 137 w 2240"/>
                        <a:gd name="T13" fmla="*/ 743 h 1003"/>
                        <a:gd name="T14" fmla="*/ 159 w 2240"/>
                        <a:gd name="T15" fmla="*/ 831 h 1003"/>
                        <a:gd name="T16" fmla="*/ 179 w 2240"/>
                        <a:gd name="T17" fmla="*/ 880 h 1003"/>
                        <a:gd name="T18" fmla="*/ 221 w 2240"/>
                        <a:gd name="T19" fmla="*/ 929 h 1003"/>
                        <a:gd name="T20" fmla="*/ 263 w 2240"/>
                        <a:gd name="T21" fmla="*/ 914 h 1003"/>
                        <a:gd name="T22" fmla="*/ 288 w 2240"/>
                        <a:gd name="T23" fmla="*/ 878 h 1003"/>
                        <a:gd name="T24" fmla="*/ 307 w 2240"/>
                        <a:gd name="T25" fmla="*/ 837 h 1003"/>
                        <a:gd name="T26" fmla="*/ 329 w 2240"/>
                        <a:gd name="T27" fmla="*/ 777 h 1003"/>
                        <a:gd name="T28" fmla="*/ 347 w 2240"/>
                        <a:gd name="T29" fmla="*/ 718 h 1003"/>
                        <a:gd name="T30" fmla="*/ 369 w 2240"/>
                        <a:gd name="T31" fmla="*/ 657 h 1003"/>
                        <a:gd name="T32" fmla="*/ 404 w 2240"/>
                        <a:gd name="T33" fmla="*/ 611 h 1003"/>
                        <a:gd name="T34" fmla="*/ 441 w 2240"/>
                        <a:gd name="T35" fmla="*/ 633 h 1003"/>
                        <a:gd name="T36" fmla="*/ 463 w 2240"/>
                        <a:gd name="T37" fmla="*/ 665 h 1003"/>
                        <a:gd name="T38" fmla="*/ 491 w 2240"/>
                        <a:gd name="T39" fmla="*/ 716 h 1003"/>
                        <a:gd name="T40" fmla="*/ 513 w 2240"/>
                        <a:gd name="T41" fmla="*/ 759 h 1003"/>
                        <a:gd name="T42" fmla="*/ 538 w 2240"/>
                        <a:gd name="T43" fmla="*/ 808 h 1003"/>
                        <a:gd name="T44" fmla="*/ 561 w 2240"/>
                        <a:gd name="T45" fmla="*/ 849 h 1003"/>
                        <a:gd name="T46" fmla="*/ 586 w 2240"/>
                        <a:gd name="T47" fmla="*/ 891 h 1003"/>
                        <a:gd name="T48" fmla="*/ 608 w 2240"/>
                        <a:gd name="T49" fmla="*/ 921 h 1003"/>
                        <a:gd name="T50" fmla="*/ 639 w 2240"/>
                        <a:gd name="T51" fmla="*/ 952 h 1003"/>
                        <a:gd name="T52" fmla="*/ 673 w 2240"/>
                        <a:gd name="T53" fmla="*/ 969 h 1003"/>
                        <a:gd name="T54" fmla="*/ 720 w 2240"/>
                        <a:gd name="T55" fmla="*/ 969 h 1003"/>
                        <a:gd name="T56" fmla="*/ 758 w 2240"/>
                        <a:gd name="T57" fmla="*/ 953 h 1003"/>
                        <a:gd name="T58" fmla="*/ 798 w 2240"/>
                        <a:gd name="T59" fmla="*/ 925 h 1003"/>
                        <a:gd name="T60" fmla="*/ 830 w 2240"/>
                        <a:gd name="T61" fmla="*/ 900 h 1003"/>
                        <a:gd name="T62" fmla="*/ 886 w 2240"/>
                        <a:gd name="T63" fmla="*/ 875 h 1003"/>
                        <a:gd name="T64" fmla="*/ 937 w 2240"/>
                        <a:gd name="T65" fmla="*/ 880 h 1003"/>
                        <a:gd name="T66" fmla="*/ 974 w 2240"/>
                        <a:gd name="T67" fmla="*/ 900 h 1003"/>
                        <a:gd name="T68" fmla="*/ 1015 w 2240"/>
                        <a:gd name="T69" fmla="*/ 929 h 1003"/>
                        <a:gd name="T70" fmla="*/ 1046 w 2240"/>
                        <a:gd name="T71" fmla="*/ 948 h 1003"/>
                        <a:gd name="T72" fmla="*/ 1087 w 2240"/>
                        <a:gd name="T73" fmla="*/ 970 h 1003"/>
                        <a:gd name="T74" fmla="*/ 1134 w 2240"/>
                        <a:gd name="T75" fmla="*/ 987 h 1003"/>
                        <a:gd name="T76" fmla="*/ 1193 w 2240"/>
                        <a:gd name="T77" fmla="*/ 990 h 1003"/>
                        <a:gd name="T78" fmla="*/ 1240 w 2240"/>
                        <a:gd name="T79" fmla="*/ 983 h 1003"/>
                        <a:gd name="T80" fmla="*/ 1299 w 2240"/>
                        <a:gd name="T81" fmla="*/ 967 h 1003"/>
                        <a:gd name="T82" fmla="*/ 1347 w 2240"/>
                        <a:gd name="T83" fmla="*/ 957 h 1003"/>
                        <a:gd name="T84" fmla="*/ 1397 w 2240"/>
                        <a:gd name="T85" fmla="*/ 954 h 1003"/>
                        <a:gd name="T86" fmla="*/ 1450 w 2240"/>
                        <a:gd name="T87" fmla="*/ 962 h 1003"/>
                        <a:gd name="T88" fmla="*/ 1500 w 2240"/>
                        <a:gd name="T89" fmla="*/ 974 h 1003"/>
                        <a:gd name="T90" fmla="*/ 1544 w 2240"/>
                        <a:gd name="T91" fmla="*/ 985 h 1003"/>
                        <a:gd name="T92" fmla="*/ 1591 w 2240"/>
                        <a:gd name="T93" fmla="*/ 996 h 1003"/>
                        <a:gd name="T94" fmla="*/ 1647 w 2240"/>
                        <a:gd name="T95" fmla="*/ 999 h 1003"/>
                        <a:gd name="T96" fmla="*/ 1689 w 2240"/>
                        <a:gd name="T97" fmla="*/ 999 h 1003"/>
                        <a:gd name="T98" fmla="*/ 1745 w 2240"/>
                        <a:gd name="T99" fmla="*/ 996 h 1003"/>
                        <a:gd name="T100" fmla="*/ 1795 w 2240"/>
                        <a:gd name="T101" fmla="*/ 992 h 1003"/>
                        <a:gd name="T102" fmla="*/ 1851 w 2240"/>
                        <a:gd name="T103" fmla="*/ 989 h 1003"/>
                        <a:gd name="T104" fmla="*/ 1908 w 2240"/>
                        <a:gd name="T105" fmla="*/ 988 h 1003"/>
                        <a:gd name="T106" fmla="*/ 1959 w 2240"/>
                        <a:gd name="T107" fmla="*/ 993 h 1003"/>
                        <a:gd name="T108" fmla="*/ 2015 w 2240"/>
                        <a:gd name="T109" fmla="*/ 998 h 1003"/>
                        <a:gd name="T110" fmla="*/ 2071 w 2240"/>
                        <a:gd name="T111" fmla="*/ 1003 h 1003"/>
                        <a:gd name="T112" fmla="*/ 2130 w 2240"/>
                        <a:gd name="T113" fmla="*/ 1003 h 1003"/>
                        <a:gd name="T114" fmla="*/ 2177 w 2240"/>
                        <a:gd name="T115" fmla="*/ 999 h 1003"/>
                        <a:gd name="T116" fmla="*/ 2237 w 2240"/>
                        <a:gd name="T117" fmla="*/ 993 h 1003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  <a:cxn ang="0">
                          <a:pos x="T12" y="T13"/>
                        </a:cxn>
                        <a:cxn ang="0">
                          <a:pos x="T14" y="T15"/>
                        </a:cxn>
                        <a:cxn ang="0">
                          <a:pos x="T16" y="T17"/>
                        </a:cxn>
                        <a:cxn ang="0">
                          <a:pos x="T18" y="T19"/>
                        </a:cxn>
                        <a:cxn ang="0">
                          <a:pos x="T20" y="T21"/>
                        </a:cxn>
                        <a:cxn ang="0">
                          <a:pos x="T22" y="T23"/>
                        </a:cxn>
                        <a:cxn ang="0">
                          <a:pos x="T24" y="T25"/>
                        </a:cxn>
                        <a:cxn ang="0">
                          <a:pos x="T26" y="T27"/>
                        </a:cxn>
                        <a:cxn ang="0">
                          <a:pos x="T28" y="T29"/>
                        </a:cxn>
                        <a:cxn ang="0">
                          <a:pos x="T30" y="T31"/>
                        </a:cxn>
                        <a:cxn ang="0">
                          <a:pos x="T32" y="T33"/>
                        </a:cxn>
                        <a:cxn ang="0">
                          <a:pos x="T34" y="T35"/>
                        </a:cxn>
                        <a:cxn ang="0">
                          <a:pos x="T36" y="T37"/>
                        </a:cxn>
                        <a:cxn ang="0">
                          <a:pos x="T38" y="T39"/>
                        </a:cxn>
                        <a:cxn ang="0">
                          <a:pos x="T40" y="T41"/>
                        </a:cxn>
                        <a:cxn ang="0">
                          <a:pos x="T42" y="T43"/>
                        </a:cxn>
                        <a:cxn ang="0">
                          <a:pos x="T44" y="T45"/>
                        </a:cxn>
                        <a:cxn ang="0">
                          <a:pos x="T46" y="T47"/>
                        </a:cxn>
                        <a:cxn ang="0">
                          <a:pos x="T48" y="T49"/>
                        </a:cxn>
                        <a:cxn ang="0">
                          <a:pos x="T50" y="T51"/>
                        </a:cxn>
                        <a:cxn ang="0">
                          <a:pos x="T52" y="T53"/>
                        </a:cxn>
                        <a:cxn ang="0">
                          <a:pos x="T54" y="T55"/>
                        </a:cxn>
                        <a:cxn ang="0">
                          <a:pos x="T56" y="T57"/>
                        </a:cxn>
                        <a:cxn ang="0">
                          <a:pos x="T58" y="T59"/>
                        </a:cxn>
                        <a:cxn ang="0">
                          <a:pos x="T60" y="T61"/>
                        </a:cxn>
                        <a:cxn ang="0">
                          <a:pos x="T62" y="T63"/>
                        </a:cxn>
                        <a:cxn ang="0">
                          <a:pos x="T64" y="T65"/>
                        </a:cxn>
                        <a:cxn ang="0">
                          <a:pos x="T66" y="T67"/>
                        </a:cxn>
                        <a:cxn ang="0">
                          <a:pos x="T68" y="T69"/>
                        </a:cxn>
                        <a:cxn ang="0">
                          <a:pos x="T70" y="T71"/>
                        </a:cxn>
                        <a:cxn ang="0">
                          <a:pos x="T72" y="T73"/>
                        </a:cxn>
                        <a:cxn ang="0">
                          <a:pos x="T74" y="T75"/>
                        </a:cxn>
                        <a:cxn ang="0">
                          <a:pos x="T76" y="T77"/>
                        </a:cxn>
                        <a:cxn ang="0">
                          <a:pos x="T78" y="T79"/>
                        </a:cxn>
                        <a:cxn ang="0">
                          <a:pos x="T80" y="T81"/>
                        </a:cxn>
                        <a:cxn ang="0">
                          <a:pos x="T82" y="T83"/>
                        </a:cxn>
                        <a:cxn ang="0">
                          <a:pos x="T84" y="T85"/>
                        </a:cxn>
                        <a:cxn ang="0">
                          <a:pos x="T86" y="T87"/>
                        </a:cxn>
                        <a:cxn ang="0">
                          <a:pos x="T88" y="T89"/>
                        </a:cxn>
                        <a:cxn ang="0">
                          <a:pos x="T90" y="T91"/>
                        </a:cxn>
                        <a:cxn ang="0">
                          <a:pos x="T92" y="T93"/>
                        </a:cxn>
                        <a:cxn ang="0">
                          <a:pos x="T94" y="T95"/>
                        </a:cxn>
                        <a:cxn ang="0">
                          <a:pos x="T96" y="T97"/>
                        </a:cxn>
                        <a:cxn ang="0">
                          <a:pos x="T98" y="T99"/>
                        </a:cxn>
                        <a:cxn ang="0">
                          <a:pos x="T100" y="T101"/>
                        </a:cxn>
                        <a:cxn ang="0">
                          <a:pos x="T102" y="T103"/>
                        </a:cxn>
                        <a:cxn ang="0">
                          <a:pos x="T104" y="T105"/>
                        </a:cxn>
                        <a:cxn ang="0">
                          <a:pos x="T106" y="T107"/>
                        </a:cxn>
                        <a:cxn ang="0">
                          <a:pos x="T108" y="T109"/>
                        </a:cxn>
                        <a:cxn ang="0">
                          <a:pos x="T110" y="T111"/>
                        </a:cxn>
                        <a:cxn ang="0">
                          <a:pos x="T112" y="T113"/>
                        </a:cxn>
                        <a:cxn ang="0">
                          <a:pos x="T114" y="T115"/>
                        </a:cxn>
                        <a:cxn ang="0">
                          <a:pos x="T116" y="T117"/>
                        </a:cxn>
                      </a:cxnLst>
                      <a:rect l="0" t="0" r="r" b="b"/>
                      <a:pathLst>
                        <a:path w="2240" h="1003">
                          <a:moveTo>
                            <a:pt x="0" y="0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  <a:lnTo>
                            <a:pt x="3" y="10"/>
                          </a:lnTo>
                          <a:lnTo>
                            <a:pt x="3" y="10"/>
                          </a:lnTo>
                          <a:lnTo>
                            <a:pt x="6" y="20"/>
                          </a:lnTo>
                          <a:lnTo>
                            <a:pt x="6" y="20"/>
                          </a:lnTo>
                          <a:lnTo>
                            <a:pt x="9" y="32"/>
                          </a:lnTo>
                          <a:lnTo>
                            <a:pt x="9" y="32"/>
                          </a:lnTo>
                          <a:lnTo>
                            <a:pt x="12" y="44"/>
                          </a:lnTo>
                          <a:lnTo>
                            <a:pt x="12" y="44"/>
                          </a:lnTo>
                          <a:lnTo>
                            <a:pt x="15" y="56"/>
                          </a:lnTo>
                          <a:lnTo>
                            <a:pt x="15" y="56"/>
                          </a:lnTo>
                          <a:lnTo>
                            <a:pt x="18" y="69"/>
                          </a:lnTo>
                          <a:lnTo>
                            <a:pt x="18" y="69"/>
                          </a:lnTo>
                          <a:lnTo>
                            <a:pt x="21" y="82"/>
                          </a:lnTo>
                          <a:lnTo>
                            <a:pt x="21" y="82"/>
                          </a:lnTo>
                          <a:lnTo>
                            <a:pt x="24" y="98"/>
                          </a:lnTo>
                          <a:lnTo>
                            <a:pt x="24" y="98"/>
                          </a:lnTo>
                          <a:lnTo>
                            <a:pt x="28" y="112"/>
                          </a:lnTo>
                          <a:lnTo>
                            <a:pt x="28" y="112"/>
                          </a:lnTo>
                          <a:lnTo>
                            <a:pt x="31" y="129"/>
                          </a:lnTo>
                          <a:lnTo>
                            <a:pt x="31" y="129"/>
                          </a:lnTo>
                          <a:lnTo>
                            <a:pt x="34" y="144"/>
                          </a:lnTo>
                          <a:lnTo>
                            <a:pt x="34" y="144"/>
                          </a:lnTo>
                          <a:lnTo>
                            <a:pt x="37" y="161"/>
                          </a:lnTo>
                          <a:lnTo>
                            <a:pt x="37" y="161"/>
                          </a:lnTo>
                          <a:lnTo>
                            <a:pt x="40" y="177"/>
                          </a:lnTo>
                          <a:lnTo>
                            <a:pt x="40" y="177"/>
                          </a:lnTo>
                          <a:lnTo>
                            <a:pt x="43" y="194"/>
                          </a:lnTo>
                          <a:lnTo>
                            <a:pt x="43" y="194"/>
                          </a:lnTo>
                          <a:lnTo>
                            <a:pt x="46" y="211"/>
                          </a:lnTo>
                          <a:lnTo>
                            <a:pt x="46" y="211"/>
                          </a:lnTo>
                          <a:lnTo>
                            <a:pt x="49" y="226"/>
                          </a:lnTo>
                          <a:lnTo>
                            <a:pt x="49" y="226"/>
                          </a:lnTo>
                          <a:lnTo>
                            <a:pt x="53" y="244"/>
                          </a:lnTo>
                          <a:lnTo>
                            <a:pt x="53" y="244"/>
                          </a:lnTo>
                          <a:lnTo>
                            <a:pt x="56" y="262"/>
                          </a:lnTo>
                          <a:lnTo>
                            <a:pt x="56" y="262"/>
                          </a:lnTo>
                          <a:lnTo>
                            <a:pt x="59" y="280"/>
                          </a:lnTo>
                          <a:lnTo>
                            <a:pt x="59" y="280"/>
                          </a:lnTo>
                          <a:lnTo>
                            <a:pt x="62" y="297"/>
                          </a:lnTo>
                          <a:lnTo>
                            <a:pt x="62" y="297"/>
                          </a:lnTo>
                          <a:lnTo>
                            <a:pt x="65" y="315"/>
                          </a:lnTo>
                          <a:lnTo>
                            <a:pt x="65" y="315"/>
                          </a:lnTo>
                          <a:lnTo>
                            <a:pt x="68" y="333"/>
                          </a:lnTo>
                          <a:lnTo>
                            <a:pt x="68" y="333"/>
                          </a:lnTo>
                          <a:lnTo>
                            <a:pt x="71" y="351"/>
                          </a:lnTo>
                          <a:lnTo>
                            <a:pt x="71" y="351"/>
                          </a:lnTo>
                          <a:lnTo>
                            <a:pt x="74" y="370"/>
                          </a:lnTo>
                          <a:lnTo>
                            <a:pt x="74" y="370"/>
                          </a:lnTo>
                          <a:lnTo>
                            <a:pt x="78" y="388"/>
                          </a:lnTo>
                          <a:lnTo>
                            <a:pt x="78" y="388"/>
                          </a:lnTo>
                          <a:lnTo>
                            <a:pt x="81" y="409"/>
                          </a:lnTo>
                          <a:lnTo>
                            <a:pt x="81" y="409"/>
                          </a:lnTo>
                          <a:lnTo>
                            <a:pt x="84" y="428"/>
                          </a:lnTo>
                          <a:lnTo>
                            <a:pt x="84" y="428"/>
                          </a:lnTo>
                          <a:lnTo>
                            <a:pt x="87" y="449"/>
                          </a:lnTo>
                          <a:lnTo>
                            <a:pt x="87" y="449"/>
                          </a:lnTo>
                          <a:lnTo>
                            <a:pt x="90" y="468"/>
                          </a:lnTo>
                          <a:lnTo>
                            <a:pt x="90" y="468"/>
                          </a:lnTo>
                          <a:lnTo>
                            <a:pt x="93" y="487"/>
                          </a:lnTo>
                          <a:lnTo>
                            <a:pt x="93" y="487"/>
                          </a:lnTo>
                          <a:lnTo>
                            <a:pt x="96" y="508"/>
                          </a:lnTo>
                          <a:lnTo>
                            <a:pt x="96" y="508"/>
                          </a:lnTo>
                          <a:lnTo>
                            <a:pt x="99" y="529"/>
                          </a:lnTo>
                          <a:lnTo>
                            <a:pt x="99" y="529"/>
                          </a:lnTo>
                          <a:lnTo>
                            <a:pt x="103" y="549"/>
                          </a:lnTo>
                          <a:lnTo>
                            <a:pt x="103" y="549"/>
                          </a:lnTo>
                          <a:lnTo>
                            <a:pt x="106" y="568"/>
                          </a:lnTo>
                          <a:lnTo>
                            <a:pt x="106" y="568"/>
                          </a:lnTo>
                          <a:lnTo>
                            <a:pt x="109" y="588"/>
                          </a:lnTo>
                          <a:lnTo>
                            <a:pt x="109" y="588"/>
                          </a:lnTo>
                          <a:lnTo>
                            <a:pt x="112" y="607"/>
                          </a:lnTo>
                          <a:lnTo>
                            <a:pt x="112" y="607"/>
                          </a:lnTo>
                          <a:lnTo>
                            <a:pt x="115" y="625"/>
                          </a:lnTo>
                          <a:lnTo>
                            <a:pt x="115" y="625"/>
                          </a:lnTo>
                          <a:lnTo>
                            <a:pt x="118" y="643"/>
                          </a:lnTo>
                          <a:lnTo>
                            <a:pt x="118" y="643"/>
                          </a:lnTo>
                          <a:lnTo>
                            <a:pt x="121" y="661"/>
                          </a:lnTo>
                          <a:lnTo>
                            <a:pt x="121" y="661"/>
                          </a:lnTo>
                          <a:lnTo>
                            <a:pt x="126" y="679"/>
                          </a:lnTo>
                          <a:lnTo>
                            <a:pt x="126" y="679"/>
                          </a:lnTo>
                          <a:lnTo>
                            <a:pt x="128" y="696"/>
                          </a:lnTo>
                          <a:lnTo>
                            <a:pt x="128" y="696"/>
                          </a:lnTo>
                          <a:lnTo>
                            <a:pt x="131" y="713"/>
                          </a:lnTo>
                          <a:lnTo>
                            <a:pt x="131" y="713"/>
                          </a:lnTo>
                          <a:lnTo>
                            <a:pt x="134" y="728"/>
                          </a:lnTo>
                          <a:lnTo>
                            <a:pt x="134" y="728"/>
                          </a:lnTo>
                          <a:lnTo>
                            <a:pt x="137" y="743"/>
                          </a:lnTo>
                          <a:lnTo>
                            <a:pt x="137" y="743"/>
                          </a:lnTo>
                          <a:lnTo>
                            <a:pt x="140" y="758"/>
                          </a:lnTo>
                          <a:lnTo>
                            <a:pt x="140" y="758"/>
                          </a:lnTo>
                          <a:lnTo>
                            <a:pt x="143" y="772"/>
                          </a:lnTo>
                          <a:lnTo>
                            <a:pt x="143" y="772"/>
                          </a:lnTo>
                          <a:lnTo>
                            <a:pt x="146" y="785"/>
                          </a:lnTo>
                          <a:lnTo>
                            <a:pt x="146" y="785"/>
                          </a:lnTo>
                          <a:lnTo>
                            <a:pt x="151" y="797"/>
                          </a:lnTo>
                          <a:lnTo>
                            <a:pt x="151" y="797"/>
                          </a:lnTo>
                          <a:lnTo>
                            <a:pt x="154" y="809"/>
                          </a:lnTo>
                          <a:lnTo>
                            <a:pt x="154" y="809"/>
                          </a:lnTo>
                          <a:lnTo>
                            <a:pt x="157" y="821"/>
                          </a:lnTo>
                          <a:lnTo>
                            <a:pt x="157" y="821"/>
                          </a:lnTo>
                          <a:lnTo>
                            <a:pt x="159" y="831"/>
                          </a:lnTo>
                          <a:lnTo>
                            <a:pt x="159" y="831"/>
                          </a:lnTo>
                          <a:lnTo>
                            <a:pt x="162" y="840"/>
                          </a:lnTo>
                          <a:lnTo>
                            <a:pt x="162" y="840"/>
                          </a:lnTo>
                          <a:lnTo>
                            <a:pt x="165" y="849"/>
                          </a:lnTo>
                          <a:lnTo>
                            <a:pt x="165" y="849"/>
                          </a:lnTo>
                          <a:lnTo>
                            <a:pt x="168" y="858"/>
                          </a:lnTo>
                          <a:lnTo>
                            <a:pt x="168" y="858"/>
                          </a:lnTo>
                          <a:lnTo>
                            <a:pt x="171" y="866"/>
                          </a:lnTo>
                          <a:lnTo>
                            <a:pt x="171" y="866"/>
                          </a:lnTo>
                          <a:lnTo>
                            <a:pt x="176" y="873"/>
                          </a:lnTo>
                          <a:lnTo>
                            <a:pt x="176" y="873"/>
                          </a:lnTo>
                          <a:lnTo>
                            <a:pt x="179" y="880"/>
                          </a:lnTo>
                          <a:lnTo>
                            <a:pt x="179" y="880"/>
                          </a:lnTo>
                          <a:lnTo>
                            <a:pt x="182" y="886"/>
                          </a:lnTo>
                          <a:lnTo>
                            <a:pt x="185" y="891"/>
                          </a:lnTo>
                          <a:lnTo>
                            <a:pt x="187" y="896"/>
                          </a:lnTo>
                          <a:lnTo>
                            <a:pt x="187" y="896"/>
                          </a:lnTo>
                          <a:lnTo>
                            <a:pt x="190" y="902"/>
                          </a:lnTo>
                          <a:lnTo>
                            <a:pt x="193" y="905"/>
                          </a:lnTo>
                          <a:lnTo>
                            <a:pt x="196" y="909"/>
                          </a:lnTo>
                          <a:lnTo>
                            <a:pt x="201" y="913"/>
                          </a:lnTo>
                          <a:lnTo>
                            <a:pt x="204" y="916"/>
                          </a:lnTo>
                          <a:lnTo>
                            <a:pt x="210" y="922"/>
                          </a:lnTo>
                          <a:lnTo>
                            <a:pt x="213" y="923"/>
                          </a:lnTo>
                          <a:lnTo>
                            <a:pt x="218" y="927"/>
                          </a:lnTo>
                          <a:lnTo>
                            <a:pt x="221" y="929"/>
                          </a:lnTo>
                          <a:lnTo>
                            <a:pt x="229" y="930"/>
                          </a:lnTo>
                          <a:lnTo>
                            <a:pt x="232" y="930"/>
                          </a:lnTo>
                          <a:lnTo>
                            <a:pt x="238" y="929"/>
                          </a:lnTo>
                          <a:lnTo>
                            <a:pt x="241" y="929"/>
                          </a:lnTo>
                          <a:lnTo>
                            <a:pt x="246" y="926"/>
                          </a:lnTo>
                          <a:lnTo>
                            <a:pt x="249" y="925"/>
                          </a:lnTo>
                          <a:lnTo>
                            <a:pt x="249" y="925"/>
                          </a:lnTo>
                          <a:lnTo>
                            <a:pt x="254" y="922"/>
                          </a:lnTo>
                          <a:lnTo>
                            <a:pt x="254" y="922"/>
                          </a:lnTo>
                          <a:lnTo>
                            <a:pt x="257" y="920"/>
                          </a:lnTo>
                          <a:lnTo>
                            <a:pt x="260" y="918"/>
                          </a:lnTo>
                          <a:lnTo>
                            <a:pt x="263" y="914"/>
                          </a:lnTo>
                          <a:lnTo>
                            <a:pt x="263" y="914"/>
                          </a:lnTo>
                          <a:lnTo>
                            <a:pt x="266" y="912"/>
                          </a:lnTo>
                          <a:lnTo>
                            <a:pt x="269" y="908"/>
                          </a:lnTo>
                          <a:lnTo>
                            <a:pt x="272" y="904"/>
                          </a:lnTo>
                          <a:lnTo>
                            <a:pt x="272" y="904"/>
                          </a:lnTo>
                          <a:lnTo>
                            <a:pt x="274" y="900"/>
                          </a:lnTo>
                          <a:lnTo>
                            <a:pt x="274" y="900"/>
                          </a:lnTo>
                          <a:lnTo>
                            <a:pt x="279" y="895"/>
                          </a:lnTo>
                          <a:lnTo>
                            <a:pt x="279" y="895"/>
                          </a:lnTo>
                          <a:lnTo>
                            <a:pt x="282" y="890"/>
                          </a:lnTo>
                          <a:lnTo>
                            <a:pt x="282" y="890"/>
                          </a:lnTo>
                          <a:lnTo>
                            <a:pt x="285" y="885"/>
                          </a:lnTo>
                          <a:lnTo>
                            <a:pt x="285" y="885"/>
                          </a:lnTo>
                          <a:lnTo>
                            <a:pt x="288" y="878"/>
                          </a:lnTo>
                          <a:lnTo>
                            <a:pt x="288" y="878"/>
                          </a:lnTo>
                          <a:lnTo>
                            <a:pt x="291" y="873"/>
                          </a:lnTo>
                          <a:lnTo>
                            <a:pt x="291" y="873"/>
                          </a:lnTo>
                          <a:lnTo>
                            <a:pt x="294" y="867"/>
                          </a:lnTo>
                          <a:lnTo>
                            <a:pt x="294" y="867"/>
                          </a:lnTo>
                          <a:lnTo>
                            <a:pt x="297" y="860"/>
                          </a:lnTo>
                          <a:lnTo>
                            <a:pt x="297" y="860"/>
                          </a:lnTo>
                          <a:lnTo>
                            <a:pt x="300" y="853"/>
                          </a:lnTo>
                          <a:lnTo>
                            <a:pt x="300" y="853"/>
                          </a:lnTo>
                          <a:lnTo>
                            <a:pt x="304" y="845"/>
                          </a:lnTo>
                          <a:lnTo>
                            <a:pt x="304" y="845"/>
                          </a:lnTo>
                          <a:lnTo>
                            <a:pt x="307" y="837"/>
                          </a:lnTo>
                          <a:lnTo>
                            <a:pt x="307" y="837"/>
                          </a:lnTo>
                          <a:lnTo>
                            <a:pt x="310" y="830"/>
                          </a:lnTo>
                          <a:lnTo>
                            <a:pt x="310" y="830"/>
                          </a:lnTo>
                          <a:lnTo>
                            <a:pt x="313" y="821"/>
                          </a:lnTo>
                          <a:lnTo>
                            <a:pt x="313" y="821"/>
                          </a:lnTo>
                          <a:lnTo>
                            <a:pt x="316" y="813"/>
                          </a:lnTo>
                          <a:lnTo>
                            <a:pt x="316" y="813"/>
                          </a:lnTo>
                          <a:lnTo>
                            <a:pt x="319" y="804"/>
                          </a:lnTo>
                          <a:lnTo>
                            <a:pt x="319" y="804"/>
                          </a:lnTo>
                          <a:lnTo>
                            <a:pt x="322" y="795"/>
                          </a:lnTo>
                          <a:lnTo>
                            <a:pt x="322" y="795"/>
                          </a:lnTo>
                          <a:lnTo>
                            <a:pt x="325" y="786"/>
                          </a:lnTo>
                          <a:lnTo>
                            <a:pt x="325" y="786"/>
                          </a:lnTo>
                          <a:lnTo>
                            <a:pt x="329" y="777"/>
                          </a:lnTo>
                          <a:lnTo>
                            <a:pt x="329" y="777"/>
                          </a:lnTo>
                          <a:lnTo>
                            <a:pt x="332" y="767"/>
                          </a:lnTo>
                          <a:lnTo>
                            <a:pt x="332" y="767"/>
                          </a:lnTo>
                          <a:lnTo>
                            <a:pt x="335" y="758"/>
                          </a:lnTo>
                          <a:lnTo>
                            <a:pt x="335" y="758"/>
                          </a:lnTo>
                          <a:lnTo>
                            <a:pt x="338" y="747"/>
                          </a:lnTo>
                          <a:lnTo>
                            <a:pt x="338" y="747"/>
                          </a:lnTo>
                          <a:lnTo>
                            <a:pt x="341" y="737"/>
                          </a:lnTo>
                          <a:lnTo>
                            <a:pt x="341" y="737"/>
                          </a:lnTo>
                          <a:lnTo>
                            <a:pt x="344" y="728"/>
                          </a:lnTo>
                          <a:lnTo>
                            <a:pt x="344" y="728"/>
                          </a:lnTo>
                          <a:lnTo>
                            <a:pt x="347" y="718"/>
                          </a:lnTo>
                          <a:lnTo>
                            <a:pt x="347" y="718"/>
                          </a:lnTo>
                          <a:lnTo>
                            <a:pt x="351" y="709"/>
                          </a:lnTo>
                          <a:lnTo>
                            <a:pt x="351" y="709"/>
                          </a:lnTo>
                          <a:lnTo>
                            <a:pt x="354" y="700"/>
                          </a:lnTo>
                          <a:lnTo>
                            <a:pt x="354" y="700"/>
                          </a:lnTo>
                          <a:lnTo>
                            <a:pt x="357" y="691"/>
                          </a:lnTo>
                          <a:lnTo>
                            <a:pt x="357" y="691"/>
                          </a:lnTo>
                          <a:lnTo>
                            <a:pt x="360" y="682"/>
                          </a:lnTo>
                          <a:lnTo>
                            <a:pt x="360" y="682"/>
                          </a:lnTo>
                          <a:lnTo>
                            <a:pt x="363" y="673"/>
                          </a:lnTo>
                          <a:lnTo>
                            <a:pt x="363" y="673"/>
                          </a:lnTo>
                          <a:lnTo>
                            <a:pt x="366" y="665"/>
                          </a:lnTo>
                          <a:lnTo>
                            <a:pt x="366" y="665"/>
                          </a:lnTo>
                          <a:lnTo>
                            <a:pt x="369" y="657"/>
                          </a:lnTo>
                          <a:lnTo>
                            <a:pt x="369" y="657"/>
                          </a:lnTo>
                          <a:lnTo>
                            <a:pt x="372" y="651"/>
                          </a:lnTo>
                          <a:lnTo>
                            <a:pt x="372" y="651"/>
                          </a:lnTo>
                          <a:lnTo>
                            <a:pt x="376" y="644"/>
                          </a:lnTo>
                          <a:lnTo>
                            <a:pt x="379" y="638"/>
                          </a:lnTo>
                          <a:lnTo>
                            <a:pt x="382" y="633"/>
                          </a:lnTo>
                          <a:lnTo>
                            <a:pt x="382" y="633"/>
                          </a:lnTo>
                          <a:lnTo>
                            <a:pt x="385" y="628"/>
                          </a:lnTo>
                          <a:lnTo>
                            <a:pt x="388" y="624"/>
                          </a:lnTo>
                          <a:lnTo>
                            <a:pt x="391" y="620"/>
                          </a:lnTo>
                          <a:lnTo>
                            <a:pt x="397" y="615"/>
                          </a:lnTo>
                          <a:lnTo>
                            <a:pt x="401" y="612"/>
                          </a:lnTo>
                          <a:lnTo>
                            <a:pt x="404" y="611"/>
                          </a:lnTo>
                          <a:lnTo>
                            <a:pt x="407" y="611"/>
                          </a:lnTo>
                          <a:lnTo>
                            <a:pt x="413" y="611"/>
                          </a:lnTo>
                          <a:lnTo>
                            <a:pt x="416" y="611"/>
                          </a:lnTo>
                          <a:lnTo>
                            <a:pt x="419" y="612"/>
                          </a:lnTo>
                          <a:lnTo>
                            <a:pt x="422" y="615"/>
                          </a:lnTo>
                          <a:lnTo>
                            <a:pt x="422" y="615"/>
                          </a:lnTo>
                          <a:lnTo>
                            <a:pt x="426" y="617"/>
                          </a:lnTo>
                          <a:lnTo>
                            <a:pt x="429" y="620"/>
                          </a:lnTo>
                          <a:lnTo>
                            <a:pt x="432" y="622"/>
                          </a:lnTo>
                          <a:lnTo>
                            <a:pt x="432" y="622"/>
                          </a:lnTo>
                          <a:lnTo>
                            <a:pt x="435" y="625"/>
                          </a:lnTo>
                          <a:lnTo>
                            <a:pt x="438" y="629"/>
                          </a:lnTo>
                          <a:lnTo>
                            <a:pt x="441" y="633"/>
                          </a:lnTo>
                          <a:lnTo>
                            <a:pt x="441" y="633"/>
                          </a:lnTo>
                          <a:lnTo>
                            <a:pt x="444" y="637"/>
                          </a:lnTo>
                          <a:lnTo>
                            <a:pt x="444" y="637"/>
                          </a:lnTo>
                          <a:lnTo>
                            <a:pt x="447" y="640"/>
                          </a:lnTo>
                          <a:lnTo>
                            <a:pt x="447" y="640"/>
                          </a:lnTo>
                          <a:lnTo>
                            <a:pt x="451" y="646"/>
                          </a:lnTo>
                          <a:lnTo>
                            <a:pt x="454" y="651"/>
                          </a:lnTo>
                          <a:lnTo>
                            <a:pt x="457" y="655"/>
                          </a:lnTo>
                          <a:lnTo>
                            <a:pt x="457" y="655"/>
                          </a:lnTo>
                          <a:lnTo>
                            <a:pt x="460" y="660"/>
                          </a:lnTo>
                          <a:lnTo>
                            <a:pt x="460" y="660"/>
                          </a:lnTo>
                          <a:lnTo>
                            <a:pt x="463" y="665"/>
                          </a:lnTo>
                          <a:lnTo>
                            <a:pt x="463" y="665"/>
                          </a:lnTo>
                          <a:lnTo>
                            <a:pt x="466" y="671"/>
                          </a:lnTo>
                          <a:lnTo>
                            <a:pt x="466" y="671"/>
                          </a:lnTo>
                          <a:lnTo>
                            <a:pt x="469" y="677"/>
                          </a:lnTo>
                          <a:lnTo>
                            <a:pt x="472" y="683"/>
                          </a:lnTo>
                          <a:lnTo>
                            <a:pt x="475" y="688"/>
                          </a:lnTo>
                          <a:lnTo>
                            <a:pt x="475" y="688"/>
                          </a:lnTo>
                          <a:lnTo>
                            <a:pt x="479" y="693"/>
                          </a:lnTo>
                          <a:lnTo>
                            <a:pt x="479" y="693"/>
                          </a:lnTo>
                          <a:lnTo>
                            <a:pt x="482" y="700"/>
                          </a:lnTo>
                          <a:lnTo>
                            <a:pt x="485" y="706"/>
                          </a:lnTo>
                          <a:lnTo>
                            <a:pt x="488" y="711"/>
                          </a:lnTo>
                          <a:lnTo>
                            <a:pt x="488" y="711"/>
                          </a:lnTo>
                          <a:lnTo>
                            <a:pt x="491" y="716"/>
                          </a:lnTo>
                          <a:lnTo>
                            <a:pt x="491" y="716"/>
                          </a:lnTo>
                          <a:lnTo>
                            <a:pt x="494" y="723"/>
                          </a:lnTo>
                          <a:lnTo>
                            <a:pt x="494" y="723"/>
                          </a:lnTo>
                          <a:lnTo>
                            <a:pt x="497" y="728"/>
                          </a:lnTo>
                          <a:lnTo>
                            <a:pt x="497" y="728"/>
                          </a:lnTo>
                          <a:lnTo>
                            <a:pt x="500" y="734"/>
                          </a:lnTo>
                          <a:lnTo>
                            <a:pt x="500" y="734"/>
                          </a:lnTo>
                          <a:lnTo>
                            <a:pt x="505" y="740"/>
                          </a:lnTo>
                          <a:lnTo>
                            <a:pt x="505" y="740"/>
                          </a:lnTo>
                          <a:lnTo>
                            <a:pt x="507" y="746"/>
                          </a:lnTo>
                          <a:lnTo>
                            <a:pt x="510" y="752"/>
                          </a:lnTo>
                          <a:lnTo>
                            <a:pt x="513" y="759"/>
                          </a:lnTo>
                          <a:lnTo>
                            <a:pt x="513" y="759"/>
                          </a:lnTo>
                          <a:lnTo>
                            <a:pt x="516" y="765"/>
                          </a:lnTo>
                          <a:lnTo>
                            <a:pt x="516" y="765"/>
                          </a:lnTo>
                          <a:lnTo>
                            <a:pt x="519" y="770"/>
                          </a:lnTo>
                          <a:lnTo>
                            <a:pt x="519" y="770"/>
                          </a:lnTo>
                          <a:lnTo>
                            <a:pt x="522" y="777"/>
                          </a:lnTo>
                          <a:lnTo>
                            <a:pt x="525" y="783"/>
                          </a:lnTo>
                          <a:lnTo>
                            <a:pt x="530" y="788"/>
                          </a:lnTo>
                          <a:lnTo>
                            <a:pt x="530" y="788"/>
                          </a:lnTo>
                          <a:lnTo>
                            <a:pt x="533" y="795"/>
                          </a:lnTo>
                          <a:lnTo>
                            <a:pt x="533" y="795"/>
                          </a:lnTo>
                          <a:lnTo>
                            <a:pt x="536" y="801"/>
                          </a:lnTo>
                          <a:lnTo>
                            <a:pt x="536" y="801"/>
                          </a:lnTo>
                          <a:lnTo>
                            <a:pt x="538" y="808"/>
                          </a:lnTo>
                          <a:lnTo>
                            <a:pt x="538" y="808"/>
                          </a:lnTo>
                          <a:lnTo>
                            <a:pt x="541" y="813"/>
                          </a:lnTo>
                          <a:lnTo>
                            <a:pt x="541" y="813"/>
                          </a:lnTo>
                          <a:lnTo>
                            <a:pt x="544" y="819"/>
                          </a:lnTo>
                          <a:lnTo>
                            <a:pt x="544" y="819"/>
                          </a:lnTo>
                          <a:lnTo>
                            <a:pt x="547" y="826"/>
                          </a:lnTo>
                          <a:lnTo>
                            <a:pt x="547" y="826"/>
                          </a:lnTo>
                          <a:lnTo>
                            <a:pt x="550" y="832"/>
                          </a:lnTo>
                          <a:lnTo>
                            <a:pt x="555" y="837"/>
                          </a:lnTo>
                          <a:lnTo>
                            <a:pt x="558" y="844"/>
                          </a:lnTo>
                          <a:lnTo>
                            <a:pt x="558" y="844"/>
                          </a:lnTo>
                          <a:lnTo>
                            <a:pt x="561" y="849"/>
                          </a:lnTo>
                          <a:lnTo>
                            <a:pt x="561" y="849"/>
                          </a:lnTo>
                          <a:lnTo>
                            <a:pt x="564" y="855"/>
                          </a:lnTo>
                          <a:lnTo>
                            <a:pt x="564" y="855"/>
                          </a:lnTo>
                          <a:lnTo>
                            <a:pt x="566" y="860"/>
                          </a:lnTo>
                          <a:lnTo>
                            <a:pt x="566" y="860"/>
                          </a:lnTo>
                          <a:lnTo>
                            <a:pt x="569" y="866"/>
                          </a:lnTo>
                          <a:lnTo>
                            <a:pt x="569" y="866"/>
                          </a:lnTo>
                          <a:lnTo>
                            <a:pt x="572" y="872"/>
                          </a:lnTo>
                          <a:lnTo>
                            <a:pt x="572" y="872"/>
                          </a:lnTo>
                          <a:lnTo>
                            <a:pt x="577" y="877"/>
                          </a:lnTo>
                          <a:lnTo>
                            <a:pt x="580" y="881"/>
                          </a:lnTo>
                          <a:lnTo>
                            <a:pt x="583" y="886"/>
                          </a:lnTo>
                          <a:lnTo>
                            <a:pt x="583" y="886"/>
                          </a:lnTo>
                          <a:lnTo>
                            <a:pt x="586" y="891"/>
                          </a:lnTo>
                          <a:lnTo>
                            <a:pt x="586" y="891"/>
                          </a:lnTo>
                          <a:lnTo>
                            <a:pt x="589" y="896"/>
                          </a:lnTo>
                          <a:lnTo>
                            <a:pt x="589" y="896"/>
                          </a:lnTo>
                          <a:lnTo>
                            <a:pt x="592" y="900"/>
                          </a:lnTo>
                          <a:lnTo>
                            <a:pt x="592" y="900"/>
                          </a:lnTo>
                          <a:lnTo>
                            <a:pt x="595" y="905"/>
                          </a:lnTo>
                          <a:lnTo>
                            <a:pt x="595" y="905"/>
                          </a:lnTo>
                          <a:lnTo>
                            <a:pt x="597" y="909"/>
                          </a:lnTo>
                          <a:lnTo>
                            <a:pt x="597" y="909"/>
                          </a:lnTo>
                          <a:lnTo>
                            <a:pt x="602" y="913"/>
                          </a:lnTo>
                          <a:lnTo>
                            <a:pt x="602" y="913"/>
                          </a:lnTo>
                          <a:lnTo>
                            <a:pt x="605" y="917"/>
                          </a:lnTo>
                          <a:lnTo>
                            <a:pt x="608" y="921"/>
                          </a:lnTo>
                          <a:lnTo>
                            <a:pt x="611" y="925"/>
                          </a:lnTo>
                          <a:lnTo>
                            <a:pt x="614" y="929"/>
                          </a:lnTo>
                          <a:lnTo>
                            <a:pt x="617" y="931"/>
                          </a:lnTo>
                          <a:lnTo>
                            <a:pt x="617" y="931"/>
                          </a:lnTo>
                          <a:lnTo>
                            <a:pt x="620" y="935"/>
                          </a:lnTo>
                          <a:lnTo>
                            <a:pt x="623" y="938"/>
                          </a:lnTo>
                          <a:lnTo>
                            <a:pt x="627" y="942"/>
                          </a:lnTo>
                          <a:lnTo>
                            <a:pt x="627" y="942"/>
                          </a:lnTo>
                          <a:lnTo>
                            <a:pt x="630" y="944"/>
                          </a:lnTo>
                          <a:lnTo>
                            <a:pt x="630" y="944"/>
                          </a:lnTo>
                          <a:lnTo>
                            <a:pt x="633" y="947"/>
                          </a:lnTo>
                          <a:lnTo>
                            <a:pt x="636" y="949"/>
                          </a:lnTo>
                          <a:lnTo>
                            <a:pt x="639" y="952"/>
                          </a:lnTo>
                          <a:lnTo>
                            <a:pt x="642" y="953"/>
                          </a:lnTo>
                          <a:lnTo>
                            <a:pt x="645" y="956"/>
                          </a:lnTo>
                          <a:lnTo>
                            <a:pt x="645" y="956"/>
                          </a:lnTo>
                          <a:lnTo>
                            <a:pt x="648" y="958"/>
                          </a:lnTo>
                          <a:lnTo>
                            <a:pt x="652" y="960"/>
                          </a:lnTo>
                          <a:lnTo>
                            <a:pt x="655" y="961"/>
                          </a:lnTo>
                          <a:lnTo>
                            <a:pt x="655" y="961"/>
                          </a:lnTo>
                          <a:lnTo>
                            <a:pt x="658" y="963"/>
                          </a:lnTo>
                          <a:lnTo>
                            <a:pt x="661" y="965"/>
                          </a:lnTo>
                          <a:lnTo>
                            <a:pt x="664" y="966"/>
                          </a:lnTo>
                          <a:lnTo>
                            <a:pt x="670" y="969"/>
                          </a:lnTo>
                          <a:lnTo>
                            <a:pt x="673" y="969"/>
                          </a:lnTo>
                          <a:lnTo>
                            <a:pt x="673" y="969"/>
                          </a:lnTo>
                          <a:lnTo>
                            <a:pt x="677" y="970"/>
                          </a:lnTo>
                          <a:lnTo>
                            <a:pt x="680" y="970"/>
                          </a:lnTo>
                          <a:lnTo>
                            <a:pt x="683" y="971"/>
                          </a:lnTo>
                          <a:lnTo>
                            <a:pt x="689" y="971"/>
                          </a:lnTo>
                          <a:lnTo>
                            <a:pt x="692" y="972"/>
                          </a:lnTo>
                          <a:lnTo>
                            <a:pt x="698" y="972"/>
                          </a:lnTo>
                          <a:lnTo>
                            <a:pt x="701" y="971"/>
                          </a:lnTo>
                          <a:lnTo>
                            <a:pt x="705" y="971"/>
                          </a:lnTo>
                          <a:lnTo>
                            <a:pt x="708" y="971"/>
                          </a:lnTo>
                          <a:lnTo>
                            <a:pt x="714" y="970"/>
                          </a:lnTo>
                          <a:lnTo>
                            <a:pt x="717" y="970"/>
                          </a:lnTo>
                          <a:lnTo>
                            <a:pt x="717" y="970"/>
                          </a:lnTo>
                          <a:lnTo>
                            <a:pt x="720" y="969"/>
                          </a:lnTo>
                          <a:lnTo>
                            <a:pt x="723" y="969"/>
                          </a:lnTo>
                          <a:lnTo>
                            <a:pt x="726" y="967"/>
                          </a:lnTo>
                          <a:lnTo>
                            <a:pt x="733" y="965"/>
                          </a:lnTo>
                          <a:lnTo>
                            <a:pt x="736" y="963"/>
                          </a:lnTo>
                          <a:lnTo>
                            <a:pt x="739" y="962"/>
                          </a:lnTo>
                          <a:lnTo>
                            <a:pt x="742" y="961"/>
                          </a:lnTo>
                          <a:lnTo>
                            <a:pt x="742" y="961"/>
                          </a:lnTo>
                          <a:lnTo>
                            <a:pt x="745" y="960"/>
                          </a:lnTo>
                          <a:lnTo>
                            <a:pt x="751" y="957"/>
                          </a:lnTo>
                          <a:lnTo>
                            <a:pt x="755" y="954"/>
                          </a:lnTo>
                          <a:lnTo>
                            <a:pt x="755" y="954"/>
                          </a:lnTo>
                          <a:lnTo>
                            <a:pt x="758" y="953"/>
                          </a:lnTo>
                          <a:lnTo>
                            <a:pt x="758" y="953"/>
                          </a:lnTo>
                          <a:lnTo>
                            <a:pt x="761" y="952"/>
                          </a:lnTo>
                          <a:lnTo>
                            <a:pt x="767" y="947"/>
                          </a:lnTo>
                          <a:lnTo>
                            <a:pt x="770" y="945"/>
                          </a:lnTo>
                          <a:lnTo>
                            <a:pt x="776" y="942"/>
                          </a:lnTo>
                          <a:lnTo>
                            <a:pt x="780" y="939"/>
                          </a:lnTo>
                          <a:lnTo>
                            <a:pt x="780" y="939"/>
                          </a:lnTo>
                          <a:lnTo>
                            <a:pt x="783" y="936"/>
                          </a:lnTo>
                          <a:lnTo>
                            <a:pt x="786" y="935"/>
                          </a:lnTo>
                          <a:lnTo>
                            <a:pt x="789" y="933"/>
                          </a:lnTo>
                          <a:lnTo>
                            <a:pt x="789" y="933"/>
                          </a:lnTo>
                          <a:lnTo>
                            <a:pt x="792" y="930"/>
                          </a:lnTo>
                          <a:lnTo>
                            <a:pt x="795" y="927"/>
                          </a:lnTo>
                          <a:lnTo>
                            <a:pt x="798" y="925"/>
                          </a:lnTo>
                          <a:lnTo>
                            <a:pt x="798" y="925"/>
                          </a:lnTo>
                          <a:lnTo>
                            <a:pt x="802" y="922"/>
                          </a:lnTo>
                          <a:lnTo>
                            <a:pt x="802" y="922"/>
                          </a:lnTo>
                          <a:lnTo>
                            <a:pt x="805" y="921"/>
                          </a:lnTo>
                          <a:lnTo>
                            <a:pt x="808" y="917"/>
                          </a:lnTo>
                          <a:lnTo>
                            <a:pt x="811" y="914"/>
                          </a:lnTo>
                          <a:lnTo>
                            <a:pt x="811" y="914"/>
                          </a:lnTo>
                          <a:lnTo>
                            <a:pt x="814" y="912"/>
                          </a:lnTo>
                          <a:lnTo>
                            <a:pt x="817" y="909"/>
                          </a:lnTo>
                          <a:lnTo>
                            <a:pt x="820" y="907"/>
                          </a:lnTo>
                          <a:lnTo>
                            <a:pt x="820" y="907"/>
                          </a:lnTo>
                          <a:lnTo>
                            <a:pt x="823" y="905"/>
                          </a:lnTo>
                          <a:lnTo>
                            <a:pt x="830" y="900"/>
                          </a:lnTo>
                          <a:lnTo>
                            <a:pt x="833" y="898"/>
                          </a:lnTo>
                          <a:lnTo>
                            <a:pt x="839" y="894"/>
                          </a:lnTo>
                          <a:lnTo>
                            <a:pt x="842" y="891"/>
                          </a:lnTo>
                          <a:lnTo>
                            <a:pt x="848" y="887"/>
                          </a:lnTo>
                          <a:lnTo>
                            <a:pt x="853" y="886"/>
                          </a:lnTo>
                          <a:lnTo>
                            <a:pt x="856" y="885"/>
                          </a:lnTo>
                          <a:lnTo>
                            <a:pt x="858" y="884"/>
                          </a:lnTo>
                          <a:lnTo>
                            <a:pt x="864" y="880"/>
                          </a:lnTo>
                          <a:lnTo>
                            <a:pt x="867" y="878"/>
                          </a:lnTo>
                          <a:lnTo>
                            <a:pt x="873" y="877"/>
                          </a:lnTo>
                          <a:lnTo>
                            <a:pt x="878" y="876"/>
                          </a:lnTo>
                          <a:lnTo>
                            <a:pt x="884" y="875"/>
                          </a:lnTo>
                          <a:lnTo>
                            <a:pt x="886" y="875"/>
                          </a:lnTo>
                          <a:lnTo>
                            <a:pt x="892" y="875"/>
                          </a:lnTo>
                          <a:lnTo>
                            <a:pt x="895" y="873"/>
                          </a:lnTo>
                          <a:lnTo>
                            <a:pt x="898" y="873"/>
                          </a:lnTo>
                          <a:lnTo>
                            <a:pt x="903" y="875"/>
                          </a:lnTo>
                          <a:lnTo>
                            <a:pt x="909" y="873"/>
                          </a:lnTo>
                          <a:lnTo>
                            <a:pt x="912" y="873"/>
                          </a:lnTo>
                          <a:lnTo>
                            <a:pt x="917" y="875"/>
                          </a:lnTo>
                          <a:lnTo>
                            <a:pt x="920" y="875"/>
                          </a:lnTo>
                          <a:lnTo>
                            <a:pt x="923" y="876"/>
                          </a:lnTo>
                          <a:lnTo>
                            <a:pt x="926" y="877"/>
                          </a:lnTo>
                          <a:lnTo>
                            <a:pt x="926" y="877"/>
                          </a:lnTo>
                          <a:lnTo>
                            <a:pt x="931" y="878"/>
                          </a:lnTo>
                          <a:lnTo>
                            <a:pt x="937" y="880"/>
                          </a:lnTo>
                          <a:lnTo>
                            <a:pt x="940" y="881"/>
                          </a:lnTo>
                          <a:lnTo>
                            <a:pt x="943" y="882"/>
                          </a:lnTo>
                          <a:lnTo>
                            <a:pt x="945" y="885"/>
                          </a:lnTo>
                          <a:lnTo>
                            <a:pt x="945" y="885"/>
                          </a:lnTo>
                          <a:lnTo>
                            <a:pt x="948" y="886"/>
                          </a:lnTo>
                          <a:lnTo>
                            <a:pt x="951" y="887"/>
                          </a:lnTo>
                          <a:lnTo>
                            <a:pt x="956" y="889"/>
                          </a:lnTo>
                          <a:lnTo>
                            <a:pt x="959" y="890"/>
                          </a:lnTo>
                          <a:lnTo>
                            <a:pt x="962" y="893"/>
                          </a:lnTo>
                          <a:lnTo>
                            <a:pt x="962" y="893"/>
                          </a:lnTo>
                          <a:lnTo>
                            <a:pt x="965" y="894"/>
                          </a:lnTo>
                          <a:lnTo>
                            <a:pt x="971" y="898"/>
                          </a:lnTo>
                          <a:lnTo>
                            <a:pt x="974" y="900"/>
                          </a:lnTo>
                          <a:lnTo>
                            <a:pt x="981" y="904"/>
                          </a:lnTo>
                          <a:lnTo>
                            <a:pt x="984" y="907"/>
                          </a:lnTo>
                          <a:lnTo>
                            <a:pt x="984" y="907"/>
                          </a:lnTo>
                          <a:lnTo>
                            <a:pt x="987" y="909"/>
                          </a:lnTo>
                          <a:lnTo>
                            <a:pt x="990" y="911"/>
                          </a:lnTo>
                          <a:lnTo>
                            <a:pt x="993" y="913"/>
                          </a:lnTo>
                          <a:lnTo>
                            <a:pt x="993" y="913"/>
                          </a:lnTo>
                          <a:lnTo>
                            <a:pt x="996" y="916"/>
                          </a:lnTo>
                          <a:lnTo>
                            <a:pt x="999" y="917"/>
                          </a:lnTo>
                          <a:lnTo>
                            <a:pt x="1002" y="920"/>
                          </a:lnTo>
                          <a:lnTo>
                            <a:pt x="1006" y="922"/>
                          </a:lnTo>
                          <a:lnTo>
                            <a:pt x="1009" y="923"/>
                          </a:lnTo>
                          <a:lnTo>
                            <a:pt x="1015" y="929"/>
                          </a:lnTo>
                          <a:lnTo>
                            <a:pt x="1018" y="930"/>
                          </a:lnTo>
                          <a:lnTo>
                            <a:pt x="1018" y="930"/>
                          </a:lnTo>
                          <a:lnTo>
                            <a:pt x="1021" y="933"/>
                          </a:lnTo>
                          <a:lnTo>
                            <a:pt x="1024" y="934"/>
                          </a:lnTo>
                          <a:lnTo>
                            <a:pt x="1028" y="936"/>
                          </a:lnTo>
                          <a:lnTo>
                            <a:pt x="1028" y="936"/>
                          </a:lnTo>
                          <a:lnTo>
                            <a:pt x="1031" y="939"/>
                          </a:lnTo>
                          <a:lnTo>
                            <a:pt x="1034" y="940"/>
                          </a:lnTo>
                          <a:lnTo>
                            <a:pt x="1037" y="943"/>
                          </a:lnTo>
                          <a:lnTo>
                            <a:pt x="1040" y="944"/>
                          </a:lnTo>
                          <a:lnTo>
                            <a:pt x="1043" y="947"/>
                          </a:lnTo>
                          <a:lnTo>
                            <a:pt x="1043" y="947"/>
                          </a:lnTo>
                          <a:lnTo>
                            <a:pt x="1046" y="948"/>
                          </a:lnTo>
                          <a:lnTo>
                            <a:pt x="1049" y="951"/>
                          </a:lnTo>
                          <a:lnTo>
                            <a:pt x="1053" y="952"/>
                          </a:lnTo>
                          <a:lnTo>
                            <a:pt x="1053" y="952"/>
                          </a:lnTo>
                          <a:lnTo>
                            <a:pt x="1056" y="954"/>
                          </a:lnTo>
                          <a:lnTo>
                            <a:pt x="1059" y="956"/>
                          </a:lnTo>
                          <a:lnTo>
                            <a:pt x="1062" y="957"/>
                          </a:lnTo>
                          <a:lnTo>
                            <a:pt x="1068" y="961"/>
                          </a:lnTo>
                          <a:lnTo>
                            <a:pt x="1071" y="962"/>
                          </a:lnTo>
                          <a:lnTo>
                            <a:pt x="1078" y="966"/>
                          </a:lnTo>
                          <a:lnTo>
                            <a:pt x="1081" y="967"/>
                          </a:lnTo>
                          <a:lnTo>
                            <a:pt x="1084" y="969"/>
                          </a:lnTo>
                          <a:lnTo>
                            <a:pt x="1087" y="970"/>
                          </a:lnTo>
                          <a:lnTo>
                            <a:pt x="1087" y="970"/>
                          </a:lnTo>
                          <a:lnTo>
                            <a:pt x="1090" y="971"/>
                          </a:lnTo>
                          <a:lnTo>
                            <a:pt x="1096" y="975"/>
                          </a:lnTo>
                          <a:lnTo>
                            <a:pt x="1099" y="976"/>
                          </a:lnTo>
                          <a:lnTo>
                            <a:pt x="1103" y="976"/>
                          </a:lnTo>
                          <a:lnTo>
                            <a:pt x="1106" y="978"/>
                          </a:lnTo>
                          <a:lnTo>
                            <a:pt x="1112" y="980"/>
                          </a:lnTo>
                          <a:lnTo>
                            <a:pt x="1115" y="981"/>
                          </a:lnTo>
                          <a:lnTo>
                            <a:pt x="1121" y="983"/>
                          </a:lnTo>
                          <a:lnTo>
                            <a:pt x="1124" y="984"/>
                          </a:lnTo>
                          <a:lnTo>
                            <a:pt x="1124" y="984"/>
                          </a:lnTo>
                          <a:lnTo>
                            <a:pt x="1128" y="985"/>
                          </a:lnTo>
                          <a:lnTo>
                            <a:pt x="1131" y="985"/>
                          </a:lnTo>
                          <a:lnTo>
                            <a:pt x="1134" y="987"/>
                          </a:lnTo>
                          <a:lnTo>
                            <a:pt x="1140" y="988"/>
                          </a:lnTo>
                          <a:lnTo>
                            <a:pt x="1143" y="988"/>
                          </a:lnTo>
                          <a:lnTo>
                            <a:pt x="1149" y="989"/>
                          </a:lnTo>
                          <a:lnTo>
                            <a:pt x="1152" y="989"/>
                          </a:lnTo>
                          <a:lnTo>
                            <a:pt x="1156" y="989"/>
                          </a:lnTo>
                          <a:lnTo>
                            <a:pt x="1159" y="990"/>
                          </a:lnTo>
                          <a:lnTo>
                            <a:pt x="1165" y="990"/>
                          </a:lnTo>
                          <a:lnTo>
                            <a:pt x="1168" y="990"/>
                          </a:lnTo>
                          <a:lnTo>
                            <a:pt x="1174" y="990"/>
                          </a:lnTo>
                          <a:lnTo>
                            <a:pt x="1177" y="990"/>
                          </a:lnTo>
                          <a:lnTo>
                            <a:pt x="1184" y="992"/>
                          </a:lnTo>
                          <a:lnTo>
                            <a:pt x="1187" y="992"/>
                          </a:lnTo>
                          <a:lnTo>
                            <a:pt x="1193" y="990"/>
                          </a:lnTo>
                          <a:lnTo>
                            <a:pt x="1196" y="990"/>
                          </a:lnTo>
                          <a:lnTo>
                            <a:pt x="1202" y="990"/>
                          </a:lnTo>
                          <a:lnTo>
                            <a:pt x="1207" y="989"/>
                          </a:lnTo>
                          <a:lnTo>
                            <a:pt x="1209" y="989"/>
                          </a:lnTo>
                          <a:lnTo>
                            <a:pt x="1212" y="989"/>
                          </a:lnTo>
                          <a:lnTo>
                            <a:pt x="1218" y="988"/>
                          </a:lnTo>
                          <a:lnTo>
                            <a:pt x="1221" y="987"/>
                          </a:lnTo>
                          <a:lnTo>
                            <a:pt x="1227" y="985"/>
                          </a:lnTo>
                          <a:lnTo>
                            <a:pt x="1232" y="985"/>
                          </a:lnTo>
                          <a:lnTo>
                            <a:pt x="1232" y="985"/>
                          </a:lnTo>
                          <a:lnTo>
                            <a:pt x="1235" y="984"/>
                          </a:lnTo>
                          <a:lnTo>
                            <a:pt x="1237" y="984"/>
                          </a:lnTo>
                          <a:lnTo>
                            <a:pt x="1240" y="983"/>
                          </a:lnTo>
                          <a:lnTo>
                            <a:pt x="1246" y="981"/>
                          </a:lnTo>
                          <a:lnTo>
                            <a:pt x="1249" y="980"/>
                          </a:lnTo>
                          <a:lnTo>
                            <a:pt x="1254" y="980"/>
                          </a:lnTo>
                          <a:lnTo>
                            <a:pt x="1257" y="979"/>
                          </a:lnTo>
                          <a:lnTo>
                            <a:pt x="1263" y="978"/>
                          </a:lnTo>
                          <a:lnTo>
                            <a:pt x="1265" y="976"/>
                          </a:lnTo>
                          <a:lnTo>
                            <a:pt x="1271" y="975"/>
                          </a:lnTo>
                          <a:lnTo>
                            <a:pt x="1274" y="974"/>
                          </a:lnTo>
                          <a:lnTo>
                            <a:pt x="1282" y="972"/>
                          </a:lnTo>
                          <a:lnTo>
                            <a:pt x="1285" y="971"/>
                          </a:lnTo>
                          <a:lnTo>
                            <a:pt x="1291" y="970"/>
                          </a:lnTo>
                          <a:lnTo>
                            <a:pt x="1294" y="969"/>
                          </a:lnTo>
                          <a:lnTo>
                            <a:pt x="1299" y="967"/>
                          </a:lnTo>
                          <a:lnTo>
                            <a:pt x="1304" y="966"/>
                          </a:lnTo>
                          <a:lnTo>
                            <a:pt x="1307" y="966"/>
                          </a:lnTo>
                          <a:lnTo>
                            <a:pt x="1310" y="965"/>
                          </a:lnTo>
                          <a:lnTo>
                            <a:pt x="1316" y="963"/>
                          </a:lnTo>
                          <a:lnTo>
                            <a:pt x="1319" y="962"/>
                          </a:lnTo>
                          <a:lnTo>
                            <a:pt x="1322" y="962"/>
                          </a:lnTo>
                          <a:lnTo>
                            <a:pt x="1324" y="961"/>
                          </a:lnTo>
                          <a:lnTo>
                            <a:pt x="1324" y="961"/>
                          </a:lnTo>
                          <a:lnTo>
                            <a:pt x="1329" y="961"/>
                          </a:lnTo>
                          <a:lnTo>
                            <a:pt x="1335" y="960"/>
                          </a:lnTo>
                          <a:lnTo>
                            <a:pt x="1338" y="958"/>
                          </a:lnTo>
                          <a:lnTo>
                            <a:pt x="1344" y="957"/>
                          </a:lnTo>
                          <a:lnTo>
                            <a:pt x="1347" y="957"/>
                          </a:lnTo>
                          <a:lnTo>
                            <a:pt x="1350" y="956"/>
                          </a:lnTo>
                          <a:lnTo>
                            <a:pt x="1354" y="956"/>
                          </a:lnTo>
                          <a:lnTo>
                            <a:pt x="1360" y="956"/>
                          </a:lnTo>
                          <a:lnTo>
                            <a:pt x="1363" y="954"/>
                          </a:lnTo>
                          <a:lnTo>
                            <a:pt x="1369" y="954"/>
                          </a:lnTo>
                          <a:lnTo>
                            <a:pt x="1372" y="954"/>
                          </a:lnTo>
                          <a:lnTo>
                            <a:pt x="1378" y="954"/>
                          </a:lnTo>
                          <a:lnTo>
                            <a:pt x="1382" y="954"/>
                          </a:lnTo>
                          <a:lnTo>
                            <a:pt x="1388" y="954"/>
                          </a:lnTo>
                          <a:lnTo>
                            <a:pt x="1391" y="953"/>
                          </a:lnTo>
                          <a:lnTo>
                            <a:pt x="1394" y="953"/>
                          </a:lnTo>
                          <a:lnTo>
                            <a:pt x="1397" y="954"/>
                          </a:lnTo>
                          <a:lnTo>
                            <a:pt x="1397" y="954"/>
                          </a:lnTo>
                          <a:lnTo>
                            <a:pt x="1400" y="954"/>
                          </a:lnTo>
                          <a:lnTo>
                            <a:pt x="1403" y="954"/>
                          </a:lnTo>
                          <a:lnTo>
                            <a:pt x="1407" y="954"/>
                          </a:lnTo>
                          <a:lnTo>
                            <a:pt x="1413" y="956"/>
                          </a:lnTo>
                          <a:lnTo>
                            <a:pt x="1416" y="956"/>
                          </a:lnTo>
                          <a:lnTo>
                            <a:pt x="1422" y="957"/>
                          </a:lnTo>
                          <a:lnTo>
                            <a:pt x="1425" y="957"/>
                          </a:lnTo>
                          <a:lnTo>
                            <a:pt x="1432" y="958"/>
                          </a:lnTo>
                          <a:lnTo>
                            <a:pt x="1435" y="960"/>
                          </a:lnTo>
                          <a:lnTo>
                            <a:pt x="1441" y="960"/>
                          </a:lnTo>
                          <a:lnTo>
                            <a:pt x="1444" y="961"/>
                          </a:lnTo>
                          <a:lnTo>
                            <a:pt x="1447" y="961"/>
                          </a:lnTo>
                          <a:lnTo>
                            <a:pt x="1450" y="962"/>
                          </a:lnTo>
                          <a:lnTo>
                            <a:pt x="1450" y="962"/>
                          </a:lnTo>
                          <a:lnTo>
                            <a:pt x="1453" y="962"/>
                          </a:lnTo>
                          <a:lnTo>
                            <a:pt x="1457" y="963"/>
                          </a:lnTo>
                          <a:lnTo>
                            <a:pt x="1460" y="963"/>
                          </a:lnTo>
                          <a:lnTo>
                            <a:pt x="1466" y="965"/>
                          </a:lnTo>
                          <a:lnTo>
                            <a:pt x="1469" y="966"/>
                          </a:lnTo>
                          <a:lnTo>
                            <a:pt x="1475" y="967"/>
                          </a:lnTo>
                          <a:lnTo>
                            <a:pt x="1479" y="967"/>
                          </a:lnTo>
                          <a:lnTo>
                            <a:pt x="1485" y="969"/>
                          </a:lnTo>
                          <a:lnTo>
                            <a:pt x="1488" y="970"/>
                          </a:lnTo>
                          <a:lnTo>
                            <a:pt x="1494" y="971"/>
                          </a:lnTo>
                          <a:lnTo>
                            <a:pt x="1497" y="972"/>
                          </a:lnTo>
                          <a:lnTo>
                            <a:pt x="1500" y="974"/>
                          </a:lnTo>
                          <a:lnTo>
                            <a:pt x="1504" y="974"/>
                          </a:lnTo>
                          <a:lnTo>
                            <a:pt x="1510" y="975"/>
                          </a:lnTo>
                          <a:lnTo>
                            <a:pt x="1513" y="976"/>
                          </a:lnTo>
                          <a:lnTo>
                            <a:pt x="1513" y="976"/>
                          </a:lnTo>
                          <a:lnTo>
                            <a:pt x="1516" y="978"/>
                          </a:lnTo>
                          <a:lnTo>
                            <a:pt x="1519" y="979"/>
                          </a:lnTo>
                          <a:lnTo>
                            <a:pt x="1522" y="979"/>
                          </a:lnTo>
                          <a:lnTo>
                            <a:pt x="1529" y="980"/>
                          </a:lnTo>
                          <a:lnTo>
                            <a:pt x="1532" y="981"/>
                          </a:lnTo>
                          <a:lnTo>
                            <a:pt x="1538" y="984"/>
                          </a:lnTo>
                          <a:lnTo>
                            <a:pt x="1541" y="984"/>
                          </a:lnTo>
                          <a:lnTo>
                            <a:pt x="1541" y="984"/>
                          </a:lnTo>
                          <a:lnTo>
                            <a:pt x="1544" y="985"/>
                          </a:lnTo>
                          <a:lnTo>
                            <a:pt x="1547" y="987"/>
                          </a:lnTo>
                          <a:lnTo>
                            <a:pt x="1550" y="987"/>
                          </a:lnTo>
                          <a:lnTo>
                            <a:pt x="1555" y="988"/>
                          </a:lnTo>
                          <a:lnTo>
                            <a:pt x="1557" y="988"/>
                          </a:lnTo>
                          <a:lnTo>
                            <a:pt x="1563" y="989"/>
                          </a:lnTo>
                          <a:lnTo>
                            <a:pt x="1566" y="990"/>
                          </a:lnTo>
                          <a:lnTo>
                            <a:pt x="1572" y="992"/>
                          </a:lnTo>
                          <a:lnTo>
                            <a:pt x="1575" y="992"/>
                          </a:lnTo>
                          <a:lnTo>
                            <a:pt x="1575" y="992"/>
                          </a:lnTo>
                          <a:lnTo>
                            <a:pt x="1580" y="993"/>
                          </a:lnTo>
                          <a:lnTo>
                            <a:pt x="1583" y="993"/>
                          </a:lnTo>
                          <a:lnTo>
                            <a:pt x="1586" y="994"/>
                          </a:lnTo>
                          <a:lnTo>
                            <a:pt x="1591" y="996"/>
                          </a:lnTo>
                          <a:lnTo>
                            <a:pt x="1594" y="996"/>
                          </a:lnTo>
                          <a:lnTo>
                            <a:pt x="1600" y="997"/>
                          </a:lnTo>
                          <a:lnTo>
                            <a:pt x="1603" y="997"/>
                          </a:lnTo>
                          <a:lnTo>
                            <a:pt x="1608" y="998"/>
                          </a:lnTo>
                          <a:lnTo>
                            <a:pt x="1611" y="998"/>
                          </a:lnTo>
                          <a:lnTo>
                            <a:pt x="1616" y="998"/>
                          </a:lnTo>
                          <a:lnTo>
                            <a:pt x="1619" y="999"/>
                          </a:lnTo>
                          <a:lnTo>
                            <a:pt x="1625" y="999"/>
                          </a:lnTo>
                          <a:lnTo>
                            <a:pt x="1628" y="999"/>
                          </a:lnTo>
                          <a:lnTo>
                            <a:pt x="1636" y="999"/>
                          </a:lnTo>
                          <a:lnTo>
                            <a:pt x="1639" y="999"/>
                          </a:lnTo>
                          <a:lnTo>
                            <a:pt x="1644" y="999"/>
                          </a:lnTo>
                          <a:lnTo>
                            <a:pt x="1647" y="999"/>
                          </a:lnTo>
                          <a:lnTo>
                            <a:pt x="1650" y="999"/>
                          </a:lnTo>
                          <a:lnTo>
                            <a:pt x="1653" y="1001"/>
                          </a:lnTo>
                          <a:lnTo>
                            <a:pt x="1653" y="1001"/>
                          </a:lnTo>
                          <a:lnTo>
                            <a:pt x="1658" y="1001"/>
                          </a:lnTo>
                          <a:lnTo>
                            <a:pt x="1661" y="1001"/>
                          </a:lnTo>
                          <a:lnTo>
                            <a:pt x="1664" y="1001"/>
                          </a:lnTo>
                          <a:lnTo>
                            <a:pt x="1667" y="1001"/>
                          </a:lnTo>
                          <a:lnTo>
                            <a:pt x="1670" y="999"/>
                          </a:lnTo>
                          <a:lnTo>
                            <a:pt x="1670" y="999"/>
                          </a:lnTo>
                          <a:lnTo>
                            <a:pt x="1673" y="999"/>
                          </a:lnTo>
                          <a:lnTo>
                            <a:pt x="1678" y="999"/>
                          </a:lnTo>
                          <a:lnTo>
                            <a:pt x="1683" y="999"/>
                          </a:lnTo>
                          <a:lnTo>
                            <a:pt x="1689" y="999"/>
                          </a:lnTo>
                          <a:lnTo>
                            <a:pt x="1692" y="999"/>
                          </a:lnTo>
                          <a:lnTo>
                            <a:pt x="1698" y="999"/>
                          </a:lnTo>
                          <a:lnTo>
                            <a:pt x="1701" y="999"/>
                          </a:lnTo>
                          <a:lnTo>
                            <a:pt x="1705" y="999"/>
                          </a:lnTo>
                          <a:lnTo>
                            <a:pt x="1708" y="998"/>
                          </a:lnTo>
                          <a:lnTo>
                            <a:pt x="1714" y="998"/>
                          </a:lnTo>
                          <a:lnTo>
                            <a:pt x="1717" y="998"/>
                          </a:lnTo>
                          <a:lnTo>
                            <a:pt x="1723" y="997"/>
                          </a:lnTo>
                          <a:lnTo>
                            <a:pt x="1726" y="997"/>
                          </a:lnTo>
                          <a:lnTo>
                            <a:pt x="1733" y="997"/>
                          </a:lnTo>
                          <a:lnTo>
                            <a:pt x="1736" y="997"/>
                          </a:lnTo>
                          <a:lnTo>
                            <a:pt x="1742" y="996"/>
                          </a:lnTo>
                          <a:lnTo>
                            <a:pt x="1745" y="996"/>
                          </a:lnTo>
                          <a:lnTo>
                            <a:pt x="1751" y="996"/>
                          </a:lnTo>
                          <a:lnTo>
                            <a:pt x="1755" y="994"/>
                          </a:lnTo>
                          <a:lnTo>
                            <a:pt x="1758" y="994"/>
                          </a:lnTo>
                          <a:lnTo>
                            <a:pt x="1761" y="994"/>
                          </a:lnTo>
                          <a:lnTo>
                            <a:pt x="1767" y="994"/>
                          </a:lnTo>
                          <a:lnTo>
                            <a:pt x="1770" y="993"/>
                          </a:lnTo>
                          <a:lnTo>
                            <a:pt x="1776" y="993"/>
                          </a:lnTo>
                          <a:lnTo>
                            <a:pt x="1780" y="993"/>
                          </a:lnTo>
                          <a:lnTo>
                            <a:pt x="1783" y="993"/>
                          </a:lnTo>
                          <a:lnTo>
                            <a:pt x="1786" y="992"/>
                          </a:lnTo>
                          <a:lnTo>
                            <a:pt x="1786" y="992"/>
                          </a:lnTo>
                          <a:lnTo>
                            <a:pt x="1789" y="992"/>
                          </a:lnTo>
                          <a:lnTo>
                            <a:pt x="1795" y="992"/>
                          </a:lnTo>
                          <a:lnTo>
                            <a:pt x="1798" y="990"/>
                          </a:lnTo>
                          <a:lnTo>
                            <a:pt x="1801" y="990"/>
                          </a:lnTo>
                          <a:lnTo>
                            <a:pt x="1805" y="990"/>
                          </a:lnTo>
                          <a:lnTo>
                            <a:pt x="1811" y="990"/>
                          </a:lnTo>
                          <a:lnTo>
                            <a:pt x="1814" y="990"/>
                          </a:lnTo>
                          <a:lnTo>
                            <a:pt x="1820" y="989"/>
                          </a:lnTo>
                          <a:lnTo>
                            <a:pt x="1823" y="989"/>
                          </a:lnTo>
                          <a:lnTo>
                            <a:pt x="1829" y="989"/>
                          </a:lnTo>
                          <a:lnTo>
                            <a:pt x="1833" y="989"/>
                          </a:lnTo>
                          <a:lnTo>
                            <a:pt x="1839" y="989"/>
                          </a:lnTo>
                          <a:lnTo>
                            <a:pt x="1842" y="989"/>
                          </a:lnTo>
                          <a:lnTo>
                            <a:pt x="1848" y="989"/>
                          </a:lnTo>
                          <a:lnTo>
                            <a:pt x="1851" y="989"/>
                          </a:lnTo>
                          <a:lnTo>
                            <a:pt x="1854" y="989"/>
                          </a:lnTo>
                          <a:lnTo>
                            <a:pt x="1858" y="989"/>
                          </a:lnTo>
                          <a:lnTo>
                            <a:pt x="1864" y="989"/>
                          </a:lnTo>
                          <a:lnTo>
                            <a:pt x="1867" y="989"/>
                          </a:lnTo>
                          <a:lnTo>
                            <a:pt x="1873" y="989"/>
                          </a:lnTo>
                          <a:lnTo>
                            <a:pt x="1876" y="989"/>
                          </a:lnTo>
                          <a:lnTo>
                            <a:pt x="1883" y="989"/>
                          </a:lnTo>
                          <a:lnTo>
                            <a:pt x="1886" y="989"/>
                          </a:lnTo>
                          <a:lnTo>
                            <a:pt x="1892" y="989"/>
                          </a:lnTo>
                          <a:lnTo>
                            <a:pt x="1895" y="989"/>
                          </a:lnTo>
                          <a:lnTo>
                            <a:pt x="1901" y="988"/>
                          </a:lnTo>
                          <a:lnTo>
                            <a:pt x="1904" y="989"/>
                          </a:lnTo>
                          <a:lnTo>
                            <a:pt x="1908" y="988"/>
                          </a:lnTo>
                          <a:lnTo>
                            <a:pt x="1911" y="989"/>
                          </a:lnTo>
                          <a:lnTo>
                            <a:pt x="1917" y="989"/>
                          </a:lnTo>
                          <a:lnTo>
                            <a:pt x="1920" y="989"/>
                          </a:lnTo>
                          <a:lnTo>
                            <a:pt x="1926" y="989"/>
                          </a:lnTo>
                          <a:lnTo>
                            <a:pt x="1931" y="989"/>
                          </a:lnTo>
                          <a:lnTo>
                            <a:pt x="1936" y="990"/>
                          </a:lnTo>
                          <a:lnTo>
                            <a:pt x="1939" y="990"/>
                          </a:lnTo>
                          <a:lnTo>
                            <a:pt x="1945" y="990"/>
                          </a:lnTo>
                          <a:lnTo>
                            <a:pt x="1948" y="990"/>
                          </a:lnTo>
                          <a:lnTo>
                            <a:pt x="1951" y="992"/>
                          </a:lnTo>
                          <a:lnTo>
                            <a:pt x="1956" y="992"/>
                          </a:lnTo>
                          <a:lnTo>
                            <a:pt x="1956" y="992"/>
                          </a:lnTo>
                          <a:lnTo>
                            <a:pt x="1959" y="993"/>
                          </a:lnTo>
                          <a:lnTo>
                            <a:pt x="1962" y="993"/>
                          </a:lnTo>
                          <a:lnTo>
                            <a:pt x="1965" y="993"/>
                          </a:lnTo>
                          <a:lnTo>
                            <a:pt x="1970" y="994"/>
                          </a:lnTo>
                          <a:lnTo>
                            <a:pt x="1973" y="994"/>
                          </a:lnTo>
                          <a:lnTo>
                            <a:pt x="1981" y="994"/>
                          </a:lnTo>
                          <a:lnTo>
                            <a:pt x="1984" y="996"/>
                          </a:lnTo>
                          <a:lnTo>
                            <a:pt x="1990" y="996"/>
                          </a:lnTo>
                          <a:lnTo>
                            <a:pt x="1993" y="996"/>
                          </a:lnTo>
                          <a:lnTo>
                            <a:pt x="1998" y="997"/>
                          </a:lnTo>
                          <a:lnTo>
                            <a:pt x="2001" y="997"/>
                          </a:lnTo>
                          <a:lnTo>
                            <a:pt x="2006" y="997"/>
                          </a:lnTo>
                          <a:lnTo>
                            <a:pt x="2009" y="997"/>
                          </a:lnTo>
                          <a:lnTo>
                            <a:pt x="2015" y="998"/>
                          </a:lnTo>
                          <a:lnTo>
                            <a:pt x="2018" y="998"/>
                          </a:lnTo>
                          <a:lnTo>
                            <a:pt x="2023" y="999"/>
                          </a:lnTo>
                          <a:lnTo>
                            <a:pt x="2026" y="999"/>
                          </a:lnTo>
                          <a:lnTo>
                            <a:pt x="2034" y="999"/>
                          </a:lnTo>
                          <a:lnTo>
                            <a:pt x="2037" y="1001"/>
                          </a:lnTo>
                          <a:lnTo>
                            <a:pt x="2043" y="1001"/>
                          </a:lnTo>
                          <a:lnTo>
                            <a:pt x="2046" y="1002"/>
                          </a:lnTo>
                          <a:lnTo>
                            <a:pt x="2052" y="1002"/>
                          </a:lnTo>
                          <a:lnTo>
                            <a:pt x="2054" y="1002"/>
                          </a:lnTo>
                          <a:lnTo>
                            <a:pt x="2059" y="1002"/>
                          </a:lnTo>
                          <a:lnTo>
                            <a:pt x="2062" y="1003"/>
                          </a:lnTo>
                          <a:lnTo>
                            <a:pt x="2068" y="1003"/>
                          </a:lnTo>
                          <a:lnTo>
                            <a:pt x="2071" y="1003"/>
                          </a:lnTo>
                          <a:lnTo>
                            <a:pt x="2077" y="1003"/>
                          </a:lnTo>
                          <a:lnTo>
                            <a:pt x="2080" y="1003"/>
                          </a:lnTo>
                          <a:lnTo>
                            <a:pt x="2087" y="1003"/>
                          </a:lnTo>
                          <a:lnTo>
                            <a:pt x="2090" y="1003"/>
                          </a:lnTo>
                          <a:lnTo>
                            <a:pt x="2096" y="1003"/>
                          </a:lnTo>
                          <a:lnTo>
                            <a:pt x="2099" y="1003"/>
                          </a:lnTo>
                          <a:lnTo>
                            <a:pt x="2105" y="1003"/>
                          </a:lnTo>
                          <a:lnTo>
                            <a:pt x="2109" y="1003"/>
                          </a:lnTo>
                          <a:lnTo>
                            <a:pt x="2112" y="1003"/>
                          </a:lnTo>
                          <a:lnTo>
                            <a:pt x="2115" y="1003"/>
                          </a:lnTo>
                          <a:lnTo>
                            <a:pt x="2121" y="1003"/>
                          </a:lnTo>
                          <a:lnTo>
                            <a:pt x="2124" y="1003"/>
                          </a:lnTo>
                          <a:lnTo>
                            <a:pt x="2130" y="1003"/>
                          </a:lnTo>
                          <a:lnTo>
                            <a:pt x="2134" y="1002"/>
                          </a:lnTo>
                          <a:lnTo>
                            <a:pt x="2140" y="1002"/>
                          </a:lnTo>
                          <a:lnTo>
                            <a:pt x="2143" y="1002"/>
                          </a:lnTo>
                          <a:lnTo>
                            <a:pt x="2149" y="1001"/>
                          </a:lnTo>
                          <a:lnTo>
                            <a:pt x="2152" y="1001"/>
                          </a:lnTo>
                          <a:lnTo>
                            <a:pt x="2156" y="1001"/>
                          </a:lnTo>
                          <a:lnTo>
                            <a:pt x="2159" y="1001"/>
                          </a:lnTo>
                          <a:lnTo>
                            <a:pt x="2162" y="1001"/>
                          </a:lnTo>
                          <a:lnTo>
                            <a:pt x="2165" y="999"/>
                          </a:lnTo>
                          <a:lnTo>
                            <a:pt x="2165" y="999"/>
                          </a:lnTo>
                          <a:lnTo>
                            <a:pt x="2168" y="999"/>
                          </a:lnTo>
                          <a:lnTo>
                            <a:pt x="2174" y="999"/>
                          </a:lnTo>
                          <a:lnTo>
                            <a:pt x="2177" y="999"/>
                          </a:lnTo>
                          <a:lnTo>
                            <a:pt x="2184" y="998"/>
                          </a:lnTo>
                          <a:lnTo>
                            <a:pt x="2187" y="998"/>
                          </a:lnTo>
                          <a:lnTo>
                            <a:pt x="2193" y="998"/>
                          </a:lnTo>
                          <a:lnTo>
                            <a:pt x="2196" y="997"/>
                          </a:lnTo>
                          <a:lnTo>
                            <a:pt x="2202" y="997"/>
                          </a:lnTo>
                          <a:lnTo>
                            <a:pt x="2206" y="997"/>
                          </a:lnTo>
                          <a:lnTo>
                            <a:pt x="2209" y="996"/>
                          </a:lnTo>
                          <a:lnTo>
                            <a:pt x="2212" y="996"/>
                          </a:lnTo>
                          <a:lnTo>
                            <a:pt x="2218" y="996"/>
                          </a:lnTo>
                          <a:lnTo>
                            <a:pt x="2221" y="996"/>
                          </a:lnTo>
                          <a:lnTo>
                            <a:pt x="2227" y="994"/>
                          </a:lnTo>
                          <a:lnTo>
                            <a:pt x="2231" y="994"/>
                          </a:lnTo>
                          <a:lnTo>
                            <a:pt x="2237" y="993"/>
                          </a:lnTo>
                          <a:lnTo>
                            <a:pt x="2240" y="993"/>
                          </a:lnTo>
                        </a:path>
                      </a:pathLst>
                    </a:custGeom>
                    <a:noFill/>
                    <a:ln w="14288">
                      <a:solidFill>
                        <a:srgbClr val="C000C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4" name="Freeform 32">
                      <a:extLst>
                        <a:ext uri="{FF2B5EF4-FFF2-40B4-BE49-F238E27FC236}">
                          <a16:creationId xmlns:a16="http://schemas.microsoft.com/office/drawing/2014/main" id="{C2B673DE-5051-4744-A1EA-D67F52BF1E6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1314450" y="4233863"/>
                      <a:ext cx="1778000" cy="349250"/>
                    </a:xfrm>
                    <a:custGeom>
                      <a:avLst/>
                      <a:gdLst>
                        <a:gd name="T0" fmla="*/ 12 w 2240"/>
                        <a:gd name="T1" fmla="*/ 20 h 441"/>
                        <a:gd name="T2" fmla="*/ 34 w 2240"/>
                        <a:gd name="T3" fmla="*/ 68 h 441"/>
                        <a:gd name="T4" fmla="*/ 49 w 2240"/>
                        <a:gd name="T5" fmla="*/ 107 h 441"/>
                        <a:gd name="T6" fmla="*/ 68 w 2240"/>
                        <a:gd name="T7" fmla="*/ 159 h 441"/>
                        <a:gd name="T8" fmla="*/ 84 w 2240"/>
                        <a:gd name="T9" fmla="*/ 203 h 441"/>
                        <a:gd name="T10" fmla="*/ 103 w 2240"/>
                        <a:gd name="T11" fmla="*/ 252 h 441"/>
                        <a:gd name="T12" fmla="*/ 121 w 2240"/>
                        <a:gd name="T13" fmla="*/ 293 h 441"/>
                        <a:gd name="T14" fmla="*/ 140 w 2240"/>
                        <a:gd name="T15" fmla="*/ 325 h 441"/>
                        <a:gd name="T16" fmla="*/ 165 w 2240"/>
                        <a:gd name="T17" fmla="*/ 355 h 441"/>
                        <a:gd name="T18" fmla="*/ 213 w 2240"/>
                        <a:gd name="T19" fmla="*/ 372 h 441"/>
                        <a:gd name="T20" fmla="*/ 249 w 2240"/>
                        <a:gd name="T21" fmla="*/ 356 h 441"/>
                        <a:gd name="T22" fmla="*/ 274 w 2240"/>
                        <a:gd name="T23" fmla="*/ 332 h 441"/>
                        <a:gd name="T24" fmla="*/ 300 w 2240"/>
                        <a:gd name="T25" fmla="*/ 297 h 441"/>
                        <a:gd name="T26" fmla="*/ 329 w 2240"/>
                        <a:gd name="T27" fmla="*/ 258 h 441"/>
                        <a:gd name="T28" fmla="*/ 360 w 2240"/>
                        <a:gd name="T29" fmla="*/ 225 h 441"/>
                        <a:gd name="T30" fmla="*/ 394 w 2240"/>
                        <a:gd name="T31" fmla="*/ 217 h 441"/>
                        <a:gd name="T32" fmla="*/ 432 w 2240"/>
                        <a:gd name="T33" fmla="*/ 238 h 441"/>
                        <a:gd name="T34" fmla="*/ 466 w 2240"/>
                        <a:gd name="T35" fmla="*/ 271 h 441"/>
                        <a:gd name="T36" fmla="*/ 491 w 2240"/>
                        <a:gd name="T37" fmla="*/ 299 h 441"/>
                        <a:gd name="T38" fmla="*/ 513 w 2240"/>
                        <a:gd name="T39" fmla="*/ 324 h 441"/>
                        <a:gd name="T40" fmla="*/ 538 w 2240"/>
                        <a:gd name="T41" fmla="*/ 350 h 441"/>
                        <a:gd name="T42" fmla="*/ 564 w 2240"/>
                        <a:gd name="T43" fmla="*/ 372 h 441"/>
                        <a:gd name="T44" fmla="*/ 597 w 2240"/>
                        <a:gd name="T45" fmla="*/ 392 h 441"/>
                        <a:gd name="T46" fmla="*/ 639 w 2240"/>
                        <a:gd name="T47" fmla="*/ 406 h 441"/>
                        <a:gd name="T48" fmla="*/ 689 w 2240"/>
                        <a:gd name="T49" fmla="*/ 408 h 441"/>
                        <a:gd name="T50" fmla="*/ 726 w 2240"/>
                        <a:gd name="T51" fmla="*/ 401 h 441"/>
                        <a:gd name="T52" fmla="*/ 767 w 2240"/>
                        <a:gd name="T53" fmla="*/ 390 h 441"/>
                        <a:gd name="T54" fmla="*/ 811 w 2240"/>
                        <a:gd name="T55" fmla="*/ 378 h 441"/>
                        <a:gd name="T56" fmla="*/ 856 w 2240"/>
                        <a:gd name="T57" fmla="*/ 375 h 441"/>
                        <a:gd name="T58" fmla="*/ 903 w 2240"/>
                        <a:gd name="T59" fmla="*/ 382 h 441"/>
                        <a:gd name="T60" fmla="*/ 945 w 2240"/>
                        <a:gd name="T61" fmla="*/ 392 h 441"/>
                        <a:gd name="T62" fmla="*/ 984 w 2240"/>
                        <a:gd name="T63" fmla="*/ 405 h 441"/>
                        <a:gd name="T64" fmla="*/ 1031 w 2240"/>
                        <a:gd name="T65" fmla="*/ 417 h 441"/>
                        <a:gd name="T66" fmla="*/ 1071 w 2240"/>
                        <a:gd name="T67" fmla="*/ 423 h 441"/>
                        <a:gd name="T68" fmla="*/ 1112 w 2240"/>
                        <a:gd name="T69" fmla="*/ 427 h 441"/>
                        <a:gd name="T70" fmla="*/ 1159 w 2240"/>
                        <a:gd name="T71" fmla="*/ 427 h 441"/>
                        <a:gd name="T72" fmla="*/ 1207 w 2240"/>
                        <a:gd name="T73" fmla="*/ 426 h 441"/>
                        <a:gd name="T74" fmla="*/ 1249 w 2240"/>
                        <a:gd name="T75" fmla="*/ 423 h 441"/>
                        <a:gd name="T76" fmla="*/ 1299 w 2240"/>
                        <a:gd name="T77" fmla="*/ 422 h 441"/>
                        <a:gd name="T78" fmla="*/ 1347 w 2240"/>
                        <a:gd name="T79" fmla="*/ 422 h 441"/>
                        <a:gd name="T80" fmla="*/ 1391 w 2240"/>
                        <a:gd name="T81" fmla="*/ 424 h 441"/>
                        <a:gd name="T82" fmla="*/ 1435 w 2240"/>
                        <a:gd name="T83" fmla="*/ 429 h 441"/>
                        <a:gd name="T84" fmla="*/ 1475 w 2240"/>
                        <a:gd name="T85" fmla="*/ 433 h 441"/>
                        <a:gd name="T86" fmla="*/ 1522 w 2240"/>
                        <a:gd name="T87" fmla="*/ 437 h 441"/>
                        <a:gd name="T88" fmla="*/ 1572 w 2240"/>
                        <a:gd name="T89" fmla="*/ 438 h 441"/>
                        <a:gd name="T90" fmla="*/ 1619 w 2240"/>
                        <a:gd name="T91" fmla="*/ 438 h 441"/>
                        <a:gd name="T92" fmla="*/ 1670 w 2240"/>
                        <a:gd name="T93" fmla="*/ 437 h 441"/>
                        <a:gd name="T94" fmla="*/ 1717 w 2240"/>
                        <a:gd name="T95" fmla="*/ 436 h 441"/>
                        <a:gd name="T96" fmla="*/ 1767 w 2240"/>
                        <a:gd name="T97" fmla="*/ 435 h 441"/>
                        <a:gd name="T98" fmla="*/ 1814 w 2240"/>
                        <a:gd name="T99" fmla="*/ 435 h 441"/>
                        <a:gd name="T100" fmla="*/ 1864 w 2240"/>
                        <a:gd name="T101" fmla="*/ 437 h 441"/>
                        <a:gd name="T102" fmla="*/ 1911 w 2240"/>
                        <a:gd name="T103" fmla="*/ 438 h 441"/>
                        <a:gd name="T104" fmla="*/ 1962 w 2240"/>
                        <a:gd name="T105" fmla="*/ 440 h 441"/>
                        <a:gd name="T106" fmla="*/ 2001 w 2240"/>
                        <a:gd name="T107" fmla="*/ 441 h 441"/>
                        <a:gd name="T108" fmla="*/ 2052 w 2240"/>
                        <a:gd name="T109" fmla="*/ 441 h 441"/>
                        <a:gd name="T110" fmla="*/ 2099 w 2240"/>
                        <a:gd name="T111" fmla="*/ 441 h 441"/>
                        <a:gd name="T112" fmla="*/ 2140 w 2240"/>
                        <a:gd name="T113" fmla="*/ 440 h 441"/>
                        <a:gd name="T114" fmla="*/ 2187 w 2240"/>
                        <a:gd name="T115" fmla="*/ 437 h 441"/>
                        <a:gd name="T116" fmla="*/ 2237 w 2240"/>
                        <a:gd name="T117" fmla="*/ 436 h 441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  <a:cxn ang="0">
                          <a:pos x="T12" y="T13"/>
                        </a:cxn>
                        <a:cxn ang="0">
                          <a:pos x="T14" y="T15"/>
                        </a:cxn>
                        <a:cxn ang="0">
                          <a:pos x="T16" y="T17"/>
                        </a:cxn>
                        <a:cxn ang="0">
                          <a:pos x="T18" y="T19"/>
                        </a:cxn>
                        <a:cxn ang="0">
                          <a:pos x="T20" y="T21"/>
                        </a:cxn>
                        <a:cxn ang="0">
                          <a:pos x="T22" y="T23"/>
                        </a:cxn>
                        <a:cxn ang="0">
                          <a:pos x="T24" y="T25"/>
                        </a:cxn>
                        <a:cxn ang="0">
                          <a:pos x="T26" y="T27"/>
                        </a:cxn>
                        <a:cxn ang="0">
                          <a:pos x="T28" y="T29"/>
                        </a:cxn>
                        <a:cxn ang="0">
                          <a:pos x="T30" y="T31"/>
                        </a:cxn>
                        <a:cxn ang="0">
                          <a:pos x="T32" y="T33"/>
                        </a:cxn>
                        <a:cxn ang="0">
                          <a:pos x="T34" y="T35"/>
                        </a:cxn>
                        <a:cxn ang="0">
                          <a:pos x="T36" y="T37"/>
                        </a:cxn>
                        <a:cxn ang="0">
                          <a:pos x="T38" y="T39"/>
                        </a:cxn>
                        <a:cxn ang="0">
                          <a:pos x="T40" y="T41"/>
                        </a:cxn>
                        <a:cxn ang="0">
                          <a:pos x="T42" y="T43"/>
                        </a:cxn>
                        <a:cxn ang="0">
                          <a:pos x="T44" y="T45"/>
                        </a:cxn>
                        <a:cxn ang="0">
                          <a:pos x="T46" y="T47"/>
                        </a:cxn>
                        <a:cxn ang="0">
                          <a:pos x="T48" y="T49"/>
                        </a:cxn>
                        <a:cxn ang="0">
                          <a:pos x="T50" y="T51"/>
                        </a:cxn>
                        <a:cxn ang="0">
                          <a:pos x="T52" y="T53"/>
                        </a:cxn>
                        <a:cxn ang="0">
                          <a:pos x="T54" y="T55"/>
                        </a:cxn>
                        <a:cxn ang="0">
                          <a:pos x="T56" y="T57"/>
                        </a:cxn>
                        <a:cxn ang="0">
                          <a:pos x="T58" y="T59"/>
                        </a:cxn>
                        <a:cxn ang="0">
                          <a:pos x="T60" y="T61"/>
                        </a:cxn>
                        <a:cxn ang="0">
                          <a:pos x="T62" y="T63"/>
                        </a:cxn>
                        <a:cxn ang="0">
                          <a:pos x="T64" y="T65"/>
                        </a:cxn>
                        <a:cxn ang="0">
                          <a:pos x="T66" y="T67"/>
                        </a:cxn>
                        <a:cxn ang="0">
                          <a:pos x="T68" y="T69"/>
                        </a:cxn>
                        <a:cxn ang="0">
                          <a:pos x="T70" y="T71"/>
                        </a:cxn>
                        <a:cxn ang="0">
                          <a:pos x="T72" y="T73"/>
                        </a:cxn>
                        <a:cxn ang="0">
                          <a:pos x="T74" y="T75"/>
                        </a:cxn>
                        <a:cxn ang="0">
                          <a:pos x="T76" y="T77"/>
                        </a:cxn>
                        <a:cxn ang="0">
                          <a:pos x="T78" y="T79"/>
                        </a:cxn>
                        <a:cxn ang="0">
                          <a:pos x="T80" y="T81"/>
                        </a:cxn>
                        <a:cxn ang="0">
                          <a:pos x="T82" y="T83"/>
                        </a:cxn>
                        <a:cxn ang="0">
                          <a:pos x="T84" y="T85"/>
                        </a:cxn>
                        <a:cxn ang="0">
                          <a:pos x="T86" y="T87"/>
                        </a:cxn>
                        <a:cxn ang="0">
                          <a:pos x="T88" y="T89"/>
                        </a:cxn>
                        <a:cxn ang="0">
                          <a:pos x="T90" y="T91"/>
                        </a:cxn>
                        <a:cxn ang="0">
                          <a:pos x="T92" y="T93"/>
                        </a:cxn>
                        <a:cxn ang="0">
                          <a:pos x="T94" y="T95"/>
                        </a:cxn>
                        <a:cxn ang="0">
                          <a:pos x="T96" y="T97"/>
                        </a:cxn>
                        <a:cxn ang="0">
                          <a:pos x="T98" y="T99"/>
                        </a:cxn>
                        <a:cxn ang="0">
                          <a:pos x="T100" y="T101"/>
                        </a:cxn>
                        <a:cxn ang="0">
                          <a:pos x="T102" y="T103"/>
                        </a:cxn>
                        <a:cxn ang="0">
                          <a:pos x="T104" y="T105"/>
                        </a:cxn>
                        <a:cxn ang="0">
                          <a:pos x="T106" y="T107"/>
                        </a:cxn>
                        <a:cxn ang="0">
                          <a:pos x="T108" y="T109"/>
                        </a:cxn>
                        <a:cxn ang="0">
                          <a:pos x="T110" y="T111"/>
                        </a:cxn>
                        <a:cxn ang="0">
                          <a:pos x="T112" y="T113"/>
                        </a:cxn>
                        <a:cxn ang="0">
                          <a:pos x="T114" y="T115"/>
                        </a:cxn>
                        <a:cxn ang="0">
                          <a:pos x="T116" y="T117"/>
                        </a:cxn>
                      </a:cxnLst>
                      <a:rect l="0" t="0" r="r" b="b"/>
                      <a:pathLst>
                        <a:path w="2240" h="441">
                          <a:moveTo>
                            <a:pt x="0" y="0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  <a:lnTo>
                            <a:pt x="3" y="5"/>
                          </a:lnTo>
                          <a:lnTo>
                            <a:pt x="3" y="5"/>
                          </a:lnTo>
                          <a:lnTo>
                            <a:pt x="6" y="10"/>
                          </a:lnTo>
                          <a:lnTo>
                            <a:pt x="6" y="10"/>
                          </a:lnTo>
                          <a:lnTo>
                            <a:pt x="9" y="14"/>
                          </a:lnTo>
                          <a:lnTo>
                            <a:pt x="9" y="14"/>
                          </a:lnTo>
                          <a:lnTo>
                            <a:pt x="12" y="20"/>
                          </a:lnTo>
                          <a:lnTo>
                            <a:pt x="12" y="20"/>
                          </a:lnTo>
                          <a:lnTo>
                            <a:pt x="15" y="25"/>
                          </a:lnTo>
                          <a:lnTo>
                            <a:pt x="15" y="25"/>
                          </a:lnTo>
                          <a:lnTo>
                            <a:pt x="18" y="32"/>
                          </a:lnTo>
                          <a:lnTo>
                            <a:pt x="21" y="38"/>
                          </a:lnTo>
                          <a:lnTo>
                            <a:pt x="24" y="45"/>
                          </a:lnTo>
                          <a:lnTo>
                            <a:pt x="24" y="45"/>
                          </a:lnTo>
                          <a:lnTo>
                            <a:pt x="28" y="53"/>
                          </a:lnTo>
                          <a:lnTo>
                            <a:pt x="28" y="53"/>
                          </a:lnTo>
                          <a:lnTo>
                            <a:pt x="31" y="60"/>
                          </a:lnTo>
                          <a:lnTo>
                            <a:pt x="31" y="60"/>
                          </a:lnTo>
                          <a:lnTo>
                            <a:pt x="34" y="68"/>
                          </a:lnTo>
                          <a:lnTo>
                            <a:pt x="34" y="68"/>
                          </a:lnTo>
                          <a:lnTo>
                            <a:pt x="37" y="76"/>
                          </a:lnTo>
                          <a:lnTo>
                            <a:pt x="37" y="76"/>
                          </a:lnTo>
                          <a:lnTo>
                            <a:pt x="40" y="83"/>
                          </a:lnTo>
                          <a:lnTo>
                            <a:pt x="40" y="83"/>
                          </a:lnTo>
                          <a:lnTo>
                            <a:pt x="43" y="91"/>
                          </a:lnTo>
                          <a:lnTo>
                            <a:pt x="43" y="91"/>
                          </a:lnTo>
                          <a:lnTo>
                            <a:pt x="46" y="99"/>
                          </a:lnTo>
                          <a:lnTo>
                            <a:pt x="46" y="99"/>
                          </a:lnTo>
                          <a:lnTo>
                            <a:pt x="49" y="107"/>
                          </a:lnTo>
                          <a:lnTo>
                            <a:pt x="49" y="107"/>
                          </a:lnTo>
                          <a:lnTo>
                            <a:pt x="53" y="116"/>
                          </a:lnTo>
                          <a:lnTo>
                            <a:pt x="53" y="116"/>
                          </a:lnTo>
                          <a:lnTo>
                            <a:pt x="56" y="125"/>
                          </a:lnTo>
                          <a:lnTo>
                            <a:pt x="56" y="125"/>
                          </a:lnTo>
                          <a:lnTo>
                            <a:pt x="59" y="134"/>
                          </a:lnTo>
                          <a:lnTo>
                            <a:pt x="59" y="134"/>
                          </a:lnTo>
                          <a:lnTo>
                            <a:pt x="62" y="141"/>
                          </a:lnTo>
                          <a:lnTo>
                            <a:pt x="62" y="141"/>
                          </a:lnTo>
                          <a:lnTo>
                            <a:pt x="65" y="150"/>
                          </a:lnTo>
                          <a:lnTo>
                            <a:pt x="65" y="150"/>
                          </a:lnTo>
                          <a:lnTo>
                            <a:pt x="68" y="159"/>
                          </a:lnTo>
                          <a:lnTo>
                            <a:pt x="68" y="159"/>
                          </a:lnTo>
                          <a:lnTo>
                            <a:pt x="71" y="168"/>
                          </a:lnTo>
                          <a:lnTo>
                            <a:pt x="71" y="168"/>
                          </a:lnTo>
                          <a:lnTo>
                            <a:pt x="74" y="176"/>
                          </a:lnTo>
                          <a:lnTo>
                            <a:pt x="74" y="176"/>
                          </a:lnTo>
                          <a:lnTo>
                            <a:pt x="78" y="186"/>
                          </a:lnTo>
                          <a:lnTo>
                            <a:pt x="78" y="186"/>
                          </a:lnTo>
                          <a:lnTo>
                            <a:pt x="81" y="194"/>
                          </a:lnTo>
                          <a:lnTo>
                            <a:pt x="81" y="194"/>
                          </a:lnTo>
                          <a:lnTo>
                            <a:pt x="84" y="203"/>
                          </a:lnTo>
                          <a:lnTo>
                            <a:pt x="84" y="203"/>
                          </a:lnTo>
                          <a:lnTo>
                            <a:pt x="87" y="211"/>
                          </a:lnTo>
                          <a:lnTo>
                            <a:pt x="87" y="211"/>
                          </a:lnTo>
                          <a:lnTo>
                            <a:pt x="90" y="220"/>
                          </a:lnTo>
                          <a:lnTo>
                            <a:pt x="90" y="220"/>
                          </a:lnTo>
                          <a:lnTo>
                            <a:pt x="93" y="227"/>
                          </a:lnTo>
                          <a:lnTo>
                            <a:pt x="93" y="227"/>
                          </a:lnTo>
                          <a:lnTo>
                            <a:pt x="96" y="235"/>
                          </a:lnTo>
                          <a:lnTo>
                            <a:pt x="96" y="235"/>
                          </a:lnTo>
                          <a:lnTo>
                            <a:pt x="99" y="244"/>
                          </a:lnTo>
                          <a:lnTo>
                            <a:pt x="99" y="244"/>
                          </a:lnTo>
                          <a:lnTo>
                            <a:pt x="103" y="252"/>
                          </a:lnTo>
                          <a:lnTo>
                            <a:pt x="103" y="252"/>
                          </a:lnTo>
                          <a:lnTo>
                            <a:pt x="106" y="260"/>
                          </a:lnTo>
                          <a:lnTo>
                            <a:pt x="106" y="260"/>
                          </a:lnTo>
                          <a:lnTo>
                            <a:pt x="109" y="267"/>
                          </a:lnTo>
                          <a:lnTo>
                            <a:pt x="109" y="267"/>
                          </a:lnTo>
                          <a:lnTo>
                            <a:pt x="112" y="274"/>
                          </a:lnTo>
                          <a:lnTo>
                            <a:pt x="112" y="274"/>
                          </a:lnTo>
                          <a:lnTo>
                            <a:pt x="115" y="280"/>
                          </a:lnTo>
                          <a:lnTo>
                            <a:pt x="115" y="280"/>
                          </a:lnTo>
                          <a:lnTo>
                            <a:pt x="118" y="287"/>
                          </a:lnTo>
                          <a:lnTo>
                            <a:pt x="121" y="293"/>
                          </a:lnTo>
                          <a:lnTo>
                            <a:pt x="126" y="299"/>
                          </a:lnTo>
                          <a:lnTo>
                            <a:pt x="126" y="299"/>
                          </a:lnTo>
                          <a:lnTo>
                            <a:pt x="128" y="305"/>
                          </a:lnTo>
                          <a:lnTo>
                            <a:pt x="128" y="305"/>
                          </a:lnTo>
                          <a:lnTo>
                            <a:pt x="131" y="311"/>
                          </a:lnTo>
                          <a:lnTo>
                            <a:pt x="131" y="311"/>
                          </a:lnTo>
                          <a:lnTo>
                            <a:pt x="134" y="316"/>
                          </a:lnTo>
                          <a:lnTo>
                            <a:pt x="134" y="316"/>
                          </a:lnTo>
                          <a:lnTo>
                            <a:pt x="137" y="321"/>
                          </a:lnTo>
                          <a:lnTo>
                            <a:pt x="137" y="321"/>
                          </a:lnTo>
                          <a:lnTo>
                            <a:pt x="140" y="325"/>
                          </a:lnTo>
                          <a:lnTo>
                            <a:pt x="140" y="325"/>
                          </a:lnTo>
                          <a:lnTo>
                            <a:pt x="143" y="330"/>
                          </a:lnTo>
                          <a:lnTo>
                            <a:pt x="143" y="330"/>
                          </a:lnTo>
                          <a:lnTo>
                            <a:pt x="146" y="334"/>
                          </a:lnTo>
                          <a:lnTo>
                            <a:pt x="146" y="334"/>
                          </a:lnTo>
                          <a:lnTo>
                            <a:pt x="151" y="338"/>
                          </a:lnTo>
                          <a:lnTo>
                            <a:pt x="151" y="338"/>
                          </a:lnTo>
                          <a:lnTo>
                            <a:pt x="154" y="342"/>
                          </a:lnTo>
                          <a:lnTo>
                            <a:pt x="157" y="346"/>
                          </a:lnTo>
                          <a:lnTo>
                            <a:pt x="159" y="348"/>
                          </a:lnTo>
                          <a:lnTo>
                            <a:pt x="165" y="355"/>
                          </a:lnTo>
                          <a:lnTo>
                            <a:pt x="168" y="357"/>
                          </a:lnTo>
                          <a:lnTo>
                            <a:pt x="176" y="361"/>
                          </a:lnTo>
                          <a:lnTo>
                            <a:pt x="179" y="364"/>
                          </a:lnTo>
                          <a:lnTo>
                            <a:pt x="185" y="366"/>
                          </a:lnTo>
                          <a:lnTo>
                            <a:pt x="187" y="368"/>
                          </a:lnTo>
                          <a:lnTo>
                            <a:pt x="193" y="370"/>
                          </a:lnTo>
                          <a:lnTo>
                            <a:pt x="196" y="370"/>
                          </a:lnTo>
                          <a:lnTo>
                            <a:pt x="201" y="370"/>
                          </a:lnTo>
                          <a:lnTo>
                            <a:pt x="204" y="372"/>
                          </a:lnTo>
                          <a:lnTo>
                            <a:pt x="210" y="372"/>
                          </a:lnTo>
                          <a:lnTo>
                            <a:pt x="213" y="372"/>
                          </a:lnTo>
                          <a:lnTo>
                            <a:pt x="213" y="372"/>
                          </a:lnTo>
                          <a:lnTo>
                            <a:pt x="216" y="370"/>
                          </a:lnTo>
                          <a:lnTo>
                            <a:pt x="218" y="370"/>
                          </a:lnTo>
                          <a:lnTo>
                            <a:pt x="221" y="370"/>
                          </a:lnTo>
                          <a:lnTo>
                            <a:pt x="229" y="368"/>
                          </a:lnTo>
                          <a:lnTo>
                            <a:pt x="232" y="366"/>
                          </a:lnTo>
                          <a:lnTo>
                            <a:pt x="238" y="364"/>
                          </a:lnTo>
                          <a:lnTo>
                            <a:pt x="241" y="361"/>
                          </a:lnTo>
                          <a:lnTo>
                            <a:pt x="246" y="357"/>
                          </a:lnTo>
                          <a:lnTo>
                            <a:pt x="249" y="356"/>
                          </a:lnTo>
                          <a:lnTo>
                            <a:pt x="249" y="356"/>
                          </a:lnTo>
                          <a:lnTo>
                            <a:pt x="254" y="354"/>
                          </a:lnTo>
                          <a:lnTo>
                            <a:pt x="254" y="354"/>
                          </a:lnTo>
                          <a:lnTo>
                            <a:pt x="257" y="351"/>
                          </a:lnTo>
                          <a:lnTo>
                            <a:pt x="257" y="351"/>
                          </a:lnTo>
                          <a:lnTo>
                            <a:pt x="260" y="347"/>
                          </a:lnTo>
                          <a:lnTo>
                            <a:pt x="263" y="345"/>
                          </a:lnTo>
                          <a:lnTo>
                            <a:pt x="266" y="342"/>
                          </a:lnTo>
                          <a:lnTo>
                            <a:pt x="266" y="342"/>
                          </a:lnTo>
                          <a:lnTo>
                            <a:pt x="269" y="338"/>
                          </a:lnTo>
                          <a:lnTo>
                            <a:pt x="272" y="334"/>
                          </a:lnTo>
                          <a:lnTo>
                            <a:pt x="274" y="332"/>
                          </a:lnTo>
                          <a:lnTo>
                            <a:pt x="279" y="328"/>
                          </a:lnTo>
                          <a:lnTo>
                            <a:pt x="282" y="324"/>
                          </a:lnTo>
                          <a:lnTo>
                            <a:pt x="282" y="324"/>
                          </a:lnTo>
                          <a:lnTo>
                            <a:pt x="285" y="319"/>
                          </a:lnTo>
                          <a:lnTo>
                            <a:pt x="285" y="319"/>
                          </a:lnTo>
                          <a:lnTo>
                            <a:pt x="288" y="315"/>
                          </a:lnTo>
                          <a:lnTo>
                            <a:pt x="291" y="311"/>
                          </a:lnTo>
                          <a:lnTo>
                            <a:pt x="294" y="306"/>
                          </a:lnTo>
                          <a:lnTo>
                            <a:pt x="297" y="302"/>
                          </a:lnTo>
                          <a:lnTo>
                            <a:pt x="300" y="297"/>
                          </a:lnTo>
                          <a:lnTo>
                            <a:pt x="300" y="297"/>
                          </a:lnTo>
                          <a:lnTo>
                            <a:pt x="304" y="293"/>
                          </a:lnTo>
                          <a:lnTo>
                            <a:pt x="307" y="288"/>
                          </a:lnTo>
                          <a:lnTo>
                            <a:pt x="310" y="284"/>
                          </a:lnTo>
                          <a:lnTo>
                            <a:pt x="313" y="279"/>
                          </a:lnTo>
                          <a:lnTo>
                            <a:pt x="316" y="275"/>
                          </a:lnTo>
                          <a:lnTo>
                            <a:pt x="316" y="275"/>
                          </a:lnTo>
                          <a:lnTo>
                            <a:pt x="319" y="270"/>
                          </a:lnTo>
                          <a:lnTo>
                            <a:pt x="322" y="266"/>
                          </a:lnTo>
                          <a:lnTo>
                            <a:pt x="325" y="262"/>
                          </a:lnTo>
                          <a:lnTo>
                            <a:pt x="325" y="262"/>
                          </a:lnTo>
                          <a:lnTo>
                            <a:pt x="329" y="258"/>
                          </a:lnTo>
                          <a:lnTo>
                            <a:pt x="329" y="258"/>
                          </a:lnTo>
                          <a:lnTo>
                            <a:pt x="332" y="254"/>
                          </a:lnTo>
                          <a:lnTo>
                            <a:pt x="335" y="249"/>
                          </a:lnTo>
                          <a:lnTo>
                            <a:pt x="338" y="245"/>
                          </a:lnTo>
                          <a:lnTo>
                            <a:pt x="341" y="242"/>
                          </a:lnTo>
                          <a:lnTo>
                            <a:pt x="344" y="239"/>
                          </a:lnTo>
                          <a:lnTo>
                            <a:pt x="344" y="239"/>
                          </a:lnTo>
                          <a:lnTo>
                            <a:pt x="347" y="235"/>
                          </a:lnTo>
                          <a:lnTo>
                            <a:pt x="351" y="233"/>
                          </a:lnTo>
                          <a:lnTo>
                            <a:pt x="354" y="230"/>
                          </a:lnTo>
                          <a:lnTo>
                            <a:pt x="360" y="225"/>
                          </a:lnTo>
                          <a:lnTo>
                            <a:pt x="363" y="224"/>
                          </a:lnTo>
                          <a:lnTo>
                            <a:pt x="369" y="220"/>
                          </a:lnTo>
                          <a:lnTo>
                            <a:pt x="372" y="218"/>
                          </a:lnTo>
                          <a:lnTo>
                            <a:pt x="379" y="217"/>
                          </a:lnTo>
                          <a:lnTo>
                            <a:pt x="382" y="217"/>
                          </a:lnTo>
                          <a:lnTo>
                            <a:pt x="385" y="217"/>
                          </a:lnTo>
                          <a:lnTo>
                            <a:pt x="388" y="216"/>
                          </a:lnTo>
                          <a:lnTo>
                            <a:pt x="388" y="216"/>
                          </a:lnTo>
                          <a:lnTo>
                            <a:pt x="391" y="216"/>
                          </a:lnTo>
                          <a:lnTo>
                            <a:pt x="391" y="216"/>
                          </a:lnTo>
                          <a:lnTo>
                            <a:pt x="394" y="217"/>
                          </a:lnTo>
                          <a:lnTo>
                            <a:pt x="397" y="218"/>
                          </a:lnTo>
                          <a:lnTo>
                            <a:pt x="401" y="218"/>
                          </a:lnTo>
                          <a:lnTo>
                            <a:pt x="404" y="220"/>
                          </a:lnTo>
                          <a:lnTo>
                            <a:pt x="407" y="221"/>
                          </a:lnTo>
                          <a:lnTo>
                            <a:pt x="410" y="224"/>
                          </a:lnTo>
                          <a:lnTo>
                            <a:pt x="413" y="225"/>
                          </a:lnTo>
                          <a:lnTo>
                            <a:pt x="413" y="225"/>
                          </a:lnTo>
                          <a:lnTo>
                            <a:pt x="416" y="226"/>
                          </a:lnTo>
                          <a:lnTo>
                            <a:pt x="422" y="230"/>
                          </a:lnTo>
                          <a:lnTo>
                            <a:pt x="426" y="233"/>
                          </a:lnTo>
                          <a:lnTo>
                            <a:pt x="432" y="238"/>
                          </a:lnTo>
                          <a:lnTo>
                            <a:pt x="435" y="240"/>
                          </a:lnTo>
                          <a:lnTo>
                            <a:pt x="441" y="245"/>
                          </a:lnTo>
                          <a:lnTo>
                            <a:pt x="444" y="249"/>
                          </a:lnTo>
                          <a:lnTo>
                            <a:pt x="447" y="252"/>
                          </a:lnTo>
                          <a:lnTo>
                            <a:pt x="451" y="254"/>
                          </a:lnTo>
                          <a:lnTo>
                            <a:pt x="451" y="254"/>
                          </a:lnTo>
                          <a:lnTo>
                            <a:pt x="454" y="258"/>
                          </a:lnTo>
                          <a:lnTo>
                            <a:pt x="457" y="261"/>
                          </a:lnTo>
                          <a:lnTo>
                            <a:pt x="460" y="265"/>
                          </a:lnTo>
                          <a:lnTo>
                            <a:pt x="463" y="267"/>
                          </a:lnTo>
                          <a:lnTo>
                            <a:pt x="466" y="271"/>
                          </a:lnTo>
                          <a:lnTo>
                            <a:pt x="466" y="271"/>
                          </a:lnTo>
                          <a:lnTo>
                            <a:pt x="469" y="275"/>
                          </a:lnTo>
                          <a:lnTo>
                            <a:pt x="469" y="275"/>
                          </a:lnTo>
                          <a:lnTo>
                            <a:pt x="472" y="279"/>
                          </a:lnTo>
                          <a:lnTo>
                            <a:pt x="475" y="283"/>
                          </a:lnTo>
                          <a:lnTo>
                            <a:pt x="479" y="285"/>
                          </a:lnTo>
                          <a:lnTo>
                            <a:pt x="479" y="285"/>
                          </a:lnTo>
                          <a:lnTo>
                            <a:pt x="482" y="289"/>
                          </a:lnTo>
                          <a:lnTo>
                            <a:pt x="485" y="293"/>
                          </a:lnTo>
                          <a:lnTo>
                            <a:pt x="488" y="296"/>
                          </a:lnTo>
                          <a:lnTo>
                            <a:pt x="491" y="299"/>
                          </a:lnTo>
                          <a:lnTo>
                            <a:pt x="494" y="303"/>
                          </a:lnTo>
                          <a:lnTo>
                            <a:pt x="494" y="303"/>
                          </a:lnTo>
                          <a:lnTo>
                            <a:pt x="497" y="307"/>
                          </a:lnTo>
                          <a:lnTo>
                            <a:pt x="497" y="307"/>
                          </a:lnTo>
                          <a:lnTo>
                            <a:pt x="500" y="310"/>
                          </a:lnTo>
                          <a:lnTo>
                            <a:pt x="500" y="310"/>
                          </a:lnTo>
                          <a:lnTo>
                            <a:pt x="505" y="314"/>
                          </a:lnTo>
                          <a:lnTo>
                            <a:pt x="507" y="316"/>
                          </a:lnTo>
                          <a:lnTo>
                            <a:pt x="510" y="320"/>
                          </a:lnTo>
                          <a:lnTo>
                            <a:pt x="510" y="320"/>
                          </a:lnTo>
                          <a:lnTo>
                            <a:pt x="513" y="324"/>
                          </a:lnTo>
                          <a:lnTo>
                            <a:pt x="513" y="324"/>
                          </a:lnTo>
                          <a:lnTo>
                            <a:pt x="516" y="327"/>
                          </a:lnTo>
                          <a:lnTo>
                            <a:pt x="519" y="330"/>
                          </a:lnTo>
                          <a:lnTo>
                            <a:pt x="522" y="334"/>
                          </a:lnTo>
                          <a:lnTo>
                            <a:pt x="525" y="337"/>
                          </a:lnTo>
                          <a:lnTo>
                            <a:pt x="530" y="341"/>
                          </a:lnTo>
                          <a:lnTo>
                            <a:pt x="530" y="341"/>
                          </a:lnTo>
                          <a:lnTo>
                            <a:pt x="533" y="343"/>
                          </a:lnTo>
                          <a:lnTo>
                            <a:pt x="536" y="346"/>
                          </a:lnTo>
                          <a:lnTo>
                            <a:pt x="538" y="350"/>
                          </a:lnTo>
                          <a:lnTo>
                            <a:pt x="538" y="350"/>
                          </a:lnTo>
                          <a:lnTo>
                            <a:pt x="541" y="352"/>
                          </a:lnTo>
                          <a:lnTo>
                            <a:pt x="544" y="355"/>
                          </a:lnTo>
                          <a:lnTo>
                            <a:pt x="547" y="357"/>
                          </a:lnTo>
                          <a:lnTo>
                            <a:pt x="547" y="357"/>
                          </a:lnTo>
                          <a:lnTo>
                            <a:pt x="550" y="360"/>
                          </a:lnTo>
                          <a:lnTo>
                            <a:pt x="550" y="360"/>
                          </a:lnTo>
                          <a:lnTo>
                            <a:pt x="555" y="364"/>
                          </a:lnTo>
                          <a:lnTo>
                            <a:pt x="555" y="364"/>
                          </a:lnTo>
                          <a:lnTo>
                            <a:pt x="558" y="366"/>
                          </a:lnTo>
                          <a:lnTo>
                            <a:pt x="561" y="369"/>
                          </a:lnTo>
                          <a:lnTo>
                            <a:pt x="564" y="372"/>
                          </a:lnTo>
                          <a:lnTo>
                            <a:pt x="564" y="372"/>
                          </a:lnTo>
                          <a:lnTo>
                            <a:pt x="566" y="374"/>
                          </a:lnTo>
                          <a:lnTo>
                            <a:pt x="572" y="378"/>
                          </a:lnTo>
                          <a:lnTo>
                            <a:pt x="577" y="381"/>
                          </a:lnTo>
                          <a:lnTo>
                            <a:pt x="583" y="384"/>
                          </a:lnTo>
                          <a:lnTo>
                            <a:pt x="586" y="386"/>
                          </a:lnTo>
                          <a:lnTo>
                            <a:pt x="586" y="386"/>
                          </a:lnTo>
                          <a:lnTo>
                            <a:pt x="589" y="387"/>
                          </a:lnTo>
                          <a:lnTo>
                            <a:pt x="592" y="390"/>
                          </a:lnTo>
                          <a:lnTo>
                            <a:pt x="595" y="391"/>
                          </a:lnTo>
                          <a:lnTo>
                            <a:pt x="597" y="392"/>
                          </a:lnTo>
                          <a:lnTo>
                            <a:pt x="602" y="395"/>
                          </a:lnTo>
                          <a:lnTo>
                            <a:pt x="608" y="397"/>
                          </a:lnTo>
                          <a:lnTo>
                            <a:pt x="611" y="399"/>
                          </a:lnTo>
                          <a:lnTo>
                            <a:pt x="617" y="400"/>
                          </a:lnTo>
                          <a:lnTo>
                            <a:pt x="620" y="401"/>
                          </a:lnTo>
                          <a:lnTo>
                            <a:pt x="620" y="401"/>
                          </a:lnTo>
                          <a:lnTo>
                            <a:pt x="623" y="402"/>
                          </a:lnTo>
                          <a:lnTo>
                            <a:pt x="627" y="402"/>
                          </a:lnTo>
                          <a:lnTo>
                            <a:pt x="630" y="404"/>
                          </a:lnTo>
                          <a:lnTo>
                            <a:pt x="636" y="405"/>
                          </a:lnTo>
                          <a:lnTo>
                            <a:pt x="639" y="406"/>
                          </a:lnTo>
                          <a:lnTo>
                            <a:pt x="645" y="406"/>
                          </a:lnTo>
                          <a:lnTo>
                            <a:pt x="648" y="408"/>
                          </a:lnTo>
                          <a:lnTo>
                            <a:pt x="652" y="408"/>
                          </a:lnTo>
                          <a:lnTo>
                            <a:pt x="655" y="408"/>
                          </a:lnTo>
                          <a:lnTo>
                            <a:pt x="661" y="408"/>
                          </a:lnTo>
                          <a:lnTo>
                            <a:pt x="664" y="409"/>
                          </a:lnTo>
                          <a:lnTo>
                            <a:pt x="670" y="409"/>
                          </a:lnTo>
                          <a:lnTo>
                            <a:pt x="673" y="408"/>
                          </a:lnTo>
                          <a:lnTo>
                            <a:pt x="680" y="408"/>
                          </a:lnTo>
                          <a:lnTo>
                            <a:pt x="683" y="408"/>
                          </a:lnTo>
                          <a:lnTo>
                            <a:pt x="689" y="408"/>
                          </a:lnTo>
                          <a:lnTo>
                            <a:pt x="692" y="408"/>
                          </a:lnTo>
                          <a:lnTo>
                            <a:pt x="698" y="406"/>
                          </a:lnTo>
                          <a:lnTo>
                            <a:pt x="701" y="405"/>
                          </a:lnTo>
                          <a:lnTo>
                            <a:pt x="705" y="405"/>
                          </a:lnTo>
                          <a:lnTo>
                            <a:pt x="708" y="405"/>
                          </a:lnTo>
                          <a:lnTo>
                            <a:pt x="714" y="404"/>
                          </a:lnTo>
                          <a:lnTo>
                            <a:pt x="717" y="402"/>
                          </a:lnTo>
                          <a:lnTo>
                            <a:pt x="720" y="402"/>
                          </a:lnTo>
                          <a:lnTo>
                            <a:pt x="723" y="401"/>
                          </a:lnTo>
                          <a:lnTo>
                            <a:pt x="723" y="401"/>
                          </a:lnTo>
                          <a:lnTo>
                            <a:pt x="726" y="401"/>
                          </a:lnTo>
                          <a:lnTo>
                            <a:pt x="733" y="399"/>
                          </a:lnTo>
                          <a:lnTo>
                            <a:pt x="736" y="399"/>
                          </a:lnTo>
                          <a:lnTo>
                            <a:pt x="742" y="396"/>
                          </a:lnTo>
                          <a:lnTo>
                            <a:pt x="745" y="396"/>
                          </a:lnTo>
                          <a:lnTo>
                            <a:pt x="748" y="395"/>
                          </a:lnTo>
                          <a:lnTo>
                            <a:pt x="751" y="393"/>
                          </a:lnTo>
                          <a:lnTo>
                            <a:pt x="751" y="393"/>
                          </a:lnTo>
                          <a:lnTo>
                            <a:pt x="755" y="393"/>
                          </a:lnTo>
                          <a:lnTo>
                            <a:pt x="758" y="392"/>
                          </a:lnTo>
                          <a:lnTo>
                            <a:pt x="761" y="391"/>
                          </a:lnTo>
                          <a:lnTo>
                            <a:pt x="767" y="390"/>
                          </a:lnTo>
                          <a:lnTo>
                            <a:pt x="770" y="388"/>
                          </a:lnTo>
                          <a:lnTo>
                            <a:pt x="776" y="387"/>
                          </a:lnTo>
                          <a:lnTo>
                            <a:pt x="780" y="386"/>
                          </a:lnTo>
                          <a:lnTo>
                            <a:pt x="786" y="384"/>
                          </a:lnTo>
                          <a:lnTo>
                            <a:pt x="789" y="383"/>
                          </a:lnTo>
                          <a:lnTo>
                            <a:pt x="795" y="382"/>
                          </a:lnTo>
                          <a:lnTo>
                            <a:pt x="798" y="381"/>
                          </a:lnTo>
                          <a:lnTo>
                            <a:pt x="802" y="381"/>
                          </a:lnTo>
                          <a:lnTo>
                            <a:pt x="805" y="379"/>
                          </a:lnTo>
                          <a:lnTo>
                            <a:pt x="808" y="379"/>
                          </a:lnTo>
                          <a:lnTo>
                            <a:pt x="811" y="378"/>
                          </a:lnTo>
                          <a:lnTo>
                            <a:pt x="811" y="378"/>
                          </a:lnTo>
                          <a:lnTo>
                            <a:pt x="814" y="378"/>
                          </a:lnTo>
                          <a:lnTo>
                            <a:pt x="820" y="377"/>
                          </a:lnTo>
                          <a:lnTo>
                            <a:pt x="823" y="377"/>
                          </a:lnTo>
                          <a:lnTo>
                            <a:pt x="830" y="375"/>
                          </a:lnTo>
                          <a:lnTo>
                            <a:pt x="833" y="375"/>
                          </a:lnTo>
                          <a:lnTo>
                            <a:pt x="839" y="375"/>
                          </a:lnTo>
                          <a:lnTo>
                            <a:pt x="842" y="374"/>
                          </a:lnTo>
                          <a:lnTo>
                            <a:pt x="848" y="374"/>
                          </a:lnTo>
                          <a:lnTo>
                            <a:pt x="853" y="375"/>
                          </a:lnTo>
                          <a:lnTo>
                            <a:pt x="856" y="375"/>
                          </a:lnTo>
                          <a:lnTo>
                            <a:pt x="858" y="375"/>
                          </a:lnTo>
                          <a:lnTo>
                            <a:pt x="864" y="375"/>
                          </a:lnTo>
                          <a:lnTo>
                            <a:pt x="867" y="377"/>
                          </a:lnTo>
                          <a:lnTo>
                            <a:pt x="873" y="377"/>
                          </a:lnTo>
                          <a:lnTo>
                            <a:pt x="878" y="378"/>
                          </a:lnTo>
                          <a:lnTo>
                            <a:pt x="884" y="378"/>
                          </a:lnTo>
                          <a:lnTo>
                            <a:pt x="886" y="379"/>
                          </a:lnTo>
                          <a:lnTo>
                            <a:pt x="892" y="381"/>
                          </a:lnTo>
                          <a:lnTo>
                            <a:pt x="895" y="381"/>
                          </a:lnTo>
                          <a:lnTo>
                            <a:pt x="898" y="381"/>
                          </a:lnTo>
                          <a:lnTo>
                            <a:pt x="903" y="382"/>
                          </a:lnTo>
                          <a:lnTo>
                            <a:pt x="909" y="383"/>
                          </a:lnTo>
                          <a:lnTo>
                            <a:pt x="912" y="383"/>
                          </a:lnTo>
                          <a:lnTo>
                            <a:pt x="917" y="384"/>
                          </a:lnTo>
                          <a:lnTo>
                            <a:pt x="920" y="386"/>
                          </a:lnTo>
                          <a:lnTo>
                            <a:pt x="920" y="386"/>
                          </a:lnTo>
                          <a:lnTo>
                            <a:pt x="923" y="387"/>
                          </a:lnTo>
                          <a:lnTo>
                            <a:pt x="926" y="387"/>
                          </a:lnTo>
                          <a:lnTo>
                            <a:pt x="931" y="388"/>
                          </a:lnTo>
                          <a:lnTo>
                            <a:pt x="937" y="391"/>
                          </a:lnTo>
                          <a:lnTo>
                            <a:pt x="940" y="391"/>
                          </a:lnTo>
                          <a:lnTo>
                            <a:pt x="945" y="392"/>
                          </a:lnTo>
                          <a:lnTo>
                            <a:pt x="948" y="393"/>
                          </a:lnTo>
                          <a:lnTo>
                            <a:pt x="948" y="393"/>
                          </a:lnTo>
                          <a:lnTo>
                            <a:pt x="951" y="395"/>
                          </a:lnTo>
                          <a:lnTo>
                            <a:pt x="951" y="395"/>
                          </a:lnTo>
                          <a:lnTo>
                            <a:pt x="956" y="396"/>
                          </a:lnTo>
                          <a:lnTo>
                            <a:pt x="962" y="397"/>
                          </a:lnTo>
                          <a:lnTo>
                            <a:pt x="965" y="399"/>
                          </a:lnTo>
                          <a:lnTo>
                            <a:pt x="971" y="401"/>
                          </a:lnTo>
                          <a:lnTo>
                            <a:pt x="974" y="402"/>
                          </a:lnTo>
                          <a:lnTo>
                            <a:pt x="981" y="404"/>
                          </a:lnTo>
                          <a:lnTo>
                            <a:pt x="984" y="405"/>
                          </a:lnTo>
                          <a:lnTo>
                            <a:pt x="990" y="406"/>
                          </a:lnTo>
                          <a:lnTo>
                            <a:pt x="993" y="408"/>
                          </a:lnTo>
                          <a:lnTo>
                            <a:pt x="999" y="409"/>
                          </a:lnTo>
                          <a:lnTo>
                            <a:pt x="1002" y="410"/>
                          </a:lnTo>
                          <a:lnTo>
                            <a:pt x="1006" y="411"/>
                          </a:lnTo>
                          <a:lnTo>
                            <a:pt x="1009" y="411"/>
                          </a:lnTo>
                          <a:lnTo>
                            <a:pt x="1015" y="414"/>
                          </a:lnTo>
                          <a:lnTo>
                            <a:pt x="1018" y="414"/>
                          </a:lnTo>
                          <a:lnTo>
                            <a:pt x="1024" y="415"/>
                          </a:lnTo>
                          <a:lnTo>
                            <a:pt x="1028" y="417"/>
                          </a:lnTo>
                          <a:lnTo>
                            <a:pt x="1031" y="417"/>
                          </a:lnTo>
                          <a:lnTo>
                            <a:pt x="1034" y="418"/>
                          </a:lnTo>
                          <a:lnTo>
                            <a:pt x="1034" y="418"/>
                          </a:lnTo>
                          <a:lnTo>
                            <a:pt x="1037" y="418"/>
                          </a:lnTo>
                          <a:lnTo>
                            <a:pt x="1043" y="419"/>
                          </a:lnTo>
                          <a:lnTo>
                            <a:pt x="1046" y="419"/>
                          </a:lnTo>
                          <a:lnTo>
                            <a:pt x="1049" y="420"/>
                          </a:lnTo>
                          <a:lnTo>
                            <a:pt x="1053" y="420"/>
                          </a:lnTo>
                          <a:lnTo>
                            <a:pt x="1059" y="422"/>
                          </a:lnTo>
                          <a:lnTo>
                            <a:pt x="1062" y="422"/>
                          </a:lnTo>
                          <a:lnTo>
                            <a:pt x="1068" y="423"/>
                          </a:lnTo>
                          <a:lnTo>
                            <a:pt x="1071" y="423"/>
                          </a:lnTo>
                          <a:lnTo>
                            <a:pt x="1078" y="424"/>
                          </a:lnTo>
                          <a:lnTo>
                            <a:pt x="1081" y="424"/>
                          </a:lnTo>
                          <a:lnTo>
                            <a:pt x="1081" y="424"/>
                          </a:lnTo>
                          <a:lnTo>
                            <a:pt x="1084" y="426"/>
                          </a:lnTo>
                          <a:lnTo>
                            <a:pt x="1087" y="426"/>
                          </a:lnTo>
                          <a:lnTo>
                            <a:pt x="1090" y="426"/>
                          </a:lnTo>
                          <a:lnTo>
                            <a:pt x="1096" y="427"/>
                          </a:lnTo>
                          <a:lnTo>
                            <a:pt x="1099" y="427"/>
                          </a:lnTo>
                          <a:lnTo>
                            <a:pt x="1103" y="427"/>
                          </a:lnTo>
                          <a:lnTo>
                            <a:pt x="1106" y="427"/>
                          </a:lnTo>
                          <a:lnTo>
                            <a:pt x="1112" y="427"/>
                          </a:lnTo>
                          <a:lnTo>
                            <a:pt x="1115" y="427"/>
                          </a:lnTo>
                          <a:lnTo>
                            <a:pt x="1121" y="427"/>
                          </a:lnTo>
                          <a:lnTo>
                            <a:pt x="1124" y="427"/>
                          </a:lnTo>
                          <a:lnTo>
                            <a:pt x="1131" y="427"/>
                          </a:lnTo>
                          <a:lnTo>
                            <a:pt x="1134" y="427"/>
                          </a:lnTo>
                          <a:lnTo>
                            <a:pt x="1140" y="427"/>
                          </a:lnTo>
                          <a:lnTo>
                            <a:pt x="1143" y="427"/>
                          </a:lnTo>
                          <a:lnTo>
                            <a:pt x="1149" y="427"/>
                          </a:lnTo>
                          <a:lnTo>
                            <a:pt x="1152" y="427"/>
                          </a:lnTo>
                          <a:lnTo>
                            <a:pt x="1156" y="427"/>
                          </a:lnTo>
                          <a:lnTo>
                            <a:pt x="1159" y="427"/>
                          </a:lnTo>
                          <a:lnTo>
                            <a:pt x="1165" y="427"/>
                          </a:lnTo>
                          <a:lnTo>
                            <a:pt x="1168" y="427"/>
                          </a:lnTo>
                          <a:lnTo>
                            <a:pt x="1174" y="427"/>
                          </a:lnTo>
                          <a:lnTo>
                            <a:pt x="1177" y="427"/>
                          </a:lnTo>
                          <a:lnTo>
                            <a:pt x="1184" y="426"/>
                          </a:lnTo>
                          <a:lnTo>
                            <a:pt x="1187" y="427"/>
                          </a:lnTo>
                          <a:lnTo>
                            <a:pt x="1193" y="426"/>
                          </a:lnTo>
                          <a:lnTo>
                            <a:pt x="1196" y="426"/>
                          </a:lnTo>
                          <a:lnTo>
                            <a:pt x="1202" y="426"/>
                          </a:lnTo>
                          <a:lnTo>
                            <a:pt x="1207" y="426"/>
                          </a:lnTo>
                          <a:lnTo>
                            <a:pt x="1207" y="426"/>
                          </a:lnTo>
                          <a:lnTo>
                            <a:pt x="1209" y="424"/>
                          </a:lnTo>
                          <a:lnTo>
                            <a:pt x="1209" y="424"/>
                          </a:lnTo>
                          <a:lnTo>
                            <a:pt x="1212" y="424"/>
                          </a:lnTo>
                          <a:lnTo>
                            <a:pt x="1218" y="424"/>
                          </a:lnTo>
                          <a:lnTo>
                            <a:pt x="1221" y="424"/>
                          </a:lnTo>
                          <a:lnTo>
                            <a:pt x="1227" y="424"/>
                          </a:lnTo>
                          <a:lnTo>
                            <a:pt x="1232" y="423"/>
                          </a:lnTo>
                          <a:lnTo>
                            <a:pt x="1237" y="423"/>
                          </a:lnTo>
                          <a:lnTo>
                            <a:pt x="1240" y="423"/>
                          </a:lnTo>
                          <a:lnTo>
                            <a:pt x="1246" y="423"/>
                          </a:lnTo>
                          <a:lnTo>
                            <a:pt x="1249" y="423"/>
                          </a:lnTo>
                          <a:lnTo>
                            <a:pt x="1254" y="422"/>
                          </a:lnTo>
                          <a:lnTo>
                            <a:pt x="1257" y="422"/>
                          </a:lnTo>
                          <a:lnTo>
                            <a:pt x="1263" y="422"/>
                          </a:lnTo>
                          <a:lnTo>
                            <a:pt x="1265" y="422"/>
                          </a:lnTo>
                          <a:lnTo>
                            <a:pt x="1271" y="422"/>
                          </a:lnTo>
                          <a:lnTo>
                            <a:pt x="1274" y="422"/>
                          </a:lnTo>
                          <a:lnTo>
                            <a:pt x="1282" y="422"/>
                          </a:lnTo>
                          <a:lnTo>
                            <a:pt x="1285" y="422"/>
                          </a:lnTo>
                          <a:lnTo>
                            <a:pt x="1291" y="422"/>
                          </a:lnTo>
                          <a:lnTo>
                            <a:pt x="1294" y="422"/>
                          </a:lnTo>
                          <a:lnTo>
                            <a:pt x="1299" y="422"/>
                          </a:lnTo>
                          <a:lnTo>
                            <a:pt x="1304" y="422"/>
                          </a:lnTo>
                          <a:lnTo>
                            <a:pt x="1307" y="422"/>
                          </a:lnTo>
                          <a:lnTo>
                            <a:pt x="1310" y="422"/>
                          </a:lnTo>
                          <a:lnTo>
                            <a:pt x="1316" y="422"/>
                          </a:lnTo>
                          <a:lnTo>
                            <a:pt x="1319" y="422"/>
                          </a:lnTo>
                          <a:lnTo>
                            <a:pt x="1324" y="420"/>
                          </a:lnTo>
                          <a:lnTo>
                            <a:pt x="1329" y="420"/>
                          </a:lnTo>
                          <a:lnTo>
                            <a:pt x="1335" y="422"/>
                          </a:lnTo>
                          <a:lnTo>
                            <a:pt x="1338" y="422"/>
                          </a:lnTo>
                          <a:lnTo>
                            <a:pt x="1344" y="422"/>
                          </a:lnTo>
                          <a:lnTo>
                            <a:pt x="1347" y="422"/>
                          </a:lnTo>
                          <a:lnTo>
                            <a:pt x="1350" y="422"/>
                          </a:lnTo>
                          <a:lnTo>
                            <a:pt x="1354" y="422"/>
                          </a:lnTo>
                          <a:lnTo>
                            <a:pt x="1360" y="422"/>
                          </a:lnTo>
                          <a:lnTo>
                            <a:pt x="1363" y="423"/>
                          </a:lnTo>
                          <a:lnTo>
                            <a:pt x="1369" y="423"/>
                          </a:lnTo>
                          <a:lnTo>
                            <a:pt x="1372" y="423"/>
                          </a:lnTo>
                          <a:lnTo>
                            <a:pt x="1378" y="423"/>
                          </a:lnTo>
                          <a:lnTo>
                            <a:pt x="1382" y="424"/>
                          </a:lnTo>
                          <a:lnTo>
                            <a:pt x="1388" y="424"/>
                          </a:lnTo>
                          <a:lnTo>
                            <a:pt x="1391" y="424"/>
                          </a:lnTo>
                          <a:lnTo>
                            <a:pt x="1391" y="424"/>
                          </a:lnTo>
                          <a:lnTo>
                            <a:pt x="1394" y="426"/>
                          </a:lnTo>
                          <a:lnTo>
                            <a:pt x="1397" y="426"/>
                          </a:lnTo>
                          <a:lnTo>
                            <a:pt x="1400" y="426"/>
                          </a:lnTo>
                          <a:lnTo>
                            <a:pt x="1403" y="426"/>
                          </a:lnTo>
                          <a:lnTo>
                            <a:pt x="1407" y="427"/>
                          </a:lnTo>
                          <a:lnTo>
                            <a:pt x="1413" y="427"/>
                          </a:lnTo>
                          <a:lnTo>
                            <a:pt x="1416" y="427"/>
                          </a:lnTo>
                          <a:lnTo>
                            <a:pt x="1422" y="428"/>
                          </a:lnTo>
                          <a:lnTo>
                            <a:pt x="1425" y="428"/>
                          </a:lnTo>
                          <a:lnTo>
                            <a:pt x="1432" y="429"/>
                          </a:lnTo>
                          <a:lnTo>
                            <a:pt x="1435" y="429"/>
                          </a:lnTo>
                          <a:lnTo>
                            <a:pt x="1441" y="429"/>
                          </a:lnTo>
                          <a:lnTo>
                            <a:pt x="1444" y="431"/>
                          </a:lnTo>
                          <a:lnTo>
                            <a:pt x="1450" y="431"/>
                          </a:lnTo>
                          <a:lnTo>
                            <a:pt x="1453" y="431"/>
                          </a:lnTo>
                          <a:lnTo>
                            <a:pt x="1457" y="431"/>
                          </a:lnTo>
                          <a:lnTo>
                            <a:pt x="1460" y="431"/>
                          </a:lnTo>
                          <a:lnTo>
                            <a:pt x="1466" y="432"/>
                          </a:lnTo>
                          <a:lnTo>
                            <a:pt x="1469" y="432"/>
                          </a:lnTo>
                          <a:lnTo>
                            <a:pt x="1472" y="432"/>
                          </a:lnTo>
                          <a:lnTo>
                            <a:pt x="1475" y="433"/>
                          </a:lnTo>
                          <a:lnTo>
                            <a:pt x="1475" y="433"/>
                          </a:lnTo>
                          <a:lnTo>
                            <a:pt x="1479" y="433"/>
                          </a:lnTo>
                          <a:lnTo>
                            <a:pt x="1485" y="433"/>
                          </a:lnTo>
                          <a:lnTo>
                            <a:pt x="1488" y="433"/>
                          </a:lnTo>
                          <a:lnTo>
                            <a:pt x="1494" y="435"/>
                          </a:lnTo>
                          <a:lnTo>
                            <a:pt x="1497" y="435"/>
                          </a:lnTo>
                          <a:lnTo>
                            <a:pt x="1500" y="435"/>
                          </a:lnTo>
                          <a:lnTo>
                            <a:pt x="1504" y="435"/>
                          </a:lnTo>
                          <a:lnTo>
                            <a:pt x="1510" y="436"/>
                          </a:lnTo>
                          <a:lnTo>
                            <a:pt x="1513" y="436"/>
                          </a:lnTo>
                          <a:lnTo>
                            <a:pt x="1519" y="436"/>
                          </a:lnTo>
                          <a:lnTo>
                            <a:pt x="1522" y="437"/>
                          </a:lnTo>
                          <a:lnTo>
                            <a:pt x="1529" y="437"/>
                          </a:lnTo>
                          <a:lnTo>
                            <a:pt x="1532" y="437"/>
                          </a:lnTo>
                          <a:lnTo>
                            <a:pt x="1538" y="437"/>
                          </a:lnTo>
                          <a:lnTo>
                            <a:pt x="1541" y="437"/>
                          </a:lnTo>
                          <a:lnTo>
                            <a:pt x="1547" y="437"/>
                          </a:lnTo>
                          <a:lnTo>
                            <a:pt x="1550" y="438"/>
                          </a:lnTo>
                          <a:lnTo>
                            <a:pt x="1555" y="437"/>
                          </a:lnTo>
                          <a:lnTo>
                            <a:pt x="1557" y="438"/>
                          </a:lnTo>
                          <a:lnTo>
                            <a:pt x="1563" y="438"/>
                          </a:lnTo>
                          <a:lnTo>
                            <a:pt x="1566" y="438"/>
                          </a:lnTo>
                          <a:lnTo>
                            <a:pt x="1572" y="438"/>
                          </a:lnTo>
                          <a:lnTo>
                            <a:pt x="1575" y="438"/>
                          </a:lnTo>
                          <a:lnTo>
                            <a:pt x="1583" y="438"/>
                          </a:lnTo>
                          <a:lnTo>
                            <a:pt x="1586" y="438"/>
                          </a:lnTo>
                          <a:lnTo>
                            <a:pt x="1591" y="438"/>
                          </a:lnTo>
                          <a:lnTo>
                            <a:pt x="1594" y="438"/>
                          </a:lnTo>
                          <a:lnTo>
                            <a:pt x="1600" y="438"/>
                          </a:lnTo>
                          <a:lnTo>
                            <a:pt x="1603" y="438"/>
                          </a:lnTo>
                          <a:lnTo>
                            <a:pt x="1608" y="438"/>
                          </a:lnTo>
                          <a:lnTo>
                            <a:pt x="1611" y="438"/>
                          </a:lnTo>
                          <a:lnTo>
                            <a:pt x="1616" y="438"/>
                          </a:lnTo>
                          <a:lnTo>
                            <a:pt x="1619" y="438"/>
                          </a:lnTo>
                          <a:lnTo>
                            <a:pt x="1625" y="438"/>
                          </a:lnTo>
                          <a:lnTo>
                            <a:pt x="1628" y="438"/>
                          </a:lnTo>
                          <a:lnTo>
                            <a:pt x="1636" y="438"/>
                          </a:lnTo>
                          <a:lnTo>
                            <a:pt x="1639" y="438"/>
                          </a:lnTo>
                          <a:lnTo>
                            <a:pt x="1644" y="437"/>
                          </a:lnTo>
                          <a:lnTo>
                            <a:pt x="1647" y="437"/>
                          </a:lnTo>
                          <a:lnTo>
                            <a:pt x="1653" y="437"/>
                          </a:lnTo>
                          <a:lnTo>
                            <a:pt x="1658" y="437"/>
                          </a:lnTo>
                          <a:lnTo>
                            <a:pt x="1661" y="437"/>
                          </a:lnTo>
                          <a:lnTo>
                            <a:pt x="1664" y="437"/>
                          </a:lnTo>
                          <a:lnTo>
                            <a:pt x="1670" y="437"/>
                          </a:lnTo>
                          <a:lnTo>
                            <a:pt x="1673" y="437"/>
                          </a:lnTo>
                          <a:lnTo>
                            <a:pt x="1678" y="437"/>
                          </a:lnTo>
                          <a:lnTo>
                            <a:pt x="1683" y="437"/>
                          </a:lnTo>
                          <a:lnTo>
                            <a:pt x="1689" y="437"/>
                          </a:lnTo>
                          <a:lnTo>
                            <a:pt x="1692" y="436"/>
                          </a:lnTo>
                          <a:lnTo>
                            <a:pt x="1698" y="436"/>
                          </a:lnTo>
                          <a:lnTo>
                            <a:pt x="1701" y="436"/>
                          </a:lnTo>
                          <a:lnTo>
                            <a:pt x="1705" y="436"/>
                          </a:lnTo>
                          <a:lnTo>
                            <a:pt x="1708" y="436"/>
                          </a:lnTo>
                          <a:lnTo>
                            <a:pt x="1714" y="436"/>
                          </a:lnTo>
                          <a:lnTo>
                            <a:pt x="1717" y="436"/>
                          </a:lnTo>
                          <a:lnTo>
                            <a:pt x="1723" y="436"/>
                          </a:lnTo>
                          <a:lnTo>
                            <a:pt x="1726" y="436"/>
                          </a:lnTo>
                          <a:lnTo>
                            <a:pt x="1733" y="436"/>
                          </a:lnTo>
                          <a:lnTo>
                            <a:pt x="1736" y="436"/>
                          </a:lnTo>
                          <a:lnTo>
                            <a:pt x="1742" y="436"/>
                          </a:lnTo>
                          <a:lnTo>
                            <a:pt x="1745" y="435"/>
                          </a:lnTo>
                          <a:lnTo>
                            <a:pt x="1751" y="435"/>
                          </a:lnTo>
                          <a:lnTo>
                            <a:pt x="1755" y="436"/>
                          </a:lnTo>
                          <a:lnTo>
                            <a:pt x="1758" y="436"/>
                          </a:lnTo>
                          <a:lnTo>
                            <a:pt x="1761" y="436"/>
                          </a:lnTo>
                          <a:lnTo>
                            <a:pt x="1767" y="435"/>
                          </a:lnTo>
                          <a:lnTo>
                            <a:pt x="1770" y="435"/>
                          </a:lnTo>
                          <a:lnTo>
                            <a:pt x="1776" y="435"/>
                          </a:lnTo>
                          <a:lnTo>
                            <a:pt x="1780" y="435"/>
                          </a:lnTo>
                          <a:lnTo>
                            <a:pt x="1786" y="435"/>
                          </a:lnTo>
                          <a:lnTo>
                            <a:pt x="1789" y="435"/>
                          </a:lnTo>
                          <a:lnTo>
                            <a:pt x="1795" y="435"/>
                          </a:lnTo>
                          <a:lnTo>
                            <a:pt x="1798" y="435"/>
                          </a:lnTo>
                          <a:lnTo>
                            <a:pt x="1801" y="435"/>
                          </a:lnTo>
                          <a:lnTo>
                            <a:pt x="1805" y="435"/>
                          </a:lnTo>
                          <a:lnTo>
                            <a:pt x="1811" y="435"/>
                          </a:lnTo>
                          <a:lnTo>
                            <a:pt x="1814" y="435"/>
                          </a:lnTo>
                          <a:lnTo>
                            <a:pt x="1820" y="435"/>
                          </a:lnTo>
                          <a:lnTo>
                            <a:pt x="1823" y="435"/>
                          </a:lnTo>
                          <a:lnTo>
                            <a:pt x="1829" y="435"/>
                          </a:lnTo>
                          <a:lnTo>
                            <a:pt x="1833" y="436"/>
                          </a:lnTo>
                          <a:lnTo>
                            <a:pt x="1839" y="436"/>
                          </a:lnTo>
                          <a:lnTo>
                            <a:pt x="1842" y="436"/>
                          </a:lnTo>
                          <a:lnTo>
                            <a:pt x="1848" y="436"/>
                          </a:lnTo>
                          <a:lnTo>
                            <a:pt x="1851" y="436"/>
                          </a:lnTo>
                          <a:lnTo>
                            <a:pt x="1854" y="436"/>
                          </a:lnTo>
                          <a:lnTo>
                            <a:pt x="1858" y="436"/>
                          </a:lnTo>
                          <a:lnTo>
                            <a:pt x="1864" y="437"/>
                          </a:lnTo>
                          <a:lnTo>
                            <a:pt x="1867" y="437"/>
                          </a:lnTo>
                          <a:lnTo>
                            <a:pt x="1873" y="437"/>
                          </a:lnTo>
                          <a:lnTo>
                            <a:pt x="1876" y="437"/>
                          </a:lnTo>
                          <a:lnTo>
                            <a:pt x="1883" y="437"/>
                          </a:lnTo>
                          <a:lnTo>
                            <a:pt x="1886" y="437"/>
                          </a:lnTo>
                          <a:lnTo>
                            <a:pt x="1892" y="438"/>
                          </a:lnTo>
                          <a:lnTo>
                            <a:pt x="1895" y="438"/>
                          </a:lnTo>
                          <a:lnTo>
                            <a:pt x="1901" y="438"/>
                          </a:lnTo>
                          <a:lnTo>
                            <a:pt x="1904" y="438"/>
                          </a:lnTo>
                          <a:lnTo>
                            <a:pt x="1908" y="438"/>
                          </a:lnTo>
                          <a:lnTo>
                            <a:pt x="1911" y="438"/>
                          </a:lnTo>
                          <a:lnTo>
                            <a:pt x="1917" y="438"/>
                          </a:lnTo>
                          <a:lnTo>
                            <a:pt x="1920" y="438"/>
                          </a:lnTo>
                          <a:lnTo>
                            <a:pt x="1926" y="438"/>
                          </a:lnTo>
                          <a:lnTo>
                            <a:pt x="1931" y="438"/>
                          </a:lnTo>
                          <a:lnTo>
                            <a:pt x="1936" y="438"/>
                          </a:lnTo>
                          <a:lnTo>
                            <a:pt x="1939" y="438"/>
                          </a:lnTo>
                          <a:lnTo>
                            <a:pt x="1945" y="438"/>
                          </a:lnTo>
                          <a:lnTo>
                            <a:pt x="1948" y="438"/>
                          </a:lnTo>
                          <a:lnTo>
                            <a:pt x="1951" y="438"/>
                          </a:lnTo>
                          <a:lnTo>
                            <a:pt x="1956" y="438"/>
                          </a:lnTo>
                          <a:lnTo>
                            <a:pt x="1962" y="440"/>
                          </a:lnTo>
                          <a:lnTo>
                            <a:pt x="1965" y="440"/>
                          </a:lnTo>
                          <a:lnTo>
                            <a:pt x="1970" y="440"/>
                          </a:lnTo>
                          <a:lnTo>
                            <a:pt x="1973" y="440"/>
                          </a:lnTo>
                          <a:lnTo>
                            <a:pt x="1981" y="440"/>
                          </a:lnTo>
                          <a:lnTo>
                            <a:pt x="1984" y="440"/>
                          </a:lnTo>
                          <a:lnTo>
                            <a:pt x="1990" y="440"/>
                          </a:lnTo>
                          <a:lnTo>
                            <a:pt x="1993" y="440"/>
                          </a:lnTo>
                          <a:lnTo>
                            <a:pt x="1993" y="440"/>
                          </a:lnTo>
                          <a:lnTo>
                            <a:pt x="1995" y="441"/>
                          </a:lnTo>
                          <a:lnTo>
                            <a:pt x="1998" y="441"/>
                          </a:lnTo>
                          <a:lnTo>
                            <a:pt x="2001" y="441"/>
                          </a:lnTo>
                          <a:lnTo>
                            <a:pt x="2006" y="441"/>
                          </a:lnTo>
                          <a:lnTo>
                            <a:pt x="2009" y="441"/>
                          </a:lnTo>
                          <a:lnTo>
                            <a:pt x="2015" y="441"/>
                          </a:lnTo>
                          <a:lnTo>
                            <a:pt x="2018" y="441"/>
                          </a:lnTo>
                          <a:lnTo>
                            <a:pt x="2023" y="441"/>
                          </a:lnTo>
                          <a:lnTo>
                            <a:pt x="2026" y="441"/>
                          </a:lnTo>
                          <a:lnTo>
                            <a:pt x="2034" y="441"/>
                          </a:lnTo>
                          <a:lnTo>
                            <a:pt x="2037" y="441"/>
                          </a:lnTo>
                          <a:lnTo>
                            <a:pt x="2043" y="441"/>
                          </a:lnTo>
                          <a:lnTo>
                            <a:pt x="2046" y="441"/>
                          </a:lnTo>
                          <a:lnTo>
                            <a:pt x="2052" y="441"/>
                          </a:lnTo>
                          <a:lnTo>
                            <a:pt x="2054" y="441"/>
                          </a:lnTo>
                          <a:lnTo>
                            <a:pt x="2059" y="441"/>
                          </a:lnTo>
                          <a:lnTo>
                            <a:pt x="2062" y="441"/>
                          </a:lnTo>
                          <a:lnTo>
                            <a:pt x="2068" y="441"/>
                          </a:lnTo>
                          <a:lnTo>
                            <a:pt x="2071" y="441"/>
                          </a:lnTo>
                          <a:lnTo>
                            <a:pt x="2077" y="441"/>
                          </a:lnTo>
                          <a:lnTo>
                            <a:pt x="2080" y="441"/>
                          </a:lnTo>
                          <a:lnTo>
                            <a:pt x="2087" y="441"/>
                          </a:lnTo>
                          <a:lnTo>
                            <a:pt x="2090" y="441"/>
                          </a:lnTo>
                          <a:lnTo>
                            <a:pt x="2096" y="441"/>
                          </a:lnTo>
                          <a:lnTo>
                            <a:pt x="2099" y="441"/>
                          </a:lnTo>
                          <a:lnTo>
                            <a:pt x="2099" y="441"/>
                          </a:lnTo>
                          <a:lnTo>
                            <a:pt x="2102" y="440"/>
                          </a:lnTo>
                          <a:lnTo>
                            <a:pt x="2105" y="440"/>
                          </a:lnTo>
                          <a:lnTo>
                            <a:pt x="2109" y="440"/>
                          </a:lnTo>
                          <a:lnTo>
                            <a:pt x="2112" y="440"/>
                          </a:lnTo>
                          <a:lnTo>
                            <a:pt x="2115" y="440"/>
                          </a:lnTo>
                          <a:lnTo>
                            <a:pt x="2121" y="440"/>
                          </a:lnTo>
                          <a:lnTo>
                            <a:pt x="2124" y="440"/>
                          </a:lnTo>
                          <a:lnTo>
                            <a:pt x="2130" y="440"/>
                          </a:lnTo>
                          <a:lnTo>
                            <a:pt x="2134" y="440"/>
                          </a:lnTo>
                          <a:lnTo>
                            <a:pt x="2140" y="440"/>
                          </a:lnTo>
                          <a:lnTo>
                            <a:pt x="2143" y="440"/>
                          </a:lnTo>
                          <a:lnTo>
                            <a:pt x="2149" y="438"/>
                          </a:lnTo>
                          <a:lnTo>
                            <a:pt x="2152" y="438"/>
                          </a:lnTo>
                          <a:lnTo>
                            <a:pt x="2156" y="438"/>
                          </a:lnTo>
                          <a:lnTo>
                            <a:pt x="2159" y="438"/>
                          </a:lnTo>
                          <a:lnTo>
                            <a:pt x="2165" y="438"/>
                          </a:lnTo>
                          <a:lnTo>
                            <a:pt x="2168" y="438"/>
                          </a:lnTo>
                          <a:lnTo>
                            <a:pt x="2174" y="438"/>
                          </a:lnTo>
                          <a:lnTo>
                            <a:pt x="2177" y="438"/>
                          </a:lnTo>
                          <a:lnTo>
                            <a:pt x="2184" y="438"/>
                          </a:lnTo>
                          <a:lnTo>
                            <a:pt x="2187" y="437"/>
                          </a:lnTo>
                          <a:lnTo>
                            <a:pt x="2193" y="437"/>
                          </a:lnTo>
                          <a:lnTo>
                            <a:pt x="2196" y="437"/>
                          </a:lnTo>
                          <a:lnTo>
                            <a:pt x="2202" y="437"/>
                          </a:lnTo>
                          <a:lnTo>
                            <a:pt x="2206" y="437"/>
                          </a:lnTo>
                          <a:lnTo>
                            <a:pt x="2209" y="437"/>
                          </a:lnTo>
                          <a:lnTo>
                            <a:pt x="2212" y="437"/>
                          </a:lnTo>
                          <a:lnTo>
                            <a:pt x="2218" y="437"/>
                          </a:lnTo>
                          <a:lnTo>
                            <a:pt x="2221" y="437"/>
                          </a:lnTo>
                          <a:lnTo>
                            <a:pt x="2227" y="436"/>
                          </a:lnTo>
                          <a:lnTo>
                            <a:pt x="2231" y="437"/>
                          </a:lnTo>
                          <a:lnTo>
                            <a:pt x="2237" y="436"/>
                          </a:lnTo>
                          <a:lnTo>
                            <a:pt x="2240" y="436"/>
                          </a:lnTo>
                        </a:path>
                      </a:pathLst>
                    </a:custGeom>
                    <a:noFill/>
                    <a:ln w="14288">
                      <a:solidFill>
                        <a:srgbClr val="0000FF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37" name="Rectangle 35">
                      <a:extLst>
                        <a:ext uri="{FF2B5EF4-FFF2-40B4-BE49-F238E27FC236}">
                          <a16:creationId xmlns:a16="http://schemas.microsoft.com/office/drawing/2014/main" id="{784DFE53-F7D4-488E-BB50-81AA07296DBB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079625" y="4798972"/>
                      <a:ext cx="291574" cy="1554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defTabSz="914400"/>
                      <a:r>
                        <a:rPr lang="en-US" altLang="en-US" sz="900" dirty="0">
                          <a:solidFill>
                            <a:srgbClr val="000000"/>
                          </a:solidFill>
                        </a:rPr>
                        <a:t>Days</a:t>
                      </a:r>
                      <a:endParaRPr lang="en-US" altLang="en-US" sz="900" dirty="0"/>
                    </a:p>
                  </p:txBody>
                </p:sp>
              </p:grpSp>
            </p:grpSp>
            <p:sp>
              <p:nvSpPr>
                <p:cNvPr id="68" name="Rectangle 67">
                  <a:extLst>
                    <a:ext uri="{FF2B5EF4-FFF2-40B4-BE49-F238E27FC236}">
                      <a16:creationId xmlns:a16="http://schemas.microsoft.com/office/drawing/2014/main" id="{BCD0E177-CF21-435B-9BB0-5F3CCFC3E19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11193" y="3957636"/>
                  <a:ext cx="1136753" cy="3028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algn="ctr" defTabSz="914400"/>
                  <a:r>
                    <a:rPr lang="en-US" altLang="en-US" sz="900" dirty="0">
                      <a:solidFill>
                        <a:srgbClr val="000000"/>
                      </a:solidFill>
                    </a:rPr>
                    <a:t>Rel. Luminescence </a:t>
                  </a:r>
                </a:p>
                <a:p>
                  <a:pPr algn="ctr" defTabSz="914400"/>
                  <a:r>
                    <a:rPr lang="en-US" altLang="en-US" sz="900" dirty="0">
                      <a:solidFill>
                        <a:srgbClr val="000000"/>
                      </a:solidFill>
                    </a:rPr>
                    <a:t>(counts/s)</a:t>
                  </a:r>
                  <a:endParaRPr lang="en-US" altLang="en-US" sz="900" dirty="0"/>
                </a:p>
              </p:txBody>
            </p:sp>
          </p:grpSp>
        </p:grpSp>
        <p:sp>
          <p:nvSpPr>
            <p:cNvPr id="69" name="Rectangle 33">
              <a:extLst>
                <a:ext uri="{FF2B5EF4-FFF2-40B4-BE49-F238E27FC236}">
                  <a16:creationId xmlns:a16="http://schemas.microsoft.com/office/drawing/2014/main" id="{45D38341-F546-4672-8AE3-B4CD016195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1298" y="3319833"/>
              <a:ext cx="93550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1000" dirty="0">
                  <a:solidFill>
                    <a:srgbClr val="000000"/>
                  </a:solidFill>
                </a:rPr>
                <a:t>3T3-L1</a:t>
              </a:r>
              <a:r>
                <a:rPr lang="en-US" altLang="en-US" sz="1000" i="1" dirty="0">
                  <a:solidFill>
                    <a:srgbClr val="000000"/>
                  </a:solidFill>
                </a:rPr>
                <a:t> Per2:luc</a:t>
              </a:r>
              <a:endParaRPr lang="en-US" altLang="en-US" sz="1000" dirty="0"/>
            </a:p>
          </p:txBody>
        </p:sp>
      </p:grpSp>
      <p:sp>
        <p:nvSpPr>
          <p:cNvPr id="77" name="TextBox 76">
            <a:extLst>
              <a:ext uri="{FF2B5EF4-FFF2-40B4-BE49-F238E27FC236}">
                <a16:creationId xmlns:a16="http://schemas.microsoft.com/office/drawing/2014/main" id="{DBF24944-9F28-4635-BA8E-265D35569D33}"/>
              </a:ext>
            </a:extLst>
          </p:cNvPr>
          <p:cNvSpPr txBox="1"/>
          <p:nvPr/>
        </p:nvSpPr>
        <p:spPr>
          <a:xfrm>
            <a:off x="179794" y="779095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197A8A1-288B-4956-8E4F-0B60D081F6BB}"/>
              </a:ext>
            </a:extLst>
          </p:cNvPr>
          <p:cNvSpPr txBox="1"/>
          <p:nvPr/>
        </p:nvSpPr>
        <p:spPr>
          <a:xfrm>
            <a:off x="2790506" y="790096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E1A836A7-CE2F-47BC-A5CD-10B6B3D12E7F}"/>
              </a:ext>
            </a:extLst>
          </p:cNvPr>
          <p:cNvGrpSpPr/>
          <p:nvPr/>
        </p:nvGrpSpPr>
        <p:grpSpPr>
          <a:xfrm>
            <a:off x="2990457" y="923135"/>
            <a:ext cx="2176424" cy="1513845"/>
            <a:chOff x="3582099" y="966215"/>
            <a:chExt cx="2176424" cy="1512219"/>
          </a:xfrm>
        </p:grpSpPr>
        <p:grpSp>
          <p:nvGrpSpPr>
            <p:cNvPr id="145" name="Group 144">
              <a:extLst>
                <a:ext uri="{FF2B5EF4-FFF2-40B4-BE49-F238E27FC236}">
                  <a16:creationId xmlns:a16="http://schemas.microsoft.com/office/drawing/2014/main" id="{DD3F0C01-39A4-4E60-B614-CFA6D981FC18}"/>
                </a:ext>
              </a:extLst>
            </p:cNvPr>
            <p:cNvGrpSpPr/>
            <p:nvPr/>
          </p:nvGrpSpPr>
          <p:grpSpPr>
            <a:xfrm>
              <a:off x="3905250" y="1165225"/>
              <a:ext cx="173124" cy="1062911"/>
              <a:chOff x="3905250" y="1165225"/>
              <a:chExt cx="173124" cy="1062911"/>
            </a:xfrm>
          </p:grpSpPr>
          <p:sp>
            <p:nvSpPr>
              <p:cNvPr id="96" name="Rectangle 85">
                <a:extLst>
                  <a:ext uri="{FF2B5EF4-FFF2-40B4-BE49-F238E27FC236}">
                    <a16:creationId xmlns:a16="http://schemas.microsoft.com/office/drawing/2014/main" id="{33129E75-12EA-4A9E-87BD-5ABBF78855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10025" y="2105025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800" dirty="0">
                    <a:solidFill>
                      <a:srgbClr val="000000"/>
                    </a:solidFill>
                  </a:rPr>
                  <a:t>0</a:t>
                </a:r>
                <a:endParaRPr lang="en-US" altLang="en-US" sz="800" dirty="0"/>
              </a:p>
            </p:txBody>
          </p:sp>
          <p:sp>
            <p:nvSpPr>
              <p:cNvPr id="97" name="Rectangle 86">
                <a:extLst>
                  <a:ext uri="{FF2B5EF4-FFF2-40B4-BE49-F238E27FC236}">
                    <a16:creationId xmlns:a16="http://schemas.microsoft.com/office/drawing/2014/main" id="{96A11A8C-AA0E-43A5-A71D-F80806EAAA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05250" y="179228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800">
                    <a:solidFill>
                      <a:srgbClr val="000000"/>
                    </a:solidFill>
                  </a:rPr>
                  <a:t>120</a:t>
                </a:r>
                <a:endParaRPr lang="en-US" altLang="en-US" sz="800"/>
              </a:p>
            </p:txBody>
          </p:sp>
          <p:sp>
            <p:nvSpPr>
              <p:cNvPr id="98" name="Rectangle 87">
                <a:extLst>
                  <a:ext uri="{FF2B5EF4-FFF2-40B4-BE49-F238E27FC236}">
                    <a16:creationId xmlns:a16="http://schemas.microsoft.com/office/drawing/2014/main" id="{D3A61150-E524-4927-A8DE-4FFC34493F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05250" y="1479550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800">
                    <a:solidFill>
                      <a:srgbClr val="000000"/>
                    </a:solidFill>
                  </a:rPr>
                  <a:t>240</a:t>
                </a:r>
                <a:endParaRPr lang="en-US" altLang="en-US" sz="800"/>
              </a:p>
            </p:txBody>
          </p:sp>
          <p:sp>
            <p:nvSpPr>
              <p:cNvPr id="99" name="Rectangle 88">
                <a:extLst>
                  <a:ext uri="{FF2B5EF4-FFF2-40B4-BE49-F238E27FC236}">
                    <a16:creationId xmlns:a16="http://schemas.microsoft.com/office/drawing/2014/main" id="{49879D5C-083D-4952-83C2-E04CE93891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05250" y="116522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800">
                    <a:solidFill>
                      <a:srgbClr val="000000"/>
                    </a:solidFill>
                  </a:rPr>
                  <a:t>360</a:t>
                </a:r>
                <a:endParaRPr lang="en-US" altLang="en-US" sz="800"/>
              </a:p>
            </p:txBody>
          </p:sp>
        </p:grpSp>
        <p:sp>
          <p:nvSpPr>
            <p:cNvPr id="110" name="Rectangle 99">
              <a:extLst>
                <a:ext uri="{FF2B5EF4-FFF2-40B4-BE49-F238E27FC236}">
                  <a16:creationId xmlns:a16="http://schemas.microsoft.com/office/drawing/2014/main" id="{B8D200EF-4250-487E-8A02-85C939DD53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4221" y="966215"/>
              <a:ext cx="1115690" cy="138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914400"/>
              <a:r>
                <a:rPr lang="en-US" altLang="en-US" sz="900" dirty="0">
                  <a:solidFill>
                    <a:srgbClr val="000000"/>
                  </a:solidFill>
                </a:rPr>
                <a:t>C3H10T1/2 Per2:Luc</a:t>
              </a:r>
              <a:endParaRPr lang="en-US" altLang="en-US" dirty="0"/>
            </a:p>
          </p:txBody>
        </p:sp>
        <p:grpSp>
          <p:nvGrpSpPr>
            <p:cNvPr id="144" name="Group 143">
              <a:extLst>
                <a:ext uri="{FF2B5EF4-FFF2-40B4-BE49-F238E27FC236}">
                  <a16:creationId xmlns:a16="http://schemas.microsoft.com/office/drawing/2014/main" id="{AA720752-C649-44DC-8A7A-801CDF65C3F9}"/>
                </a:ext>
              </a:extLst>
            </p:cNvPr>
            <p:cNvGrpSpPr/>
            <p:nvPr/>
          </p:nvGrpSpPr>
          <p:grpSpPr>
            <a:xfrm>
              <a:off x="4098966" y="1209675"/>
              <a:ext cx="1659557" cy="1268759"/>
              <a:chOff x="4075113" y="1209675"/>
              <a:chExt cx="1659557" cy="1268759"/>
            </a:xfrm>
          </p:grpSpPr>
          <p:sp>
            <p:nvSpPr>
              <p:cNvPr id="83" name="Rectangle 72">
                <a:extLst>
                  <a:ext uri="{FF2B5EF4-FFF2-40B4-BE49-F238E27FC236}">
                    <a16:creationId xmlns:a16="http://schemas.microsoft.com/office/drawing/2014/main" id="{E7D7FBB8-5115-4DF9-9D03-150AF281E0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7813" y="2212975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900">
                    <a:solidFill>
                      <a:srgbClr val="000000"/>
                    </a:solidFill>
                  </a:rPr>
                  <a:t>0</a:t>
                </a:r>
                <a:endParaRPr lang="en-US" altLang="en-US" sz="900"/>
              </a:p>
            </p:txBody>
          </p:sp>
          <p:sp>
            <p:nvSpPr>
              <p:cNvPr id="84" name="Rectangle 73">
                <a:extLst>
                  <a:ext uri="{FF2B5EF4-FFF2-40B4-BE49-F238E27FC236}">
                    <a16:creationId xmlns:a16="http://schemas.microsoft.com/office/drawing/2014/main" id="{36164872-E0DF-4C2E-A719-8FFEDEA073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3725" y="2212975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900">
                    <a:solidFill>
                      <a:srgbClr val="000000"/>
                    </a:solidFill>
                  </a:rPr>
                  <a:t>1</a:t>
                </a:r>
                <a:endParaRPr lang="en-US" altLang="en-US" sz="900"/>
              </a:p>
            </p:txBody>
          </p:sp>
          <p:sp>
            <p:nvSpPr>
              <p:cNvPr id="85" name="Rectangle 74">
                <a:extLst>
                  <a:ext uri="{FF2B5EF4-FFF2-40B4-BE49-F238E27FC236}">
                    <a16:creationId xmlns:a16="http://schemas.microsoft.com/office/drawing/2014/main" id="{3983AC76-44F1-474C-9274-1E83F8D576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9638" y="2212975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900">
                    <a:solidFill>
                      <a:srgbClr val="000000"/>
                    </a:solidFill>
                  </a:rPr>
                  <a:t>2</a:t>
                </a:r>
                <a:endParaRPr lang="en-US" altLang="en-US" sz="900"/>
              </a:p>
            </p:txBody>
          </p:sp>
          <p:sp>
            <p:nvSpPr>
              <p:cNvPr id="86" name="Rectangle 75">
                <a:extLst>
                  <a:ext uri="{FF2B5EF4-FFF2-40B4-BE49-F238E27FC236}">
                    <a16:creationId xmlns:a16="http://schemas.microsoft.com/office/drawing/2014/main" id="{AB274612-E90A-41D5-859C-C5DCC3DA9D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7138" y="2212975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900">
                    <a:solidFill>
                      <a:srgbClr val="000000"/>
                    </a:solidFill>
                  </a:rPr>
                  <a:t>3</a:t>
                </a:r>
                <a:endParaRPr lang="en-US" altLang="en-US" sz="900"/>
              </a:p>
            </p:txBody>
          </p:sp>
          <p:sp>
            <p:nvSpPr>
              <p:cNvPr id="87" name="Rectangle 76">
                <a:extLst>
                  <a:ext uri="{FF2B5EF4-FFF2-40B4-BE49-F238E27FC236}">
                    <a16:creationId xmlns:a16="http://schemas.microsoft.com/office/drawing/2014/main" id="{F7C1023D-A788-4226-83A9-1329916777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53050" y="2212975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900">
                    <a:solidFill>
                      <a:srgbClr val="000000"/>
                    </a:solidFill>
                  </a:rPr>
                  <a:t>4</a:t>
                </a:r>
                <a:endParaRPr lang="en-US" altLang="en-US" sz="900"/>
              </a:p>
            </p:txBody>
          </p:sp>
          <p:sp>
            <p:nvSpPr>
              <p:cNvPr id="88" name="Rectangle 77">
                <a:extLst>
                  <a:ext uri="{FF2B5EF4-FFF2-40B4-BE49-F238E27FC236}">
                    <a16:creationId xmlns:a16="http://schemas.microsoft.com/office/drawing/2014/main" id="{D9CF8611-1C85-402F-A81D-8E05139FF3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70550" y="2212975"/>
                <a:ext cx="6412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900">
                    <a:solidFill>
                      <a:srgbClr val="000000"/>
                    </a:solidFill>
                  </a:rPr>
                  <a:t>5</a:t>
                </a:r>
                <a:endParaRPr lang="en-US" altLang="en-US" sz="900"/>
              </a:p>
            </p:txBody>
          </p:sp>
          <p:sp>
            <p:nvSpPr>
              <p:cNvPr id="89" name="Line 78">
                <a:extLst>
                  <a:ext uri="{FF2B5EF4-FFF2-40B4-BE49-F238E27FC236}">
                    <a16:creationId xmlns:a16="http://schemas.microsoft.com/office/drawing/2014/main" id="{08756CAF-09D7-44C7-8C6D-BD8B955768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10038" y="2155825"/>
                <a:ext cx="1595438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" name="Line 79">
                <a:extLst>
                  <a:ext uri="{FF2B5EF4-FFF2-40B4-BE49-F238E27FC236}">
                    <a16:creationId xmlns:a16="http://schemas.microsoft.com/office/drawing/2014/main" id="{B0F28FD3-69E2-4EA2-8B6A-4484F48C61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16388" y="2155825"/>
                <a:ext cx="0" cy="39687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" name="Line 80">
                <a:extLst>
                  <a:ext uri="{FF2B5EF4-FFF2-40B4-BE49-F238E27FC236}">
                    <a16:creationId xmlns:a16="http://schemas.microsoft.com/office/drawing/2014/main" id="{C973DEF9-69C3-4353-A492-E54F0976C8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32300" y="2155825"/>
                <a:ext cx="0" cy="39687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2" name="Line 81">
                <a:extLst>
                  <a:ext uri="{FF2B5EF4-FFF2-40B4-BE49-F238E27FC236}">
                    <a16:creationId xmlns:a16="http://schemas.microsoft.com/office/drawing/2014/main" id="{427B8D63-4337-4269-BBF3-2C3934267E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48213" y="2155825"/>
                <a:ext cx="0" cy="39687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3" name="Line 82">
                <a:extLst>
                  <a:ext uri="{FF2B5EF4-FFF2-40B4-BE49-F238E27FC236}">
                    <a16:creationId xmlns:a16="http://schemas.microsoft.com/office/drawing/2014/main" id="{A10F409A-EEAF-4917-9782-03A2FF9D60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65713" y="2155825"/>
                <a:ext cx="0" cy="39687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4" name="Line 83">
                <a:extLst>
                  <a:ext uri="{FF2B5EF4-FFF2-40B4-BE49-F238E27FC236}">
                    <a16:creationId xmlns:a16="http://schemas.microsoft.com/office/drawing/2014/main" id="{DBF0C538-ADEC-4899-A6BE-3844F735DC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81625" y="2155825"/>
                <a:ext cx="0" cy="39687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5" name="Line 84">
                <a:extLst>
                  <a:ext uri="{FF2B5EF4-FFF2-40B4-BE49-F238E27FC236}">
                    <a16:creationId xmlns:a16="http://schemas.microsoft.com/office/drawing/2014/main" id="{27206CA5-4CD5-4508-BE9A-FBB5F199EB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99125" y="2155825"/>
                <a:ext cx="0" cy="39687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0" name="Line 89">
                <a:extLst>
                  <a:ext uri="{FF2B5EF4-FFF2-40B4-BE49-F238E27FC236}">
                    <a16:creationId xmlns:a16="http://schemas.microsoft.com/office/drawing/2014/main" id="{CAE090A4-D3B7-43C7-A268-D670BDDC92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16388" y="1209675"/>
                <a:ext cx="0" cy="95250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1" name="Line 90">
                <a:extLst>
                  <a:ext uri="{FF2B5EF4-FFF2-40B4-BE49-F238E27FC236}">
                    <a16:creationId xmlns:a16="http://schemas.microsoft.com/office/drawing/2014/main" id="{B40DB9BA-A1F1-47A6-9A5A-72914DAE17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75113" y="2155825"/>
                <a:ext cx="41275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" name="Line 91">
                <a:extLst>
                  <a:ext uri="{FF2B5EF4-FFF2-40B4-BE49-F238E27FC236}">
                    <a16:creationId xmlns:a16="http://schemas.microsoft.com/office/drawing/2014/main" id="{A0980779-365B-4327-AAA3-542F7671FE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75113" y="1843088"/>
                <a:ext cx="41275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" name="Line 92">
                <a:extLst>
                  <a:ext uri="{FF2B5EF4-FFF2-40B4-BE49-F238E27FC236}">
                    <a16:creationId xmlns:a16="http://schemas.microsoft.com/office/drawing/2014/main" id="{6E4C55BD-E0BB-4683-9AA9-C2D862C306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75113" y="1528763"/>
                <a:ext cx="41275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" name="Line 93">
                <a:extLst>
                  <a:ext uri="{FF2B5EF4-FFF2-40B4-BE49-F238E27FC236}">
                    <a16:creationId xmlns:a16="http://schemas.microsoft.com/office/drawing/2014/main" id="{9BC9D72D-668F-4FA0-9814-BFA9361313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75113" y="1216025"/>
                <a:ext cx="41275" cy="0"/>
              </a:xfrm>
              <a:prstGeom prst="line">
                <a:avLst/>
              </a:prstGeom>
              <a:noFill/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" name="Freeform 94">
                <a:extLst>
                  <a:ext uri="{FF2B5EF4-FFF2-40B4-BE49-F238E27FC236}">
                    <a16:creationId xmlns:a16="http://schemas.microsoft.com/office/drawing/2014/main" id="{09BA9377-4E6A-4166-A358-0C836822BC6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19563" y="1392238"/>
                <a:ext cx="1573213" cy="630237"/>
              </a:xfrm>
              <a:custGeom>
                <a:avLst/>
                <a:gdLst>
                  <a:gd name="T0" fmla="*/ 23 w 1982"/>
                  <a:gd name="T1" fmla="*/ 47 h 794"/>
                  <a:gd name="T2" fmla="*/ 42 w 1982"/>
                  <a:gd name="T3" fmla="*/ 119 h 794"/>
                  <a:gd name="T4" fmla="*/ 59 w 1982"/>
                  <a:gd name="T5" fmla="*/ 176 h 794"/>
                  <a:gd name="T6" fmla="*/ 78 w 1982"/>
                  <a:gd name="T7" fmla="*/ 250 h 794"/>
                  <a:gd name="T8" fmla="*/ 98 w 1982"/>
                  <a:gd name="T9" fmla="*/ 325 h 794"/>
                  <a:gd name="T10" fmla="*/ 116 w 1982"/>
                  <a:gd name="T11" fmla="*/ 425 h 794"/>
                  <a:gd name="T12" fmla="*/ 133 w 1982"/>
                  <a:gd name="T13" fmla="*/ 510 h 794"/>
                  <a:gd name="T14" fmla="*/ 153 w 1982"/>
                  <a:gd name="T15" fmla="*/ 594 h 794"/>
                  <a:gd name="T16" fmla="*/ 169 w 1982"/>
                  <a:gd name="T17" fmla="*/ 650 h 794"/>
                  <a:gd name="T18" fmla="*/ 195 w 1982"/>
                  <a:gd name="T19" fmla="*/ 709 h 794"/>
                  <a:gd name="T20" fmla="*/ 225 w 1982"/>
                  <a:gd name="T21" fmla="*/ 734 h 794"/>
                  <a:gd name="T22" fmla="*/ 258 w 1982"/>
                  <a:gd name="T23" fmla="*/ 704 h 794"/>
                  <a:gd name="T24" fmla="*/ 279 w 1982"/>
                  <a:gd name="T25" fmla="*/ 653 h 794"/>
                  <a:gd name="T26" fmla="*/ 299 w 1982"/>
                  <a:gd name="T27" fmla="*/ 582 h 794"/>
                  <a:gd name="T28" fmla="*/ 317 w 1982"/>
                  <a:gd name="T29" fmla="*/ 504 h 794"/>
                  <a:gd name="T30" fmla="*/ 335 w 1982"/>
                  <a:gd name="T31" fmla="*/ 398 h 794"/>
                  <a:gd name="T32" fmla="*/ 352 w 1982"/>
                  <a:gd name="T33" fmla="*/ 312 h 794"/>
                  <a:gd name="T34" fmla="*/ 371 w 1982"/>
                  <a:gd name="T35" fmla="*/ 232 h 794"/>
                  <a:gd name="T36" fmla="*/ 391 w 1982"/>
                  <a:gd name="T37" fmla="*/ 189 h 794"/>
                  <a:gd name="T38" fmla="*/ 427 w 1982"/>
                  <a:gd name="T39" fmla="*/ 207 h 794"/>
                  <a:gd name="T40" fmla="*/ 446 w 1982"/>
                  <a:gd name="T41" fmla="*/ 257 h 794"/>
                  <a:gd name="T42" fmla="*/ 466 w 1982"/>
                  <a:gd name="T43" fmla="*/ 316 h 794"/>
                  <a:gd name="T44" fmla="*/ 483 w 1982"/>
                  <a:gd name="T45" fmla="*/ 370 h 794"/>
                  <a:gd name="T46" fmla="*/ 501 w 1982"/>
                  <a:gd name="T47" fmla="*/ 434 h 794"/>
                  <a:gd name="T48" fmla="*/ 519 w 1982"/>
                  <a:gd name="T49" fmla="*/ 488 h 794"/>
                  <a:gd name="T50" fmla="*/ 537 w 1982"/>
                  <a:gd name="T51" fmla="*/ 546 h 794"/>
                  <a:gd name="T52" fmla="*/ 554 w 1982"/>
                  <a:gd name="T53" fmla="*/ 594 h 794"/>
                  <a:gd name="T54" fmla="*/ 576 w 1982"/>
                  <a:gd name="T55" fmla="*/ 650 h 794"/>
                  <a:gd name="T56" fmla="*/ 596 w 1982"/>
                  <a:gd name="T57" fmla="*/ 689 h 794"/>
                  <a:gd name="T58" fmla="*/ 632 w 1982"/>
                  <a:gd name="T59" fmla="*/ 731 h 794"/>
                  <a:gd name="T60" fmla="*/ 673 w 1982"/>
                  <a:gd name="T61" fmla="*/ 748 h 794"/>
                  <a:gd name="T62" fmla="*/ 706 w 1982"/>
                  <a:gd name="T63" fmla="*/ 728 h 794"/>
                  <a:gd name="T64" fmla="*/ 726 w 1982"/>
                  <a:gd name="T65" fmla="*/ 700 h 794"/>
                  <a:gd name="T66" fmla="*/ 756 w 1982"/>
                  <a:gd name="T67" fmla="*/ 654 h 794"/>
                  <a:gd name="T68" fmla="*/ 784 w 1982"/>
                  <a:gd name="T69" fmla="*/ 611 h 794"/>
                  <a:gd name="T70" fmla="*/ 818 w 1982"/>
                  <a:gd name="T71" fmla="*/ 572 h 794"/>
                  <a:gd name="T72" fmla="*/ 848 w 1982"/>
                  <a:gd name="T73" fmla="*/ 558 h 794"/>
                  <a:gd name="T74" fmla="*/ 881 w 1982"/>
                  <a:gd name="T75" fmla="*/ 546 h 794"/>
                  <a:gd name="T76" fmla="*/ 922 w 1982"/>
                  <a:gd name="T77" fmla="*/ 584 h 794"/>
                  <a:gd name="T78" fmla="*/ 955 w 1982"/>
                  <a:gd name="T79" fmla="*/ 626 h 794"/>
                  <a:gd name="T80" fmla="*/ 990 w 1982"/>
                  <a:gd name="T81" fmla="*/ 664 h 794"/>
                  <a:gd name="T82" fmla="*/ 1018 w 1982"/>
                  <a:gd name="T83" fmla="*/ 696 h 794"/>
                  <a:gd name="T84" fmla="*/ 1060 w 1982"/>
                  <a:gd name="T85" fmla="*/ 730 h 794"/>
                  <a:gd name="T86" fmla="*/ 1104 w 1982"/>
                  <a:gd name="T87" fmla="*/ 745 h 794"/>
                  <a:gd name="T88" fmla="*/ 1146 w 1982"/>
                  <a:gd name="T89" fmla="*/ 745 h 794"/>
                  <a:gd name="T90" fmla="*/ 1190 w 1982"/>
                  <a:gd name="T91" fmla="*/ 728 h 794"/>
                  <a:gd name="T92" fmla="*/ 1223 w 1982"/>
                  <a:gd name="T93" fmla="*/ 712 h 794"/>
                  <a:gd name="T94" fmla="*/ 1259 w 1982"/>
                  <a:gd name="T95" fmla="*/ 691 h 794"/>
                  <a:gd name="T96" fmla="*/ 1309 w 1982"/>
                  <a:gd name="T97" fmla="*/ 682 h 794"/>
                  <a:gd name="T98" fmla="*/ 1348 w 1982"/>
                  <a:gd name="T99" fmla="*/ 686 h 794"/>
                  <a:gd name="T100" fmla="*/ 1395 w 1982"/>
                  <a:gd name="T101" fmla="*/ 705 h 794"/>
                  <a:gd name="T102" fmla="*/ 1439 w 1982"/>
                  <a:gd name="T103" fmla="*/ 723 h 794"/>
                  <a:gd name="T104" fmla="*/ 1481 w 1982"/>
                  <a:gd name="T105" fmla="*/ 739 h 794"/>
                  <a:gd name="T106" fmla="*/ 1524 w 1982"/>
                  <a:gd name="T107" fmla="*/ 756 h 794"/>
                  <a:gd name="T108" fmla="*/ 1574 w 1982"/>
                  <a:gd name="T109" fmla="*/ 763 h 794"/>
                  <a:gd name="T110" fmla="*/ 1630 w 1982"/>
                  <a:gd name="T111" fmla="*/ 756 h 794"/>
                  <a:gd name="T112" fmla="*/ 1677 w 1982"/>
                  <a:gd name="T113" fmla="*/ 750 h 794"/>
                  <a:gd name="T114" fmla="*/ 1724 w 1982"/>
                  <a:gd name="T115" fmla="*/ 744 h 794"/>
                  <a:gd name="T116" fmla="*/ 1782 w 1982"/>
                  <a:gd name="T117" fmla="*/ 737 h 794"/>
                  <a:gd name="T118" fmla="*/ 1826 w 1982"/>
                  <a:gd name="T119" fmla="*/ 744 h 794"/>
                  <a:gd name="T120" fmla="*/ 1876 w 1982"/>
                  <a:gd name="T121" fmla="*/ 756 h 794"/>
                  <a:gd name="T122" fmla="*/ 1921 w 1982"/>
                  <a:gd name="T123" fmla="*/ 767 h 794"/>
                  <a:gd name="T124" fmla="*/ 1954 w 1982"/>
                  <a:gd name="T125" fmla="*/ 774 h 7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1982" h="794">
                    <a:moveTo>
                      <a:pt x="0" y="0"/>
                    </a:moveTo>
                    <a:lnTo>
                      <a:pt x="0" y="0"/>
                    </a:lnTo>
                    <a:lnTo>
                      <a:pt x="3" y="3"/>
                    </a:lnTo>
                    <a:lnTo>
                      <a:pt x="6" y="8"/>
                    </a:lnTo>
                    <a:lnTo>
                      <a:pt x="9" y="12"/>
                    </a:lnTo>
                    <a:lnTo>
                      <a:pt x="12" y="19"/>
                    </a:lnTo>
                    <a:lnTo>
                      <a:pt x="12" y="19"/>
                    </a:lnTo>
                    <a:lnTo>
                      <a:pt x="15" y="26"/>
                    </a:lnTo>
                    <a:lnTo>
                      <a:pt x="15" y="26"/>
                    </a:lnTo>
                    <a:lnTo>
                      <a:pt x="17" y="32"/>
                    </a:lnTo>
                    <a:lnTo>
                      <a:pt x="20" y="39"/>
                    </a:lnTo>
                    <a:lnTo>
                      <a:pt x="23" y="47"/>
                    </a:lnTo>
                    <a:lnTo>
                      <a:pt x="23" y="47"/>
                    </a:lnTo>
                    <a:lnTo>
                      <a:pt x="26" y="54"/>
                    </a:lnTo>
                    <a:lnTo>
                      <a:pt x="26" y="54"/>
                    </a:lnTo>
                    <a:lnTo>
                      <a:pt x="29" y="60"/>
                    </a:lnTo>
                    <a:lnTo>
                      <a:pt x="29" y="60"/>
                    </a:lnTo>
                    <a:lnTo>
                      <a:pt x="30" y="87"/>
                    </a:lnTo>
                    <a:lnTo>
                      <a:pt x="30" y="87"/>
                    </a:lnTo>
                    <a:lnTo>
                      <a:pt x="33" y="95"/>
                    </a:lnTo>
                    <a:lnTo>
                      <a:pt x="33" y="95"/>
                    </a:lnTo>
                    <a:lnTo>
                      <a:pt x="36" y="103"/>
                    </a:lnTo>
                    <a:lnTo>
                      <a:pt x="36" y="103"/>
                    </a:lnTo>
                    <a:lnTo>
                      <a:pt x="39" y="113"/>
                    </a:lnTo>
                    <a:lnTo>
                      <a:pt x="39" y="113"/>
                    </a:lnTo>
                    <a:lnTo>
                      <a:pt x="42" y="119"/>
                    </a:lnTo>
                    <a:lnTo>
                      <a:pt x="42" y="119"/>
                    </a:lnTo>
                    <a:lnTo>
                      <a:pt x="45" y="129"/>
                    </a:lnTo>
                    <a:lnTo>
                      <a:pt x="45" y="129"/>
                    </a:lnTo>
                    <a:lnTo>
                      <a:pt x="47" y="137"/>
                    </a:lnTo>
                    <a:lnTo>
                      <a:pt x="47" y="137"/>
                    </a:lnTo>
                    <a:lnTo>
                      <a:pt x="50" y="146"/>
                    </a:lnTo>
                    <a:lnTo>
                      <a:pt x="50" y="146"/>
                    </a:lnTo>
                    <a:lnTo>
                      <a:pt x="53" y="155"/>
                    </a:lnTo>
                    <a:lnTo>
                      <a:pt x="53" y="155"/>
                    </a:lnTo>
                    <a:lnTo>
                      <a:pt x="56" y="180"/>
                    </a:lnTo>
                    <a:lnTo>
                      <a:pt x="56" y="180"/>
                    </a:lnTo>
                    <a:lnTo>
                      <a:pt x="59" y="176"/>
                    </a:lnTo>
                    <a:lnTo>
                      <a:pt x="59" y="176"/>
                    </a:lnTo>
                    <a:lnTo>
                      <a:pt x="62" y="184"/>
                    </a:lnTo>
                    <a:lnTo>
                      <a:pt x="62" y="184"/>
                    </a:lnTo>
                    <a:lnTo>
                      <a:pt x="65" y="196"/>
                    </a:lnTo>
                    <a:lnTo>
                      <a:pt x="65" y="196"/>
                    </a:lnTo>
                    <a:lnTo>
                      <a:pt x="68" y="206"/>
                    </a:lnTo>
                    <a:lnTo>
                      <a:pt x="68" y="206"/>
                    </a:lnTo>
                    <a:lnTo>
                      <a:pt x="70" y="215"/>
                    </a:lnTo>
                    <a:lnTo>
                      <a:pt x="70" y="215"/>
                    </a:lnTo>
                    <a:lnTo>
                      <a:pt x="72" y="228"/>
                    </a:lnTo>
                    <a:lnTo>
                      <a:pt x="72" y="228"/>
                    </a:lnTo>
                    <a:lnTo>
                      <a:pt x="75" y="239"/>
                    </a:lnTo>
                    <a:lnTo>
                      <a:pt x="75" y="239"/>
                    </a:lnTo>
                    <a:lnTo>
                      <a:pt x="78" y="250"/>
                    </a:lnTo>
                    <a:lnTo>
                      <a:pt x="78" y="250"/>
                    </a:lnTo>
                    <a:lnTo>
                      <a:pt x="80" y="262"/>
                    </a:lnTo>
                    <a:lnTo>
                      <a:pt x="80" y="262"/>
                    </a:lnTo>
                    <a:lnTo>
                      <a:pt x="83" y="274"/>
                    </a:lnTo>
                    <a:lnTo>
                      <a:pt x="86" y="270"/>
                    </a:lnTo>
                    <a:lnTo>
                      <a:pt x="89" y="284"/>
                    </a:lnTo>
                    <a:lnTo>
                      <a:pt x="89" y="284"/>
                    </a:lnTo>
                    <a:lnTo>
                      <a:pt x="92" y="296"/>
                    </a:lnTo>
                    <a:lnTo>
                      <a:pt x="92" y="296"/>
                    </a:lnTo>
                    <a:lnTo>
                      <a:pt x="95" y="310"/>
                    </a:lnTo>
                    <a:lnTo>
                      <a:pt x="95" y="310"/>
                    </a:lnTo>
                    <a:lnTo>
                      <a:pt x="98" y="325"/>
                    </a:lnTo>
                    <a:lnTo>
                      <a:pt x="98" y="325"/>
                    </a:lnTo>
                    <a:lnTo>
                      <a:pt x="100" y="339"/>
                    </a:lnTo>
                    <a:lnTo>
                      <a:pt x="100" y="339"/>
                    </a:lnTo>
                    <a:lnTo>
                      <a:pt x="103" y="354"/>
                    </a:lnTo>
                    <a:lnTo>
                      <a:pt x="103" y="354"/>
                    </a:lnTo>
                    <a:lnTo>
                      <a:pt x="106" y="368"/>
                    </a:lnTo>
                    <a:lnTo>
                      <a:pt x="106" y="368"/>
                    </a:lnTo>
                    <a:lnTo>
                      <a:pt x="109" y="381"/>
                    </a:lnTo>
                    <a:lnTo>
                      <a:pt x="109" y="381"/>
                    </a:lnTo>
                    <a:lnTo>
                      <a:pt x="112" y="397"/>
                    </a:lnTo>
                    <a:lnTo>
                      <a:pt x="112" y="397"/>
                    </a:lnTo>
                    <a:lnTo>
                      <a:pt x="113" y="410"/>
                    </a:lnTo>
                    <a:lnTo>
                      <a:pt x="113" y="410"/>
                    </a:lnTo>
                    <a:lnTo>
                      <a:pt x="116" y="425"/>
                    </a:lnTo>
                    <a:lnTo>
                      <a:pt x="116" y="425"/>
                    </a:lnTo>
                    <a:lnTo>
                      <a:pt x="119" y="440"/>
                    </a:lnTo>
                    <a:lnTo>
                      <a:pt x="119" y="440"/>
                    </a:lnTo>
                    <a:lnTo>
                      <a:pt x="122" y="456"/>
                    </a:lnTo>
                    <a:lnTo>
                      <a:pt x="122" y="456"/>
                    </a:lnTo>
                    <a:lnTo>
                      <a:pt x="125" y="469"/>
                    </a:lnTo>
                    <a:lnTo>
                      <a:pt x="125" y="469"/>
                    </a:lnTo>
                    <a:lnTo>
                      <a:pt x="128" y="484"/>
                    </a:lnTo>
                    <a:lnTo>
                      <a:pt x="128" y="484"/>
                    </a:lnTo>
                    <a:lnTo>
                      <a:pt x="131" y="498"/>
                    </a:lnTo>
                    <a:lnTo>
                      <a:pt x="131" y="498"/>
                    </a:lnTo>
                    <a:lnTo>
                      <a:pt x="133" y="510"/>
                    </a:lnTo>
                    <a:lnTo>
                      <a:pt x="133" y="510"/>
                    </a:lnTo>
                    <a:lnTo>
                      <a:pt x="136" y="524"/>
                    </a:lnTo>
                    <a:lnTo>
                      <a:pt x="136" y="524"/>
                    </a:lnTo>
                    <a:lnTo>
                      <a:pt x="139" y="538"/>
                    </a:lnTo>
                    <a:lnTo>
                      <a:pt x="139" y="538"/>
                    </a:lnTo>
                    <a:lnTo>
                      <a:pt x="142" y="550"/>
                    </a:lnTo>
                    <a:lnTo>
                      <a:pt x="142" y="550"/>
                    </a:lnTo>
                    <a:lnTo>
                      <a:pt x="145" y="563"/>
                    </a:lnTo>
                    <a:lnTo>
                      <a:pt x="145" y="563"/>
                    </a:lnTo>
                    <a:lnTo>
                      <a:pt x="148" y="573"/>
                    </a:lnTo>
                    <a:lnTo>
                      <a:pt x="148" y="573"/>
                    </a:lnTo>
                    <a:lnTo>
                      <a:pt x="151" y="584"/>
                    </a:lnTo>
                    <a:lnTo>
                      <a:pt x="151" y="584"/>
                    </a:lnTo>
                    <a:lnTo>
                      <a:pt x="153" y="594"/>
                    </a:lnTo>
                    <a:lnTo>
                      <a:pt x="153" y="594"/>
                    </a:lnTo>
                    <a:lnTo>
                      <a:pt x="155" y="605"/>
                    </a:lnTo>
                    <a:lnTo>
                      <a:pt x="155" y="605"/>
                    </a:lnTo>
                    <a:lnTo>
                      <a:pt x="158" y="615"/>
                    </a:lnTo>
                    <a:lnTo>
                      <a:pt x="158" y="615"/>
                    </a:lnTo>
                    <a:lnTo>
                      <a:pt x="161" y="623"/>
                    </a:lnTo>
                    <a:lnTo>
                      <a:pt x="161" y="623"/>
                    </a:lnTo>
                    <a:lnTo>
                      <a:pt x="163" y="632"/>
                    </a:lnTo>
                    <a:lnTo>
                      <a:pt x="163" y="632"/>
                    </a:lnTo>
                    <a:lnTo>
                      <a:pt x="166" y="641"/>
                    </a:lnTo>
                    <a:lnTo>
                      <a:pt x="166" y="641"/>
                    </a:lnTo>
                    <a:lnTo>
                      <a:pt x="169" y="650"/>
                    </a:lnTo>
                    <a:lnTo>
                      <a:pt x="169" y="650"/>
                    </a:lnTo>
                    <a:lnTo>
                      <a:pt x="172" y="657"/>
                    </a:lnTo>
                    <a:lnTo>
                      <a:pt x="175" y="664"/>
                    </a:lnTo>
                    <a:lnTo>
                      <a:pt x="178" y="671"/>
                    </a:lnTo>
                    <a:lnTo>
                      <a:pt x="178" y="671"/>
                    </a:lnTo>
                    <a:lnTo>
                      <a:pt x="181" y="678"/>
                    </a:lnTo>
                    <a:lnTo>
                      <a:pt x="181" y="678"/>
                    </a:lnTo>
                    <a:lnTo>
                      <a:pt x="184" y="687"/>
                    </a:lnTo>
                    <a:lnTo>
                      <a:pt x="184" y="687"/>
                    </a:lnTo>
                    <a:lnTo>
                      <a:pt x="186" y="693"/>
                    </a:lnTo>
                    <a:lnTo>
                      <a:pt x="186" y="693"/>
                    </a:lnTo>
                    <a:lnTo>
                      <a:pt x="189" y="698"/>
                    </a:lnTo>
                    <a:lnTo>
                      <a:pt x="192" y="705"/>
                    </a:lnTo>
                    <a:lnTo>
                      <a:pt x="195" y="709"/>
                    </a:lnTo>
                    <a:lnTo>
                      <a:pt x="196" y="713"/>
                    </a:lnTo>
                    <a:lnTo>
                      <a:pt x="199" y="718"/>
                    </a:lnTo>
                    <a:lnTo>
                      <a:pt x="199" y="718"/>
                    </a:lnTo>
                    <a:lnTo>
                      <a:pt x="202" y="720"/>
                    </a:lnTo>
                    <a:lnTo>
                      <a:pt x="202" y="720"/>
                    </a:lnTo>
                    <a:lnTo>
                      <a:pt x="205" y="723"/>
                    </a:lnTo>
                    <a:lnTo>
                      <a:pt x="208" y="730"/>
                    </a:lnTo>
                    <a:lnTo>
                      <a:pt x="211" y="728"/>
                    </a:lnTo>
                    <a:lnTo>
                      <a:pt x="214" y="730"/>
                    </a:lnTo>
                    <a:lnTo>
                      <a:pt x="216" y="734"/>
                    </a:lnTo>
                    <a:lnTo>
                      <a:pt x="216" y="734"/>
                    </a:lnTo>
                    <a:lnTo>
                      <a:pt x="219" y="733"/>
                    </a:lnTo>
                    <a:lnTo>
                      <a:pt x="225" y="734"/>
                    </a:lnTo>
                    <a:lnTo>
                      <a:pt x="228" y="734"/>
                    </a:lnTo>
                    <a:lnTo>
                      <a:pt x="234" y="733"/>
                    </a:lnTo>
                    <a:lnTo>
                      <a:pt x="236" y="731"/>
                    </a:lnTo>
                    <a:lnTo>
                      <a:pt x="236" y="731"/>
                    </a:lnTo>
                    <a:lnTo>
                      <a:pt x="238" y="726"/>
                    </a:lnTo>
                    <a:lnTo>
                      <a:pt x="244" y="723"/>
                    </a:lnTo>
                    <a:lnTo>
                      <a:pt x="247" y="718"/>
                    </a:lnTo>
                    <a:lnTo>
                      <a:pt x="249" y="715"/>
                    </a:lnTo>
                    <a:lnTo>
                      <a:pt x="252" y="712"/>
                    </a:lnTo>
                    <a:lnTo>
                      <a:pt x="252" y="712"/>
                    </a:lnTo>
                    <a:lnTo>
                      <a:pt x="255" y="708"/>
                    </a:lnTo>
                    <a:lnTo>
                      <a:pt x="255" y="708"/>
                    </a:lnTo>
                    <a:lnTo>
                      <a:pt x="258" y="704"/>
                    </a:lnTo>
                    <a:lnTo>
                      <a:pt x="261" y="700"/>
                    </a:lnTo>
                    <a:lnTo>
                      <a:pt x="264" y="694"/>
                    </a:lnTo>
                    <a:lnTo>
                      <a:pt x="264" y="694"/>
                    </a:lnTo>
                    <a:lnTo>
                      <a:pt x="267" y="689"/>
                    </a:lnTo>
                    <a:lnTo>
                      <a:pt x="269" y="682"/>
                    </a:lnTo>
                    <a:lnTo>
                      <a:pt x="272" y="676"/>
                    </a:lnTo>
                    <a:lnTo>
                      <a:pt x="272" y="676"/>
                    </a:lnTo>
                    <a:lnTo>
                      <a:pt x="275" y="668"/>
                    </a:lnTo>
                    <a:lnTo>
                      <a:pt x="275" y="668"/>
                    </a:lnTo>
                    <a:lnTo>
                      <a:pt x="278" y="660"/>
                    </a:lnTo>
                    <a:lnTo>
                      <a:pt x="278" y="660"/>
                    </a:lnTo>
                    <a:lnTo>
                      <a:pt x="279" y="653"/>
                    </a:lnTo>
                    <a:lnTo>
                      <a:pt x="279" y="653"/>
                    </a:lnTo>
                    <a:lnTo>
                      <a:pt x="282" y="645"/>
                    </a:lnTo>
                    <a:lnTo>
                      <a:pt x="282" y="645"/>
                    </a:lnTo>
                    <a:lnTo>
                      <a:pt x="285" y="635"/>
                    </a:lnTo>
                    <a:lnTo>
                      <a:pt x="285" y="635"/>
                    </a:lnTo>
                    <a:lnTo>
                      <a:pt x="288" y="626"/>
                    </a:lnTo>
                    <a:lnTo>
                      <a:pt x="288" y="626"/>
                    </a:lnTo>
                    <a:lnTo>
                      <a:pt x="291" y="616"/>
                    </a:lnTo>
                    <a:lnTo>
                      <a:pt x="291" y="616"/>
                    </a:lnTo>
                    <a:lnTo>
                      <a:pt x="294" y="605"/>
                    </a:lnTo>
                    <a:lnTo>
                      <a:pt x="294" y="605"/>
                    </a:lnTo>
                    <a:lnTo>
                      <a:pt x="297" y="594"/>
                    </a:lnTo>
                    <a:lnTo>
                      <a:pt x="297" y="594"/>
                    </a:lnTo>
                    <a:lnTo>
                      <a:pt x="299" y="582"/>
                    </a:lnTo>
                    <a:lnTo>
                      <a:pt x="299" y="582"/>
                    </a:lnTo>
                    <a:lnTo>
                      <a:pt x="302" y="569"/>
                    </a:lnTo>
                    <a:lnTo>
                      <a:pt x="302" y="569"/>
                    </a:lnTo>
                    <a:lnTo>
                      <a:pt x="305" y="557"/>
                    </a:lnTo>
                    <a:lnTo>
                      <a:pt x="305" y="557"/>
                    </a:lnTo>
                    <a:lnTo>
                      <a:pt x="308" y="543"/>
                    </a:lnTo>
                    <a:lnTo>
                      <a:pt x="308" y="543"/>
                    </a:lnTo>
                    <a:lnTo>
                      <a:pt x="311" y="531"/>
                    </a:lnTo>
                    <a:lnTo>
                      <a:pt x="311" y="531"/>
                    </a:lnTo>
                    <a:lnTo>
                      <a:pt x="314" y="517"/>
                    </a:lnTo>
                    <a:lnTo>
                      <a:pt x="314" y="517"/>
                    </a:lnTo>
                    <a:lnTo>
                      <a:pt x="317" y="504"/>
                    </a:lnTo>
                    <a:lnTo>
                      <a:pt x="317" y="504"/>
                    </a:lnTo>
                    <a:lnTo>
                      <a:pt x="320" y="488"/>
                    </a:lnTo>
                    <a:lnTo>
                      <a:pt x="320" y="488"/>
                    </a:lnTo>
                    <a:lnTo>
                      <a:pt x="321" y="473"/>
                    </a:lnTo>
                    <a:lnTo>
                      <a:pt x="321" y="473"/>
                    </a:lnTo>
                    <a:lnTo>
                      <a:pt x="324" y="458"/>
                    </a:lnTo>
                    <a:lnTo>
                      <a:pt x="324" y="458"/>
                    </a:lnTo>
                    <a:lnTo>
                      <a:pt x="327" y="443"/>
                    </a:lnTo>
                    <a:lnTo>
                      <a:pt x="327" y="443"/>
                    </a:lnTo>
                    <a:lnTo>
                      <a:pt x="330" y="428"/>
                    </a:lnTo>
                    <a:lnTo>
                      <a:pt x="330" y="428"/>
                    </a:lnTo>
                    <a:lnTo>
                      <a:pt x="332" y="413"/>
                    </a:lnTo>
                    <a:lnTo>
                      <a:pt x="332" y="413"/>
                    </a:lnTo>
                    <a:lnTo>
                      <a:pt x="335" y="398"/>
                    </a:lnTo>
                    <a:lnTo>
                      <a:pt x="335" y="398"/>
                    </a:lnTo>
                    <a:lnTo>
                      <a:pt x="338" y="383"/>
                    </a:lnTo>
                    <a:lnTo>
                      <a:pt x="338" y="383"/>
                    </a:lnTo>
                    <a:lnTo>
                      <a:pt x="341" y="366"/>
                    </a:lnTo>
                    <a:lnTo>
                      <a:pt x="341" y="366"/>
                    </a:lnTo>
                    <a:lnTo>
                      <a:pt x="344" y="353"/>
                    </a:lnTo>
                    <a:lnTo>
                      <a:pt x="344" y="353"/>
                    </a:lnTo>
                    <a:lnTo>
                      <a:pt x="347" y="338"/>
                    </a:lnTo>
                    <a:lnTo>
                      <a:pt x="347" y="338"/>
                    </a:lnTo>
                    <a:lnTo>
                      <a:pt x="350" y="324"/>
                    </a:lnTo>
                    <a:lnTo>
                      <a:pt x="350" y="324"/>
                    </a:lnTo>
                    <a:lnTo>
                      <a:pt x="352" y="312"/>
                    </a:lnTo>
                    <a:lnTo>
                      <a:pt x="352" y="312"/>
                    </a:lnTo>
                    <a:lnTo>
                      <a:pt x="355" y="298"/>
                    </a:lnTo>
                    <a:lnTo>
                      <a:pt x="355" y="298"/>
                    </a:lnTo>
                    <a:lnTo>
                      <a:pt x="358" y="285"/>
                    </a:lnTo>
                    <a:lnTo>
                      <a:pt x="358" y="285"/>
                    </a:lnTo>
                    <a:lnTo>
                      <a:pt x="361" y="273"/>
                    </a:lnTo>
                    <a:lnTo>
                      <a:pt x="361" y="273"/>
                    </a:lnTo>
                    <a:lnTo>
                      <a:pt x="363" y="262"/>
                    </a:lnTo>
                    <a:lnTo>
                      <a:pt x="363" y="262"/>
                    </a:lnTo>
                    <a:lnTo>
                      <a:pt x="365" y="251"/>
                    </a:lnTo>
                    <a:lnTo>
                      <a:pt x="365" y="251"/>
                    </a:lnTo>
                    <a:lnTo>
                      <a:pt x="368" y="242"/>
                    </a:lnTo>
                    <a:lnTo>
                      <a:pt x="368" y="242"/>
                    </a:lnTo>
                    <a:lnTo>
                      <a:pt x="371" y="232"/>
                    </a:lnTo>
                    <a:lnTo>
                      <a:pt x="371" y="232"/>
                    </a:lnTo>
                    <a:lnTo>
                      <a:pt x="374" y="224"/>
                    </a:lnTo>
                    <a:lnTo>
                      <a:pt x="374" y="224"/>
                    </a:lnTo>
                    <a:lnTo>
                      <a:pt x="377" y="215"/>
                    </a:lnTo>
                    <a:lnTo>
                      <a:pt x="377" y="215"/>
                    </a:lnTo>
                    <a:lnTo>
                      <a:pt x="380" y="209"/>
                    </a:lnTo>
                    <a:lnTo>
                      <a:pt x="380" y="209"/>
                    </a:lnTo>
                    <a:lnTo>
                      <a:pt x="383" y="203"/>
                    </a:lnTo>
                    <a:lnTo>
                      <a:pt x="385" y="198"/>
                    </a:lnTo>
                    <a:lnTo>
                      <a:pt x="388" y="192"/>
                    </a:lnTo>
                    <a:lnTo>
                      <a:pt x="388" y="192"/>
                    </a:lnTo>
                    <a:lnTo>
                      <a:pt x="391" y="189"/>
                    </a:lnTo>
                    <a:lnTo>
                      <a:pt x="391" y="189"/>
                    </a:lnTo>
                    <a:lnTo>
                      <a:pt x="394" y="187"/>
                    </a:lnTo>
                    <a:lnTo>
                      <a:pt x="397" y="185"/>
                    </a:lnTo>
                    <a:lnTo>
                      <a:pt x="400" y="184"/>
                    </a:lnTo>
                    <a:lnTo>
                      <a:pt x="407" y="183"/>
                    </a:lnTo>
                    <a:lnTo>
                      <a:pt x="410" y="184"/>
                    </a:lnTo>
                    <a:lnTo>
                      <a:pt x="413" y="187"/>
                    </a:lnTo>
                    <a:lnTo>
                      <a:pt x="415" y="191"/>
                    </a:lnTo>
                    <a:lnTo>
                      <a:pt x="415" y="191"/>
                    </a:lnTo>
                    <a:lnTo>
                      <a:pt x="418" y="195"/>
                    </a:lnTo>
                    <a:lnTo>
                      <a:pt x="418" y="195"/>
                    </a:lnTo>
                    <a:lnTo>
                      <a:pt x="421" y="199"/>
                    </a:lnTo>
                    <a:lnTo>
                      <a:pt x="424" y="203"/>
                    </a:lnTo>
                    <a:lnTo>
                      <a:pt x="427" y="207"/>
                    </a:lnTo>
                    <a:lnTo>
                      <a:pt x="427" y="207"/>
                    </a:lnTo>
                    <a:lnTo>
                      <a:pt x="430" y="214"/>
                    </a:lnTo>
                    <a:lnTo>
                      <a:pt x="433" y="220"/>
                    </a:lnTo>
                    <a:lnTo>
                      <a:pt x="436" y="228"/>
                    </a:lnTo>
                    <a:lnTo>
                      <a:pt x="436" y="228"/>
                    </a:lnTo>
                    <a:lnTo>
                      <a:pt x="438" y="235"/>
                    </a:lnTo>
                    <a:lnTo>
                      <a:pt x="438" y="235"/>
                    </a:lnTo>
                    <a:lnTo>
                      <a:pt x="441" y="243"/>
                    </a:lnTo>
                    <a:lnTo>
                      <a:pt x="441" y="243"/>
                    </a:lnTo>
                    <a:lnTo>
                      <a:pt x="444" y="250"/>
                    </a:lnTo>
                    <a:lnTo>
                      <a:pt x="444" y="250"/>
                    </a:lnTo>
                    <a:lnTo>
                      <a:pt x="446" y="257"/>
                    </a:lnTo>
                    <a:lnTo>
                      <a:pt x="446" y="257"/>
                    </a:lnTo>
                    <a:lnTo>
                      <a:pt x="448" y="264"/>
                    </a:lnTo>
                    <a:lnTo>
                      <a:pt x="448" y="264"/>
                    </a:lnTo>
                    <a:lnTo>
                      <a:pt x="451" y="272"/>
                    </a:lnTo>
                    <a:lnTo>
                      <a:pt x="451" y="272"/>
                    </a:lnTo>
                    <a:lnTo>
                      <a:pt x="454" y="280"/>
                    </a:lnTo>
                    <a:lnTo>
                      <a:pt x="454" y="280"/>
                    </a:lnTo>
                    <a:lnTo>
                      <a:pt x="457" y="290"/>
                    </a:lnTo>
                    <a:lnTo>
                      <a:pt x="457" y="290"/>
                    </a:lnTo>
                    <a:lnTo>
                      <a:pt x="460" y="298"/>
                    </a:lnTo>
                    <a:lnTo>
                      <a:pt x="460" y="298"/>
                    </a:lnTo>
                    <a:lnTo>
                      <a:pt x="463" y="306"/>
                    </a:lnTo>
                    <a:lnTo>
                      <a:pt x="463" y="306"/>
                    </a:lnTo>
                    <a:lnTo>
                      <a:pt x="466" y="316"/>
                    </a:lnTo>
                    <a:lnTo>
                      <a:pt x="466" y="316"/>
                    </a:lnTo>
                    <a:lnTo>
                      <a:pt x="468" y="324"/>
                    </a:lnTo>
                    <a:lnTo>
                      <a:pt x="468" y="324"/>
                    </a:lnTo>
                    <a:lnTo>
                      <a:pt x="471" y="333"/>
                    </a:lnTo>
                    <a:lnTo>
                      <a:pt x="471" y="333"/>
                    </a:lnTo>
                    <a:lnTo>
                      <a:pt x="474" y="342"/>
                    </a:lnTo>
                    <a:lnTo>
                      <a:pt x="474" y="342"/>
                    </a:lnTo>
                    <a:lnTo>
                      <a:pt x="477" y="351"/>
                    </a:lnTo>
                    <a:lnTo>
                      <a:pt x="477" y="351"/>
                    </a:lnTo>
                    <a:lnTo>
                      <a:pt x="480" y="361"/>
                    </a:lnTo>
                    <a:lnTo>
                      <a:pt x="480" y="361"/>
                    </a:lnTo>
                    <a:lnTo>
                      <a:pt x="483" y="370"/>
                    </a:lnTo>
                    <a:lnTo>
                      <a:pt x="483" y="370"/>
                    </a:lnTo>
                    <a:lnTo>
                      <a:pt x="486" y="380"/>
                    </a:lnTo>
                    <a:lnTo>
                      <a:pt x="486" y="380"/>
                    </a:lnTo>
                    <a:lnTo>
                      <a:pt x="487" y="388"/>
                    </a:lnTo>
                    <a:lnTo>
                      <a:pt x="487" y="388"/>
                    </a:lnTo>
                    <a:lnTo>
                      <a:pt x="490" y="398"/>
                    </a:lnTo>
                    <a:lnTo>
                      <a:pt x="490" y="398"/>
                    </a:lnTo>
                    <a:lnTo>
                      <a:pt x="493" y="406"/>
                    </a:lnTo>
                    <a:lnTo>
                      <a:pt x="493" y="406"/>
                    </a:lnTo>
                    <a:lnTo>
                      <a:pt x="496" y="416"/>
                    </a:lnTo>
                    <a:lnTo>
                      <a:pt x="496" y="416"/>
                    </a:lnTo>
                    <a:lnTo>
                      <a:pt x="499" y="424"/>
                    </a:lnTo>
                    <a:lnTo>
                      <a:pt x="499" y="424"/>
                    </a:lnTo>
                    <a:lnTo>
                      <a:pt x="501" y="434"/>
                    </a:lnTo>
                    <a:lnTo>
                      <a:pt x="501" y="434"/>
                    </a:lnTo>
                    <a:lnTo>
                      <a:pt x="504" y="443"/>
                    </a:lnTo>
                    <a:lnTo>
                      <a:pt x="504" y="443"/>
                    </a:lnTo>
                    <a:lnTo>
                      <a:pt x="507" y="453"/>
                    </a:lnTo>
                    <a:lnTo>
                      <a:pt x="507" y="453"/>
                    </a:lnTo>
                    <a:lnTo>
                      <a:pt x="510" y="461"/>
                    </a:lnTo>
                    <a:lnTo>
                      <a:pt x="510" y="461"/>
                    </a:lnTo>
                    <a:lnTo>
                      <a:pt x="513" y="471"/>
                    </a:lnTo>
                    <a:lnTo>
                      <a:pt x="513" y="471"/>
                    </a:lnTo>
                    <a:lnTo>
                      <a:pt x="516" y="479"/>
                    </a:lnTo>
                    <a:lnTo>
                      <a:pt x="516" y="479"/>
                    </a:lnTo>
                    <a:lnTo>
                      <a:pt x="519" y="488"/>
                    </a:lnTo>
                    <a:lnTo>
                      <a:pt x="519" y="488"/>
                    </a:lnTo>
                    <a:lnTo>
                      <a:pt x="521" y="497"/>
                    </a:lnTo>
                    <a:lnTo>
                      <a:pt x="521" y="497"/>
                    </a:lnTo>
                    <a:lnTo>
                      <a:pt x="524" y="505"/>
                    </a:lnTo>
                    <a:lnTo>
                      <a:pt x="524" y="505"/>
                    </a:lnTo>
                    <a:lnTo>
                      <a:pt x="527" y="513"/>
                    </a:lnTo>
                    <a:lnTo>
                      <a:pt x="527" y="513"/>
                    </a:lnTo>
                    <a:lnTo>
                      <a:pt x="529" y="521"/>
                    </a:lnTo>
                    <a:lnTo>
                      <a:pt x="529" y="521"/>
                    </a:lnTo>
                    <a:lnTo>
                      <a:pt x="531" y="530"/>
                    </a:lnTo>
                    <a:lnTo>
                      <a:pt x="531" y="530"/>
                    </a:lnTo>
                    <a:lnTo>
                      <a:pt x="534" y="538"/>
                    </a:lnTo>
                    <a:lnTo>
                      <a:pt x="534" y="538"/>
                    </a:lnTo>
                    <a:lnTo>
                      <a:pt x="537" y="546"/>
                    </a:lnTo>
                    <a:lnTo>
                      <a:pt x="537" y="546"/>
                    </a:lnTo>
                    <a:lnTo>
                      <a:pt x="540" y="554"/>
                    </a:lnTo>
                    <a:lnTo>
                      <a:pt x="540" y="554"/>
                    </a:lnTo>
                    <a:lnTo>
                      <a:pt x="543" y="563"/>
                    </a:lnTo>
                    <a:lnTo>
                      <a:pt x="543" y="563"/>
                    </a:lnTo>
                    <a:lnTo>
                      <a:pt x="546" y="571"/>
                    </a:lnTo>
                    <a:lnTo>
                      <a:pt x="546" y="571"/>
                    </a:lnTo>
                    <a:lnTo>
                      <a:pt x="549" y="578"/>
                    </a:lnTo>
                    <a:lnTo>
                      <a:pt x="549" y="578"/>
                    </a:lnTo>
                    <a:lnTo>
                      <a:pt x="552" y="586"/>
                    </a:lnTo>
                    <a:lnTo>
                      <a:pt x="552" y="586"/>
                    </a:lnTo>
                    <a:lnTo>
                      <a:pt x="554" y="594"/>
                    </a:lnTo>
                    <a:lnTo>
                      <a:pt x="554" y="594"/>
                    </a:lnTo>
                    <a:lnTo>
                      <a:pt x="557" y="602"/>
                    </a:lnTo>
                    <a:lnTo>
                      <a:pt x="557" y="602"/>
                    </a:lnTo>
                    <a:lnTo>
                      <a:pt x="560" y="609"/>
                    </a:lnTo>
                    <a:lnTo>
                      <a:pt x="560" y="609"/>
                    </a:lnTo>
                    <a:lnTo>
                      <a:pt x="563" y="617"/>
                    </a:lnTo>
                    <a:lnTo>
                      <a:pt x="563" y="617"/>
                    </a:lnTo>
                    <a:lnTo>
                      <a:pt x="566" y="626"/>
                    </a:lnTo>
                    <a:lnTo>
                      <a:pt x="569" y="631"/>
                    </a:lnTo>
                    <a:lnTo>
                      <a:pt x="570" y="638"/>
                    </a:lnTo>
                    <a:lnTo>
                      <a:pt x="570" y="638"/>
                    </a:lnTo>
                    <a:lnTo>
                      <a:pt x="573" y="645"/>
                    </a:lnTo>
                    <a:lnTo>
                      <a:pt x="573" y="645"/>
                    </a:lnTo>
                    <a:lnTo>
                      <a:pt x="576" y="650"/>
                    </a:lnTo>
                    <a:lnTo>
                      <a:pt x="576" y="650"/>
                    </a:lnTo>
                    <a:lnTo>
                      <a:pt x="579" y="657"/>
                    </a:lnTo>
                    <a:lnTo>
                      <a:pt x="579" y="657"/>
                    </a:lnTo>
                    <a:lnTo>
                      <a:pt x="582" y="663"/>
                    </a:lnTo>
                    <a:lnTo>
                      <a:pt x="582" y="663"/>
                    </a:lnTo>
                    <a:lnTo>
                      <a:pt x="584" y="668"/>
                    </a:lnTo>
                    <a:lnTo>
                      <a:pt x="584" y="668"/>
                    </a:lnTo>
                    <a:lnTo>
                      <a:pt x="587" y="674"/>
                    </a:lnTo>
                    <a:lnTo>
                      <a:pt x="587" y="674"/>
                    </a:lnTo>
                    <a:lnTo>
                      <a:pt x="590" y="679"/>
                    </a:lnTo>
                    <a:lnTo>
                      <a:pt x="590" y="679"/>
                    </a:lnTo>
                    <a:lnTo>
                      <a:pt x="593" y="683"/>
                    </a:lnTo>
                    <a:lnTo>
                      <a:pt x="596" y="689"/>
                    </a:lnTo>
                    <a:lnTo>
                      <a:pt x="599" y="693"/>
                    </a:lnTo>
                    <a:lnTo>
                      <a:pt x="602" y="697"/>
                    </a:lnTo>
                    <a:lnTo>
                      <a:pt x="605" y="701"/>
                    </a:lnTo>
                    <a:lnTo>
                      <a:pt x="605" y="701"/>
                    </a:lnTo>
                    <a:lnTo>
                      <a:pt x="607" y="705"/>
                    </a:lnTo>
                    <a:lnTo>
                      <a:pt x="607" y="705"/>
                    </a:lnTo>
                    <a:lnTo>
                      <a:pt x="610" y="708"/>
                    </a:lnTo>
                    <a:lnTo>
                      <a:pt x="612" y="712"/>
                    </a:lnTo>
                    <a:lnTo>
                      <a:pt x="615" y="716"/>
                    </a:lnTo>
                    <a:lnTo>
                      <a:pt x="620" y="722"/>
                    </a:lnTo>
                    <a:lnTo>
                      <a:pt x="623" y="724"/>
                    </a:lnTo>
                    <a:lnTo>
                      <a:pt x="629" y="730"/>
                    </a:lnTo>
                    <a:lnTo>
                      <a:pt x="632" y="731"/>
                    </a:lnTo>
                    <a:lnTo>
                      <a:pt x="637" y="735"/>
                    </a:lnTo>
                    <a:lnTo>
                      <a:pt x="640" y="737"/>
                    </a:lnTo>
                    <a:lnTo>
                      <a:pt x="640" y="737"/>
                    </a:lnTo>
                    <a:lnTo>
                      <a:pt x="643" y="739"/>
                    </a:lnTo>
                    <a:lnTo>
                      <a:pt x="646" y="739"/>
                    </a:lnTo>
                    <a:lnTo>
                      <a:pt x="649" y="741"/>
                    </a:lnTo>
                    <a:lnTo>
                      <a:pt x="656" y="745"/>
                    </a:lnTo>
                    <a:lnTo>
                      <a:pt x="659" y="745"/>
                    </a:lnTo>
                    <a:lnTo>
                      <a:pt x="662" y="745"/>
                    </a:lnTo>
                    <a:lnTo>
                      <a:pt x="665" y="749"/>
                    </a:lnTo>
                    <a:lnTo>
                      <a:pt x="665" y="749"/>
                    </a:lnTo>
                    <a:lnTo>
                      <a:pt x="668" y="749"/>
                    </a:lnTo>
                    <a:lnTo>
                      <a:pt x="673" y="748"/>
                    </a:lnTo>
                    <a:lnTo>
                      <a:pt x="676" y="748"/>
                    </a:lnTo>
                    <a:lnTo>
                      <a:pt x="679" y="748"/>
                    </a:lnTo>
                    <a:lnTo>
                      <a:pt x="682" y="746"/>
                    </a:lnTo>
                    <a:lnTo>
                      <a:pt x="682" y="746"/>
                    </a:lnTo>
                    <a:lnTo>
                      <a:pt x="685" y="745"/>
                    </a:lnTo>
                    <a:lnTo>
                      <a:pt x="690" y="746"/>
                    </a:lnTo>
                    <a:lnTo>
                      <a:pt x="693" y="739"/>
                    </a:lnTo>
                    <a:lnTo>
                      <a:pt x="693" y="739"/>
                    </a:lnTo>
                    <a:lnTo>
                      <a:pt x="695" y="738"/>
                    </a:lnTo>
                    <a:lnTo>
                      <a:pt x="698" y="737"/>
                    </a:lnTo>
                    <a:lnTo>
                      <a:pt x="700" y="734"/>
                    </a:lnTo>
                    <a:lnTo>
                      <a:pt x="703" y="731"/>
                    </a:lnTo>
                    <a:lnTo>
                      <a:pt x="706" y="728"/>
                    </a:lnTo>
                    <a:lnTo>
                      <a:pt x="706" y="728"/>
                    </a:lnTo>
                    <a:lnTo>
                      <a:pt x="709" y="727"/>
                    </a:lnTo>
                    <a:lnTo>
                      <a:pt x="712" y="723"/>
                    </a:lnTo>
                    <a:lnTo>
                      <a:pt x="715" y="720"/>
                    </a:lnTo>
                    <a:lnTo>
                      <a:pt x="715" y="720"/>
                    </a:lnTo>
                    <a:lnTo>
                      <a:pt x="718" y="718"/>
                    </a:lnTo>
                    <a:lnTo>
                      <a:pt x="718" y="718"/>
                    </a:lnTo>
                    <a:lnTo>
                      <a:pt x="721" y="709"/>
                    </a:lnTo>
                    <a:lnTo>
                      <a:pt x="721" y="709"/>
                    </a:lnTo>
                    <a:lnTo>
                      <a:pt x="723" y="704"/>
                    </a:lnTo>
                    <a:lnTo>
                      <a:pt x="723" y="704"/>
                    </a:lnTo>
                    <a:lnTo>
                      <a:pt x="726" y="700"/>
                    </a:lnTo>
                    <a:lnTo>
                      <a:pt x="726" y="700"/>
                    </a:lnTo>
                    <a:lnTo>
                      <a:pt x="729" y="696"/>
                    </a:lnTo>
                    <a:lnTo>
                      <a:pt x="732" y="693"/>
                    </a:lnTo>
                    <a:lnTo>
                      <a:pt x="735" y="689"/>
                    </a:lnTo>
                    <a:lnTo>
                      <a:pt x="736" y="685"/>
                    </a:lnTo>
                    <a:lnTo>
                      <a:pt x="739" y="680"/>
                    </a:lnTo>
                    <a:lnTo>
                      <a:pt x="742" y="676"/>
                    </a:lnTo>
                    <a:lnTo>
                      <a:pt x="745" y="672"/>
                    </a:lnTo>
                    <a:lnTo>
                      <a:pt x="748" y="665"/>
                    </a:lnTo>
                    <a:lnTo>
                      <a:pt x="751" y="663"/>
                    </a:lnTo>
                    <a:lnTo>
                      <a:pt x="751" y="663"/>
                    </a:lnTo>
                    <a:lnTo>
                      <a:pt x="753" y="659"/>
                    </a:lnTo>
                    <a:lnTo>
                      <a:pt x="753" y="659"/>
                    </a:lnTo>
                    <a:lnTo>
                      <a:pt x="756" y="654"/>
                    </a:lnTo>
                    <a:lnTo>
                      <a:pt x="759" y="649"/>
                    </a:lnTo>
                    <a:lnTo>
                      <a:pt x="762" y="645"/>
                    </a:lnTo>
                    <a:lnTo>
                      <a:pt x="762" y="645"/>
                    </a:lnTo>
                    <a:lnTo>
                      <a:pt x="765" y="639"/>
                    </a:lnTo>
                    <a:lnTo>
                      <a:pt x="768" y="635"/>
                    </a:lnTo>
                    <a:lnTo>
                      <a:pt x="771" y="630"/>
                    </a:lnTo>
                    <a:lnTo>
                      <a:pt x="774" y="626"/>
                    </a:lnTo>
                    <a:lnTo>
                      <a:pt x="776" y="622"/>
                    </a:lnTo>
                    <a:lnTo>
                      <a:pt x="776" y="622"/>
                    </a:lnTo>
                    <a:lnTo>
                      <a:pt x="778" y="620"/>
                    </a:lnTo>
                    <a:lnTo>
                      <a:pt x="781" y="616"/>
                    </a:lnTo>
                    <a:lnTo>
                      <a:pt x="784" y="611"/>
                    </a:lnTo>
                    <a:lnTo>
                      <a:pt x="784" y="611"/>
                    </a:lnTo>
                    <a:lnTo>
                      <a:pt x="786" y="606"/>
                    </a:lnTo>
                    <a:lnTo>
                      <a:pt x="789" y="602"/>
                    </a:lnTo>
                    <a:lnTo>
                      <a:pt x="792" y="598"/>
                    </a:lnTo>
                    <a:lnTo>
                      <a:pt x="792" y="598"/>
                    </a:lnTo>
                    <a:lnTo>
                      <a:pt x="795" y="601"/>
                    </a:lnTo>
                    <a:lnTo>
                      <a:pt x="795" y="601"/>
                    </a:lnTo>
                    <a:lnTo>
                      <a:pt x="798" y="597"/>
                    </a:lnTo>
                    <a:lnTo>
                      <a:pt x="801" y="594"/>
                    </a:lnTo>
                    <a:lnTo>
                      <a:pt x="804" y="590"/>
                    </a:lnTo>
                    <a:lnTo>
                      <a:pt x="809" y="583"/>
                    </a:lnTo>
                    <a:lnTo>
                      <a:pt x="812" y="579"/>
                    </a:lnTo>
                    <a:lnTo>
                      <a:pt x="815" y="576"/>
                    </a:lnTo>
                    <a:lnTo>
                      <a:pt x="818" y="572"/>
                    </a:lnTo>
                    <a:lnTo>
                      <a:pt x="818" y="572"/>
                    </a:lnTo>
                    <a:lnTo>
                      <a:pt x="819" y="583"/>
                    </a:lnTo>
                    <a:lnTo>
                      <a:pt x="819" y="583"/>
                    </a:lnTo>
                    <a:lnTo>
                      <a:pt x="822" y="573"/>
                    </a:lnTo>
                    <a:lnTo>
                      <a:pt x="828" y="569"/>
                    </a:lnTo>
                    <a:lnTo>
                      <a:pt x="831" y="568"/>
                    </a:lnTo>
                    <a:lnTo>
                      <a:pt x="831" y="568"/>
                    </a:lnTo>
                    <a:lnTo>
                      <a:pt x="834" y="565"/>
                    </a:lnTo>
                    <a:lnTo>
                      <a:pt x="837" y="564"/>
                    </a:lnTo>
                    <a:lnTo>
                      <a:pt x="839" y="563"/>
                    </a:lnTo>
                    <a:lnTo>
                      <a:pt x="845" y="565"/>
                    </a:lnTo>
                    <a:lnTo>
                      <a:pt x="848" y="558"/>
                    </a:lnTo>
                    <a:lnTo>
                      <a:pt x="848" y="558"/>
                    </a:lnTo>
                    <a:lnTo>
                      <a:pt x="851" y="550"/>
                    </a:lnTo>
                    <a:lnTo>
                      <a:pt x="851" y="550"/>
                    </a:lnTo>
                    <a:lnTo>
                      <a:pt x="854" y="549"/>
                    </a:lnTo>
                    <a:lnTo>
                      <a:pt x="854" y="549"/>
                    </a:lnTo>
                    <a:lnTo>
                      <a:pt x="857" y="549"/>
                    </a:lnTo>
                    <a:lnTo>
                      <a:pt x="861" y="547"/>
                    </a:lnTo>
                    <a:lnTo>
                      <a:pt x="864" y="547"/>
                    </a:lnTo>
                    <a:lnTo>
                      <a:pt x="869" y="549"/>
                    </a:lnTo>
                    <a:lnTo>
                      <a:pt x="872" y="550"/>
                    </a:lnTo>
                    <a:lnTo>
                      <a:pt x="872" y="550"/>
                    </a:lnTo>
                    <a:lnTo>
                      <a:pt x="875" y="545"/>
                    </a:lnTo>
                    <a:lnTo>
                      <a:pt x="878" y="546"/>
                    </a:lnTo>
                    <a:lnTo>
                      <a:pt x="881" y="546"/>
                    </a:lnTo>
                    <a:lnTo>
                      <a:pt x="887" y="549"/>
                    </a:lnTo>
                    <a:lnTo>
                      <a:pt x="890" y="550"/>
                    </a:lnTo>
                    <a:lnTo>
                      <a:pt x="895" y="554"/>
                    </a:lnTo>
                    <a:lnTo>
                      <a:pt x="898" y="557"/>
                    </a:lnTo>
                    <a:lnTo>
                      <a:pt x="898" y="557"/>
                    </a:lnTo>
                    <a:lnTo>
                      <a:pt x="901" y="560"/>
                    </a:lnTo>
                    <a:lnTo>
                      <a:pt x="905" y="564"/>
                    </a:lnTo>
                    <a:lnTo>
                      <a:pt x="908" y="568"/>
                    </a:lnTo>
                    <a:lnTo>
                      <a:pt x="914" y="573"/>
                    </a:lnTo>
                    <a:lnTo>
                      <a:pt x="917" y="578"/>
                    </a:lnTo>
                    <a:lnTo>
                      <a:pt x="920" y="582"/>
                    </a:lnTo>
                    <a:lnTo>
                      <a:pt x="922" y="584"/>
                    </a:lnTo>
                    <a:lnTo>
                      <a:pt x="922" y="584"/>
                    </a:lnTo>
                    <a:lnTo>
                      <a:pt x="925" y="587"/>
                    </a:lnTo>
                    <a:lnTo>
                      <a:pt x="928" y="590"/>
                    </a:lnTo>
                    <a:lnTo>
                      <a:pt x="931" y="594"/>
                    </a:lnTo>
                    <a:lnTo>
                      <a:pt x="931" y="594"/>
                    </a:lnTo>
                    <a:lnTo>
                      <a:pt x="934" y="598"/>
                    </a:lnTo>
                    <a:lnTo>
                      <a:pt x="934" y="598"/>
                    </a:lnTo>
                    <a:lnTo>
                      <a:pt x="937" y="601"/>
                    </a:lnTo>
                    <a:lnTo>
                      <a:pt x="940" y="605"/>
                    </a:lnTo>
                    <a:lnTo>
                      <a:pt x="942" y="608"/>
                    </a:lnTo>
                    <a:lnTo>
                      <a:pt x="947" y="615"/>
                    </a:lnTo>
                    <a:lnTo>
                      <a:pt x="950" y="619"/>
                    </a:lnTo>
                    <a:lnTo>
                      <a:pt x="953" y="622"/>
                    </a:lnTo>
                    <a:lnTo>
                      <a:pt x="955" y="626"/>
                    </a:lnTo>
                    <a:lnTo>
                      <a:pt x="955" y="626"/>
                    </a:lnTo>
                    <a:lnTo>
                      <a:pt x="958" y="630"/>
                    </a:lnTo>
                    <a:lnTo>
                      <a:pt x="958" y="630"/>
                    </a:lnTo>
                    <a:lnTo>
                      <a:pt x="961" y="632"/>
                    </a:lnTo>
                    <a:lnTo>
                      <a:pt x="964" y="635"/>
                    </a:lnTo>
                    <a:lnTo>
                      <a:pt x="967" y="638"/>
                    </a:lnTo>
                    <a:lnTo>
                      <a:pt x="967" y="638"/>
                    </a:lnTo>
                    <a:lnTo>
                      <a:pt x="970" y="642"/>
                    </a:lnTo>
                    <a:lnTo>
                      <a:pt x="973" y="645"/>
                    </a:lnTo>
                    <a:lnTo>
                      <a:pt x="975" y="649"/>
                    </a:lnTo>
                    <a:lnTo>
                      <a:pt x="981" y="656"/>
                    </a:lnTo>
                    <a:lnTo>
                      <a:pt x="984" y="659"/>
                    </a:lnTo>
                    <a:lnTo>
                      <a:pt x="990" y="664"/>
                    </a:lnTo>
                    <a:lnTo>
                      <a:pt x="993" y="668"/>
                    </a:lnTo>
                    <a:lnTo>
                      <a:pt x="995" y="671"/>
                    </a:lnTo>
                    <a:lnTo>
                      <a:pt x="998" y="674"/>
                    </a:lnTo>
                    <a:lnTo>
                      <a:pt x="998" y="674"/>
                    </a:lnTo>
                    <a:lnTo>
                      <a:pt x="1001" y="678"/>
                    </a:lnTo>
                    <a:lnTo>
                      <a:pt x="1004" y="680"/>
                    </a:lnTo>
                    <a:lnTo>
                      <a:pt x="1007" y="683"/>
                    </a:lnTo>
                    <a:lnTo>
                      <a:pt x="1007" y="683"/>
                    </a:lnTo>
                    <a:lnTo>
                      <a:pt x="1010" y="687"/>
                    </a:lnTo>
                    <a:lnTo>
                      <a:pt x="1010" y="687"/>
                    </a:lnTo>
                    <a:lnTo>
                      <a:pt x="1013" y="690"/>
                    </a:lnTo>
                    <a:lnTo>
                      <a:pt x="1016" y="693"/>
                    </a:lnTo>
                    <a:lnTo>
                      <a:pt x="1018" y="696"/>
                    </a:lnTo>
                    <a:lnTo>
                      <a:pt x="1018" y="696"/>
                    </a:lnTo>
                    <a:lnTo>
                      <a:pt x="1021" y="698"/>
                    </a:lnTo>
                    <a:lnTo>
                      <a:pt x="1026" y="702"/>
                    </a:lnTo>
                    <a:lnTo>
                      <a:pt x="1028" y="707"/>
                    </a:lnTo>
                    <a:lnTo>
                      <a:pt x="1034" y="711"/>
                    </a:lnTo>
                    <a:lnTo>
                      <a:pt x="1037" y="712"/>
                    </a:lnTo>
                    <a:lnTo>
                      <a:pt x="1037" y="712"/>
                    </a:lnTo>
                    <a:lnTo>
                      <a:pt x="1040" y="715"/>
                    </a:lnTo>
                    <a:lnTo>
                      <a:pt x="1043" y="718"/>
                    </a:lnTo>
                    <a:lnTo>
                      <a:pt x="1046" y="723"/>
                    </a:lnTo>
                    <a:lnTo>
                      <a:pt x="1051" y="726"/>
                    </a:lnTo>
                    <a:lnTo>
                      <a:pt x="1054" y="727"/>
                    </a:lnTo>
                    <a:lnTo>
                      <a:pt x="1060" y="730"/>
                    </a:lnTo>
                    <a:lnTo>
                      <a:pt x="1063" y="731"/>
                    </a:lnTo>
                    <a:lnTo>
                      <a:pt x="1067" y="734"/>
                    </a:lnTo>
                    <a:lnTo>
                      <a:pt x="1070" y="739"/>
                    </a:lnTo>
                    <a:lnTo>
                      <a:pt x="1070" y="739"/>
                    </a:lnTo>
                    <a:lnTo>
                      <a:pt x="1073" y="734"/>
                    </a:lnTo>
                    <a:lnTo>
                      <a:pt x="1076" y="738"/>
                    </a:lnTo>
                    <a:lnTo>
                      <a:pt x="1079" y="739"/>
                    </a:lnTo>
                    <a:lnTo>
                      <a:pt x="1084" y="742"/>
                    </a:lnTo>
                    <a:lnTo>
                      <a:pt x="1087" y="742"/>
                    </a:lnTo>
                    <a:lnTo>
                      <a:pt x="1093" y="745"/>
                    </a:lnTo>
                    <a:lnTo>
                      <a:pt x="1096" y="745"/>
                    </a:lnTo>
                    <a:lnTo>
                      <a:pt x="1101" y="742"/>
                    </a:lnTo>
                    <a:lnTo>
                      <a:pt x="1104" y="745"/>
                    </a:lnTo>
                    <a:lnTo>
                      <a:pt x="1111" y="746"/>
                    </a:lnTo>
                    <a:lnTo>
                      <a:pt x="1114" y="746"/>
                    </a:lnTo>
                    <a:lnTo>
                      <a:pt x="1114" y="746"/>
                    </a:lnTo>
                    <a:lnTo>
                      <a:pt x="1117" y="748"/>
                    </a:lnTo>
                    <a:lnTo>
                      <a:pt x="1120" y="748"/>
                    </a:lnTo>
                    <a:lnTo>
                      <a:pt x="1123" y="748"/>
                    </a:lnTo>
                    <a:lnTo>
                      <a:pt x="1126" y="748"/>
                    </a:lnTo>
                    <a:lnTo>
                      <a:pt x="1129" y="746"/>
                    </a:lnTo>
                    <a:lnTo>
                      <a:pt x="1129" y="746"/>
                    </a:lnTo>
                    <a:lnTo>
                      <a:pt x="1132" y="746"/>
                    </a:lnTo>
                    <a:lnTo>
                      <a:pt x="1137" y="746"/>
                    </a:lnTo>
                    <a:lnTo>
                      <a:pt x="1140" y="745"/>
                    </a:lnTo>
                    <a:lnTo>
                      <a:pt x="1146" y="745"/>
                    </a:lnTo>
                    <a:lnTo>
                      <a:pt x="1149" y="744"/>
                    </a:lnTo>
                    <a:lnTo>
                      <a:pt x="1153" y="742"/>
                    </a:lnTo>
                    <a:lnTo>
                      <a:pt x="1156" y="742"/>
                    </a:lnTo>
                    <a:lnTo>
                      <a:pt x="1162" y="741"/>
                    </a:lnTo>
                    <a:lnTo>
                      <a:pt x="1164" y="739"/>
                    </a:lnTo>
                    <a:lnTo>
                      <a:pt x="1164" y="739"/>
                    </a:lnTo>
                    <a:lnTo>
                      <a:pt x="1167" y="738"/>
                    </a:lnTo>
                    <a:lnTo>
                      <a:pt x="1170" y="738"/>
                    </a:lnTo>
                    <a:lnTo>
                      <a:pt x="1173" y="737"/>
                    </a:lnTo>
                    <a:lnTo>
                      <a:pt x="1179" y="734"/>
                    </a:lnTo>
                    <a:lnTo>
                      <a:pt x="1182" y="733"/>
                    </a:lnTo>
                    <a:lnTo>
                      <a:pt x="1187" y="731"/>
                    </a:lnTo>
                    <a:lnTo>
                      <a:pt x="1190" y="728"/>
                    </a:lnTo>
                    <a:lnTo>
                      <a:pt x="1190" y="728"/>
                    </a:lnTo>
                    <a:lnTo>
                      <a:pt x="1192" y="733"/>
                    </a:lnTo>
                    <a:lnTo>
                      <a:pt x="1192" y="733"/>
                    </a:lnTo>
                    <a:lnTo>
                      <a:pt x="1195" y="728"/>
                    </a:lnTo>
                    <a:lnTo>
                      <a:pt x="1197" y="727"/>
                    </a:lnTo>
                    <a:lnTo>
                      <a:pt x="1200" y="726"/>
                    </a:lnTo>
                    <a:lnTo>
                      <a:pt x="1206" y="723"/>
                    </a:lnTo>
                    <a:lnTo>
                      <a:pt x="1209" y="720"/>
                    </a:lnTo>
                    <a:lnTo>
                      <a:pt x="1215" y="718"/>
                    </a:lnTo>
                    <a:lnTo>
                      <a:pt x="1217" y="720"/>
                    </a:lnTo>
                    <a:lnTo>
                      <a:pt x="1217" y="720"/>
                    </a:lnTo>
                    <a:lnTo>
                      <a:pt x="1220" y="712"/>
                    </a:lnTo>
                    <a:lnTo>
                      <a:pt x="1223" y="712"/>
                    </a:lnTo>
                    <a:lnTo>
                      <a:pt x="1226" y="711"/>
                    </a:lnTo>
                    <a:lnTo>
                      <a:pt x="1232" y="708"/>
                    </a:lnTo>
                    <a:lnTo>
                      <a:pt x="1233" y="707"/>
                    </a:lnTo>
                    <a:lnTo>
                      <a:pt x="1233" y="707"/>
                    </a:lnTo>
                    <a:lnTo>
                      <a:pt x="1236" y="705"/>
                    </a:lnTo>
                    <a:lnTo>
                      <a:pt x="1239" y="702"/>
                    </a:lnTo>
                    <a:lnTo>
                      <a:pt x="1242" y="701"/>
                    </a:lnTo>
                    <a:lnTo>
                      <a:pt x="1245" y="700"/>
                    </a:lnTo>
                    <a:lnTo>
                      <a:pt x="1248" y="696"/>
                    </a:lnTo>
                    <a:lnTo>
                      <a:pt x="1248" y="696"/>
                    </a:lnTo>
                    <a:lnTo>
                      <a:pt x="1250" y="696"/>
                    </a:lnTo>
                    <a:lnTo>
                      <a:pt x="1256" y="693"/>
                    </a:lnTo>
                    <a:lnTo>
                      <a:pt x="1259" y="691"/>
                    </a:lnTo>
                    <a:lnTo>
                      <a:pt x="1262" y="690"/>
                    </a:lnTo>
                    <a:lnTo>
                      <a:pt x="1265" y="689"/>
                    </a:lnTo>
                    <a:lnTo>
                      <a:pt x="1265" y="689"/>
                    </a:lnTo>
                    <a:lnTo>
                      <a:pt x="1268" y="687"/>
                    </a:lnTo>
                    <a:lnTo>
                      <a:pt x="1275" y="686"/>
                    </a:lnTo>
                    <a:lnTo>
                      <a:pt x="1278" y="685"/>
                    </a:lnTo>
                    <a:lnTo>
                      <a:pt x="1283" y="683"/>
                    </a:lnTo>
                    <a:lnTo>
                      <a:pt x="1286" y="682"/>
                    </a:lnTo>
                    <a:lnTo>
                      <a:pt x="1292" y="683"/>
                    </a:lnTo>
                    <a:lnTo>
                      <a:pt x="1295" y="683"/>
                    </a:lnTo>
                    <a:lnTo>
                      <a:pt x="1301" y="683"/>
                    </a:lnTo>
                    <a:lnTo>
                      <a:pt x="1303" y="683"/>
                    </a:lnTo>
                    <a:lnTo>
                      <a:pt x="1309" y="682"/>
                    </a:lnTo>
                    <a:lnTo>
                      <a:pt x="1312" y="682"/>
                    </a:lnTo>
                    <a:lnTo>
                      <a:pt x="1315" y="687"/>
                    </a:lnTo>
                    <a:lnTo>
                      <a:pt x="1316" y="679"/>
                    </a:lnTo>
                    <a:lnTo>
                      <a:pt x="1316" y="679"/>
                    </a:lnTo>
                    <a:lnTo>
                      <a:pt x="1319" y="683"/>
                    </a:lnTo>
                    <a:lnTo>
                      <a:pt x="1325" y="683"/>
                    </a:lnTo>
                    <a:lnTo>
                      <a:pt x="1328" y="683"/>
                    </a:lnTo>
                    <a:lnTo>
                      <a:pt x="1333" y="685"/>
                    </a:lnTo>
                    <a:lnTo>
                      <a:pt x="1336" y="685"/>
                    </a:lnTo>
                    <a:lnTo>
                      <a:pt x="1342" y="686"/>
                    </a:lnTo>
                    <a:lnTo>
                      <a:pt x="1345" y="680"/>
                    </a:lnTo>
                    <a:lnTo>
                      <a:pt x="1345" y="680"/>
                    </a:lnTo>
                    <a:lnTo>
                      <a:pt x="1348" y="686"/>
                    </a:lnTo>
                    <a:lnTo>
                      <a:pt x="1351" y="686"/>
                    </a:lnTo>
                    <a:lnTo>
                      <a:pt x="1353" y="687"/>
                    </a:lnTo>
                    <a:lnTo>
                      <a:pt x="1358" y="689"/>
                    </a:lnTo>
                    <a:lnTo>
                      <a:pt x="1361" y="690"/>
                    </a:lnTo>
                    <a:lnTo>
                      <a:pt x="1361" y="690"/>
                    </a:lnTo>
                    <a:lnTo>
                      <a:pt x="1364" y="690"/>
                    </a:lnTo>
                    <a:lnTo>
                      <a:pt x="1369" y="693"/>
                    </a:lnTo>
                    <a:lnTo>
                      <a:pt x="1372" y="694"/>
                    </a:lnTo>
                    <a:lnTo>
                      <a:pt x="1378" y="696"/>
                    </a:lnTo>
                    <a:lnTo>
                      <a:pt x="1381" y="702"/>
                    </a:lnTo>
                    <a:lnTo>
                      <a:pt x="1386" y="702"/>
                    </a:lnTo>
                    <a:lnTo>
                      <a:pt x="1389" y="702"/>
                    </a:lnTo>
                    <a:lnTo>
                      <a:pt x="1395" y="705"/>
                    </a:lnTo>
                    <a:lnTo>
                      <a:pt x="1398" y="707"/>
                    </a:lnTo>
                    <a:lnTo>
                      <a:pt x="1402" y="709"/>
                    </a:lnTo>
                    <a:lnTo>
                      <a:pt x="1405" y="715"/>
                    </a:lnTo>
                    <a:lnTo>
                      <a:pt x="1405" y="715"/>
                    </a:lnTo>
                    <a:lnTo>
                      <a:pt x="1408" y="709"/>
                    </a:lnTo>
                    <a:lnTo>
                      <a:pt x="1411" y="713"/>
                    </a:lnTo>
                    <a:lnTo>
                      <a:pt x="1414" y="715"/>
                    </a:lnTo>
                    <a:lnTo>
                      <a:pt x="1419" y="716"/>
                    </a:lnTo>
                    <a:lnTo>
                      <a:pt x="1422" y="718"/>
                    </a:lnTo>
                    <a:lnTo>
                      <a:pt x="1428" y="720"/>
                    </a:lnTo>
                    <a:lnTo>
                      <a:pt x="1431" y="722"/>
                    </a:lnTo>
                    <a:lnTo>
                      <a:pt x="1437" y="719"/>
                    </a:lnTo>
                    <a:lnTo>
                      <a:pt x="1439" y="723"/>
                    </a:lnTo>
                    <a:lnTo>
                      <a:pt x="1447" y="727"/>
                    </a:lnTo>
                    <a:lnTo>
                      <a:pt x="1449" y="727"/>
                    </a:lnTo>
                    <a:lnTo>
                      <a:pt x="1455" y="730"/>
                    </a:lnTo>
                    <a:lnTo>
                      <a:pt x="1458" y="730"/>
                    </a:lnTo>
                    <a:lnTo>
                      <a:pt x="1458" y="730"/>
                    </a:lnTo>
                    <a:lnTo>
                      <a:pt x="1461" y="731"/>
                    </a:lnTo>
                    <a:lnTo>
                      <a:pt x="1464" y="731"/>
                    </a:lnTo>
                    <a:lnTo>
                      <a:pt x="1467" y="734"/>
                    </a:lnTo>
                    <a:lnTo>
                      <a:pt x="1472" y="737"/>
                    </a:lnTo>
                    <a:lnTo>
                      <a:pt x="1475" y="737"/>
                    </a:lnTo>
                    <a:lnTo>
                      <a:pt x="1478" y="738"/>
                    </a:lnTo>
                    <a:lnTo>
                      <a:pt x="1481" y="739"/>
                    </a:lnTo>
                    <a:lnTo>
                      <a:pt x="1481" y="739"/>
                    </a:lnTo>
                    <a:lnTo>
                      <a:pt x="1482" y="741"/>
                    </a:lnTo>
                    <a:lnTo>
                      <a:pt x="1488" y="742"/>
                    </a:lnTo>
                    <a:lnTo>
                      <a:pt x="1491" y="744"/>
                    </a:lnTo>
                    <a:lnTo>
                      <a:pt x="1497" y="746"/>
                    </a:lnTo>
                    <a:lnTo>
                      <a:pt x="1500" y="746"/>
                    </a:lnTo>
                    <a:lnTo>
                      <a:pt x="1500" y="746"/>
                    </a:lnTo>
                    <a:lnTo>
                      <a:pt x="1502" y="748"/>
                    </a:lnTo>
                    <a:lnTo>
                      <a:pt x="1505" y="749"/>
                    </a:lnTo>
                    <a:lnTo>
                      <a:pt x="1508" y="750"/>
                    </a:lnTo>
                    <a:lnTo>
                      <a:pt x="1514" y="752"/>
                    </a:lnTo>
                    <a:lnTo>
                      <a:pt x="1517" y="753"/>
                    </a:lnTo>
                    <a:lnTo>
                      <a:pt x="1522" y="755"/>
                    </a:lnTo>
                    <a:lnTo>
                      <a:pt x="1524" y="756"/>
                    </a:lnTo>
                    <a:lnTo>
                      <a:pt x="1524" y="756"/>
                    </a:lnTo>
                    <a:lnTo>
                      <a:pt x="1527" y="757"/>
                    </a:lnTo>
                    <a:lnTo>
                      <a:pt x="1532" y="759"/>
                    </a:lnTo>
                    <a:lnTo>
                      <a:pt x="1535" y="759"/>
                    </a:lnTo>
                    <a:lnTo>
                      <a:pt x="1541" y="760"/>
                    </a:lnTo>
                    <a:lnTo>
                      <a:pt x="1544" y="760"/>
                    </a:lnTo>
                    <a:lnTo>
                      <a:pt x="1550" y="761"/>
                    </a:lnTo>
                    <a:lnTo>
                      <a:pt x="1553" y="761"/>
                    </a:lnTo>
                    <a:lnTo>
                      <a:pt x="1558" y="761"/>
                    </a:lnTo>
                    <a:lnTo>
                      <a:pt x="1561" y="763"/>
                    </a:lnTo>
                    <a:lnTo>
                      <a:pt x="1565" y="763"/>
                    </a:lnTo>
                    <a:lnTo>
                      <a:pt x="1568" y="763"/>
                    </a:lnTo>
                    <a:lnTo>
                      <a:pt x="1574" y="763"/>
                    </a:lnTo>
                    <a:lnTo>
                      <a:pt x="1577" y="763"/>
                    </a:lnTo>
                    <a:lnTo>
                      <a:pt x="1583" y="763"/>
                    </a:lnTo>
                    <a:lnTo>
                      <a:pt x="1585" y="763"/>
                    </a:lnTo>
                    <a:lnTo>
                      <a:pt x="1591" y="763"/>
                    </a:lnTo>
                    <a:lnTo>
                      <a:pt x="1594" y="763"/>
                    </a:lnTo>
                    <a:lnTo>
                      <a:pt x="1600" y="763"/>
                    </a:lnTo>
                    <a:lnTo>
                      <a:pt x="1603" y="761"/>
                    </a:lnTo>
                    <a:lnTo>
                      <a:pt x="1610" y="760"/>
                    </a:lnTo>
                    <a:lnTo>
                      <a:pt x="1613" y="760"/>
                    </a:lnTo>
                    <a:lnTo>
                      <a:pt x="1618" y="759"/>
                    </a:lnTo>
                    <a:lnTo>
                      <a:pt x="1621" y="759"/>
                    </a:lnTo>
                    <a:lnTo>
                      <a:pt x="1627" y="757"/>
                    </a:lnTo>
                    <a:lnTo>
                      <a:pt x="1630" y="756"/>
                    </a:lnTo>
                    <a:lnTo>
                      <a:pt x="1636" y="756"/>
                    </a:lnTo>
                    <a:lnTo>
                      <a:pt x="1638" y="756"/>
                    </a:lnTo>
                    <a:lnTo>
                      <a:pt x="1641" y="756"/>
                    </a:lnTo>
                    <a:lnTo>
                      <a:pt x="1644" y="755"/>
                    </a:lnTo>
                    <a:lnTo>
                      <a:pt x="1644" y="755"/>
                    </a:lnTo>
                    <a:lnTo>
                      <a:pt x="1647" y="755"/>
                    </a:lnTo>
                    <a:lnTo>
                      <a:pt x="1651" y="753"/>
                    </a:lnTo>
                    <a:lnTo>
                      <a:pt x="1654" y="753"/>
                    </a:lnTo>
                    <a:lnTo>
                      <a:pt x="1660" y="753"/>
                    </a:lnTo>
                    <a:lnTo>
                      <a:pt x="1663" y="753"/>
                    </a:lnTo>
                    <a:lnTo>
                      <a:pt x="1669" y="752"/>
                    </a:lnTo>
                    <a:lnTo>
                      <a:pt x="1671" y="752"/>
                    </a:lnTo>
                    <a:lnTo>
                      <a:pt x="1677" y="750"/>
                    </a:lnTo>
                    <a:lnTo>
                      <a:pt x="1680" y="750"/>
                    </a:lnTo>
                    <a:lnTo>
                      <a:pt x="1686" y="750"/>
                    </a:lnTo>
                    <a:lnTo>
                      <a:pt x="1689" y="749"/>
                    </a:lnTo>
                    <a:lnTo>
                      <a:pt x="1696" y="749"/>
                    </a:lnTo>
                    <a:lnTo>
                      <a:pt x="1699" y="748"/>
                    </a:lnTo>
                    <a:lnTo>
                      <a:pt x="1701" y="748"/>
                    </a:lnTo>
                    <a:lnTo>
                      <a:pt x="1704" y="746"/>
                    </a:lnTo>
                    <a:lnTo>
                      <a:pt x="1704" y="746"/>
                    </a:lnTo>
                    <a:lnTo>
                      <a:pt x="1707" y="746"/>
                    </a:lnTo>
                    <a:lnTo>
                      <a:pt x="1713" y="746"/>
                    </a:lnTo>
                    <a:lnTo>
                      <a:pt x="1716" y="745"/>
                    </a:lnTo>
                    <a:lnTo>
                      <a:pt x="1722" y="744"/>
                    </a:lnTo>
                    <a:lnTo>
                      <a:pt x="1724" y="744"/>
                    </a:lnTo>
                    <a:lnTo>
                      <a:pt x="1730" y="742"/>
                    </a:lnTo>
                    <a:lnTo>
                      <a:pt x="1732" y="742"/>
                    </a:lnTo>
                    <a:lnTo>
                      <a:pt x="1737" y="741"/>
                    </a:lnTo>
                    <a:lnTo>
                      <a:pt x="1740" y="741"/>
                    </a:lnTo>
                    <a:lnTo>
                      <a:pt x="1746" y="739"/>
                    </a:lnTo>
                    <a:lnTo>
                      <a:pt x="1749" y="738"/>
                    </a:lnTo>
                    <a:lnTo>
                      <a:pt x="1754" y="738"/>
                    </a:lnTo>
                    <a:lnTo>
                      <a:pt x="1757" y="738"/>
                    </a:lnTo>
                    <a:lnTo>
                      <a:pt x="1763" y="738"/>
                    </a:lnTo>
                    <a:lnTo>
                      <a:pt x="1766" y="737"/>
                    </a:lnTo>
                    <a:lnTo>
                      <a:pt x="1773" y="737"/>
                    </a:lnTo>
                    <a:lnTo>
                      <a:pt x="1776" y="737"/>
                    </a:lnTo>
                    <a:lnTo>
                      <a:pt x="1782" y="737"/>
                    </a:lnTo>
                    <a:lnTo>
                      <a:pt x="1785" y="737"/>
                    </a:lnTo>
                    <a:lnTo>
                      <a:pt x="1790" y="737"/>
                    </a:lnTo>
                    <a:lnTo>
                      <a:pt x="1793" y="737"/>
                    </a:lnTo>
                    <a:lnTo>
                      <a:pt x="1799" y="738"/>
                    </a:lnTo>
                    <a:lnTo>
                      <a:pt x="1802" y="738"/>
                    </a:lnTo>
                    <a:lnTo>
                      <a:pt x="1802" y="738"/>
                    </a:lnTo>
                    <a:lnTo>
                      <a:pt x="1805" y="739"/>
                    </a:lnTo>
                    <a:lnTo>
                      <a:pt x="1807" y="739"/>
                    </a:lnTo>
                    <a:lnTo>
                      <a:pt x="1810" y="739"/>
                    </a:lnTo>
                    <a:lnTo>
                      <a:pt x="1815" y="739"/>
                    </a:lnTo>
                    <a:lnTo>
                      <a:pt x="1817" y="741"/>
                    </a:lnTo>
                    <a:lnTo>
                      <a:pt x="1823" y="742"/>
                    </a:lnTo>
                    <a:lnTo>
                      <a:pt x="1826" y="744"/>
                    </a:lnTo>
                    <a:lnTo>
                      <a:pt x="1832" y="745"/>
                    </a:lnTo>
                    <a:lnTo>
                      <a:pt x="1835" y="745"/>
                    </a:lnTo>
                    <a:lnTo>
                      <a:pt x="1840" y="746"/>
                    </a:lnTo>
                    <a:lnTo>
                      <a:pt x="1843" y="748"/>
                    </a:lnTo>
                    <a:lnTo>
                      <a:pt x="1849" y="749"/>
                    </a:lnTo>
                    <a:lnTo>
                      <a:pt x="1852" y="749"/>
                    </a:lnTo>
                    <a:lnTo>
                      <a:pt x="1859" y="752"/>
                    </a:lnTo>
                    <a:lnTo>
                      <a:pt x="1862" y="752"/>
                    </a:lnTo>
                    <a:lnTo>
                      <a:pt x="1868" y="753"/>
                    </a:lnTo>
                    <a:lnTo>
                      <a:pt x="1870" y="755"/>
                    </a:lnTo>
                    <a:lnTo>
                      <a:pt x="1873" y="755"/>
                    </a:lnTo>
                    <a:lnTo>
                      <a:pt x="1876" y="756"/>
                    </a:lnTo>
                    <a:lnTo>
                      <a:pt x="1876" y="756"/>
                    </a:lnTo>
                    <a:lnTo>
                      <a:pt x="1879" y="756"/>
                    </a:lnTo>
                    <a:lnTo>
                      <a:pt x="1885" y="757"/>
                    </a:lnTo>
                    <a:lnTo>
                      <a:pt x="1888" y="757"/>
                    </a:lnTo>
                    <a:lnTo>
                      <a:pt x="1893" y="759"/>
                    </a:lnTo>
                    <a:lnTo>
                      <a:pt x="1896" y="759"/>
                    </a:lnTo>
                    <a:lnTo>
                      <a:pt x="1901" y="760"/>
                    </a:lnTo>
                    <a:lnTo>
                      <a:pt x="1903" y="761"/>
                    </a:lnTo>
                    <a:lnTo>
                      <a:pt x="1903" y="761"/>
                    </a:lnTo>
                    <a:lnTo>
                      <a:pt x="1906" y="766"/>
                    </a:lnTo>
                    <a:lnTo>
                      <a:pt x="1909" y="764"/>
                    </a:lnTo>
                    <a:lnTo>
                      <a:pt x="1912" y="766"/>
                    </a:lnTo>
                    <a:lnTo>
                      <a:pt x="1918" y="767"/>
                    </a:lnTo>
                    <a:lnTo>
                      <a:pt x="1921" y="767"/>
                    </a:lnTo>
                    <a:lnTo>
                      <a:pt x="1926" y="768"/>
                    </a:lnTo>
                    <a:lnTo>
                      <a:pt x="1929" y="770"/>
                    </a:lnTo>
                    <a:lnTo>
                      <a:pt x="1929" y="770"/>
                    </a:lnTo>
                    <a:lnTo>
                      <a:pt x="1932" y="772"/>
                    </a:lnTo>
                    <a:lnTo>
                      <a:pt x="1932" y="772"/>
                    </a:lnTo>
                    <a:lnTo>
                      <a:pt x="1935" y="770"/>
                    </a:lnTo>
                    <a:lnTo>
                      <a:pt x="1935" y="770"/>
                    </a:lnTo>
                    <a:lnTo>
                      <a:pt x="1938" y="771"/>
                    </a:lnTo>
                    <a:lnTo>
                      <a:pt x="1939" y="771"/>
                    </a:lnTo>
                    <a:lnTo>
                      <a:pt x="1942" y="772"/>
                    </a:lnTo>
                    <a:lnTo>
                      <a:pt x="1945" y="772"/>
                    </a:lnTo>
                    <a:lnTo>
                      <a:pt x="1948" y="774"/>
                    </a:lnTo>
                    <a:lnTo>
                      <a:pt x="1954" y="774"/>
                    </a:lnTo>
                    <a:lnTo>
                      <a:pt x="1956" y="775"/>
                    </a:lnTo>
                    <a:lnTo>
                      <a:pt x="1962" y="772"/>
                    </a:lnTo>
                    <a:lnTo>
                      <a:pt x="1965" y="774"/>
                    </a:lnTo>
                    <a:lnTo>
                      <a:pt x="1971" y="774"/>
                    </a:lnTo>
                    <a:lnTo>
                      <a:pt x="1974" y="775"/>
                    </a:lnTo>
                    <a:lnTo>
                      <a:pt x="1979" y="775"/>
                    </a:lnTo>
                    <a:lnTo>
                      <a:pt x="1981" y="774"/>
                    </a:lnTo>
                    <a:lnTo>
                      <a:pt x="1981" y="774"/>
                    </a:lnTo>
                    <a:lnTo>
                      <a:pt x="1982" y="794"/>
                    </a:lnTo>
                  </a:path>
                </a:pathLst>
              </a:custGeom>
              <a:noFill/>
              <a:ln w="14288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" name="Freeform 95">
                <a:extLst>
                  <a:ext uri="{FF2B5EF4-FFF2-40B4-BE49-F238E27FC236}">
                    <a16:creationId xmlns:a16="http://schemas.microsoft.com/office/drawing/2014/main" id="{4B0EC79E-46BD-4415-845E-4530C37F295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19563" y="1325563"/>
                <a:ext cx="1571625" cy="668337"/>
              </a:xfrm>
              <a:custGeom>
                <a:avLst/>
                <a:gdLst>
                  <a:gd name="T0" fmla="*/ 20 w 1981"/>
                  <a:gd name="T1" fmla="*/ 59 h 843"/>
                  <a:gd name="T2" fmla="*/ 39 w 1981"/>
                  <a:gd name="T3" fmla="*/ 129 h 843"/>
                  <a:gd name="T4" fmla="*/ 59 w 1981"/>
                  <a:gd name="T5" fmla="*/ 199 h 843"/>
                  <a:gd name="T6" fmla="*/ 78 w 1981"/>
                  <a:gd name="T7" fmla="*/ 279 h 843"/>
                  <a:gd name="T8" fmla="*/ 98 w 1981"/>
                  <a:gd name="T9" fmla="*/ 376 h 843"/>
                  <a:gd name="T10" fmla="*/ 116 w 1981"/>
                  <a:gd name="T11" fmla="*/ 482 h 843"/>
                  <a:gd name="T12" fmla="*/ 136 w 1981"/>
                  <a:gd name="T13" fmla="*/ 583 h 843"/>
                  <a:gd name="T14" fmla="*/ 155 w 1981"/>
                  <a:gd name="T15" fmla="*/ 670 h 843"/>
                  <a:gd name="T16" fmla="*/ 175 w 1981"/>
                  <a:gd name="T17" fmla="*/ 730 h 843"/>
                  <a:gd name="T18" fmla="*/ 199 w 1981"/>
                  <a:gd name="T19" fmla="*/ 777 h 843"/>
                  <a:gd name="T20" fmla="*/ 236 w 1981"/>
                  <a:gd name="T21" fmla="*/ 780 h 843"/>
                  <a:gd name="T22" fmla="*/ 264 w 1981"/>
                  <a:gd name="T23" fmla="*/ 729 h 843"/>
                  <a:gd name="T24" fmla="*/ 282 w 1981"/>
                  <a:gd name="T25" fmla="*/ 659 h 843"/>
                  <a:gd name="T26" fmla="*/ 302 w 1981"/>
                  <a:gd name="T27" fmla="*/ 559 h 843"/>
                  <a:gd name="T28" fmla="*/ 321 w 1981"/>
                  <a:gd name="T29" fmla="*/ 438 h 843"/>
                  <a:gd name="T30" fmla="*/ 341 w 1981"/>
                  <a:gd name="T31" fmla="*/ 312 h 843"/>
                  <a:gd name="T32" fmla="*/ 361 w 1981"/>
                  <a:gd name="T33" fmla="*/ 208 h 843"/>
                  <a:gd name="T34" fmla="*/ 380 w 1981"/>
                  <a:gd name="T35" fmla="*/ 146 h 843"/>
                  <a:gd name="T36" fmla="*/ 413 w 1981"/>
                  <a:gd name="T37" fmla="*/ 157 h 843"/>
                  <a:gd name="T38" fmla="*/ 436 w 1981"/>
                  <a:gd name="T39" fmla="*/ 221 h 843"/>
                  <a:gd name="T40" fmla="*/ 454 w 1981"/>
                  <a:gd name="T41" fmla="*/ 293 h 843"/>
                  <a:gd name="T42" fmla="*/ 474 w 1981"/>
                  <a:gd name="T43" fmla="*/ 365 h 843"/>
                  <a:gd name="T44" fmla="*/ 493 w 1981"/>
                  <a:gd name="T45" fmla="*/ 439 h 843"/>
                  <a:gd name="T46" fmla="*/ 513 w 1981"/>
                  <a:gd name="T47" fmla="*/ 501 h 843"/>
                  <a:gd name="T48" fmla="*/ 534 w 1981"/>
                  <a:gd name="T49" fmla="*/ 570 h 843"/>
                  <a:gd name="T50" fmla="*/ 554 w 1981"/>
                  <a:gd name="T51" fmla="*/ 627 h 843"/>
                  <a:gd name="T52" fmla="*/ 573 w 1981"/>
                  <a:gd name="T53" fmla="*/ 684 h 843"/>
                  <a:gd name="T54" fmla="*/ 602 w 1981"/>
                  <a:gd name="T55" fmla="*/ 741 h 843"/>
                  <a:gd name="T56" fmla="*/ 632 w 1981"/>
                  <a:gd name="T57" fmla="*/ 780 h 843"/>
                  <a:gd name="T58" fmla="*/ 676 w 1981"/>
                  <a:gd name="T59" fmla="*/ 788 h 843"/>
                  <a:gd name="T60" fmla="*/ 709 w 1981"/>
                  <a:gd name="T61" fmla="*/ 756 h 843"/>
                  <a:gd name="T62" fmla="*/ 735 w 1981"/>
                  <a:gd name="T63" fmla="*/ 708 h 843"/>
                  <a:gd name="T64" fmla="*/ 762 w 1981"/>
                  <a:gd name="T65" fmla="*/ 653 h 843"/>
                  <a:gd name="T66" fmla="*/ 792 w 1981"/>
                  <a:gd name="T67" fmla="*/ 600 h 843"/>
                  <a:gd name="T68" fmla="*/ 822 w 1981"/>
                  <a:gd name="T69" fmla="*/ 568 h 843"/>
                  <a:gd name="T70" fmla="*/ 857 w 1981"/>
                  <a:gd name="T71" fmla="*/ 551 h 843"/>
                  <a:gd name="T72" fmla="*/ 898 w 1981"/>
                  <a:gd name="T73" fmla="*/ 579 h 843"/>
                  <a:gd name="T74" fmla="*/ 928 w 1981"/>
                  <a:gd name="T75" fmla="*/ 619 h 843"/>
                  <a:gd name="T76" fmla="*/ 958 w 1981"/>
                  <a:gd name="T77" fmla="*/ 662 h 843"/>
                  <a:gd name="T78" fmla="*/ 990 w 1981"/>
                  <a:gd name="T79" fmla="*/ 701 h 843"/>
                  <a:gd name="T80" fmla="*/ 1026 w 1981"/>
                  <a:gd name="T81" fmla="*/ 743 h 843"/>
                  <a:gd name="T82" fmla="*/ 1063 w 1981"/>
                  <a:gd name="T83" fmla="*/ 771 h 843"/>
                  <a:gd name="T84" fmla="*/ 1104 w 1981"/>
                  <a:gd name="T85" fmla="*/ 784 h 843"/>
                  <a:gd name="T86" fmla="*/ 1153 w 1981"/>
                  <a:gd name="T87" fmla="*/ 773 h 843"/>
                  <a:gd name="T88" fmla="*/ 1200 w 1981"/>
                  <a:gd name="T89" fmla="*/ 748 h 843"/>
                  <a:gd name="T90" fmla="*/ 1242 w 1981"/>
                  <a:gd name="T91" fmla="*/ 722 h 843"/>
                  <a:gd name="T92" fmla="*/ 1295 w 1981"/>
                  <a:gd name="T93" fmla="*/ 707 h 843"/>
                  <a:gd name="T94" fmla="*/ 1345 w 1981"/>
                  <a:gd name="T95" fmla="*/ 716 h 843"/>
                  <a:gd name="T96" fmla="*/ 1389 w 1981"/>
                  <a:gd name="T97" fmla="*/ 734 h 843"/>
                  <a:gd name="T98" fmla="*/ 1431 w 1981"/>
                  <a:gd name="T99" fmla="*/ 758 h 843"/>
                  <a:gd name="T100" fmla="*/ 1482 w 1981"/>
                  <a:gd name="T101" fmla="*/ 788 h 843"/>
                  <a:gd name="T102" fmla="*/ 1535 w 1981"/>
                  <a:gd name="T103" fmla="*/ 808 h 843"/>
                  <a:gd name="T104" fmla="*/ 1594 w 1981"/>
                  <a:gd name="T105" fmla="*/ 814 h 843"/>
                  <a:gd name="T106" fmla="*/ 1654 w 1981"/>
                  <a:gd name="T107" fmla="*/ 812 h 843"/>
                  <a:gd name="T108" fmla="*/ 1716 w 1981"/>
                  <a:gd name="T109" fmla="*/ 811 h 843"/>
                  <a:gd name="T110" fmla="*/ 1776 w 1981"/>
                  <a:gd name="T111" fmla="*/ 811 h 843"/>
                  <a:gd name="T112" fmla="*/ 1826 w 1981"/>
                  <a:gd name="T113" fmla="*/ 819 h 843"/>
                  <a:gd name="T114" fmla="*/ 1879 w 1981"/>
                  <a:gd name="T115" fmla="*/ 828 h 843"/>
                  <a:gd name="T116" fmla="*/ 1929 w 1981"/>
                  <a:gd name="T117" fmla="*/ 834 h 843"/>
                  <a:gd name="T118" fmla="*/ 1981 w 1981"/>
                  <a:gd name="T119" fmla="*/ 843 h 8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1981" h="843">
                    <a:moveTo>
                      <a:pt x="0" y="0"/>
                    </a:moveTo>
                    <a:lnTo>
                      <a:pt x="0" y="0"/>
                    </a:lnTo>
                    <a:lnTo>
                      <a:pt x="3" y="7"/>
                    </a:lnTo>
                    <a:lnTo>
                      <a:pt x="6" y="16"/>
                    </a:lnTo>
                    <a:lnTo>
                      <a:pt x="6" y="16"/>
                    </a:lnTo>
                    <a:lnTo>
                      <a:pt x="9" y="24"/>
                    </a:lnTo>
                    <a:lnTo>
                      <a:pt x="9" y="24"/>
                    </a:lnTo>
                    <a:lnTo>
                      <a:pt x="12" y="32"/>
                    </a:lnTo>
                    <a:lnTo>
                      <a:pt x="12" y="32"/>
                    </a:lnTo>
                    <a:lnTo>
                      <a:pt x="15" y="42"/>
                    </a:lnTo>
                    <a:lnTo>
                      <a:pt x="15" y="42"/>
                    </a:lnTo>
                    <a:lnTo>
                      <a:pt x="17" y="50"/>
                    </a:lnTo>
                    <a:lnTo>
                      <a:pt x="17" y="50"/>
                    </a:lnTo>
                    <a:lnTo>
                      <a:pt x="20" y="59"/>
                    </a:lnTo>
                    <a:lnTo>
                      <a:pt x="20" y="59"/>
                    </a:lnTo>
                    <a:lnTo>
                      <a:pt x="23" y="69"/>
                    </a:lnTo>
                    <a:lnTo>
                      <a:pt x="23" y="69"/>
                    </a:lnTo>
                    <a:lnTo>
                      <a:pt x="26" y="79"/>
                    </a:lnTo>
                    <a:lnTo>
                      <a:pt x="26" y="79"/>
                    </a:lnTo>
                    <a:lnTo>
                      <a:pt x="29" y="90"/>
                    </a:lnTo>
                    <a:lnTo>
                      <a:pt x="29" y="90"/>
                    </a:lnTo>
                    <a:lnTo>
                      <a:pt x="30" y="101"/>
                    </a:lnTo>
                    <a:lnTo>
                      <a:pt x="30" y="101"/>
                    </a:lnTo>
                    <a:lnTo>
                      <a:pt x="33" y="112"/>
                    </a:lnTo>
                    <a:lnTo>
                      <a:pt x="33" y="112"/>
                    </a:lnTo>
                    <a:lnTo>
                      <a:pt x="36" y="120"/>
                    </a:lnTo>
                    <a:lnTo>
                      <a:pt x="36" y="120"/>
                    </a:lnTo>
                    <a:lnTo>
                      <a:pt x="39" y="129"/>
                    </a:lnTo>
                    <a:lnTo>
                      <a:pt x="39" y="129"/>
                    </a:lnTo>
                    <a:lnTo>
                      <a:pt x="42" y="139"/>
                    </a:lnTo>
                    <a:lnTo>
                      <a:pt x="42" y="139"/>
                    </a:lnTo>
                    <a:lnTo>
                      <a:pt x="45" y="149"/>
                    </a:lnTo>
                    <a:lnTo>
                      <a:pt x="45" y="149"/>
                    </a:lnTo>
                    <a:lnTo>
                      <a:pt x="47" y="158"/>
                    </a:lnTo>
                    <a:lnTo>
                      <a:pt x="47" y="158"/>
                    </a:lnTo>
                    <a:lnTo>
                      <a:pt x="50" y="168"/>
                    </a:lnTo>
                    <a:lnTo>
                      <a:pt x="50" y="168"/>
                    </a:lnTo>
                    <a:lnTo>
                      <a:pt x="53" y="177"/>
                    </a:lnTo>
                    <a:lnTo>
                      <a:pt x="53" y="177"/>
                    </a:lnTo>
                    <a:lnTo>
                      <a:pt x="56" y="188"/>
                    </a:lnTo>
                    <a:lnTo>
                      <a:pt x="56" y="188"/>
                    </a:lnTo>
                    <a:lnTo>
                      <a:pt x="59" y="199"/>
                    </a:lnTo>
                    <a:lnTo>
                      <a:pt x="59" y="199"/>
                    </a:lnTo>
                    <a:lnTo>
                      <a:pt x="62" y="209"/>
                    </a:lnTo>
                    <a:lnTo>
                      <a:pt x="62" y="209"/>
                    </a:lnTo>
                    <a:lnTo>
                      <a:pt x="65" y="220"/>
                    </a:lnTo>
                    <a:lnTo>
                      <a:pt x="65" y="220"/>
                    </a:lnTo>
                    <a:lnTo>
                      <a:pt x="68" y="231"/>
                    </a:lnTo>
                    <a:lnTo>
                      <a:pt x="68" y="231"/>
                    </a:lnTo>
                    <a:lnTo>
                      <a:pt x="70" y="243"/>
                    </a:lnTo>
                    <a:lnTo>
                      <a:pt x="70" y="243"/>
                    </a:lnTo>
                    <a:lnTo>
                      <a:pt x="72" y="256"/>
                    </a:lnTo>
                    <a:lnTo>
                      <a:pt x="72" y="256"/>
                    </a:lnTo>
                    <a:lnTo>
                      <a:pt x="75" y="267"/>
                    </a:lnTo>
                    <a:lnTo>
                      <a:pt x="75" y="267"/>
                    </a:lnTo>
                    <a:lnTo>
                      <a:pt x="78" y="279"/>
                    </a:lnTo>
                    <a:lnTo>
                      <a:pt x="78" y="279"/>
                    </a:lnTo>
                    <a:lnTo>
                      <a:pt x="80" y="293"/>
                    </a:lnTo>
                    <a:lnTo>
                      <a:pt x="80" y="293"/>
                    </a:lnTo>
                    <a:lnTo>
                      <a:pt x="83" y="305"/>
                    </a:lnTo>
                    <a:lnTo>
                      <a:pt x="83" y="305"/>
                    </a:lnTo>
                    <a:lnTo>
                      <a:pt x="86" y="317"/>
                    </a:lnTo>
                    <a:lnTo>
                      <a:pt x="86" y="317"/>
                    </a:lnTo>
                    <a:lnTo>
                      <a:pt x="89" y="332"/>
                    </a:lnTo>
                    <a:lnTo>
                      <a:pt x="89" y="332"/>
                    </a:lnTo>
                    <a:lnTo>
                      <a:pt x="92" y="346"/>
                    </a:lnTo>
                    <a:lnTo>
                      <a:pt x="92" y="346"/>
                    </a:lnTo>
                    <a:lnTo>
                      <a:pt x="95" y="361"/>
                    </a:lnTo>
                    <a:lnTo>
                      <a:pt x="95" y="361"/>
                    </a:lnTo>
                    <a:lnTo>
                      <a:pt x="98" y="376"/>
                    </a:lnTo>
                    <a:lnTo>
                      <a:pt x="98" y="376"/>
                    </a:lnTo>
                    <a:lnTo>
                      <a:pt x="100" y="390"/>
                    </a:lnTo>
                    <a:lnTo>
                      <a:pt x="100" y="390"/>
                    </a:lnTo>
                    <a:lnTo>
                      <a:pt x="103" y="405"/>
                    </a:lnTo>
                    <a:lnTo>
                      <a:pt x="103" y="405"/>
                    </a:lnTo>
                    <a:lnTo>
                      <a:pt x="106" y="422"/>
                    </a:lnTo>
                    <a:lnTo>
                      <a:pt x="106" y="422"/>
                    </a:lnTo>
                    <a:lnTo>
                      <a:pt x="109" y="435"/>
                    </a:lnTo>
                    <a:lnTo>
                      <a:pt x="109" y="435"/>
                    </a:lnTo>
                    <a:lnTo>
                      <a:pt x="112" y="450"/>
                    </a:lnTo>
                    <a:lnTo>
                      <a:pt x="112" y="450"/>
                    </a:lnTo>
                    <a:lnTo>
                      <a:pt x="113" y="467"/>
                    </a:lnTo>
                    <a:lnTo>
                      <a:pt x="113" y="467"/>
                    </a:lnTo>
                    <a:lnTo>
                      <a:pt x="116" y="482"/>
                    </a:lnTo>
                    <a:lnTo>
                      <a:pt x="116" y="482"/>
                    </a:lnTo>
                    <a:lnTo>
                      <a:pt x="119" y="496"/>
                    </a:lnTo>
                    <a:lnTo>
                      <a:pt x="119" y="496"/>
                    </a:lnTo>
                    <a:lnTo>
                      <a:pt x="122" y="512"/>
                    </a:lnTo>
                    <a:lnTo>
                      <a:pt x="122" y="512"/>
                    </a:lnTo>
                    <a:lnTo>
                      <a:pt x="125" y="527"/>
                    </a:lnTo>
                    <a:lnTo>
                      <a:pt x="125" y="527"/>
                    </a:lnTo>
                    <a:lnTo>
                      <a:pt x="128" y="542"/>
                    </a:lnTo>
                    <a:lnTo>
                      <a:pt x="128" y="542"/>
                    </a:lnTo>
                    <a:lnTo>
                      <a:pt x="131" y="557"/>
                    </a:lnTo>
                    <a:lnTo>
                      <a:pt x="131" y="557"/>
                    </a:lnTo>
                    <a:lnTo>
                      <a:pt x="133" y="571"/>
                    </a:lnTo>
                    <a:lnTo>
                      <a:pt x="133" y="571"/>
                    </a:lnTo>
                    <a:lnTo>
                      <a:pt x="136" y="583"/>
                    </a:lnTo>
                    <a:lnTo>
                      <a:pt x="136" y="583"/>
                    </a:lnTo>
                    <a:lnTo>
                      <a:pt x="139" y="597"/>
                    </a:lnTo>
                    <a:lnTo>
                      <a:pt x="139" y="597"/>
                    </a:lnTo>
                    <a:lnTo>
                      <a:pt x="142" y="611"/>
                    </a:lnTo>
                    <a:lnTo>
                      <a:pt x="142" y="611"/>
                    </a:lnTo>
                    <a:lnTo>
                      <a:pt x="145" y="623"/>
                    </a:lnTo>
                    <a:lnTo>
                      <a:pt x="145" y="623"/>
                    </a:lnTo>
                    <a:lnTo>
                      <a:pt x="148" y="636"/>
                    </a:lnTo>
                    <a:lnTo>
                      <a:pt x="148" y="636"/>
                    </a:lnTo>
                    <a:lnTo>
                      <a:pt x="151" y="648"/>
                    </a:lnTo>
                    <a:lnTo>
                      <a:pt x="151" y="648"/>
                    </a:lnTo>
                    <a:lnTo>
                      <a:pt x="153" y="659"/>
                    </a:lnTo>
                    <a:lnTo>
                      <a:pt x="153" y="659"/>
                    </a:lnTo>
                    <a:lnTo>
                      <a:pt x="155" y="670"/>
                    </a:lnTo>
                    <a:lnTo>
                      <a:pt x="155" y="670"/>
                    </a:lnTo>
                    <a:lnTo>
                      <a:pt x="158" y="679"/>
                    </a:lnTo>
                    <a:lnTo>
                      <a:pt x="158" y="679"/>
                    </a:lnTo>
                    <a:lnTo>
                      <a:pt x="161" y="689"/>
                    </a:lnTo>
                    <a:lnTo>
                      <a:pt x="161" y="689"/>
                    </a:lnTo>
                    <a:lnTo>
                      <a:pt x="163" y="699"/>
                    </a:lnTo>
                    <a:lnTo>
                      <a:pt x="163" y="699"/>
                    </a:lnTo>
                    <a:lnTo>
                      <a:pt x="166" y="707"/>
                    </a:lnTo>
                    <a:lnTo>
                      <a:pt x="166" y="707"/>
                    </a:lnTo>
                    <a:lnTo>
                      <a:pt x="169" y="715"/>
                    </a:lnTo>
                    <a:lnTo>
                      <a:pt x="169" y="715"/>
                    </a:lnTo>
                    <a:lnTo>
                      <a:pt x="172" y="723"/>
                    </a:lnTo>
                    <a:lnTo>
                      <a:pt x="172" y="723"/>
                    </a:lnTo>
                    <a:lnTo>
                      <a:pt x="175" y="730"/>
                    </a:lnTo>
                    <a:lnTo>
                      <a:pt x="175" y="730"/>
                    </a:lnTo>
                    <a:lnTo>
                      <a:pt x="178" y="737"/>
                    </a:lnTo>
                    <a:lnTo>
                      <a:pt x="178" y="737"/>
                    </a:lnTo>
                    <a:lnTo>
                      <a:pt x="181" y="743"/>
                    </a:lnTo>
                    <a:lnTo>
                      <a:pt x="181" y="743"/>
                    </a:lnTo>
                    <a:lnTo>
                      <a:pt x="184" y="749"/>
                    </a:lnTo>
                    <a:lnTo>
                      <a:pt x="184" y="749"/>
                    </a:lnTo>
                    <a:lnTo>
                      <a:pt x="186" y="755"/>
                    </a:lnTo>
                    <a:lnTo>
                      <a:pt x="186" y="755"/>
                    </a:lnTo>
                    <a:lnTo>
                      <a:pt x="189" y="760"/>
                    </a:lnTo>
                    <a:lnTo>
                      <a:pt x="192" y="764"/>
                    </a:lnTo>
                    <a:lnTo>
                      <a:pt x="195" y="769"/>
                    </a:lnTo>
                    <a:lnTo>
                      <a:pt x="196" y="773"/>
                    </a:lnTo>
                    <a:lnTo>
                      <a:pt x="199" y="777"/>
                    </a:lnTo>
                    <a:lnTo>
                      <a:pt x="199" y="777"/>
                    </a:lnTo>
                    <a:lnTo>
                      <a:pt x="202" y="780"/>
                    </a:lnTo>
                    <a:lnTo>
                      <a:pt x="205" y="781"/>
                    </a:lnTo>
                    <a:lnTo>
                      <a:pt x="208" y="784"/>
                    </a:lnTo>
                    <a:lnTo>
                      <a:pt x="208" y="784"/>
                    </a:lnTo>
                    <a:lnTo>
                      <a:pt x="211" y="785"/>
                    </a:lnTo>
                    <a:lnTo>
                      <a:pt x="216" y="786"/>
                    </a:lnTo>
                    <a:lnTo>
                      <a:pt x="219" y="786"/>
                    </a:lnTo>
                    <a:lnTo>
                      <a:pt x="225" y="786"/>
                    </a:lnTo>
                    <a:lnTo>
                      <a:pt x="228" y="785"/>
                    </a:lnTo>
                    <a:lnTo>
                      <a:pt x="231" y="782"/>
                    </a:lnTo>
                    <a:lnTo>
                      <a:pt x="234" y="781"/>
                    </a:lnTo>
                    <a:lnTo>
                      <a:pt x="234" y="781"/>
                    </a:lnTo>
                    <a:lnTo>
                      <a:pt x="236" y="780"/>
                    </a:lnTo>
                    <a:lnTo>
                      <a:pt x="238" y="775"/>
                    </a:lnTo>
                    <a:lnTo>
                      <a:pt x="241" y="773"/>
                    </a:lnTo>
                    <a:lnTo>
                      <a:pt x="244" y="769"/>
                    </a:lnTo>
                    <a:lnTo>
                      <a:pt x="247" y="764"/>
                    </a:lnTo>
                    <a:lnTo>
                      <a:pt x="249" y="760"/>
                    </a:lnTo>
                    <a:lnTo>
                      <a:pt x="252" y="755"/>
                    </a:lnTo>
                    <a:lnTo>
                      <a:pt x="252" y="755"/>
                    </a:lnTo>
                    <a:lnTo>
                      <a:pt x="255" y="749"/>
                    </a:lnTo>
                    <a:lnTo>
                      <a:pt x="255" y="749"/>
                    </a:lnTo>
                    <a:lnTo>
                      <a:pt x="258" y="743"/>
                    </a:lnTo>
                    <a:lnTo>
                      <a:pt x="258" y="743"/>
                    </a:lnTo>
                    <a:lnTo>
                      <a:pt x="261" y="736"/>
                    </a:lnTo>
                    <a:lnTo>
                      <a:pt x="261" y="736"/>
                    </a:lnTo>
                    <a:lnTo>
                      <a:pt x="264" y="729"/>
                    </a:lnTo>
                    <a:lnTo>
                      <a:pt x="264" y="729"/>
                    </a:lnTo>
                    <a:lnTo>
                      <a:pt x="267" y="721"/>
                    </a:lnTo>
                    <a:lnTo>
                      <a:pt x="267" y="721"/>
                    </a:lnTo>
                    <a:lnTo>
                      <a:pt x="269" y="711"/>
                    </a:lnTo>
                    <a:lnTo>
                      <a:pt x="269" y="711"/>
                    </a:lnTo>
                    <a:lnTo>
                      <a:pt x="272" y="701"/>
                    </a:lnTo>
                    <a:lnTo>
                      <a:pt x="272" y="701"/>
                    </a:lnTo>
                    <a:lnTo>
                      <a:pt x="275" y="692"/>
                    </a:lnTo>
                    <a:lnTo>
                      <a:pt x="275" y="692"/>
                    </a:lnTo>
                    <a:lnTo>
                      <a:pt x="278" y="682"/>
                    </a:lnTo>
                    <a:lnTo>
                      <a:pt x="278" y="682"/>
                    </a:lnTo>
                    <a:lnTo>
                      <a:pt x="279" y="670"/>
                    </a:lnTo>
                    <a:lnTo>
                      <a:pt x="279" y="670"/>
                    </a:lnTo>
                    <a:lnTo>
                      <a:pt x="282" y="659"/>
                    </a:lnTo>
                    <a:lnTo>
                      <a:pt x="282" y="659"/>
                    </a:lnTo>
                    <a:lnTo>
                      <a:pt x="285" y="647"/>
                    </a:lnTo>
                    <a:lnTo>
                      <a:pt x="285" y="647"/>
                    </a:lnTo>
                    <a:lnTo>
                      <a:pt x="288" y="633"/>
                    </a:lnTo>
                    <a:lnTo>
                      <a:pt x="288" y="633"/>
                    </a:lnTo>
                    <a:lnTo>
                      <a:pt x="291" y="619"/>
                    </a:lnTo>
                    <a:lnTo>
                      <a:pt x="291" y="619"/>
                    </a:lnTo>
                    <a:lnTo>
                      <a:pt x="294" y="605"/>
                    </a:lnTo>
                    <a:lnTo>
                      <a:pt x="294" y="605"/>
                    </a:lnTo>
                    <a:lnTo>
                      <a:pt x="297" y="590"/>
                    </a:lnTo>
                    <a:lnTo>
                      <a:pt x="297" y="590"/>
                    </a:lnTo>
                    <a:lnTo>
                      <a:pt x="299" y="575"/>
                    </a:lnTo>
                    <a:lnTo>
                      <a:pt x="299" y="575"/>
                    </a:lnTo>
                    <a:lnTo>
                      <a:pt x="302" y="559"/>
                    </a:lnTo>
                    <a:lnTo>
                      <a:pt x="302" y="559"/>
                    </a:lnTo>
                    <a:lnTo>
                      <a:pt x="305" y="544"/>
                    </a:lnTo>
                    <a:lnTo>
                      <a:pt x="305" y="544"/>
                    </a:lnTo>
                    <a:lnTo>
                      <a:pt x="308" y="526"/>
                    </a:lnTo>
                    <a:lnTo>
                      <a:pt x="308" y="526"/>
                    </a:lnTo>
                    <a:lnTo>
                      <a:pt x="311" y="511"/>
                    </a:lnTo>
                    <a:lnTo>
                      <a:pt x="311" y="511"/>
                    </a:lnTo>
                    <a:lnTo>
                      <a:pt x="314" y="493"/>
                    </a:lnTo>
                    <a:lnTo>
                      <a:pt x="314" y="493"/>
                    </a:lnTo>
                    <a:lnTo>
                      <a:pt x="317" y="475"/>
                    </a:lnTo>
                    <a:lnTo>
                      <a:pt x="317" y="475"/>
                    </a:lnTo>
                    <a:lnTo>
                      <a:pt x="320" y="456"/>
                    </a:lnTo>
                    <a:lnTo>
                      <a:pt x="320" y="456"/>
                    </a:lnTo>
                    <a:lnTo>
                      <a:pt x="321" y="438"/>
                    </a:lnTo>
                    <a:lnTo>
                      <a:pt x="321" y="438"/>
                    </a:lnTo>
                    <a:lnTo>
                      <a:pt x="324" y="420"/>
                    </a:lnTo>
                    <a:lnTo>
                      <a:pt x="324" y="420"/>
                    </a:lnTo>
                    <a:lnTo>
                      <a:pt x="327" y="402"/>
                    </a:lnTo>
                    <a:lnTo>
                      <a:pt x="327" y="402"/>
                    </a:lnTo>
                    <a:lnTo>
                      <a:pt x="330" y="383"/>
                    </a:lnTo>
                    <a:lnTo>
                      <a:pt x="330" y="383"/>
                    </a:lnTo>
                    <a:lnTo>
                      <a:pt x="332" y="365"/>
                    </a:lnTo>
                    <a:lnTo>
                      <a:pt x="332" y="365"/>
                    </a:lnTo>
                    <a:lnTo>
                      <a:pt x="335" y="348"/>
                    </a:lnTo>
                    <a:lnTo>
                      <a:pt x="335" y="348"/>
                    </a:lnTo>
                    <a:lnTo>
                      <a:pt x="338" y="330"/>
                    </a:lnTo>
                    <a:lnTo>
                      <a:pt x="338" y="330"/>
                    </a:lnTo>
                    <a:lnTo>
                      <a:pt x="341" y="312"/>
                    </a:lnTo>
                    <a:lnTo>
                      <a:pt x="341" y="312"/>
                    </a:lnTo>
                    <a:lnTo>
                      <a:pt x="344" y="295"/>
                    </a:lnTo>
                    <a:lnTo>
                      <a:pt x="344" y="295"/>
                    </a:lnTo>
                    <a:lnTo>
                      <a:pt x="347" y="279"/>
                    </a:lnTo>
                    <a:lnTo>
                      <a:pt x="347" y="279"/>
                    </a:lnTo>
                    <a:lnTo>
                      <a:pt x="350" y="264"/>
                    </a:lnTo>
                    <a:lnTo>
                      <a:pt x="350" y="264"/>
                    </a:lnTo>
                    <a:lnTo>
                      <a:pt x="352" y="249"/>
                    </a:lnTo>
                    <a:lnTo>
                      <a:pt x="352" y="249"/>
                    </a:lnTo>
                    <a:lnTo>
                      <a:pt x="355" y="234"/>
                    </a:lnTo>
                    <a:lnTo>
                      <a:pt x="355" y="234"/>
                    </a:lnTo>
                    <a:lnTo>
                      <a:pt x="358" y="220"/>
                    </a:lnTo>
                    <a:lnTo>
                      <a:pt x="358" y="220"/>
                    </a:lnTo>
                    <a:lnTo>
                      <a:pt x="361" y="208"/>
                    </a:lnTo>
                    <a:lnTo>
                      <a:pt x="361" y="208"/>
                    </a:lnTo>
                    <a:lnTo>
                      <a:pt x="363" y="197"/>
                    </a:lnTo>
                    <a:lnTo>
                      <a:pt x="363" y="197"/>
                    </a:lnTo>
                    <a:lnTo>
                      <a:pt x="365" y="186"/>
                    </a:lnTo>
                    <a:lnTo>
                      <a:pt x="365" y="186"/>
                    </a:lnTo>
                    <a:lnTo>
                      <a:pt x="368" y="176"/>
                    </a:lnTo>
                    <a:lnTo>
                      <a:pt x="368" y="176"/>
                    </a:lnTo>
                    <a:lnTo>
                      <a:pt x="371" y="166"/>
                    </a:lnTo>
                    <a:lnTo>
                      <a:pt x="371" y="166"/>
                    </a:lnTo>
                    <a:lnTo>
                      <a:pt x="374" y="160"/>
                    </a:lnTo>
                    <a:lnTo>
                      <a:pt x="374" y="160"/>
                    </a:lnTo>
                    <a:lnTo>
                      <a:pt x="377" y="153"/>
                    </a:lnTo>
                    <a:lnTo>
                      <a:pt x="377" y="153"/>
                    </a:lnTo>
                    <a:lnTo>
                      <a:pt x="380" y="146"/>
                    </a:lnTo>
                    <a:lnTo>
                      <a:pt x="380" y="146"/>
                    </a:lnTo>
                    <a:lnTo>
                      <a:pt x="383" y="142"/>
                    </a:lnTo>
                    <a:lnTo>
                      <a:pt x="383" y="142"/>
                    </a:lnTo>
                    <a:lnTo>
                      <a:pt x="385" y="138"/>
                    </a:lnTo>
                    <a:lnTo>
                      <a:pt x="388" y="135"/>
                    </a:lnTo>
                    <a:lnTo>
                      <a:pt x="391" y="134"/>
                    </a:lnTo>
                    <a:lnTo>
                      <a:pt x="397" y="135"/>
                    </a:lnTo>
                    <a:lnTo>
                      <a:pt x="400" y="136"/>
                    </a:lnTo>
                    <a:lnTo>
                      <a:pt x="403" y="138"/>
                    </a:lnTo>
                    <a:lnTo>
                      <a:pt x="404" y="140"/>
                    </a:lnTo>
                    <a:lnTo>
                      <a:pt x="407" y="146"/>
                    </a:lnTo>
                    <a:lnTo>
                      <a:pt x="410" y="151"/>
                    </a:lnTo>
                    <a:lnTo>
                      <a:pt x="410" y="151"/>
                    </a:lnTo>
                    <a:lnTo>
                      <a:pt x="413" y="157"/>
                    </a:lnTo>
                    <a:lnTo>
                      <a:pt x="415" y="164"/>
                    </a:lnTo>
                    <a:lnTo>
                      <a:pt x="418" y="171"/>
                    </a:lnTo>
                    <a:lnTo>
                      <a:pt x="418" y="171"/>
                    </a:lnTo>
                    <a:lnTo>
                      <a:pt x="421" y="177"/>
                    </a:lnTo>
                    <a:lnTo>
                      <a:pt x="421" y="177"/>
                    </a:lnTo>
                    <a:lnTo>
                      <a:pt x="424" y="186"/>
                    </a:lnTo>
                    <a:lnTo>
                      <a:pt x="424" y="186"/>
                    </a:lnTo>
                    <a:lnTo>
                      <a:pt x="427" y="194"/>
                    </a:lnTo>
                    <a:lnTo>
                      <a:pt x="427" y="194"/>
                    </a:lnTo>
                    <a:lnTo>
                      <a:pt x="430" y="202"/>
                    </a:lnTo>
                    <a:lnTo>
                      <a:pt x="430" y="202"/>
                    </a:lnTo>
                    <a:lnTo>
                      <a:pt x="433" y="212"/>
                    </a:lnTo>
                    <a:lnTo>
                      <a:pt x="433" y="212"/>
                    </a:lnTo>
                    <a:lnTo>
                      <a:pt x="436" y="221"/>
                    </a:lnTo>
                    <a:lnTo>
                      <a:pt x="436" y="221"/>
                    </a:lnTo>
                    <a:lnTo>
                      <a:pt x="438" y="231"/>
                    </a:lnTo>
                    <a:lnTo>
                      <a:pt x="438" y="231"/>
                    </a:lnTo>
                    <a:lnTo>
                      <a:pt x="441" y="242"/>
                    </a:lnTo>
                    <a:lnTo>
                      <a:pt x="441" y="242"/>
                    </a:lnTo>
                    <a:lnTo>
                      <a:pt x="444" y="251"/>
                    </a:lnTo>
                    <a:lnTo>
                      <a:pt x="444" y="251"/>
                    </a:lnTo>
                    <a:lnTo>
                      <a:pt x="446" y="262"/>
                    </a:lnTo>
                    <a:lnTo>
                      <a:pt x="446" y="262"/>
                    </a:lnTo>
                    <a:lnTo>
                      <a:pt x="448" y="272"/>
                    </a:lnTo>
                    <a:lnTo>
                      <a:pt x="448" y="272"/>
                    </a:lnTo>
                    <a:lnTo>
                      <a:pt x="451" y="282"/>
                    </a:lnTo>
                    <a:lnTo>
                      <a:pt x="451" y="282"/>
                    </a:lnTo>
                    <a:lnTo>
                      <a:pt x="454" y="293"/>
                    </a:lnTo>
                    <a:lnTo>
                      <a:pt x="454" y="293"/>
                    </a:lnTo>
                    <a:lnTo>
                      <a:pt x="457" y="304"/>
                    </a:lnTo>
                    <a:lnTo>
                      <a:pt x="457" y="304"/>
                    </a:lnTo>
                    <a:lnTo>
                      <a:pt x="460" y="313"/>
                    </a:lnTo>
                    <a:lnTo>
                      <a:pt x="460" y="313"/>
                    </a:lnTo>
                    <a:lnTo>
                      <a:pt x="463" y="324"/>
                    </a:lnTo>
                    <a:lnTo>
                      <a:pt x="463" y="324"/>
                    </a:lnTo>
                    <a:lnTo>
                      <a:pt x="466" y="335"/>
                    </a:lnTo>
                    <a:lnTo>
                      <a:pt x="466" y="335"/>
                    </a:lnTo>
                    <a:lnTo>
                      <a:pt x="468" y="345"/>
                    </a:lnTo>
                    <a:lnTo>
                      <a:pt x="468" y="345"/>
                    </a:lnTo>
                    <a:lnTo>
                      <a:pt x="471" y="356"/>
                    </a:lnTo>
                    <a:lnTo>
                      <a:pt x="471" y="356"/>
                    </a:lnTo>
                    <a:lnTo>
                      <a:pt x="474" y="365"/>
                    </a:lnTo>
                    <a:lnTo>
                      <a:pt x="474" y="365"/>
                    </a:lnTo>
                    <a:lnTo>
                      <a:pt x="477" y="378"/>
                    </a:lnTo>
                    <a:lnTo>
                      <a:pt x="477" y="378"/>
                    </a:lnTo>
                    <a:lnTo>
                      <a:pt x="480" y="389"/>
                    </a:lnTo>
                    <a:lnTo>
                      <a:pt x="480" y="389"/>
                    </a:lnTo>
                    <a:lnTo>
                      <a:pt x="483" y="398"/>
                    </a:lnTo>
                    <a:lnTo>
                      <a:pt x="483" y="398"/>
                    </a:lnTo>
                    <a:lnTo>
                      <a:pt x="486" y="408"/>
                    </a:lnTo>
                    <a:lnTo>
                      <a:pt x="486" y="408"/>
                    </a:lnTo>
                    <a:lnTo>
                      <a:pt x="487" y="419"/>
                    </a:lnTo>
                    <a:lnTo>
                      <a:pt x="487" y="419"/>
                    </a:lnTo>
                    <a:lnTo>
                      <a:pt x="490" y="428"/>
                    </a:lnTo>
                    <a:lnTo>
                      <a:pt x="490" y="428"/>
                    </a:lnTo>
                    <a:lnTo>
                      <a:pt x="493" y="439"/>
                    </a:lnTo>
                    <a:lnTo>
                      <a:pt x="493" y="439"/>
                    </a:lnTo>
                    <a:lnTo>
                      <a:pt x="496" y="449"/>
                    </a:lnTo>
                    <a:lnTo>
                      <a:pt x="496" y="449"/>
                    </a:lnTo>
                    <a:lnTo>
                      <a:pt x="499" y="459"/>
                    </a:lnTo>
                    <a:lnTo>
                      <a:pt x="499" y="459"/>
                    </a:lnTo>
                    <a:lnTo>
                      <a:pt x="501" y="465"/>
                    </a:lnTo>
                    <a:lnTo>
                      <a:pt x="501" y="465"/>
                    </a:lnTo>
                    <a:lnTo>
                      <a:pt x="504" y="475"/>
                    </a:lnTo>
                    <a:lnTo>
                      <a:pt x="504" y="475"/>
                    </a:lnTo>
                    <a:lnTo>
                      <a:pt x="507" y="483"/>
                    </a:lnTo>
                    <a:lnTo>
                      <a:pt x="507" y="483"/>
                    </a:lnTo>
                    <a:lnTo>
                      <a:pt x="510" y="492"/>
                    </a:lnTo>
                    <a:lnTo>
                      <a:pt x="510" y="492"/>
                    </a:lnTo>
                    <a:lnTo>
                      <a:pt x="513" y="501"/>
                    </a:lnTo>
                    <a:lnTo>
                      <a:pt x="513" y="501"/>
                    </a:lnTo>
                    <a:lnTo>
                      <a:pt x="516" y="509"/>
                    </a:lnTo>
                    <a:lnTo>
                      <a:pt x="516" y="509"/>
                    </a:lnTo>
                    <a:lnTo>
                      <a:pt x="519" y="518"/>
                    </a:lnTo>
                    <a:lnTo>
                      <a:pt x="519" y="518"/>
                    </a:lnTo>
                    <a:lnTo>
                      <a:pt x="521" y="527"/>
                    </a:lnTo>
                    <a:lnTo>
                      <a:pt x="521" y="527"/>
                    </a:lnTo>
                    <a:lnTo>
                      <a:pt x="524" y="535"/>
                    </a:lnTo>
                    <a:lnTo>
                      <a:pt x="527" y="542"/>
                    </a:lnTo>
                    <a:lnTo>
                      <a:pt x="529" y="552"/>
                    </a:lnTo>
                    <a:lnTo>
                      <a:pt x="529" y="552"/>
                    </a:lnTo>
                    <a:lnTo>
                      <a:pt x="531" y="561"/>
                    </a:lnTo>
                    <a:lnTo>
                      <a:pt x="531" y="561"/>
                    </a:lnTo>
                    <a:lnTo>
                      <a:pt x="534" y="570"/>
                    </a:lnTo>
                    <a:lnTo>
                      <a:pt x="534" y="570"/>
                    </a:lnTo>
                    <a:lnTo>
                      <a:pt x="537" y="578"/>
                    </a:lnTo>
                    <a:lnTo>
                      <a:pt x="537" y="578"/>
                    </a:lnTo>
                    <a:lnTo>
                      <a:pt x="540" y="586"/>
                    </a:lnTo>
                    <a:lnTo>
                      <a:pt x="540" y="586"/>
                    </a:lnTo>
                    <a:lnTo>
                      <a:pt x="543" y="594"/>
                    </a:lnTo>
                    <a:lnTo>
                      <a:pt x="543" y="594"/>
                    </a:lnTo>
                    <a:lnTo>
                      <a:pt x="546" y="603"/>
                    </a:lnTo>
                    <a:lnTo>
                      <a:pt x="546" y="603"/>
                    </a:lnTo>
                    <a:lnTo>
                      <a:pt x="549" y="611"/>
                    </a:lnTo>
                    <a:lnTo>
                      <a:pt x="549" y="611"/>
                    </a:lnTo>
                    <a:lnTo>
                      <a:pt x="552" y="620"/>
                    </a:lnTo>
                    <a:lnTo>
                      <a:pt x="552" y="620"/>
                    </a:lnTo>
                    <a:lnTo>
                      <a:pt x="554" y="627"/>
                    </a:lnTo>
                    <a:lnTo>
                      <a:pt x="554" y="627"/>
                    </a:lnTo>
                    <a:lnTo>
                      <a:pt x="557" y="638"/>
                    </a:lnTo>
                    <a:lnTo>
                      <a:pt x="557" y="638"/>
                    </a:lnTo>
                    <a:lnTo>
                      <a:pt x="560" y="647"/>
                    </a:lnTo>
                    <a:lnTo>
                      <a:pt x="560" y="647"/>
                    </a:lnTo>
                    <a:lnTo>
                      <a:pt x="563" y="655"/>
                    </a:lnTo>
                    <a:lnTo>
                      <a:pt x="563" y="655"/>
                    </a:lnTo>
                    <a:lnTo>
                      <a:pt x="566" y="662"/>
                    </a:lnTo>
                    <a:lnTo>
                      <a:pt x="566" y="662"/>
                    </a:lnTo>
                    <a:lnTo>
                      <a:pt x="569" y="670"/>
                    </a:lnTo>
                    <a:lnTo>
                      <a:pt x="569" y="670"/>
                    </a:lnTo>
                    <a:lnTo>
                      <a:pt x="570" y="677"/>
                    </a:lnTo>
                    <a:lnTo>
                      <a:pt x="570" y="677"/>
                    </a:lnTo>
                    <a:lnTo>
                      <a:pt x="573" y="684"/>
                    </a:lnTo>
                    <a:lnTo>
                      <a:pt x="576" y="690"/>
                    </a:lnTo>
                    <a:lnTo>
                      <a:pt x="579" y="697"/>
                    </a:lnTo>
                    <a:lnTo>
                      <a:pt x="579" y="697"/>
                    </a:lnTo>
                    <a:lnTo>
                      <a:pt x="582" y="703"/>
                    </a:lnTo>
                    <a:lnTo>
                      <a:pt x="582" y="703"/>
                    </a:lnTo>
                    <a:lnTo>
                      <a:pt x="584" y="708"/>
                    </a:lnTo>
                    <a:lnTo>
                      <a:pt x="587" y="715"/>
                    </a:lnTo>
                    <a:lnTo>
                      <a:pt x="590" y="721"/>
                    </a:lnTo>
                    <a:lnTo>
                      <a:pt x="590" y="721"/>
                    </a:lnTo>
                    <a:lnTo>
                      <a:pt x="593" y="726"/>
                    </a:lnTo>
                    <a:lnTo>
                      <a:pt x="596" y="730"/>
                    </a:lnTo>
                    <a:lnTo>
                      <a:pt x="599" y="736"/>
                    </a:lnTo>
                    <a:lnTo>
                      <a:pt x="599" y="736"/>
                    </a:lnTo>
                    <a:lnTo>
                      <a:pt x="602" y="741"/>
                    </a:lnTo>
                    <a:lnTo>
                      <a:pt x="605" y="745"/>
                    </a:lnTo>
                    <a:lnTo>
                      <a:pt x="607" y="749"/>
                    </a:lnTo>
                    <a:lnTo>
                      <a:pt x="610" y="754"/>
                    </a:lnTo>
                    <a:lnTo>
                      <a:pt x="612" y="758"/>
                    </a:lnTo>
                    <a:lnTo>
                      <a:pt x="612" y="758"/>
                    </a:lnTo>
                    <a:lnTo>
                      <a:pt x="615" y="762"/>
                    </a:lnTo>
                    <a:lnTo>
                      <a:pt x="617" y="764"/>
                    </a:lnTo>
                    <a:lnTo>
                      <a:pt x="620" y="769"/>
                    </a:lnTo>
                    <a:lnTo>
                      <a:pt x="620" y="769"/>
                    </a:lnTo>
                    <a:lnTo>
                      <a:pt x="623" y="771"/>
                    </a:lnTo>
                    <a:lnTo>
                      <a:pt x="623" y="771"/>
                    </a:lnTo>
                    <a:lnTo>
                      <a:pt x="626" y="774"/>
                    </a:lnTo>
                    <a:lnTo>
                      <a:pt x="629" y="777"/>
                    </a:lnTo>
                    <a:lnTo>
                      <a:pt x="632" y="780"/>
                    </a:lnTo>
                    <a:lnTo>
                      <a:pt x="635" y="781"/>
                    </a:lnTo>
                    <a:lnTo>
                      <a:pt x="637" y="782"/>
                    </a:lnTo>
                    <a:lnTo>
                      <a:pt x="637" y="782"/>
                    </a:lnTo>
                    <a:lnTo>
                      <a:pt x="640" y="785"/>
                    </a:lnTo>
                    <a:lnTo>
                      <a:pt x="646" y="786"/>
                    </a:lnTo>
                    <a:lnTo>
                      <a:pt x="649" y="788"/>
                    </a:lnTo>
                    <a:lnTo>
                      <a:pt x="653" y="789"/>
                    </a:lnTo>
                    <a:lnTo>
                      <a:pt x="656" y="791"/>
                    </a:lnTo>
                    <a:lnTo>
                      <a:pt x="656" y="791"/>
                    </a:lnTo>
                    <a:lnTo>
                      <a:pt x="659" y="791"/>
                    </a:lnTo>
                    <a:lnTo>
                      <a:pt x="665" y="792"/>
                    </a:lnTo>
                    <a:lnTo>
                      <a:pt x="668" y="792"/>
                    </a:lnTo>
                    <a:lnTo>
                      <a:pt x="673" y="791"/>
                    </a:lnTo>
                    <a:lnTo>
                      <a:pt x="676" y="788"/>
                    </a:lnTo>
                    <a:lnTo>
                      <a:pt x="682" y="785"/>
                    </a:lnTo>
                    <a:lnTo>
                      <a:pt x="685" y="784"/>
                    </a:lnTo>
                    <a:lnTo>
                      <a:pt x="685" y="784"/>
                    </a:lnTo>
                    <a:lnTo>
                      <a:pt x="688" y="781"/>
                    </a:lnTo>
                    <a:lnTo>
                      <a:pt x="690" y="781"/>
                    </a:lnTo>
                    <a:lnTo>
                      <a:pt x="693" y="775"/>
                    </a:lnTo>
                    <a:lnTo>
                      <a:pt x="695" y="774"/>
                    </a:lnTo>
                    <a:lnTo>
                      <a:pt x="698" y="770"/>
                    </a:lnTo>
                    <a:lnTo>
                      <a:pt x="698" y="770"/>
                    </a:lnTo>
                    <a:lnTo>
                      <a:pt x="700" y="767"/>
                    </a:lnTo>
                    <a:lnTo>
                      <a:pt x="700" y="767"/>
                    </a:lnTo>
                    <a:lnTo>
                      <a:pt x="703" y="763"/>
                    </a:lnTo>
                    <a:lnTo>
                      <a:pt x="706" y="759"/>
                    </a:lnTo>
                    <a:lnTo>
                      <a:pt x="709" y="756"/>
                    </a:lnTo>
                    <a:lnTo>
                      <a:pt x="712" y="752"/>
                    </a:lnTo>
                    <a:lnTo>
                      <a:pt x="715" y="748"/>
                    </a:lnTo>
                    <a:lnTo>
                      <a:pt x="715" y="748"/>
                    </a:lnTo>
                    <a:lnTo>
                      <a:pt x="718" y="744"/>
                    </a:lnTo>
                    <a:lnTo>
                      <a:pt x="718" y="744"/>
                    </a:lnTo>
                    <a:lnTo>
                      <a:pt x="721" y="734"/>
                    </a:lnTo>
                    <a:lnTo>
                      <a:pt x="721" y="734"/>
                    </a:lnTo>
                    <a:lnTo>
                      <a:pt x="723" y="727"/>
                    </a:lnTo>
                    <a:lnTo>
                      <a:pt x="723" y="727"/>
                    </a:lnTo>
                    <a:lnTo>
                      <a:pt x="726" y="723"/>
                    </a:lnTo>
                    <a:lnTo>
                      <a:pt x="729" y="718"/>
                    </a:lnTo>
                    <a:lnTo>
                      <a:pt x="732" y="714"/>
                    </a:lnTo>
                    <a:lnTo>
                      <a:pt x="732" y="714"/>
                    </a:lnTo>
                    <a:lnTo>
                      <a:pt x="735" y="708"/>
                    </a:lnTo>
                    <a:lnTo>
                      <a:pt x="735" y="708"/>
                    </a:lnTo>
                    <a:lnTo>
                      <a:pt x="736" y="703"/>
                    </a:lnTo>
                    <a:lnTo>
                      <a:pt x="736" y="703"/>
                    </a:lnTo>
                    <a:lnTo>
                      <a:pt x="739" y="697"/>
                    </a:lnTo>
                    <a:lnTo>
                      <a:pt x="742" y="692"/>
                    </a:lnTo>
                    <a:lnTo>
                      <a:pt x="745" y="685"/>
                    </a:lnTo>
                    <a:lnTo>
                      <a:pt x="745" y="685"/>
                    </a:lnTo>
                    <a:lnTo>
                      <a:pt x="748" y="679"/>
                    </a:lnTo>
                    <a:lnTo>
                      <a:pt x="751" y="675"/>
                    </a:lnTo>
                    <a:lnTo>
                      <a:pt x="753" y="671"/>
                    </a:lnTo>
                    <a:lnTo>
                      <a:pt x="753" y="671"/>
                    </a:lnTo>
                    <a:lnTo>
                      <a:pt x="756" y="666"/>
                    </a:lnTo>
                    <a:lnTo>
                      <a:pt x="759" y="659"/>
                    </a:lnTo>
                    <a:lnTo>
                      <a:pt x="762" y="653"/>
                    </a:lnTo>
                    <a:lnTo>
                      <a:pt x="762" y="653"/>
                    </a:lnTo>
                    <a:lnTo>
                      <a:pt x="765" y="648"/>
                    </a:lnTo>
                    <a:lnTo>
                      <a:pt x="768" y="642"/>
                    </a:lnTo>
                    <a:lnTo>
                      <a:pt x="771" y="637"/>
                    </a:lnTo>
                    <a:lnTo>
                      <a:pt x="771" y="637"/>
                    </a:lnTo>
                    <a:lnTo>
                      <a:pt x="774" y="630"/>
                    </a:lnTo>
                    <a:lnTo>
                      <a:pt x="776" y="627"/>
                    </a:lnTo>
                    <a:lnTo>
                      <a:pt x="778" y="625"/>
                    </a:lnTo>
                    <a:lnTo>
                      <a:pt x="781" y="619"/>
                    </a:lnTo>
                    <a:lnTo>
                      <a:pt x="784" y="614"/>
                    </a:lnTo>
                    <a:lnTo>
                      <a:pt x="784" y="614"/>
                    </a:lnTo>
                    <a:lnTo>
                      <a:pt x="786" y="608"/>
                    </a:lnTo>
                    <a:lnTo>
                      <a:pt x="789" y="604"/>
                    </a:lnTo>
                    <a:lnTo>
                      <a:pt x="792" y="600"/>
                    </a:lnTo>
                    <a:lnTo>
                      <a:pt x="792" y="600"/>
                    </a:lnTo>
                    <a:lnTo>
                      <a:pt x="795" y="600"/>
                    </a:lnTo>
                    <a:lnTo>
                      <a:pt x="798" y="596"/>
                    </a:lnTo>
                    <a:lnTo>
                      <a:pt x="801" y="592"/>
                    </a:lnTo>
                    <a:lnTo>
                      <a:pt x="801" y="592"/>
                    </a:lnTo>
                    <a:lnTo>
                      <a:pt x="804" y="588"/>
                    </a:lnTo>
                    <a:lnTo>
                      <a:pt x="804" y="588"/>
                    </a:lnTo>
                    <a:lnTo>
                      <a:pt x="806" y="583"/>
                    </a:lnTo>
                    <a:lnTo>
                      <a:pt x="809" y="581"/>
                    </a:lnTo>
                    <a:lnTo>
                      <a:pt x="812" y="577"/>
                    </a:lnTo>
                    <a:lnTo>
                      <a:pt x="812" y="577"/>
                    </a:lnTo>
                    <a:lnTo>
                      <a:pt x="815" y="574"/>
                    </a:lnTo>
                    <a:lnTo>
                      <a:pt x="819" y="575"/>
                    </a:lnTo>
                    <a:lnTo>
                      <a:pt x="822" y="568"/>
                    </a:lnTo>
                    <a:lnTo>
                      <a:pt x="822" y="568"/>
                    </a:lnTo>
                    <a:lnTo>
                      <a:pt x="825" y="566"/>
                    </a:lnTo>
                    <a:lnTo>
                      <a:pt x="828" y="564"/>
                    </a:lnTo>
                    <a:lnTo>
                      <a:pt x="831" y="561"/>
                    </a:lnTo>
                    <a:lnTo>
                      <a:pt x="834" y="560"/>
                    </a:lnTo>
                    <a:lnTo>
                      <a:pt x="837" y="559"/>
                    </a:lnTo>
                    <a:lnTo>
                      <a:pt x="837" y="559"/>
                    </a:lnTo>
                    <a:lnTo>
                      <a:pt x="839" y="557"/>
                    </a:lnTo>
                    <a:lnTo>
                      <a:pt x="845" y="557"/>
                    </a:lnTo>
                    <a:lnTo>
                      <a:pt x="848" y="556"/>
                    </a:lnTo>
                    <a:lnTo>
                      <a:pt x="848" y="556"/>
                    </a:lnTo>
                    <a:lnTo>
                      <a:pt x="851" y="551"/>
                    </a:lnTo>
                    <a:lnTo>
                      <a:pt x="854" y="551"/>
                    </a:lnTo>
                    <a:lnTo>
                      <a:pt x="857" y="551"/>
                    </a:lnTo>
                    <a:lnTo>
                      <a:pt x="859" y="551"/>
                    </a:lnTo>
                    <a:lnTo>
                      <a:pt x="861" y="552"/>
                    </a:lnTo>
                    <a:lnTo>
                      <a:pt x="861" y="552"/>
                    </a:lnTo>
                    <a:lnTo>
                      <a:pt x="864" y="552"/>
                    </a:lnTo>
                    <a:lnTo>
                      <a:pt x="869" y="556"/>
                    </a:lnTo>
                    <a:lnTo>
                      <a:pt x="872" y="557"/>
                    </a:lnTo>
                    <a:lnTo>
                      <a:pt x="878" y="559"/>
                    </a:lnTo>
                    <a:lnTo>
                      <a:pt x="881" y="561"/>
                    </a:lnTo>
                    <a:lnTo>
                      <a:pt x="887" y="567"/>
                    </a:lnTo>
                    <a:lnTo>
                      <a:pt x="890" y="570"/>
                    </a:lnTo>
                    <a:lnTo>
                      <a:pt x="892" y="572"/>
                    </a:lnTo>
                    <a:lnTo>
                      <a:pt x="895" y="577"/>
                    </a:lnTo>
                    <a:lnTo>
                      <a:pt x="895" y="577"/>
                    </a:lnTo>
                    <a:lnTo>
                      <a:pt x="898" y="579"/>
                    </a:lnTo>
                    <a:lnTo>
                      <a:pt x="901" y="582"/>
                    </a:lnTo>
                    <a:lnTo>
                      <a:pt x="902" y="586"/>
                    </a:lnTo>
                    <a:lnTo>
                      <a:pt x="905" y="589"/>
                    </a:lnTo>
                    <a:lnTo>
                      <a:pt x="908" y="593"/>
                    </a:lnTo>
                    <a:lnTo>
                      <a:pt x="911" y="597"/>
                    </a:lnTo>
                    <a:lnTo>
                      <a:pt x="914" y="601"/>
                    </a:lnTo>
                    <a:lnTo>
                      <a:pt x="914" y="601"/>
                    </a:lnTo>
                    <a:lnTo>
                      <a:pt x="917" y="604"/>
                    </a:lnTo>
                    <a:lnTo>
                      <a:pt x="920" y="608"/>
                    </a:lnTo>
                    <a:lnTo>
                      <a:pt x="922" y="611"/>
                    </a:lnTo>
                    <a:lnTo>
                      <a:pt x="922" y="611"/>
                    </a:lnTo>
                    <a:lnTo>
                      <a:pt x="925" y="615"/>
                    </a:lnTo>
                    <a:lnTo>
                      <a:pt x="925" y="615"/>
                    </a:lnTo>
                    <a:lnTo>
                      <a:pt x="928" y="619"/>
                    </a:lnTo>
                    <a:lnTo>
                      <a:pt x="931" y="623"/>
                    </a:lnTo>
                    <a:lnTo>
                      <a:pt x="934" y="627"/>
                    </a:lnTo>
                    <a:lnTo>
                      <a:pt x="937" y="631"/>
                    </a:lnTo>
                    <a:lnTo>
                      <a:pt x="940" y="636"/>
                    </a:lnTo>
                    <a:lnTo>
                      <a:pt x="940" y="636"/>
                    </a:lnTo>
                    <a:lnTo>
                      <a:pt x="942" y="638"/>
                    </a:lnTo>
                    <a:lnTo>
                      <a:pt x="942" y="638"/>
                    </a:lnTo>
                    <a:lnTo>
                      <a:pt x="944" y="642"/>
                    </a:lnTo>
                    <a:lnTo>
                      <a:pt x="947" y="647"/>
                    </a:lnTo>
                    <a:lnTo>
                      <a:pt x="950" y="651"/>
                    </a:lnTo>
                    <a:lnTo>
                      <a:pt x="953" y="655"/>
                    </a:lnTo>
                    <a:lnTo>
                      <a:pt x="955" y="659"/>
                    </a:lnTo>
                    <a:lnTo>
                      <a:pt x="955" y="659"/>
                    </a:lnTo>
                    <a:lnTo>
                      <a:pt x="958" y="662"/>
                    </a:lnTo>
                    <a:lnTo>
                      <a:pt x="961" y="666"/>
                    </a:lnTo>
                    <a:lnTo>
                      <a:pt x="964" y="670"/>
                    </a:lnTo>
                    <a:lnTo>
                      <a:pt x="964" y="670"/>
                    </a:lnTo>
                    <a:lnTo>
                      <a:pt x="967" y="673"/>
                    </a:lnTo>
                    <a:lnTo>
                      <a:pt x="967" y="673"/>
                    </a:lnTo>
                    <a:lnTo>
                      <a:pt x="970" y="677"/>
                    </a:lnTo>
                    <a:lnTo>
                      <a:pt x="973" y="679"/>
                    </a:lnTo>
                    <a:lnTo>
                      <a:pt x="975" y="684"/>
                    </a:lnTo>
                    <a:lnTo>
                      <a:pt x="978" y="688"/>
                    </a:lnTo>
                    <a:lnTo>
                      <a:pt x="981" y="692"/>
                    </a:lnTo>
                    <a:lnTo>
                      <a:pt x="981" y="692"/>
                    </a:lnTo>
                    <a:lnTo>
                      <a:pt x="984" y="695"/>
                    </a:lnTo>
                    <a:lnTo>
                      <a:pt x="987" y="699"/>
                    </a:lnTo>
                    <a:lnTo>
                      <a:pt x="990" y="701"/>
                    </a:lnTo>
                    <a:lnTo>
                      <a:pt x="990" y="701"/>
                    </a:lnTo>
                    <a:lnTo>
                      <a:pt x="993" y="706"/>
                    </a:lnTo>
                    <a:lnTo>
                      <a:pt x="993" y="706"/>
                    </a:lnTo>
                    <a:lnTo>
                      <a:pt x="995" y="708"/>
                    </a:lnTo>
                    <a:lnTo>
                      <a:pt x="998" y="712"/>
                    </a:lnTo>
                    <a:lnTo>
                      <a:pt x="1001" y="715"/>
                    </a:lnTo>
                    <a:lnTo>
                      <a:pt x="1001" y="715"/>
                    </a:lnTo>
                    <a:lnTo>
                      <a:pt x="1004" y="718"/>
                    </a:lnTo>
                    <a:lnTo>
                      <a:pt x="1007" y="722"/>
                    </a:lnTo>
                    <a:lnTo>
                      <a:pt x="1010" y="725"/>
                    </a:lnTo>
                    <a:lnTo>
                      <a:pt x="1016" y="730"/>
                    </a:lnTo>
                    <a:lnTo>
                      <a:pt x="1018" y="734"/>
                    </a:lnTo>
                    <a:lnTo>
                      <a:pt x="1024" y="740"/>
                    </a:lnTo>
                    <a:lnTo>
                      <a:pt x="1026" y="743"/>
                    </a:lnTo>
                    <a:lnTo>
                      <a:pt x="1026" y="743"/>
                    </a:lnTo>
                    <a:lnTo>
                      <a:pt x="1028" y="745"/>
                    </a:lnTo>
                    <a:lnTo>
                      <a:pt x="1031" y="748"/>
                    </a:lnTo>
                    <a:lnTo>
                      <a:pt x="1034" y="751"/>
                    </a:lnTo>
                    <a:lnTo>
                      <a:pt x="1034" y="751"/>
                    </a:lnTo>
                    <a:lnTo>
                      <a:pt x="1037" y="752"/>
                    </a:lnTo>
                    <a:lnTo>
                      <a:pt x="1040" y="755"/>
                    </a:lnTo>
                    <a:lnTo>
                      <a:pt x="1043" y="758"/>
                    </a:lnTo>
                    <a:lnTo>
                      <a:pt x="1043" y="758"/>
                    </a:lnTo>
                    <a:lnTo>
                      <a:pt x="1046" y="759"/>
                    </a:lnTo>
                    <a:lnTo>
                      <a:pt x="1051" y="764"/>
                    </a:lnTo>
                    <a:lnTo>
                      <a:pt x="1054" y="766"/>
                    </a:lnTo>
                    <a:lnTo>
                      <a:pt x="1060" y="770"/>
                    </a:lnTo>
                    <a:lnTo>
                      <a:pt x="1063" y="771"/>
                    </a:lnTo>
                    <a:lnTo>
                      <a:pt x="1066" y="773"/>
                    </a:lnTo>
                    <a:lnTo>
                      <a:pt x="1067" y="774"/>
                    </a:lnTo>
                    <a:lnTo>
                      <a:pt x="1067" y="774"/>
                    </a:lnTo>
                    <a:lnTo>
                      <a:pt x="1070" y="775"/>
                    </a:lnTo>
                    <a:lnTo>
                      <a:pt x="1076" y="777"/>
                    </a:lnTo>
                    <a:lnTo>
                      <a:pt x="1079" y="778"/>
                    </a:lnTo>
                    <a:lnTo>
                      <a:pt x="1084" y="780"/>
                    </a:lnTo>
                    <a:lnTo>
                      <a:pt x="1087" y="781"/>
                    </a:lnTo>
                    <a:lnTo>
                      <a:pt x="1090" y="781"/>
                    </a:lnTo>
                    <a:lnTo>
                      <a:pt x="1093" y="782"/>
                    </a:lnTo>
                    <a:lnTo>
                      <a:pt x="1093" y="782"/>
                    </a:lnTo>
                    <a:lnTo>
                      <a:pt x="1096" y="782"/>
                    </a:lnTo>
                    <a:lnTo>
                      <a:pt x="1101" y="784"/>
                    </a:lnTo>
                    <a:lnTo>
                      <a:pt x="1104" y="784"/>
                    </a:lnTo>
                    <a:lnTo>
                      <a:pt x="1111" y="784"/>
                    </a:lnTo>
                    <a:lnTo>
                      <a:pt x="1114" y="784"/>
                    </a:lnTo>
                    <a:lnTo>
                      <a:pt x="1120" y="784"/>
                    </a:lnTo>
                    <a:lnTo>
                      <a:pt x="1123" y="782"/>
                    </a:lnTo>
                    <a:lnTo>
                      <a:pt x="1126" y="782"/>
                    </a:lnTo>
                    <a:lnTo>
                      <a:pt x="1129" y="781"/>
                    </a:lnTo>
                    <a:lnTo>
                      <a:pt x="1129" y="781"/>
                    </a:lnTo>
                    <a:lnTo>
                      <a:pt x="1132" y="781"/>
                    </a:lnTo>
                    <a:lnTo>
                      <a:pt x="1137" y="780"/>
                    </a:lnTo>
                    <a:lnTo>
                      <a:pt x="1140" y="778"/>
                    </a:lnTo>
                    <a:lnTo>
                      <a:pt x="1146" y="777"/>
                    </a:lnTo>
                    <a:lnTo>
                      <a:pt x="1149" y="775"/>
                    </a:lnTo>
                    <a:lnTo>
                      <a:pt x="1150" y="774"/>
                    </a:lnTo>
                    <a:lnTo>
                      <a:pt x="1153" y="773"/>
                    </a:lnTo>
                    <a:lnTo>
                      <a:pt x="1153" y="773"/>
                    </a:lnTo>
                    <a:lnTo>
                      <a:pt x="1156" y="773"/>
                    </a:lnTo>
                    <a:lnTo>
                      <a:pt x="1162" y="770"/>
                    </a:lnTo>
                    <a:lnTo>
                      <a:pt x="1164" y="769"/>
                    </a:lnTo>
                    <a:lnTo>
                      <a:pt x="1170" y="766"/>
                    </a:lnTo>
                    <a:lnTo>
                      <a:pt x="1173" y="764"/>
                    </a:lnTo>
                    <a:lnTo>
                      <a:pt x="1179" y="762"/>
                    </a:lnTo>
                    <a:lnTo>
                      <a:pt x="1182" y="759"/>
                    </a:lnTo>
                    <a:lnTo>
                      <a:pt x="1185" y="758"/>
                    </a:lnTo>
                    <a:lnTo>
                      <a:pt x="1187" y="756"/>
                    </a:lnTo>
                    <a:lnTo>
                      <a:pt x="1187" y="756"/>
                    </a:lnTo>
                    <a:lnTo>
                      <a:pt x="1190" y="755"/>
                    </a:lnTo>
                    <a:lnTo>
                      <a:pt x="1197" y="749"/>
                    </a:lnTo>
                    <a:lnTo>
                      <a:pt x="1200" y="748"/>
                    </a:lnTo>
                    <a:lnTo>
                      <a:pt x="1206" y="745"/>
                    </a:lnTo>
                    <a:lnTo>
                      <a:pt x="1209" y="743"/>
                    </a:lnTo>
                    <a:lnTo>
                      <a:pt x="1212" y="741"/>
                    </a:lnTo>
                    <a:lnTo>
                      <a:pt x="1215" y="740"/>
                    </a:lnTo>
                    <a:lnTo>
                      <a:pt x="1215" y="740"/>
                    </a:lnTo>
                    <a:lnTo>
                      <a:pt x="1217" y="737"/>
                    </a:lnTo>
                    <a:lnTo>
                      <a:pt x="1223" y="733"/>
                    </a:lnTo>
                    <a:lnTo>
                      <a:pt x="1226" y="732"/>
                    </a:lnTo>
                    <a:lnTo>
                      <a:pt x="1232" y="729"/>
                    </a:lnTo>
                    <a:lnTo>
                      <a:pt x="1233" y="727"/>
                    </a:lnTo>
                    <a:lnTo>
                      <a:pt x="1236" y="725"/>
                    </a:lnTo>
                    <a:lnTo>
                      <a:pt x="1239" y="723"/>
                    </a:lnTo>
                    <a:lnTo>
                      <a:pt x="1239" y="723"/>
                    </a:lnTo>
                    <a:lnTo>
                      <a:pt x="1242" y="722"/>
                    </a:lnTo>
                    <a:lnTo>
                      <a:pt x="1248" y="719"/>
                    </a:lnTo>
                    <a:lnTo>
                      <a:pt x="1250" y="716"/>
                    </a:lnTo>
                    <a:lnTo>
                      <a:pt x="1250" y="716"/>
                    </a:lnTo>
                    <a:lnTo>
                      <a:pt x="1253" y="715"/>
                    </a:lnTo>
                    <a:lnTo>
                      <a:pt x="1256" y="714"/>
                    </a:lnTo>
                    <a:lnTo>
                      <a:pt x="1259" y="712"/>
                    </a:lnTo>
                    <a:lnTo>
                      <a:pt x="1265" y="711"/>
                    </a:lnTo>
                    <a:lnTo>
                      <a:pt x="1268" y="710"/>
                    </a:lnTo>
                    <a:lnTo>
                      <a:pt x="1275" y="708"/>
                    </a:lnTo>
                    <a:lnTo>
                      <a:pt x="1278" y="707"/>
                    </a:lnTo>
                    <a:lnTo>
                      <a:pt x="1283" y="707"/>
                    </a:lnTo>
                    <a:lnTo>
                      <a:pt x="1286" y="707"/>
                    </a:lnTo>
                    <a:lnTo>
                      <a:pt x="1292" y="707"/>
                    </a:lnTo>
                    <a:lnTo>
                      <a:pt x="1295" y="707"/>
                    </a:lnTo>
                    <a:lnTo>
                      <a:pt x="1301" y="707"/>
                    </a:lnTo>
                    <a:lnTo>
                      <a:pt x="1303" y="707"/>
                    </a:lnTo>
                    <a:lnTo>
                      <a:pt x="1306" y="707"/>
                    </a:lnTo>
                    <a:lnTo>
                      <a:pt x="1309" y="708"/>
                    </a:lnTo>
                    <a:lnTo>
                      <a:pt x="1309" y="708"/>
                    </a:lnTo>
                    <a:lnTo>
                      <a:pt x="1312" y="708"/>
                    </a:lnTo>
                    <a:lnTo>
                      <a:pt x="1316" y="708"/>
                    </a:lnTo>
                    <a:lnTo>
                      <a:pt x="1319" y="710"/>
                    </a:lnTo>
                    <a:lnTo>
                      <a:pt x="1325" y="711"/>
                    </a:lnTo>
                    <a:lnTo>
                      <a:pt x="1328" y="711"/>
                    </a:lnTo>
                    <a:lnTo>
                      <a:pt x="1333" y="712"/>
                    </a:lnTo>
                    <a:lnTo>
                      <a:pt x="1336" y="714"/>
                    </a:lnTo>
                    <a:lnTo>
                      <a:pt x="1342" y="715"/>
                    </a:lnTo>
                    <a:lnTo>
                      <a:pt x="1345" y="716"/>
                    </a:lnTo>
                    <a:lnTo>
                      <a:pt x="1351" y="718"/>
                    </a:lnTo>
                    <a:lnTo>
                      <a:pt x="1353" y="719"/>
                    </a:lnTo>
                    <a:lnTo>
                      <a:pt x="1361" y="722"/>
                    </a:lnTo>
                    <a:lnTo>
                      <a:pt x="1364" y="723"/>
                    </a:lnTo>
                    <a:lnTo>
                      <a:pt x="1364" y="723"/>
                    </a:lnTo>
                    <a:lnTo>
                      <a:pt x="1366" y="725"/>
                    </a:lnTo>
                    <a:lnTo>
                      <a:pt x="1369" y="726"/>
                    </a:lnTo>
                    <a:lnTo>
                      <a:pt x="1372" y="727"/>
                    </a:lnTo>
                    <a:lnTo>
                      <a:pt x="1378" y="729"/>
                    </a:lnTo>
                    <a:lnTo>
                      <a:pt x="1381" y="730"/>
                    </a:lnTo>
                    <a:lnTo>
                      <a:pt x="1384" y="732"/>
                    </a:lnTo>
                    <a:lnTo>
                      <a:pt x="1386" y="733"/>
                    </a:lnTo>
                    <a:lnTo>
                      <a:pt x="1386" y="733"/>
                    </a:lnTo>
                    <a:lnTo>
                      <a:pt x="1389" y="734"/>
                    </a:lnTo>
                    <a:lnTo>
                      <a:pt x="1395" y="737"/>
                    </a:lnTo>
                    <a:lnTo>
                      <a:pt x="1398" y="738"/>
                    </a:lnTo>
                    <a:lnTo>
                      <a:pt x="1399" y="740"/>
                    </a:lnTo>
                    <a:lnTo>
                      <a:pt x="1402" y="741"/>
                    </a:lnTo>
                    <a:lnTo>
                      <a:pt x="1402" y="741"/>
                    </a:lnTo>
                    <a:lnTo>
                      <a:pt x="1405" y="743"/>
                    </a:lnTo>
                    <a:lnTo>
                      <a:pt x="1411" y="745"/>
                    </a:lnTo>
                    <a:lnTo>
                      <a:pt x="1414" y="748"/>
                    </a:lnTo>
                    <a:lnTo>
                      <a:pt x="1414" y="748"/>
                    </a:lnTo>
                    <a:lnTo>
                      <a:pt x="1416" y="749"/>
                    </a:lnTo>
                    <a:lnTo>
                      <a:pt x="1419" y="751"/>
                    </a:lnTo>
                    <a:lnTo>
                      <a:pt x="1422" y="752"/>
                    </a:lnTo>
                    <a:lnTo>
                      <a:pt x="1428" y="756"/>
                    </a:lnTo>
                    <a:lnTo>
                      <a:pt x="1431" y="758"/>
                    </a:lnTo>
                    <a:lnTo>
                      <a:pt x="1437" y="760"/>
                    </a:lnTo>
                    <a:lnTo>
                      <a:pt x="1439" y="763"/>
                    </a:lnTo>
                    <a:lnTo>
                      <a:pt x="1441" y="764"/>
                    </a:lnTo>
                    <a:lnTo>
                      <a:pt x="1444" y="766"/>
                    </a:lnTo>
                    <a:lnTo>
                      <a:pt x="1447" y="769"/>
                    </a:lnTo>
                    <a:lnTo>
                      <a:pt x="1449" y="770"/>
                    </a:lnTo>
                    <a:lnTo>
                      <a:pt x="1455" y="773"/>
                    </a:lnTo>
                    <a:lnTo>
                      <a:pt x="1458" y="774"/>
                    </a:lnTo>
                    <a:lnTo>
                      <a:pt x="1464" y="777"/>
                    </a:lnTo>
                    <a:lnTo>
                      <a:pt x="1467" y="778"/>
                    </a:lnTo>
                    <a:lnTo>
                      <a:pt x="1472" y="781"/>
                    </a:lnTo>
                    <a:lnTo>
                      <a:pt x="1475" y="782"/>
                    </a:lnTo>
                    <a:lnTo>
                      <a:pt x="1481" y="786"/>
                    </a:lnTo>
                    <a:lnTo>
                      <a:pt x="1482" y="788"/>
                    </a:lnTo>
                    <a:lnTo>
                      <a:pt x="1488" y="789"/>
                    </a:lnTo>
                    <a:lnTo>
                      <a:pt x="1491" y="791"/>
                    </a:lnTo>
                    <a:lnTo>
                      <a:pt x="1497" y="793"/>
                    </a:lnTo>
                    <a:lnTo>
                      <a:pt x="1500" y="795"/>
                    </a:lnTo>
                    <a:lnTo>
                      <a:pt x="1505" y="797"/>
                    </a:lnTo>
                    <a:lnTo>
                      <a:pt x="1508" y="799"/>
                    </a:lnTo>
                    <a:lnTo>
                      <a:pt x="1514" y="800"/>
                    </a:lnTo>
                    <a:lnTo>
                      <a:pt x="1517" y="802"/>
                    </a:lnTo>
                    <a:lnTo>
                      <a:pt x="1524" y="804"/>
                    </a:lnTo>
                    <a:lnTo>
                      <a:pt x="1527" y="806"/>
                    </a:lnTo>
                    <a:lnTo>
                      <a:pt x="1527" y="806"/>
                    </a:lnTo>
                    <a:lnTo>
                      <a:pt x="1530" y="807"/>
                    </a:lnTo>
                    <a:lnTo>
                      <a:pt x="1532" y="808"/>
                    </a:lnTo>
                    <a:lnTo>
                      <a:pt x="1535" y="808"/>
                    </a:lnTo>
                    <a:lnTo>
                      <a:pt x="1541" y="810"/>
                    </a:lnTo>
                    <a:lnTo>
                      <a:pt x="1544" y="811"/>
                    </a:lnTo>
                    <a:lnTo>
                      <a:pt x="1550" y="811"/>
                    </a:lnTo>
                    <a:lnTo>
                      <a:pt x="1553" y="812"/>
                    </a:lnTo>
                    <a:lnTo>
                      <a:pt x="1558" y="812"/>
                    </a:lnTo>
                    <a:lnTo>
                      <a:pt x="1561" y="812"/>
                    </a:lnTo>
                    <a:lnTo>
                      <a:pt x="1565" y="812"/>
                    </a:lnTo>
                    <a:lnTo>
                      <a:pt x="1568" y="814"/>
                    </a:lnTo>
                    <a:lnTo>
                      <a:pt x="1574" y="814"/>
                    </a:lnTo>
                    <a:lnTo>
                      <a:pt x="1577" y="814"/>
                    </a:lnTo>
                    <a:lnTo>
                      <a:pt x="1583" y="814"/>
                    </a:lnTo>
                    <a:lnTo>
                      <a:pt x="1585" y="814"/>
                    </a:lnTo>
                    <a:lnTo>
                      <a:pt x="1591" y="814"/>
                    </a:lnTo>
                    <a:lnTo>
                      <a:pt x="1594" y="814"/>
                    </a:lnTo>
                    <a:lnTo>
                      <a:pt x="1600" y="814"/>
                    </a:lnTo>
                    <a:lnTo>
                      <a:pt x="1603" y="814"/>
                    </a:lnTo>
                    <a:lnTo>
                      <a:pt x="1610" y="814"/>
                    </a:lnTo>
                    <a:lnTo>
                      <a:pt x="1613" y="814"/>
                    </a:lnTo>
                    <a:lnTo>
                      <a:pt x="1618" y="814"/>
                    </a:lnTo>
                    <a:lnTo>
                      <a:pt x="1621" y="814"/>
                    </a:lnTo>
                    <a:lnTo>
                      <a:pt x="1627" y="814"/>
                    </a:lnTo>
                    <a:lnTo>
                      <a:pt x="1630" y="812"/>
                    </a:lnTo>
                    <a:lnTo>
                      <a:pt x="1636" y="812"/>
                    </a:lnTo>
                    <a:lnTo>
                      <a:pt x="1638" y="812"/>
                    </a:lnTo>
                    <a:lnTo>
                      <a:pt x="1644" y="812"/>
                    </a:lnTo>
                    <a:lnTo>
                      <a:pt x="1647" y="812"/>
                    </a:lnTo>
                    <a:lnTo>
                      <a:pt x="1651" y="812"/>
                    </a:lnTo>
                    <a:lnTo>
                      <a:pt x="1654" y="812"/>
                    </a:lnTo>
                    <a:lnTo>
                      <a:pt x="1660" y="812"/>
                    </a:lnTo>
                    <a:lnTo>
                      <a:pt x="1663" y="812"/>
                    </a:lnTo>
                    <a:lnTo>
                      <a:pt x="1669" y="812"/>
                    </a:lnTo>
                    <a:lnTo>
                      <a:pt x="1671" y="812"/>
                    </a:lnTo>
                    <a:lnTo>
                      <a:pt x="1677" y="812"/>
                    </a:lnTo>
                    <a:lnTo>
                      <a:pt x="1680" y="812"/>
                    </a:lnTo>
                    <a:lnTo>
                      <a:pt x="1686" y="812"/>
                    </a:lnTo>
                    <a:lnTo>
                      <a:pt x="1689" y="812"/>
                    </a:lnTo>
                    <a:lnTo>
                      <a:pt x="1696" y="812"/>
                    </a:lnTo>
                    <a:lnTo>
                      <a:pt x="1699" y="811"/>
                    </a:lnTo>
                    <a:lnTo>
                      <a:pt x="1704" y="812"/>
                    </a:lnTo>
                    <a:lnTo>
                      <a:pt x="1707" y="812"/>
                    </a:lnTo>
                    <a:lnTo>
                      <a:pt x="1713" y="811"/>
                    </a:lnTo>
                    <a:lnTo>
                      <a:pt x="1716" y="811"/>
                    </a:lnTo>
                    <a:lnTo>
                      <a:pt x="1722" y="811"/>
                    </a:lnTo>
                    <a:lnTo>
                      <a:pt x="1724" y="811"/>
                    </a:lnTo>
                    <a:lnTo>
                      <a:pt x="1730" y="811"/>
                    </a:lnTo>
                    <a:lnTo>
                      <a:pt x="1732" y="810"/>
                    </a:lnTo>
                    <a:lnTo>
                      <a:pt x="1737" y="810"/>
                    </a:lnTo>
                    <a:lnTo>
                      <a:pt x="1740" y="810"/>
                    </a:lnTo>
                    <a:lnTo>
                      <a:pt x="1746" y="810"/>
                    </a:lnTo>
                    <a:lnTo>
                      <a:pt x="1749" y="810"/>
                    </a:lnTo>
                    <a:lnTo>
                      <a:pt x="1754" y="810"/>
                    </a:lnTo>
                    <a:lnTo>
                      <a:pt x="1757" y="810"/>
                    </a:lnTo>
                    <a:lnTo>
                      <a:pt x="1763" y="810"/>
                    </a:lnTo>
                    <a:lnTo>
                      <a:pt x="1766" y="810"/>
                    </a:lnTo>
                    <a:lnTo>
                      <a:pt x="1773" y="811"/>
                    </a:lnTo>
                    <a:lnTo>
                      <a:pt x="1776" y="811"/>
                    </a:lnTo>
                    <a:lnTo>
                      <a:pt x="1782" y="811"/>
                    </a:lnTo>
                    <a:lnTo>
                      <a:pt x="1785" y="812"/>
                    </a:lnTo>
                    <a:lnTo>
                      <a:pt x="1790" y="812"/>
                    </a:lnTo>
                    <a:lnTo>
                      <a:pt x="1793" y="814"/>
                    </a:lnTo>
                    <a:lnTo>
                      <a:pt x="1799" y="814"/>
                    </a:lnTo>
                    <a:lnTo>
                      <a:pt x="1802" y="814"/>
                    </a:lnTo>
                    <a:lnTo>
                      <a:pt x="1802" y="814"/>
                    </a:lnTo>
                    <a:lnTo>
                      <a:pt x="1805" y="815"/>
                    </a:lnTo>
                    <a:lnTo>
                      <a:pt x="1807" y="815"/>
                    </a:lnTo>
                    <a:lnTo>
                      <a:pt x="1810" y="817"/>
                    </a:lnTo>
                    <a:lnTo>
                      <a:pt x="1815" y="817"/>
                    </a:lnTo>
                    <a:lnTo>
                      <a:pt x="1817" y="818"/>
                    </a:lnTo>
                    <a:lnTo>
                      <a:pt x="1823" y="818"/>
                    </a:lnTo>
                    <a:lnTo>
                      <a:pt x="1826" y="819"/>
                    </a:lnTo>
                    <a:lnTo>
                      <a:pt x="1832" y="821"/>
                    </a:lnTo>
                    <a:lnTo>
                      <a:pt x="1835" y="821"/>
                    </a:lnTo>
                    <a:lnTo>
                      <a:pt x="1840" y="821"/>
                    </a:lnTo>
                    <a:lnTo>
                      <a:pt x="1843" y="821"/>
                    </a:lnTo>
                    <a:lnTo>
                      <a:pt x="1849" y="822"/>
                    </a:lnTo>
                    <a:lnTo>
                      <a:pt x="1852" y="822"/>
                    </a:lnTo>
                    <a:lnTo>
                      <a:pt x="1855" y="822"/>
                    </a:lnTo>
                    <a:lnTo>
                      <a:pt x="1856" y="823"/>
                    </a:lnTo>
                    <a:lnTo>
                      <a:pt x="1859" y="823"/>
                    </a:lnTo>
                    <a:lnTo>
                      <a:pt x="1862" y="825"/>
                    </a:lnTo>
                    <a:lnTo>
                      <a:pt x="1868" y="825"/>
                    </a:lnTo>
                    <a:lnTo>
                      <a:pt x="1870" y="825"/>
                    </a:lnTo>
                    <a:lnTo>
                      <a:pt x="1876" y="826"/>
                    </a:lnTo>
                    <a:lnTo>
                      <a:pt x="1879" y="828"/>
                    </a:lnTo>
                    <a:lnTo>
                      <a:pt x="1885" y="828"/>
                    </a:lnTo>
                    <a:lnTo>
                      <a:pt x="1888" y="829"/>
                    </a:lnTo>
                    <a:lnTo>
                      <a:pt x="1893" y="829"/>
                    </a:lnTo>
                    <a:lnTo>
                      <a:pt x="1896" y="830"/>
                    </a:lnTo>
                    <a:lnTo>
                      <a:pt x="1898" y="830"/>
                    </a:lnTo>
                    <a:lnTo>
                      <a:pt x="1901" y="832"/>
                    </a:lnTo>
                    <a:lnTo>
                      <a:pt x="1901" y="832"/>
                    </a:lnTo>
                    <a:lnTo>
                      <a:pt x="1903" y="832"/>
                    </a:lnTo>
                    <a:lnTo>
                      <a:pt x="1909" y="833"/>
                    </a:lnTo>
                    <a:lnTo>
                      <a:pt x="1912" y="833"/>
                    </a:lnTo>
                    <a:lnTo>
                      <a:pt x="1918" y="833"/>
                    </a:lnTo>
                    <a:lnTo>
                      <a:pt x="1921" y="834"/>
                    </a:lnTo>
                    <a:lnTo>
                      <a:pt x="1926" y="834"/>
                    </a:lnTo>
                    <a:lnTo>
                      <a:pt x="1929" y="834"/>
                    </a:lnTo>
                    <a:lnTo>
                      <a:pt x="1935" y="836"/>
                    </a:lnTo>
                    <a:lnTo>
                      <a:pt x="1938" y="836"/>
                    </a:lnTo>
                    <a:lnTo>
                      <a:pt x="1945" y="837"/>
                    </a:lnTo>
                    <a:lnTo>
                      <a:pt x="1948" y="837"/>
                    </a:lnTo>
                    <a:lnTo>
                      <a:pt x="1954" y="839"/>
                    </a:lnTo>
                    <a:lnTo>
                      <a:pt x="1956" y="839"/>
                    </a:lnTo>
                    <a:lnTo>
                      <a:pt x="1956" y="839"/>
                    </a:lnTo>
                    <a:lnTo>
                      <a:pt x="1959" y="840"/>
                    </a:lnTo>
                    <a:lnTo>
                      <a:pt x="1962" y="840"/>
                    </a:lnTo>
                    <a:lnTo>
                      <a:pt x="1965" y="840"/>
                    </a:lnTo>
                    <a:lnTo>
                      <a:pt x="1971" y="841"/>
                    </a:lnTo>
                    <a:lnTo>
                      <a:pt x="1974" y="843"/>
                    </a:lnTo>
                    <a:lnTo>
                      <a:pt x="1979" y="843"/>
                    </a:lnTo>
                    <a:lnTo>
                      <a:pt x="1981" y="843"/>
                    </a:lnTo>
                  </a:path>
                </a:pathLst>
              </a:custGeom>
              <a:noFill/>
              <a:ln w="14288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" name="Freeform 96">
                <a:extLst>
                  <a:ext uri="{FF2B5EF4-FFF2-40B4-BE49-F238E27FC236}">
                    <a16:creationId xmlns:a16="http://schemas.microsoft.com/office/drawing/2014/main" id="{F25F1620-CE55-4DC3-8D13-52AC30C3909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19563" y="1390650"/>
                <a:ext cx="1571625" cy="654050"/>
              </a:xfrm>
              <a:custGeom>
                <a:avLst/>
                <a:gdLst>
                  <a:gd name="T0" fmla="*/ 20 w 1981"/>
                  <a:gd name="T1" fmla="*/ 48 h 823"/>
                  <a:gd name="T2" fmla="*/ 39 w 1981"/>
                  <a:gd name="T3" fmla="*/ 120 h 823"/>
                  <a:gd name="T4" fmla="*/ 56 w 1981"/>
                  <a:gd name="T5" fmla="*/ 186 h 823"/>
                  <a:gd name="T6" fmla="*/ 75 w 1981"/>
                  <a:gd name="T7" fmla="*/ 256 h 823"/>
                  <a:gd name="T8" fmla="*/ 92 w 1981"/>
                  <a:gd name="T9" fmla="*/ 326 h 823"/>
                  <a:gd name="T10" fmla="*/ 112 w 1981"/>
                  <a:gd name="T11" fmla="*/ 425 h 823"/>
                  <a:gd name="T12" fmla="*/ 128 w 1981"/>
                  <a:gd name="T13" fmla="*/ 510 h 823"/>
                  <a:gd name="T14" fmla="*/ 148 w 1981"/>
                  <a:gd name="T15" fmla="*/ 592 h 823"/>
                  <a:gd name="T16" fmla="*/ 166 w 1981"/>
                  <a:gd name="T17" fmla="*/ 649 h 823"/>
                  <a:gd name="T18" fmla="*/ 186 w 1981"/>
                  <a:gd name="T19" fmla="*/ 687 h 823"/>
                  <a:gd name="T20" fmla="*/ 222 w 1981"/>
                  <a:gd name="T21" fmla="*/ 699 h 823"/>
                  <a:gd name="T22" fmla="*/ 247 w 1981"/>
                  <a:gd name="T23" fmla="*/ 661 h 823"/>
                  <a:gd name="T24" fmla="*/ 264 w 1981"/>
                  <a:gd name="T25" fmla="*/ 610 h 823"/>
                  <a:gd name="T26" fmla="*/ 282 w 1981"/>
                  <a:gd name="T27" fmla="*/ 525 h 823"/>
                  <a:gd name="T28" fmla="*/ 299 w 1981"/>
                  <a:gd name="T29" fmla="*/ 428 h 823"/>
                  <a:gd name="T30" fmla="*/ 320 w 1981"/>
                  <a:gd name="T31" fmla="*/ 302 h 823"/>
                  <a:gd name="T32" fmla="*/ 335 w 1981"/>
                  <a:gd name="T33" fmla="*/ 200 h 823"/>
                  <a:gd name="T34" fmla="*/ 355 w 1981"/>
                  <a:gd name="T35" fmla="*/ 111 h 823"/>
                  <a:gd name="T36" fmla="*/ 380 w 1981"/>
                  <a:gd name="T37" fmla="*/ 70 h 823"/>
                  <a:gd name="T38" fmla="*/ 407 w 1981"/>
                  <a:gd name="T39" fmla="*/ 112 h 823"/>
                  <a:gd name="T40" fmla="*/ 424 w 1981"/>
                  <a:gd name="T41" fmla="*/ 166 h 823"/>
                  <a:gd name="T42" fmla="*/ 444 w 1981"/>
                  <a:gd name="T43" fmla="*/ 237 h 823"/>
                  <a:gd name="T44" fmla="*/ 460 w 1981"/>
                  <a:gd name="T45" fmla="*/ 300 h 823"/>
                  <a:gd name="T46" fmla="*/ 480 w 1981"/>
                  <a:gd name="T47" fmla="*/ 369 h 823"/>
                  <a:gd name="T48" fmla="*/ 496 w 1981"/>
                  <a:gd name="T49" fmla="*/ 424 h 823"/>
                  <a:gd name="T50" fmla="*/ 516 w 1981"/>
                  <a:gd name="T51" fmla="*/ 484 h 823"/>
                  <a:gd name="T52" fmla="*/ 534 w 1981"/>
                  <a:gd name="T53" fmla="*/ 542 h 823"/>
                  <a:gd name="T54" fmla="*/ 554 w 1981"/>
                  <a:gd name="T55" fmla="*/ 591 h 823"/>
                  <a:gd name="T56" fmla="*/ 576 w 1981"/>
                  <a:gd name="T57" fmla="*/ 639 h 823"/>
                  <a:gd name="T58" fmla="*/ 605 w 1981"/>
                  <a:gd name="T59" fmla="*/ 684 h 823"/>
                  <a:gd name="T60" fmla="*/ 629 w 1981"/>
                  <a:gd name="T61" fmla="*/ 708 h 823"/>
                  <a:gd name="T62" fmla="*/ 668 w 1981"/>
                  <a:gd name="T63" fmla="*/ 706 h 823"/>
                  <a:gd name="T64" fmla="*/ 698 w 1981"/>
                  <a:gd name="T65" fmla="*/ 673 h 823"/>
                  <a:gd name="T66" fmla="*/ 723 w 1981"/>
                  <a:gd name="T67" fmla="*/ 624 h 823"/>
                  <a:gd name="T68" fmla="*/ 742 w 1981"/>
                  <a:gd name="T69" fmla="*/ 587 h 823"/>
                  <a:gd name="T70" fmla="*/ 771 w 1981"/>
                  <a:gd name="T71" fmla="*/ 536 h 823"/>
                  <a:gd name="T72" fmla="*/ 795 w 1981"/>
                  <a:gd name="T73" fmla="*/ 511 h 823"/>
                  <a:gd name="T74" fmla="*/ 831 w 1981"/>
                  <a:gd name="T75" fmla="*/ 492 h 823"/>
                  <a:gd name="T76" fmla="*/ 869 w 1981"/>
                  <a:gd name="T77" fmla="*/ 496 h 823"/>
                  <a:gd name="T78" fmla="*/ 908 w 1981"/>
                  <a:gd name="T79" fmla="*/ 535 h 823"/>
                  <a:gd name="T80" fmla="*/ 937 w 1981"/>
                  <a:gd name="T81" fmla="*/ 573 h 823"/>
                  <a:gd name="T82" fmla="*/ 964 w 1981"/>
                  <a:gd name="T83" fmla="*/ 610 h 823"/>
                  <a:gd name="T84" fmla="*/ 990 w 1981"/>
                  <a:gd name="T85" fmla="*/ 639 h 823"/>
                  <a:gd name="T86" fmla="*/ 1037 w 1981"/>
                  <a:gd name="T87" fmla="*/ 683 h 823"/>
                  <a:gd name="T88" fmla="*/ 1093 w 1981"/>
                  <a:gd name="T89" fmla="*/ 697 h 823"/>
                  <a:gd name="T90" fmla="*/ 1140 w 1981"/>
                  <a:gd name="T91" fmla="*/ 680 h 823"/>
                  <a:gd name="T92" fmla="*/ 1179 w 1981"/>
                  <a:gd name="T93" fmla="*/ 658 h 823"/>
                  <a:gd name="T94" fmla="*/ 1226 w 1981"/>
                  <a:gd name="T95" fmla="*/ 633 h 823"/>
                  <a:gd name="T96" fmla="*/ 1275 w 1981"/>
                  <a:gd name="T97" fmla="*/ 627 h 823"/>
                  <a:gd name="T98" fmla="*/ 1328 w 1981"/>
                  <a:gd name="T99" fmla="*/ 642 h 823"/>
                  <a:gd name="T100" fmla="*/ 1378 w 1981"/>
                  <a:gd name="T101" fmla="*/ 669 h 823"/>
                  <a:gd name="T102" fmla="*/ 1414 w 1981"/>
                  <a:gd name="T103" fmla="*/ 690 h 823"/>
                  <a:gd name="T104" fmla="*/ 1455 w 1981"/>
                  <a:gd name="T105" fmla="*/ 710 h 823"/>
                  <a:gd name="T106" fmla="*/ 1500 w 1981"/>
                  <a:gd name="T107" fmla="*/ 727 h 823"/>
                  <a:gd name="T108" fmla="*/ 1550 w 1981"/>
                  <a:gd name="T109" fmla="*/ 740 h 823"/>
                  <a:gd name="T110" fmla="*/ 1603 w 1981"/>
                  <a:gd name="T111" fmla="*/ 747 h 823"/>
                  <a:gd name="T112" fmla="*/ 1651 w 1981"/>
                  <a:gd name="T113" fmla="*/ 751 h 823"/>
                  <a:gd name="T114" fmla="*/ 1707 w 1981"/>
                  <a:gd name="T115" fmla="*/ 756 h 823"/>
                  <a:gd name="T116" fmla="*/ 1754 w 1981"/>
                  <a:gd name="T117" fmla="*/ 760 h 823"/>
                  <a:gd name="T118" fmla="*/ 1810 w 1981"/>
                  <a:gd name="T119" fmla="*/ 765 h 823"/>
                  <a:gd name="T120" fmla="*/ 1859 w 1981"/>
                  <a:gd name="T121" fmla="*/ 775 h 823"/>
                  <a:gd name="T122" fmla="*/ 1903 w 1981"/>
                  <a:gd name="T123" fmla="*/ 812 h 823"/>
                  <a:gd name="T124" fmla="*/ 1954 w 1981"/>
                  <a:gd name="T125" fmla="*/ 820 h 8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1981" h="823">
                    <a:moveTo>
                      <a:pt x="0" y="0"/>
                    </a:moveTo>
                    <a:lnTo>
                      <a:pt x="0" y="0"/>
                    </a:lnTo>
                    <a:lnTo>
                      <a:pt x="3" y="5"/>
                    </a:lnTo>
                    <a:lnTo>
                      <a:pt x="6" y="12"/>
                    </a:lnTo>
                    <a:lnTo>
                      <a:pt x="6" y="12"/>
                    </a:lnTo>
                    <a:lnTo>
                      <a:pt x="9" y="16"/>
                    </a:lnTo>
                    <a:lnTo>
                      <a:pt x="9" y="16"/>
                    </a:lnTo>
                    <a:lnTo>
                      <a:pt x="12" y="24"/>
                    </a:lnTo>
                    <a:lnTo>
                      <a:pt x="12" y="24"/>
                    </a:lnTo>
                    <a:lnTo>
                      <a:pt x="15" y="33"/>
                    </a:lnTo>
                    <a:lnTo>
                      <a:pt x="17" y="40"/>
                    </a:lnTo>
                    <a:lnTo>
                      <a:pt x="20" y="48"/>
                    </a:lnTo>
                    <a:lnTo>
                      <a:pt x="20" y="48"/>
                    </a:lnTo>
                    <a:lnTo>
                      <a:pt x="23" y="56"/>
                    </a:lnTo>
                    <a:lnTo>
                      <a:pt x="23" y="56"/>
                    </a:lnTo>
                    <a:lnTo>
                      <a:pt x="26" y="63"/>
                    </a:lnTo>
                    <a:lnTo>
                      <a:pt x="26" y="63"/>
                    </a:lnTo>
                    <a:lnTo>
                      <a:pt x="29" y="72"/>
                    </a:lnTo>
                    <a:lnTo>
                      <a:pt x="29" y="72"/>
                    </a:lnTo>
                    <a:lnTo>
                      <a:pt x="30" y="90"/>
                    </a:lnTo>
                    <a:lnTo>
                      <a:pt x="30" y="90"/>
                    </a:lnTo>
                    <a:lnTo>
                      <a:pt x="33" y="100"/>
                    </a:lnTo>
                    <a:lnTo>
                      <a:pt x="33" y="100"/>
                    </a:lnTo>
                    <a:lnTo>
                      <a:pt x="36" y="110"/>
                    </a:lnTo>
                    <a:lnTo>
                      <a:pt x="36" y="110"/>
                    </a:lnTo>
                    <a:lnTo>
                      <a:pt x="39" y="120"/>
                    </a:lnTo>
                    <a:lnTo>
                      <a:pt x="39" y="120"/>
                    </a:lnTo>
                    <a:lnTo>
                      <a:pt x="42" y="130"/>
                    </a:lnTo>
                    <a:lnTo>
                      <a:pt x="42" y="130"/>
                    </a:lnTo>
                    <a:lnTo>
                      <a:pt x="45" y="140"/>
                    </a:lnTo>
                    <a:lnTo>
                      <a:pt x="45" y="140"/>
                    </a:lnTo>
                    <a:lnTo>
                      <a:pt x="47" y="149"/>
                    </a:lnTo>
                    <a:lnTo>
                      <a:pt x="47" y="149"/>
                    </a:lnTo>
                    <a:lnTo>
                      <a:pt x="50" y="158"/>
                    </a:lnTo>
                    <a:lnTo>
                      <a:pt x="50" y="158"/>
                    </a:lnTo>
                    <a:lnTo>
                      <a:pt x="53" y="168"/>
                    </a:lnTo>
                    <a:lnTo>
                      <a:pt x="53" y="168"/>
                    </a:lnTo>
                    <a:lnTo>
                      <a:pt x="56" y="186"/>
                    </a:lnTo>
                    <a:lnTo>
                      <a:pt x="56" y="186"/>
                    </a:lnTo>
                    <a:lnTo>
                      <a:pt x="59" y="189"/>
                    </a:lnTo>
                    <a:lnTo>
                      <a:pt x="59" y="189"/>
                    </a:lnTo>
                    <a:lnTo>
                      <a:pt x="62" y="199"/>
                    </a:lnTo>
                    <a:lnTo>
                      <a:pt x="62" y="199"/>
                    </a:lnTo>
                    <a:lnTo>
                      <a:pt x="65" y="211"/>
                    </a:lnTo>
                    <a:lnTo>
                      <a:pt x="65" y="211"/>
                    </a:lnTo>
                    <a:lnTo>
                      <a:pt x="68" y="222"/>
                    </a:lnTo>
                    <a:lnTo>
                      <a:pt x="68" y="222"/>
                    </a:lnTo>
                    <a:lnTo>
                      <a:pt x="70" y="232"/>
                    </a:lnTo>
                    <a:lnTo>
                      <a:pt x="70" y="232"/>
                    </a:lnTo>
                    <a:lnTo>
                      <a:pt x="72" y="244"/>
                    </a:lnTo>
                    <a:lnTo>
                      <a:pt x="72" y="244"/>
                    </a:lnTo>
                    <a:lnTo>
                      <a:pt x="75" y="256"/>
                    </a:lnTo>
                    <a:lnTo>
                      <a:pt x="75" y="256"/>
                    </a:lnTo>
                    <a:lnTo>
                      <a:pt x="78" y="269"/>
                    </a:lnTo>
                    <a:lnTo>
                      <a:pt x="78" y="269"/>
                    </a:lnTo>
                    <a:lnTo>
                      <a:pt x="80" y="281"/>
                    </a:lnTo>
                    <a:lnTo>
                      <a:pt x="80" y="281"/>
                    </a:lnTo>
                    <a:lnTo>
                      <a:pt x="83" y="293"/>
                    </a:lnTo>
                    <a:lnTo>
                      <a:pt x="83" y="293"/>
                    </a:lnTo>
                    <a:lnTo>
                      <a:pt x="86" y="299"/>
                    </a:lnTo>
                    <a:lnTo>
                      <a:pt x="86" y="299"/>
                    </a:lnTo>
                    <a:lnTo>
                      <a:pt x="89" y="313"/>
                    </a:lnTo>
                    <a:lnTo>
                      <a:pt x="89" y="313"/>
                    </a:lnTo>
                    <a:lnTo>
                      <a:pt x="92" y="326"/>
                    </a:lnTo>
                    <a:lnTo>
                      <a:pt x="92" y="326"/>
                    </a:lnTo>
                    <a:lnTo>
                      <a:pt x="95" y="340"/>
                    </a:lnTo>
                    <a:lnTo>
                      <a:pt x="95" y="340"/>
                    </a:lnTo>
                    <a:lnTo>
                      <a:pt x="98" y="354"/>
                    </a:lnTo>
                    <a:lnTo>
                      <a:pt x="98" y="354"/>
                    </a:lnTo>
                    <a:lnTo>
                      <a:pt x="100" y="369"/>
                    </a:lnTo>
                    <a:lnTo>
                      <a:pt x="100" y="369"/>
                    </a:lnTo>
                    <a:lnTo>
                      <a:pt x="103" y="382"/>
                    </a:lnTo>
                    <a:lnTo>
                      <a:pt x="103" y="382"/>
                    </a:lnTo>
                    <a:lnTo>
                      <a:pt x="106" y="396"/>
                    </a:lnTo>
                    <a:lnTo>
                      <a:pt x="106" y="396"/>
                    </a:lnTo>
                    <a:lnTo>
                      <a:pt x="109" y="411"/>
                    </a:lnTo>
                    <a:lnTo>
                      <a:pt x="109" y="411"/>
                    </a:lnTo>
                    <a:lnTo>
                      <a:pt x="112" y="425"/>
                    </a:lnTo>
                    <a:lnTo>
                      <a:pt x="112" y="425"/>
                    </a:lnTo>
                    <a:lnTo>
                      <a:pt x="113" y="440"/>
                    </a:lnTo>
                    <a:lnTo>
                      <a:pt x="113" y="440"/>
                    </a:lnTo>
                    <a:lnTo>
                      <a:pt x="116" y="455"/>
                    </a:lnTo>
                    <a:lnTo>
                      <a:pt x="116" y="455"/>
                    </a:lnTo>
                    <a:lnTo>
                      <a:pt x="119" y="469"/>
                    </a:lnTo>
                    <a:lnTo>
                      <a:pt x="119" y="469"/>
                    </a:lnTo>
                    <a:lnTo>
                      <a:pt x="122" y="483"/>
                    </a:lnTo>
                    <a:lnTo>
                      <a:pt x="122" y="483"/>
                    </a:lnTo>
                    <a:lnTo>
                      <a:pt x="125" y="496"/>
                    </a:lnTo>
                    <a:lnTo>
                      <a:pt x="125" y="496"/>
                    </a:lnTo>
                    <a:lnTo>
                      <a:pt x="128" y="510"/>
                    </a:lnTo>
                    <a:lnTo>
                      <a:pt x="128" y="510"/>
                    </a:lnTo>
                    <a:lnTo>
                      <a:pt x="131" y="524"/>
                    </a:lnTo>
                    <a:lnTo>
                      <a:pt x="131" y="524"/>
                    </a:lnTo>
                    <a:lnTo>
                      <a:pt x="133" y="536"/>
                    </a:lnTo>
                    <a:lnTo>
                      <a:pt x="133" y="536"/>
                    </a:lnTo>
                    <a:lnTo>
                      <a:pt x="136" y="547"/>
                    </a:lnTo>
                    <a:lnTo>
                      <a:pt x="136" y="547"/>
                    </a:lnTo>
                    <a:lnTo>
                      <a:pt x="139" y="559"/>
                    </a:lnTo>
                    <a:lnTo>
                      <a:pt x="139" y="559"/>
                    </a:lnTo>
                    <a:lnTo>
                      <a:pt x="142" y="570"/>
                    </a:lnTo>
                    <a:lnTo>
                      <a:pt x="142" y="570"/>
                    </a:lnTo>
                    <a:lnTo>
                      <a:pt x="145" y="581"/>
                    </a:lnTo>
                    <a:lnTo>
                      <a:pt x="145" y="581"/>
                    </a:lnTo>
                    <a:lnTo>
                      <a:pt x="148" y="592"/>
                    </a:lnTo>
                    <a:lnTo>
                      <a:pt x="148" y="592"/>
                    </a:lnTo>
                    <a:lnTo>
                      <a:pt x="151" y="601"/>
                    </a:lnTo>
                    <a:lnTo>
                      <a:pt x="151" y="601"/>
                    </a:lnTo>
                    <a:lnTo>
                      <a:pt x="153" y="610"/>
                    </a:lnTo>
                    <a:lnTo>
                      <a:pt x="153" y="610"/>
                    </a:lnTo>
                    <a:lnTo>
                      <a:pt x="155" y="618"/>
                    </a:lnTo>
                    <a:lnTo>
                      <a:pt x="155" y="618"/>
                    </a:lnTo>
                    <a:lnTo>
                      <a:pt x="158" y="627"/>
                    </a:lnTo>
                    <a:lnTo>
                      <a:pt x="158" y="627"/>
                    </a:lnTo>
                    <a:lnTo>
                      <a:pt x="161" y="635"/>
                    </a:lnTo>
                    <a:lnTo>
                      <a:pt x="161" y="635"/>
                    </a:lnTo>
                    <a:lnTo>
                      <a:pt x="163" y="642"/>
                    </a:lnTo>
                    <a:lnTo>
                      <a:pt x="166" y="649"/>
                    </a:lnTo>
                    <a:lnTo>
                      <a:pt x="169" y="655"/>
                    </a:lnTo>
                    <a:lnTo>
                      <a:pt x="169" y="655"/>
                    </a:lnTo>
                    <a:lnTo>
                      <a:pt x="172" y="662"/>
                    </a:lnTo>
                    <a:lnTo>
                      <a:pt x="172" y="662"/>
                    </a:lnTo>
                    <a:lnTo>
                      <a:pt x="175" y="668"/>
                    </a:lnTo>
                    <a:lnTo>
                      <a:pt x="175" y="668"/>
                    </a:lnTo>
                    <a:lnTo>
                      <a:pt x="178" y="672"/>
                    </a:lnTo>
                    <a:lnTo>
                      <a:pt x="178" y="672"/>
                    </a:lnTo>
                    <a:lnTo>
                      <a:pt x="181" y="677"/>
                    </a:lnTo>
                    <a:lnTo>
                      <a:pt x="181" y="677"/>
                    </a:lnTo>
                    <a:lnTo>
                      <a:pt x="184" y="683"/>
                    </a:lnTo>
                    <a:lnTo>
                      <a:pt x="184" y="683"/>
                    </a:lnTo>
                    <a:lnTo>
                      <a:pt x="186" y="687"/>
                    </a:lnTo>
                    <a:lnTo>
                      <a:pt x="189" y="690"/>
                    </a:lnTo>
                    <a:lnTo>
                      <a:pt x="192" y="694"/>
                    </a:lnTo>
                    <a:lnTo>
                      <a:pt x="192" y="694"/>
                    </a:lnTo>
                    <a:lnTo>
                      <a:pt x="195" y="697"/>
                    </a:lnTo>
                    <a:lnTo>
                      <a:pt x="196" y="698"/>
                    </a:lnTo>
                    <a:lnTo>
                      <a:pt x="199" y="701"/>
                    </a:lnTo>
                    <a:lnTo>
                      <a:pt x="199" y="701"/>
                    </a:lnTo>
                    <a:lnTo>
                      <a:pt x="202" y="702"/>
                    </a:lnTo>
                    <a:lnTo>
                      <a:pt x="208" y="705"/>
                    </a:lnTo>
                    <a:lnTo>
                      <a:pt x="211" y="703"/>
                    </a:lnTo>
                    <a:lnTo>
                      <a:pt x="216" y="702"/>
                    </a:lnTo>
                    <a:lnTo>
                      <a:pt x="219" y="701"/>
                    </a:lnTo>
                    <a:lnTo>
                      <a:pt x="222" y="699"/>
                    </a:lnTo>
                    <a:lnTo>
                      <a:pt x="225" y="697"/>
                    </a:lnTo>
                    <a:lnTo>
                      <a:pt x="225" y="697"/>
                    </a:lnTo>
                    <a:lnTo>
                      <a:pt x="228" y="694"/>
                    </a:lnTo>
                    <a:lnTo>
                      <a:pt x="231" y="691"/>
                    </a:lnTo>
                    <a:lnTo>
                      <a:pt x="234" y="687"/>
                    </a:lnTo>
                    <a:lnTo>
                      <a:pt x="234" y="687"/>
                    </a:lnTo>
                    <a:lnTo>
                      <a:pt x="236" y="684"/>
                    </a:lnTo>
                    <a:lnTo>
                      <a:pt x="236" y="684"/>
                    </a:lnTo>
                    <a:lnTo>
                      <a:pt x="238" y="677"/>
                    </a:lnTo>
                    <a:lnTo>
                      <a:pt x="238" y="677"/>
                    </a:lnTo>
                    <a:lnTo>
                      <a:pt x="241" y="673"/>
                    </a:lnTo>
                    <a:lnTo>
                      <a:pt x="244" y="668"/>
                    </a:lnTo>
                    <a:lnTo>
                      <a:pt x="247" y="661"/>
                    </a:lnTo>
                    <a:lnTo>
                      <a:pt x="247" y="661"/>
                    </a:lnTo>
                    <a:lnTo>
                      <a:pt x="249" y="654"/>
                    </a:lnTo>
                    <a:lnTo>
                      <a:pt x="249" y="654"/>
                    </a:lnTo>
                    <a:lnTo>
                      <a:pt x="252" y="646"/>
                    </a:lnTo>
                    <a:lnTo>
                      <a:pt x="252" y="646"/>
                    </a:lnTo>
                    <a:lnTo>
                      <a:pt x="255" y="638"/>
                    </a:lnTo>
                    <a:lnTo>
                      <a:pt x="255" y="638"/>
                    </a:lnTo>
                    <a:lnTo>
                      <a:pt x="258" y="629"/>
                    </a:lnTo>
                    <a:lnTo>
                      <a:pt x="258" y="629"/>
                    </a:lnTo>
                    <a:lnTo>
                      <a:pt x="261" y="620"/>
                    </a:lnTo>
                    <a:lnTo>
                      <a:pt x="261" y="620"/>
                    </a:lnTo>
                    <a:lnTo>
                      <a:pt x="264" y="610"/>
                    </a:lnTo>
                    <a:lnTo>
                      <a:pt x="264" y="610"/>
                    </a:lnTo>
                    <a:lnTo>
                      <a:pt x="267" y="601"/>
                    </a:lnTo>
                    <a:lnTo>
                      <a:pt x="267" y="601"/>
                    </a:lnTo>
                    <a:lnTo>
                      <a:pt x="269" y="590"/>
                    </a:lnTo>
                    <a:lnTo>
                      <a:pt x="269" y="590"/>
                    </a:lnTo>
                    <a:lnTo>
                      <a:pt x="272" y="577"/>
                    </a:lnTo>
                    <a:lnTo>
                      <a:pt x="272" y="577"/>
                    </a:lnTo>
                    <a:lnTo>
                      <a:pt x="275" y="565"/>
                    </a:lnTo>
                    <a:lnTo>
                      <a:pt x="275" y="565"/>
                    </a:lnTo>
                    <a:lnTo>
                      <a:pt x="278" y="553"/>
                    </a:lnTo>
                    <a:lnTo>
                      <a:pt x="278" y="553"/>
                    </a:lnTo>
                    <a:lnTo>
                      <a:pt x="279" y="539"/>
                    </a:lnTo>
                    <a:lnTo>
                      <a:pt x="279" y="539"/>
                    </a:lnTo>
                    <a:lnTo>
                      <a:pt x="282" y="525"/>
                    </a:lnTo>
                    <a:lnTo>
                      <a:pt x="282" y="525"/>
                    </a:lnTo>
                    <a:lnTo>
                      <a:pt x="285" y="510"/>
                    </a:lnTo>
                    <a:lnTo>
                      <a:pt x="285" y="510"/>
                    </a:lnTo>
                    <a:lnTo>
                      <a:pt x="288" y="495"/>
                    </a:lnTo>
                    <a:lnTo>
                      <a:pt x="288" y="495"/>
                    </a:lnTo>
                    <a:lnTo>
                      <a:pt x="291" y="480"/>
                    </a:lnTo>
                    <a:lnTo>
                      <a:pt x="291" y="480"/>
                    </a:lnTo>
                    <a:lnTo>
                      <a:pt x="294" y="462"/>
                    </a:lnTo>
                    <a:lnTo>
                      <a:pt x="294" y="462"/>
                    </a:lnTo>
                    <a:lnTo>
                      <a:pt x="297" y="446"/>
                    </a:lnTo>
                    <a:lnTo>
                      <a:pt x="297" y="446"/>
                    </a:lnTo>
                    <a:lnTo>
                      <a:pt x="299" y="428"/>
                    </a:lnTo>
                    <a:lnTo>
                      <a:pt x="299" y="428"/>
                    </a:lnTo>
                    <a:lnTo>
                      <a:pt x="302" y="410"/>
                    </a:lnTo>
                    <a:lnTo>
                      <a:pt x="302" y="410"/>
                    </a:lnTo>
                    <a:lnTo>
                      <a:pt x="305" y="392"/>
                    </a:lnTo>
                    <a:lnTo>
                      <a:pt x="305" y="392"/>
                    </a:lnTo>
                    <a:lnTo>
                      <a:pt x="308" y="374"/>
                    </a:lnTo>
                    <a:lnTo>
                      <a:pt x="308" y="374"/>
                    </a:lnTo>
                    <a:lnTo>
                      <a:pt x="311" y="356"/>
                    </a:lnTo>
                    <a:lnTo>
                      <a:pt x="311" y="356"/>
                    </a:lnTo>
                    <a:lnTo>
                      <a:pt x="314" y="339"/>
                    </a:lnTo>
                    <a:lnTo>
                      <a:pt x="314" y="339"/>
                    </a:lnTo>
                    <a:lnTo>
                      <a:pt x="317" y="319"/>
                    </a:lnTo>
                    <a:lnTo>
                      <a:pt x="317" y="319"/>
                    </a:lnTo>
                    <a:lnTo>
                      <a:pt x="320" y="302"/>
                    </a:lnTo>
                    <a:lnTo>
                      <a:pt x="320" y="302"/>
                    </a:lnTo>
                    <a:lnTo>
                      <a:pt x="321" y="284"/>
                    </a:lnTo>
                    <a:lnTo>
                      <a:pt x="321" y="284"/>
                    </a:lnTo>
                    <a:lnTo>
                      <a:pt x="324" y="266"/>
                    </a:lnTo>
                    <a:lnTo>
                      <a:pt x="324" y="266"/>
                    </a:lnTo>
                    <a:lnTo>
                      <a:pt x="327" y="249"/>
                    </a:lnTo>
                    <a:lnTo>
                      <a:pt x="327" y="249"/>
                    </a:lnTo>
                    <a:lnTo>
                      <a:pt x="330" y="232"/>
                    </a:lnTo>
                    <a:lnTo>
                      <a:pt x="330" y="232"/>
                    </a:lnTo>
                    <a:lnTo>
                      <a:pt x="332" y="215"/>
                    </a:lnTo>
                    <a:lnTo>
                      <a:pt x="332" y="215"/>
                    </a:lnTo>
                    <a:lnTo>
                      <a:pt x="335" y="200"/>
                    </a:lnTo>
                    <a:lnTo>
                      <a:pt x="335" y="200"/>
                    </a:lnTo>
                    <a:lnTo>
                      <a:pt x="338" y="185"/>
                    </a:lnTo>
                    <a:lnTo>
                      <a:pt x="338" y="185"/>
                    </a:lnTo>
                    <a:lnTo>
                      <a:pt x="341" y="170"/>
                    </a:lnTo>
                    <a:lnTo>
                      <a:pt x="341" y="170"/>
                    </a:lnTo>
                    <a:lnTo>
                      <a:pt x="344" y="156"/>
                    </a:lnTo>
                    <a:lnTo>
                      <a:pt x="344" y="156"/>
                    </a:lnTo>
                    <a:lnTo>
                      <a:pt x="347" y="144"/>
                    </a:lnTo>
                    <a:lnTo>
                      <a:pt x="347" y="144"/>
                    </a:lnTo>
                    <a:lnTo>
                      <a:pt x="350" y="131"/>
                    </a:lnTo>
                    <a:lnTo>
                      <a:pt x="350" y="131"/>
                    </a:lnTo>
                    <a:lnTo>
                      <a:pt x="352" y="122"/>
                    </a:lnTo>
                    <a:lnTo>
                      <a:pt x="352" y="122"/>
                    </a:lnTo>
                    <a:lnTo>
                      <a:pt x="355" y="111"/>
                    </a:lnTo>
                    <a:lnTo>
                      <a:pt x="355" y="111"/>
                    </a:lnTo>
                    <a:lnTo>
                      <a:pt x="358" y="103"/>
                    </a:lnTo>
                    <a:lnTo>
                      <a:pt x="358" y="103"/>
                    </a:lnTo>
                    <a:lnTo>
                      <a:pt x="361" y="94"/>
                    </a:lnTo>
                    <a:lnTo>
                      <a:pt x="361" y="94"/>
                    </a:lnTo>
                    <a:lnTo>
                      <a:pt x="363" y="89"/>
                    </a:lnTo>
                    <a:lnTo>
                      <a:pt x="363" y="89"/>
                    </a:lnTo>
                    <a:lnTo>
                      <a:pt x="365" y="83"/>
                    </a:lnTo>
                    <a:lnTo>
                      <a:pt x="365" y="83"/>
                    </a:lnTo>
                    <a:lnTo>
                      <a:pt x="368" y="79"/>
                    </a:lnTo>
                    <a:lnTo>
                      <a:pt x="371" y="74"/>
                    </a:lnTo>
                    <a:lnTo>
                      <a:pt x="374" y="72"/>
                    </a:lnTo>
                    <a:lnTo>
                      <a:pt x="380" y="70"/>
                    </a:lnTo>
                    <a:lnTo>
                      <a:pt x="383" y="68"/>
                    </a:lnTo>
                    <a:lnTo>
                      <a:pt x="385" y="71"/>
                    </a:lnTo>
                    <a:lnTo>
                      <a:pt x="388" y="74"/>
                    </a:lnTo>
                    <a:lnTo>
                      <a:pt x="388" y="74"/>
                    </a:lnTo>
                    <a:lnTo>
                      <a:pt x="391" y="78"/>
                    </a:lnTo>
                    <a:lnTo>
                      <a:pt x="394" y="81"/>
                    </a:lnTo>
                    <a:lnTo>
                      <a:pt x="397" y="86"/>
                    </a:lnTo>
                    <a:lnTo>
                      <a:pt x="397" y="86"/>
                    </a:lnTo>
                    <a:lnTo>
                      <a:pt x="400" y="90"/>
                    </a:lnTo>
                    <a:lnTo>
                      <a:pt x="403" y="97"/>
                    </a:lnTo>
                    <a:lnTo>
                      <a:pt x="404" y="104"/>
                    </a:lnTo>
                    <a:lnTo>
                      <a:pt x="404" y="104"/>
                    </a:lnTo>
                    <a:lnTo>
                      <a:pt x="407" y="112"/>
                    </a:lnTo>
                    <a:lnTo>
                      <a:pt x="407" y="112"/>
                    </a:lnTo>
                    <a:lnTo>
                      <a:pt x="410" y="120"/>
                    </a:lnTo>
                    <a:lnTo>
                      <a:pt x="410" y="120"/>
                    </a:lnTo>
                    <a:lnTo>
                      <a:pt x="413" y="130"/>
                    </a:lnTo>
                    <a:lnTo>
                      <a:pt x="413" y="130"/>
                    </a:lnTo>
                    <a:lnTo>
                      <a:pt x="415" y="138"/>
                    </a:lnTo>
                    <a:lnTo>
                      <a:pt x="415" y="138"/>
                    </a:lnTo>
                    <a:lnTo>
                      <a:pt x="418" y="147"/>
                    </a:lnTo>
                    <a:lnTo>
                      <a:pt x="418" y="147"/>
                    </a:lnTo>
                    <a:lnTo>
                      <a:pt x="421" y="156"/>
                    </a:lnTo>
                    <a:lnTo>
                      <a:pt x="421" y="156"/>
                    </a:lnTo>
                    <a:lnTo>
                      <a:pt x="424" y="166"/>
                    </a:lnTo>
                    <a:lnTo>
                      <a:pt x="424" y="166"/>
                    </a:lnTo>
                    <a:lnTo>
                      <a:pt x="427" y="175"/>
                    </a:lnTo>
                    <a:lnTo>
                      <a:pt x="427" y="175"/>
                    </a:lnTo>
                    <a:lnTo>
                      <a:pt x="430" y="185"/>
                    </a:lnTo>
                    <a:lnTo>
                      <a:pt x="430" y="185"/>
                    </a:lnTo>
                    <a:lnTo>
                      <a:pt x="433" y="196"/>
                    </a:lnTo>
                    <a:lnTo>
                      <a:pt x="433" y="196"/>
                    </a:lnTo>
                    <a:lnTo>
                      <a:pt x="436" y="206"/>
                    </a:lnTo>
                    <a:lnTo>
                      <a:pt x="436" y="206"/>
                    </a:lnTo>
                    <a:lnTo>
                      <a:pt x="438" y="216"/>
                    </a:lnTo>
                    <a:lnTo>
                      <a:pt x="438" y="216"/>
                    </a:lnTo>
                    <a:lnTo>
                      <a:pt x="441" y="227"/>
                    </a:lnTo>
                    <a:lnTo>
                      <a:pt x="441" y="227"/>
                    </a:lnTo>
                    <a:lnTo>
                      <a:pt x="444" y="237"/>
                    </a:lnTo>
                    <a:lnTo>
                      <a:pt x="444" y="237"/>
                    </a:lnTo>
                    <a:lnTo>
                      <a:pt x="446" y="248"/>
                    </a:lnTo>
                    <a:lnTo>
                      <a:pt x="446" y="248"/>
                    </a:lnTo>
                    <a:lnTo>
                      <a:pt x="448" y="259"/>
                    </a:lnTo>
                    <a:lnTo>
                      <a:pt x="448" y="259"/>
                    </a:lnTo>
                    <a:lnTo>
                      <a:pt x="451" y="270"/>
                    </a:lnTo>
                    <a:lnTo>
                      <a:pt x="451" y="270"/>
                    </a:lnTo>
                    <a:lnTo>
                      <a:pt x="454" y="280"/>
                    </a:lnTo>
                    <a:lnTo>
                      <a:pt x="454" y="280"/>
                    </a:lnTo>
                    <a:lnTo>
                      <a:pt x="457" y="289"/>
                    </a:lnTo>
                    <a:lnTo>
                      <a:pt x="457" y="289"/>
                    </a:lnTo>
                    <a:lnTo>
                      <a:pt x="460" y="300"/>
                    </a:lnTo>
                    <a:lnTo>
                      <a:pt x="460" y="300"/>
                    </a:lnTo>
                    <a:lnTo>
                      <a:pt x="463" y="310"/>
                    </a:lnTo>
                    <a:lnTo>
                      <a:pt x="463" y="310"/>
                    </a:lnTo>
                    <a:lnTo>
                      <a:pt x="466" y="319"/>
                    </a:lnTo>
                    <a:lnTo>
                      <a:pt x="466" y="319"/>
                    </a:lnTo>
                    <a:lnTo>
                      <a:pt x="468" y="330"/>
                    </a:lnTo>
                    <a:lnTo>
                      <a:pt x="468" y="330"/>
                    </a:lnTo>
                    <a:lnTo>
                      <a:pt x="471" y="339"/>
                    </a:lnTo>
                    <a:lnTo>
                      <a:pt x="471" y="339"/>
                    </a:lnTo>
                    <a:lnTo>
                      <a:pt x="474" y="350"/>
                    </a:lnTo>
                    <a:lnTo>
                      <a:pt x="474" y="350"/>
                    </a:lnTo>
                    <a:lnTo>
                      <a:pt x="477" y="359"/>
                    </a:lnTo>
                    <a:lnTo>
                      <a:pt x="477" y="359"/>
                    </a:lnTo>
                    <a:lnTo>
                      <a:pt x="480" y="369"/>
                    </a:lnTo>
                    <a:lnTo>
                      <a:pt x="480" y="369"/>
                    </a:lnTo>
                    <a:lnTo>
                      <a:pt x="483" y="378"/>
                    </a:lnTo>
                    <a:lnTo>
                      <a:pt x="483" y="378"/>
                    </a:lnTo>
                    <a:lnTo>
                      <a:pt x="486" y="388"/>
                    </a:lnTo>
                    <a:lnTo>
                      <a:pt x="486" y="388"/>
                    </a:lnTo>
                    <a:lnTo>
                      <a:pt x="487" y="396"/>
                    </a:lnTo>
                    <a:lnTo>
                      <a:pt x="487" y="396"/>
                    </a:lnTo>
                    <a:lnTo>
                      <a:pt x="490" y="406"/>
                    </a:lnTo>
                    <a:lnTo>
                      <a:pt x="490" y="406"/>
                    </a:lnTo>
                    <a:lnTo>
                      <a:pt x="493" y="415"/>
                    </a:lnTo>
                    <a:lnTo>
                      <a:pt x="493" y="415"/>
                    </a:lnTo>
                    <a:lnTo>
                      <a:pt x="496" y="424"/>
                    </a:lnTo>
                    <a:lnTo>
                      <a:pt x="496" y="424"/>
                    </a:lnTo>
                    <a:lnTo>
                      <a:pt x="499" y="433"/>
                    </a:lnTo>
                    <a:lnTo>
                      <a:pt x="499" y="433"/>
                    </a:lnTo>
                    <a:lnTo>
                      <a:pt x="501" y="441"/>
                    </a:lnTo>
                    <a:lnTo>
                      <a:pt x="501" y="441"/>
                    </a:lnTo>
                    <a:lnTo>
                      <a:pt x="504" y="450"/>
                    </a:lnTo>
                    <a:lnTo>
                      <a:pt x="504" y="450"/>
                    </a:lnTo>
                    <a:lnTo>
                      <a:pt x="507" y="458"/>
                    </a:lnTo>
                    <a:lnTo>
                      <a:pt x="507" y="458"/>
                    </a:lnTo>
                    <a:lnTo>
                      <a:pt x="510" y="468"/>
                    </a:lnTo>
                    <a:lnTo>
                      <a:pt x="510" y="468"/>
                    </a:lnTo>
                    <a:lnTo>
                      <a:pt x="513" y="476"/>
                    </a:lnTo>
                    <a:lnTo>
                      <a:pt x="513" y="476"/>
                    </a:lnTo>
                    <a:lnTo>
                      <a:pt x="516" y="484"/>
                    </a:lnTo>
                    <a:lnTo>
                      <a:pt x="516" y="484"/>
                    </a:lnTo>
                    <a:lnTo>
                      <a:pt x="519" y="492"/>
                    </a:lnTo>
                    <a:lnTo>
                      <a:pt x="519" y="492"/>
                    </a:lnTo>
                    <a:lnTo>
                      <a:pt x="521" y="502"/>
                    </a:lnTo>
                    <a:lnTo>
                      <a:pt x="524" y="509"/>
                    </a:lnTo>
                    <a:lnTo>
                      <a:pt x="527" y="517"/>
                    </a:lnTo>
                    <a:lnTo>
                      <a:pt x="527" y="517"/>
                    </a:lnTo>
                    <a:lnTo>
                      <a:pt x="529" y="525"/>
                    </a:lnTo>
                    <a:lnTo>
                      <a:pt x="529" y="525"/>
                    </a:lnTo>
                    <a:lnTo>
                      <a:pt x="531" y="532"/>
                    </a:lnTo>
                    <a:lnTo>
                      <a:pt x="531" y="532"/>
                    </a:lnTo>
                    <a:lnTo>
                      <a:pt x="534" y="542"/>
                    </a:lnTo>
                    <a:lnTo>
                      <a:pt x="534" y="542"/>
                    </a:lnTo>
                    <a:lnTo>
                      <a:pt x="537" y="548"/>
                    </a:lnTo>
                    <a:lnTo>
                      <a:pt x="537" y="548"/>
                    </a:lnTo>
                    <a:lnTo>
                      <a:pt x="540" y="557"/>
                    </a:lnTo>
                    <a:lnTo>
                      <a:pt x="540" y="557"/>
                    </a:lnTo>
                    <a:lnTo>
                      <a:pt x="543" y="564"/>
                    </a:lnTo>
                    <a:lnTo>
                      <a:pt x="543" y="564"/>
                    </a:lnTo>
                    <a:lnTo>
                      <a:pt x="546" y="572"/>
                    </a:lnTo>
                    <a:lnTo>
                      <a:pt x="546" y="572"/>
                    </a:lnTo>
                    <a:lnTo>
                      <a:pt x="549" y="577"/>
                    </a:lnTo>
                    <a:lnTo>
                      <a:pt x="549" y="577"/>
                    </a:lnTo>
                    <a:lnTo>
                      <a:pt x="552" y="584"/>
                    </a:lnTo>
                    <a:lnTo>
                      <a:pt x="552" y="584"/>
                    </a:lnTo>
                    <a:lnTo>
                      <a:pt x="554" y="591"/>
                    </a:lnTo>
                    <a:lnTo>
                      <a:pt x="554" y="591"/>
                    </a:lnTo>
                    <a:lnTo>
                      <a:pt x="557" y="598"/>
                    </a:lnTo>
                    <a:lnTo>
                      <a:pt x="557" y="598"/>
                    </a:lnTo>
                    <a:lnTo>
                      <a:pt x="560" y="605"/>
                    </a:lnTo>
                    <a:lnTo>
                      <a:pt x="560" y="605"/>
                    </a:lnTo>
                    <a:lnTo>
                      <a:pt x="563" y="610"/>
                    </a:lnTo>
                    <a:lnTo>
                      <a:pt x="563" y="610"/>
                    </a:lnTo>
                    <a:lnTo>
                      <a:pt x="566" y="617"/>
                    </a:lnTo>
                    <a:lnTo>
                      <a:pt x="569" y="623"/>
                    </a:lnTo>
                    <a:lnTo>
                      <a:pt x="570" y="628"/>
                    </a:lnTo>
                    <a:lnTo>
                      <a:pt x="570" y="628"/>
                    </a:lnTo>
                    <a:lnTo>
                      <a:pt x="573" y="633"/>
                    </a:lnTo>
                    <a:lnTo>
                      <a:pt x="576" y="639"/>
                    </a:lnTo>
                    <a:lnTo>
                      <a:pt x="579" y="644"/>
                    </a:lnTo>
                    <a:lnTo>
                      <a:pt x="579" y="644"/>
                    </a:lnTo>
                    <a:lnTo>
                      <a:pt x="582" y="650"/>
                    </a:lnTo>
                    <a:lnTo>
                      <a:pt x="584" y="655"/>
                    </a:lnTo>
                    <a:lnTo>
                      <a:pt x="587" y="660"/>
                    </a:lnTo>
                    <a:lnTo>
                      <a:pt x="587" y="660"/>
                    </a:lnTo>
                    <a:lnTo>
                      <a:pt x="590" y="664"/>
                    </a:lnTo>
                    <a:lnTo>
                      <a:pt x="590" y="664"/>
                    </a:lnTo>
                    <a:lnTo>
                      <a:pt x="593" y="668"/>
                    </a:lnTo>
                    <a:lnTo>
                      <a:pt x="596" y="672"/>
                    </a:lnTo>
                    <a:lnTo>
                      <a:pt x="599" y="676"/>
                    </a:lnTo>
                    <a:lnTo>
                      <a:pt x="602" y="680"/>
                    </a:lnTo>
                    <a:lnTo>
                      <a:pt x="605" y="684"/>
                    </a:lnTo>
                    <a:lnTo>
                      <a:pt x="605" y="684"/>
                    </a:lnTo>
                    <a:lnTo>
                      <a:pt x="607" y="688"/>
                    </a:lnTo>
                    <a:lnTo>
                      <a:pt x="607" y="688"/>
                    </a:lnTo>
                    <a:lnTo>
                      <a:pt x="610" y="691"/>
                    </a:lnTo>
                    <a:lnTo>
                      <a:pt x="612" y="694"/>
                    </a:lnTo>
                    <a:lnTo>
                      <a:pt x="615" y="697"/>
                    </a:lnTo>
                    <a:lnTo>
                      <a:pt x="615" y="697"/>
                    </a:lnTo>
                    <a:lnTo>
                      <a:pt x="617" y="699"/>
                    </a:lnTo>
                    <a:lnTo>
                      <a:pt x="620" y="702"/>
                    </a:lnTo>
                    <a:lnTo>
                      <a:pt x="623" y="703"/>
                    </a:lnTo>
                    <a:lnTo>
                      <a:pt x="626" y="706"/>
                    </a:lnTo>
                    <a:lnTo>
                      <a:pt x="629" y="708"/>
                    </a:lnTo>
                    <a:lnTo>
                      <a:pt x="629" y="708"/>
                    </a:lnTo>
                    <a:lnTo>
                      <a:pt x="632" y="709"/>
                    </a:lnTo>
                    <a:lnTo>
                      <a:pt x="637" y="710"/>
                    </a:lnTo>
                    <a:lnTo>
                      <a:pt x="640" y="710"/>
                    </a:lnTo>
                    <a:lnTo>
                      <a:pt x="646" y="710"/>
                    </a:lnTo>
                    <a:lnTo>
                      <a:pt x="649" y="710"/>
                    </a:lnTo>
                    <a:lnTo>
                      <a:pt x="656" y="708"/>
                    </a:lnTo>
                    <a:lnTo>
                      <a:pt x="659" y="708"/>
                    </a:lnTo>
                    <a:lnTo>
                      <a:pt x="659" y="708"/>
                    </a:lnTo>
                    <a:lnTo>
                      <a:pt x="662" y="706"/>
                    </a:lnTo>
                    <a:lnTo>
                      <a:pt x="662" y="706"/>
                    </a:lnTo>
                    <a:lnTo>
                      <a:pt x="665" y="708"/>
                    </a:lnTo>
                    <a:lnTo>
                      <a:pt x="665" y="708"/>
                    </a:lnTo>
                    <a:lnTo>
                      <a:pt x="668" y="706"/>
                    </a:lnTo>
                    <a:lnTo>
                      <a:pt x="673" y="702"/>
                    </a:lnTo>
                    <a:lnTo>
                      <a:pt x="676" y="699"/>
                    </a:lnTo>
                    <a:lnTo>
                      <a:pt x="676" y="699"/>
                    </a:lnTo>
                    <a:lnTo>
                      <a:pt x="679" y="697"/>
                    </a:lnTo>
                    <a:lnTo>
                      <a:pt x="682" y="694"/>
                    </a:lnTo>
                    <a:lnTo>
                      <a:pt x="685" y="691"/>
                    </a:lnTo>
                    <a:lnTo>
                      <a:pt x="685" y="691"/>
                    </a:lnTo>
                    <a:lnTo>
                      <a:pt x="688" y="688"/>
                    </a:lnTo>
                    <a:lnTo>
                      <a:pt x="690" y="687"/>
                    </a:lnTo>
                    <a:lnTo>
                      <a:pt x="693" y="680"/>
                    </a:lnTo>
                    <a:lnTo>
                      <a:pt x="695" y="676"/>
                    </a:lnTo>
                    <a:lnTo>
                      <a:pt x="698" y="673"/>
                    </a:lnTo>
                    <a:lnTo>
                      <a:pt x="698" y="673"/>
                    </a:lnTo>
                    <a:lnTo>
                      <a:pt x="700" y="668"/>
                    </a:lnTo>
                    <a:lnTo>
                      <a:pt x="700" y="668"/>
                    </a:lnTo>
                    <a:lnTo>
                      <a:pt x="703" y="664"/>
                    </a:lnTo>
                    <a:lnTo>
                      <a:pt x="706" y="660"/>
                    </a:lnTo>
                    <a:lnTo>
                      <a:pt x="709" y="654"/>
                    </a:lnTo>
                    <a:lnTo>
                      <a:pt x="712" y="650"/>
                    </a:lnTo>
                    <a:lnTo>
                      <a:pt x="715" y="646"/>
                    </a:lnTo>
                    <a:lnTo>
                      <a:pt x="715" y="646"/>
                    </a:lnTo>
                    <a:lnTo>
                      <a:pt x="718" y="640"/>
                    </a:lnTo>
                    <a:lnTo>
                      <a:pt x="718" y="640"/>
                    </a:lnTo>
                    <a:lnTo>
                      <a:pt x="721" y="632"/>
                    </a:lnTo>
                    <a:lnTo>
                      <a:pt x="721" y="632"/>
                    </a:lnTo>
                    <a:lnTo>
                      <a:pt x="723" y="624"/>
                    </a:lnTo>
                    <a:lnTo>
                      <a:pt x="723" y="624"/>
                    </a:lnTo>
                    <a:lnTo>
                      <a:pt x="726" y="618"/>
                    </a:lnTo>
                    <a:lnTo>
                      <a:pt x="726" y="618"/>
                    </a:lnTo>
                    <a:lnTo>
                      <a:pt x="729" y="613"/>
                    </a:lnTo>
                    <a:lnTo>
                      <a:pt x="729" y="613"/>
                    </a:lnTo>
                    <a:lnTo>
                      <a:pt x="732" y="607"/>
                    </a:lnTo>
                    <a:lnTo>
                      <a:pt x="732" y="607"/>
                    </a:lnTo>
                    <a:lnTo>
                      <a:pt x="735" y="602"/>
                    </a:lnTo>
                    <a:lnTo>
                      <a:pt x="735" y="602"/>
                    </a:lnTo>
                    <a:lnTo>
                      <a:pt x="736" y="598"/>
                    </a:lnTo>
                    <a:lnTo>
                      <a:pt x="739" y="592"/>
                    </a:lnTo>
                    <a:lnTo>
                      <a:pt x="742" y="587"/>
                    </a:lnTo>
                    <a:lnTo>
                      <a:pt x="742" y="587"/>
                    </a:lnTo>
                    <a:lnTo>
                      <a:pt x="745" y="581"/>
                    </a:lnTo>
                    <a:lnTo>
                      <a:pt x="745" y="581"/>
                    </a:lnTo>
                    <a:lnTo>
                      <a:pt x="748" y="572"/>
                    </a:lnTo>
                    <a:lnTo>
                      <a:pt x="751" y="570"/>
                    </a:lnTo>
                    <a:lnTo>
                      <a:pt x="753" y="566"/>
                    </a:lnTo>
                    <a:lnTo>
                      <a:pt x="756" y="561"/>
                    </a:lnTo>
                    <a:lnTo>
                      <a:pt x="759" y="555"/>
                    </a:lnTo>
                    <a:lnTo>
                      <a:pt x="759" y="555"/>
                    </a:lnTo>
                    <a:lnTo>
                      <a:pt x="762" y="550"/>
                    </a:lnTo>
                    <a:lnTo>
                      <a:pt x="765" y="546"/>
                    </a:lnTo>
                    <a:lnTo>
                      <a:pt x="768" y="540"/>
                    </a:lnTo>
                    <a:lnTo>
                      <a:pt x="768" y="540"/>
                    </a:lnTo>
                    <a:lnTo>
                      <a:pt x="771" y="536"/>
                    </a:lnTo>
                    <a:lnTo>
                      <a:pt x="771" y="536"/>
                    </a:lnTo>
                    <a:lnTo>
                      <a:pt x="774" y="532"/>
                    </a:lnTo>
                    <a:lnTo>
                      <a:pt x="776" y="526"/>
                    </a:lnTo>
                    <a:lnTo>
                      <a:pt x="778" y="526"/>
                    </a:lnTo>
                    <a:lnTo>
                      <a:pt x="778" y="526"/>
                    </a:lnTo>
                    <a:lnTo>
                      <a:pt x="781" y="522"/>
                    </a:lnTo>
                    <a:lnTo>
                      <a:pt x="784" y="518"/>
                    </a:lnTo>
                    <a:lnTo>
                      <a:pt x="786" y="514"/>
                    </a:lnTo>
                    <a:lnTo>
                      <a:pt x="789" y="511"/>
                    </a:lnTo>
                    <a:lnTo>
                      <a:pt x="792" y="509"/>
                    </a:lnTo>
                    <a:lnTo>
                      <a:pt x="792" y="509"/>
                    </a:lnTo>
                    <a:lnTo>
                      <a:pt x="795" y="511"/>
                    </a:lnTo>
                    <a:lnTo>
                      <a:pt x="795" y="511"/>
                    </a:lnTo>
                    <a:lnTo>
                      <a:pt x="798" y="507"/>
                    </a:lnTo>
                    <a:lnTo>
                      <a:pt x="801" y="505"/>
                    </a:lnTo>
                    <a:lnTo>
                      <a:pt x="804" y="503"/>
                    </a:lnTo>
                    <a:lnTo>
                      <a:pt x="804" y="503"/>
                    </a:lnTo>
                    <a:lnTo>
                      <a:pt x="806" y="500"/>
                    </a:lnTo>
                    <a:lnTo>
                      <a:pt x="809" y="498"/>
                    </a:lnTo>
                    <a:lnTo>
                      <a:pt x="812" y="496"/>
                    </a:lnTo>
                    <a:lnTo>
                      <a:pt x="818" y="494"/>
                    </a:lnTo>
                    <a:lnTo>
                      <a:pt x="819" y="502"/>
                    </a:lnTo>
                    <a:lnTo>
                      <a:pt x="819" y="502"/>
                    </a:lnTo>
                    <a:lnTo>
                      <a:pt x="822" y="495"/>
                    </a:lnTo>
                    <a:lnTo>
                      <a:pt x="828" y="494"/>
                    </a:lnTo>
                    <a:lnTo>
                      <a:pt x="831" y="492"/>
                    </a:lnTo>
                    <a:lnTo>
                      <a:pt x="837" y="491"/>
                    </a:lnTo>
                    <a:lnTo>
                      <a:pt x="839" y="492"/>
                    </a:lnTo>
                    <a:lnTo>
                      <a:pt x="842" y="491"/>
                    </a:lnTo>
                    <a:lnTo>
                      <a:pt x="845" y="496"/>
                    </a:lnTo>
                    <a:lnTo>
                      <a:pt x="845" y="496"/>
                    </a:lnTo>
                    <a:lnTo>
                      <a:pt x="848" y="492"/>
                    </a:lnTo>
                    <a:lnTo>
                      <a:pt x="854" y="487"/>
                    </a:lnTo>
                    <a:lnTo>
                      <a:pt x="857" y="488"/>
                    </a:lnTo>
                    <a:lnTo>
                      <a:pt x="861" y="489"/>
                    </a:lnTo>
                    <a:lnTo>
                      <a:pt x="864" y="492"/>
                    </a:lnTo>
                    <a:lnTo>
                      <a:pt x="864" y="492"/>
                    </a:lnTo>
                    <a:lnTo>
                      <a:pt x="867" y="494"/>
                    </a:lnTo>
                    <a:lnTo>
                      <a:pt x="869" y="496"/>
                    </a:lnTo>
                    <a:lnTo>
                      <a:pt x="872" y="498"/>
                    </a:lnTo>
                    <a:lnTo>
                      <a:pt x="878" y="498"/>
                    </a:lnTo>
                    <a:lnTo>
                      <a:pt x="881" y="500"/>
                    </a:lnTo>
                    <a:lnTo>
                      <a:pt x="881" y="500"/>
                    </a:lnTo>
                    <a:lnTo>
                      <a:pt x="884" y="503"/>
                    </a:lnTo>
                    <a:lnTo>
                      <a:pt x="887" y="507"/>
                    </a:lnTo>
                    <a:lnTo>
                      <a:pt x="890" y="510"/>
                    </a:lnTo>
                    <a:lnTo>
                      <a:pt x="895" y="516"/>
                    </a:lnTo>
                    <a:lnTo>
                      <a:pt x="898" y="520"/>
                    </a:lnTo>
                    <a:lnTo>
                      <a:pt x="901" y="522"/>
                    </a:lnTo>
                    <a:lnTo>
                      <a:pt x="902" y="526"/>
                    </a:lnTo>
                    <a:lnTo>
                      <a:pt x="905" y="531"/>
                    </a:lnTo>
                    <a:lnTo>
                      <a:pt x="908" y="535"/>
                    </a:lnTo>
                    <a:lnTo>
                      <a:pt x="911" y="539"/>
                    </a:lnTo>
                    <a:lnTo>
                      <a:pt x="914" y="543"/>
                    </a:lnTo>
                    <a:lnTo>
                      <a:pt x="914" y="543"/>
                    </a:lnTo>
                    <a:lnTo>
                      <a:pt x="917" y="546"/>
                    </a:lnTo>
                    <a:lnTo>
                      <a:pt x="917" y="546"/>
                    </a:lnTo>
                    <a:lnTo>
                      <a:pt x="920" y="551"/>
                    </a:lnTo>
                    <a:lnTo>
                      <a:pt x="922" y="555"/>
                    </a:lnTo>
                    <a:lnTo>
                      <a:pt x="925" y="558"/>
                    </a:lnTo>
                    <a:lnTo>
                      <a:pt x="925" y="558"/>
                    </a:lnTo>
                    <a:lnTo>
                      <a:pt x="928" y="562"/>
                    </a:lnTo>
                    <a:lnTo>
                      <a:pt x="931" y="566"/>
                    </a:lnTo>
                    <a:lnTo>
                      <a:pt x="934" y="570"/>
                    </a:lnTo>
                    <a:lnTo>
                      <a:pt x="937" y="573"/>
                    </a:lnTo>
                    <a:lnTo>
                      <a:pt x="940" y="577"/>
                    </a:lnTo>
                    <a:lnTo>
                      <a:pt x="940" y="577"/>
                    </a:lnTo>
                    <a:lnTo>
                      <a:pt x="942" y="580"/>
                    </a:lnTo>
                    <a:lnTo>
                      <a:pt x="942" y="580"/>
                    </a:lnTo>
                    <a:lnTo>
                      <a:pt x="944" y="585"/>
                    </a:lnTo>
                    <a:lnTo>
                      <a:pt x="947" y="588"/>
                    </a:lnTo>
                    <a:lnTo>
                      <a:pt x="950" y="592"/>
                    </a:lnTo>
                    <a:lnTo>
                      <a:pt x="953" y="596"/>
                    </a:lnTo>
                    <a:lnTo>
                      <a:pt x="955" y="601"/>
                    </a:lnTo>
                    <a:lnTo>
                      <a:pt x="955" y="601"/>
                    </a:lnTo>
                    <a:lnTo>
                      <a:pt x="958" y="603"/>
                    </a:lnTo>
                    <a:lnTo>
                      <a:pt x="961" y="607"/>
                    </a:lnTo>
                    <a:lnTo>
                      <a:pt x="964" y="610"/>
                    </a:lnTo>
                    <a:lnTo>
                      <a:pt x="964" y="610"/>
                    </a:lnTo>
                    <a:lnTo>
                      <a:pt x="967" y="613"/>
                    </a:lnTo>
                    <a:lnTo>
                      <a:pt x="967" y="613"/>
                    </a:lnTo>
                    <a:lnTo>
                      <a:pt x="970" y="617"/>
                    </a:lnTo>
                    <a:lnTo>
                      <a:pt x="973" y="620"/>
                    </a:lnTo>
                    <a:lnTo>
                      <a:pt x="975" y="623"/>
                    </a:lnTo>
                    <a:lnTo>
                      <a:pt x="975" y="623"/>
                    </a:lnTo>
                    <a:lnTo>
                      <a:pt x="978" y="627"/>
                    </a:lnTo>
                    <a:lnTo>
                      <a:pt x="981" y="629"/>
                    </a:lnTo>
                    <a:lnTo>
                      <a:pt x="984" y="632"/>
                    </a:lnTo>
                    <a:lnTo>
                      <a:pt x="984" y="632"/>
                    </a:lnTo>
                    <a:lnTo>
                      <a:pt x="987" y="636"/>
                    </a:lnTo>
                    <a:lnTo>
                      <a:pt x="990" y="639"/>
                    </a:lnTo>
                    <a:lnTo>
                      <a:pt x="993" y="642"/>
                    </a:lnTo>
                    <a:lnTo>
                      <a:pt x="998" y="647"/>
                    </a:lnTo>
                    <a:lnTo>
                      <a:pt x="1001" y="651"/>
                    </a:lnTo>
                    <a:lnTo>
                      <a:pt x="1007" y="657"/>
                    </a:lnTo>
                    <a:lnTo>
                      <a:pt x="1010" y="660"/>
                    </a:lnTo>
                    <a:lnTo>
                      <a:pt x="1016" y="665"/>
                    </a:lnTo>
                    <a:lnTo>
                      <a:pt x="1018" y="666"/>
                    </a:lnTo>
                    <a:lnTo>
                      <a:pt x="1024" y="672"/>
                    </a:lnTo>
                    <a:lnTo>
                      <a:pt x="1026" y="675"/>
                    </a:lnTo>
                    <a:lnTo>
                      <a:pt x="1026" y="675"/>
                    </a:lnTo>
                    <a:lnTo>
                      <a:pt x="1028" y="676"/>
                    </a:lnTo>
                    <a:lnTo>
                      <a:pt x="1034" y="680"/>
                    </a:lnTo>
                    <a:lnTo>
                      <a:pt x="1037" y="683"/>
                    </a:lnTo>
                    <a:lnTo>
                      <a:pt x="1043" y="686"/>
                    </a:lnTo>
                    <a:lnTo>
                      <a:pt x="1046" y="687"/>
                    </a:lnTo>
                    <a:lnTo>
                      <a:pt x="1051" y="690"/>
                    </a:lnTo>
                    <a:lnTo>
                      <a:pt x="1054" y="691"/>
                    </a:lnTo>
                    <a:lnTo>
                      <a:pt x="1060" y="694"/>
                    </a:lnTo>
                    <a:lnTo>
                      <a:pt x="1063" y="695"/>
                    </a:lnTo>
                    <a:lnTo>
                      <a:pt x="1067" y="697"/>
                    </a:lnTo>
                    <a:lnTo>
                      <a:pt x="1070" y="697"/>
                    </a:lnTo>
                    <a:lnTo>
                      <a:pt x="1076" y="698"/>
                    </a:lnTo>
                    <a:lnTo>
                      <a:pt x="1079" y="698"/>
                    </a:lnTo>
                    <a:lnTo>
                      <a:pt x="1084" y="698"/>
                    </a:lnTo>
                    <a:lnTo>
                      <a:pt x="1087" y="698"/>
                    </a:lnTo>
                    <a:lnTo>
                      <a:pt x="1093" y="697"/>
                    </a:lnTo>
                    <a:lnTo>
                      <a:pt x="1096" y="695"/>
                    </a:lnTo>
                    <a:lnTo>
                      <a:pt x="1101" y="695"/>
                    </a:lnTo>
                    <a:lnTo>
                      <a:pt x="1104" y="694"/>
                    </a:lnTo>
                    <a:lnTo>
                      <a:pt x="1111" y="691"/>
                    </a:lnTo>
                    <a:lnTo>
                      <a:pt x="1114" y="690"/>
                    </a:lnTo>
                    <a:lnTo>
                      <a:pt x="1120" y="688"/>
                    </a:lnTo>
                    <a:lnTo>
                      <a:pt x="1123" y="687"/>
                    </a:lnTo>
                    <a:lnTo>
                      <a:pt x="1129" y="686"/>
                    </a:lnTo>
                    <a:lnTo>
                      <a:pt x="1132" y="684"/>
                    </a:lnTo>
                    <a:lnTo>
                      <a:pt x="1134" y="683"/>
                    </a:lnTo>
                    <a:lnTo>
                      <a:pt x="1137" y="681"/>
                    </a:lnTo>
                    <a:lnTo>
                      <a:pt x="1137" y="681"/>
                    </a:lnTo>
                    <a:lnTo>
                      <a:pt x="1140" y="680"/>
                    </a:lnTo>
                    <a:lnTo>
                      <a:pt x="1146" y="677"/>
                    </a:lnTo>
                    <a:lnTo>
                      <a:pt x="1149" y="676"/>
                    </a:lnTo>
                    <a:lnTo>
                      <a:pt x="1150" y="675"/>
                    </a:lnTo>
                    <a:lnTo>
                      <a:pt x="1153" y="673"/>
                    </a:lnTo>
                    <a:lnTo>
                      <a:pt x="1153" y="673"/>
                    </a:lnTo>
                    <a:lnTo>
                      <a:pt x="1156" y="672"/>
                    </a:lnTo>
                    <a:lnTo>
                      <a:pt x="1162" y="668"/>
                    </a:lnTo>
                    <a:lnTo>
                      <a:pt x="1164" y="666"/>
                    </a:lnTo>
                    <a:lnTo>
                      <a:pt x="1164" y="666"/>
                    </a:lnTo>
                    <a:lnTo>
                      <a:pt x="1167" y="665"/>
                    </a:lnTo>
                    <a:lnTo>
                      <a:pt x="1170" y="664"/>
                    </a:lnTo>
                    <a:lnTo>
                      <a:pt x="1173" y="661"/>
                    </a:lnTo>
                    <a:lnTo>
                      <a:pt x="1179" y="658"/>
                    </a:lnTo>
                    <a:lnTo>
                      <a:pt x="1182" y="657"/>
                    </a:lnTo>
                    <a:lnTo>
                      <a:pt x="1187" y="653"/>
                    </a:lnTo>
                    <a:lnTo>
                      <a:pt x="1190" y="651"/>
                    </a:lnTo>
                    <a:lnTo>
                      <a:pt x="1192" y="650"/>
                    </a:lnTo>
                    <a:lnTo>
                      <a:pt x="1195" y="649"/>
                    </a:lnTo>
                    <a:lnTo>
                      <a:pt x="1197" y="647"/>
                    </a:lnTo>
                    <a:lnTo>
                      <a:pt x="1200" y="646"/>
                    </a:lnTo>
                    <a:lnTo>
                      <a:pt x="1206" y="642"/>
                    </a:lnTo>
                    <a:lnTo>
                      <a:pt x="1209" y="640"/>
                    </a:lnTo>
                    <a:lnTo>
                      <a:pt x="1215" y="638"/>
                    </a:lnTo>
                    <a:lnTo>
                      <a:pt x="1217" y="636"/>
                    </a:lnTo>
                    <a:lnTo>
                      <a:pt x="1223" y="633"/>
                    </a:lnTo>
                    <a:lnTo>
                      <a:pt x="1226" y="633"/>
                    </a:lnTo>
                    <a:lnTo>
                      <a:pt x="1226" y="633"/>
                    </a:lnTo>
                    <a:lnTo>
                      <a:pt x="1229" y="631"/>
                    </a:lnTo>
                    <a:lnTo>
                      <a:pt x="1232" y="631"/>
                    </a:lnTo>
                    <a:lnTo>
                      <a:pt x="1233" y="629"/>
                    </a:lnTo>
                    <a:lnTo>
                      <a:pt x="1239" y="628"/>
                    </a:lnTo>
                    <a:lnTo>
                      <a:pt x="1242" y="628"/>
                    </a:lnTo>
                    <a:lnTo>
                      <a:pt x="1248" y="627"/>
                    </a:lnTo>
                    <a:lnTo>
                      <a:pt x="1250" y="625"/>
                    </a:lnTo>
                    <a:lnTo>
                      <a:pt x="1256" y="625"/>
                    </a:lnTo>
                    <a:lnTo>
                      <a:pt x="1259" y="625"/>
                    </a:lnTo>
                    <a:lnTo>
                      <a:pt x="1265" y="625"/>
                    </a:lnTo>
                    <a:lnTo>
                      <a:pt x="1268" y="625"/>
                    </a:lnTo>
                    <a:lnTo>
                      <a:pt x="1275" y="627"/>
                    </a:lnTo>
                    <a:lnTo>
                      <a:pt x="1278" y="627"/>
                    </a:lnTo>
                    <a:lnTo>
                      <a:pt x="1283" y="627"/>
                    </a:lnTo>
                    <a:lnTo>
                      <a:pt x="1286" y="628"/>
                    </a:lnTo>
                    <a:lnTo>
                      <a:pt x="1292" y="628"/>
                    </a:lnTo>
                    <a:lnTo>
                      <a:pt x="1295" y="629"/>
                    </a:lnTo>
                    <a:lnTo>
                      <a:pt x="1301" y="631"/>
                    </a:lnTo>
                    <a:lnTo>
                      <a:pt x="1303" y="631"/>
                    </a:lnTo>
                    <a:lnTo>
                      <a:pt x="1309" y="632"/>
                    </a:lnTo>
                    <a:lnTo>
                      <a:pt x="1312" y="633"/>
                    </a:lnTo>
                    <a:lnTo>
                      <a:pt x="1316" y="636"/>
                    </a:lnTo>
                    <a:lnTo>
                      <a:pt x="1319" y="638"/>
                    </a:lnTo>
                    <a:lnTo>
                      <a:pt x="1325" y="640"/>
                    </a:lnTo>
                    <a:lnTo>
                      <a:pt x="1328" y="642"/>
                    </a:lnTo>
                    <a:lnTo>
                      <a:pt x="1333" y="644"/>
                    </a:lnTo>
                    <a:lnTo>
                      <a:pt x="1336" y="644"/>
                    </a:lnTo>
                    <a:lnTo>
                      <a:pt x="1342" y="649"/>
                    </a:lnTo>
                    <a:lnTo>
                      <a:pt x="1345" y="650"/>
                    </a:lnTo>
                    <a:lnTo>
                      <a:pt x="1351" y="654"/>
                    </a:lnTo>
                    <a:lnTo>
                      <a:pt x="1353" y="655"/>
                    </a:lnTo>
                    <a:lnTo>
                      <a:pt x="1356" y="657"/>
                    </a:lnTo>
                    <a:lnTo>
                      <a:pt x="1358" y="658"/>
                    </a:lnTo>
                    <a:lnTo>
                      <a:pt x="1361" y="660"/>
                    </a:lnTo>
                    <a:lnTo>
                      <a:pt x="1364" y="662"/>
                    </a:lnTo>
                    <a:lnTo>
                      <a:pt x="1369" y="665"/>
                    </a:lnTo>
                    <a:lnTo>
                      <a:pt x="1372" y="666"/>
                    </a:lnTo>
                    <a:lnTo>
                      <a:pt x="1378" y="669"/>
                    </a:lnTo>
                    <a:lnTo>
                      <a:pt x="1381" y="671"/>
                    </a:lnTo>
                    <a:lnTo>
                      <a:pt x="1384" y="673"/>
                    </a:lnTo>
                    <a:lnTo>
                      <a:pt x="1386" y="675"/>
                    </a:lnTo>
                    <a:lnTo>
                      <a:pt x="1386" y="675"/>
                    </a:lnTo>
                    <a:lnTo>
                      <a:pt x="1389" y="676"/>
                    </a:lnTo>
                    <a:lnTo>
                      <a:pt x="1395" y="679"/>
                    </a:lnTo>
                    <a:lnTo>
                      <a:pt x="1398" y="680"/>
                    </a:lnTo>
                    <a:lnTo>
                      <a:pt x="1399" y="681"/>
                    </a:lnTo>
                    <a:lnTo>
                      <a:pt x="1402" y="683"/>
                    </a:lnTo>
                    <a:lnTo>
                      <a:pt x="1402" y="683"/>
                    </a:lnTo>
                    <a:lnTo>
                      <a:pt x="1405" y="684"/>
                    </a:lnTo>
                    <a:lnTo>
                      <a:pt x="1411" y="688"/>
                    </a:lnTo>
                    <a:lnTo>
                      <a:pt x="1414" y="690"/>
                    </a:lnTo>
                    <a:lnTo>
                      <a:pt x="1414" y="690"/>
                    </a:lnTo>
                    <a:lnTo>
                      <a:pt x="1416" y="691"/>
                    </a:lnTo>
                    <a:lnTo>
                      <a:pt x="1419" y="692"/>
                    </a:lnTo>
                    <a:lnTo>
                      <a:pt x="1422" y="694"/>
                    </a:lnTo>
                    <a:lnTo>
                      <a:pt x="1428" y="697"/>
                    </a:lnTo>
                    <a:lnTo>
                      <a:pt x="1431" y="698"/>
                    </a:lnTo>
                    <a:lnTo>
                      <a:pt x="1431" y="698"/>
                    </a:lnTo>
                    <a:lnTo>
                      <a:pt x="1434" y="699"/>
                    </a:lnTo>
                    <a:lnTo>
                      <a:pt x="1437" y="701"/>
                    </a:lnTo>
                    <a:lnTo>
                      <a:pt x="1439" y="702"/>
                    </a:lnTo>
                    <a:lnTo>
                      <a:pt x="1447" y="706"/>
                    </a:lnTo>
                    <a:lnTo>
                      <a:pt x="1449" y="708"/>
                    </a:lnTo>
                    <a:lnTo>
                      <a:pt x="1455" y="710"/>
                    </a:lnTo>
                    <a:lnTo>
                      <a:pt x="1458" y="710"/>
                    </a:lnTo>
                    <a:lnTo>
                      <a:pt x="1464" y="713"/>
                    </a:lnTo>
                    <a:lnTo>
                      <a:pt x="1467" y="714"/>
                    </a:lnTo>
                    <a:lnTo>
                      <a:pt x="1467" y="714"/>
                    </a:lnTo>
                    <a:lnTo>
                      <a:pt x="1469" y="716"/>
                    </a:lnTo>
                    <a:lnTo>
                      <a:pt x="1472" y="717"/>
                    </a:lnTo>
                    <a:lnTo>
                      <a:pt x="1475" y="717"/>
                    </a:lnTo>
                    <a:lnTo>
                      <a:pt x="1481" y="720"/>
                    </a:lnTo>
                    <a:lnTo>
                      <a:pt x="1482" y="721"/>
                    </a:lnTo>
                    <a:lnTo>
                      <a:pt x="1488" y="723"/>
                    </a:lnTo>
                    <a:lnTo>
                      <a:pt x="1491" y="724"/>
                    </a:lnTo>
                    <a:lnTo>
                      <a:pt x="1497" y="725"/>
                    </a:lnTo>
                    <a:lnTo>
                      <a:pt x="1500" y="727"/>
                    </a:lnTo>
                    <a:lnTo>
                      <a:pt x="1505" y="728"/>
                    </a:lnTo>
                    <a:lnTo>
                      <a:pt x="1508" y="729"/>
                    </a:lnTo>
                    <a:lnTo>
                      <a:pt x="1514" y="731"/>
                    </a:lnTo>
                    <a:lnTo>
                      <a:pt x="1517" y="732"/>
                    </a:lnTo>
                    <a:lnTo>
                      <a:pt x="1524" y="735"/>
                    </a:lnTo>
                    <a:lnTo>
                      <a:pt x="1527" y="735"/>
                    </a:lnTo>
                    <a:lnTo>
                      <a:pt x="1532" y="736"/>
                    </a:lnTo>
                    <a:lnTo>
                      <a:pt x="1535" y="738"/>
                    </a:lnTo>
                    <a:lnTo>
                      <a:pt x="1541" y="738"/>
                    </a:lnTo>
                    <a:lnTo>
                      <a:pt x="1544" y="739"/>
                    </a:lnTo>
                    <a:lnTo>
                      <a:pt x="1547" y="739"/>
                    </a:lnTo>
                    <a:lnTo>
                      <a:pt x="1550" y="740"/>
                    </a:lnTo>
                    <a:lnTo>
                      <a:pt x="1550" y="740"/>
                    </a:lnTo>
                    <a:lnTo>
                      <a:pt x="1553" y="740"/>
                    </a:lnTo>
                    <a:lnTo>
                      <a:pt x="1558" y="742"/>
                    </a:lnTo>
                    <a:lnTo>
                      <a:pt x="1561" y="743"/>
                    </a:lnTo>
                    <a:lnTo>
                      <a:pt x="1565" y="743"/>
                    </a:lnTo>
                    <a:lnTo>
                      <a:pt x="1568" y="745"/>
                    </a:lnTo>
                    <a:lnTo>
                      <a:pt x="1574" y="745"/>
                    </a:lnTo>
                    <a:lnTo>
                      <a:pt x="1577" y="745"/>
                    </a:lnTo>
                    <a:lnTo>
                      <a:pt x="1583" y="746"/>
                    </a:lnTo>
                    <a:lnTo>
                      <a:pt x="1585" y="746"/>
                    </a:lnTo>
                    <a:lnTo>
                      <a:pt x="1591" y="747"/>
                    </a:lnTo>
                    <a:lnTo>
                      <a:pt x="1594" y="747"/>
                    </a:lnTo>
                    <a:lnTo>
                      <a:pt x="1600" y="747"/>
                    </a:lnTo>
                    <a:lnTo>
                      <a:pt x="1603" y="747"/>
                    </a:lnTo>
                    <a:lnTo>
                      <a:pt x="1603" y="747"/>
                    </a:lnTo>
                    <a:lnTo>
                      <a:pt x="1606" y="749"/>
                    </a:lnTo>
                    <a:lnTo>
                      <a:pt x="1610" y="749"/>
                    </a:lnTo>
                    <a:lnTo>
                      <a:pt x="1613" y="749"/>
                    </a:lnTo>
                    <a:lnTo>
                      <a:pt x="1618" y="749"/>
                    </a:lnTo>
                    <a:lnTo>
                      <a:pt x="1621" y="749"/>
                    </a:lnTo>
                    <a:lnTo>
                      <a:pt x="1627" y="750"/>
                    </a:lnTo>
                    <a:lnTo>
                      <a:pt x="1630" y="750"/>
                    </a:lnTo>
                    <a:lnTo>
                      <a:pt x="1636" y="751"/>
                    </a:lnTo>
                    <a:lnTo>
                      <a:pt x="1638" y="751"/>
                    </a:lnTo>
                    <a:lnTo>
                      <a:pt x="1644" y="751"/>
                    </a:lnTo>
                    <a:lnTo>
                      <a:pt x="1647" y="751"/>
                    </a:lnTo>
                    <a:lnTo>
                      <a:pt x="1651" y="751"/>
                    </a:lnTo>
                    <a:lnTo>
                      <a:pt x="1654" y="751"/>
                    </a:lnTo>
                    <a:lnTo>
                      <a:pt x="1660" y="751"/>
                    </a:lnTo>
                    <a:lnTo>
                      <a:pt x="1663" y="751"/>
                    </a:lnTo>
                    <a:lnTo>
                      <a:pt x="1669" y="753"/>
                    </a:lnTo>
                    <a:lnTo>
                      <a:pt x="1671" y="753"/>
                    </a:lnTo>
                    <a:lnTo>
                      <a:pt x="1677" y="753"/>
                    </a:lnTo>
                    <a:lnTo>
                      <a:pt x="1680" y="753"/>
                    </a:lnTo>
                    <a:lnTo>
                      <a:pt x="1686" y="753"/>
                    </a:lnTo>
                    <a:lnTo>
                      <a:pt x="1689" y="753"/>
                    </a:lnTo>
                    <a:lnTo>
                      <a:pt x="1696" y="754"/>
                    </a:lnTo>
                    <a:lnTo>
                      <a:pt x="1699" y="754"/>
                    </a:lnTo>
                    <a:lnTo>
                      <a:pt x="1704" y="756"/>
                    </a:lnTo>
                    <a:lnTo>
                      <a:pt x="1707" y="756"/>
                    </a:lnTo>
                    <a:lnTo>
                      <a:pt x="1707" y="756"/>
                    </a:lnTo>
                    <a:lnTo>
                      <a:pt x="1710" y="757"/>
                    </a:lnTo>
                    <a:lnTo>
                      <a:pt x="1713" y="757"/>
                    </a:lnTo>
                    <a:lnTo>
                      <a:pt x="1716" y="757"/>
                    </a:lnTo>
                    <a:lnTo>
                      <a:pt x="1722" y="758"/>
                    </a:lnTo>
                    <a:lnTo>
                      <a:pt x="1724" y="757"/>
                    </a:lnTo>
                    <a:lnTo>
                      <a:pt x="1730" y="758"/>
                    </a:lnTo>
                    <a:lnTo>
                      <a:pt x="1732" y="758"/>
                    </a:lnTo>
                    <a:lnTo>
                      <a:pt x="1737" y="758"/>
                    </a:lnTo>
                    <a:lnTo>
                      <a:pt x="1740" y="758"/>
                    </a:lnTo>
                    <a:lnTo>
                      <a:pt x="1746" y="758"/>
                    </a:lnTo>
                    <a:lnTo>
                      <a:pt x="1749" y="758"/>
                    </a:lnTo>
                    <a:lnTo>
                      <a:pt x="1754" y="760"/>
                    </a:lnTo>
                    <a:lnTo>
                      <a:pt x="1757" y="760"/>
                    </a:lnTo>
                    <a:lnTo>
                      <a:pt x="1763" y="760"/>
                    </a:lnTo>
                    <a:lnTo>
                      <a:pt x="1766" y="760"/>
                    </a:lnTo>
                    <a:lnTo>
                      <a:pt x="1773" y="761"/>
                    </a:lnTo>
                    <a:lnTo>
                      <a:pt x="1776" y="761"/>
                    </a:lnTo>
                    <a:lnTo>
                      <a:pt x="1782" y="762"/>
                    </a:lnTo>
                    <a:lnTo>
                      <a:pt x="1785" y="762"/>
                    </a:lnTo>
                    <a:lnTo>
                      <a:pt x="1790" y="764"/>
                    </a:lnTo>
                    <a:lnTo>
                      <a:pt x="1793" y="764"/>
                    </a:lnTo>
                    <a:lnTo>
                      <a:pt x="1799" y="764"/>
                    </a:lnTo>
                    <a:lnTo>
                      <a:pt x="1802" y="765"/>
                    </a:lnTo>
                    <a:lnTo>
                      <a:pt x="1807" y="765"/>
                    </a:lnTo>
                    <a:lnTo>
                      <a:pt x="1810" y="765"/>
                    </a:lnTo>
                    <a:lnTo>
                      <a:pt x="1815" y="767"/>
                    </a:lnTo>
                    <a:lnTo>
                      <a:pt x="1817" y="767"/>
                    </a:lnTo>
                    <a:lnTo>
                      <a:pt x="1823" y="768"/>
                    </a:lnTo>
                    <a:lnTo>
                      <a:pt x="1826" y="768"/>
                    </a:lnTo>
                    <a:lnTo>
                      <a:pt x="1832" y="769"/>
                    </a:lnTo>
                    <a:lnTo>
                      <a:pt x="1835" y="769"/>
                    </a:lnTo>
                    <a:lnTo>
                      <a:pt x="1840" y="771"/>
                    </a:lnTo>
                    <a:lnTo>
                      <a:pt x="1843" y="772"/>
                    </a:lnTo>
                    <a:lnTo>
                      <a:pt x="1846" y="772"/>
                    </a:lnTo>
                    <a:lnTo>
                      <a:pt x="1849" y="773"/>
                    </a:lnTo>
                    <a:lnTo>
                      <a:pt x="1849" y="773"/>
                    </a:lnTo>
                    <a:lnTo>
                      <a:pt x="1852" y="773"/>
                    </a:lnTo>
                    <a:lnTo>
                      <a:pt x="1859" y="775"/>
                    </a:lnTo>
                    <a:lnTo>
                      <a:pt x="1862" y="776"/>
                    </a:lnTo>
                    <a:lnTo>
                      <a:pt x="1868" y="776"/>
                    </a:lnTo>
                    <a:lnTo>
                      <a:pt x="1870" y="791"/>
                    </a:lnTo>
                    <a:lnTo>
                      <a:pt x="1873" y="791"/>
                    </a:lnTo>
                    <a:lnTo>
                      <a:pt x="1876" y="809"/>
                    </a:lnTo>
                    <a:lnTo>
                      <a:pt x="1876" y="809"/>
                    </a:lnTo>
                    <a:lnTo>
                      <a:pt x="1879" y="809"/>
                    </a:lnTo>
                    <a:lnTo>
                      <a:pt x="1885" y="810"/>
                    </a:lnTo>
                    <a:lnTo>
                      <a:pt x="1888" y="810"/>
                    </a:lnTo>
                    <a:lnTo>
                      <a:pt x="1893" y="812"/>
                    </a:lnTo>
                    <a:lnTo>
                      <a:pt x="1896" y="812"/>
                    </a:lnTo>
                    <a:lnTo>
                      <a:pt x="1901" y="812"/>
                    </a:lnTo>
                    <a:lnTo>
                      <a:pt x="1903" y="812"/>
                    </a:lnTo>
                    <a:lnTo>
                      <a:pt x="1909" y="813"/>
                    </a:lnTo>
                    <a:lnTo>
                      <a:pt x="1912" y="813"/>
                    </a:lnTo>
                    <a:lnTo>
                      <a:pt x="1915" y="813"/>
                    </a:lnTo>
                    <a:lnTo>
                      <a:pt x="1918" y="815"/>
                    </a:lnTo>
                    <a:lnTo>
                      <a:pt x="1918" y="815"/>
                    </a:lnTo>
                    <a:lnTo>
                      <a:pt x="1921" y="815"/>
                    </a:lnTo>
                    <a:lnTo>
                      <a:pt x="1926" y="816"/>
                    </a:lnTo>
                    <a:lnTo>
                      <a:pt x="1929" y="816"/>
                    </a:lnTo>
                    <a:lnTo>
                      <a:pt x="1935" y="817"/>
                    </a:lnTo>
                    <a:lnTo>
                      <a:pt x="1938" y="817"/>
                    </a:lnTo>
                    <a:lnTo>
                      <a:pt x="1945" y="819"/>
                    </a:lnTo>
                    <a:lnTo>
                      <a:pt x="1948" y="819"/>
                    </a:lnTo>
                    <a:lnTo>
                      <a:pt x="1954" y="820"/>
                    </a:lnTo>
                    <a:lnTo>
                      <a:pt x="1956" y="820"/>
                    </a:lnTo>
                    <a:lnTo>
                      <a:pt x="1962" y="820"/>
                    </a:lnTo>
                    <a:lnTo>
                      <a:pt x="1965" y="820"/>
                    </a:lnTo>
                    <a:lnTo>
                      <a:pt x="1971" y="821"/>
                    </a:lnTo>
                    <a:lnTo>
                      <a:pt x="1974" y="821"/>
                    </a:lnTo>
                    <a:lnTo>
                      <a:pt x="1976" y="821"/>
                    </a:lnTo>
                    <a:lnTo>
                      <a:pt x="1979" y="823"/>
                    </a:lnTo>
                    <a:lnTo>
                      <a:pt x="1979" y="823"/>
                    </a:lnTo>
                    <a:lnTo>
                      <a:pt x="1981" y="823"/>
                    </a:lnTo>
                  </a:path>
                </a:pathLst>
              </a:custGeom>
              <a:noFill/>
              <a:ln w="14288">
                <a:solidFill>
                  <a:srgbClr val="C00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Freeform 97">
                <a:extLst>
                  <a:ext uri="{FF2B5EF4-FFF2-40B4-BE49-F238E27FC236}">
                    <a16:creationId xmlns:a16="http://schemas.microsoft.com/office/drawing/2014/main" id="{35BB438C-8177-4103-BD3D-C065FC818EC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19563" y="1697038"/>
                <a:ext cx="1573213" cy="365125"/>
              </a:xfrm>
              <a:custGeom>
                <a:avLst/>
                <a:gdLst>
                  <a:gd name="T0" fmla="*/ 17 w 1982"/>
                  <a:gd name="T1" fmla="*/ 26 h 460"/>
                  <a:gd name="T2" fmla="*/ 39 w 1982"/>
                  <a:gd name="T3" fmla="*/ 81 h 460"/>
                  <a:gd name="T4" fmla="*/ 62 w 1982"/>
                  <a:gd name="T5" fmla="*/ 133 h 460"/>
                  <a:gd name="T6" fmla="*/ 78 w 1982"/>
                  <a:gd name="T7" fmla="*/ 176 h 460"/>
                  <a:gd name="T8" fmla="*/ 98 w 1982"/>
                  <a:gd name="T9" fmla="*/ 221 h 460"/>
                  <a:gd name="T10" fmla="*/ 113 w 1982"/>
                  <a:gd name="T11" fmla="*/ 266 h 460"/>
                  <a:gd name="T12" fmla="*/ 136 w 1982"/>
                  <a:gd name="T13" fmla="*/ 317 h 460"/>
                  <a:gd name="T14" fmla="*/ 161 w 1982"/>
                  <a:gd name="T15" fmla="*/ 357 h 460"/>
                  <a:gd name="T16" fmla="*/ 186 w 1982"/>
                  <a:gd name="T17" fmla="*/ 383 h 460"/>
                  <a:gd name="T18" fmla="*/ 228 w 1982"/>
                  <a:gd name="T19" fmla="*/ 382 h 460"/>
                  <a:gd name="T20" fmla="*/ 252 w 1982"/>
                  <a:gd name="T21" fmla="*/ 344 h 460"/>
                  <a:gd name="T22" fmla="*/ 269 w 1982"/>
                  <a:gd name="T23" fmla="*/ 312 h 460"/>
                  <a:gd name="T24" fmla="*/ 288 w 1982"/>
                  <a:gd name="T25" fmla="*/ 258 h 460"/>
                  <a:gd name="T26" fmla="*/ 305 w 1982"/>
                  <a:gd name="T27" fmla="*/ 205 h 460"/>
                  <a:gd name="T28" fmla="*/ 321 w 1982"/>
                  <a:gd name="T29" fmla="*/ 157 h 460"/>
                  <a:gd name="T30" fmla="*/ 347 w 1982"/>
                  <a:gd name="T31" fmla="*/ 106 h 460"/>
                  <a:gd name="T32" fmla="*/ 385 w 1982"/>
                  <a:gd name="T33" fmla="*/ 110 h 460"/>
                  <a:gd name="T34" fmla="*/ 410 w 1982"/>
                  <a:gd name="T35" fmla="*/ 147 h 460"/>
                  <a:gd name="T36" fmla="*/ 436 w 1982"/>
                  <a:gd name="T37" fmla="*/ 189 h 460"/>
                  <a:gd name="T38" fmla="*/ 451 w 1982"/>
                  <a:gd name="T39" fmla="*/ 221 h 460"/>
                  <a:gd name="T40" fmla="*/ 471 w 1982"/>
                  <a:gd name="T41" fmla="*/ 258 h 460"/>
                  <a:gd name="T42" fmla="*/ 501 w 1982"/>
                  <a:gd name="T43" fmla="*/ 310 h 460"/>
                  <a:gd name="T44" fmla="*/ 529 w 1982"/>
                  <a:gd name="T45" fmla="*/ 349 h 460"/>
                  <a:gd name="T46" fmla="*/ 560 w 1982"/>
                  <a:gd name="T47" fmla="*/ 380 h 460"/>
                  <a:gd name="T48" fmla="*/ 590 w 1982"/>
                  <a:gd name="T49" fmla="*/ 406 h 460"/>
                  <a:gd name="T50" fmla="*/ 623 w 1982"/>
                  <a:gd name="T51" fmla="*/ 423 h 460"/>
                  <a:gd name="T52" fmla="*/ 668 w 1982"/>
                  <a:gd name="T53" fmla="*/ 417 h 460"/>
                  <a:gd name="T54" fmla="*/ 709 w 1982"/>
                  <a:gd name="T55" fmla="*/ 386 h 460"/>
                  <a:gd name="T56" fmla="*/ 745 w 1982"/>
                  <a:gd name="T57" fmla="*/ 342 h 460"/>
                  <a:gd name="T58" fmla="*/ 771 w 1982"/>
                  <a:gd name="T59" fmla="*/ 317 h 460"/>
                  <a:gd name="T60" fmla="*/ 804 w 1982"/>
                  <a:gd name="T61" fmla="*/ 307 h 460"/>
                  <a:gd name="T62" fmla="*/ 834 w 1982"/>
                  <a:gd name="T63" fmla="*/ 305 h 460"/>
                  <a:gd name="T64" fmla="*/ 872 w 1982"/>
                  <a:gd name="T65" fmla="*/ 302 h 460"/>
                  <a:gd name="T66" fmla="*/ 908 w 1982"/>
                  <a:gd name="T67" fmla="*/ 318 h 460"/>
                  <a:gd name="T68" fmla="*/ 942 w 1982"/>
                  <a:gd name="T69" fmla="*/ 342 h 460"/>
                  <a:gd name="T70" fmla="*/ 981 w 1982"/>
                  <a:gd name="T71" fmla="*/ 364 h 460"/>
                  <a:gd name="T72" fmla="*/ 1028 w 1982"/>
                  <a:gd name="T73" fmla="*/ 377 h 460"/>
                  <a:gd name="T74" fmla="*/ 1070 w 1982"/>
                  <a:gd name="T75" fmla="*/ 373 h 460"/>
                  <a:gd name="T76" fmla="*/ 1104 w 1982"/>
                  <a:gd name="T77" fmla="*/ 357 h 460"/>
                  <a:gd name="T78" fmla="*/ 1140 w 1982"/>
                  <a:gd name="T79" fmla="*/ 336 h 460"/>
                  <a:gd name="T80" fmla="*/ 1179 w 1982"/>
                  <a:gd name="T81" fmla="*/ 313 h 460"/>
                  <a:gd name="T82" fmla="*/ 1220 w 1982"/>
                  <a:gd name="T83" fmla="*/ 316 h 460"/>
                  <a:gd name="T84" fmla="*/ 1259 w 1982"/>
                  <a:gd name="T85" fmla="*/ 306 h 460"/>
                  <a:gd name="T86" fmla="*/ 1303 w 1982"/>
                  <a:gd name="T87" fmla="*/ 323 h 460"/>
                  <a:gd name="T88" fmla="*/ 1345 w 1982"/>
                  <a:gd name="T89" fmla="*/ 346 h 460"/>
                  <a:gd name="T90" fmla="*/ 1381 w 1982"/>
                  <a:gd name="T91" fmla="*/ 357 h 460"/>
                  <a:gd name="T92" fmla="*/ 1422 w 1982"/>
                  <a:gd name="T93" fmla="*/ 379 h 460"/>
                  <a:gd name="T94" fmla="*/ 1461 w 1982"/>
                  <a:gd name="T95" fmla="*/ 388 h 460"/>
                  <a:gd name="T96" fmla="*/ 1500 w 1982"/>
                  <a:gd name="T97" fmla="*/ 399 h 460"/>
                  <a:gd name="T98" fmla="*/ 1544 w 1982"/>
                  <a:gd name="T99" fmla="*/ 409 h 460"/>
                  <a:gd name="T100" fmla="*/ 1585 w 1982"/>
                  <a:gd name="T101" fmla="*/ 416 h 460"/>
                  <a:gd name="T102" fmla="*/ 1633 w 1982"/>
                  <a:gd name="T103" fmla="*/ 421 h 460"/>
                  <a:gd name="T104" fmla="*/ 1680 w 1982"/>
                  <a:gd name="T105" fmla="*/ 427 h 460"/>
                  <a:gd name="T106" fmla="*/ 1724 w 1982"/>
                  <a:gd name="T107" fmla="*/ 432 h 460"/>
                  <a:gd name="T108" fmla="*/ 1766 w 1982"/>
                  <a:gd name="T109" fmla="*/ 438 h 460"/>
                  <a:gd name="T110" fmla="*/ 1817 w 1982"/>
                  <a:gd name="T111" fmla="*/ 445 h 460"/>
                  <a:gd name="T112" fmla="*/ 1862 w 1982"/>
                  <a:gd name="T113" fmla="*/ 450 h 460"/>
                  <a:gd name="T114" fmla="*/ 1903 w 1982"/>
                  <a:gd name="T115" fmla="*/ 454 h 460"/>
                  <a:gd name="T116" fmla="*/ 1938 w 1982"/>
                  <a:gd name="T117" fmla="*/ 458 h 460"/>
                  <a:gd name="T118" fmla="*/ 1982 w 1982"/>
                  <a:gd name="T119" fmla="*/ 446 h 4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</a:cxnLst>
                <a:rect l="0" t="0" r="r" b="b"/>
                <a:pathLst>
                  <a:path w="1982" h="460">
                    <a:moveTo>
                      <a:pt x="0" y="0"/>
                    </a:moveTo>
                    <a:lnTo>
                      <a:pt x="0" y="0"/>
                    </a:lnTo>
                    <a:lnTo>
                      <a:pt x="0" y="0"/>
                    </a:lnTo>
                    <a:lnTo>
                      <a:pt x="3" y="4"/>
                    </a:lnTo>
                    <a:lnTo>
                      <a:pt x="3" y="4"/>
                    </a:lnTo>
                    <a:lnTo>
                      <a:pt x="6" y="8"/>
                    </a:lnTo>
                    <a:lnTo>
                      <a:pt x="6" y="8"/>
                    </a:lnTo>
                    <a:lnTo>
                      <a:pt x="9" y="13"/>
                    </a:lnTo>
                    <a:lnTo>
                      <a:pt x="12" y="17"/>
                    </a:lnTo>
                    <a:lnTo>
                      <a:pt x="15" y="21"/>
                    </a:lnTo>
                    <a:lnTo>
                      <a:pt x="15" y="21"/>
                    </a:lnTo>
                    <a:lnTo>
                      <a:pt x="17" y="26"/>
                    </a:lnTo>
                    <a:lnTo>
                      <a:pt x="20" y="32"/>
                    </a:lnTo>
                    <a:lnTo>
                      <a:pt x="23" y="37"/>
                    </a:lnTo>
                    <a:lnTo>
                      <a:pt x="26" y="41"/>
                    </a:lnTo>
                    <a:lnTo>
                      <a:pt x="29" y="48"/>
                    </a:lnTo>
                    <a:lnTo>
                      <a:pt x="29" y="48"/>
                    </a:lnTo>
                    <a:lnTo>
                      <a:pt x="30" y="63"/>
                    </a:lnTo>
                    <a:lnTo>
                      <a:pt x="30" y="63"/>
                    </a:lnTo>
                    <a:lnTo>
                      <a:pt x="33" y="69"/>
                    </a:lnTo>
                    <a:lnTo>
                      <a:pt x="33" y="69"/>
                    </a:lnTo>
                    <a:lnTo>
                      <a:pt x="36" y="76"/>
                    </a:lnTo>
                    <a:lnTo>
                      <a:pt x="36" y="76"/>
                    </a:lnTo>
                    <a:lnTo>
                      <a:pt x="39" y="81"/>
                    </a:lnTo>
                    <a:lnTo>
                      <a:pt x="39" y="81"/>
                    </a:lnTo>
                    <a:lnTo>
                      <a:pt x="42" y="87"/>
                    </a:lnTo>
                    <a:lnTo>
                      <a:pt x="42" y="87"/>
                    </a:lnTo>
                    <a:lnTo>
                      <a:pt x="45" y="93"/>
                    </a:lnTo>
                    <a:lnTo>
                      <a:pt x="45" y="93"/>
                    </a:lnTo>
                    <a:lnTo>
                      <a:pt x="47" y="100"/>
                    </a:lnTo>
                    <a:lnTo>
                      <a:pt x="50" y="106"/>
                    </a:lnTo>
                    <a:lnTo>
                      <a:pt x="53" y="113"/>
                    </a:lnTo>
                    <a:lnTo>
                      <a:pt x="53" y="113"/>
                    </a:lnTo>
                    <a:lnTo>
                      <a:pt x="56" y="126"/>
                    </a:lnTo>
                    <a:lnTo>
                      <a:pt x="59" y="126"/>
                    </a:lnTo>
                    <a:lnTo>
                      <a:pt x="62" y="133"/>
                    </a:lnTo>
                    <a:lnTo>
                      <a:pt x="62" y="133"/>
                    </a:lnTo>
                    <a:lnTo>
                      <a:pt x="65" y="140"/>
                    </a:lnTo>
                    <a:lnTo>
                      <a:pt x="65" y="140"/>
                    </a:lnTo>
                    <a:lnTo>
                      <a:pt x="68" y="148"/>
                    </a:lnTo>
                    <a:lnTo>
                      <a:pt x="68" y="148"/>
                    </a:lnTo>
                    <a:lnTo>
                      <a:pt x="70" y="155"/>
                    </a:lnTo>
                    <a:lnTo>
                      <a:pt x="70" y="155"/>
                    </a:lnTo>
                    <a:lnTo>
                      <a:pt x="72" y="162"/>
                    </a:lnTo>
                    <a:lnTo>
                      <a:pt x="72" y="162"/>
                    </a:lnTo>
                    <a:lnTo>
                      <a:pt x="75" y="169"/>
                    </a:lnTo>
                    <a:lnTo>
                      <a:pt x="75" y="169"/>
                    </a:lnTo>
                    <a:lnTo>
                      <a:pt x="78" y="176"/>
                    </a:lnTo>
                    <a:lnTo>
                      <a:pt x="78" y="176"/>
                    </a:lnTo>
                    <a:lnTo>
                      <a:pt x="80" y="184"/>
                    </a:lnTo>
                    <a:lnTo>
                      <a:pt x="80" y="184"/>
                    </a:lnTo>
                    <a:lnTo>
                      <a:pt x="83" y="191"/>
                    </a:lnTo>
                    <a:lnTo>
                      <a:pt x="86" y="191"/>
                    </a:lnTo>
                    <a:lnTo>
                      <a:pt x="89" y="199"/>
                    </a:lnTo>
                    <a:lnTo>
                      <a:pt x="89" y="199"/>
                    </a:lnTo>
                    <a:lnTo>
                      <a:pt x="92" y="206"/>
                    </a:lnTo>
                    <a:lnTo>
                      <a:pt x="92" y="206"/>
                    </a:lnTo>
                    <a:lnTo>
                      <a:pt x="95" y="214"/>
                    </a:lnTo>
                    <a:lnTo>
                      <a:pt x="95" y="214"/>
                    </a:lnTo>
                    <a:lnTo>
                      <a:pt x="98" y="221"/>
                    </a:lnTo>
                    <a:lnTo>
                      <a:pt x="98" y="221"/>
                    </a:lnTo>
                    <a:lnTo>
                      <a:pt x="100" y="229"/>
                    </a:lnTo>
                    <a:lnTo>
                      <a:pt x="100" y="229"/>
                    </a:lnTo>
                    <a:lnTo>
                      <a:pt x="103" y="236"/>
                    </a:lnTo>
                    <a:lnTo>
                      <a:pt x="103" y="236"/>
                    </a:lnTo>
                    <a:lnTo>
                      <a:pt x="106" y="244"/>
                    </a:lnTo>
                    <a:lnTo>
                      <a:pt x="106" y="244"/>
                    </a:lnTo>
                    <a:lnTo>
                      <a:pt x="109" y="251"/>
                    </a:lnTo>
                    <a:lnTo>
                      <a:pt x="109" y="251"/>
                    </a:lnTo>
                    <a:lnTo>
                      <a:pt x="112" y="258"/>
                    </a:lnTo>
                    <a:lnTo>
                      <a:pt x="112" y="258"/>
                    </a:lnTo>
                    <a:lnTo>
                      <a:pt x="113" y="266"/>
                    </a:lnTo>
                    <a:lnTo>
                      <a:pt x="113" y="266"/>
                    </a:lnTo>
                    <a:lnTo>
                      <a:pt x="116" y="273"/>
                    </a:lnTo>
                    <a:lnTo>
                      <a:pt x="119" y="280"/>
                    </a:lnTo>
                    <a:lnTo>
                      <a:pt x="122" y="287"/>
                    </a:lnTo>
                    <a:lnTo>
                      <a:pt x="122" y="287"/>
                    </a:lnTo>
                    <a:lnTo>
                      <a:pt x="125" y="292"/>
                    </a:lnTo>
                    <a:lnTo>
                      <a:pt x="125" y="292"/>
                    </a:lnTo>
                    <a:lnTo>
                      <a:pt x="128" y="299"/>
                    </a:lnTo>
                    <a:lnTo>
                      <a:pt x="131" y="305"/>
                    </a:lnTo>
                    <a:lnTo>
                      <a:pt x="133" y="312"/>
                    </a:lnTo>
                    <a:lnTo>
                      <a:pt x="133" y="312"/>
                    </a:lnTo>
                    <a:lnTo>
                      <a:pt x="136" y="317"/>
                    </a:lnTo>
                    <a:lnTo>
                      <a:pt x="136" y="317"/>
                    </a:lnTo>
                    <a:lnTo>
                      <a:pt x="139" y="323"/>
                    </a:lnTo>
                    <a:lnTo>
                      <a:pt x="139" y="323"/>
                    </a:lnTo>
                    <a:lnTo>
                      <a:pt x="142" y="327"/>
                    </a:lnTo>
                    <a:lnTo>
                      <a:pt x="142" y="327"/>
                    </a:lnTo>
                    <a:lnTo>
                      <a:pt x="145" y="332"/>
                    </a:lnTo>
                    <a:lnTo>
                      <a:pt x="148" y="338"/>
                    </a:lnTo>
                    <a:lnTo>
                      <a:pt x="151" y="340"/>
                    </a:lnTo>
                    <a:lnTo>
                      <a:pt x="153" y="346"/>
                    </a:lnTo>
                    <a:lnTo>
                      <a:pt x="155" y="350"/>
                    </a:lnTo>
                    <a:lnTo>
                      <a:pt x="158" y="354"/>
                    </a:lnTo>
                    <a:lnTo>
                      <a:pt x="161" y="357"/>
                    </a:lnTo>
                    <a:lnTo>
                      <a:pt x="163" y="361"/>
                    </a:lnTo>
                    <a:lnTo>
                      <a:pt x="166" y="364"/>
                    </a:lnTo>
                    <a:lnTo>
                      <a:pt x="166" y="364"/>
                    </a:lnTo>
                    <a:lnTo>
                      <a:pt x="169" y="366"/>
                    </a:lnTo>
                    <a:lnTo>
                      <a:pt x="172" y="369"/>
                    </a:lnTo>
                    <a:lnTo>
                      <a:pt x="175" y="372"/>
                    </a:lnTo>
                    <a:lnTo>
                      <a:pt x="175" y="372"/>
                    </a:lnTo>
                    <a:lnTo>
                      <a:pt x="178" y="373"/>
                    </a:lnTo>
                    <a:lnTo>
                      <a:pt x="181" y="376"/>
                    </a:lnTo>
                    <a:lnTo>
                      <a:pt x="184" y="380"/>
                    </a:lnTo>
                    <a:lnTo>
                      <a:pt x="184" y="380"/>
                    </a:lnTo>
                    <a:lnTo>
                      <a:pt x="186" y="383"/>
                    </a:lnTo>
                    <a:lnTo>
                      <a:pt x="189" y="384"/>
                    </a:lnTo>
                    <a:lnTo>
                      <a:pt x="192" y="388"/>
                    </a:lnTo>
                    <a:lnTo>
                      <a:pt x="192" y="388"/>
                    </a:lnTo>
                    <a:lnTo>
                      <a:pt x="195" y="390"/>
                    </a:lnTo>
                    <a:lnTo>
                      <a:pt x="199" y="390"/>
                    </a:lnTo>
                    <a:lnTo>
                      <a:pt x="202" y="391"/>
                    </a:lnTo>
                    <a:lnTo>
                      <a:pt x="208" y="394"/>
                    </a:lnTo>
                    <a:lnTo>
                      <a:pt x="211" y="390"/>
                    </a:lnTo>
                    <a:lnTo>
                      <a:pt x="216" y="391"/>
                    </a:lnTo>
                    <a:lnTo>
                      <a:pt x="219" y="387"/>
                    </a:lnTo>
                    <a:lnTo>
                      <a:pt x="225" y="383"/>
                    </a:lnTo>
                    <a:lnTo>
                      <a:pt x="228" y="382"/>
                    </a:lnTo>
                    <a:lnTo>
                      <a:pt x="228" y="382"/>
                    </a:lnTo>
                    <a:lnTo>
                      <a:pt x="231" y="379"/>
                    </a:lnTo>
                    <a:lnTo>
                      <a:pt x="234" y="376"/>
                    </a:lnTo>
                    <a:lnTo>
                      <a:pt x="236" y="373"/>
                    </a:lnTo>
                    <a:lnTo>
                      <a:pt x="236" y="373"/>
                    </a:lnTo>
                    <a:lnTo>
                      <a:pt x="238" y="368"/>
                    </a:lnTo>
                    <a:lnTo>
                      <a:pt x="241" y="365"/>
                    </a:lnTo>
                    <a:lnTo>
                      <a:pt x="244" y="361"/>
                    </a:lnTo>
                    <a:lnTo>
                      <a:pt x="244" y="361"/>
                    </a:lnTo>
                    <a:lnTo>
                      <a:pt x="247" y="354"/>
                    </a:lnTo>
                    <a:lnTo>
                      <a:pt x="249" y="350"/>
                    </a:lnTo>
                    <a:lnTo>
                      <a:pt x="252" y="344"/>
                    </a:lnTo>
                    <a:lnTo>
                      <a:pt x="252" y="344"/>
                    </a:lnTo>
                    <a:lnTo>
                      <a:pt x="255" y="340"/>
                    </a:lnTo>
                    <a:lnTo>
                      <a:pt x="255" y="340"/>
                    </a:lnTo>
                    <a:lnTo>
                      <a:pt x="258" y="335"/>
                    </a:lnTo>
                    <a:lnTo>
                      <a:pt x="258" y="335"/>
                    </a:lnTo>
                    <a:lnTo>
                      <a:pt x="261" y="329"/>
                    </a:lnTo>
                    <a:lnTo>
                      <a:pt x="261" y="329"/>
                    </a:lnTo>
                    <a:lnTo>
                      <a:pt x="264" y="324"/>
                    </a:lnTo>
                    <a:lnTo>
                      <a:pt x="264" y="324"/>
                    </a:lnTo>
                    <a:lnTo>
                      <a:pt x="267" y="318"/>
                    </a:lnTo>
                    <a:lnTo>
                      <a:pt x="267" y="318"/>
                    </a:lnTo>
                    <a:lnTo>
                      <a:pt x="269" y="312"/>
                    </a:lnTo>
                    <a:lnTo>
                      <a:pt x="269" y="312"/>
                    </a:lnTo>
                    <a:lnTo>
                      <a:pt x="272" y="305"/>
                    </a:lnTo>
                    <a:lnTo>
                      <a:pt x="275" y="298"/>
                    </a:lnTo>
                    <a:lnTo>
                      <a:pt x="278" y="290"/>
                    </a:lnTo>
                    <a:lnTo>
                      <a:pt x="278" y="290"/>
                    </a:lnTo>
                    <a:lnTo>
                      <a:pt x="279" y="283"/>
                    </a:lnTo>
                    <a:lnTo>
                      <a:pt x="279" y="283"/>
                    </a:lnTo>
                    <a:lnTo>
                      <a:pt x="282" y="275"/>
                    </a:lnTo>
                    <a:lnTo>
                      <a:pt x="282" y="275"/>
                    </a:lnTo>
                    <a:lnTo>
                      <a:pt x="285" y="266"/>
                    </a:lnTo>
                    <a:lnTo>
                      <a:pt x="285" y="266"/>
                    </a:lnTo>
                    <a:lnTo>
                      <a:pt x="288" y="258"/>
                    </a:lnTo>
                    <a:lnTo>
                      <a:pt x="288" y="258"/>
                    </a:lnTo>
                    <a:lnTo>
                      <a:pt x="291" y="250"/>
                    </a:lnTo>
                    <a:lnTo>
                      <a:pt x="291" y="250"/>
                    </a:lnTo>
                    <a:lnTo>
                      <a:pt x="294" y="240"/>
                    </a:lnTo>
                    <a:lnTo>
                      <a:pt x="294" y="240"/>
                    </a:lnTo>
                    <a:lnTo>
                      <a:pt x="297" y="231"/>
                    </a:lnTo>
                    <a:lnTo>
                      <a:pt x="297" y="231"/>
                    </a:lnTo>
                    <a:lnTo>
                      <a:pt x="299" y="222"/>
                    </a:lnTo>
                    <a:lnTo>
                      <a:pt x="299" y="222"/>
                    </a:lnTo>
                    <a:lnTo>
                      <a:pt x="302" y="214"/>
                    </a:lnTo>
                    <a:lnTo>
                      <a:pt x="302" y="214"/>
                    </a:lnTo>
                    <a:lnTo>
                      <a:pt x="305" y="205"/>
                    </a:lnTo>
                    <a:lnTo>
                      <a:pt x="305" y="205"/>
                    </a:lnTo>
                    <a:lnTo>
                      <a:pt x="308" y="196"/>
                    </a:lnTo>
                    <a:lnTo>
                      <a:pt x="308" y="196"/>
                    </a:lnTo>
                    <a:lnTo>
                      <a:pt x="311" y="188"/>
                    </a:lnTo>
                    <a:lnTo>
                      <a:pt x="311" y="188"/>
                    </a:lnTo>
                    <a:lnTo>
                      <a:pt x="314" y="180"/>
                    </a:lnTo>
                    <a:lnTo>
                      <a:pt x="314" y="180"/>
                    </a:lnTo>
                    <a:lnTo>
                      <a:pt x="317" y="172"/>
                    </a:lnTo>
                    <a:lnTo>
                      <a:pt x="317" y="172"/>
                    </a:lnTo>
                    <a:lnTo>
                      <a:pt x="320" y="163"/>
                    </a:lnTo>
                    <a:lnTo>
                      <a:pt x="320" y="163"/>
                    </a:lnTo>
                    <a:lnTo>
                      <a:pt x="321" y="157"/>
                    </a:lnTo>
                    <a:lnTo>
                      <a:pt x="321" y="157"/>
                    </a:lnTo>
                    <a:lnTo>
                      <a:pt x="324" y="148"/>
                    </a:lnTo>
                    <a:lnTo>
                      <a:pt x="327" y="141"/>
                    </a:lnTo>
                    <a:lnTo>
                      <a:pt x="330" y="136"/>
                    </a:lnTo>
                    <a:lnTo>
                      <a:pt x="330" y="136"/>
                    </a:lnTo>
                    <a:lnTo>
                      <a:pt x="332" y="129"/>
                    </a:lnTo>
                    <a:lnTo>
                      <a:pt x="332" y="129"/>
                    </a:lnTo>
                    <a:lnTo>
                      <a:pt x="335" y="124"/>
                    </a:lnTo>
                    <a:lnTo>
                      <a:pt x="338" y="120"/>
                    </a:lnTo>
                    <a:lnTo>
                      <a:pt x="341" y="114"/>
                    </a:lnTo>
                    <a:lnTo>
                      <a:pt x="344" y="110"/>
                    </a:lnTo>
                    <a:lnTo>
                      <a:pt x="347" y="106"/>
                    </a:lnTo>
                    <a:lnTo>
                      <a:pt x="347" y="106"/>
                    </a:lnTo>
                    <a:lnTo>
                      <a:pt x="350" y="103"/>
                    </a:lnTo>
                    <a:lnTo>
                      <a:pt x="355" y="100"/>
                    </a:lnTo>
                    <a:lnTo>
                      <a:pt x="358" y="98"/>
                    </a:lnTo>
                    <a:lnTo>
                      <a:pt x="363" y="98"/>
                    </a:lnTo>
                    <a:lnTo>
                      <a:pt x="365" y="96"/>
                    </a:lnTo>
                    <a:lnTo>
                      <a:pt x="371" y="99"/>
                    </a:lnTo>
                    <a:lnTo>
                      <a:pt x="374" y="100"/>
                    </a:lnTo>
                    <a:lnTo>
                      <a:pt x="380" y="104"/>
                    </a:lnTo>
                    <a:lnTo>
                      <a:pt x="383" y="106"/>
                    </a:lnTo>
                    <a:lnTo>
                      <a:pt x="383" y="106"/>
                    </a:lnTo>
                    <a:lnTo>
                      <a:pt x="385" y="110"/>
                    </a:lnTo>
                    <a:lnTo>
                      <a:pt x="388" y="114"/>
                    </a:lnTo>
                    <a:lnTo>
                      <a:pt x="391" y="117"/>
                    </a:lnTo>
                    <a:lnTo>
                      <a:pt x="394" y="121"/>
                    </a:lnTo>
                    <a:lnTo>
                      <a:pt x="397" y="125"/>
                    </a:lnTo>
                    <a:lnTo>
                      <a:pt x="397" y="125"/>
                    </a:lnTo>
                    <a:lnTo>
                      <a:pt x="400" y="128"/>
                    </a:lnTo>
                    <a:lnTo>
                      <a:pt x="403" y="132"/>
                    </a:lnTo>
                    <a:lnTo>
                      <a:pt x="404" y="137"/>
                    </a:lnTo>
                    <a:lnTo>
                      <a:pt x="404" y="137"/>
                    </a:lnTo>
                    <a:lnTo>
                      <a:pt x="407" y="141"/>
                    </a:lnTo>
                    <a:lnTo>
                      <a:pt x="407" y="141"/>
                    </a:lnTo>
                    <a:lnTo>
                      <a:pt x="410" y="147"/>
                    </a:lnTo>
                    <a:lnTo>
                      <a:pt x="410" y="147"/>
                    </a:lnTo>
                    <a:lnTo>
                      <a:pt x="413" y="151"/>
                    </a:lnTo>
                    <a:lnTo>
                      <a:pt x="415" y="155"/>
                    </a:lnTo>
                    <a:lnTo>
                      <a:pt x="418" y="161"/>
                    </a:lnTo>
                    <a:lnTo>
                      <a:pt x="421" y="165"/>
                    </a:lnTo>
                    <a:lnTo>
                      <a:pt x="424" y="170"/>
                    </a:lnTo>
                    <a:lnTo>
                      <a:pt x="424" y="170"/>
                    </a:lnTo>
                    <a:lnTo>
                      <a:pt x="427" y="174"/>
                    </a:lnTo>
                    <a:lnTo>
                      <a:pt x="430" y="180"/>
                    </a:lnTo>
                    <a:lnTo>
                      <a:pt x="433" y="184"/>
                    </a:lnTo>
                    <a:lnTo>
                      <a:pt x="433" y="184"/>
                    </a:lnTo>
                    <a:lnTo>
                      <a:pt x="436" y="189"/>
                    </a:lnTo>
                    <a:lnTo>
                      <a:pt x="436" y="189"/>
                    </a:lnTo>
                    <a:lnTo>
                      <a:pt x="438" y="195"/>
                    </a:lnTo>
                    <a:lnTo>
                      <a:pt x="438" y="195"/>
                    </a:lnTo>
                    <a:lnTo>
                      <a:pt x="441" y="199"/>
                    </a:lnTo>
                    <a:lnTo>
                      <a:pt x="441" y="199"/>
                    </a:lnTo>
                    <a:lnTo>
                      <a:pt x="444" y="206"/>
                    </a:lnTo>
                    <a:lnTo>
                      <a:pt x="444" y="206"/>
                    </a:lnTo>
                    <a:lnTo>
                      <a:pt x="446" y="211"/>
                    </a:lnTo>
                    <a:lnTo>
                      <a:pt x="446" y="211"/>
                    </a:lnTo>
                    <a:lnTo>
                      <a:pt x="448" y="216"/>
                    </a:lnTo>
                    <a:lnTo>
                      <a:pt x="448" y="216"/>
                    </a:lnTo>
                    <a:lnTo>
                      <a:pt x="451" y="221"/>
                    </a:lnTo>
                    <a:lnTo>
                      <a:pt x="451" y="221"/>
                    </a:lnTo>
                    <a:lnTo>
                      <a:pt x="454" y="227"/>
                    </a:lnTo>
                    <a:lnTo>
                      <a:pt x="454" y="227"/>
                    </a:lnTo>
                    <a:lnTo>
                      <a:pt x="457" y="232"/>
                    </a:lnTo>
                    <a:lnTo>
                      <a:pt x="457" y="232"/>
                    </a:lnTo>
                    <a:lnTo>
                      <a:pt x="460" y="238"/>
                    </a:lnTo>
                    <a:lnTo>
                      <a:pt x="460" y="238"/>
                    </a:lnTo>
                    <a:lnTo>
                      <a:pt x="463" y="242"/>
                    </a:lnTo>
                    <a:lnTo>
                      <a:pt x="466" y="247"/>
                    </a:lnTo>
                    <a:lnTo>
                      <a:pt x="468" y="253"/>
                    </a:lnTo>
                    <a:lnTo>
                      <a:pt x="468" y="253"/>
                    </a:lnTo>
                    <a:lnTo>
                      <a:pt x="471" y="258"/>
                    </a:lnTo>
                    <a:lnTo>
                      <a:pt x="474" y="262"/>
                    </a:lnTo>
                    <a:lnTo>
                      <a:pt x="477" y="268"/>
                    </a:lnTo>
                    <a:lnTo>
                      <a:pt x="480" y="272"/>
                    </a:lnTo>
                    <a:lnTo>
                      <a:pt x="483" y="277"/>
                    </a:lnTo>
                    <a:lnTo>
                      <a:pt x="483" y="277"/>
                    </a:lnTo>
                    <a:lnTo>
                      <a:pt x="486" y="281"/>
                    </a:lnTo>
                    <a:lnTo>
                      <a:pt x="487" y="287"/>
                    </a:lnTo>
                    <a:lnTo>
                      <a:pt x="490" y="292"/>
                    </a:lnTo>
                    <a:lnTo>
                      <a:pt x="493" y="296"/>
                    </a:lnTo>
                    <a:lnTo>
                      <a:pt x="496" y="301"/>
                    </a:lnTo>
                    <a:lnTo>
                      <a:pt x="499" y="305"/>
                    </a:lnTo>
                    <a:lnTo>
                      <a:pt x="501" y="310"/>
                    </a:lnTo>
                    <a:lnTo>
                      <a:pt x="501" y="310"/>
                    </a:lnTo>
                    <a:lnTo>
                      <a:pt x="504" y="314"/>
                    </a:lnTo>
                    <a:lnTo>
                      <a:pt x="510" y="321"/>
                    </a:lnTo>
                    <a:lnTo>
                      <a:pt x="513" y="325"/>
                    </a:lnTo>
                    <a:lnTo>
                      <a:pt x="516" y="329"/>
                    </a:lnTo>
                    <a:lnTo>
                      <a:pt x="519" y="334"/>
                    </a:lnTo>
                    <a:lnTo>
                      <a:pt x="519" y="334"/>
                    </a:lnTo>
                    <a:lnTo>
                      <a:pt x="521" y="336"/>
                    </a:lnTo>
                    <a:lnTo>
                      <a:pt x="521" y="336"/>
                    </a:lnTo>
                    <a:lnTo>
                      <a:pt x="524" y="340"/>
                    </a:lnTo>
                    <a:lnTo>
                      <a:pt x="527" y="344"/>
                    </a:lnTo>
                    <a:lnTo>
                      <a:pt x="529" y="349"/>
                    </a:lnTo>
                    <a:lnTo>
                      <a:pt x="534" y="354"/>
                    </a:lnTo>
                    <a:lnTo>
                      <a:pt x="537" y="358"/>
                    </a:lnTo>
                    <a:lnTo>
                      <a:pt x="540" y="361"/>
                    </a:lnTo>
                    <a:lnTo>
                      <a:pt x="543" y="364"/>
                    </a:lnTo>
                    <a:lnTo>
                      <a:pt x="543" y="364"/>
                    </a:lnTo>
                    <a:lnTo>
                      <a:pt x="546" y="366"/>
                    </a:lnTo>
                    <a:lnTo>
                      <a:pt x="549" y="369"/>
                    </a:lnTo>
                    <a:lnTo>
                      <a:pt x="552" y="372"/>
                    </a:lnTo>
                    <a:lnTo>
                      <a:pt x="552" y="372"/>
                    </a:lnTo>
                    <a:lnTo>
                      <a:pt x="554" y="375"/>
                    </a:lnTo>
                    <a:lnTo>
                      <a:pt x="557" y="377"/>
                    </a:lnTo>
                    <a:lnTo>
                      <a:pt x="560" y="380"/>
                    </a:lnTo>
                    <a:lnTo>
                      <a:pt x="560" y="380"/>
                    </a:lnTo>
                    <a:lnTo>
                      <a:pt x="563" y="383"/>
                    </a:lnTo>
                    <a:lnTo>
                      <a:pt x="566" y="386"/>
                    </a:lnTo>
                    <a:lnTo>
                      <a:pt x="569" y="388"/>
                    </a:lnTo>
                    <a:lnTo>
                      <a:pt x="570" y="391"/>
                    </a:lnTo>
                    <a:lnTo>
                      <a:pt x="573" y="393"/>
                    </a:lnTo>
                    <a:lnTo>
                      <a:pt x="576" y="395"/>
                    </a:lnTo>
                    <a:lnTo>
                      <a:pt x="579" y="398"/>
                    </a:lnTo>
                    <a:lnTo>
                      <a:pt x="579" y="398"/>
                    </a:lnTo>
                    <a:lnTo>
                      <a:pt x="582" y="399"/>
                    </a:lnTo>
                    <a:lnTo>
                      <a:pt x="587" y="403"/>
                    </a:lnTo>
                    <a:lnTo>
                      <a:pt x="590" y="406"/>
                    </a:lnTo>
                    <a:lnTo>
                      <a:pt x="596" y="409"/>
                    </a:lnTo>
                    <a:lnTo>
                      <a:pt x="599" y="412"/>
                    </a:lnTo>
                    <a:lnTo>
                      <a:pt x="599" y="412"/>
                    </a:lnTo>
                    <a:lnTo>
                      <a:pt x="602" y="413"/>
                    </a:lnTo>
                    <a:lnTo>
                      <a:pt x="605" y="414"/>
                    </a:lnTo>
                    <a:lnTo>
                      <a:pt x="607" y="416"/>
                    </a:lnTo>
                    <a:lnTo>
                      <a:pt x="612" y="419"/>
                    </a:lnTo>
                    <a:lnTo>
                      <a:pt x="615" y="420"/>
                    </a:lnTo>
                    <a:lnTo>
                      <a:pt x="615" y="420"/>
                    </a:lnTo>
                    <a:lnTo>
                      <a:pt x="617" y="421"/>
                    </a:lnTo>
                    <a:lnTo>
                      <a:pt x="620" y="421"/>
                    </a:lnTo>
                    <a:lnTo>
                      <a:pt x="623" y="423"/>
                    </a:lnTo>
                    <a:lnTo>
                      <a:pt x="629" y="423"/>
                    </a:lnTo>
                    <a:lnTo>
                      <a:pt x="632" y="421"/>
                    </a:lnTo>
                    <a:lnTo>
                      <a:pt x="637" y="421"/>
                    </a:lnTo>
                    <a:lnTo>
                      <a:pt x="640" y="421"/>
                    </a:lnTo>
                    <a:lnTo>
                      <a:pt x="640" y="421"/>
                    </a:lnTo>
                    <a:lnTo>
                      <a:pt x="643" y="420"/>
                    </a:lnTo>
                    <a:lnTo>
                      <a:pt x="646" y="420"/>
                    </a:lnTo>
                    <a:lnTo>
                      <a:pt x="649" y="420"/>
                    </a:lnTo>
                    <a:lnTo>
                      <a:pt x="656" y="417"/>
                    </a:lnTo>
                    <a:lnTo>
                      <a:pt x="659" y="417"/>
                    </a:lnTo>
                    <a:lnTo>
                      <a:pt x="665" y="419"/>
                    </a:lnTo>
                    <a:lnTo>
                      <a:pt x="668" y="417"/>
                    </a:lnTo>
                    <a:lnTo>
                      <a:pt x="673" y="414"/>
                    </a:lnTo>
                    <a:lnTo>
                      <a:pt x="676" y="412"/>
                    </a:lnTo>
                    <a:lnTo>
                      <a:pt x="682" y="409"/>
                    </a:lnTo>
                    <a:lnTo>
                      <a:pt x="685" y="406"/>
                    </a:lnTo>
                    <a:lnTo>
                      <a:pt x="690" y="406"/>
                    </a:lnTo>
                    <a:lnTo>
                      <a:pt x="693" y="401"/>
                    </a:lnTo>
                    <a:lnTo>
                      <a:pt x="695" y="398"/>
                    </a:lnTo>
                    <a:lnTo>
                      <a:pt x="698" y="395"/>
                    </a:lnTo>
                    <a:lnTo>
                      <a:pt x="698" y="395"/>
                    </a:lnTo>
                    <a:lnTo>
                      <a:pt x="700" y="393"/>
                    </a:lnTo>
                    <a:lnTo>
                      <a:pt x="706" y="388"/>
                    </a:lnTo>
                    <a:lnTo>
                      <a:pt x="709" y="386"/>
                    </a:lnTo>
                    <a:lnTo>
                      <a:pt x="715" y="380"/>
                    </a:lnTo>
                    <a:lnTo>
                      <a:pt x="718" y="377"/>
                    </a:lnTo>
                    <a:lnTo>
                      <a:pt x="718" y="377"/>
                    </a:lnTo>
                    <a:lnTo>
                      <a:pt x="721" y="371"/>
                    </a:lnTo>
                    <a:lnTo>
                      <a:pt x="723" y="365"/>
                    </a:lnTo>
                    <a:lnTo>
                      <a:pt x="726" y="362"/>
                    </a:lnTo>
                    <a:lnTo>
                      <a:pt x="732" y="357"/>
                    </a:lnTo>
                    <a:lnTo>
                      <a:pt x="735" y="354"/>
                    </a:lnTo>
                    <a:lnTo>
                      <a:pt x="739" y="349"/>
                    </a:lnTo>
                    <a:lnTo>
                      <a:pt x="742" y="346"/>
                    </a:lnTo>
                    <a:lnTo>
                      <a:pt x="742" y="346"/>
                    </a:lnTo>
                    <a:lnTo>
                      <a:pt x="745" y="342"/>
                    </a:lnTo>
                    <a:lnTo>
                      <a:pt x="745" y="342"/>
                    </a:lnTo>
                    <a:lnTo>
                      <a:pt x="748" y="338"/>
                    </a:lnTo>
                    <a:lnTo>
                      <a:pt x="751" y="338"/>
                    </a:lnTo>
                    <a:lnTo>
                      <a:pt x="753" y="334"/>
                    </a:lnTo>
                    <a:lnTo>
                      <a:pt x="756" y="331"/>
                    </a:lnTo>
                    <a:lnTo>
                      <a:pt x="759" y="328"/>
                    </a:lnTo>
                    <a:lnTo>
                      <a:pt x="759" y="328"/>
                    </a:lnTo>
                    <a:lnTo>
                      <a:pt x="762" y="325"/>
                    </a:lnTo>
                    <a:lnTo>
                      <a:pt x="765" y="323"/>
                    </a:lnTo>
                    <a:lnTo>
                      <a:pt x="768" y="320"/>
                    </a:lnTo>
                    <a:lnTo>
                      <a:pt x="768" y="320"/>
                    </a:lnTo>
                    <a:lnTo>
                      <a:pt x="771" y="317"/>
                    </a:lnTo>
                    <a:lnTo>
                      <a:pt x="774" y="316"/>
                    </a:lnTo>
                    <a:lnTo>
                      <a:pt x="776" y="313"/>
                    </a:lnTo>
                    <a:lnTo>
                      <a:pt x="776" y="313"/>
                    </a:lnTo>
                    <a:lnTo>
                      <a:pt x="778" y="313"/>
                    </a:lnTo>
                    <a:lnTo>
                      <a:pt x="784" y="310"/>
                    </a:lnTo>
                    <a:lnTo>
                      <a:pt x="786" y="307"/>
                    </a:lnTo>
                    <a:lnTo>
                      <a:pt x="789" y="306"/>
                    </a:lnTo>
                    <a:lnTo>
                      <a:pt x="792" y="305"/>
                    </a:lnTo>
                    <a:lnTo>
                      <a:pt x="792" y="305"/>
                    </a:lnTo>
                    <a:lnTo>
                      <a:pt x="795" y="310"/>
                    </a:lnTo>
                    <a:lnTo>
                      <a:pt x="801" y="307"/>
                    </a:lnTo>
                    <a:lnTo>
                      <a:pt x="804" y="307"/>
                    </a:lnTo>
                    <a:lnTo>
                      <a:pt x="806" y="306"/>
                    </a:lnTo>
                    <a:lnTo>
                      <a:pt x="809" y="305"/>
                    </a:lnTo>
                    <a:lnTo>
                      <a:pt x="809" y="305"/>
                    </a:lnTo>
                    <a:lnTo>
                      <a:pt x="812" y="303"/>
                    </a:lnTo>
                    <a:lnTo>
                      <a:pt x="818" y="302"/>
                    </a:lnTo>
                    <a:lnTo>
                      <a:pt x="819" y="313"/>
                    </a:lnTo>
                    <a:lnTo>
                      <a:pt x="819" y="313"/>
                    </a:lnTo>
                    <a:lnTo>
                      <a:pt x="822" y="306"/>
                    </a:lnTo>
                    <a:lnTo>
                      <a:pt x="828" y="306"/>
                    </a:lnTo>
                    <a:lnTo>
                      <a:pt x="831" y="306"/>
                    </a:lnTo>
                    <a:lnTo>
                      <a:pt x="831" y="306"/>
                    </a:lnTo>
                    <a:lnTo>
                      <a:pt x="834" y="305"/>
                    </a:lnTo>
                    <a:lnTo>
                      <a:pt x="837" y="305"/>
                    </a:lnTo>
                    <a:lnTo>
                      <a:pt x="839" y="305"/>
                    </a:lnTo>
                    <a:lnTo>
                      <a:pt x="842" y="305"/>
                    </a:lnTo>
                    <a:lnTo>
                      <a:pt x="845" y="309"/>
                    </a:lnTo>
                    <a:lnTo>
                      <a:pt x="845" y="309"/>
                    </a:lnTo>
                    <a:lnTo>
                      <a:pt x="848" y="305"/>
                    </a:lnTo>
                    <a:lnTo>
                      <a:pt x="854" y="298"/>
                    </a:lnTo>
                    <a:lnTo>
                      <a:pt x="857" y="298"/>
                    </a:lnTo>
                    <a:lnTo>
                      <a:pt x="861" y="298"/>
                    </a:lnTo>
                    <a:lnTo>
                      <a:pt x="864" y="299"/>
                    </a:lnTo>
                    <a:lnTo>
                      <a:pt x="869" y="301"/>
                    </a:lnTo>
                    <a:lnTo>
                      <a:pt x="872" y="302"/>
                    </a:lnTo>
                    <a:lnTo>
                      <a:pt x="878" y="299"/>
                    </a:lnTo>
                    <a:lnTo>
                      <a:pt x="881" y="301"/>
                    </a:lnTo>
                    <a:lnTo>
                      <a:pt x="887" y="302"/>
                    </a:lnTo>
                    <a:lnTo>
                      <a:pt x="890" y="305"/>
                    </a:lnTo>
                    <a:lnTo>
                      <a:pt x="890" y="305"/>
                    </a:lnTo>
                    <a:lnTo>
                      <a:pt x="892" y="306"/>
                    </a:lnTo>
                    <a:lnTo>
                      <a:pt x="895" y="307"/>
                    </a:lnTo>
                    <a:lnTo>
                      <a:pt x="898" y="310"/>
                    </a:lnTo>
                    <a:lnTo>
                      <a:pt x="902" y="313"/>
                    </a:lnTo>
                    <a:lnTo>
                      <a:pt x="905" y="316"/>
                    </a:lnTo>
                    <a:lnTo>
                      <a:pt x="905" y="316"/>
                    </a:lnTo>
                    <a:lnTo>
                      <a:pt x="908" y="318"/>
                    </a:lnTo>
                    <a:lnTo>
                      <a:pt x="911" y="320"/>
                    </a:lnTo>
                    <a:lnTo>
                      <a:pt x="914" y="323"/>
                    </a:lnTo>
                    <a:lnTo>
                      <a:pt x="914" y="323"/>
                    </a:lnTo>
                    <a:lnTo>
                      <a:pt x="917" y="324"/>
                    </a:lnTo>
                    <a:lnTo>
                      <a:pt x="922" y="328"/>
                    </a:lnTo>
                    <a:lnTo>
                      <a:pt x="925" y="331"/>
                    </a:lnTo>
                    <a:lnTo>
                      <a:pt x="931" y="335"/>
                    </a:lnTo>
                    <a:lnTo>
                      <a:pt x="934" y="336"/>
                    </a:lnTo>
                    <a:lnTo>
                      <a:pt x="934" y="336"/>
                    </a:lnTo>
                    <a:lnTo>
                      <a:pt x="937" y="339"/>
                    </a:lnTo>
                    <a:lnTo>
                      <a:pt x="940" y="340"/>
                    </a:lnTo>
                    <a:lnTo>
                      <a:pt x="942" y="342"/>
                    </a:lnTo>
                    <a:lnTo>
                      <a:pt x="947" y="346"/>
                    </a:lnTo>
                    <a:lnTo>
                      <a:pt x="950" y="347"/>
                    </a:lnTo>
                    <a:lnTo>
                      <a:pt x="955" y="350"/>
                    </a:lnTo>
                    <a:lnTo>
                      <a:pt x="958" y="351"/>
                    </a:lnTo>
                    <a:lnTo>
                      <a:pt x="961" y="354"/>
                    </a:lnTo>
                    <a:lnTo>
                      <a:pt x="964" y="355"/>
                    </a:lnTo>
                    <a:lnTo>
                      <a:pt x="964" y="355"/>
                    </a:lnTo>
                    <a:lnTo>
                      <a:pt x="967" y="357"/>
                    </a:lnTo>
                    <a:lnTo>
                      <a:pt x="973" y="360"/>
                    </a:lnTo>
                    <a:lnTo>
                      <a:pt x="975" y="361"/>
                    </a:lnTo>
                    <a:lnTo>
                      <a:pt x="978" y="362"/>
                    </a:lnTo>
                    <a:lnTo>
                      <a:pt x="981" y="364"/>
                    </a:lnTo>
                    <a:lnTo>
                      <a:pt x="981" y="364"/>
                    </a:lnTo>
                    <a:lnTo>
                      <a:pt x="984" y="365"/>
                    </a:lnTo>
                    <a:lnTo>
                      <a:pt x="990" y="368"/>
                    </a:lnTo>
                    <a:lnTo>
                      <a:pt x="993" y="368"/>
                    </a:lnTo>
                    <a:lnTo>
                      <a:pt x="998" y="371"/>
                    </a:lnTo>
                    <a:lnTo>
                      <a:pt x="1001" y="372"/>
                    </a:lnTo>
                    <a:lnTo>
                      <a:pt x="1007" y="373"/>
                    </a:lnTo>
                    <a:lnTo>
                      <a:pt x="1010" y="375"/>
                    </a:lnTo>
                    <a:lnTo>
                      <a:pt x="1016" y="376"/>
                    </a:lnTo>
                    <a:lnTo>
                      <a:pt x="1018" y="376"/>
                    </a:lnTo>
                    <a:lnTo>
                      <a:pt x="1026" y="377"/>
                    </a:lnTo>
                    <a:lnTo>
                      <a:pt x="1028" y="377"/>
                    </a:lnTo>
                    <a:lnTo>
                      <a:pt x="1034" y="377"/>
                    </a:lnTo>
                    <a:lnTo>
                      <a:pt x="1037" y="377"/>
                    </a:lnTo>
                    <a:lnTo>
                      <a:pt x="1043" y="376"/>
                    </a:lnTo>
                    <a:lnTo>
                      <a:pt x="1046" y="376"/>
                    </a:lnTo>
                    <a:lnTo>
                      <a:pt x="1046" y="376"/>
                    </a:lnTo>
                    <a:lnTo>
                      <a:pt x="1048" y="380"/>
                    </a:lnTo>
                    <a:lnTo>
                      <a:pt x="1051" y="380"/>
                    </a:lnTo>
                    <a:lnTo>
                      <a:pt x="1054" y="379"/>
                    </a:lnTo>
                    <a:lnTo>
                      <a:pt x="1060" y="379"/>
                    </a:lnTo>
                    <a:lnTo>
                      <a:pt x="1063" y="377"/>
                    </a:lnTo>
                    <a:lnTo>
                      <a:pt x="1067" y="376"/>
                    </a:lnTo>
                    <a:lnTo>
                      <a:pt x="1070" y="373"/>
                    </a:lnTo>
                    <a:lnTo>
                      <a:pt x="1076" y="373"/>
                    </a:lnTo>
                    <a:lnTo>
                      <a:pt x="1079" y="372"/>
                    </a:lnTo>
                    <a:lnTo>
                      <a:pt x="1079" y="372"/>
                    </a:lnTo>
                    <a:lnTo>
                      <a:pt x="1081" y="371"/>
                    </a:lnTo>
                    <a:lnTo>
                      <a:pt x="1084" y="371"/>
                    </a:lnTo>
                    <a:lnTo>
                      <a:pt x="1087" y="369"/>
                    </a:lnTo>
                    <a:lnTo>
                      <a:pt x="1093" y="366"/>
                    </a:lnTo>
                    <a:lnTo>
                      <a:pt x="1096" y="365"/>
                    </a:lnTo>
                    <a:lnTo>
                      <a:pt x="1099" y="364"/>
                    </a:lnTo>
                    <a:lnTo>
                      <a:pt x="1101" y="362"/>
                    </a:lnTo>
                    <a:lnTo>
                      <a:pt x="1101" y="362"/>
                    </a:lnTo>
                    <a:lnTo>
                      <a:pt x="1104" y="357"/>
                    </a:lnTo>
                    <a:lnTo>
                      <a:pt x="1107" y="355"/>
                    </a:lnTo>
                    <a:lnTo>
                      <a:pt x="1109" y="354"/>
                    </a:lnTo>
                    <a:lnTo>
                      <a:pt x="1111" y="351"/>
                    </a:lnTo>
                    <a:lnTo>
                      <a:pt x="1114" y="350"/>
                    </a:lnTo>
                    <a:lnTo>
                      <a:pt x="1120" y="347"/>
                    </a:lnTo>
                    <a:lnTo>
                      <a:pt x="1123" y="346"/>
                    </a:lnTo>
                    <a:lnTo>
                      <a:pt x="1129" y="343"/>
                    </a:lnTo>
                    <a:lnTo>
                      <a:pt x="1132" y="342"/>
                    </a:lnTo>
                    <a:lnTo>
                      <a:pt x="1134" y="339"/>
                    </a:lnTo>
                    <a:lnTo>
                      <a:pt x="1137" y="338"/>
                    </a:lnTo>
                    <a:lnTo>
                      <a:pt x="1137" y="338"/>
                    </a:lnTo>
                    <a:lnTo>
                      <a:pt x="1140" y="336"/>
                    </a:lnTo>
                    <a:lnTo>
                      <a:pt x="1146" y="332"/>
                    </a:lnTo>
                    <a:lnTo>
                      <a:pt x="1149" y="331"/>
                    </a:lnTo>
                    <a:lnTo>
                      <a:pt x="1149" y="331"/>
                    </a:lnTo>
                    <a:lnTo>
                      <a:pt x="1150" y="329"/>
                    </a:lnTo>
                    <a:lnTo>
                      <a:pt x="1153" y="328"/>
                    </a:lnTo>
                    <a:lnTo>
                      <a:pt x="1156" y="327"/>
                    </a:lnTo>
                    <a:lnTo>
                      <a:pt x="1162" y="323"/>
                    </a:lnTo>
                    <a:lnTo>
                      <a:pt x="1164" y="321"/>
                    </a:lnTo>
                    <a:lnTo>
                      <a:pt x="1170" y="317"/>
                    </a:lnTo>
                    <a:lnTo>
                      <a:pt x="1173" y="316"/>
                    </a:lnTo>
                    <a:lnTo>
                      <a:pt x="1176" y="314"/>
                    </a:lnTo>
                    <a:lnTo>
                      <a:pt x="1179" y="313"/>
                    </a:lnTo>
                    <a:lnTo>
                      <a:pt x="1179" y="313"/>
                    </a:lnTo>
                    <a:lnTo>
                      <a:pt x="1182" y="313"/>
                    </a:lnTo>
                    <a:lnTo>
                      <a:pt x="1187" y="310"/>
                    </a:lnTo>
                    <a:lnTo>
                      <a:pt x="1190" y="309"/>
                    </a:lnTo>
                    <a:lnTo>
                      <a:pt x="1197" y="312"/>
                    </a:lnTo>
                    <a:lnTo>
                      <a:pt x="1200" y="310"/>
                    </a:lnTo>
                    <a:lnTo>
                      <a:pt x="1206" y="310"/>
                    </a:lnTo>
                    <a:lnTo>
                      <a:pt x="1209" y="310"/>
                    </a:lnTo>
                    <a:lnTo>
                      <a:pt x="1215" y="309"/>
                    </a:lnTo>
                    <a:lnTo>
                      <a:pt x="1217" y="307"/>
                    </a:lnTo>
                    <a:lnTo>
                      <a:pt x="1217" y="307"/>
                    </a:lnTo>
                    <a:lnTo>
                      <a:pt x="1220" y="316"/>
                    </a:lnTo>
                    <a:lnTo>
                      <a:pt x="1220" y="316"/>
                    </a:lnTo>
                    <a:lnTo>
                      <a:pt x="1223" y="309"/>
                    </a:lnTo>
                    <a:lnTo>
                      <a:pt x="1223" y="309"/>
                    </a:lnTo>
                    <a:lnTo>
                      <a:pt x="1226" y="309"/>
                    </a:lnTo>
                    <a:lnTo>
                      <a:pt x="1232" y="309"/>
                    </a:lnTo>
                    <a:lnTo>
                      <a:pt x="1233" y="309"/>
                    </a:lnTo>
                    <a:lnTo>
                      <a:pt x="1239" y="309"/>
                    </a:lnTo>
                    <a:lnTo>
                      <a:pt x="1242" y="309"/>
                    </a:lnTo>
                    <a:lnTo>
                      <a:pt x="1248" y="312"/>
                    </a:lnTo>
                    <a:lnTo>
                      <a:pt x="1250" y="305"/>
                    </a:lnTo>
                    <a:lnTo>
                      <a:pt x="1256" y="305"/>
                    </a:lnTo>
                    <a:lnTo>
                      <a:pt x="1259" y="306"/>
                    </a:lnTo>
                    <a:lnTo>
                      <a:pt x="1265" y="306"/>
                    </a:lnTo>
                    <a:lnTo>
                      <a:pt x="1268" y="307"/>
                    </a:lnTo>
                    <a:lnTo>
                      <a:pt x="1275" y="309"/>
                    </a:lnTo>
                    <a:lnTo>
                      <a:pt x="1278" y="310"/>
                    </a:lnTo>
                    <a:lnTo>
                      <a:pt x="1283" y="312"/>
                    </a:lnTo>
                    <a:lnTo>
                      <a:pt x="1286" y="313"/>
                    </a:lnTo>
                    <a:lnTo>
                      <a:pt x="1289" y="312"/>
                    </a:lnTo>
                    <a:lnTo>
                      <a:pt x="1292" y="320"/>
                    </a:lnTo>
                    <a:lnTo>
                      <a:pt x="1292" y="320"/>
                    </a:lnTo>
                    <a:lnTo>
                      <a:pt x="1295" y="320"/>
                    </a:lnTo>
                    <a:lnTo>
                      <a:pt x="1301" y="321"/>
                    </a:lnTo>
                    <a:lnTo>
                      <a:pt x="1303" y="323"/>
                    </a:lnTo>
                    <a:lnTo>
                      <a:pt x="1309" y="325"/>
                    </a:lnTo>
                    <a:lnTo>
                      <a:pt x="1312" y="325"/>
                    </a:lnTo>
                    <a:lnTo>
                      <a:pt x="1315" y="327"/>
                    </a:lnTo>
                    <a:lnTo>
                      <a:pt x="1316" y="336"/>
                    </a:lnTo>
                    <a:lnTo>
                      <a:pt x="1316" y="336"/>
                    </a:lnTo>
                    <a:lnTo>
                      <a:pt x="1319" y="331"/>
                    </a:lnTo>
                    <a:lnTo>
                      <a:pt x="1325" y="334"/>
                    </a:lnTo>
                    <a:lnTo>
                      <a:pt x="1328" y="335"/>
                    </a:lnTo>
                    <a:lnTo>
                      <a:pt x="1333" y="338"/>
                    </a:lnTo>
                    <a:lnTo>
                      <a:pt x="1336" y="339"/>
                    </a:lnTo>
                    <a:lnTo>
                      <a:pt x="1342" y="343"/>
                    </a:lnTo>
                    <a:lnTo>
                      <a:pt x="1345" y="346"/>
                    </a:lnTo>
                    <a:lnTo>
                      <a:pt x="1351" y="343"/>
                    </a:lnTo>
                    <a:lnTo>
                      <a:pt x="1353" y="344"/>
                    </a:lnTo>
                    <a:lnTo>
                      <a:pt x="1356" y="346"/>
                    </a:lnTo>
                    <a:lnTo>
                      <a:pt x="1358" y="347"/>
                    </a:lnTo>
                    <a:lnTo>
                      <a:pt x="1361" y="350"/>
                    </a:lnTo>
                    <a:lnTo>
                      <a:pt x="1364" y="351"/>
                    </a:lnTo>
                    <a:lnTo>
                      <a:pt x="1369" y="354"/>
                    </a:lnTo>
                    <a:lnTo>
                      <a:pt x="1372" y="354"/>
                    </a:lnTo>
                    <a:lnTo>
                      <a:pt x="1372" y="354"/>
                    </a:lnTo>
                    <a:lnTo>
                      <a:pt x="1375" y="355"/>
                    </a:lnTo>
                    <a:lnTo>
                      <a:pt x="1378" y="357"/>
                    </a:lnTo>
                    <a:lnTo>
                      <a:pt x="1381" y="357"/>
                    </a:lnTo>
                    <a:lnTo>
                      <a:pt x="1381" y="357"/>
                    </a:lnTo>
                    <a:lnTo>
                      <a:pt x="1384" y="364"/>
                    </a:lnTo>
                    <a:lnTo>
                      <a:pt x="1386" y="365"/>
                    </a:lnTo>
                    <a:lnTo>
                      <a:pt x="1389" y="366"/>
                    </a:lnTo>
                    <a:lnTo>
                      <a:pt x="1395" y="368"/>
                    </a:lnTo>
                    <a:lnTo>
                      <a:pt x="1398" y="369"/>
                    </a:lnTo>
                    <a:lnTo>
                      <a:pt x="1402" y="371"/>
                    </a:lnTo>
                    <a:lnTo>
                      <a:pt x="1405" y="372"/>
                    </a:lnTo>
                    <a:lnTo>
                      <a:pt x="1411" y="375"/>
                    </a:lnTo>
                    <a:lnTo>
                      <a:pt x="1414" y="376"/>
                    </a:lnTo>
                    <a:lnTo>
                      <a:pt x="1419" y="377"/>
                    </a:lnTo>
                    <a:lnTo>
                      <a:pt x="1422" y="379"/>
                    </a:lnTo>
                    <a:lnTo>
                      <a:pt x="1422" y="379"/>
                    </a:lnTo>
                    <a:lnTo>
                      <a:pt x="1425" y="380"/>
                    </a:lnTo>
                    <a:lnTo>
                      <a:pt x="1428" y="380"/>
                    </a:lnTo>
                    <a:lnTo>
                      <a:pt x="1431" y="382"/>
                    </a:lnTo>
                    <a:lnTo>
                      <a:pt x="1437" y="386"/>
                    </a:lnTo>
                    <a:lnTo>
                      <a:pt x="1439" y="382"/>
                    </a:lnTo>
                    <a:lnTo>
                      <a:pt x="1447" y="384"/>
                    </a:lnTo>
                    <a:lnTo>
                      <a:pt x="1449" y="386"/>
                    </a:lnTo>
                    <a:lnTo>
                      <a:pt x="1455" y="387"/>
                    </a:lnTo>
                    <a:lnTo>
                      <a:pt x="1458" y="387"/>
                    </a:lnTo>
                    <a:lnTo>
                      <a:pt x="1458" y="387"/>
                    </a:lnTo>
                    <a:lnTo>
                      <a:pt x="1461" y="388"/>
                    </a:lnTo>
                    <a:lnTo>
                      <a:pt x="1464" y="390"/>
                    </a:lnTo>
                    <a:lnTo>
                      <a:pt x="1467" y="390"/>
                    </a:lnTo>
                    <a:lnTo>
                      <a:pt x="1472" y="391"/>
                    </a:lnTo>
                    <a:lnTo>
                      <a:pt x="1475" y="393"/>
                    </a:lnTo>
                    <a:lnTo>
                      <a:pt x="1481" y="394"/>
                    </a:lnTo>
                    <a:lnTo>
                      <a:pt x="1482" y="395"/>
                    </a:lnTo>
                    <a:lnTo>
                      <a:pt x="1485" y="395"/>
                    </a:lnTo>
                    <a:lnTo>
                      <a:pt x="1488" y="397"/>
                    </a:lnTo>
                    <a:lnTo>
                      <a:pt x="1488" y="397"/>
                    </a:lnTo>
                    <a:lnTo>
                      <a:pt x="1491" y="397"/>
                    </a:lnTo>
                    <a:lnTo>
                      <a:pt x="1497" y="398"/>
                    </a:lnTo>
                    <a:lnTo>
                      <a:pt x="1500" y="399"/>
                    </a:lnTo>
                    <a:lnTo>
                      <a:pt x="1505" y="401"/>
                    </a:lnTo>
                    <a:lnTo>
                      <a:pt x="1508" y="402"/>
                    </a:lnTo>
                    <a:lnTo>
                      <a:pt x="1514" y="403"/>
                    </a:lnTo>
                    <a:lnTo>
                      <a:pt x="1517" y="403"/>
                    </a:lnTo>
                    <a:lnTo>
                      <a:pt x="1517" y="403"/>
                    </a:lnTo>
                    <a:lnTo>
                      <a:pt x="1520" y="405"/>
                    </a:lnTo>
                    <a:lnTo>
                      <a:pt x="1524" y="406"/>
                    </a:lnTo>
                    <a:lnTo>
                      <a:pt x="1527" y="406"/>
                    </a:lnTo>
                    <a:lnTo>
                      <a:pt x="1532" y="408"/>
                    </a:lnTo>
                    <a:lnTo>
                      <a:pt x="1535" y="408"/>
                    </a:lnTo>
                    <a:lnTo>
                      <a:pt x="1541" y="409"/>
                    </a:lnTo>
                    <a:lnTo>
                      <a:pt x="1544" y="409"/>
                    </a:lnTo>
                    <a:lnTo>
                      <a:pt x="1550" y="410"/>
                    </a:lnTo>
                    <a:lnTo>
                      <a:pt x="1553" y="410"/>
                    </a:lnTo>
                    <a:lnTo>
                      <a:pt x="1558" y="412"/>
                    </a:lnTo>
                    <a:lnTo>
                      <a:pt x="1561" y="412"/>
                    </a:lnTo>
                    <a:lnTo>
                      <a:pt x="1564" y="412"/>
                    </a:lnTo>
                    <a:lnTo>
                      <a:pt x="1565" y="413"/>
                    </a:lnTo>
                    <a:lnTo>
                      <a:pt x="1565" y="413"/>
                    </a:lnTo>
                    <a:lnTo>
                      <a:pt x="1568" y="413"/>
                    </a:lnTo>
                    <a:lnTo>
                      <a:pt x="1574" y="413"/>
                    </a:lnTo>
                    <a:lnTo>
                      <a:pt x="1577" y="414"/>
                    </a:lnTo>
                    <a:lnTo>
                      <a:pt x="1583" y="414"/>
                    </a:lnTo>
                    <a:lnTo>
                      <a:pt x="1585" y="416"/>
                    </a:lnTo>
                    <a:lnTo>
                      <a:pt x="1591" y="416"/>
                    </a:lnTo>
                    <a:lnTo>
                      <a:pt x="1594" y="416"/>
                    </a:lnTo>
                    <a:lnTo>
                      <a:pt x="1600" y="417"/>
                    </a:lnTo>
                    <a:lnTo>
                      <a:pt x="1603" y="417"/>
                    </a:lnTo>
                    <a:lnTo>
                      <a:pt x="1610" y="419"/>
                    </a:lnTo>
                    <a:lnTo>
                      <a:pt x="1613" y="419"/>
                    </a:lnTo>
                    <a:lnTo>
                      <a:pt x="1618" y="419"/>
                    </a:lnTo>
                    <a:lnTo>
                      <a:pt x="1621" y="420"/>
                    </a:lnTo>
                    <a:lnTo>
                      <a:pt x="1627" y="420"/>
                    </a:lnTo>
                    <a:lnTo>
                      <a:pt x="1630" y="420"/>
                    </a:lnTo>
                    <a:lnTo>
                      <a:pt x="1630" y="420"/>
                    </a:lnTo>
                    <a:lnTo>
                      <a:pt x="1633" y="421"/>
                    </a:lnTo>
                    <a:lnTo>
                      <a:pt x="1636" y="421"/>
                    </a:lnTo>
                    <a:lnTo>
                      <a:pt x="1638" y="421"/>
                    </a:lnTo>
                    <a:lnTo>
                      <a:pt x="1644" y="423"/>
                    </a:lnTo>
                    <a:lnTo>
                      <a:pt x="1647" y="423"/>
                    </a:lnTo>
                    <a:lnTo>
                      <a:pt x="1651" y="423"/>
                    </a:lnTo>
                    <a:lnTo>
                      <a:pt x="1654" y="424"/>
                    </a:lnTo>
                    <a:lnTo>
                      <a:pt x="1660" y="424"/>
                    </a:lnTo>
                    <a:lnTo>
                      <a:pt x="1663" y="424"/>
                    </a:lnTo>
                    <a:lnTo>
                      <a:pt x="1669" y="425"/>
                    </a:lnTo>
                    <a:lnTo>
                      <a:pt x="1671" y="425"/>
                    </a:lnTo>
                    <a:lnTo>
                      <a:pt x="1677" y="427"/>
                    </a:lnTo>
                    <a:lnTo>
                      <a:pt x="1680" y="427"/>
                    </a:lnTo>
                    <a:lnTo>
                      <a:pt x="1686" y="428"/>
                    </a:lnTo>
                    <a:lnTo>
                      <a:pt x="1689" y="428"/>
                    </a:lnTo>
                    <a:lnTo>
                      <a:pt x="1693" y="428"/>
                    </a:lnTo>
                    <a:lnTo>
                      <a:pt x="1696" y="430"/>
                    </a:lnTo>
                    <a:lnTo>
                      <a:pt x="1696" y="430"/>
                    </a:lnTo>
                    <a:lnTo>
                      <a:pt x="1699" y="430"/>
                    </a:lnTo>
                    <a:lnTo>
                      <a:pt x="1704" y="431"/>
                    </a:lnTo>
                    <a:lnTo>
                      <a:pt x="1707" y="431"/>
                    </a:lnTo>
                    <a:lnTo>
                      <a:pt x="1713" y="431"/>
                    </a:lnTo>
                    <a:lnTo>
                      <a:pt x="1716" y="432"/>
                    </a:lnTo>
                    <a:lnTo>
                      <a:pt x="1722" y="432"/>
                    </a:lnTo>
                    <a:lnTo>
                      <a:pt x="1724" y="432"/>
                    </a:lnTo>
                    <a:lnTo>
                      <a:pt x="1730" y="434"/>
                    </a:lnTo>
                    <a:lnTo>
                      <a:pt x="1732" y="434"/>
                    </a:lnTo>
                    <a:lnTo>
                      <a:pt x="1737" y="434"/>
                    </a:lnTo>
                    <a:lnTo>
                      <a:pt x="1740" y="434"/>
                    </a:lnTo>
                    <a:lnTo>
                      <a:pt x="1746" y="435"/>
                    </a:lnTo>
                    <a:lnTo>
                      <a:pt x="1749" y="435"/>
                    </a:lnTo>
                    <a:lnTo>
                      <a:pt x="1754" y="436"/>
                    </a:lnTo>
                    <a:lnTo>
                      <a:pt x="1757" y="436"/>
                    </a:lnTo>
                    <a:lnTo>
                      <a:pt x="1760" y="436"/>
                    </a:lnTo>
                    <a:lnTo>
                      <a:pt x="1763" y="438"/>
                    </a:lnTo>
                    <a:lnTo>
                      <a:pt x="1763" y="438"/>
                    </a:lnTo>
                    <a:lnTo>
                      <a:pt x="1766" y="438"/>
                    </a:lnTo>
                    <a:lnTo>
                      <a:pt x="1773" y="439"/>
                    </a:lnTo>
                    <a:lnTo>
                      <a:pt x="1776" y="439"/>
                    </a:lnTo>
                    <a:lnTo>
                      <a:pt x="1782" y="441"/>
                    </a:lnTo>
                    <a:lnTo>
                      <a:pt x="1785" y="441"/>
                    </a:lnTo>
                    <a:lnTo>
                      <a:pt x="1790" y="442"/>
                    </a:lnTo>
                    <a:lnTo>
                      <a:pt x="1793" y="442"/>
                    </a:lnTo>
                    <a:lnTo>
                      <a:pt x="1799" y="442"/>
                    </a:lnTo>
                    <a:lnTo>
                      <a:pt x="1802" y="443"/>
                    </a:lnTo>
                    <a:lnTo>
                      <a:pt x="1807" y="443"/>
                    </a:lnTo>
                    <a:lnTo>
                      <a:pt x="1810" y="443"/>
                    </a:lnTo>
                    <a:lnTo>
                      <a:pt x="1815" y="445"/>
                    </a:lnTo>
                    <a:lnTo>
                      <a:pt x="1817" y="445"/>
                    </a:lnTo>
                    <a:lnTo>
                      <a:pt x="1820" y="445"/>
                    </a:lnTo>
                    <a:lnTo>
                      <a:pt x="1823" y="446"/>
                    </a:lnTo>
                    <a:lnTo>
                      <a:pt x="1823" y="446"/>
                    </a:lnTo>
                    <a:lnTo>
                      <a:pt x="1826" y="446"/>
                    </a:lnTo>
                    <a:lnTo>
                      <a:pt x="1832" y="446"/>
                    </a:lnTo>
                    <a:lnTo>
                      <a:pt x="1835" y="446"/>
                    </a:lnTo>
                    <a:lnTo>
                      <a:pt x="1840" y="447"/>
                    </a:lnTo>
                    <a:lnTo>
                      <a:pt x="1843" y="447"/>
                    </a:lnTo>
                    <a:lnTo>
                      <a:pt x="1849" y="449"/>
                    </a:lnTo>
                    <a:lnTo>
                      <a:pt x="1852" y="449"/>
                    </a:lnTo>
                    <a:lnTo>
                      <a:pt x="1859" y="449"/>
                    </a:lnTo>
                    <a:lnTo>
                      <a:pt x="1862" y="450"/>
                    </a:lnTo>
                    <a:lnTo>
                      <a:pt x="1868" y="450"/>
                    </a:lnTo>
                    <a:lnTo>
                      <a:pt x="1870" y="450"/>
                    </a:lnTo>
                    <a:lnTo>
                      <a:pt x="1876" y="451"/>
                    </a:lnTo>
                    <a:lnTo>
                      <a:pt x="1879" y="451"/>
                    </a:lnTo>
                    <a:lnTo>
                      <a:pt x="1885" y="451"/>
                    </a:lnTo>
                    <a:lnTo>
                      <a:pt x="1888" y="451"/>
                    </a:lnTo>
                    <a:lnTo>
                      <a:pt x="1893" y="453"/>
                    </a:lnTo>
                    <a:lnTo>
                      <a:pt x="1896" y="453"/>
                    </a:lnTo>
                    <a:lnTo>
                      <a:pt x="1898" y="453"/>
                    </a:lnTo>
                    <a:lnTo>
                      <a:pt x="1901" y="454"/>
                    </a:lnTo>
                    <a:lnTo>
                      <a:pt x="1901" y="454"/>
                    </a:lnTo>
                    <a:lnTo>
                      <a:pt x="1903" y="454"/>
                    </a:lnTo>
                    <a:lnTo>
                      <a:pt x="1903" y="454"/>
                    </a:lnTo>
                    <a:lnTo>
                      <a:pt x="1906" y="453"/>
                    </a:lnTo>
                    <a:lnTo>
                      <a:pt x="1906" y="453"/>
                    </a:lnTo>
                    <a:lnTo>
                      <a:pt x="1909" y="456"/>
                    </a:lnTo>
                    <a:lnTo>
                      <a:pt x="1909" y="456"/>
                    </a:lnTo>
                    <a:lnTo>
                      <a:pt x="1912" y="456"/>
                    </a:lnTo>
                    <a:lnTo>
                      <a:pt x="1918" y="457"/>
                    </a:lnTo>
                    <a:lnTo>
                      <a:pt x="1921" y="457"/>
                    </a:lnTo>
                    <a:lnTo>
                      <a:pt x="1926" y="458"/>
                    </a:lnTo>
                    <a:lnTo>
                      <a:pt x="1929" y="458"/>
                    </a:lnTo>
                    <a:lnTo>
                      <a:pt x="1935" y="460"/>
                    </a:lnTo>
                    <a:lnTo>
                      <a:pt x="1938" y="458"/>
                    </a:lnTo>
                    <a:lnTo>
                      <a:pt x="1945" y="458"/>
                    </a:lnTo>
                    <a:lnTo>
                      <a:pt x="1948" y="458"/>
                    </a:lnTo>
                    <a:lnTo>
                      <a:pt x="1954" y="458"/>
                    </a:lnTo>
                    <a:lnTo>
                      <a:pt x="1956" y="458"/>
                    </a:lnTo>
                    <a:lnTo>
                      <a:pt x="1962" y="460"/>
                    </a:lnTo>
                    <a:lnTo>
                      <a:pt x="1965" y="458"/>
                    </a:lnTo>
                    <a:lnTo>
                      <a:pt x="1971" y="460"/>
                    </a:lnTo>
                    <a:lnTo>
                      <a:pt x="1974" y="460"/>
                    </a:lnTo>
                    <a:lnTo>
                      <a:pt x="1979" y="460"/>
                    </a:lnTo>
                    <a:lnTo>
                      <a:pt x="1981" y="460"/>
                    </a:lnTo>
                    <a:lnTo>
                      <a:pt x="1981" y="460"/>
                    </a:lnTo>
                    <a:lnTo>
                      <a:pt x="1982" y="446"/>
                    </a:lnTo>
                  </a:path>
                </a:pathLst>
              </a:custGeom>
              <a:noFill/>
              <a:ln w="14288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" name="Rectangle 100">
                <a:extLst>
                  <a:ext uri="{FF2B5EF4-FFF2-40B4-BE49-F238E27FC236}">
                    <a16:creationId xmlns:a16="http://schemas.microsoft.com/office/drawing/2014/main" id="{B85DE488-5C59-4C7E-B75B-8838235810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8375" y="2339935"/>
                <a:ext cx="26289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900">
                    <a:solidFill>
                      <a:srgbClr val="000000"/>
                    </a:solidFill>
                  </a:rPr>
                  <a:t>Days</a:t>
                </a:r>
                <a:endParaRPr lang="en-US" altLang="en-US" sz="900"/>
              </a:p>
            </p:txBody>
          </p:sp>
        </p:grpSp>
        <p:grpSp>
          <p:nvGrpSpPr>
            <p:cNvPr id="143" name="Group 142">
              <a:extLst>
                <a:ext uri="{FF2B5EF4-FFF2-40B4-BE49-F238E27FC236}">
                  <a16:creationId xmlns:a16="http://schemas.microsoft.com/office/drawing/2014/main" id="{4F50950E-0978-4DE0-9EF6-459CA958E29E}"/>
                </a:ext>
              </a:extLst>
            </p:cNvPr>
            <p:cNvGrpSpPr/>
            <p:nvPr/>
          </p:nvGrpSpPr>
          <p:grpSpPr>
            <a:xfrm>
              <a:off x="4862717" y="1155707"/>
              <a:ext cx="866612" cy="577845"/>
              <a:chOff x="4727575" y="1165131"/>
              <a:chExt cx="866612" cy="577845"/>
            </a:xfrm>
          </p:grpSpPr>
          <p:sp>
            <p:nvSpPr>
              <p:cNvPr id="134" name="Rectangle 123">
                <a:extLst>
                  <a:ext uri="{FF2B5EF4-FFF2-40B4-BE49-F238E27FC236}">
                    <a16:creationId xmlns:a16="http://schemas.microsoft.com/office/drawing/2014/main" id="{0A3222CA-165E-4566-B3CB-FBBC71E3DF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54588" y="1165131"/>
                <a:ext cx="384721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000" dirty="0">
                    <a:solidFill>
                      <a:srgbClr val="000000"/>
                    </a:solidFill>
                  </a:rPr>
                  <a:t>DMSO</a:t>
                </a:r>
                <a:endParaRPr lang="en-US" altLang="en-US" sz="1000" dirty="0"/>
              </a:p>
            </p:txBody>
          </p:sp>
          <p:sp>
            <p:nvSpPr>
              <p:cNvPr id="135" name="Line 124">
                <a:extLst>
                  <a:ext uri="{FF2B5EF4-FFF2-40B4-BE49-F238E27FC236}">
                    <a16:creationId xmlns:a16="http://schemas.microsoft.com/office/drawing/2014/main" id="{A167D475-E1EB-46E1-9A99-448EE24EAA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27575" y="1273175"/>
                <a:ext cx="146050" cy="0"/>
              </a:xfrm>
              <a:prstGeom prst="line">
                <a:avLst/>
              </a:prstGeom>
              <a:noFill/>
              <a:ln w="14288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/>
              </a:p>
            </p:txBody>
          </p:sp>
          <p:sp>
            <p:nvSpPr>
              <p:cNvPr id="136" name="Rectangle 125">
                <a:extLst>
                  <a:ext uri="{FF2B5EF4-FFF2-40B4-BE49-F238E27FC236}">
                    <a16:creationId xmlns:a16="http://schemas.microsoft.com/office/drawing/2014/main" id="{FFC15384-B085-4063-9A27-7A6DB2C30D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54588" y="1314396"/>
                <a:ext cx="569067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000" dirty="0">
                    <a:solidFill>
                      <a:srgbClr val="000000"/>
                    </a:solidFill>
                  </a:rPr>
                  <a:t>Nob(2um)</a:t>
                </a:r>
                <a:endParaRPr lang="en-US" altLang="en-US" sz="1000" dirty="0"/>
              </a:p>
            </p:txBody>
          </p:sp>
          <p:sp>
            <p:nvSpPr>
              <p:cNvPr id="137" name="Line 126">
                <a:extLst>
                  <a:ext uri="{FF2B5EF4-FFF2-40B4-BE49-F238E27FC236}">
                    <a16:creationId xmlns:a16="http://schemas.microsoft.com/office/drawing/2014/main" id="{AEC8F845-7D42-4D29-9A53-867A0EFF84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27575" y="1398588"/>
                <a:ext cx="146050" cy="0"/>
              </a:xfrm>
              <a:prstGeom prst="line">
                <a:avLst/>
              </a:prstGeom>
              <a:noFill/>
              <a:ln w="14288">
                <a:solidFill>
                  <a:srgbClr val="C00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/>
              </a:p>
            </p:txBody>
          </p:sp>
          <p:sp>
            <p:nvSpPr>
              <p:cNvPr id="138" name="Rectangle 127">
                <a:extLst>
                  <a:ext uri="{FF2B5EF4-FFF2-40B4-BE49-F238E27FC236}">
                    <a16:creationId xmlns:a16="http://schemas.microsoft.com/office/drawing/2014/main" id="{4347DFDA-9E30-400B-B546-71657C0012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54588" y="1457312"/>
                <a:ext cx="569067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000" dirty="0">
                    <a:solidFill>
                      <a:srgbClr val="000000"/>
                    </a:solidFill>
                  </a:rPr>
                  <a:t>Nob(5um)</a:t>
                </a:r>
                <a:endParaRPr lang="en-US" altLang="en-US" sz="1000" dirty="0"/>
              </a:p>
            </p:txBody>
          </p:sp>
          <p:sp>
            <p:nvSpPr>
              <p:cNvPr id="139" name="Line 128">
                <a:extLst>
                  <a:ext uri="{FF2B5EF4-FFF2-40B4-BE49-F238E27FC236}">
                    <a16:creationId xmlns:a16="http://schemas.microsoft.com/office/drawing/2014/main" id="{9546578F-A6E2-41CF-9FEA-1F823972B6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27575" y="1533552"/>
                <a:ext cx="146050" cy="0"/>
              </a:xfrm>
              <a:prstGeom prst="line">
                <a:avLst/>
              </a:prstGeom>
              <a:noFill/>
              <a:ln w="14288">
                <a:solidFill>
                  <a:srgbClr val="00FF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/>
              </a:p>
            </p:txBody>
          </p:sp>
          <p:sp>
            <p:nvSpPr>
              <p:cNvPr id="140" name="Rectangle 129">
                <a:extLst>
                  <a:ext uri="{FF2B5EF4-FFF2-40B4-BE49-F238E27FC236}">
                    <a16:creationId xmlns:a16="http://schemas.microsoft.com/office/drawing/2014/main" id="{DF8D63A2-9EFF-45A1-9084-3E1F4A8686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54588" y="1589088"/>
                <a:ext cx="639599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en-US" sz="1000" dirty="0">
                    <a:solidFill>
                      <a:srgbClr val="000000"/>
                    </a:solidFill>
                  </a:rPr>
                  <a:t>Nob(10um)</a:t>
                </a:r>
                <a:endParaRPr lang="en-US" altLang="en-US" sz="1000" dirty="0"/>
              </a:p>
            </p:txBody>
          </p:sp>
          <p:sp>
            <p:nvSpPr>
              <p:cNvPr id="141" name="Line 130">
                <a:extLst>
                  <a:ext uri="{FF2B5EF4-FFF2-40B4-BE49-F238E27FC236}">
                    <a16:creationId xmlns:a16="http://schemas.microsoft.com/office/drawing/2014/main" id="{939C2177-A0EF-40E5-BF1F-B4B10E1A8B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27575" y="1643063"/>
                <a:ext cx="146050" cy="0"/>
              </a:xfrm>
              <a:prstGeom prst="line">
                <a:avLst/>
              </a:prstGeom>
              <a:noFill/>
              <a:ln w="14288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000"/>
              </a:p>
            </p:txBody>
          </p:sp>
        </p:grpSp>
        <p:sp>
          <p:nvSpPr>
            <p:cNvPr id="142" name="Rectangle 141">
              <a:extLst>
                <a:ext uri="{FF2B5EF4-FFF2-40B4-BE49-F238E27FC236}">
                  <a16:creationId xmlns:a16="http://schemas.microsoft.com/office/drawing/2014/main" id="{0DCBD59A-5E20-4B82-A1F5-AFF69FDE6D6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214593" y="1541830"/>
              <a:ext cx="101201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914400"/>
              <a:r>
                <a:rPr lang="en-US" altLang="en-US" sz="900" dirty="0">
                  <a:solidFill>
                    <a:srgbClr val="000000"/>
                  </a:solidFill>
                </a:rPr>
                <a:t>Rel. Luminescence </a:t>
              </a:r>
            </a:p>
            <a:p>
              <a:pPr algn="ctr" defTabSz="914400"/>
              <a:r>
                <a:rPr lang="en-US" altLang="en-US" sz="900" dirty="0">
                  <a:solidFill>
                    <a:srgbClr val="000000"/>
                  </a:solidFill>
                </a:rPr>
                <a:t>(counts/s)</a:t>
              </a:r>
              <a:endParaRPr lang="en-US" altLang="en-US" sz="900" dirty="0"/>
            </a:p>
          </p:txBody>
        </p:sp>
      </p:grp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80590A67-1340-4E4B-AE8F-6544F34ECF5B}"/>
              </a:ext>
            </a:extLst>
          </p:cNvPr>
          <p:cNvGrpSpPr/>
          <p:nvPr/>
        </p:nvGrpSpPr>
        <p:grpSpPr>
          <a:xfrm>
            <a:off x="190289" y="2652041"/>
            <a:ext cx="2193946" cy="1264865"/>
            <a:chOff x="3380905" y="1447789"/>
            <a:chExt cx="2318298" cy="1434443"/>
          </a:xfrm>
        </p:grpSpPr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528695F-DBF7-4BDD-B82A-ACA9CAF77398}"/>
                </a:ext>
              </a:extLst>
            </p:cNvPr>
            <p:cNvSpPr txBox="1"/>
            <p:nvPr/>
          </p:nvSpPr>
          <p:spPr>
            <a:xfrm>
              <a:off x="3746925" y="1447789"/>
              <a:ext cx="1855433" cy="3202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3T3L1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887AECDC-0A4A-45CA-B4FB-962A5A79530E}"/>
                </a:ext>
              </a:extLst>
            </p:cNvPr>
            <p:cNvCxnSpPr>
              <a:cxnSpLocks/>
            </p:cNvCxnSpPr>
            <p:nvPr/>
          </p:nvCxnSpPr>
          <p:spPr>
            <a:xfrm>
              <a:off x="4140031" y="1745024"/>
              <a:ext cx="1508679" cy="0"/>
            </a:xfrm>
            <a:prstGeom prst="line">
              <a:avLst/>
            </a:prstGeom>
            <a:ln w="19050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C26E5D10-A4AE-4EDD-98D4-D24EDBB353C4}"/>
                </a:ext>
              </a:extLst>
            </p:cNvPr>
            <p:cNvSpPr txBox="1"/>
            <p:nvPr/>
          </p:nvSpPr>
          <p:spPr>
            <a:xfrm>
              <a:off x="3380905" y="1737689"/>
              <a:ext cx="2317504" cy="5011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D0                  D6</a:t>
              </a: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B(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)      0          0       2        5</a:t>
              </a:r>
            </a:p>
          </p:txBody>
        </p:sp>
        <p:sp>
          <p:nvSpPr>
            <p:cNvPr id="116" name="TextBox 26">
              <a:extLst>
                <a:ext uri="{FF2B5EF4-FFF2-40B4-BE49-F238E27FC236}">
                  <a16:creationId xmlns:a16="http://schemas.microsoft.com/office/drawing/2014/main" id="{4CE096EC-181E-4AEC-87DE-F9C8AF59D596}"/>
                </a:ext>
              </a:extLst>
            </p:cNvPr>
            <p:cNvSpPr txBox="1"/>
            <p:nvPr/>
          </p:nvSpPr>
          <p:spPr>
            <a:xfrm>
              <a:off x="3581005" y="2639640"/>
              <a:ext cx="670634" cy="242592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defPPr>
                <a:defRPr lang="en-US"/>
              </a:defPPr>
              <a:lvl1pPr>
                <a:lnSpc>
                  <a:spcPct val="90000"/>
                </a:lnSpc>
                <a:spcBef>
                  <a:spcPct val="0"/>
                </a:spcBef>
                <a:buNone/>
                <a:defRPr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defRPr>
              </a:lvl1pPr>
            </a:lstStyle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HSP90</a:t>
              </a:r>
            </a:p>
          </p:txBody>
        </p:sp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21423952-89BB-4321-84A7-1BC9CBA6555B}"/>
                </a:ext>
              </a:extLst>
            </p:cNvPr>
            <p:cNvGrpSpPr/>
            <p:nvPr/>
          </p:nvGrpSpPr>
          <p:grpSpPr>
            <a:xfrm>
              <a:off x="3605952" y="2175968"/>
              <a:ext cx="2093251" cy="328511"/>
              <a:chOff x="3506004" y="3812448"/>
              <a:chExt cx="2240421" cy="328511"/>
            </a:xfrm>
          </p:grpSpPr>
          <p:sp>
            <p:nvSpPr>
              <p:cNvPr id="121" name="TextBox 26">
                <a:extLst>
                  <a:ext uri="{FF2B5EF4-FFF2-40B4-BE49-F238E27FC236}">
                    <a16:creationId xmlns:a16="http://schemas.microsoft.com/office/drawing/2014/main" id="{A150B793-1E5C-445C-8A6B-491A74CA52F8}"/>
                  </a:ext>
                </a:extLst>
              </p:cNvPr>
              <p:cNvSpPr txBox="1"/>
              <p:nvPr/>
            </p:nvSpPr>
            <p:spPr>
              <a:xfrm>
                <a:off x="3506004" y="3898366"/>
                <a:ext cx="697112" cy="242593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defPPr>
                  <a:defRPr lang="en-US"/>
                </a:defPPr>
                <a:lvl1pPr>
                  <a:lnSpc>
                    <a:spcPct val="90000"/>
                  </a:lnSpc>
                  <a:spcBef>
                    <a:spcPct val="0"/>
                  </a:spcBef>
                  <a:buNone/>
                  <a:defRPr>
                    <a:latin typeface="Times New Roman" panose="02020603050405020304" pitchFamily="18" charset="0"/>
                    <a:ea typeface="+mj-ea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Bmal1</a:t>
                </a:r>
              </a:p>
            </p:txBody>
          </p:sp>
          <p:pic>
            <p:nvPicPr>
              <p:cNvPr id="122" name="Picture 121">
                <a:extLst>
                  <a:ext uri="{FF2B5EF4-FFF2-40B4-BE49-F238E27FC236}">
                    <a16:creationId xmlns:a16="http://schemas.microsoft.com/office/drawing/2014/main" id="{091F7FE0-124A-42E8-B0D5-271A06CE32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" contrast="1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081438" y="3812448"/>
                <a:ext cx="1664987" cy="28304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pic>
          <p:nvPicPr>
            <p:cNvPr id="118" name="Picture 117">
              <a:extLst>
                <a:ext uri="{FF2B5EF4-FFF2-40B4-BE49-F238E27FC236}">
                  <a16:creationId xmlns:a16="http://schemas.microsoft.com/office/drawing/2014/main" id="{25E3D393-1DBA-4733-A77D-258AC6ED295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38254" y="2541073"/>
              <a:ext cx="1555618" cy="28653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818CD613-0788-4402-A5B6-8977C2541666}"/>
                </a:ext>
              </a:extLst>
            </p:cNvPr>
            <p:cNvCxnSpPr/>
            <p:nvPr/>
          </p:nvCxnSpPr>
          <p:spPr>
            <a:xfrm>
              <a:off x="4631692" y="1948919"/>
              <a:ext cx="99378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41894AC7-AB21-4620-8529-3EFE8907648A}"/>
                </a:ext>
              </a:extLst>
            </p:cNvPr>
            <p:cNvCxnSpPr/>
            <p:nvPr/>
          </p:nvCxnSpPr>
          <p:spPr>
            <a:xfrm>
              <a:off x="4140031" y="1958515"/>
              <a:ext cx="3206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3" name="TextBox 122">
            <a:extLst>
              <a:ext uri="{FF2B5EF4-FFF2-40B4-BE49-F238E27FC236}">
                <a16:creationId xmlns:a16="http://schemas.microsoft.com/office/drawing/2014/main" id="{2B1906F8-6475-4D39-8496-3C209CAB7535}"/>
              </a:ext>
            </a:extLst>
          </p:cNvPr>
          <p:cNvSpPr txBox="1"/>
          <p:nvPr/>
        </p:nvSpPr>
        <p:spPr>
          <a:xfrm>
            <a:off x="237629" y="2574632"/>
            <a:ext cx="4168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4286C60C-0A67-4512-A9BA-859D8D350E03}"/>
              </a:ext>
            </a:extLst>
          </p:cNvPr>
          <p:cNvSpPr txBox="1"/>
          <p:nvPr/>
        </p:nvSpPr>
        <p:spPr>
          <a:xfrm>
            <a:off x="237629" y="4613701"/>
            <a:ext cx="63228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, B) Average original tracing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er2::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dLuc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uciferase recordings for 6 days of 3T3-L1 preadipocytes (A) and C3H10T1/2 (B) treated by Nobiletin at indicate concentration. (C) Immunoblot of Baml1 protein at day 0 and day 6 3T3-L1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dipogen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ifferentiation. </a:t>
            </a:r>
          </a:p>
        </p:txBody>
      </p:sp>
    </p:spTree>
    <p:extLst>
      <p:ext uri="{BB962C8B-B14F-4D97-AF65-F5344CB8AC3E}">
        <p14:creationId xmlns:p14="http://schemas.microsoft.com/office/powerpoint/2010/main" val="873358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>
            <a:extLst>
              <a:ext uri="{FF2B5EF4-FFF2-40B4-BE49-F238E27FC236}">
                <a16:creationId xmlns:a16="http://schemas.microsoft.com/office/drawing/2014/main" id="{F759BFE5-8D2E-4180-9EDA-38AEC411B9A9}"/>
              </a:ext>
            </a:extLst>
          </p:cNvPr>
          <p:cNvSpPr txBox="1"/>
          <p:nvPr/>
        </p:nvSpPr>
        <p:spPr>
          <a:xfrm>
            <a:off x="246146" y="243528"/>
            <a:ext cx="15263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02D2264-4AC6-462E-A547-BD4F503379AB}"/>
              </a:ext>
            </a:extLst>
          </p:cNvPr>
          <p:cNvSpPr txBox="1"/>
          <p:nvPr/>
        </p:nvSpPr>
        <p:spPr>
          <a:xfrm>
            <a:off x="179490" y="5176115"/>
            <a:ext cx="63228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phase contrast (A) and Bodipy staining (B) of day 6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dipogen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ifferentiation of 3T3-L1 preadipocytes treated by Nobiletin at indicated concentration. 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BF8B290-CC4B-461A-9B9D-3FD5D298A060}"/>
              </a:ext>
            </a:extLst>
          </p:cNvPr>
          <p:cNvSpPr txBox="1"/>
          <p:nvPr/>
        </p:nvSpPr>
        <p:spPr>
          <a:xfrm>
            <a:off x="240314" y="676437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C033363-3575-4D2F-A1E9-F7EA58C44F36}"/>
              </a:ext>
            </a:extLst>
          </p:cNvPr>
          <p:cNvSpPr txBox="1"/>
          <p:nvPr/>
        </p:nvSpPr>
        <p:spPr>
          <a:xfrm>
            <a:off x="248441" y="2253156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DBE5FA2D-EF4C-4627-ADAD-81E558634E92}"/>
              </a:ext>
            </a:extLst>
          </p:cNvPr>
          <p:cNvGrpSpPr/>
          <p:nvPr/>
        </p:nvGrpSpPr>
        <p:grpSpPr>
          <a:xfrm>
            <a:off x="579031" y="773827"/>
            <a:ext cx="3843440" cy="1242178"/>
            <a:chOff x="1692828" y="5244101"/>
            <a:chExt cx="4377631" cy="1477361"/>
          </a:xfrm>
        </p:grpSpPr>
        <p:sp>
          <p:nvSpPr>
            <p:cNvPr id="24" name="Title 1">
              <a:extLst>
                <a:ext uri="{FF2B5EF4-FFF2-40B4-BE49-F238E27FC236}">
                  <a16:creationId xmlns:a16="http://schemas.microsoft.com/office/drawing/2014/main" id="{0CB29239-5BB6-401A-A375-5E16A4968AD2}"/>
                </a:ext>
              </a:extLst>
            </p:cNvPr>
            <p:cNvSpPr txBox="1">
              <a:spLocks/>
            </p:cNvSpPr>
            <p:nvPr/>
          </p:nvSpPr>
          <p:spPr>
            <a:xfrm>
              <a:off x="2055467" y="5265547"/>
              <a:ext cx="759195" cy="277745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25" name="Title 1">
              <a:extLst>
                <a:ext uri="{FF2B5EF4-FFF2-40B4-BE49-F238E27FC236}">
                  <a16:creationId xmlns:a16="http://schemas.microsoft.com/office/drawing/2014/main" id="{A02CDA78-0DD7-4102-874A-F58E866743D0}"/>
                </a:ext>
              </a:extLst>
            </p:cNvPr>
            <p:cNvSpPr txBox="1">
              <a:spLocks/>
            </p:cNvSpPr>
            <p:nvPr/>
          </p:nvSpPr>
          <p:spPr>
            <a:xfrm>
              <a:off x="3401739" y="5261362"/>
              <a:ext cx="924579" cy="277745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B(2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9E54EE65-9450-43D0-9850-D51FC246BFE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63920" y="5509411"/>
              <a:ext cx="1435447" cy="1209006"/>
            </a:xfrm>
            <a:prstGeom prst="rect">
              <a:avLst/>
            </a:prstGeom>
          </p:spPr>
        </p:pic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1C1C2CFF-17F3-4658-9E39-54C82442C42C}"/>
                </a:ext>
              </a:extLst>
            </p:cNvPr>
            <p:cNvGrpSpPr/>
            <p:nvPr/>
          </p:nvGrpSpPr>
          <p:grpSpPr>
            <a:xfrm>
              <a:off x="1692828" y="5512456"/>
              <a:ext cx="1435447" cy="1209006"/>
              <a:chOff x="1183866" y="5478428"/>
              <a:chExt cx="1435447" cy="1209006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BACC6A9C-9371-41B4-A8A3-68D346E898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83866" y="5478428"/>
                <a:ext cx="1435447" cy="1209006"/>
              </a:xfrm>
              <a:prstGeom prst="rect">
                <a:avLst/>
              </a:prstGeom>
            </p:spPr>
          </p:pic>
          <p:grpSp>
            <p:nvGrpSpPr>
              <p:cNvPr id="51" name="Group 50">
                <a:extLst>
                  <a:ext uri="{FF2B5EF4-FFF2-40B4-BE49-F238E27FC236}">
                    <a16:creationId xmlns:a16="http://schemas.microsoft.com/office/drawing/2014/main" id="{70AAA33B-572D-4523-9CA7-BC5B1DEC66F5}"/>
                  </a:ext>
                </a:extLst>
              </p:cNvPr>
              <p:cNvGrpSpPr/>
              <p:nvPr/>
            </p:nvGrpSpPr>
            <p:grpSpPr>
              <a:xfrm>
                <a:off x="2026596" y="6320385"/>
                <a:ext cx="526777" cy="261606"/>
                <a:chOff x="3606326" y="6171207"/>
                <a:chExt cx="590644" cy="315531"/>
              </a:xfrm>
            </p:grpSpPr>
            <p:cxnSp>
              <p:nvCxnSpPr>
                <p:cNvPr id="52" name="Straight Connector 51">
                  <a:extLst>
                    <a:ext uri="{FF2B5EF4-FFF2-40B4-BE49-F238E27FC236}">
                      <a16:creationId xmlns:a16="http://schemas.microsoft.com/office/drawing/2014/main" id="{96523DEA-FC78-4548-B06D-A2066F1166F6}"/>
                    </a:ext>
                  </a:extLst>
                </p:cNvPr>
                <p:cNvCxnSpPr/>
                <p:nvPr/>
              </p:nvCxnSpPr>
              <p:spPr>
                <a:xfrm>
                  <a:off x="3818609" y="6486738"/>
                  <a:ext cx="255182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06D702E7-7643-494D-869B-24FE462DBEE6}"/>
                    </a:ext>
                  </a:extLst>
                </p:cNvPr>
                <p:cNvSpPr txBox="1"/>
                <p:nvPr/>
              </p:nvSpPr>
              <p:spPr>
                <a:xfrm>
                  <a:off x="3606326" y="6171207"/>
                  <a:ext cx="590644" cy="2784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r>
                    <a:rPr lang="el-GR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</a:p>
              </p:txBody>
            </p:sp>
          </p:grp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95401A5B-CCD6-4764-A795-1787D90F92D7}"/>
                </a:ext>
              </a:extLst>
            </p:cNvPr>
            <p:cNvGrpSpPr/>
            <p:nvPr/>
          </p:nvGrpSpPr>
          <p:grpSpPr>
            <a:xfrm>
              <a:off x="4046383" y="6372387"/>
              <a:ext cx="526777" cy="252317"/>
              <a:chOff x="3616431" y="6182411"/>
              <a:chExt cx="590644" cy="304327"/>
            </a:xfrm>
          </p:grpSpPr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53E04797-9932-479C-BDE5-F4B3950F6C6F}"/>
                  </a:ext>
                </a:extLst>
              </p:cNvPr>
              <p:cNvCxnSpPr/>
              <p:nvPr/>
            </p:nvCxnSpPr>
            <p:spPr>
              <a:xfrm>
                <a:off x="3818609" y="6486738"/>
                <a:ext cx="255182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4B3F071F-6483-4639-8A13-FA50B9DAF1EF}"/>
                  </a:ext>
                </a:extLst>
              </p:cNvPr>
              <p:cNvSpPr txBox="1"/>
              <p:nvPr/>
            </p:nvSpPr>
            <p:spPr>
              <a:xfrm>
                <a:off x="3616431" y="6182411"/>
                <a:ext cx="590644" cy="2784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r>
                  <a:rPr lang="el-GR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79879DF0-9F6F-4B51-89D7-07AAA82AA75B}"/>
                </a:ext>
              </a:extLst>
            </p:cNvPr>
            <p:cNvGrpSpPr/>
            <p:nvPr/>
          </p:nvGrpSpPr>
          <p:grpSpPr>
            <a:xfrm>
              <a:off x="4635012" y="5509411"/>
              <a:ext cx="1435447" cy="1209006"/>
              <a:chOff x="1183866" y="7960778"/>
              <a:chExt cx="1435447" cy="1209006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5535A1D9-5E7C-413E-A815-002B071512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83866" y="7960778"/>
                <a:ext cx="1435447" cy="1209006"/>
              </a:xfrm>
              <a:prstGeom prst="rect">
                <a:avLst/>
              </a:prstGeom>
            </p:spPr>
          </p:pic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BBF2B4E7-E76D-493B-A812-20DAE14D57BD}"/>
                  </a:ext>
                </a:extLst>
              </p:cNvPr>
              <p:cNvGrpSpPr/>
              <p:nvPr/>
            </p:nvGrpSpPr>
            <p:grpSpPr>
              <a:xfrm>
                <a:off x="2054670" y="8815105"/>
                <a:ext cx="526777" cy="242793"/>
                <a:chOff x="3567902" y="6228362"/>
                <a:chExt cx="590644" cy="292840"/>
              </a:xfrm>
            </p:grpSpPr>
            <p:cxnSp>
              <p:nvCxnSpPr>
                <p:cNvPr id="58" name="Straight Connector 57">
                  <a:extLst>
                    <a:ext uri="{FF2B5EF4-FFF2-40B4-BE49-F238E27FC236}">
                      <a16:creationId xmlns:a16="http://schemas.microsoft.com/office/drawing/2014/main" id="{72F3D6F2-DFA3-463E-975A-DE6EBA32EE18}"/>
                    </a:ext>
                  </a:extLst>
                </p:cNvPr>
                <p:cNvCxnSpPr/>
                <p:nvPr/>
              </p:nvCxnSpPr>
              <p:spPr>
                <a:xfrm>
                  <a:off x="3818609" y="6521202"/>
                  <a:ext cx="255182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B32F9B82-000B-49A8-B25B-DFE10E076582}"/>
                    </a:ext>
                  </a:extLst>
                </p:cNvPr>
                <p:cNvSpPr txBox="1"/>
                <p:nvPr/>
              </p:nvSpPr>
              <p:spPr>
                <a:xfrm>
                  <a:off x="3567902" y="6228362"/>
                  <a:ext cx="590644" cy="2784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r>
                    <a:rPr lang="el-GR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</a:p>
              </p:txBody>
            </p:sp>
          </p:grpSp>
        </p:grpSp>
        <p:sp>
          <p:nvSpPr>
            <p:cNvPr id="60" name="Title 1">
              <a:extLst>
                <a:ext uri="{FF2B5EF4-FFF2-40B4-BE49-F238E27FC236}">
                  <a16:creationId xmlns:a16="http://schemas.microsoft.com/office/drawing/2014/main" id="{C48B3575-4BC5-48C8-9E98-B31ECC376B92}"/>
                </a:ext>
              </a:extLst>
            </p:cNvPr>
            <p:cNvSpPr txBox="1">
              <a:spLocks/>
            </p:cNvSpPr>
            <p:nvPr/>
          </p:nvSpPr>
          <p:spPr>
            <a:xfrm>
              <a:off x="4838588" y="5244101"/>
              <a:ext cx="1084694" cy="277745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B(5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</a:p>
          </p:txBody>
        </p:sp>
      </p:grpSp>
      <p:grpSp>
        <p:nvGrpSpPr>
          <p:cNvPr id="94" name="Group 93">
            <a:extLst>
              <a:ext uri="{FF2B5EF4-FFF2-40B4-BE49-F238E27FC236}">
                <a16:creationId xmlns:a16="http://schemas.microsoft.com/office/drawing/2014/main" id="{E9EC55E7-A42B-4820-ABF4-FDD2C76B6C3A}"/>
              </a:ext>
            </a:extLst>
          </p:cNvPr>
          <p:cNvGrpSpPr/>
          <p:nvPr/>
        </p:nvGrpSpPr>
        <p:grpSpPr>
          <a:xfrm>
            <a:off x="350478" y="2236520"/>
            <a:ext cx="4111625" cy="2216494"/>
            <a:chOff x="980893" y="3230149"/>
            <a:chExt cx="4385097" cy="2326213"/>
          </a:xfrm>
        </p:grpSpPr>
        <p:sp>
          <p:nvSpPr>
            <p:cNvPr id="18" name="Title 1">
              <a:extLst>
                <a:ext uri="{FF2B5EF4-FFF2-40B4-BE49-F238E27FC236}">
                  <a16:creationId xmlns:a16="http://schemas.microsoft.com/office/drawing/2014/main" id="{68930A6E-48D0-4760-B0D9-EFCF0197A3C3}"/>
                </a:ext>
              </a:extLst>
            </p:cNvPr>
            <p:cNvSpPr txBox="1">
              <a:spLocks/>
            </p:cNvSpPr>
            <p:nvPr/>
          </p:nvSpPr>
          <p:spPr>
            <a:xfrm rot="16200000">
              <a:off x="806046" y="3832030"/>
              <a:ext cx="623083" cy="273389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000" dirty="0">
                  <a:solidFill>
                    <a:srgbClr val="00CC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odipy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715A22B-B1F1-4A57-B483-4CC66034CBA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11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254750" y="3490500"/>
              <a:ext cx="1336645" cy="1011539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A9FEF7E5-83A9-4D88-86A6-A9A6CD175BE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639374" y="3490500"/>
              <a:ext cx="1336645" cy="1011539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CABBD826-157B-4B8E-979E-8375B94734C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024661" y="3490500"/>
              <a:ext cx="1336645" cy="1011539"/>
            </a:xfrm>
            <a:prstGeom prst="rect">
              <a:avLst/>
            </a:prstGeom>
          </p:spPr>
        </p:pic>
        <p:sp>
          <p:nvSpPr>
            <p:cNvPr id="62" name="Title 1">
              <a:extLst>
                <a:ext uri="{FF2B5EF4-FFF2-40B4-BE49-F238E27FC236}">
                  <a16:creationId xmlns:a16="http://schemas.microsoft.com/office/drawing/2014/main" id="{5840D98E-C328-4021-889D-758F90653E51}"/>
                </a:ext>
              </a:extLst>
            </p:cNvPr>
            <p:cNvSpPr txBox="1">
              <a:spLocks/>
            </p:cNvSpPr>
            <p:nvPr/>
          </p:nvSpPr>
          <p:spPr>
            <a:xfrm>
              <a:off x="1558322" y="3244499"/>
              <a:ext cx="759195" cy="274058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63" name="Title 1">
              <a:extLst>
                <a:ext uri="{FF2B5EF4-FFF2-40B4-BE49-F238E27FC236}">
                  <a16:creationId xmlns:a16="http://schemas.microsoft.com/office/drawing/2014/main" id="{EC19B39E-1C20-43BF-B46E-3C3D963CD4D4}"/>
                </a:ext>
              </a:extLst>
            </p:cNvPr>
            <p:cNvSpPr txBox="1">
              <a:spLocks/>
            </p:cNvSpPr>
            <p:nvPr/>
          </p:nvSpPr>
          <p:spPr>
            <a:xfrm>
              <a:off x="2835003" y="3230149"/>
              <a:ext cx="1084694" cy="274058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B(2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64" name="Title 1">
              <a:extLst>
                <a:ext uri="{FF2B5EF4-FFF2-40B4-BE49-F238E27FC236}">
                  <a16:creationId xmlns:a16="http://schemas.microsoft.com/office/drawing/2014/main" id="{0E5C9550-4176-42C8-9829-425E7F379684}"/>
                </a:ext>
              </a:extLst>
            </p:cNvPr>
            <p:cNvSpPr txBox="1">
              <a:spLocks/>
            </p:cNvSpPr>
            <p:nvPr/>
          </p:nvSpPr>
          <p:spPr>
            <a:xfrm>
              <a:off x="4245024" y="3239240"/>
              <a:ext cx="983409" cy="274058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OB(5</a:t>
              </a:r>
              <a:r>
                <a:rPr lang="el-G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</a:p>
          </p:txBody>
        </p:sp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9F699F17-B71A-432E-BF08-140D53E28062}"/>
                </a:ext>
              </a:extLst>
            </p:cNvPr>
            <p:cNvGrpSpPr/>
            <p:nvPr/>
          </p:nvGrpSpPr>
          <p:grpSpPr>
            <a:xfrm>
              <a:off x="988843" y="4542908"/>
              <a:ext cx="4377147" cy="1013454"/>
              <a:chOff x="980180" y="4712009"/>
              <a:chExt cx="4377147" cy="1013454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862091C4-C4FA-450A-A428-30789A61B3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50000"/>
                        </a14:imgEffect>
                        <a14:imgEffect>
                          <a14:brightnessContrast bright="10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254750" y="4713924"/>
                <a:ext cx="1336645" cy="1011539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B1A24081-DD6D-4B98-8D89-C7E06D6CE5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sharpenSoften amount="50000"/>
                        </a14:imgEffect>
                        <a14:imgEffect>
                          <a14:brightnessContrast bright="10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639374" y="4712009"/>
                <a:ext cx="1336645" cy="1011539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E11EF07C-AF0A-4644-9C3D-9FD8C6D7C0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sharpenSoften amount="50000"/>
                        </a14:imgEffect>
                        <a14:imgEffect>
                          <a14:brightnessContrast bright="8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020682" y="4712009"/>
                <a:ext cx="1336645" cy="1011539"/>
              </a:xfrm>
              <a:prstGeom prst="rect">
                <a:avLst/>
              </a:prstGeom>
            </p:spPr>
          </p:pic>
          <p:sp>
            <p:nvSpPr>
              <p:cNvPr id="65" name="Title 1">
                <a:extLst>
                  <a:ext uri="{FF2B5EF4-FFF2-40B4-BE49-F238E27FC236}">
                    <a16:creationId xmlns:a16="http://schemas.microsoft.com/office/drawing/2014/main" id="{9FFD585C-99B5-454B-9E44-AC01B69E2CBE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629057" y="5063132"/>
                <a:ext cx="975635" cy="273389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lvl1pPr algn="ctr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60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1000" dirty="0">
                    <a:solidFill>
                      <a:srgbClr val="00CC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dipy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sz="10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grpSp>
            <p:nvGrpSpPr>
              <p:cNvPr id="87" name="Group 86">
                <a:extLst>
                  <a:ext uri="{FF2B5EF4-FFF2-40B4-BE49-F238E27FC236}">
                    <a16:creationId xmlns:a16="http://schemas.microsoft.com/office/drawing/2014/main" id="{3C598613-304E-406E-AF99-58E872B58C3E}"/>
                  </a:ext>
                </a:extLst>
              </p:cNvPr>
              <p:cNvGrpSpPr/>
              <p:nvPr/>
            </p:nvGrpSpPr>
            <p:grpSpPr>
              <a:xfrm>
                <a:off x="2088546" y="5386757"/>
                <a:ext cx="438729" cy="229635"/>
                <a:chOff x="1793484" y="6449356"/>
                <a:chExt cx="491746" cy="318260"/>
              </a:xfrm>
            </p:grpSpPr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id="{6F995BE0-80F7-4ADC-98FA-DE2038121AAF}"/>
                    </a:ext>
                  </a:extLst>
                </p:cNvPr>
                <p:cNvCxnSpPr/>
                <p:nvPr/>
              </p:nvCxnSpPr>
              <p:spPr>
                <a:xfrm>
                  <a:off x="2019612" y="6767616"/>
                  <a:ext cx="23284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AFE0EC81-2BA5-4D38-8B64-E453298C26D5}"/>
                    </a:ext>
                  </a:extLst>
                </p:cNvPr>
                <p:cNvSpPr txBox="1"/>
                <p:nvPr/>
              </p:nvSpPr>
              <p:spPr>
                <a:xfrm>
                  <a:off x="1793484" y="6449356"/>
                  <a:ext cx="491746" cy="19138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r>
                    <a:rPr lang="el-GR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μ</a:t>
                  </a:r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</a:p>
              </p:txBody>
            </p:sp>
          </p:grp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EA13DC9D-B22C-48A1-8A60-47634A0C027F}"/>
                </a:ext>
              </a:extLst>
            </p:cNvPr>
            <p:cNvGrpSpPr/>
            <p:nvPr/>
          </p:nvGrpSpPr>
          <p:grpSpPr>
            <a:xfrm>
              <a:off x="2059302" y="4180458"/>
              <a:ext cx="438729" cy="221290"/>
              <a:chOff x="1812438" y="6460921"/>
              <a:chExt cx="491746" cy="306695"/>
            </a:xfrm>
          </p:grpSpPr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44076246-EC3E-4A06-A397-1DBA907A2F02}"/>
                  </a:ext>
                </a:extLst>
              </p:cNvPr>
              <p:cNvCxnSpPr/>
              <p:nvPr/>
            </p:nvCxnSpPr>
            <p:spPr>
              <a:xfrm>
                <a:off x="2019612" y="6767616"/>
                <a:ext cx="23284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7C748E1B-1B07-4FAE-BE26-939BAE5C4B08}"/>
                  </a:ext>
                </a:extLst>
              </p:cNvPr>
              <p:cNvSpPr txBox="1"/>
              <p:nvPr/>
            </p:nvSpPr>
            <p:spPr>
              <a:xfrm>
                <a:off x="1812438" y="6460921"/>
                <a:ext cx="491746" cy="1913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r>
                  <a:rPr lang="el-GR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sz="9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82901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9799F5E-57BA-46B7-A72D-002589080DD6}"/>
              </a:ext>
            </a:extLst>
          </p:cNvPr>
          <p:cNvSpPr txBox="1"/>
          <p:nvPr/>
        </p:nvSpPr>
        <p:spPr>
          <a:xfrm>
            <a:off x="100421" y="288147"/>
            <a:ext cx="15618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3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3" name="Group 152">
            <a:extLst>
              <a:ext uri="{FF2B5EF4-FFF2-40B4-BE49-F238E27FC236}">
                <a16:creationId xmlns:a16="http://schemas.microsoft.com/office/drawing/2014/main" id="{61ED2983-88EE-44E9-9B06-EDB111D6174C}"/>
              </a:ext>
            </a:extLst>
          </p:cNvPr>
          <p:cNvGrpSpPr/>
          <p:nvPr/>
        </p:nvGrpSpPr>
        <p:grpSpPr>
          <a:xfrm>
            <a:off x="406969" y="704640"/>
            <a:ext cx="3487600" cy="2835429"/>
            <a:chOff x="676468" y="1964056"/>
            <a:chExt cx="3570380" cy="2878288"/>
          </a:xfrm>
        </p:grpSpPr>
        <p:sp>
          <p:nvSpPr>
            <p:cNvPr id="154" name="Title 1">
              <a:extLst>
                <a:ext uri="{FF2B5EF4-FFF2-40B4-BE49-F238E27FC236}">
                  <a16:creationId xmlns:a16="http://schemas.microsoft.com/office/drawing/2014/main" id="{96B74DAB-5C95-403A-A9CE-DC5EDF16C9AD}"/>
                </a:ext>
              </a:extLst>
            </p:cNvPr>
            <p:cNvSpPr txBox="1">
              <a:spLocks/>
            </p:cNvSpPr>
            <p:nvPr/>
          </p:nvSpPr>
          <p:spPr>
            <a:xfrm>
              <a:off x="3192462" y="1964056"/>
              <a:ext cx="1054386" cy="287403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ob (5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</a:p>
          </p:txBody>
        </p:sp>
        <p:sp>
          <p:nvSpPr>
            <p:cNvPr id="155" name="Title 1">
              <a:extLst>
                <a:ext uri="{FF2B5EF4-FFF2-40B4-BE49-F238E27FC236}">
                  <a16:creationId xmlns:a16="http://schemas.microsoft.com/office/drawing/2014/main" id="{1952A346-DF06-4C08-A7AB-A7D4539E6424}"/>
                </a:ext>
              </a:extLst>
            </p:cNvPr>
            <p:cNvSpPr txBox="1">
              <a:spLocks/>
            </p:cNvSpPr>
            <p:nvPr/>
          </p:nvSpPr>
          <p:spPr>
            <a:xfrm>
              <a:off x="1094522" y="1964056"/>
              <a:ext cx="737981" cy="287403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156" name="Title 1">
              <a:extLst>
                <a:ext uri="{FF2B5EF4-FFF2-40B4-BE49-F238E27FC236}">
                  <a16:creationId xmlns:a16="http://schemas.microsoft.com/office/drawing/2014/main" id="{EAE3C9F0-DAB5-4F36-9514-62C63F8A8B17}"/>
                </a:ext>
              </a:extLst>
            </p:cNvPr>
            <p:cNvSpPr txBox="1">
              <a:spLocks/>
            </p:cNvSpPr>
            <p:nvPr/>
          </p:nvSpPr>
          <p:spPr>
            <a:xfrm>
              <a:off x="2081325" y="1964056"/>
              <a:ext cx="904494" cy="287403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ob (2 </a:t>
              </a:r>
              <a:r>
                <a:rPr lang="el-GR" sz="11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M)</a:t>
              </a:r>
            </a:p>
          </p:txBody>
        </p:sp>
        <p:grpSp>
          <p:nvGrpSpPr>
            <p:cNvPr id="157" name="Group 156">
              <a:extLst>
                <a:ext uri="{FF2B5EF4-FFF2-40B4-BE49-F238E27FC236}">
                  <a16:creationId xmlns:a16="http://schemas.microsoft.com/office/drawing/2014/main" id="{606D3EC6-38B0-4113-9DEF-BEF8C7957ABB}"/>
                </a:ext>
              </a:extLst>
            </p:cNvPr>
            <p:cNvGrpSpPr/>
            <p:nvPr/>
          </p:nvGrpSpPr>
          <p:grpSpPr>
            <a:xfrm>
              <a:off x="676468" y="2213225"/>
              <a:ext cx="3490015" cy="2629119"/>
              <a:chOff x="680998" y="2210574"/>
              <a:chExt cx="4758782" cy="3304543"/>
            </a:xfrm>
          </p:grpSpPr>
          <p:pic>
            <p:nvPicPr>
              <p:cNvPr id="158" name="图片 22">
                <a:extLst>
                  <a:ext uri="{FF2B5EF4-FFF2-40B4-BE49-F238E27FC236}">
                    <a16:creationId xmlns:a16="http://schemas.microsoft.com/office/drawing/2014/main" id="{12E0B3C2-F6C9-464D-9F9A-76CD00AE04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1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3776" y="3335989"/>
                <a:ext cx="1483049" cy="1063885"/>
              </a:xfrm>
              <a:prstGeom prst="rect">
                <a:avLst/>
              </a:prstGeom>
            </p:spPr>
          </p:pic>
          <p:pic>
            <p:nvPicPr>
              <p:cNvPr id="159" name="图片 26">
                <a:extLst>
                  <a:ext uri="{FF2B5EF4-FFF2-40B4-BE49-F238E27FC236}">
                    <a16:creationId xmlns:a16="http://schemas.microsoft.com/office/drawing/2014/main" id="{F43684E7-78BE-46BC-A54C-1E738F7BDEC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25000"/>
                        </a14:imgEffect>
                        <a14:imgEffect>
                          <a14:brightnessContrast bright="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3776" y="2223542"/>
                <a:ext cx="1483049" cy="1063885"/>
              </a:xfrm>
              <a:prstGeom prst="rect">
                <a:avLst/>
              </a:prstGeom>
            </p:spPr>
          </p:pic>
          <p:pic>
            <p:nvPicPr>
              <p:cNvPr id="160" name="图片 30">
                <a:extLst>
                  <a:ext uri="{FF2B5EF4-FFF2-40B4-BE49-F238E27FC236}">
                    <a16:creationId xmlns:a16="http://schemas.microsoft.com/office/drawing/2014/main" id="{A8BEC132-218A-489E-8B96-1281DDEB6F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24915" y="3335989"/>
                <a:ext cx="1483049" cy="1063885"/>
              </a:xfrm>
              <a:prstGeom prst="rect">
                <a:avLst/>
              </a:prstGeom>
            </p:spPr>
          </p:pic>
          <p:pic>
            <p:nvPicPr>
              <p:cNvPr id="161" name="图片 33">
                <a:extLst>
                  <a:ext uri="{FF2B5EF4-FFF2-40B4-BE49-F238E27FC236}">
                    <a16:creationId xmlns:a16="http://schemas.microsoft.com/office/drawing/2014/main" id="{82377EBD-D19E-45B6-BF4C-8C3E1114C9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25000"/>
                        </a14:imgEffect>
                        <a14:imgEffect>
                          <a14:brightnessContrast bright="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24915" y="2223542"/>
                <a:ext cx="1483049" cy="1063885"/>
              </a:xfrm>
              <a:prstGeom prst="rect">
                <a:avLst/>
              </a:prstGeom>
            </p:spPr>
          </p:pic>
          <p:pic>
            <p:nvPicPr>
              <p:cNvPr id="162" name="图片 37">
                <a:extLst>
                  <a:ext uri="{FF2B5EF4-FFF2-40B4-BE49-F238E27FC236}">
                    <a16:creationId xmlns:a16="http://schemas.microsoft.com/office/drawing/2014/main" id="{2EB8B5B3-B6E0-463F-82B3-3666E66361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10000" contrast="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48103" y="3335989"/>
                <a:ext cx="1483049" cy="1063885"/>
              </a:xfrm>
              <a:prstGeom prst="rect">
                <a:avLst/>
              </a:prstGeom>
            </p:spPr>
          </p:pic>
          <p:pic>
            <p:nvPicPr>
              <p:cNvPr id="163" name="图片 38">
                <a:extLst>
                  <a:ext uri="{FF2B5EF4-FFF2-40B4-BE49-F238E27FC236}">
                    <a16:creationId xmlns:a16="http://schemas.microsoft.com/office/drawing/2014/main" id="{B8F18FC1-1A80-4227-8535-2FD7873ABA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50000"/>
                        </a14:imgEffect>
                        <a14:imgEffect>
                          <a14:brightnessContrast bright="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48103" y="2223542"/>
                <a:ext cx="1483049" cy="1063885"/>
              </a:xfrm>
              <a:prstGeom prst="rect">
                <a:avLst/>
              </a:prstGeom>
            </p:spPr>
          </p:pic>
          <p:grpSp>
            <p:nvGrpSpPr>
              <p:cNvPr id="164" name="Group 163">
                <a:extLst>
                  <a:ext uri="{FF2B5EF4-FFF2-40B4-BE49-F238E27FC236}">
                    <a16:creationId xmlns:a16="http://schemas.microsoft.com/office/drawing/2014/main" id="{AFC16CF6-78F9-4BD5-9A8C-3DEA5F34FFAA}"/>
                  </a:ext>
                </a:extLst>
              </p:cNvPr>
              <p:cNvGrpSpPr/>
              <p:nvPr/>
            </p:nvGrpSpPr>
            <p:grpSpPr>
              <a:xfrm>
                <a:off x="1754538" y="2837040"/>
                <a:ext cx="662791" cy="297982"/>
                <a:chOff x="1826066" y="5527237"/>
                <a:chExt cx="662791" cy="297982"/>
              </a:xfrm>
            </p:grpSpPr>
            <p:cxnSp>
              <p:nvCxnSpPr>
                <p:cNvPr id="174" name="Straight Connector 173">
                  <a:extLst>
                    <a:ext uri="{FF2B5EF4-FFF2-40B4-BE49-F238E27FC236}">
                      <a16:creationId xmlns:a16="http://schemas.microsoft.com/office/drawing/2014/main" id="{594AD622-A02B-4C30-B709-2C4CA15E1BF8}"/>
                    </a:ext>
                  </a:extLst>
                </p:cNvPr>
                <p:cNvCxnSpPr/>
                <p:nvPr/>
              </p:nvCxnSpPr>
              <p:spPr>
                <a:xfrm>
                  <a:off x="2108142" y="5825219"/>
                  <a:ext cx="220687" cy="0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5" name="TextBox 5">
                  <a:extLst>
                    <a:ext uri="{FF2B5EF4-FFF2-40B4-BE49-F238E27FC236}">
                      <a16:creationId xmlns:a16="http://schemas.microsoft.com/office/drawing/2014/main" id="{504EF5A7-F78C-4735-A000-85D742085DDD}"/>
                    </a:ext>
                  </a:extLst>
                </p:cNvPr>
                <p:cNvSpPr txBox="1"/>
                <p:nvPr/>
              </p:nvSpPr>
              <p:spPr>
                <a:xfrm>
                  <a:off x="1826066" y="5527237"/>
                  <a:ext cx="662791" cy="29451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0µm</a:t>
                  </a:r>
                </a:p>
              </p:txBody>
            </p:sp>
          </p:grpSp>
          <p:cxnSp>
            <p:nvCxnSpPr>
              <p:cNvPr id="165" name="Straight Connector 164">
                <a:extLst>
                  <a:ext uri="{FF2B5EF4-FFF2-40B4-BE49-F238E27FC236}">
                    <a16:creationId xmlns:a16="http://schemas.microsoft.com/office/drawing/2014/main" id="{1F509408-9EC2-4E35-AD32-6DED59F7AC72}"/>
                  </a:ext>
                </a:extLst>
              </p:cNvPr>
              <p:cNvCxnSpPr/>
              <p:nvPr/>
            </p:nvCxnSpPr>
            <p:spPr>
              <a:xfrm>
                <a:off x="2045878" y="4236627"/>
                <a:ext cx="220687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Title 1">
                <a:extLst>
                  <a:ext uri="{FF2B5EF4-FFF2-40B4-BE49-F238E27FC236}">
                    <a16:creationId xmlns:a16="http://schemas.microsoft.com/office/drawing/2014/main" id="{02ABE886-2418-4895-A39B-648A7173401D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399033" y="3681206"/>
                <a:ext cx="813809" cy="249880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lvl1pPr algn="ctr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60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1000" dirty="0">
                    <a:solidFill>
                      <a:srgbClr val="000099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</a:p>
            </p:txBody>
          </p:sp>
          <p:sp>
            <p:nvSpPr>
              <p:cNvPr id="167" name="Title 1">
                <a:extLst>
                  <a:ext uri="{FF2B5EF4-FFF2-40B4-BE49-F238E27FC236}">
                    <a16:creationId xmlns:a16="http://schemas.microsoft.com/office/drawing/2014/main" id="{CC4157C8-F8C7-4AF4-975C-92FBD6C9BF31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406842" y="2560212"/>
                <a:ext cx="862519" cy="163243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lvl1pPr algn="ctr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60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1000" dirty="0">
                    <a:solidFill>
                      <a:srgbClr val="00CC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dipy</a:t>
                </a:r>
              </a:p>
            </p:txBody>
          </p:sp>
          <p:grpSp>
            <p:nvGrpSpPr>
              <p:cNvPr id="168" name="Group 167">
                <a:extLst>
                  <a:ext uri="{FF2B5EF4-FFF2-40B4-BE49-F238E27FC236}">
                    <a16:creationId xmlns:a16="http://schemas.microsoft.com/office/drawing/2014/main" id="{CD9593A4-2FD7-41F5-804D-45CC0F048E01}"/>
                  </a:ext>
                </a:extLst>
              </p:cNvPr>
              <p:cNvGrpSpPr/>
              <p:nvPr/>
            </p:nvGrpSpPr>
            <p:grpSpPr>
              <a:xfrm>
                <a:off x="708258" y="4448435"/>
                <a:ext cx="4731522" cy="1066682"/>
                <a:chOff x="699630" y="3324179"/>
                <a:chExt cx="4731522" cy="1066682"/>
              </a:xfrm>
            </p:grpSpPr>
            <p:pic>
              <p:nvPicPr>
                <p:cNvPr id="169" name="图片 20">
                  <a:extLst>
                    <a:ext uri="{FF2B5EF4-FFF2-40B4-BE49-F238E27FC236}">
                      <a16:creationId xmlns:a16="http://schemas.microsoft.com/office/drawing/2014/main" id="{350361BF-ED69-4124-87D2-F9E2991116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 cstate="print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sharpenSoften amount="25000"/>
                          </a14:imgEffect>
                          <a14:imgEffect>
                            <a14:brightnessContrast bright="3000" contras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3776" y="3326976"/>
                  <a:ext cx="1483049" cy="1063885"/>
                </a:xfrm>
                <a:prstGeom prst="rect">
                  <a:avLst/>
                </a:prstGeom>
              </p:spPr>
            </p:pic>
            <p:pic>
              <p:nvPicPr>
                <p:cNvPr id="170" name="图片 27">
                  <a:extLst>
                    <a:ext uri="{FF2B5EF4-FFF2-40B4-BE49-F238E27FC236}">
                      <a16:creationId xmlns:a16="http://schemas.microsoft.com/office/drawing/2014/main" id="{42668E93-5588-46B9-ACCF-49702161EE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 cstate="print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sharpenSoften amount="25000"/>
                          </a14:imgEffect>
                          <a14:imgEffect>
                            <a14:brightnessContrast bright="3000" contras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24914" y="3326976"/>
                  <a:ext cx="1483049" cy="1063885"/>
                </a:xfrm>
                <a:prstGeom prst="rect">
                  <a:avLst/>
                </a:prstGeom>
              </p:spPr>
            </p:pic>
            <p:pic>
              <p:nvPicPr>
                <p:cNvPr id="171" name="图片 34">
                  <a:extLst>
                    <a:ext uri="{FF2B5EF4-FFF2-40B4-BE49-F238E27FC236}">
                      <a16:creationId xmlns:a16="http://schemas.microsoft.com/office/drawing/2014/main" id="{90BBA884-2E80-4567-81F9-31C625817AE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 cstate="print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sharpenSoften amount="25000"/>
                          </a14:imgEffect>
                          <a14:imgEffect>
                            <a14:brightnessContrast bright="3000" contras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48103" y="3326976"/>
                  <a:ext cx="1483049" cy="1063885"/>
                </a:xfrm>
                <a:prstGeom prst="rect">
                  <a:avLst/>
                </a:prstGeom>
              </p:spPr>
            </p:pic>
            <p:cxnSp>
              <p:nvCxnSpPr>
                <p:cNvPr id="172" name="Straight Connector 171">
                  <a:extLst>
                    <a:ext uri="{FF2B5EF4-FFF2-40B4-BE49-F238E27FC236}">
                      <a16:creationId xmlns:a16="http://schemas.microsoft.com/office/drawing/2014/main" id="{02ABF7A3-B6DB-40F9-AF1B-D5E6C8FE2D0B}"/>
                    </a:ext>
                  </a:extLst>
                </p:cNvPr>
                <p:cNvCxnSpPr/>
                <p:nvPr/>
              </p:nvCxnSpPr>
              <p:spPr>
                <a:xfrm>
                  <a:off x="2060860" y="4230759"/>
                  <a:ext cx="220687" cy="0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3" name="Title 1">
                  <a:extLst>
                    <a:ext uri="{FF2B5EF4-FFF2-40B4-BE49-F238E27FC236}">
                      <a16:creationId xmlns:a16="http://schemas.microsoft.com/office/drawing/2014/main" id="{E19F1F42-AB0F-4C91-9376-884259CA2402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 rot="16200000">
                  <a:off x="345209" y="3678600"/>
                  <a:ext cx="906579" cy="197737"/>
                </a:xfrm>
                <a:prstGeom prst="rect">
                  <a:avLst/>
                </a:prstGeom>
              </p:spPr>
              <p:txBody>
                <a:bodyPr vert="horz" lIns="91440" tIns="45720" rIns="91440" bIns="45720" rtlCol="0" anchor="b">
                  <a:noAutofit/>
                </a:bodyPr>
                <a:lstStyle>
                  <a:lvl1pPr algn="ctr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sz="60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pPr algn="l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rge</a:t>
                  </a:r>
                </a:p>
              </p:txBody>
            </p:sp>
          </p:grpSp>
        </p:grpSp>
      </p:grpSp>
      <p:sp>
        <p:nvSpPr>
          <p:cNvPr id="60" name="TextBox 59">
            <a:extLst>
              <a:ext uri="{FF2B5EF4-FFF2-40B4-BE49-F238E27FC236}">
                <a16:creationId xmlns:a16="http://schemas.microsoft.com/office/drawing/2014/main" id="{5A629420-5ABA-4CF2-A46D-15C3869B89A8}"/>
              </a:ext>
            </a:extLst>
          </p:cNvPr>
          <p:cNvSpPr txBox="1"/>
          <p:nvPr/>
        </p:nvSpPr>
        <p:spPr>
          <a:xfrm>
            <a:off x="217504" y="3895066"/>
            <a:ext cx="57546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Bodipy staining of day 8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dipogen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ifferentiation of C3H10T1/2 mesenchymal stem cells treated by Nobiletin at indicated concentration.  </a:t>
            </a:r>
          </a:p>
        </p:txBody>
      </p:sp>
    </p:spTree>
    <p:extLst>
      <p:ext uri="{BB962C8B-B14F-4D97-AF65-F5344CB8AC3E}">
        <p14:creationId xmlns:p14="http://schemas.microsoft.com/office/powerpoint/2010/main" val="14023166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7A324624-E880-4323-B24C-1B1B86F719D5}"/>
              </a:ext>
            </a:extLst>
          </p:cNvPr>
          <p:cNvSpPr txBox="1"/>
          <p:nvPr/>
        </p:nvSpPr>
        <p:spPr>
          <a:xfrm>
            <a:off x="167214" y="238055"/>
            <a:ext cx="16366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4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2D7EC2B-0FEC-4E22-883D-5F89B3D9C1A6}"/>
              </a:ext>
            </a:extLst>
          </p:cNvPr>
          <p:cNvSpPr txBox="1"/>
          <p:nvPr/>
        </p:nvSpPr>
        <p:spPr>
          <a:xfrm>
            <a:off x="258262" y="3450537"/>
            <a:ext cx="54828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4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dipy staining of day 4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dipogen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ifferentiation of primary preadipocytes isolated fro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o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ontrol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MCt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Bmal1-null (BMKO) mice.  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CF0F896E-C98A-42C7-BD8E-23AFDFC76858}"/>
              </a:ext>
            </a:extLst>
          </p:cNvPr>
          <p:cNvGrpSpPr/>
          <p:nvPr/>
        </p:nvGrpSpPr>
        <p:grpSpPr>
          <a:xfrm>
            <a:off x="3332123" y="710864"/>
            <a:ext cx="3035596" cy="2102918"/>
            <a:chOff x="3452176" y="1965481"/>
            <a:chExt cx="2948624" cy="1968479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894DFD56-564E-4861-891D-85E4B606BA4B}"/>
                </a:ext>
              </a:extLst>
            </p:cNvPr>
            <p:cNvGrpSpPr/>
            <p:nvPr/>
          </p:nvGrpSpPr>
          <p:grpSpPr>
            <a:xfrm>
              <a:off x="3452176" y="1965481"/>
              <a:ext cx="2948624" cy="1968479"/>
              <a:chOff x="6351580" y="2981398"/>
              <a:chExt cx="4682242" cy="2971410"/>
            </a:xfrm>
          </p:grpSpPr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1022CAB4-16B3-4FD0-A06F-9F444D7B546D}"/>
                  </a:ext>
                </a:extLst>
              </p:cNvPr>
              <p:cNvGrpSpPr/>
              <p:nvPr/>
            </p:nvGrpSpPr>
            <p:grpSpPr>
              <a:xfrm>
                <a:off x="6351580" y="2981398"/>
                <a:ext cx="4682242" cy="2971410"/>
                <a:chOff x="6083294" y="2647897"/>
                <a:chExt cx="5075729" cy="3076507"/>
              </a:xfrm>
            </p:grpSpPr>
            <p:grpSp>
              <p:nvGrpSpPr>
                <p:cNvPr id="37" name="Group 36">
                  <a:extLst>
                    <a:ext uri="{FF2B5EF4-FFF2-40B4-BE49-F238E27FC236}">
                      <a16:creationId xmlns:a16="http://schemas.microsoft.com/office/drawing/2014/main" id="{85C3CD85-B678-47B2-A2DD-B4CF59C37DF8}"/>
                    </a:ext>
                  </a:extLst>
                </p:cNvPr>
                <p:cNvGrpSpPr/>
                <p:nvPr/>
              </p:nvGrpSpPr>
              <p:grpSpPr>
                <a:xfrm>
                  <a:off x="6083294" y="3188669"/>
                  <a:ext cx="5075729" cy="2535735"/>
                  <a:chOff x="6083294" y="3247420"/>
                  <a:chExt cx="5075729" cy="2535735"/>
                </a:xfrm>
              </p:grpSpPr>
              <p:pic>
                <p:nvPicPr>
                  <p:cNvPr id="43" name="图片 3">
                    <a:extLst>
                      <a:ext uri="{FF2B5EF4-FFF2-40B4-BE49-F238E27FC236}">
                        <a16:creationId xmlns:a16="http://schemas.microsoft.com/office/drawing/2014/main" id="{0529F03A-6CAA-437A-A810-D156B773F7E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sharpenSoften amount="15000"/>
                            </a14:imgEffect>
                            <a14:imgEffect>
                              <a14:brightnessContrast bright="30000" contrast="1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083294" y="3247420"/>
                    <a:ext cx="1645200" cy="1233900"/>
                  </a:xfrm>
                  <a:prstGeom prst="rect">
                    <a:avLst/>
                  </a:prstGeom>
                </p:spPr>
              </p:pic>
              <p:pic>
                <p:nvPicPr>
                  <p:cNvPr id="44" name="图片 11">
                    <a:extLst>
                      <a:ext uri="{FF2B5EF4-FFF2-40B4-BE49-F238E27FC236}">
                        <a16:creationId xmlns:a16="http://schemas.microsoft.com/office/drawing/2014/main" id="{CF72755E-ED70-4A40-BDEA-2909A5E4B81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sharpenSoften amount="15000"/>
                            </a14:imgEffect>
                            <a14:imgEffect>
                              <a14:brightnessContrast bright="30000" contrast="1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806107" y="3247420"/>
                    <a:ext cx="1645200" cy="1233900"/>
                  </a:xfrm>
                  <a:prstGeom prst="rect">
                    <a:avLst/>
                  </a:prstGeom>
                </p:spPr>
              </p:pic>
              <p:pic>
                <p:nvPicPr>
                  <p:cNvPr id="45" name="图片 20">
                    <a:extLst>
                      <a:ext uri="{FF2B5EF4-FFF2-40B4-BE49-F238E27FC236}">
                        <a16:creationId xmlns:a16="http://schemas.microsoft.com/office/drawing/2014/main" id="{BB497385-C2DB-4A73-8993-32B34007C26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sharpenSoften amount="15000"/>
                            </a14:imgEffect>
                            <a14:imgEffect>
                              <a14:brightnessContrast bright="25000" contrast="15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513823" y="3247420"/>
                    <a:ext cx="1645200" cy="1233900"/>
                  </a:xfrm>
                  <a:prstGeom prst="rect">
                    <a:avLst/>
                  </a:prstGeom>
                </p:spPr>
              </p:pic>
              <p:pic>
                <p:nvPicPr>
                  <p:cNvPr id="46" name="Picture 45">
                    <a:extLst>
                      <a:ext uri="{FF2B5EF4-FFF2-40B4-BE49-F238E27FC236}">
                        <a16:creationId xmlns:a16="http://schemas.microsoft.com/office/drawing/2014/main" id="{88044831-2C52-4510-B7FE-1AC7A0AF39C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>
                    <a:lum bright="6000" contrast="4000"/>
                  </a:blip>
                  <a:stretch>
                    <a:fillRect/>
                  </a:stretch>
                </p:blipFill>
                <p:spPr>
                  <a:xfrm>
                    <a:off x="6096000" y="4548726"/>
                    <a:ext cx="1648107" cy="1233900"/>
                  </a:xfrm>
                  <a:prstGeom prst="rect">
                    <a:avLst/>
                  </a:prstGeom>
                </p:spPr>
              </p:pic>
              <p:graphicFrame>
                <p:nvGraphicFramePr>
                  <p:cNvPr id="47" name="Object 46">
                    <a:extLst>
                      <a:ext uri="{FF2B5EF4-FFF2-40B4-BE49-F238E27FC236}">
                        <a16:creationId xmlns:a16="http://schemas.microsoft.com/office/drawing/2014/main" id="{437C019C-5725-4F46-9FEC-DF8F2A7BD16F}"/>
                      </a:ext>
                    </a:extLst>
                  </p:cNvPr>
                  <p:cNvGraphicFramePr>
                    <a:graphicFrameLocks/>
                  </p:cNvGraphicFramePr>
                  <p:nvPr/>
                </p:nvGraphicFramePr>
                <p:xfrm>
                  <a:off x="7800491" y="4543251"/>
                  <a:ext cx="1645920" cy="1234440"/>
                </p:xfrm>
                <a:graphic>
                  <a:graphicData uri="http://schemas.openxmlformats.org/presentationml/2006/ole">
                    <mc:AlternateContent xmlns:mc="http://schemas.openxmlformats.org/markup-compatibility/2006">
                      <mc:Choice xmlns:v="urn:schemas-microsoft-com:vml" Requires="v">
                        <p:oleObj spid="_x0000_s3082" name="Image" r:id="rId10" imgW="2196720" imgH="1638000" progId="Photoshop.Image.22">
                          <p:embed/>
                        </p:oleObj>
                      </mc:Choice>
                      <mc:Fallback>
                        <p:oleObj name="Image" r:id="rId10" imgW="2196720" imgH="1638000" progId="Photoshop.Image.22">
                          <p:embed/>
                          <p:pic>
                            <p:nvPicPr>
                              <p:cNvPr id="47" name="Object 46">
                                <a:extLst>
                                  <a:ext uri="{FF2B5EF4-FFF2-40B4-BE49-F238E27FC236}">
                                    <a16:creationId xmlns:a16="http://schemas.microsoft.com/office/drawing/2014/main" id="{437C019C-5725-4F46-9FEC-DF8F2A7BD16F}"/>
                                  </a:ext>
                                </a:extLst>
                              </p:cNvPr>
                              <p:cNvPicPr preferRelativeResize="0"/>
                              <p:nvPr/>
                            </p:nvPicPr>
                            <p:blipFill>
                              <a:blip r:embed="rId11">
                                <a:lum bright="8000" contrast="5000"/>
                              </a:blip>
                              <a:stretch>
                                <a:fillRect/>
                              </a:stretch>
                            </p:blipFill>
                            <p:spPr>
                              <a:xfrm>
                                <a:off x="7800491" y="4543251"/>
                                <a:ext cx="1645920" cy="1234440"/>
                              </a:xfrm>
                              <a:prstGeom prst="rect">
                                <a:avLst/>
                              </a:prstGeom>
                            </p:spPr>
                          </p:pic>
                        </p:oleObj>
                      </mc:Fallback>
                    </mc:AlternateContent>
                  </a:graphicData>
                </a:graphic>
              </p:graphicFrame>
              <p:pic>
                <p:nvPicPr>
                  <p:cNvPr id="48" name="Picture 47">
                    <a:extLst>
                      <a:ext uri="{FF2B5EF4-FFF2-40B4-BE49-F238E27FC236}">
                        <a16:creationId xmlns:a16="http://schemas.microsoft.com/office/drawing/2014/main" id="{9A24A92F-2892-46AB-AD9B-B27278A4C905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12">
                    <a:lum bright="4000" contrast="2000"/>
                  </a:blip>
                  <a:stretch>
                    <a:fillRect/>
                  </a:stretch>
                </p:blipFill>
                <p:spPr>
                  <a:xfrm>
                    <a:off x="9513823" y="4548715"/>
                    <a:ext cx="1645200" cy="1234440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38" name="Title 1">
                  <a:extLst>
                    <a:ext uri="{FF2B5EF4-FFF2-40B4-BE49-F238E27FC236}">
                      <a16:creationId xmlns:a16="http://schemas.microsoft.com/office/drawing/2014/main" id="{71586F2C-1D16-4FD1-909A-789554613462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814042" y="2647897"/>
                  <a:ext cx="1579899" cy="286409"/>
                </a:xfrm>
                <a:prstGeom prst="rect">
                  <a:avLst/>
                </a:prstGeom>
              </p:spPr>
              <p:txBody>
                <a:bodyPr vert="horz" lIns="91440" tIns="45720" rIns="91440" bIns="45720" rtlCol="0" anchor="b">
                  <a:noAutofit/>
                </a:bodyPr>
                <a:lstStyle>
                  <a:lvl1pPr algn="ctr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sz="60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pPr algn="l"/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4 BMKO</a:t>
                  </a:r>
                </a:p>
              </p:txBody>
            </p:sp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21A4A2BD-617A-44BB-9F58-1A88432B5EC9}"/>
                    </a:ext>
                  </a:extLst>
                </p:cNvPr>
                <p:cNvGrpSpPr/>
                <p:nvPr/>
              </p:nvGrpSpPr>
              <p:grpSpPr>
                <a:xfrm>
                  <a:off x="6987085" y="3946714"/>
                  <a:ext cx="793915" cy="337700"/>
                  <a:chOff x="7154202" y="6394368"/>
                  <a:chExt cx="793915" cy="337700"/>
                </a:xfrm>
              </p:grpSpPr>
              <p:cxnSp>
                <p:nvCxnSpPr>
                  <p:cNvPr id="41" name="Straight Connector 40">
                    <a:extLst>
                      <a:ext uri="{FF2B5EF4-FFF2-40B4-BE49-F238E27FC236}">
                        <a16:creationId xmlns:a16="http://schemas.microsoft.com/office/drawing/2014/main" id="{AEA60A81-8D11-4944-ADE3-82886AA8A270}"/>
                      </a:ext>
                    </a:extLst>
                  </p:cNvPr>
                  <p:cNvCxnSpPr/>
                  <p:nvPr/>
                </p:nvCxnSpPr>
                <p:spPr>
                  <a:xfrm>
                    <a:off x="7449177" y="6722029"/>
                    <a:ext cx="252181" cy="0"/>
                  </a:xfrm>
                  <a:prstGeom prst="line">
                    <a:avLst/>
                  </a:prstGeom>
                  <a:ln w="2857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2" name="TextBox 5">
                    <a:extLst>
                      <a:ext uri="{FF2B5EF4-FFF2-40B4-BE49-F238E27FC236}">
                        <a16:creationId xmlns:a16="http://schemas.microsoft.com/office/drawing/2014/main" id="{997E6E8C-4D31-4502-9A0E-E4979A1D6B23}"/>
                      </a:ext>
                    </a:extLst>
                  </p:cNvPr>
                  <p:cNvSpPr txBox="1"/>
                  <p:nvPr/>
                </p:nvSpPr>
                <p:spPr>
                  <a:xfrm>
                    <a:off x="7154202" y="6394368"/>
                    <a:ext cx="793915" cy="33770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µm</a:t>
                    </a:r>
                  </a:p>
                </p:txBody>
              </p:sp>
            </p:grpSp>
            <p:cxnSp>
              <p:nvCxnSpPr>
                <p:cNvPr id="40" name="Straight Connector 39">
                  <a:extLst>
                    <a:ext uri="{FF2B5EF4-FFF2-40B4-BE49-F238E27FC236}">
                      <a16:creationId xmlns:a16="http://schemas.microsoft.com/office/drawing/2014/main" id="{990D85F8-62A0-49FF-AB72-8327E42FA549}"/>
                    </a:ext>
                  </a:extLst>
                </p:cNvPr>
                <p:cNvCxnSpPr/>
                <p:nvPr/>
              </p:nvCxnSpPr>
              <p:spPr>
                <a:xfrm>
                  <a:off x="7311609" y="5561932"/>
                  <a:ext cx="252179" cy="0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4" name="Title 1">
                <a:extLst>
                  <a:ext uri="{FF2B5EF4-FFF2-40B4-BE49-F238E27FC236}">
                    <a16:creationId xmlns:a16="http://schemas.microsoft.com/office/drawing/2014/main" id="{8D1FA374-AB0B-4162-842E-8F43B1856C2D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9640545" y="3334974"/>
                <a:ext cx="1310160" cy="216937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lvl1pPr algn="ctr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60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b(2um)</a:t>
                </a:r>
              </a:p>
            </p:txBody>
          </p:sp>
          <p:sp>
            <p:nvSpPr>
              <p:cNvPr id="35" name="Title 1">
                <a:extLst>
                  <a:ext uri="{FF2B5EF4-FFF2-40B4-BE49-F238E27FC236}">
                    <a16:creationId xmlns:a16="http://schemas.microsoft.com/office/drawing/2014/main" id="{C3A9B64F-9218-4A80-BA60-80356808D14E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6603282" y="3407427"/>
                <a:ext cx="957233" cy="161844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lvl1pPr algn="ctr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60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</a:p>
            </p:txBody>
          </p:sp>
          <p:sp>
            <p:nvSpPr>
              <p:cNvPr id="36" name="Title 1">
                <a:extLst>
                  <a:ext uri="{FF2B5EF4-FFF2-40B4-BE49-F238E27FC236}">
                    <a16:creationId xmlns:a16="http://schemas.microsoft.com/office/drawing/2014/main" id="{A2268958-5344-4B62-B71C-84B81571CF3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46050" y="3158614"/>
                <a:ext cx="1297535" cy="403812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lvl1pPr algn="ctr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60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b(1um)</a:t>
                </a:r>
              </a:p>
            </p:txBody>
          </p:sp>
        </p:grp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0BA0779D-6C40-470A-8275-B5B38E219B9B}"/>
                </a:ext>
              </a:extLst>
            </p:cNvPr>
            <p:cNvCxnSpPr>
              <a:cxnSpLocks/>
            </p:cNvCxnSpPr>
            <p:nvPr/>
          </p:nvCxnSpPr>
          <p:spPr>
            <a:xfrm>
              <a:off x="3619109" y="2108922"/>
              <a:ext cx="266741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9277DD52-C125-4707-A527-4B73457F2C37}"/>
              </a:ext>
            </a:extLst>
          </p:cNvPr>
          <p:cNvGrpSpPr/>
          <p:nvPr/>
        </p:nvGrpSpPr>
        <p:grpSpPr>
          <a:xfrm>
            <a:off x="258262" y="629817"/>
            <a:ext cx="3022195" cy="2180228"/>
            <a:chOff x="714859" y="298998"/>
            <a:chExt cx="3802546" cy="2519670"/>
          </a:xfrm>
        </p:grpSpPr>
        <p:sp>
          <p:nvSpPr>
            <p:cNvPr id="71" name="Title 1">
              <a:extLst>
                <a:ext uri="{FF2B5EF4-FFF2-40B4-BE49-F238E27FC236}">
                  <a16:creationId xmlns:a16="http://schemas.microsoft.com/office/drawing/2014/main" id="{9C1196F5-EAE0-400C-A5FE-C245CC0E3423}"/>
                </a:ext>
              </a:extLst>
            </p:cNvPr>
            <p:cNvSpPr txBox="1">
              <a:spLocks/>
            </p:cNvSpPr>
            <p:nvPr/>
          </p:nvSpPr>
          <p:spPr>
            <a:xfrm>
              <a:off x="2120492" y="298998"/>
              <a:ext cx="1161357" cy="291865"/>
            </a:xfrm>
            <a:prstGeom prst="rect">
              <a:avLst/>
            </a:prstGeom>
          </p:spPr>
          <p:txBody>
            <a:bodyPr vert="horz" lIns="91440" tIns="45720" rIns="91440" bIns="45720" rtlCol="0" anchor="b">
              <a:noAutofit/>
            </a:bodyPr>
            <a:lstStyle>
              <a:lvl1pPr algn="ctr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60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l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4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BMCtr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12795ACA-3058-4AA2-B16C-E79C81CC880A}"/>
                </a:ext>
              </a:extLst>
            </p:cNvPr>
            <p:cNvGrpSpPr/>
            <p:nvPr/>
          </p:nvGrpSpPr>
          <p:grpSpPr>
            <a:xfrm>
              <a:off x="714859" y="811675"/>
              <a:ext cx="3802546" cy="2006992"/>
              <a:chOff x="653487" y="874734"/>
              <a:chExt cx="5084634" cy="2550894"/>
            </a:xfrm>
          </p:grpSpPr>
          <p:pic>
            <p:nvPicPr>
              <p:cNvPr id="91" name="Picture 90">
                <a:extLst>
                  <a:ext uri="{FF2B5EF4-FFF2-40B4-BE49-F238E27FC236}">
                    <a16:creationId xmlns:a16="http://schemas.microsoft.com/office/drawing/2014/main" id="{ECC8C482-B07E-4EBE-936E-027B4776355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sharpenSoften amount="15000"/>
                        </a14:imgEffect>
                        <a14:imgEffect>
                          <a14:brightnessContrast bright="32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3487" y="874734"/>
                <a:ext cx="1645920" cy="1234440"/>
              </a:xfrm>
              <a:prstGeom prst="rect">
                <a:avLst/>
              </a:prstGeom>
            </p:spPr>
          </p:pic>
          <p:pic>
            <p:nvPicPr>
              <p:cNvPr id="92" name="Picture 91">
                <a:extLst>
                  <a:ext uri="{FF2B5EF4-FFF2-40B4-BE49-F238E27FC236}">
                    <a16:creationId xmlns:a16="http://schemas.microsoft.com/office/drawing/2014/main" id="{03C5066D-A1AC-445A-8D47-3D8F9BC3B9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sharpenSoften amount="15000"/>
                        </a14:imgEffect>
                        <a14:imgEffect>
                          <a14:brightnessContrast bright="30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72844" y="874734"/>
                <a:ext cx="1645920" cy="1234440"/>
              </a:xfrm>
              <a:prstGeom prst="rect">
                <a:avLst/>
              </a:prstGeom>
            </p:spPr>
          </p:pic>
          <p:pic>
            <p:nvPicPr>
              <p:cNvPr id="93" name="Picture 92">
                <a:extLst>
                  <a:ext uri="{FF2B5EF4-FFF2-40B4-BE49-F238E27FC236}">
                    <a16:creationId xmlns:a16="http://schemas.microsoft.com/office/drawing/2014/main" id="{B8FD358F-2135-4C70-86DB-FA5837DA0AC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sharpenSoften amount="15000"/>
                        </a14:imgEffect>
                        <a14:imgEffect>
                          <a14:brightnessContrast bright="30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92201" y="874734"/>
                <a:ext cx="1645920" cy="1234440"/>
              </a:xfrm>
              <a:prstGeom prst="rect">
                <a:avLst/>
              </a:prstGeom>
            </p:spPr>
          </p:pic>
          <p:pic>
            <p:nvPicPr>
              <p:cNvPr id="94" name="Picture 93">
                <a:extLst>
                  <a:ext uri="{FF2B5EF4-FFF2-40B4-BE49-F238E27FC236}">
                    <a16:creationId xmlns:a16="http://schemas.microsoft.com/office/drawing/2014/main" id="{F655722B-2CBE-4ED3-A93E-4A9F6ECF5B2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9">
                <a:lum bright="6000" contrast="10000"/>
              </a:blip>
              <a:stretch>
                <a:fillRect/>
              </a:stretch>
            </p:blipFill>
            <p:spPr>
              <a:xfrm>
                <a:off x="653487" y="2191188"/>
                <a:ext cx="1645920" cy="1234440"/>
              </a:xfrm>
              <a:prstGeom prst="rect">
                <a:avLst/>
              </a:prstGeom>
            </p:spPr>
          </p:pic>
          <p:pic>
            <p:nvPicPr>
              <p:cNvPr id="95" name="Picture 94">
                <a:extLst>
                  <a:ext uri="{FF2B5EF4-FFF2-40B4-BE49-F238E27FC236}">
                    <a16:creationId xmlns:a16="http://schemas.microsoft.com/office/drawing/2014/main" id="{1BD4860F-56EE-4379-B855-F003713DCAF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0">
                <a:lum bright="6000" contrast="10000"/>
              </a:blip>
              <a:stretch>
                <a:fillRect/>
              </a:stretch>
            </p:blipFill>
            <p:spPr>
              <a:xfrm>
                <a:off x="2372844" y="2191188"/>
                <a:ext cx="1645920" cy="1232793"/>
              </a:xfrm>
              <a:prstGeom prst="rect">
                <a:avLst/>
              </a:prstGeom>
            </p:spPr>
          </p:pic>
          <p:pic>
            <p:nvPicPr>
              <p:cNvPr id="96" name="Picture 95">
                <a:extLst>
                  <a:ext uri="{FF2B5EF4-FFF2-40B4-BE49-F238E27FC236}">
                    <a16:creationId xmlns:a16="http://schemas.microsoft.com/office/drawing/2014/main" id="{F4E4C768-0331-4AF4-A274-9889433EFD5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1">
                <a:lum bright="2000"/>
              </a:blip>
              <a:stretch>
                <a:fillRect/>
              </a:stretch>
            </p:blipFill>
            <p:spPr>
              <a:xfrm>
                <a:off x="4092201" y="2191188"/>
                <a:ext cx="1645920" cy="1234440"/>
              </a:xfrm>
              <a:prstGeom prst="rect">
                <a:avLst/>
              </a:prstGeom>
            </p:spPr>
          </p:pic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8CD9B7E4-D8A2-49BE-A934-20065105D5F8}"/>
                  </a:ext>
                </a:extLst>
              </p:cNvPr>
              <p:cNvGrpSpPr/>
              <p:nvPr/>
            </p:nvGrpSpPr>
            <p:grpSpPr>
              <a:xfrm>
                <a:off x="1731380" y="1712928"/>
                <a:ext cx="798836" cy="339066"/>
                <a:chOff x="7313739" y="6512872"/>
                <a:chExt cx="798836" cy="339066"/>
              </a:xfrm>
            </p:grpSpPr>
            <p:cxnSp>
              <p:nvCxnSpPr>
                <p:cNvPr id="99" name="Straight Connector 98">
                  <a:extLst>
                    <a:ext uri="{FF2B5EF4-FFF2-40B4-BE49-F238E27FC236}">
                      <a16:creationId xmlns:a16="http://schemas.microsoft.com/office/drawing/2014/main" id="{697FE8C2-CD36-4A74-89AA-E9C4DC57CFBC}"/>
                    </a:ext>
                  </a:extLst>
                </p:cNvPr>
                <p:cNvCxnSpPr/>
                <p:nvPr/>
              </p:nvCxnSpPr>
              <p:spPr>
                <a:xfrm>
                  <a:off x="7449178" y="6753141"/>
                  <a:ext cx="252180" cy="0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0" name="TextBox 5">
                  <a:extLst>
                    <a:ext uri="{FF2B5EF4-FFF2-40B4-BE49-F238E27FC236}">
                      <a16:creationId xmlns:a16="http://schemas.microsoft.com/office/drawing/2014/main" id="{AF8906E4-1E5E-42CA-972C-7890A5E66ADF}"/>
                    </a:ext>
                  </a:extLst>
                </p:cNvPr>
                <p:cNvSpPr txBox="1"/>
                <p:nvPr/>
              </p:nvSpPr>
              <p:spPr>
                <a:xfrm>
                  <a:off x="7313739" y="6512872"/>
                  <a:ext cx="798836" cy="3390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0µm</a:t>
                  </a:r>
                </a:p>
              </p:txBody>
            </p:sp>
          </p:grpSp>
          <p:cxnSp>
            <p:nvCxnSpPr>
              <p:cNvPr id="98" name="Straight Connector 97">
                <a:extLst>
                  <a:ext uri="{FF2B5EF4-FFF2-40B4-BE49-F238E27FC236}">
                    <a16:creationId xmlns:a16="http://schemas.microsoft.com/office/drawing/2014/main" id="{6035D15D-E82F-412F-A928-35040417B37C}"/>
                  </a:ext>
                </a:extLst>
              </p:cNvPr>
              <p:cNvCxnSpPr/>
              <p:nvPr/>
            </p:nvCxnSpPr>
            <p:spPr>
              <a:xfrm>
                <a:off x="1855152" y="3271930"/>
                <a:ext cx="25218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84E31CE7-1A65-41CA-88F0-86AE148C4E7E}"/>
                </a:ext>
              </a:extLst>
            </p:cNvPr>
            <p:cNvGrpSpPr/>
            <p:nvPr/>
          </p:nvGrpSpPr>
          <p:grpSpPr>
            <a:xfrm>
              <a:off x="714859" y="540115"/>
              <a:ext cx="3802546" cy="2278553"/>
              <a:chOff x="653487" y="529580"/>
              <a:chExt cx="5084634" cy="2896048"/>
            </a:xfrm>
          </p:grpSpPr>
          <p:sp>
            <p:nvSpPr>
              <p:cNvPr id="75" name="Title 1">
                <a:extLst>
                  <a:ext uri="{FF2B5EF4-FFF2-40B4-BE49-F238E27FC236}">
                    <a16:creationId xmlns:a16="http://schemas.microsoft.com/office/drawing/2014/main" id="{AA045575-3D96-4535-A30C-75B306ECE4B5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161255" y="529580"/>
                <a:ext cx="1460510" cy="394673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lvl1pPr algn="ctr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60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b(2um)</a:t>
                </a:r>
              </a:p>
            </p:txBody>
          </p:sp>
          <p:sp>
            <p:nvSpPr>
              <p:cNvPr id="76" name="Title 1">
                <a:extLst>
                  <a:ext uri="{FF2B5EF4-FFF2-40B4-BE49-F238E27FC236}">
                    <a16:creationId xmlns:a16="http://schemas.microsoft.com/office/drawing/2014/main" id="{C8C5E6E3-70E5-44C1-BC23-17D34388DBD7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078642" y="647503"/>
                <a:ext cx="1160415" cy="273758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lvl1pPr algn="ctr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60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</a:p>
            </p:txBody>
          </p:sp>
          <p:sp>
            <p:nvSpPr>
              <p:cNvPr id="77" name="Title 1">
                <a:extLst>
                  <a:ext uri="{FF2B5EF4-FFF2-40B4-BE49-F238E27FC236}">
                    <a16:creationId xmlns:a16="http://schemas.microsoft.com/office/drawing/2014/main" id="{60350C40-36BA-4A29-973F-5718E43C616E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602967" y="540845"/>
                <a:ext cx="1361877" cy="385606"/>
              </a:xfrm>
              <a:prstGeom prst="rect">
                <a:avLst/>
              </a:prstGeom>
            </p:spPr>
            <p:txBody>
              <a:bodyPr vert="horz" lIns="91440" tIns="45720" rIns="91440" bIns="45720" rtlCol="0" anchor="b">
                <a:noAutofit/>
              </a:bodyPr>
              <a:lstStyle>
                <a:lvl1pPr algn="ctr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60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l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b(1um)</a:t>
                </a:r>
              </a:p>
            </p:txBody>
          </p:sp>
          <p:pic>
            <p:nvPicPr>
              <p:cNvPr id="78" name="Picture 77">
                <a:extLst>
                  <a:ext uri="{FF2B5EF4-FFF2-40B4-BE49-F238E27FC236}">
                    <a16:creationId xmlns:a16="http://schemas.microsoft.com/office/drawing/2014/main" id="{980E076D-B60D-4BFD-B284-BDB7CAEBA3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sharpenSoften amount="15000"/>
                        </a14:imgEffect>
                        <a14:imgEffect>
                          <a14:brightnessContrast bright="30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3487" y="874734"/>
                <a:ext cx="1645920" cy="1234440"/>
              </a:xfrm>
              <a:prstGeom prst="rect">
                <a:avLst/>
              </a:prstGeom>
            </p:spPr>
          </p:pic>
          <p:pic>
            <p:nvPicPr>
              <p:cNvPr id="79" name="Picture 78">
                <a:extLst>
                  <a:ext uri="{FF2B5EF4-FFF2-40B4-BE49-F238E27FC236}">
                    <a16:creationId xmlns:a16="http://schemas.microsoft.com/office/drawing/2014/main" id="{C851A446-A94A-4216-B73C-3E0EB8CE4A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sharpenSoften amount="15000"/>
                        </a14:imgEffect>
                        <a14:imgEffect>
                          <a14:brightnessContrast bright="22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72844" y="874734"/>
                <a:ext cx="1645920" cy="1234440"/>
              </a:xfrm>
              <a:prstGeom prst="rect">
                <a:avLst/>
              </a:prstGeom>
            </p:spPr>
          </p:pic>
          <p:pic>
            <p:nvPicPr>
              <p:cNvPr id="80" name="Picture 79">
                <a:extLst>
                  <a:ext uri="{FF2B5EF4-FFF2-40B4-BE49-F238E27FC236}">
                    <a16:creationId xmlns:a16="http://schemas.microsoft.com/office/drawing/2014/main" id="{ABBCD8E3-DADD-414C-BFCC-CD3612FD93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sharpenSoften amount="15000"/>
                        </a14:imgEffect>
                        <a14:imgEffect>
                          <a14:brightnessContrast bright="25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92201" y="874734"/>
                <a:ext cx="1645920" cy="1234440"/>
              </a:xfrm>
              <a:prstGeom prst="rect">
                <a:avLst/>
              </a:prstGeom>
            </p:spPr>
          </p:pic>
          <p:pic>
            <p:nvPicPr>
              <p:cNvPr id="81" name="Picture 80">
                <a:extLst>
                  <a:ext uri="{FF2B5EF4-FFF2-40B4-BE49-F238E27FC236}">
                    <a16:creationId xmlns:a16="http://schemas.microsoft.com/office/drawing/2014/main" id="{35DED8C0-823F-4DE3-85E0-260F9599406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9">
                <a:lum bright="6000" contrast="10000"/>
              </a:blip>
              <a:stretch>
                <a:fillRect/>
              </a:stretch>
            </p:blipFill>
            <p:spPr>
              <a:xfrm>
                <a:off x="653487" y="2191188"/>
                <a:ext cx="1645920" cy="1234440"/>
              </a:xfrm>
              <a:prstGeom prst="rect">
                <a:avLst/>
              </a:prstGeom>
            </p:spPr>
          </p:pic>
          <p:pic>
            <p:nvPicPr>
              <p:cNvPr id="82" name="Picture 81">
                <a:extLst>
                  <a:ext uri="{FF2B5EF4-FFF2-40B4-BE49-F238E27FC236}">
                    <a16:creationId xmlns:a16="http://schemas.microsoft.com/office/drawing/2014/main" id="{E52F753C-9A44-4BEE-8435-B5CEEBC053C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0">
                <a:lum bright="6000" contrast="10000"/>
              </a:blip>
              <a:stretch>
                <a:fillRect/>
              </a:stretch>
            </p:blipFill>
            <p:spPr>
              <a:xfrm>
                <a:off x="2372844" y="2191188"/>
                <a:ext cx="1645920" cy="1232793"/>
              </a:xfrm>
              <a:prstGeom prst="rect">
                <a:avLst/>
              </a:prstGeom>
            </p:spPr>
          </p:pic>
          <p:pic>
            <p:nvPicPr>
              <p:cNvPr id="83" name="Picture 82">
                <a:extLst>
                  <a:ext uri="{FF2B5EF4-FFF2-40B4-BE49-F238E27FC236}">
                    <a16:creationId xmlns:a16="http://schemas.microsoft.com/office/drawing/2014/main" id="{6812B978-823D-4F6F-8025-F3D8602AC97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1">
                <a:lum bright="2000"/>
              </a:blip>
              <a:stretch>
                <a:fillRect/>
              </a:stretch>
            </p:blipFill>
            <p:spPr>
              <a:xfrm>
                <a:off x="4092201" y="2191188"/>
                <a:ext cx="1645920" cy="1234440"/>
              </a:xfrm>
              <a:prstGeom prst="rect">
                <a:avLst/>
              </a:prstGeom>
            </p:spPr>
          </p:pic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F18260C9-43D2-4ECD-8279-D408EB85DA88}"/>
                  </a:ext>
                </a:extLst>
              </p:cNvPr>
              <p:cNvGrpSpPr/>
              <p:nvPr/>
            </p:nvGrpSpPr>
            <p:grpSpPr>
              <a:xfrm>
                <a:off x="1588844" y="1619654"/>
                <a:ext cx="798834" cy="339066"/>
                <a:chOff x="7171203" y="6419598"/>
                <a:chExt cx="798834" cy="339066"/>
              </a:xfrm>
            </p:grpSpPr>
            <p:cxnSp>
              <p:nvCxnSpPr>
                <p:cNvPr id="86" name="Straight Connector 85">
                  <a:extLst>
                    <a:ext uri="{FF2B5EF4-FFF2-40B4-BE49-F238E27FC236}">
                      <a16:creationId xmlns:a16="http://schemas.microsoft.com/office/drawing/2014/main" id="{2FB8D5A7-32F5-4793-B0B4-FCD96ADEA856}"/>
                    </a:ext>
                  </a:extLst>
                </p:cNvPr>
                <p:cNvCxnSpPr/>
                <p:nvPr/>
              </p:nvCxnSpPr>
              <p:spPr>
                <a:xfrm>
                  <a:off x="7449178" y="6753141"/>
                  <a:ext cx="252180" cy="0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7" name="TextBox 5">
                  <a:extLst>
                    <a:ext uri="{FF2B5EF4-FFF2-40B4-BE49-F238E27FC236}">
                      <a16:creationId xmlns:a16="http://schemas.microsoft.com/office/drawing/2014/main" id="{18E96D48-BA66-4C2F-86D5-0E018A38E34C}"/>
                    </a:ext>
                  </a:extLst>
                </p:cNvPr>
                <p:cNvSpPr txBox="1"/>
                <p:nvPr/>
              </p:nvSpPr>
              <p:spPr>
                <a:xfrm>
                  <a:off x="7171203" y="6419598"/>
                  <a:ext cx="798834" cy="3390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0µm</a:t>
                  </a:r>
                </a:p>
              </p:txBody>
            </p:sp>
          </p:grpSp>
          <p:cxnSp>
            <p:nvCxnSpPr>
              <p:cNvPr id="85" name="Straight Connector 84">
                <a:extLst>
                  <a:ext uri="{FF2B5EF4-FFF2-40B4-BE49-F238E27FC236}">
                    <a16:creationId xmlns:a16="http://schemas.microsoft.com/office/drawing/2014/main" id="{4977B4B4-C2EF-4D49-9394-BC7E90EB1C43}"/>
                  </a:ext>
                </a:extLst>
              </p:cNvPr>
              <p:cNvCxnSpPr/>
              <p:nvPr/>
            </p:nvCxnSpPr>
            <p:spPr>
              <a:xfrm>
                <a:off x="1855151" y="3256311"/>
                <a:ext cx="25218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A5D37B08-7767-4988-BF38-8665F5DF1050}"/>
              </a:ext>
            </a:extLst>
          </p:cNvPr>
          <p:cNvCxnSpPr>
            <a:cxnSpLocks/>
          </p:cNvCxnSpPr>
          <p:nvPr/>
        </p:nvCxnSpPr>
        <p:spPr>
          <a:xfrm>
            <a:off x="491503" y="831699"/>
            <a:ext cx="26674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635904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51357" y="332659"/>
            <a:ext cx="35379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Supplemental Table 1. Primary antibodies list.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5112331"/>
              </p:ext>
            </p:extLst>
          </p:nvPr>
        </p:nvGraphicFramePr>
        <p:xfrm>
          <a:off x="401795" y="794815"/>
          <a:ext cx="5158948" cy="3816253"/>
        </p:xfrm>
        <a:graphic>
          <a:graphicData uri="http://schemas.openxmlformats.org/drawingml/2006/table">
            <a:tbl>
              <a:tblPr/>
              <a:tblGrid>
                <a:gridCol w="15014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6188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3440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6122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87076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urc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#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ilution 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7213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mal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C-365645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97213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BPα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C-61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97213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BP</a:t>
                      </a:r>
                      <a:r>
                        <a:rPr lang="el-GR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endParaRPr lang="en-US" sz="1000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C-796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7213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ARγ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C-7273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97213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SN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C-48357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97213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BP4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C-271529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97213"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enin</a:t>
                      </a: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480S</a:t>
                      </a: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97213"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SP9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874S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:300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998" marR="64998" marT="902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51473"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β-Actin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oteintech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6009-1-Ig</a:t>
                      </a: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1:3000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222" marR="7222" marT="72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328127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82185" y="252357"/>
            <a:ext cx="4483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itchFamily="34" charset="0"/>
                <a:cs typeface="Arial" pitchFamily="34" charset="0"/>
              </a:rPr>
              <a:t>Supplemental Table 2. Primer sequence for qPCR analysis.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8983640"/>
              </p:ext>
            </p:extLst>
          </p:nvPr>
        </p:nvGraphicFramePr>
        <p:xfrm>
          <a:off x="395578" y="678395"/>
          <a:ext cx="4825387" cy="5863660"/>
        </p:xfrm>
        <a:graphic>
          <a:graphicData uri="http://schemas.openxmlformats.org/drawingml/2006/table">
            <a:tbl>
              <a:tblPr/>
              <a:tblGrid>
                <a:gridCol w="9563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682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007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93274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quences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2965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mal1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TTTCTGGAGGGTGTCCG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CCAGGACGCGCTTGTACC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4021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ock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GCTCCACGGGAATCCTT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GGGAAAGTGCTCTGTTGTA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ry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GCGTGGAAGTCATCGT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TCCGCCATTGAGTTCTAT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ry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TCCCTTCCTGTGTGGAAGA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TCCCAGCTTGGCTTGA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r1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CCATGGAGGAAGAAGA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CTGGGGCAGTTTCCTATT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CTCGCCATCCACAAGA</a:t>
                      </a: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GGAATCGAATGGGAGAAT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kumimoji="0" lang="en-US" altLang="en-US" sz="10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ora</a:t>
                      </a:r>
                      <a:endParaRPr lang="en-US" sz="1000" i="0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ACACCTTGCCCAGAACAT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GCTCAGCTGTTCCACCC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nt1</a:t>
                      </a: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TTCTACTACGTTGCTACTG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AATCCGTCAACAGGTTCGT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nt10a</a:t>
                      </a: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ACGCGTGCGCTCTGGGTA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GCTCAAGCCCTTTCCGC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nt10b</a:t>
                      </a: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AGCCTCGCCTAGGCACGA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AGCTTCCGGGAGCCACGA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zd1</a:t>
                      </a: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GCAGTACAACGGCGAAC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CCTCCTGATTCGTGTGGC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4021">
                <a:tc>
                  <a:txBody>
                    <a:bodyPr/>
                    <a:lstStyle/>
                    <a:p>
                      <a:pPr marL="0" marR="0" lvl="0" indent="0" algn="l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en-US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zd2</a:t>
                      </a:r>
                      <a:endParaRPr kumimoji="0" lang="en-US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GCCCAACCTTCTTGGC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GCGGGTAGAACTGATGCAC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8128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vl2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AGTTTGCGGGTGTGCGCA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4507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TCGTCTCGCCTACACCACC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4507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f3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GCTTGGACGAGGCCATCC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4507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GCTCGTGGTCAGTGCGCC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64507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cf4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CGCAGCGCCTTCTCTTTA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450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US" sz="10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CATCATTGACTCCCCCGAGG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64507">
                <a:tc>
                  <a:txBody>
                    <a:bodyPr/>
                    <a:lstStyle/>
                    <a:p>
                      <a:pPr marL="0" marR="0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l-GR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tenin</a:t>
                      </a: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TTGGCTGAACCATCAC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450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US" sz="10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TCCGCGTCATCCTGATAGT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087" marR="2087" marT="208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64507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B4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CTTTCTGGAGGGTGTCCGC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164507"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 fontAlgn="b">
                        <a:lnSpc>
                          <a:spcPct val="10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CCAGGACGCGCTTGTACC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1043" marR="1043" marT="10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5987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7</TotalTime>
  <Words>519</Words>
  <Application>Microsoft Office PowerPoint</Application>
  <PresentationFormat>Custom</PresentationFormat>
  <Paragraphs>229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 Ma PhD</dc:creator>
  <cp:lastModifiedBy>Ke Ma PhD</cp:lastModifiedBy>
  <cp:revision>8</cp:revision>
  <dcterms:created xsi:type="dcterms:W3CDTF">2022-12-29T01:30:15Z</dcterms:created>
  <dcterms:modified xsi:type="dcterms:W3CDTF">2023-02-08T07:19:16Z</dcterms:modified>
</cp:coreProperties>
</file>